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6"/>
  </p:notesMasterIdLst>
  <p:sldIdLst>
    <p:sldId id="1748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72" d="100"/>
          <a:sy n="72" d="100"/>
        </p:scale>
        <p:origin x="193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西浦　颯" userId="30eb12cf-a0f0-479c-babe-56a40fd49a1c" providerId="ADAL" clId="{2E553566-6D9F-4437-88D3-9E0177D0855F}"/>
    <pc:docChg chg="modSld">
      <pc:chgData name="西浦　颯" userId="30eb12cf-a0f0-479c-babe-56a40fd49a1c" providerId="ADAL" clId="{2E553566-6D9F-4437-88D3-9E0177D0855F}" dt="2024-11-07T02:14:46.496" v="13" actId="12788"/>
      <pc:docMkLst>
        <pc:docMk/>
      </pc:docMkLst>
      <pc:sldChg chg="modSp mod">
        <pc:chgData name="西浦　颯" userId="30eb12cf-a0f0-479c-babe-56a40fd49a1c" providerId="ADAL" clId="{2E553566-6D9F-4437-88D3-9E0177D0855F}" dt="2024-11-07T02:14:46.496" v="13" actId="12788"/>
        <pc:sldMkLst>
          <pc:docMk/>
          <pc:sldMk cId="4039312371" sldId="1748"/>
        </pc:sldMkLst>
        <pc:spChg chg="mod">
          <ac:chgData name="西浦　颯" userId="30eb12cf-a0f0-479c-babe-56a40fd49a1c" providerId="ADAL" clId="{2E553566-6D9F-4437-88D3-9E0177D0855F}" dt="2024-11-07T02:14:36.849" v="10" actId="1076"/>
          <ac:spMkLst>
            <pc:docMk/>
            <pc:sldMk cId="4039312371" sldId="1748"/>
            <ac:spMk id="8" creationId="{33924D19-7BBA-BF58-9DDD-BF88A7361D1D}"/>
          </ac:spMkLst>
        </pc:spChg>
        <pc:picChg chg="mod">
          <ac:chgData name="西浦　颯" userId="30eb12cf-a0f0-479c-babe-56a40fd49a1c" providerId="ADAL" clId="{2E553566-6D9F-4437-88D3-9E0177D0855F}" dt="2024-11-07T02:14:46.496" v="13" actId="12788"/>
          <ac:picMkLst>
            <pc:docMk/>
            <pc:sldMk cId="4039312371" sldId="1748"/>
            <ac:picMk id="6" creationId="{2C3D95D6-F68F-92DA-D8B6-1FA17B770C5A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AF76C0-AE09-4541-9874-ED205CE45751}" type="datetimeFigureOut">
              <a:rPr kumimoji="1" lang="ja-JP" altLang="en-US" smtClean="0"/>
              <a:t>2024/11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3439F7-03E6-41EB-8AB9-B1B8DF4E9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05046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pt-BR" altLang="ja-JP" dirty="0"/>
              <a:t>A/Panama/2007/99 (H3N2) (Pan/99)</a:t>
            </a:r>
          </a:p>
          <a:p>
            <a:r>
              <a:rPr lang="en-US" altLang="ja-JP" sz="1800" b="0" i="0" u="none" strike="noStrike" baseline="0" dirty="0">
                <a:latin typeface="MyriadPro-Regular"/>
              </a:rPr>
              <a:t>A/Netherlands/602/2009 (pH1N1) (NL/09)</a:t>
            </a:r>
            <a:r>
              <a:rPr kumimoji="1" lang="ja-JP" altLang="en-US" sz="1800" b="0" i="0" u="none" strike="noStrike" baseline="0" dirty="0">
                <a:latin typeface="MyriadPro-Regular"/>
              </a:rPr>
              <a:t>をリバースジェネティクスで作成</a:t>
            </a:r>
            <a:endParaRPr kumimoji="1" lang="en-US" altLang="ja-JP" sz="1800" b="0" i="0" u="none" strike="noStrike" baseline="0" dirty="0">
              <a:latin typeface="MyriadPro-Regular"/>
            </a:endParaRPr>
          </a:p>
          <a:p>
            <a:r>
              <a:rPr kumimoji="1" lang="ja-JP" altLang="en-US" sz="1800" b="0" i="0" u="none" strike="noStrike" baseline="0" dirty="0">
                <a:latin typeface="MyriadPro-Regular"/>
              </a:rPr>
              <a:t>変異株はサイレント変異を</a:t>
            </a:r>
            <a:r>
              <a:rPr kumimoji="1" lang="en-US" altLang="ja-JP" sz="1800" b="0" i="0" u="none" strike="noStrike" baseline="0" dirty="0">
                <a:latin typeface="MyriadPro-Regular"/>
              </a:rPr>
              <a:t>1</a:t>
            </a:r>
            <a:r>
              <a:rPr kumimoji="1" lang="ja-JP" altLang="en-US" sz="1800" b="0" i="0" u="none" strike="noStrike" baseline="0" dirty="0">
                <a:latin typeface="MyriadPro-Regular"/>
              </a:rPr>
              <a:t>～</a:t>
            </a:r>
            <a:r>
              <a:rPr kumimoji="1" lang="en-US" altLang="ja-JP" sz="1800" b="0" i="0" u="none" strike="noStrike" baseline="0" dirty="0">
                <a:latin typeface="MyriadPro-Regular"/>
              </a:rPr>
              <a:t>6</a:t>
            </a:r>
            <a:r>
              <a:rPr kumimoji="1" lang="ja-JP" altLang="en-US" sz="1800" b="0" i="0" u="none" strike="noStrike" baseline="0" dirty="0">
                <a:latin typeface="MyriadPro-Regular"/>
              </a:rPr>
              <a:t>か所加えて</a:t>
            </a:r>
            <a:r>
              <a:rPr kumimoji="1" lang="en-US" altLang="ja-JP" sz="1800" b="0" i="0" u="none" strike="noStrike" baseline="0" dirty="0">
                <a:latin typeface="MyriadPro-Regular"/>
              </a:rPr>
              <a:t>WT</a:t>
            </a:r>
            <a:r>
              <a:rPr kumimoji="1" lang="ja-JP" altLang="en-US" sz="1800" b="0" i="0" u="none" strike="noStrike" baseline="0" dirty="0">
                <a:latin typeface="MyriadPro-Regular"/>
              </a:rPr>
              <a:t>を改変したウイルス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49DDAAF-73A2-4231-A793-26D334EB465D}" type="slidenum">
              <a:rPr kumimoji="1" lang="ja-JP" altLang="en-US" sz="13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1" lang="ja-JP" altLang="en-US" sz="13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0139887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 and 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720000" y="593367"/>
            <a:ext cx="7704000" cy="763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1pPr>
            <a:lvl2pPr lvl="1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720000" y="2277700"/>
            <a:ext cx="7704000" cy="35920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0480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"/>
              <a:buFont typeface="Nunito Light"/>
              <a:buChar char="●"/>
              <a:defRPr/>
            </a:lvl1pPr>
            <a:lvl2pPr marL="914400" lvl="1" indent="-30480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"/>
              <a:buFont typeface="Nunito Light"/>
              <a:buChar char="○"/>
              <a:defRPr/>
            </a:lvl2pPr>
            <a:lvl3pPr marL="1371600" lvl="2" indent="-30480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"/>
              <a:buFont typeface="Nunito Light"/>
              <a:buChar char="■"/>
              <a:defRPr/>
            </a:lvl3pPr>
            <a:lvl4pPr marL="1828800" lvl="3" indent="-30480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"/>
              <a:buFont typeface="Nunito Light"/>
              <a:buChar char="●"/>
              <a:defRPr/>
            </a:lvl4pPr>
            <a:lvl5pPr marL="2286000" lvl="4" indent="-30480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"/>
              <a:buFont typeface="Nunito Light"/>
              <a:buChar char="○"/>
              <a:defRPr/>
            </a:lvl5pPr>
            <a:lvl6pPr marL="2743200" lvl="5" indent="-30480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"/>
              <a:buFont typeface="Nunito Light"/>
              <a:buChar char="■"/>
              <a:defRPr/>
            </a:lvl6pPr>
            <a:lvl7pPr marL="3200400" lvl="6" indent="-30480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"/>
              <a:buFont typeface="Nunito Light"/>
              <a:buChar char="●"/>
              <a:defRPr/>
            </a:lvl7pPr>
            <a:lvl8pPr marL="3657600" lvl="7" indent="-30480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"/>
              <a:buFont typeface="Nunito Light"/>
              <a:buChar char="○"/>
              <a:defRPr/>
            </a:lvl8pPr>
            <a:lvl9pPr marL="4114800" lvl="8" indent="-30480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"/>
              <a:buFont typeface="Nunito Light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/>
          <p:nvPr/>
        </p:nvSpPr>
        <p:spPr>
          <a:xfrm>
            <a:off x="-25" y="6127167"/>
            <a:ext cx="9144017" cy="787955"/>
          </a:xfrm>
          <a:custGeom>
            <a:avLst/>
            <a:gdLst/>
            <a:ahLst/>
            <a:cxnLst/>
            <a:rect l="l" t="t" r="r" b="b"/>
            <a:pathLst>
              <a:path w="81572" h="31202" extrusionOk="0">
                <a:moveTo>
                  <a:pt x="0" y="0"/>
                </a:moveTo>
                <a:lnTo>
                  <a:pt x="0" y="31201"/>
                </a:lnTo>
                <a:lnTo>
                  <a:pt x="81572" y="31201"/>
                </a:lnTo>
                <a:lnTo>
                  <a:pt x="81572" y="0"/>
                </a:lnTo>
                <a:close/>
              </a:path>
            </a:pathLst>
          </a:custGeom>
          <a:solidFill>
            <a:schemeClr val="dk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/>
          </a:p>
        </p:txBody>
      </p:sp>
    </p:spTree>
    <p:extLst>
      <p:ext uri="{BB962C8B-B14F-4D97-AF65-F5344CB8AC3E}">
        <p14:creationId xmlns:p14="http://schemas.microsoft.com/office/powerpoint/2010/main" val="41424106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 2">
  <p:cSld name="Title only 2">
    <p:spTree>
      <p:nvGrpSpPr>
        <p:cNvPr id="1" name="Shape 2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7" name="Google Shape;217;p14"/>
          <p:cNvSpPr txBox="1">
            <a:spLocks noGrp="1"/>
          </p:cNvSpPr>
          <p:nvPr>
            <p:ph type="title"/>
          </p:nvPr>
        </p:nvSpPr>
        <p:spPr>
          <a:xfrm>
            <a:off x="720000" y="593367"/>
            <a:ext cx="7704000" cy="763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1pPr>
            <a:lvl2pPr lvl="1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9pPr>
          </a:lstStyle>
          <a:p>
            <a:endParaRPr/>
          </a:p>
        </p:txBody>
      </p:sp>
      <p:sp>
        <p:nvSpPr>
          <p:cNvPr id="218" name="Google Shape;218;p14"/>
          <p:cNvSpPr/>
          <p:nvPr/>
        </p:nvSpPr>
        <p:spPr>
          <a:xfrm>
            <a:off x="-25" y="6127167"/>
            <a:ext cx="9144017" cy="787955"/>
          </a:xfrm>
          <a:custGeom>
            <a:avLst/>
            <a:gdLst/>
            <a:ahLst/>
            <a:cxnLst/>
            <a:rect l="l" t="t" r="r" b="b"/>
            <a:pathLst>
              <a:path w="81572" h="31202" extrusionOk="0">
                <a:moveTo>
                  <a:pt x="0" y="0"/>
                </a:moveTo>
                <a:lnTo>
                  <a:pt x="0" y="31201"/>
                </a:lnTo>
                <a:lnTo>
                  <a:pt x="81572" y="31201"/>
                </a:lnTo>
                <a:lnTo>
                  <a:pt x="81572" y="0"/>
                </a:lnTo>
                <a:close/>
              </a:path>
            </a:pathLst>
          </a:custGeom>
          <a:solidFill>
            <a:schemeClr val="dk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/>
          </a:p>
        </p:txBody>
      </p:sp>
      <p:grpSp>
        <p:nvGrpSpPr>
          <p:cNvPr id="219" name="Google Shape;219;p14"/>
          <p:cNvGrpSpPr/>
          <p:nvPr/>
        </p:nvGrpSpPr>
        <p:grpSpPr>
          <a:xfrm>
            <a:off x="-450521" y="3001303"/>
            <a:ext cx="10129256" cy="4029603"/>
            <a:chOff x="-450521" y="2250977"/>
            <a:chExt cx="10129256" cy="3022202"/>
          </a:xfrm>
        </p:grpSpPr>
        <p:sp>
          <p:nvSpPr>
            <p:cNvPr id="220" name="Google Shape;220;p14"/>
            <p:cNvSpPr/>
            <p:nvPr/>
          </p:nvSpPr>
          <p:spPr>
            <a:xfrm flipH="1">
              <a:off x="-450521" y="4811475"/>
              <a:ext cx="1627556" cy="461704"/>
            </a:xfrm>
            <a:custGeom>
              <a:avLst/>
              <a:gdLst/>
              <a:ahLst/>
              <a:cxnLst/>
              <a:rect l="l" t="t" r="r" b="b"/>
              <a:pathLst>
                <a:path w="64014" h="9771" extrusionOk="0">
                  <a:moveTo>
                    <a:pt x="31876" y="1"/>
                  </a:moveTo>
                  <a:cubicBezTo>
                    <a:pt x="14187" y="1"/>
                    <a:pt x="1" y="2155"/>
                    <a:pt x="1" y="4875"/>
                  </a:cubicBezTo>
                  <a:cubicBezTo>
                    <a:pt x="1" y="7573"/>
                    <a:pt x="14339" y="9770"/>
                    <a:pt x="32007" y="9770"/>
                  </a:cubicBezTo>
                  <a:cubicBezTo>
                    <a:pt x="49674" y="9770"/>
                    <a:pt x="64013" y="7573"/>
                    <a:pt x="64013" y="4875"/>
                  </a:cubicBezTo>
                  <a:cubicBezTo>
                    <a:pt x="64013" y="2155"/>
                    <a:pt x="49544" y="1"/>
                    <a:pt x="31876" y="1"/>
                  </a:cubicBezTo>
                  <a:close/>
                </a:path>
              </a:pathLst>
            </a:custGeom>
            <a:solidFill>
              <a:srgbClr val="191919">
                <a:alpha val="17610"/>
              </a:srgb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grpSp>
          <p:nvGrpSpPr>
            <p:cNvPr id="221" name="Google Shape;221;p14"/>
            <p:cNvGrpSpPr/>
            <p:nvPr/>
          </p:nvGrpSpPr>
          <p:grpSpPr>
            <a:xfrm>
              <a:off x="-305475" y="3108100"/>
              <a:ext cx="800061" cy="1894999"/>
              <a:chOff x="7131700" y="3058575"/>
              <a:chExt cx="800061" cy="1894999"/>
            </a:xfrm>
          </p:grpSpPr>
          <p:sp>
            <p:nvSpPr>
              <p:cNvPr id="222" name="Google Shape;222;p14"/>
              <p:cNvSpPr/>
              <p:nvPr/>
            </p:nvSpPr>
            <p:spPr>
              <a:xfrm>
                <a:off x="7385008" y="3940203"/>
                <a:ext cx="101721" cy="80042"/>
              </a:xfrm>
              <a:custGeom>
                <a:avLst/>
                <a:gdLst/>
                <a:ahLst/>
                <a:cxnLst/>
                <a:rect l="l" t="t" r="r" b="b"/>
                <a:pathLst>
                  <a:path w="1328" h="1045" extrusionOk="0">
                    <a:moveTo>
                      <a:pt x="0" y="0"/>
                    </a:moveTo>
                    <a:lnTo>
                      <a:pt x="0" y="1045"/>
                    </a:lnTo>
                    <a:lnTo>
                      <a:pt x="1328" y="1045"/>
                    </a:lnTo>
                    <a:lnTo>
                      <a:pt x="1328" y="0"/>
                    </a:lnTo>
                    <a:close/>
                  </a:path>
                </a:pathLst>
              </a:custGeom>
              <a:solidFill>
                <a:schemeClr val="accen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23" name="Google Shape;223;p14"/>
              <p:cNvSpPr/>
              <p:nvPr/>
            </p:nvSpPr>
            <p:spPr>
              <a:xfrm>
                <a:off x="7495003" y="4095158"/>
                <a:ext cx="101721" cy="716699"/>
              </a:xfrm>
              <a:custGeom>
                <a:avLst/>
                <a:gdLst/>
                <a:ahLst/>
                <a:cxnLst/>
                <a:rect l="l" t="t" r="r" b="b"/>
                <a:pathLst>
                  <a:path w="1328" h="9357" extrusionOk="0">
                    <a:moveTo>
                      <a:pt x="0" y="1"/>
                    </a:moveTo>
                    <a:lnTo>
                      <a:pt x="0" y="9357"/>
                    </a:lnTo>
                    <a:lnTo>
                      <a:pt x="1328" y="9357"/>
                    </a:lnTo>
                    <a:lnTo>
                      <a:pt x="1328" y="1"/>
                    </a:lnTo>
                    <a:close/>
                  </a:path>
                </a:pathLst>
              </a:custGeom>
              <a:solidFill>
                <a:schemeClr val="accen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24" name="Google Shape;224;p14"/>
              <p:cNvSpPr/>
              <p:nvPr/>
            </p:nvSpPr>
            <p:spPr>
              <a:xfrm>
                <a:off x="7746626" y="4835158"/>
                <a:ext cx="116735" cy="118416"/>
              </a:xfrm>
              <a:custGeom>
                <a:avLst/>
                <a:gdLst/>
                <a:ahLst/>
                <a:cxnLst/>
                <a:rect l="l" t="t" r="r" b="b"/>
                <a:pathLst>
                  <a:path w="1524" h="1546" extrusionOk="0">
                    <a:moveTo>
                      <a:pt x="762" y="1"/>
                    </a:moveTo>
                    <a:cubicBezTo>
                      <a:pt x="327" y="1"/>
                      <a:pt x="1" y="349"/>
                      <a:pt x="1" y="784"/>
                    </a:cubicBezTo>
                    <a:cubicBezTo>
                      <a:pt x="1" y="1197"/>
                      <a:pt x="327" y="1545"/>
                      <a:pt x="762" y="1545"/>
                    </a:cubicBezTo>
                    <a:cubicBezTo>
                      <a:pt x="1176" y="1545"/>
                      <a:pt x="1524" y="1197"/>
                      <a:pt x="1524" y="784"/>
                    </a:cubicBezTo>
                    <a:cubicBezTo>
                      <a:pt x="1524" y="349"/>
                      <a:pt x="1176" y="1"/>
                      <a:pt x="762" y="1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25" name="Google Shape;225;p14"/>
              <p:cNvSpPr/>
              <p:nvPr/>
            </p:nvSpPr>
            <p:spPr>
              <a:xfrm>
                <a:off x="7215038" y="4835158"/>
                <a:ext cx="116735" cy="118416"/>
              </a:xfrm>
              <a:custGeom>
                <a:avLst/>
                <a:gdLst/>
                <a:ahLst/>
                <a:cxnLst/>
                <a:rect l="l" t="t" r="r" b="b"/>
                <a:pathLst>
                  <a:path w="1524" h="1546" extrusionOk="0">
                    <a:moveTo>
                      <a:pt x="762" y="1"/>
                    </a:moveTo>
                    <a:cubicBezTo>
                      <a:pt x="348" y="1"/>
                      <a:pt x="0" y="349"/>
                      <a:pt x="0" y="784"/>
                    </a:cubicBezTo>
                    <a:cubicBezTo>
                      <a:pt x="0" y="1197"/>
                      <a:pt x="348" y="1545"/>
                      <a:pt x="762" y="1545"/>
                    </a:cubicBezTo>
                    <a:cubicBezTo>
                      <a:pt x="1197" y="1545"/>
                      <a:pt x="1523" y="1197"/>
                      <a:pt x="1523" y="784"/>
                    </a:cubicBezTo>
                    <a:cubicBezTo>
                      <a:pt x="1523" y="349"/>
                      <a:pt x="1197" y="1"/>
                      <a:pt x="762" y="1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26" name="Google Shape;226;p14"/>
              <p:cNvSpPr/>
              <p:nvPr/>
            </p:nvSpPr>
            <p:spPr>
              <a:xfrm>
                <a:off x="7196655" y="4811796"/>
                <a:ext cx="698416" cy="48408"/>
              </a:xfrm>
              <a:custGeom>
                <a:avLst/>
                <a:gdLst/>
                <a:ahLst/>
                <a:cxnLst/>
                <a:rect l="l" t="t" r="r" b="b"/>
                <a:pathLst>
                  <a:path w="9118" h="632" extrusionOk="0">
                    <a:moveTo>
                      <a:pt x="632" y="1"/>
                    </a:moveTo>
                    <a:cubicBezTo>
                      <a:pt x="284" y="1"/>
                      <a:pt x="1" y="284"/>
                      <a:pt x="1" y="632"/>
                    </a:cubicBezTo>
                    <a:lnTo>
                      <a:pt x="9117" y="632"/>
                    </a:lnTo>
                    <a:cubicBezTo>
                      <a:pt x="9117" y="284"/>
                      <a:pt x="8834" y="1"/>
                      <a:pt x="8486" y="1"/>
                    </a:cubicBezTo>
                    <a:close/>
                  </a:path>
                </a:pathLst>
              </a:custGeom>
              <a:solidFill>
                <a:schemeClr val="accen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27" name="Google Shape;227;p14"/>
              <p:cNvSpPr/>
              <p:nvPr/>
            </p:nvSpPr>
            <p:spPr>
              <a:xfrm>
                <a:off x="7511624" y="4158503"/>
                <a:ext cx="25124" cy="653355"/>
              </a:xfrm>
              <a:custGeom>
                <a:avLst/>
                <a:gdLst/>
                <a:ahLst/>
                <a:cxnLst/>
                <a:rect l="l" t="t" r="r" b="b"/>
                <a:pathLst>
                  <a:path w="328" h="8530" extrusionOk="0">
                    <a:moveTo>
                      <a:pt x="1" y="1"/>
                    </a:moveTo>
                    <a:lnTo>
                      <a:pt x="1" y="8530"/>
                    </a:lnTo>
                    <a:lnTo>
                      <a:pt x="327" y="8530"/>
                    </a:lnTo>
                    <a:lnTo>
                      <a:pt x="327" y="1"/>
                    </a:lnTo>
                    <a:close/>
                  </a:path>
                </a:pathLst>
              </a:custGeom>
              <a:solidFill>
                <a:srgbClr val="191919">
                  <a:alpha val="1761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28" name="Google Shape;228;p14"/>
              <p:cNvSpPr/>
              <p:nvPr/>
            </p:nvSpPr>
            <p:spPr>
              <a:xfrm>
                <a:off x="7160041" y="4015191"/>
                <a:ext cx="771720" cy="145071"/>
              </a:xfrm>
              <a:custGeom>
                <a:avLst/>
                <a:gdLst/>
                <a:ahLst/>
                <a:cxnLst/>
                <a:rect l="l" t="t" r="r" b="b"/>
                <a:pathLst>
                  <a:path w="10075" h="1894" extrusionOk="0">
                    <a:moveTo>
                      <a:pt x="740" y="1"/>
                    </a:moveTo>
                    <a:cubicBezTo>
                      <a:pt x="326" y="1"/>
                      <a:pt x="0" y="327"/>
                      <a:pt x="0" y="740"/>
                    </a:cubicBezTo>
                    <a:lnTo>
                      <a:pt x="0" y="1154"/>
                    </a:lnTo>
                    <a:cubicBezTo>
                      <a:pt x="0" y="1567"/>
                      <a:pt x="326" y="1893"/>
                      <a:pt x="740" y="1893"/>
                    </a:cubicBezTo>
                    <a:lnTo>
                      <a:pt x="9334" y="1893"/>
                    </a:lnTo>
                    <a:cubicBezTo>
                      <a:pt x="9748" y="1893"/>
                      <a:pt x="10074" y="1567"/>
                      <a:pt x="10074" y="1154"/>
                    </a:cubicBezTo>
                    <a:lnTo>
                      <a:pt x="10074" y="740"/>
                    </a:lnTo>
                    <a:cubicBezTo>
                      <a:pt x="10074" y="327"/>
                      <a:pt x="9748" y="1"/>
                      <a:pt x="9334" y="1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29" name="Google Shape;229;p14"/>
              <p:cNvSpPr/>
              <p:nvPr/>
            </p:nvSpPr>
            <p:spPr>
              <a:xfrm>
                <a:off x="7131700" y="3058575"/>
                <a:ext cx="601673" cy="890034"/>
              </a:xfrm>
              <a:custGeom>
                <a:avLst/>
                <a:gdLst/>
                <a:ahLst/>
                <a:cxnLst/>
                <a:rect l="l" t="t" r="r" b="b"/>
                <a:pathLst>
                  <a:path w="7855" h="11620" extrusionOk="0">
                    <a:moveTo>
                      <a:pt x="3917" y="0"/>
                    </a:moveTo>
                    <a:cubicBezTo>
                      <a:pt x="1763" y="0"/>
                      <a:pt x="0" y="1785"/>
                      <a:pt x="0" y="3939"/>
                    </a:cubicBezTo>
                    <a:lnTo>
                      <a:pt x="0" y="9835"/>
                    </a:lnTo>
                    <a:cubicBezTo>
                      <a:pt x="0" y="10814"/>
                      <a:pt x="805" y="11619"/>
                      <a:pt x="1784" y="11619"/>
                    </a:cubicBezTo>
                    <a:lnTo>
                      <a:pt x="6071" y="11619"/>
                    </a:lnTo>
                    <a:cubicBezTo>
                      <a:pt x="7050" y="11619"/>
                      <a:pt x="7855" y="10814"/>
                      <a:pt x="7855" y="9835"/>
                    </a:cubicBezTo>
                    <a:lnTo>
                      <a:pt x="7855" y="3939"/>
                    </a:lnTo>
                    <a:cubicBezTo>
                      <a:pt x="7855" y="1785"/>
                      <a:pt x="6071" y="0"/>
                      <a:pt x="3917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30" name="Google Shape;230;p14"/>
              <p:cNvSpPr/>
              <p:nvPr/>
            </p:nvSpPr>
            <p:spPr>
              <a:xfrm>
                <a:off x="7238324" y="3111886"/>
                <a:ext cx="468394" cy="785022"/>
              </a:xfrm>
              <a:custGeom>
                <a:avLst/>
                <a:gdLst/>
                <a:ahLst/>
                <a:cxnLst/>
                <a:rect l="l" t="t" r="r" b="b"/>
                <a:pathLst>
                  <a:path w="6115" h="10249" extrusionOk="0">
                    <a:moveTo>
                      <a:pt x="3069" y="1"/>
                    </a:moveTo>
                    <a:cubicBezTo>
                      <a:pt x="1371" y="1"/>
                      <a:pt x="1" y="1371"/>
                      <a:pt x="1" y="3047"/>
                    </a:cubicBezTo>
                    <a:lnTo>
                      <a:pt x="1" y="8856"/>
                    </a:lnTo>
                    <a:cubicBezTo>
                      <a:pt x="1" y="9618"/>
                      <a:pt x="632" y="10249"/>
                      <a:pt x="1393" y="10249"/>
                    </a:cubicBezTo>
                    <a:lnTo>
                      <a:pt x="4722" y="10249"/>
                    </a:lnTo>
                    <a:cubicBezTo>
                      <a:pt x="5484" y="10249"/>
                      <a:pt x="6115" y="9618"/>
                      <a:pt x="6115" y="8856"/>
                    </a:cubicBezTo>
                    <a:lnTo>
                      <a:pt x="6115" y="3047"/>
                    </a:lnTo>
                    <a:cubicBezTo>
                      <a:pt x="6115" y="1371"/>
                      <a:pt x="4744" y="1"/>
                      <a:pt x="3069" y="1"/>
                    </a:cubicBezTo>
                    <a:close/>
                  </a:path>
                </a:pathLst>
              </a:custGeom>
              <a:solidFill>
                <a:srgbClr val="FFFFFF">
                  <a:alpha val="1824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</p:grpSp>
        <p:sp>
          <p:nvSpPr>
            <p:cNvPr id="231" name="Google Shape;231;p14"/>
            <p:cNvSpPr/>
            <p:nvPr/>
          </p:nvSpPr>
          <p:spPr>
            <a:xfrm>
              <a:off x="8051179" y="4811475"/>
              <a:ext cx="1627556" cy="461704"/>
            </a:xfrm>
            <a:custGeom>
              <a:avLst/>
              <a:gdLst/>
              <a:ahLst/>
              <a:cxnLst/>
              <a:rect l="l" t="t" r="r" b="b"/>
              <a:pathLst>
                <a:path w="64014" h="9771" extrusionOk="0">
                  <a:moveTo>
                    <a:pt x="31876" y="1"/>
                  </a:moveTo>
                  <a:cubicBezTo>
                    <a:pt x="14187" y="1"/>
                    <a:pt x="1" y="2155"/>
                    <a:pt x="1" y="4875"/>
                  </a:cubicBezTo>
                  <a:cubicBezTo>
                    <a:pt x="1" y="7573"/>
                    <a:pt x="14339" y="9770"/>
                    <a:pt x="32007" y="9770"/>
                  </a:cubicBezTo>
                  <a:cubicBezTo>
                    <a:pt x="49674" y="9770"/>
                    <a:pt x="64013" y="7573"/>
                    <a:pt x="64013" y="4875"/>
                  </a:cubicBezTo>
                  <a:cubicBezTo>
                    <a:pt x="64013" y="2155"/>
                    <a:pt x="49544" y="1"/>
                    <a:pt x="31876" y="1"/>
                  </a:cubicBezTo>
                  <a:close/>
                </a:path>
              </a:pathLst>
            </a:custGeom>
            <a:solidFill>
              <a:srgbClr val="191919">
                <a:alpha val="17610"/>
              </a:srgb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grpSp>
          <p:nvGrpSpPr>
            <p:cNvPr id="232" name="Google Shape;232;p14"/>
            <p:cNvGrpSpPr/>
            <p:nvPr/>
          </p:nvGrpSpPr>
          <p:grpSpPr>
            <a:xfrm>
              <a:off x="8430825" y="2250977"/>
              <a:ext cx="868271" cy="2892522"/>
              <a:chOff x="-1434450" y="2250977"/>
              <a:chExt cx="868271" cy="2892522"/>
            </a:xfrm>
          </p:grpSpPr>
          <p:sp>
            <p:nvSpPr>
              <p:cNvPr id="233" name="Google Shape;233;p14"/>
              <p:cNvSpPr/>
              <p:nvPr/>
            </p:nvSpPr>
            <p:spPr>
              <a:xfrm>
                <a:off x="-1301572" y="2770032"/>
                <a:ext cx="359138" cy="275989"/>
              </a:xfrm>
              <a:custGeom>
                <a:avLst/>
                <a:gdLst/>
                <a:ahLst/>
                <a:cxnLst/>
                <a:rect l="l" t="t" r="r" b="b"/>
                <a:pathLst>
                  <a:path w="4527" h="3479" extrusionOk="0">
                    <a:moveTo>
                      <a:pt x="4178" y="0"/>
                    </a:moveTo>
                    <a:cubicBezTo>
                      <a:pt x="4178" y="0"/>
                      <a:pt x="2046" y="1001"/>
                      <a:pt x="1023" y="1654"/>
                    </a:cubicBezTo>
                    <a:cubicBezTo>
                      <a:pt x="23" y="2329"/>
                      <a:pt x="1" y="2742"/>
                      <a:pt x="218" y="3112"/>
                    </a:cubicBezTo>
                    <a:cubicBezTo>
                      <a:pt x="375" y="3377"/>
                      <a:pt x="593" y="3479"/>
                      <a:pt x="839" y="3479"/>
                    </a:cubicBezTo>
                    <a:cubicBezTo>
                      <a:pt x="1480" y="3479"/>
                      <a:pt x="2305" y="2786"/>
                      <a:pt x="2699" y="2503"/>
                    </a:cubicBezTo>
                    <a:cubicBezTo>
                      <a:pt x="3243" y="2133"/>
                      <a:pt x="4527" y="610"/>
                      <a:pt x="4527" y="610"/>
                    </a:cubicBezTo>
                    <a:lnTo>
                      <a:pt x="4178" y="0"/>
                    </a:lnTo>
                    <a:close/>
                  </a:path>
                </a:pathLst>
              </a:custGeom>
              <a:solidFill>
                <a:srgbClr val="3183B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34" name="Google Shape;234;p14"/>
              <p:cNvSpPr/>
              <p:nvPr/>
            </p:nvSpPr>
            <p:spPr>
              <a:xfrm>
                <a:off x="-1325689" y="2782090"/>
                <a:ext cx="367706" cy="285350"/>
              </a:xfrm>
              <a:custGeom>
                <a:avLst/>
                <a:gdLst/>
                <a:ahLst/>
                <a:cxnLst/>
                <a:rect l="l" t="t" r="r" b="b"/>
                <a:pathLst>
                  <a:path w="4635" h="3597" extrusionOk="0">
                    <a:moveTo>
                      <a:pt x="3873" y="1"/>
                    </a:moveTo>
                    <a:cubicBezTo>
                      <a:pt x="3873" y="1"/>
                      <a:pt x="2002" y="893"/>
                      <a:pt x="1001" y="1546"/>
                    </a:cubicBezTo>
                    <a:cubicBezTo>
                      <a:pt x="0" y="2177"/>
                      <a:pt x="44" y="2851"/>
                      <a:pt x="261" y="3221"/>
                    </a:cubicBezTo>
                    <a:cubicBezTo>
                      <a:pt x="416" y="3493"/>
                      <a:pt x="636" y="3596"/>
                      <a:pt x="883" y="3596"/>
                    </a:cubicBezTo>
                    <a:cubicBezTo>
                      <a:pt x="1506" y="3596"/>
                      <a:pt x="2303" y="2942"/>
                      <a:pt x="2676" y="2677"/>
                    </a:cubicBezTo>
                    <a:cubicBezTo>
                      <a:pt x="3220" y="2307"/>
                      <a:pt x="4635" y="1284"/>
                      <a:pt x="4635" y="1284"/>
                    </a:cubicBezTo>
                    <a:lnTo>
                      <a:pt x="3873" y="1"/>
                    </a:lnTo>
                    <a:close/>
                  </a:path>
                </a:pathLst>
              </a:custGeom>
              <a:solidFill>
                <a:srgbClr val="3183B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35" name="Google Shape;235;p14"/>
              <p:cNvSpPr/>
              <p:nvPr/>
            </p:nvSpPr>
            <p:spPr>
              <a:xfrm>
                <a:off x="-987426" y="2766303"/>
                <a:ext cx="129550" cy="74967"/>
              </a:xfrm>
              <a:custGeom>
                <a:avLst/>
                <a:gdLst/>
                <a:ahLst/>
                <a:cxnLst/>
                <a:rect l="l" t="t" r="r" b="b"/>
                <a:pathLst>
                  <a:path w="1633" h="945" extrusionOk="0">
                    <a:moveTo>
                      <a:pt x="562" y="0"/>
                    </a:moveTo>
                    <a:cubicBezTo>
                      <a:pt x="289" y="0"/>
                      <a:pt x="1" y="156"/>
                      <a:pt x="1" y="156"/>
                    </a:cubicBezTo>
                    <a:lnTo>
                      <a:pt x="284" y="809"/>
                    </a:lnTo>
                    <a:cubicBezTo>
                      <a:pt x="284" y="809"/>
                      <a:pt x="1067" y="918"/>
                      <a:pt x="1176" y="939"/>
                    </a:cubicBezTo>
                    <a:cubicBezTo>
                      <a:pt x="1184" y="943"/>
                      <a:pt x="1194" y="944"/>
                      <a:pt x="1205" y="944"/>
                    </a:cubicBezTo>
                    <a:cubicBezTo>
                      <a:pt x="1336" y="944"/>
                      <a:pt x="1633" y="722"/>
                      <a:pt x="1633" y="722"/>
                    </a:cubicBezTo>
                    <a:cubicBezTo>
                      <a:pt x="1633" y="722"/>
                      <a:pt x="1132" y="265"/>
                      <a:pt x="828" y="69"/>
                    </a:cubicBezTo>
                    <a:cubicBezTo>
                      <a:pt x="749" y="19"/>
                      <a:pt x="657" y="0"/>
                      <a:pt x="562" y="0"/>
                    </a:cubicBezTo>
                    <a:close/>
                  </a:path>
                </a:pathLst>
              </a:custGeom>
              <a:solidFill>
                <a:srgbClr val="3183B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36" name="Google Shape;236;p14"/>
              <p:cNvSpPr/>
              <p:nvPr/>
            </p:nvSpPr>
            <p:spPr>
              <a:xfrm>
                <a:off x="-964975" y="2742425"/>
                <a:ext cx="100197" cy="55610"/>
              </a:xfrm>
              <a:custGeom>
                <a:avLst/>
                <a:gdLst/>
                <a:ahLst/>
                <a:cxnLst/>
                <a:rect l="l" t="t" r="r" b="b"/>
                <a:pathLst>
                  <a:path w="1263" h="701" extrusionOk="0">
                    <a:moveTo>
                      <a:pt x="1219" y="0"/>
                    </a:moveTo>
                    <a:cubicBezTo>
                      <a:pt x="1176" y="0"/>
                      <a:pt x="849" y="196"/>
                      <a:pt x="740" y="196"/>
                    </a:cubicBezTo>
                    <a:cubicBezTo>
                      <a:pt x="109" y="240"/>
                      <a:pt x="1" y="392"/>
                      <a:pt x="1" y="392"/>
                    </a:cubicBezTo>
                    <a:cubicBezTo>
                      <a:pt x="1" y="392"/>
                      <a:pt x="348" y="700"/>
                      <a:pt x="588" y="700"/>
                    </a:cubicBezTo>
                    <a:cubicBezTo>
                      <a:pt x="603" y="700"/>
                      <a:pt x="618" y="699"/>
                      <a:pt x="632" y="697"/>
                    </a:cubicBezTo>
                    <a:cubicBezTo>
                      <a:pt x="849" y="653"/>
                      <a:pt x="871" y="566"/>
                      <a:pt x="914" y="479"/>
                    </a:cubicBezTo>
                    <a:cubicBezTo>
                      <a:pt x="958" y="392"/>
                      <a:pt x="1045" y="370"/>
                      <a:pt x="1154" y="261"/>
                    </a:cubicBezTo>
                    <a:cubicBezTo>
                      <a:pt x="1241" y="174"/>
                      <a:pt x="1263" y="0"/>
                      <a:pt x="1219" y="0"/>
                    </a:cubicBezTo>
                    <a:close/>
                  </a:path>
                </a:pathLst>
              </a:custGeom>
              <a:solidFill>
                <a:srgbClr val="3183B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37" name="Google Shape;237;p14"/>
              <p:cNvSpPr/>
              <p:nvPr/>
            </p:nvSpPr>
            <p:spPr>
              <a:xfrm>
                <a:off x="-933878" y="2795655"/>
                <a:ext cx="157158" cy="55055"/>
              </a:xfrm>
              <a:custGeom>
                <a:avLst/>
                <a:gdLst/>
                <a:ahLst/>
                <a:cxnLst/>
                <a:rect l="l" t="t" r="r" b="b"/>
                <a:pathLst>
                  <a:path w="1981" h="694" extrusionOk="0">
                    <a:moveTo>
                      <a:pt x="1867" y="1"/>
                    </a:moveTo>
                    <a:cubicBezTo>
                      <a:pt x="1811" y="1"/>
                      <a:pt x="1736" y="21"/>
                      <a:pt x="1654" y="91"/>
                    </a:cubicBezTo>
                    <a:cubicBezTo>
                      <a:pt x="1522" y="185"/>
                      <a:pt x="1358" y="295"/>
                      <a:pt x="1344" y="295"/>
                    </a:cubicBezTo>
                    <a:cubicBezTo>
                      <a:pt x="1342" y="295"/>
                      <a:pt x="1343" y="293"/>
                      <a:pt x="1349" y="287"/>
                    </a:cubicBezTo>
                    <a:lnTo>
                      <a:pt x="1349" y="287"/>
                    </a:lnTo>
                    <a:cubicBezTo>
                      <a:pt x="1284" y="308"/>
                      <a:pt x="1219" y="352"/>
                      <a:pt x="1153" y="352"/>
                    </a:cubicBezTo>
                    <a:cubicBezTo>
                      <a:pt x="1001" y="330"/>
                      <a:pt x="675" y="113"/>
                      <a:pt x="675" y="113"/>
                    </a:cubicBezTo>
                    <a:cubicBezTo>
                      <a:pt x="675" y="113"/>
                      <a:pt x="675" y="91"/>
                      <a:pt x="653" y="91"/>
                    </a:cubicBezTo>
                    <a:cubicBezTo>
                      <a:pt x="615" y="166"/>
                      <a:pt x="561" y="226"/>
                      <a:pt x="505" y="226"/>
                    </a:cubicBezTo>
                    <a:cubicBezTo>
                      <a:pt x="496" y="226"/>
                      <a:pt x="488" y="224"/>
                      <a:pt x="479" y="221"/>
                    </a:cubicBezTo>
                    <a:cubicBezTo>
                      <a:pt x="461" y="210"/>
                      <a:pt x="424" y="203"/>
                      <a:pt x="378" y="203"/>
                    </a:cubicBezTo>
                    <a:cubicBezTo>
                      <a:pt x="254" y="203"/>
                      <a:pt x="64" y="253"/>
                      <a:pt x="0" y="395"/>
                    </a:cubicBezTo>
                    <a:cubicBezTo>
                      <a:pt x="0" y="395"/>
                      <a:pt x="218" y="526"/>
                      <a:pt x="522" y="591"/>
                    </a:cubicBezTo>
                    <a:cubicBezTo>
                      <a:pt x="566" y="591"/>
                      <a:pt x="610" y="613"/>
                      <a:pt x="653" y="635"/>
                    </a:cubicBezTo>
                    <a:lnTo>
                      <a:pt x="762" y="635"/>
                    </a:lnTo>
                    <a:cubicBezTo>
                      <a:pt x="784" y="635"/>
                      <a:pt x="805" y="657"/>
                      <a:pt x="827" y="657"/>
                    </a:cubicBezTo>
                    <a:cubicBezTo>
                      <a:pt x="842" y="657"/>
                      <a:pt x="866" y="647"/>
                      <a:pt x="893" y="647"/>
                    </a:cubicBezTo>
                    <a:cubicBezTo>
                      <a:pt x="907" y="647"/>
                      <a:pt x="921" y="649"/>
                      <a:pt x="936" y="657"/>
                    </a:cubicBezTo>
                    <a:cubicBezTo>
                      <a:pt x="958" y="657"/>
                      <a:pt x="1001" y="678"/>
                      <a:pt x="1023" y="678"/>
                    </a:cubicBezTo>
                    <a:cubicBezTo>
                      <a:pt x="1045" y="689"/>
                      <a:pt x="1062" y="693"/>
                      <a:pt x="1077" y="693"/>
                    </a:cubicBezTo>
                    <a:cubicBezTo>
                      <a:pt x="1121" y="693"/>
                      <a:pt x="1137" y="657"/>
                      <a:pt x="1153" y="657"/>
                    </a:cubicBezTo>
                    <a:cubicBezTo>
                      <a:pt x="1241" y="678"/>
                      <a:pt x="1284" y="678"/>
                      <a:pt x="1306" y="678"/>
                    </a:cubicBezTo>
                    <a:cubicBezTo>
                      <a:pt x="1371" y="657"/>
                      <a:pt x="1676" y="417"/>
                      <a:pt x="1697" y="374"/>
                    </a:cubicBezTo>
                    <a:cubicBezTo>
                      <a:pt x="1741" y="308"/>
                      <a:pt x="1980" y="69"/>
                      <a:pt x="1959" y="26"/>
                    </a:cubicBezTo>
                    <a:cubicBezTo>
                      <a:pt x="1948" y="15"/>
                      <a:pt x="1915" y="1"/>
                      <a:pt x="1867" y="1"/>
                    </a:cubicBezTo>
                    <a:close/>
                  </a:path>
                </a:pathLst>
              </a:custGeom>
              <a:solidFill>
                <a:srgbClr val="3183B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38" name="Google Shape;238;p14"/>
              <p:cNvSpPr/>
              <p:nvPr/>
            </p:nvSpPr>
            <p:spPr>
              <a:xfrm>
                <a:off x="-882075" y="2783835"/>
                <a:ext cx="65608" cy="39744"/>
              </a:xfrm>
              <a:custGeom>
                <a:avLst/>
                <a:gdLst/>
                <a:ahLst/>
                <a:cxnLst/>
                <a:rect l="l" t="t" r="r" b="b"/>
                <a:pathLst>
                  <a:path w="827" h="501" extrusionOk="0">
                    <a:moveTo>
                      <a:pt x="718" y="0"/>
                    </a:moveTo>
                    <a:cubicBezTo>
                      <a:pt x="675" y="0"/>
                      <a:pt x="544" y="131"/>
                      <a:pt x="544" y="131"/>
                    </a:cubicBezTo>
                    <a:cubicBezTo>
                      <a:pt x="544" y="131"/>
                      <a:pt x="500" y="22"/>
                      <a:pt x="479" y="22"/>
                    </a:cubicBezTo>
                    <a:cubicBezTo>
                      <a:pt x="472" y="21"/>
                      <a:pt x="466" y="20"/>
                      <a:pt x="459" y="20"/>
                    </a:cubicBezTo>
                    <a:cubicBezTo>
                      <a:pt x="382" y="20"/>
                      <a:pt x="323" y="133"/>
                      <a:pt x="283" y="153"/>
                    </a:cubicBezTo>
                    <a:cubicBezTo>
                      <a:pt x="280" y="158"/>
                      <a:pt x="278" y="161"/>
                      <a:pt x="276" y="161"/>
                    </a:cubicBezTo>
                    <a:cubicBezTo>
                      <a:pt x="260" y="161"/>
                      <a:pt x="256" y="44"/>
                      <a:pt x="218" y="44"/>
                    </a:cubicBezTo>
                    <a:cubicBezTo>
                      <a:pt x="131" y="44"/>
                      <a:pt x="65" y="153"/>
                      <a:pt x="0" y="240"/>
                    </a:cubicBezTo>
                    <a:cubicBezTo>
                      <a:pt x="22" y="240"/>
                      <a:pt x="22" y="262"/>
                      <a:pt x="22" y="262"/>
                    </a:cubicBezTo>
                    <a:cubicBezTo>
                      <a:pt x="22" y="262"/>
                      <a:pt x="348" y="479"/>
                      <a:pt x="500" y="501"/>
                    </a:cubicBezTo>
                    <a:cubicBezTo>
                      <a:pt x="566" y="501"/>
                      <a:pt x="631" y="457"/>
                      <a:pt x="696" y="436"/>
                    </a:cubicBezTo>
                    <a:cubicBezTo>
                      <a:pt x="718" y="414"/>
                      <a:pt x="805" y="196"/>
                      <a:pt x="805" y="87"/>
                    </a:cubicBezTo>
                    <a:cubicBezTo>
                      <a:pt x="827" y="22"/>
                      <a:pt x="762" y="0"/>
                      <a:pt x="718" y="0"/>
                    </a:cubicBezTo>
                    <a:close/>
                  </a:path>
                </a:pathLst>
              </a:custGeom>
              <a:solidFill>
                <a:srgbClr val="3183B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39" name="Google Shape;239;p14"/>
              <p:cNvSpPr/>
              <p:nvPr/>
            </p:nvSpPr>
            <p:spPr>
              <a:xfrm>
                <a:off x="-973622" y="2275252"/>
                <a:ext cx="184765" cy="339612"/>
              </a:xfrm>
              <a:custGeom>
                <a:avLst/>
                <a:gdLst/>
                <a:ahLst/>
                <a:cxnLst/>
                <a:rect l="l" t="t" r="r" b="b"/>
                <a:pathLst>
                  <a:path w="2329" h="4281" extrusionOk="0">
                    <a:moveTo>
                      <a:pt x="1216" y="0"/>
                    </a:moveTo>
                    <a:cubicBezTo>
                      <a:pt x="753" y="0"/>
                      <a:pt x="393" y="515"/>
                      <a:pt x="393" y="515"/>
                    </a:cubicBezTo>
                    <a:lnTo>
                      <a:pt x="305" y="1821"/>
                    </a:lnTo>
                    <a:cubicBezTo>
                      <a:pt x="305" y="1821"/>
                      <a:pt x="480" y="2408"/>
                      <a:pt x="240" y="3170"/>
                    </a:cubicBezTo>
                    <a:cubicBezTo>
                      <a:pt x="1" y="3931"/>
                      <a:pt x="675" y="4236"/>
                      <a:pt x="915" y="4279"/>
                    </a:cubicBezTo>
                    <a:cubicBezTo>
                      <a:pt x="925" y="4280"/>
                      <a:pt x="935" y="4281"/>
                      <a:pt x="945" y="4281"/>
                    </a:cubicBezTo>
                    <a:cubicBezTo>
                      <a:pt x="1165" y="4281"/>
                      <a:pt x="1281" y="4060"/>
                      <a:pt x="1198" y="4018"/>
                    </a:cubicBezTo>
                    <a:cubicBezTo>
                      <a:pt x="1089" y="3996"/>
                      <a:pt x="1633" y="2473"/>
                      <a:pt x="1959" y="2125"/>
                    </a:cubicBezTo>
                    <a:cubicBezTo>
                      <a:pt x="2285" y="1777"/>
                      <a:pt x="2329" y="667"/>
                      <a:pt x="1654" y="167"/>
                    </a:cubicBezTo>
                    <a:cubicBezTo>
                      <a:pt x="1504" y="46"/>
                      <a:pt x="1356" y="0"/>
                      <a:pt x="1216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40" name="Google Shape;240;p14"/>
              <p:cNvSpPr/>
              <p:nvPr/>
            </p:nvSpPr>
            <p:spPr>
              <a:xfrm>
                <a:off x="-1220418" y="4837604"/>
                <a:ext cx="260687" cy="252587"/>
              </a:xfrm>
              <a:custGeom>
                <a:avLst/>
                <a:gdLst/>
                <a:ahLst/>
                <a:cxnLst/>
                <a:rect l="l" t="t" r="r" b="b"/>
                <a:pathLst>
                  <a:path w="3286" h="3184" extrusionOk="0">
                    <a:moveTo>
                      <a:pt x="2838" y="0"/>
                    </a:moveTo>
                    <a:cubicBezTo>
                      <a:pt x="2714" y="0"/>
                      <a:pt x="1763" y="330"/>
                      <a:pt x="1763" y="330"/>
                    </a:cubicBezTo>
                    <a:cubicBezTo>
                      <a:pt x="1763" y="330"/>
                      <a:pt x="1676" y="983"/>
                      <a:pt x="697" y="2375"/>
                    </a:cubicBezTo>
                    <a:cubicBezTo>
                      <a:pt x="697" y="2375"/>
                      <a:pt x="0" y="2941"/>
                      <a:pt x="66" y="3071"/>
                    </a:cubicBezTo>
                    <a:cubicBezTo>
                      <a:pt x="88" y="3151"/>
                      <a:pt x="290" y="3183"/>
                      <a:pt x="517" y="3183"/>
                    </a:cubicBezTo>
                    <a:cubicBezTo>
                      <a:pt x="724" y="3183"/>
                      <a:pt x="953" y="3157"/>
                      <a:pt x="1088" y="3115"/>
                    </a:cubicBezTo>
                    <a:cubicBezTo>
                      <a:pt x="1393" y="3028"/>
                      <a:pt x="1872" y="2179"/>
                      <a:pt x="2220" y="1940"/>
                    </a:cubicBezTo>
                    <a:cubicBezTo>
                      <a:pt x="2568" y="1701"/>
                      <a:pt x="2916" y="1788"/>
                      <a:pt x="3177" y="1483"/>
                    </a:cubicBezTo>
                    <a:cubicBezTo>
                      <a:pt x="3286" y="1374"/>
                      <a:pt x="3286" y="1004"/>
                      <a:pt x="3155" y="787"/>
                    </a:cubicBezTo>
                    <a:cubicBezTo>
                      <a:pt x="3047" y="613"/>
                      <a:pt x="2894" y="373"/>
                      <a:pt x="2851" y="4"/>
                    </a:cubicBezTo>
                    <a:cubicBezTo>
                      <a:pt x="2850" y="1"/>
                      <a:pt x="2845" y="0"/>
                      <a:pt x="2838" y="0"/>
                    </a:cubicBezTo>
                    <a:close/>
                  </a:path>
                </a:pathLst>
              </a:custGeom>
              <a:solidFill>
                <a:srgbClr val="C09378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41" name="Google Shape;241;p14"/>
              <p:cNvSpPr/>
              <p:nvPr/>
            </p:nvSpPr>
            <p:spPr>
              <a:xfrm>
                <a:off x="-1232476" y="4875841"/>
                <a:ext cx="276236" cy="225377"/>
              </a:xfrm>
              <a:custGeom>
                <a:avLst/>
                <a:gdLst/>
                <a:ahLst/>
                <a:cxnLst/>
                <a:rect l="l" t="t" r="r" b="b"/>
                <a:pathLst>
                  <a:path w="3482" h="2841" extrusionOk="0">
                    <a:moveTo>
                      <a:pt x="3133" y="0"/>
                    </a:moveTo>
                    <a:cubicBezTo>
                      <a:pt x="3133" y="0"/>
                      <a:pt x="3133" y="283"/>
                      <a:pt x="2937" y="566"/>
                    </a:cubicBezTo>
                    <a:cubicBezTo>
                      <a:pt x="2763" y="827"/>
                      <a:pt x="1828" y="1676"/>
                      <a:pt x="1132" y="2111"/>
                    </a:cubicBezTo>
                    <a:cubicBezTo>
                      <a:pt x="1077" y="2138"/>
                      <a:pt x="934" y="2166"/>
                      <a:pt x="826" y="2166"/>
                    </a:cubicBezTo>
                    <a:cubicBezTo>
                      <a:pt x="764" y="2166"/>
                      <a:pt x="712" y="2157"/>
                      <a:pt x="696" y="2133"/>
                    </a:cubicBezTo>
                    <a:cubicBezTo>
                      <a:pt x="653" y="2067"/>
                      <a:pt x="849" y="1893"/>
                      <a:pt x="849" y="1893"/>
                    </a:cubicBezTo>
                    <a:lnTo>
                      <a:pt x="849" y="1893"/>
                    </a:lnTo>
                    <a:cubicBezTo>
                      <a:pt x="522" y="2133"/>
                      <a:pt x="0" y="2633"/>
                      <a:pt x="44" y="2742"/>
                    </a:cubicBezTo>
                    <a:cubicBezTo>
                      <a:pt x="64" y="2812"/>
                      <a:pt x="290" y="2840"/>
                      <a:pt x="556" y="2840"/>
                    </a:cubicBezTo>
                    <a:cubicBezTo>
                      <a:pt x="870" y="2840"/>
                      <a:pt x="1240" y="2801"/>
                      <a:pt x="1393" y="2742"/>
                    </a:cubicBezTo>
                    <a:cubicBezTo>
                      <a:pt x="1697" y="2655"/>
                      <a:pt x="2132" y="1828"/>
                      <a:pt x="2481" y="1589"/>
                    </a:cubicBezTo>
                    <a:cubicBezTo>
                      <a:pt x="2633" y="1480"/>
                      <a:pt x="3177" y="1175"/>
                      <a:pt x="3329" y="1001"/>
                    </a:cubicBezTo>
                    <a:cubicBezTo>
                      <a:pt x="3373" y="958"/>
                      <a:pt x="3438" y="784"/>
                      <a:pt x="3438" y="718"/>
                    </a:cubicBezTo>
                    <a:cubicBezTo>
                      <a:pt x="3481" y="414"/>
                      <a:pt x="3199" y="0"/>
                      <a:pt x="3133" y="0"/>
                    </a:cubicBez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42" name="Google Shape;242;p14"/>
              <p:cNvSpPr/>
              <p:nvPr/>
            </p:nvSpPr>
            <p:spPr>
              <a:xfrm>
                <a:off x="-1040894" y="4927643"/>
                <a:ext cx="81157" cy="136368"/>
              </a:xfrm>
              <a:custGeom>
                <a:avLst/>
                <a:gdLst/>
                <a:ahLst/>
                <a:cxnLst/>
                <a:rect l="l" t="t" r="r" b="b"/>
                <a:pathLst>
                  <a:path w="1023" h="1719" extrusionOk="0">
                    <a:moveTo>
                      <a:pt x="1023" y="0"/>
                    </a:moveTo>
                    <a:cubicBezTo>
                      <a:pt x="1023" y="0"/>
                      <a:pt x="1" y="944"/>
                      <a:pt x="49" y="944"/>
                    </a:cubicBezTo>
                    <a:cubicBezTo>
                      <a:pt x="52" y="944"/>
                      <a:pt x="57" y="941"/>
                      <a:pt x="66" y="936"/>
                    </a:cubicBezTo>
                    <a:cubicBezTo>
                      <a:pt x="155" y="875"/>
                      <a:pt x="229" y="849"/>
                      <a:pt x="291" y="849"/>
                    </a:cubicBezTo>
                    <a:cubicBezTo>
                      <a:pt x="645" y="849"/>
                      <a:pt x="566" y="1719"/>
                      <a:pt x="566" y="1719"/>
                    </a:cubicBezTo>
                    <a:lnTo>
                      <a:pt x="697" y="1719"/>
                    </a:lnTo>
                    <a:cubicBezTo>
                      <a:pt x="697" y="1719"/>
                      <a:pt x="718" y="1088"/>
                      <a:pt x="805" y="805"/>
                    </a:cubicBezTo>
                    <a:cubicBezTo>
                      <a:pt x="849" y="588"/>
                      <a:pt x="1023" y="0"/>
                      <a:pt x="1023" y="0"/>
                    </a:cubicBez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43" name="Google Shape;243;p14"/>
              <p:cNvSpPr/>
              <p:nvPr/>
            </p:nvSpPr>
            <p:spPr>
              <a:xfrm>
                <a:off x="-1138311" y="4121018"/>
                <a:ext cx="220068" cy="762282"/>
              </a:xfrm>
              <a:custGeom>
                <a:avLst/>
                <a:gdLst/>
                <a:ahLst/>
                <a:cxnLst/>
                <a:rect l="l" t="t" r="r" b="b"/>
                <a:pathLst>
                  <a:path w="2774" h="9609" extrusionOk="0">
                    <a:moveTo>
                      <a:pt x="554" y="1"/>
                    </a:moveTo>
                    <a:cubicBezTo>
                      <a:pt x="240" y="1"/>
                      <a:pt x="0" y="152"/>
                      <a:pt x="10" y="573"/>
                    </a:cubicBezTo>
                    <a:cubicBezTo>
                      <a:pt x="10" y="747"/>
                      <a:pt x="227" y="2683"/>
                      <a:pt x="293" y="3097"/>
                    </a:cubicBezTo>
                    <a:cubicBezTo>
                      <a:pt x="358" y="3510"/>
                      <a:pt x="815" y="7775"/>
                      <a:pt x="728" y="9363"/>
                    </a:cubicBezTo>
                    <a:cubicBezTo>
                      <a:pt x="728" y="9476"/>
                      <a:pt x="1199" y="9608"/>
                      <a:pt x="1509" y="9608"/>
                    </a:cubicBezTo>
                    <a:cubicBezTo>
                      <a:pt x="1675" y="9608"/>
                      <a:pt x="1795" y="9570"/>
                      <a:pt x="1772" y="9472"/>
                    </a:cubicBezTo>
                    <a:cubicBezTo>
                      <a:pt x="1729" y="9189"/>
                      <a:pt x="2686" y="4990"/>
                      <a:pt x="2730" y="4185"/>
                    </a:cubicBezTo>
                    <a:cubicBezTo>
                      <a:pt x="2773" y="3401"/>
                      <a:pt x="2599" y="1334"/>
                      <a:pt x="1794" y="529"/>
                    </a:cubicBezTo>
                    <a:cubicBezTo>
                      <a:pt x="1521" y="268"/>
                      <a:pt x="971" y="1"/>
                      <a:pt x="554" y="1"/>
                    </a:cubicBezTo>
                    <a:close/>
                  </a:path>
                </a:pathLst>
              </a:custGeom>
              <a:solidFill>
                <a:srgbClr val="C09378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44" name="Google Shape;244;p14"/>
              <p:cNvSpPr/>
              <p:nvPr/>
            </p:nvSpPr>
            <p:spPr>
              <a:xfrm>
                <a:off x="-685337" y="4967308"/>
                <a:ext cx="119157" cy="176192"/>
              </a:xfrm>
              <a:custGeom>
                <a:avLst/>
                <a:gdLst/>
                <a:ahLst/>
                <a:cxnLst/>
                <a:rect l="l" t="t" r="r" b="b"/>
                <a:pathLst>
                  <a:path w="1502" h="2221" extrusionOk="0">
                    <a:moveTo>
                      <a:pt x="1088" y="0"/>
                    </a:moveTo>
                    <a:lnTo>
                      <a:pt x="0" y="327"/>
                    </a:lnTo>
                    <a:cubicBezTo>
                      <a:pt x="0" y="327"/>
                      <a:pt x="22" y="1241"/>
                      <a:pt x="370" y="1676"/>
                    </a:cubicBezTo>
                    <a:cubicBezTo>
                      <a:pt x="434" y="1761"/>
                      <a:pt x="935" y="2220"/>
                      <a:pt x="1140" y="2220"/>
                    </a:cubicBezTo>
                    <a:cubicBezTo>
                      <a:pt x="1145" y="2220"/>
                      <a:pt x="1149" y="2220"/>
                      <a:pt x="1154" y="2220"/>
                    </a:cubicBezTo>
                    <a:cubicBezTo>
                      <a:pt x="1371" y="2176"/>
                      <a:pt x="1502" y="1545"/>
                      <a:pt x="1502" y="1262"/>
                    </a:cubicBezTo>
                    <a:cubicBezTo>
                      <a:pt x="1502" y="1001"/>
                      <a:pt x="1088" y="0"/>
                      <a:pt x="1088" y="0"/>
                    </a:cubicBez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45" name="Google Shape;245;p14"/>
              <p:cNvSpPr/>
              <p:nvPr/>
            </p:nvSpPr>
            <p:spPr>
              <a:xfrm>
                <a:off x="-687082" y="4922407"/>
                <a:ext cx="103688" cy="164134"/>
              </a:xfrm>
              <a:custGeom>
                <a:avLst/>
                <a:gdLst/>
                <a:ahLst/>
                <a:cxnLst/>
                <a:rect l="l" t="t" r="r" b="b"/>
                <a:pathLst>
                  <a:path w="1307" h="2069" extrusionOk="0">
                    <a:moveTo>
                      <a:pt x="893" y="1"/>
                    </a:moveTo>
                    <a:lnTo>
                      <a:pt x="44" y="88"/>
                    </a:lnTo>
                    <a:cubicBezTo>
                      <a:pt x="44" y="88"/>
                      <a:pt x="44" y="458"/>
                      <a:pt x="22" y="784"/>
                    </a:cubicBezTo>
                    <a:cubicBezTo>
                      <a:pt x="1" y="1128"/>
                      <a:pt x="447" y="2068"/>
                      <a:pt x="983" y="2068"/>
                    </a:cubicBezTo>
                    <a:cubicBezTo>
                      <a:pt x="989" y="2068"/>
                      <a:pt x="995" y="2068"/>
                      <a:pt x="1002" y="2068"/>
                    </a:cubicBezTo>
                    <a:cubicBezTo>
                      <a:pt x="1219" y="2068"/>
                      <a:pt x="1306" y="1502"/>
                      <a:pt x="1284" y="1350"/>
                    </a:cubicBezTo>
                    <a:cubicBezTo>
                      <a:pt x="1219" y="741"/>
                      <a:pt x="893" y="1"/>
                      <a:pt x="893" y="1"/>
                    </a:cubicBezTo>
                    <a:close/>
                  </a:path>
                </a:pathLst>
              </a:custGeom>
              <a:solidFill>
                <a:srgbClr val="DAAA8E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46" name="Google Shape;246;p14"/>
              <p:cNvSpPr/>
              <p:nvPr/>
            </p:nvSpPr>
            <p:spPr>
              <a:xfrm>
                <a:off x="-852803" y="4153067"/>
                <a:ext cx="252119" cy="847086"/>
              </a:xfrm>
              <a:custGeom>
                <a:avLst/>
                <a:gdLst/>
                <a:ahLst/>
                <a:cxnLst/>
                <a:rect l="l" t="t" r="r" b="b"/>
                <a:pathLst>
                  <a:path w="3178" h="10678" extrusionOk="0">
                    <a:moveTo>
                      <a:pt x="1071" y="0"/>
                    </a:moveTo>
                    <a:cubicBezTo>
                      <a:pt x="1020" y="0"/>
                      <a:pt x="968" y="5"/>
                      <a:pt x="915" y="16"/>
                    </a:cubicBezTo>
                    <a:cubicBezTo>
                      <a:pt x="175" y="147"/>
                      <a:pt x="1" y="669"/>
                      <a:pt x="349" y="2801"/>
                    </a:cubicBezTo>
                    <a:cubicBezTo>
                      <a:pt x="632" y="4433"/>
                      <a:pt x="1633" y="8089"/>
                      <a:pt x="2111" y="9786"/>
                    </a:cubicBezTo>
                    <a:cubicBezTo>
                      <a:pt x="2286" y="10330"/>
                      <a:pt x="2220" y="10678"/>
                      <a:pt x="2264" y="10678"/>
                    </a:cubicBezTo>
                    <a:cubicBezTo>
                      <a:pt x="2481" y="10678"/>
                      <a:pt x="3091" y="10678"/>
                      <a:pt x="3156" y="10199"/>
                    </a:cubicBezTo>
                    <a:cubicBezTo>
                      <a:pt x="3178" y="10090"/>
                      <a:pt x="2938" y="9720"/>
                      <a:pt x="2938" y="9438"/>
                    </a:cubicBezTo>
                    <a:cubicBezTo>
                      <a:pt x="2938" y="7762"/>
                      <a:pt x="2917" y="3541"/>
                      <a:pt x="2829" y="2932"/>
                    </a:cubicBezTo>
                    <a:cubicBezTo>
                      <a:pt x="2705" y="2268"/>
                      <a:pt x="2125" y="0"/>
                      <a:pt x="1071" y="0"/>
                    </a:cubicBezTo>
                    <a:close/>
                  </a:path>
                </a:pathLst>
              </a:custGeom>
              <a:solidFill>
                <a:srgbClr val="DAAA8E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47" name="Google Shape;247;p14"/>
              <p:cNvSpPr/>
              <p:nvPr/>
            </p:nvSpPr>
            <p:spPr>
              <a:xfrm>
                <a:off x="-1434450" y="2706965"/>
                <a:ext cx="347000" cy="513503"/>
              </a:xfrm>
              <a:custGeom>
                <a:avLst/>
                <a:gdLst/>
                <a:ahLst/>
                <a:cxnLst/>
                <a:rect l="l" t="t" r="r" b="b"/>
                <a:pathLst>
                  <a:path w="4374" h="6473" extrusionOk="0">
                    <a:moveTo>
                      <a:pt x="3338" y="0"/>
                    </a:moveTo>
                    <a:cubicBezTo>
                      <a:pt x="2854" y="0"/>
                      <a:pt x="2108" y="1267"/>
                      <a:pt x="1654" y="2710"/>
                    </a:cubicBezTo>
                    <a:cubicBezTo>
                      <a:pt x="805" y="5386"/>
                      <a:pt x="0" y="5822"/>
                      <a:pt x="893" y="6322"/>
                    </a:cubicBezTo>
                    <a:cubicBezTo>
                      <a:pt x="1088" y="6424"/>
                      <a:pt x="1251" y="6473"/>
                      <a:pt x="1391" y="6473"/>
                    </a:cubicBezTo>
                    <a:cubicBezTo>
                      <a:pt x="2061" y="6473"/>
                      <a:pt x="2223" y="5358"/>
                      <a:pt x="3068" y="3559"/>
                    </a:cubicBezTo>
                    <a:cubicBezTo>
                      <a:pt x="3852" y="1840"/>
                      <a:pt x="4374" y="338"/>
                      <a:pt x="3416" y="12"/>
                    </a:cubicBezTo>
                    <a:cubicBezTo>
                      <a:pt x="3391" y="4"/>
                      <a:pt x="3365" y="0"/>
                      <a:pt x="3338" y="0"/>
                    </a:cubicBezTo>
                    <a:close/>
                  </a:path>
                </a:pathLst>
              </a:custGeom>
              <a:solidFill>
                <a:schemeClr val="dk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48" name="Google Shape;248;p14"/>
              <p:cNvSpPr/>
              <p:nvPr/>
            </p:nvSpPr>
            <p:spPr>
              <a:xfrm>
                <a:off x="-1229065" y="3487490"/>
                <a:ext cx="274570" cy="812657"/>
              </a:xfrm>
              <a:custGeom>
                <a:avLst/>
                <a:gdLst/>
                <a:ahLst/>
                <a:cxnLst/>
                <a:rect l="l" t="t" r="r" b="b"/>
                <a:pathLst>
                  <a:path w="3461" h="10244" extrusionOk="0">
                    <a:moveTo>
                      <a:pt x="1571" y="0"/>
                    </a:moveTo>
                    <a:cubicBezTo>
                      <a:pt x="1113" y="0"/>
                      <a:pt x="614" y="197"/>
                      <a:pt x="349" y="682"/>
                    </a:cubicBezTo>
                    <a:cubicBezTo>
                      <a:pt x="1" y="1313"/>
                      <a:pt x="22" y="2423"/>
                      <a:pt x="196" y="3881"/>
                    </a:cubicBezTo>
                    <a:cubicBezTo>
                      <a:pt x="414" y="5861"/>
                      <a:pt x="1067" y="8994"/>
                      <a:pt x="1154" y="9277"/>
                    </a:cubicBezTo>
                    <a:cubicBezTo>
                      <a:pt x="1334" y="9940"/>
                      <a:pt x="1758" y="10243"/>
                      <a:pt x="2152" y="10243"/>
                    </a:cubicBezTo>
                    <a:cubicBezTo>
                      <a:pt x="2521" y="10243"/>
                      <a:pt x="2865" y="9978"/>
                      <a:pt x="2960" y="9494"/>
                    </a:cubicBezTo>
                    <a:cubicBezTo>
                      <a:pt x="3025" y="9211"/>
                      <a:pt x="3460" y="3533"/>
                      <a:pt x="3373" y="2902"/>
                    </a:cubicBezTo>
                    <a:cubicBezTo>
                      <a:pt x="3308" y="2271"/>
                      <a:pt x="2960" y="1117"/>
                      <a:pt x="2503" y="399"/>
                    </a:cubicBezTo>
                    <a:cubicBezTo>
                      <a:pt x="2350" y="154"/>
                      <a:pt x="1976" y="0"/>
                      <a:pt x="1571" y="0"/>
                    </a:cubicBezTo>
                    <a:close/>
                  </a:path>
                </a:pathLst>
              </a:custGeom>
              <a:solidFill>
                <a:srgbClr val="C09378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49" name="Google Shape;249;p14"/>
              <p:cNvSpPr/>
              <p:nvPr/>
            </p:nvSpPr>
            <p:spPr>
              <a:xfrm>
                <a:off x="-970132" y="3505102"/>
                <a:ext cx="300432" cy="796156"/>
              </a:xfrm>
              <a:custGeom>
                <a:avLst/>
                <a:gdLst/>
                <a:ahLst/>
                <a:cxnLst/>
                <a:rect l="l" t="t" r="r" b="b"/>
                <a:pathLst>
                  <a:path w="3787" h="10036" extrusionOk="0">
                    <a:moveTo>
                      <a:pt x="1536" y="0"/>
                    </a:moveTo>
                    <a:cubicBezTo>
                      <a:pt x="966" y="0"/>
                      <a:pt x="434" y="209"/>
                      <a:pt x="305" y="526"/>
                    </a:cubicBezTo>
                    <a:cubicBezTo>
                      <a:pt x="0" y="1309"/>
                      <a:pt x="153" y="2462"/>
                      <a:pt x="218" y="3093"/>
                    </a:cubicBezTo>
                    <a:cubicBezTo>
                      <a:pt x="261" y="3724"/>
                      <a:pt x="1589" y="9185"/>
                      <a:pt x="1698" y="9446"/>
                    </a:cubicBezTo>
                    <a:cubicBezTo>
                      <a:pt x="1859" y="9841"/>
                      <a:pt x="2209" y="10036"/>
                      <a:pt x="2572" y="10036"/>
                    </a:cubicBezTo>
                    <a:cubicBezTo>
                      <a:pt x="3090" y="10036"/>
                      <a:pt x="3635" y="9639"/>
                      <a:pt x="3699" y="8859"/>
                    </a:cubicBezTo>
                    <a:cubicBezTo>
                      <a:pt x="3721" y="8576"/>
                      <a:pt x="3786" y="5595"/>
                      <a:pt x="3634" y="3615"/>
                    </a:cubicBezTo>
                    <a:cubicBezTo>
                      <a:pt x="3503" y="2157"/>
                      <a:pt x="3308" y="1048"/>
                      <a:pt x="2851" y="526"/>
                    </a:cubicBezTo>
                    <a:cubicBezTo>
                      <a:pt x="2539" y="154"/>
                      <a:pt x="2024" y="0"/>
                      <a:pt x="1536" y="0"/>
                    </a:cubicBezTo>
                    <a:close/>
                  </a:path>
                </a:pathLst>
              </a:custGeom>
              <a:solidFill>
                <a:srgbClr val="DAAA8E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50" name="Google Shape;250;p14"/>
              <p:cNvSpPr/>
              <p:nvPr/>
            </p:nvSpPr>
            <p:spPr>
              <a:xfrm>
                <a:off x="-1218672" y="3469086"/>
                <a:ext cx="250373" cy="248620"/>
              </a:xfrm>
              <a:custGeom>
                <a:avLst/>
                <a:gdLst/>
                <a:ahLst/>
                <a:cxnLst/>
                <a:rect l="l" t="t" r="r" b="b"/>
                <a:pathLst>
                  <a:path w="3156" h="3134" extrusionOk="0">
                    <a:moveTo>
                      <a:pt x="414" y="0"/>
                    </a:moveTo>
                    <a:cubicBezTo>
                      <a:pt x="174" y="610"/>
                      <a:pt x="0" y="1154"/>
                      <a:pt x="87" y="1458"/>
                    </a:cubicBezTo>
                    <a:cubicBezTo>
                      <a:pt x="327" y="2372"/>
                      <a:pt x="2981" y="3134"/>
                      <a:pt x="2981" y="3134"/>
                    </a:cubicBezTo>
                    <a:lnTo>
                      <a:pt x="3155" y="3134"/>
                    </a:lnTo>
                    <a:lnTo>
                      <a:pt x="3155" y="218"/>
                    </a:lnTo>
                    <a:cubicBezTo>
                      <a:pt x="2133" y="218"/>
                      <a:pt x="1436" y="0"/>
                      <a:pt x="414" y="0"/>
                    </a:cubicBezTo>
                    <a:close/>
                  </a:path>
                </a:pathLst>
              </a:custGeom>
              <a:solidFill>
                <a:srgbClr val="27547C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51" name="Google Shape;251;p14"/>
              <p:cNvSpPr/>
              <p:nvPr/>
            </p:nvSpPr>
            <p:spPr>
              <a:xfrm>
                <a:off x="-1268730" y="2694113"/>
                <a:ext cx="581745" cy="792269"/>
              </a:xfrm>
              <a:custGeom>
                <a:avLst/>
                <a:gdLst/>
                <a:ahLst/>
                <a:cxnLst/>
                <a:rect l="l" t="t" r="r" b="b"/>
                <a:pathLst>
                  <a:path w="7333" h="9987" extrusionOk="0">
                    <a:moveTo>
                      <a:pt x="3786" y="0"/>
                    </a:moveTo>
                    <a:cubicBezTo>
                      <a:pt x="3786" y="0"/>
                      <a:pt x="1931" y="176"/>
                      <a:pt x="1366" y="176"/>
                    </a:cubicBezTo>
                    <a:cubicBezTo>
                      <a:pt x="1334" y="176"/>
                      <a:pt x="1307" y="175"/>
                      <a:pt x="1284" y="174"/>
                    </a:cubicBezTo>
                    <a:cubicBezTo>
                      <a:pt x="1088" y="174"/>
                      <a:pt x="958" y="849"/>
                      <a:pt x="892" y="1044"/>
                    </a:cubicBezTo>
                    <a:cubicBezTo>
                      <a:pt x="479" y="2132"/>
                      <a:pt x="0" y="3394"/>
                      <a:pt x="1023" y="4265"/>
                    </a:cubicBezTo>
                    <a:cubicBezTo>
                      <a:pt x="1240" y="4460"/>
                      <a:pt x="1458" y="6745"/>
                      <a:pt x="1458" y="7811"/>
                    </a:cubicBezTo>
                    <a:cubicBezTo>
                      <a:pt x="1458" y="8246"/>
                      <a:pt x="1349" y="8943"/>
                      <a:pt x="1045" y="9769"/>
                    </a:cubicBezTo>
                    <a:cubicBezTo>
                      <a:pt x="2067" y="9769"/>
                      <a:pt x="2764" y="9987"/>
                      <a:pt x="3786" y="9987"/>
                    </a:cubicBezTo>
                    <a:lnTo>
                      <a:pt x="6854" y="9987"/>
                    </a:lnTo>
                    <a:cubicBezTo>
                      <a:pt x="6528" y="9160"/>
                      <a:pt x="6201" y="8246"/>
                      <a:pt x="6114" y="7811"/>
                    </a:cubicBezTo>
                    <a:cubicBezTo>
                      <a:pt x="5527" y="4547"/>
                      <a:pt x="7333" y="1501"/>
                      <a:pt x="7072" y="892"/>
                    </a:cubicBezTo>
                    <a:cubicBezTo>
                      <a:pt x="6876" y="479"/>
                      <a:pt x="5940" y="305"/>
                      <a:pt x="5527" y="174"/>
                    </a:cubicBezTo>
                    <a:cubicBezTo>
                      <a:pt x="5070" y="44"/>
                      <a:pt x="3786" y="0"/>
                      <a:pt x="3786" y="0"/>
                    </a:cubicBezTo>
                    <a:close/>
                  </a:path>
                </a:pathLst>
              </a:custGeom>
              <a:solidFill>
                <a:schemeClr val="dk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52" name="Google Shape;252;p14"/>
              <p:cNvSpPr/>
              <p:nvPr/>
            </p:nvSpPr>
            <p:spPr>
              <a:xfrm>
                <a:off x="-968386" y="3486380"/>
                <a:ext cx="274490" cy="231326"/>
              </a:xfrm>
              <a:custGeom>
                <a:avLst/>
                <a:gdLst/>
                <a:ahLst/>
                <a:cxnLst/>
                <a:rect l="l" t="t" r="r" b="b"/>
                <a:pathLst>
                  <a:path w="3460" h="2916" extrusionOk="0">
                    <a:moveTo>
                      <a:pt x="0" y="0"/>
                    </a:moveTo>
                    <a:lnTo>
                      <a:pt x="0" y="2916"/>
                    </a:lnTo>
                    <a:lnTo>
                      <a:pt x="174" y="2916"/>
                    </a:lnTo>
                    <a:cubicBezTo>
                      <a:pt x="174" y="2916"/>
                      <a:pt x="3155" y="2350"/>
                      <a:pt x="3394" y="1458"/>
                    </a:cubicBezTo>
                    <a:cubicBezTo>
                      <a:pt x="3460" y="1153"/>
                      <a:pt x="3286" y="587"/>
                      <a:pt x="3068" y="0"/>
                    </a:cubicBezTo>
                    <a:close/>
                  </a:path>
                </a:pathLst>
              </a:custGeom>
              <a:solidFill>
                <a:srgbClr val="27547C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53" name="Google Shape;253;p14"/>
              <p:cNvSpPr/>
              <p:nvPr/>
            </p:nvSpPr>
            <p:spPr>
              <a:xfrm>
                <a:off x="-1094442" y="2511100"/>
                <a:ext cx="233158" cy="234817"/>
              </a:xfrm>
              <a:custGeom>
                <a:avLst/>
                <a:gdLst/>
                <a:ahLst/>
                <a:cxnLst/>
                <a:rect l="l" t="t" r="r" b="b"/>
                <a:pathLst>
                  <a:path w="2939" h="2960" extrusionOk="0">
                    <a:moveTo>
                      <a:pt x="762" y="1"/>
                    </a:moveTo>
                    <a:cubicBezTo>
                      <a:pt x="762" y="1"/>
                      <a:pt x="784" y="1284"/>
                      <a:pt x="654" y="1633"/>
                    </a:cubicBezTo>
                    <a:cubicBezTo>
                      <a:pt x="523" y="1981"/>
                      <a:pt x="1" y="2394"/>
                      <a:pt x="1" y="2394"/>
                    </a:cubicBezTo>
                    <a:lnTo>
                      <a:pt x="1197" y="2960"/>
                    </a:lnTo>
                    <a:lnTo>
                      <a:pt x="2938" y="2307"/>
                    </a:lnTo>
                    <a:cubicBezTo>
                      <a:pt x="2938" y="2307"/>
                      <a:pt x="2655" y="1981"/>
                      <a:pt x="2525" y="1633"/>
                    </a:cubicBezTo>
                    <a:cubicBezTo>
                      <a:pt x="2394" y="1284"/>
                      <a:pt x="2394" y="1"/>
                      <a:pt x="2394" y="1"/>
                    </a:cubicBezTo>
                    <a:close/>
                  </a:path>
                </a:pathLst>
              </a:custGeom>
              <a:solidFill>
                <a:srgbClr val="DAAA8E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54" name="Google Shape;254;p14"/>
              <p:cNvSpPr/>
              <p:nvPr/>
            </p:nvSpPr>
            <p:spPr>
              <a:xfrm>
                <a:off x="-1106500" y="2511100"/>
                <a:ext cx="203726" cy="196897"/>
              </a:xfrm>
              <a:custGeom>
                <a:avLst/>
                <a:gdLst/>
                <a:ahLst/>
                <a:cxnLst/>
                <a:rect l="l" t="t" r="r" b="b"/>
                <a:pathLst>
                  <a:path w="2568" h="2482" extrusionOk="0">
                    <a:moveTo>
                      <a:pt x="914" y="1"/>
                    </a:moveTo>
                    <a:cubicBezTo>
                      <a:pt x="914" y="1"/>
                      <a:pt x="936" y="1284"/>
                      <a:pt x="806" y="1633"/>
                    </a:cubicBezTo>
                    <a:cubicBezTo>
                      <a:pt x="675" y="1981"/>
                      <a:pt x="0" y="2481"/>
                      <a:pt x="0" y="2481"/>
                    </a:cubicBezTo>
                    <a:lnTo>
                      <a:pt x="2568" y="653"/>
                    </a:lnTo>
                    <a:cubicBezTo>
                      <a:pt x="2546" y="305"/>
                      <a:pt x="2546" y="1"/>
                      <a:pt x="2546" y="1"/>
                    </a:cubicBezTo>
                    <a:close/>
                  </a:path>
                </a:pathLst>
              </a:custGeom>
              <a:solidFill>
                <a:srgbClr val="191919">
                  <a:alpha val="1761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55" name="Google Shape;255;p14"/>
              <p:cNvSpPr/>
              <p:nvPr/>
            </p:nvSpPr>
            <p:spPr>
              <a:xfrm>
                <a:off x="-1132361" y="2262083"/>
                <a:ext cx="307334" cy="346672"/>
              </a:xfrm>
              <a:custGeom>
                <a:avLst/>
                <a:gdLst/>
                <a:ahLst/>
                <a:cxnLst/>
                <a:rect l="l" t="t" r="r" b="b"/>
                <a:pathLst>
                  <a:path w="3874" h="4370" extrusionOk="0">
                    <a:moveTo>
                      <a:pt x="1962" y="0"/>
                    </a:moveTo>
                    <a:cubicBezTo>
                      <a:pt x="1191" y="0"/>
                      <a:pt x="478" y="568"/>
                      <a:pt x="261" y="1617"/>
                    </a:cubicBezTo>
                    <a:cubicBezTo>
                      <a:pt x="0" y="2900"/>
                      <a:pt x="522" y="4162"/>
                      <a:pt x="1132" y="4336"/>
                    </a:cubicBezTo>
                    <a:cubicBezTo>
                      <a:pt x="1204" y="4359"/>
                      <a:pt x="1286" y="4370"/>
                      <a:pt x="1375" y="4370"/>
                    </a:cubicBezTo>
                    <a:cubicBezTo>
                      <a:pt x="2064" y="4370"/>
                      <a:pt x="3176" y="3715"/>
                      <a:pt x="3503" y="2617"/>
                    </a:cubicBezTo>
                    <a:cubicBezTo>
                      <a:pt x="3873" y="1399"/>
                      <a:pt x="3373" y="355"/>
                      <a:pt x="2437" y="72"/>
                    </a:cubicBezTo>
                    <a:cubicBezTo>
                      <a:pt x="2279" y="24"/>
                      <a:pt x="2119" y="0"/>
                      <a:pt x="1962" y="0"/>
                    </a:cubicBezTo>
                    <a:close/>
                  </a:path>
                </a:pathLst>
              </a:custGeom>
              <a:solidFill>
                <a:srgbClr val="DAAA8E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56" name="Google Shape;256;p14"/>
              <p:cNvSpPr/>
              <p:nvPr/>
            </p:nvSpPr>
            <p:spPr>
              <a:xfrm>
                <a:off x="-1035737" y="2250977"/>
                <a:ext cx="252119" cy="287809"/>
              </a:xfrm>
              <a:custGeom>
                <a:avLst/>
                <a:gdLst/>
                <a:ahLst/>
                <a:cxnLst/>
                <a:rect l="l" t="t" r="r" b="b"/>
                <a:pathLst>
                  <a:path w="3178" h="3628" extrusionOk="0">
                    <a:moveTo>
                      <a:pt x="773" y="0"/>
                    </a:moveTo>
                    <a:cubicBezTo>
                      <a:pt x="351" y="0"/>
                      <a:pt x="33" y="172"/>
                      <a:pt x="22" y="234"/>
                    </a:cubicBezTo>
                    <a:cubicBezTo>
                      <a:pt x="1" y="342"/>
                      <a:pt x="109" y="778"/>
                      <a:pt x="153" y="952"/>
                    </a:cubicBezTo>
                    <a:cubicBezTo>
                      <a:pt x="240" y="1321"/>
                      <a:pt x="566" y="1583"/>
                      <a:pt x="1328" y="1757"/>
                    </a:cubicBezTo>
                    <a:cubicBezTo>
                      <a:pt x="1850" y="1865"/>
                      <a:pt x="2111" y="2692"/>
                      <a:pt x="2068" y="2975"/>
                    </a:cubicBezTo>
                    <a:cubicBezTo>
                      <a:pt x="2046" y="3106"/>
                      <a:pt x="1828" y="3628"/>
                      <a:pt x="1828" y="3628"/>
                    </a:cubicBezTo>
                    <a:cubicBezTo>
                      <a:pt x="1828" y="3628"/>
                      <a:pt x="3177" y="2670"/>
                      <a:pt x="2307" y="1060"/>
                    </a:cubicBezTo>
                    <a:cubicBezTo>
                      <a:pt x="1857" y="219"/>
                      <a:pt x="1249" y="0"/>
                      <a:pt x="773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57" name="Google Shape;257;p14"/>
              <p:cNvSpPr/>
              <p:nvPr/>
            </p:nvSpPr>
            <p:spPr>
              <a:xfrm>
                <a:off x="-1113402" y="2267557"/>
                <a:ext cx="144702" cy="112490"/>
              </a:xfrm>
              <a:custGeom>
                <a:avLst/>
                <a:gdLst/>
                <a:ahLst/>
                <a:cxnLst/>
                <a:rect l="l" t="t" r="r" b="b"/>
                <a:pathLst>
                  <a:path w="1824" h="1418" extrusionOk="0">
                    <a:moveTo>
                      <a:pt x="1258" y="0"/>
                    </a:moveTo>
                    <a:cubicBezTo>
                      <a:pt x="1188" y="0"/>
                      <a:pt x="1103" y="8"/>
                      <a:pt x="1001" y="25"/>
                    </a:cubicBezTo>
                    <a:cubicBezTo>
                      <a:pt x="87" y="155"/>
                      <a:pt x="0" y="1417"/>
                      <a:pt x="0" y="1417"/>
                    </a:cubicBezTo>
                    <a:cubicBezTo>
                      <a:pt x="0" y="1417"/>
                      <a:pt x="479" y="1112"/>
                      <a:pt x="936" y="1069"/>
                    </a:cubicBezTo>
                    <a:cubicBezTo>
                      <a:pt x="1415" y="1025"/>
                      <a:pt x="1480" y="481"/>
                      <a:pt x="1480" y="481"/>
                    </a:cubicBezTo>
                    <a:cubicBezTo>
                      <a:pt x="1480" y="481"/>
                      <a:pt x="1824" y="0"/>
                      <a:pt x="1258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58" name="Google Shape;258;p14"/>
              <p:cNvSpPr/>
              <p:nvPr/>
            </p:nvSpPr>
            <p:spPr>
              <a:xfrm>
                <a:off x="-1246279" y="2849441"/>
                <a:ext cx="474726" cy="631784"/>
              </a:xfrm>
              <a:custGeom>
                <a:avLst/>
                <a:gdLst/>
                <a:ahLst/>
                <a:cxnLst/>
                <a:rect l="l" t="t" r="r" b="b"/>
                <a:pathLst>
                  <a:path w="5984" h="7964" extrusionOk="0">
                    <a:moveTo>
                      <a:pt x="283" y="0"/>
                    </a:moveTo>
                    <a:cubicBezTo>
                      <a:pt x="44" y="827"/>
                      <a:pt x="0" y="1676"/>
                      <a:pt x="740" y="2307"/>
                    </a:cubicBezTo>
                    <a:cubicBezTo>
                      <a:pt x="957" y="2502"/>
                      <a:pt x="1175" y="4787"/>
                      <a:pt x="1175" y="5853"/>
                    </a:cubicBezTo>
                    <a:cubicBezTo>
                      <a:pt x="1175" y="6288"/>
                      <a:pt x="1066" y="6985"/>
                      <a:pt x="762" y="7811"/>
                    </a:cubicBezTo>
                    <a:cubicBezTo>
                      <a:pt x="1414" y="7811"/>
                      <a:pt x="1915" y="7898"/>
                      <a:pt x="2481" y="7964"/>
                    </a:cubicBezTo>
                    <a:cubicBezTo>
                      <a:pt x="2481" y="7964"/>
                      <a:pt x="2285" y="7202"/>
                      <a:pt x="2285" y="6789"/>
                    </a:cubicBezTo>
                    <a:cubicBezTo>
                      <a:pt x="2296" y="6007"/>
                      <a:pt x="3098" y="5907"/>
                      <a:pt x="3921" y="5907"/>
                    </a:cubicBezTo>
                    <a:cubicBezTo>
                      <a:pt x="4202" y="5907"/>
                      <a:pt x="4485" y="5919"/>
                      <a:pt x="4740" y="5919"/>
                    </a:cubicBezTo>
                    <a:cubicBezTo>
                      <a:pt x="5192" y="5919"/>
                      <a:pt x="5556" y="5882"/>
                      <a:pt x="5657" y="5679"/>
                    </a:cubicBezTo>
                    <a:cubicBezTo>
                      <a:pt x="5984" y="5026"/>
                      <a:pt x="4482" y="3438"/>
                      <a:pt x="4635" y="3220"/>
                    </a:cubicBezTo>
                    <a:cubicBezTo>
                      <a:pt x="4809" y="3003"/>
                      <a:pt x="4635" y="2720"/>
                      <a:pt x="4373" y="2589"/>
                    </a:cubicBezTo>
                    <a:cubicBezTo>
                      <a:pt x="4091" y="2481"/>
                      <a:pt x="3503" y="2524"/>
                      <a:pt x="2089" y="2459"/>
                    </a:cubicBezTo>
                    <a:cubicBezTo>
                      <a:pt x="696" y="2372"/>
                      <a:pt x="501" y="1676"/>
                      <a:pt x="283" y="1371"/>
                    </a:cubicBezTo>
                    <a:cubicBezTo>
                      <a:pt x="87" y="1066"/>
                      <a:pt x="283" y="66"/>
                      <a:pt x="283" y="0"/>
                    </a:cubicBezTo>
                    <a:close/>
                  </a:path>
                </a:pathLst>
              </a:custGeom>
              <a:solidFill>
                <a:srgbClr val="191919">
                  <a:alpha val="1761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59" name="Google Shape;259;p14"/>
              <p:cNvSpPr/>
              <p:nvPr/>
            </p:nvSpPr>
            <p:spPr>
              <a:xfrm>
                <a:off x="-1059933" y="2711328"/>
                <a:ext cx="60531" cy="34588"/>
              </a:xfrm>
              <a:custGeom>
                <a:avLst/>
                <a:gdLst/>
                <a:ahLst/>
                <a:cxnLst/>
                <a:rect l="l" t="t" r="r" b="b"/>
                <a:pathLst>
                  <a:path w="763" h="436" extrusionOk="0">
                    <a:moveTo>
                      <a:pt x="610" y="1"/>
                    </a:moveTo>
                    <a:lnTo>
                      <a:pt x="1" y="109"/>
                    </a:lnTo>
                    <a:lnTo>
                      <a:pt x="762" y="436"/>
                    </a:lnTo>
                    <a:lnTo>
                      <a:pt x="610" y="1"/>
                    </a:lnTo>
                    <a:close/>
                  </a:path>
                </a:pathLst>
              </a:custGeom>
              <a:solidFill>
                <a:schemeClr val="l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60" name="Google Shape;260;p14"/>
              <p:cNvSpPr/>
              <p:nvPr/>
            </p:nvSpPr>
            <p:spPr>
              <a:xfrm>
                <a:off x="-999484" y="2711328"/>
                <a:ext cx="48393" cy="34588"/>
              </a:xfrm>
              <a:custGeom>
                <a:avLst/>
                <a:gdLst/>
                <a:ahLst/>
                <a:cxnLst/>
                <a:rect l="l" t="t" r="r" b="b"/>
                <a:pathLst>
                  <a:path w="610" h="436" extrusionOk="0">
                    <a:moveTo>
                      <a:pt x="153" y="1"/>
                    </a:moveTo>
                    <a:lnTo>
                      <a:pt x="0" y="436"/>
                    </a:lnTo>
                    <a:lnTo>
                      <a:pt x="610" y="218"/>
                    </a:lnTo>
                    <a:lnTo>
                      <a:pt x="153" y="1"/>
                    </a:lnTo>
                    <a:close/>
                  </a:path>
                </a:pathLst>
              </a:custGeom>
              <a:solidFill>
                <a:schemeClr val="l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61" name="Google Shape;261;p14"/>
              <p:cNvSpPr/>
              <p:nvPr/>
            </p:nvSpPr>
            <p:spPr>
              <a:xfrm>
                <a:off x="-1235966" y="3469086"/>
                <a:ext cx="576589" cy="785446"/>
              </a:xfrm>
              <a:custGeom>
                <a:avLst/>
                <a:gdLst/>
                <a:ahLst/>
                <a:cxnLst/>
                <a:rect l="l" t="t" r="r" b="b"/>
                <a:pathLst>
                  <a:path w="7268" h="9901" extrusionOk="0">
                    <a:moveTo>
                      <a:pt x="632" y="0"/>
                    </a:moveTo>
                    <a:cubicBezTo>
                      <a:pt x="632" y="0"/>
                      <a:pt x="175" y="762"/>
                      <a:pt x="88" y="2111"/>
                    </a:cubicBezTo>
                    <a:cubicBezTo>
                      <a:pt x="1" y="3482"/>
                      <a:pt x="980" y="9748"/>
                      <a:pt x="980" y="9748"/>
                    </a:cubicBezTo>
                    <a:lnTo>
                      <a:pt x="3678" y="9900"/>
                    </a:lnTo>
                    <a:lnTo>
                      <a:pt x="7268" y="9618"/>
                    </a:lnTo>
                    <a:cubicBezTo>
                      <a:pt x="7268" y="9618"/>
                      <a:pt x="7181" y="3895"/>
                      <a:pt x="7029" y="2176"/>
                    </a:cubicBezTo>
                    <a:cubicBezTo>
                      <a:pt x="6854" y="479"/>
                      <a:pt x="6376" y="44"/>
                      <a:pt x="6376" y="44"/>
                    </a:cubicBezTo>
                    <a:lnTo>
                      <a:pt x="3112" y="174"/>
                    </a:lnTo>
                    <a:lnTo>
                      <a:pt x="632" y="0"/>
                    </a:ln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62" name="Google Shape;262;p14"/>
              <p:cNvSpPr/>
              <p:nvPr/>
            </p:nvSpPr>
            <p:spPr>
              <a:xfrm>
                <a:off x="-987426" y="2652624"/>
                <a:ext cx="157158" cy="117488"/>
              </a:xfrm>
              <a:custGeom>
                <a:avLst/>
                <a:gdLst/>
                <a:ahLst/>
                <a:cxnLst/>
                <a:rect l="l" t="t" r="r" b="b"/>
                <a:pathLst>
                  <a:path w="1981" h="1481" extrusionOk="0">
                    <a:moveTo>
                      <a:pt x="1437" y="1"/>
                    </a:moveTo>
                    <a:lnTo>
                      <a:pt x="1" y="741"/>
                    </a:lnTo>
                    <a:lnTo>
                      <a:pt x="501" y="1480"/>
                    </a:lnTo>
                    <a:lnTo>
                      <a:pt x="1981" y="697"/>
                    </a:lnTo>
                    <a:lnTo>
                      <a:pt x="1437" y="1"/>
                    </a:lnTo>
                    <a:close/>
                  </a:path>
                </a:pathLst>
              </a:custGeom>
              <a:solidFill>
                <a:schemeClr val="accent6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63" name="Google Shape;263;p14"/>
              <p:cNvSpPr/>
              <p:nvPr/>
            </p:nvSpPr>
            <p:spPr>
              <a:xfrm>
                <a:off x="-1123794" y="2661271"/>
                <a:ext cx="112335" cy="103684"/>
              </a:xfrm>
              <a:custGeom>
                <a:avLst/>
                <a:gdLst/>
                <a:ahLst/>
                <a:cxnLst/>
                <a:rect l="l" t="t" r="r" b="b"/>
                <a:pathLst>
                  <a:path w="1416" h="1307" extrusionOk="0">
                    <a:moveTo>
                      <a:pt x="654" y="1"/>
                    </a:moveTo>
                    <a:lnTo>
                      <a:pt x="1" y="588"/>
                    </a:lnTo>
                    <a:lnTo>
                      <a:pt x="871" y="1306"/>
                    </a:lnTo>
                    <a:lnTo>
                      <a:pt x="1415" y="632"/>
                    </a:lnTo>
                    <a:lnTo>
                      <a:pt x="654" y="1"/>
                    </a:lnTo>
                    <a:close/>
                  </a:path>
                </a:pathLst>
              </a:custGeom>
              <a:solidFill>
                <a:schemeClr val="accent6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64" name="Google Shape;264;p14"/>
              <p:cNvSpPr/>
              <p:nvPr/>
            </p:nvSpPr>
            <p:spPr>
              <a:xfrm>
                <a:off x="-1235966" y="3469086"/>
                <a:ext cx="338432" cy="785446"/>
              </a:xfrm>
              <a:custGeom>
                <a:avLst/>
                <a:gdLst/>
                <a:ahLst/>
                <a:cxnLst/>
                <a:rect l="l" t="t" r="r" b="b"/>
                <a:pathLst>
                  <a:path w="4266" h="9901" extrusionOk="0">
                    <a:moveTo>
                      <a:pt x="632" y="0"/>
                    </a:moveTo>
                    <a:cubicBezTo>
                      <a:pt x="632" y="0"/>
                      <a:pt x="175" y="762"/>
                      <a:pt x="88" y="2111"/>
                    </a:cubicBezTo>
                    <a:cubicBezTo>
                      <a:pt x="1" y="3482"/>
                      <a:pt x="980" y="9748"/>
                      <a:pt x="980" y="9748"/>
                    </a:cubicBezTo>
                    <a:lnTo>
                      <a:pt x="3678" y="9900"/>
                    </a:lnTo>
                    <a:lnTo>
                      <a:pt x="4265" y="9879"/>
                    </a:lnTo>
                    <a:cubicBezTo>
                      <a:pt x="4265" y="9879"/>
                      <a:pt x="3612" y="9748"/>
                      <a:pt x="3525" y="9161"/>
                    </a:cubicBezTo>
                    <a:cubicBezTo>
                      <a:pt x="3337" y="8007"/>
                      <a:pt x="3148" y="5801"/>
                      <a:pt x="2978" y="5801"/>
                    </a:cubicBezTo>
                    <a:cubicBezTo>
                      <a:pt x="2972" y="5801"/>
                      <a:pt x="2966" y="5804"/>
                      <a:pt x="2960" y="5810"/>
                    </a:cubicBezTo>
                    <a:cubicBezTo>
                      <a:pt x="2786" y="6027"/>
                      <a:pt x="2873" y="7746"/>
                      <a:pt x="2568" y="8073"/>
                    </a:cubicBezTo>
                    <a:cubicBezTo>
                      <a:pt x="2444" y="8224"/>
                      <a:pt x="2294" y="8302"/>
                      <a:pt x="2141" y="8302"/>
                    </a:cubicBezTo>
                    <a:cubicBezTo>
                      <a:pt x="1919" y="8302"/>
                      <a:pt x="1691" y="8137"/>
                      <a:pt x="1524" y="7790"/>
                    </a:cubicBezTo>
                    <a:cubicBezTo>
                      <a:pt x="1263" y="7181"/>
                      <a:pt x="566" y="2938"/>
                      <a:pt x="1132" y="1436"/>
                    </a:cubicBezTo>
                    <a:cubicBezTo>
                      <a:pt x="1524" y="392"/>
                      <a:pt x="2351" y="153"/>
                      <a:pt x="2351" y="153"/>
                    </a:cubicBezTo>
                    <a:lnTo>
                      <a:pt x="2242" y="131"/>
                    </a:lnTo>
                    <a:lnTo>
                      <a:pt x="632" y="0"/>
                    </a:lnTo>
                    <a:close/>
                  </a:path>
                </a:pathLst>
              </a:custGeom>
              <a:solidFill>
                <a:srgbClr val="191919">
                  <a:alpha val="1761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65" name="Google Shape;265;p14"/>
              <p:cNvSpPr/>
              <p:nvPr/>
            </p:nvSpPr>
            <p:spPr>
              <a:xfrm>
                <a:off x="-1027090" y="2734413"/>
                <a:ext cx="50138" cy="45853"/>
              </a:xfrm>
              <a:custGeom>
                <a:avLst/>
                <a:gdLst/>
                <a:ahLst/>
                <a:cxnLst/>
                <a:rect l="l" t="t" r="r" b="b"/>
                <a:pathLst>
                  <a:path w="632" h="578" extrusionOk="0">
                    <a:moveTo>
                      <a:pt x="329" y="0"/>
                    </a:moveTo>
                    <a:cubicBezTo>
                      <a:pt x="207" y="0"/>
                      <a:pt x="79" y="23"/>
                      <a:pt x="44" y="58"/>
                    </a:cubicBezTo>
                    <a:cubicBezTo>
                      <a:pt x="0" y="145"/>
                      <a:pt x="44" y="471"/>
                      <a:pt x="66" y="536"/>
                    </a:cubicBezTo>
                    <a:cubicBezTo>
                      <a:pt x="90" y="560"/>
                      <a:pt x="179" y="578"/>
                      <a:pt x="265" y="578"/>
                    </a:cubicBezTo>
                    <a:cubicBezTo>
                      <a:pt x="337" y="578"/>
                      <a:pt x="406" y="566"/>
                      <a:pt x="436" y="536"/>
                    </a:cubicBezTo>
                    <a:cubicBezTo>
                      <a:pt x="501" y="471"/>
                      <a:pt x="631" y="167"/>
                      <a:pt x="566" y="58"/>
                    </a:cubicBezTo>
                    <a:cubicBezTo>
                      <a:pt x="536" y="17"/>
                      <a:pt x="435" y="0"/>
                      <a:pt x="329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66" name="Google Shape;266;p14"/>
              <p:cNvSpPr/>
              <p:nvPr/>
            </p:nvSpPr>
            <p:spPr>
              <a:xfrm>
                <a:off x="-1087540" y="2776934"/>
                <a:ext cx="98531" cy="274482"/>
              </a:xfrm>
              <a:custGeom>
                <a:avLst/>
                <a:gdLst/>
                <a:ahLst/>
                <a:cxnLst/>
                <a:rect l="l" t="t" r="r" b="b"/>
                <a:pathLst>
                  <a:path w="1242" h="3460" extrusionOk="0">
                    <a:moveTo>
                      <a:pt x="828" y="0"/>
                    </a:moveTo>
                    <a:lnTo>
                      <a:pt x="1" y="2350"/>
                    </a:lnTo>
                    <a:lnTo>
                      <a:pt x="501" y="3460"/>
                    </a:lnTo>
                    <a:lnTo>
                      <a:pt x="1241" y="2481"/>
                    </a:lnTo>
                    <a:lnTo>
                      <a:pt x="1198" y="0"/>
                    </a:ln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67" name="Google Shape;267;p14"/>
              <p:cNvSpPr/>
              <p:nvPr/>
            </p:nvSpPr>
            <p:spPr>
              <a:xfrm>
                <a:off x="-845901" y="2739887"/>
                <a:ext cx="171041" cy="541269"/>
              </a:xfrm>
              <a:custGeom>
                <a:avLst/>
                <a:gdLst/>
                <a:ahLst/>
                <a:cxnLst/>
                <a:rect l="l" t="t" r="r" b="b"/>
                <a:pathLst>
                  <a:path w="2156" h="6823" extrusionOk="0">
                    <a:moveTo>
                      <a:pt x="1243" y="0"/>
                    </a:moveTo>
                    <a:cubicBezTo>
                      <a:pt x="225" y="0"/>
                      <a:pt x="67" y="1509"/>
                      <a:pt x="88" y="3296"/>
                    </a:cubicBezTo>
                    <a:cubicBezTo>
                      <a:pt x="110" y="5668"/>
                      <a:pt x="1" y="6799"/>
                      <a:pt x="893" y="6821"/>
                    </a:cubicBezTo>
                    <a:cubicBezTo>
                      <a:pt x="914" y="6822"/>
                      <a:pt x="935" y="6822"/>
                      <a:pt x="955" y="6822"/>
                    </a:cubicBezTo>
                    <a:cubicBezTo>
                      <a:pt x="1858" y="6822"/>
                      <a:pt x="1554" y="5848"/>
                      <a:pt x="1937" y="3165"/>
                    </a:cubicBezTo>
                    <a:cubicBezTo>
                      <a:pt x="2155" y="1599"/>
                      <a:pt x="1937" y="76"/>
                      <a:pt x="1393" y="11"/>
                    </a:cubicBezTo>
                    <a:cubicBezTo>
                      <a:pt x="1341" y="4"/>
                      <a:pt x="1291" y="0"/>
                      <a:pt x="1243" y="0"/>
                    </a:cubicBezTo>
                    <a:close/>
                  </a:path>
                </a:pathLst>
              </a:custGeom>
              <a:solidFill>
                <a:schemeClr val="dk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68" name="Google Shape;268;p14"/>
              <p:cNvSpPr/>
              <p:nvPr/>
            </p:nvSpPr>
            <p:spPr>
              <a:xfrm>
                <a:off x="-1217006" y="2835638"/>
                <a:ext cx="333276" cy="440202"/>
              </a:xfrm>
              <a:custGeom>
                <a:avLst/>
                <a:gdLst/>
                <a:ahLst/>
                <a:cxnLst/>
                <a:rect l="l" t="t" r="r" b="b"/>
                <a:pathLst>
                  <a:path w="4201" h="5549" extrusionOk="0">
                    <a:moveTo>
                      <a:pt x="4113" y="0"/>
                    </a:moveTo>
                    <a:lnTo>
                      <a:pt x="1" y="65"/>
                    </a:lnTo>
                    <a:lnTo>
                      <a:pt x="88" y="5549"/>
                    </a:lnTo>
                    <a:lnTo>
                      <a:pt x="4200" y="5483"/>
                    </a:lnTo>
                    <a:lnTo>
                      <a:pt x="4113" y="0"/>
                    </a:lnTo>
                    <a:close/>
                  </a:path>
                </a:pathLst>
              </a:custGeom>
              <a:solidFill>
                <a:schemeClr val="accent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69" name="Google Shape;269;p14"/>
              <p:cNvSpPr/>
              <p:nvPr/>
            </p:nvSpPr>
            <p:spPr>
              <a:xfrm>
                <a:off x="-1217006" y="2840794"/>
                <a:ext cx="333276" cy="435046"/>
              </a:xfrm>
              <a:custGeom>
                <a:avLst/>
                <a:gdLst/>
                <a:ahLst/>
                <a:cxnLst/>
                <a:rect l="l" t="t" r="r" b="b"/>
                <a:pathLst>
                  <a:path w="4201" h="5484" extrusionOk="0">
                    <a:moveTo>
                      <a:pt x="1" y="0"/>
                    </a:moveTo>
                    <a:lnTo>
                      <a:pt x="88" y="5484"/>
                    </a:lnTo>
                    <a:lnTo>
                      <a:pt x="4200" y="5418"/>
                    </a:lnTo>
                    <a:lnTo>
                      <a:pt x="4179" y="3917"/>
                    </a:lnTo>
                    <a:cubicBezTo>
                      <a:pt x="4179" y="3917"/>
                      <a:pt x="2351" y="3656"/>
                      <a:pt x="1633" y="2786"/>
                    </a:cubicBezTo>
                    <a:cubicBezTo>
                      <a:pt x="915" y="1915"/>
                      <a:pt x="675" y="22"/>
                      <a:pt x="675" y="22"/>
                    </a:cubicBezTo>
                    <a:lnTo>
                      <a:pt x="1" y="0"/>
                    </a:lnTo>
                    <a:close/>
                  </a:path>
                </a:pathLst>
              </a:custGeom>
              <a:solidFill>
                <a:srgbClr val="191919">
                  <a:alpha val="1761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70" name="Google Shape;270;p14"/>
              <p:cNvSpPr/>
              <p:nvPr/>
            </p:nvSpPr>
            <p:spPr>
              <a:xfrm>
                <a:off x="-1410254" y="3090286"/>
                <a:ext cx="485118" cy="145253"/>
              </a:xfrm>
              <a:custGeom>
                <a:avLst/>
                <a:gdLst/>
                <a:ahLst/>
                <a:cxnLst/>
                <a:rect l="l" t="t" r="r" b="b"/>
                <a:pathLst>
                  <a:path w="6115" h="1831" extrusionOk="0">
                    <a:moveTo>
                      <a:pt x="4965" y="0"/>
                    </a:moveTo>
                    <a:cubicBezTo>
                      <a:pt x="4233" y="0"/>
                      <a:pt x="3221" y="116"/>
                      <a:pt x="2306" y="141"/>
                    </a:cubicBezTo>
                    <a:cubicBezTo>
                      <a:pt x="696" y="184"/>
                      <a:pt x="0" y="446"/>
                      <a:pt x="218" y="1359"/>
                    </a:cubicBezTo>
                    <a:cubicBezTo>
                      <a:pt x="288" y="1640"/>
                      <a:pt x="630" y="1831"/>
                      <a:pt x="1215" y="1831"/>
                    </a:cubicBezTo>
                    <a:cubicBezTo>
                      <a:pt x="1537" y="1831"/>
                      <a:pt x="1931" y="1773"/>
                      <a:pt x="2393" y="1642"/>
                    </a:cubicBezTo>
                    <a:cubicBezTo>
                      <a:pt x="3917" y="1229"/>
                      <a:pt x="6114" y="663"/>
                      <a:pt x="5984" y="293"/>
                    </a:cubicBezTo>
                    <a:cubicBezTo>
                      <a:pt x="5918" y="68"/>
                      <a:pt x="5523" y="0"/>
                      <a:pt x="4965" y="0"/>
                    </a:cubicBezTo>
                    <a:close/>
                  </a:path>
                </a:pathLst>
              </a:custGeom>
              <a:solidFill>
                <a:srgbClr val="C09378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71" name="Google Shape;271;p14"/>
              <p:cNvSpPr/>
              <p:nvPr/>
            </p:nvSpPr>
            <p:spPr>
              <a:xfrm>
                <a:off x="-937368" y="3125588"/>
                <a:ext cx="63942" cy="22530"/>
              </a:xfrm>
              <a:custGeom>
                <a:avLst/>
                <a:gdLst/>
                <a:ahLst/>
                <a:cxnLst/>
                <a:rect l="l" t="t" r="r" b="b"/>
                <a:pathLst>
                  <a:path w="806" h="284" extrusionOk="0">
                    <a:moveTo>
                      <a:pt x="131" y="1"/>
                    </a:moveTo>
                    <a:cubicBezTo>
                      <a:pt x="44" y="1"/>
                      <a:pt x="1" y="66"/>
                      <a:pt x="1" y="131"/>
                    </a:cubicBezTo>
                    <a:cubicBezTo>
                      <a:pt x="1" y="218"/>
                      <a:pt x="44" y="262"/>
                      <a:pt x="110" y="262"/>
                    </a:cubicBezTo>
                    <a:lnTo>
                      <a:pt x="675" y="283"/>
                    </a:lnTo>
                    <a:cubicBezTo>
                      <a:pt x="741" y="283"/>
                      <a:pt x="806" y="218"/>
                      <a:pt x="806" y="153"/>
                    </a:cubicBezTo>
                    <a:cubicBezTo>
                      <a:pt x="806" y="88"/>
                      <a:pt x="741" y="22"/>
                      <a:pt x="675" y="22"/>
                    </a:cubicBezTo>
                    <a:lnTo>
                      <a:pt x="131" y="1"/>
                    </a:lnTo>
                    <a:close/>
                  </a:path>
                </a:pathLst>
              </a:custGeom>
              <a:solidFill>
                <a:srgbClr val="FFA47C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72" name="Google Shape;272;p14"/>
              <p:cNvSpPr/>
              <p:nvPr/>
            </p:nvSpPr>
            <p:spPr>
              <a:xfrm>
                <a:off x="-935623" y="3106628"/>
                <a:ext cx="63942" cy="22530"/>
              </a:xfrm>
              <a:custGeom>
                <a:avLst/>
                <a:gdLst/>
                <a:ahLst/>
                <a:cxnLst/>
                <a:rect l="l" t="t" r="r" b="b"/>
                <a:pathLst>
                  <a:path w="806" h="284" extrusionOk="0">
                    <a:moveTo>
                      <a:pt x="131" y="0"/>
                    </a:moveTo>
                    <a:cubicBezTo>
                      <a:pt x="66" y="0"/>
                      <a:pt x="1" y="66"/>
                      <a:pt x="1" y="131"/>
                    </a:cubicBezTo>
                    <a:cubicBezTo>
                      <a:pt x="1" y="218"/>
                      <a:pt x="44" y="261"/>
                      <a:pt x="131" y="261"/>
                    </a:cubicBezTo>
                    <a:lnTo>
                      <a:pt x="675" y="283"/>
                    </a:lnTo>
                    <a:cubicBezTo>
                      <a:pt x="740" y="283"/>
                      <a:pt x="806" y="218"/>
                      <a:pt x="806" y="153"/>
                    </a:cubicBezTo>
                    <a:cubicBezTo>
                      <a:pt x="806" y="87"/>
                      <a:pt x="740" y="22"/>
                      <a:pt x="675" y="22"/>
                    </a:cubicBezTo>
                    <a:lnTo>
                      <a:pt x="131" y="0"/>
                    </a:lnTo>
                    <a:close/>
                  </a:path>
                </a:pathLst>
              </a:custGeom>
              <a:solidFill>
                <a:srgbClr val="C09378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73" name="Google Shape;273;p14"/>
              <p:cNvSpPr/>
              <p:nvPr/>
            </p:nvSpPr>
            <p:spPr>
              <a:xfrm>
                <a:off x="-935623" y="3089334"/>
                <a:ext cx="63942" cy="20784"/>
              </a:xfrm>
              <a:custGeom>
                <a:avLst/>
                <a:gdLst/>
                <a:ahLst/>
                <a:cxnLst/>
                <a:rect l="l" t="t" r="r" b="b"/>
                <a:pathLst>
                  <a:path w="806" h="262" extrusionOk="0">
                    <a:moveTo>
                      <a:pt x="131" y="1"/>
                    </a:moveTo>
                    <a:cubicBezTo>
                      <a:pt x="66" y="1"/>
                      <a:pt x="1" y="44"/>
                      <a:pt x="1" y="131"/>
                    </a:cubicBezTo>
                    <a:cubicBezTo>
                      <a:pt x="1" y="196"/>
                      <a:pt x="66" y="240"/>
                      <a:pt x="131" y="240"/>
                    </a:cubicBezTo>
                    <a:lnTo>
                      <a:pt x="675" y="262"/>
                    </a:lnTo>
                    <a:cubicBezTo>
                      <a:pt x="762" y="262"/>
                      <a:pt x="806" y="196"/>
                      <a:pt x="806" y="131"/>
                    </a:cubicBezTo>
                    <a:cubicBezTo>
                      <a:pt x="806" y="66"/>
                      <a:pt x="762" y="1"/>
                      <a:pt x="697" y="1"/>
                    </a:cubicBezTo>
                    <a:close/>
                  </a:path>
                </a:pathLst>
              </a:custGeom>
              <a:solidFill>
                <a:srgbClr val="C09378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74" name="Google Shape;274;p14"/>
              <p:cNvSpPr/>
              <p:nvPr/>
            </p:nvSpPr>
            <p:spPr>
              <a:xfrm>
                <a:off x="-935623" y="3070374"/>
                <a:ext cx="63942" cy="20784"/>
              </a:xfrm>
              <a:custGeom>
                <a:avLst/>
                <a:gdLst/>
                <a:ahLst/>
                <a:cxnLst/>
                <a:rect l="l" t="t" r="r" b="b"/>
                <a:pathLst>
                  <a:path w="806" h="262" extrusionOk="0">
                    <a:moveTo>
                      <a:pt x="131" y="0"/>
                    </a:moveTo>
                    <a:cubicBezTo>
                      <a:pt x="66" y="0"/>
                      <a:pt x="1" y="66"/>
                      <a:pt x="1" y="131"/>
                    </a:cubicBezTo>
                    <a:cubicBezTo>
                      <a:pt x="1" y="196"/>
                      <a:pt x="66" y="261"/>
                      <a:pt x="131" y="261"/>
                    </a:cubicBezTo>
                    <a:lnTo>
                      <a:pt x="675" y="261"/>
                    </a:lnTo>
                    <a:cubicBezTo>
                      <a:pt x="740" y="261"/>
                      <a:pt x="806" y="218"/>
                      <a:pt x="806" y="153"/>
                    </a:cubicBezTo>
                    <a:cubicBezTo>
                      <a:pt x="806" y="66"/>
                      <a:pt x="740" y="22"/>
                      <a:pt x="675" y="22"/>
                    </a:cubicBezTo>
                    <a:lnTo>
                      <a:pt x="131" y="0"/>
                    </a:lnTo>
                    <a:close/>
                  </a:path>
                </a:pathLst>
              </a:custGeom>
              <a:solidFill>
                <a:srgbClr val="C09378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75" name="Google Shape;275;p14"/>
              <p:cNvSpPr/>
              <p:nvPr/>
            </p:nvSpPr>
            <p:spPr>
              <a:xfrm>
                <a:off x="-1025345" y="3063235"/>
                <a:ext cx="148510" cy="93689"/>
              </a:xfrm>
              <a:custGeom>
                <a:avLst/>
                <a:gdLst/>
                <a:ahLst/>
                <a:cxnLst/>
                <a:rect l="l" t="t" r="r" b="b"/>
                <a:pathLst>
                  <a:path w="1872" h="1181" extrusionOk="0">
                    <a:moveTo>
                      <a:pt x="1050" y="1"/>
                    </a:moveTo>
                    <a:cubicBezTo>
                      <a:pt x="1031" y="1"/>
                      <a:pt x="1014" y="2"/>
                      <a:pt x="1001" y="3"/>
                    </a:cubicBezTo>
                    <a:cubicBezTo>
                      <a:pt x="827" y="25"/>
                      <a:pt x="0" y="373"/>
                      <a:pt x="0" y="373"/>
                    </a:cubicBezTo>
                    <a:lnTo>
                      <a:pt x="370" y="1091"/>
                    </a:lnTo>
                    <a:cubicBezTo>
                      <a:pt x="370" y="1091"/>
                      <a:pt x="631" y="1156"/>
                      <a:pt x="914" y="1178"/>
                    </a:cubicBezTo>
                    <a:cubicBezTo>
                      <a:pt x="936" y="1180"/>
                      <a:pt x="959" y="1181"/>
                      <a:pt x="984" y="1181"/>
                    </a:cubicBezTo>
                    <a:cubicBezTo>
                      <a:pt x="1284" y="1181"/>
                      <a:pt x="1784" y="1069"/>
                      <a:pt x="1784" y="1069"/>
                    </a:cubicBezTo>
                    <a:cubicBezTo>
                      <a:pt x="1784" y="1069"/>
                      <a:pt x="1697" y="656"/>
                      <a:pt x="1675" y="504"/>
                    </a:cubicBezTo>
                    <a:cubicBezTo>
                      <a:pt x="1654" y="351"/>
                      <a:pt x="1871" y="112"/>
                      <a:pt x="1871" y="112"/>
                    </a:cubicBezTo>
                    <a:cubicBezTo>
                      <a:pt x="1871" y="112"/>
                      <a:pt x="1278" y="1"/>
                      <a:pt x="1050" y="1"/>
                    </a:cubicBezTo>
                    <a:close/>
                  </a:path>
                </a:pathLst>
              </a:custGeom>
              <a:solidFill>
                <a:srgbClr val="C09378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76" name="Google Shape;276;p14"/>
              <p:cNvSpPr/>
              <p:nvPr/>
            </p:nvSpPr>
            <p:spPr>
              <a:xfrm>
                <a:off x="-1172106" y="3066249"/>
                <a:ext cx="461001" cy="219347"/>
              </a:xfrm>
              <a:custGeom>
                <a:avLst/>
                <a:gdLst/>
                <a:ahLst/>
                <a:cxnLst/>
                <a:rect l="l" t="t" r="r" b="b"/>
                <a:pathLst>
                  <a:path w="5811" h="2765" extrusionOk="0">
                    <a:moveTo>
                      <a:pt x="433" y="0"/>
                    </a:moveTo>
                    <a:cubicBezTo>
                      <a:pt x="246" y="0"/>
                      <a:pt x="129" y="35"/>
                      <a:pt x="109" y="118"/>
                    </a:cubicBezTo>
                    <a:cubicBezTo>
                      <a:pt x="1" y="640"/>
                      <a:pt x="1741" y="1293"/>
                      <a:pt x="3090" y="2054"/>
                    </a:cubicBezTo>
                    <a:cubicBezTo>
                      <a:pt x="3857" y="2487"/>
                      <a:pt x="4518" y="2765"/>
                      <a:pt x="4990" y="2765"/>
                    </a:cubicBezTo>
                    <a:cubicBezTo>
                      <a:pt x="5348" y="2765"/>
                      <a:pt x="5598" y="2604"/>
                      <a:pt x="5701" y="2228"/>
                    </a:cubicBezTo>
                    <a:cubicBezTo>
                      <a:pt x="5810" y="1815"/>
                      <a:pt x="4983" y="1075"/>
                      <a:pt x="3721" y="749"/>
                    </a:cubicBezTo>
                    <a:cubicBezTo>
                      <a:pt x="2588" y="427"/>
                      <a:pt x="1086" y="0"/>
                      <a:pt x="433" y="0"/>
                    </a:cubicBezTo>
                    <a:close/>
                  </a:path>
                </a:pathLst>
              </a:custGeom>
              <a:solidFill>
                <a:srgbClr val="DAAA8E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77" name="Google Shape;277;p14"/>
              <p:cNvSpPr/>
              <p:nvPr/>
            </p:nvSpPr>
            <p:spPr>
              <a:xfrm>
                <a:off x="-1234221" y="3018572"/>
                <a:ext cx="146765" cy="107095"/>
              </a:xfrm>
              <a:custGeom>
                <a:avLst/>
                <a:gdLst/>
                <a:ahLst/>
                <a:cxnLst/>
                <a:rect l="l" t="t" r="r" b="b"/>
                <a:pathLst>
                  <a:path w="1850" h="1350" extrusionOk="0">
                    <a:moveTo>
                      <a:pt x="174" y="1"/>
                    </a:moveTo>
                    <a:cubicBezTo>
                      <a:pt x="174" y="1"/>
                      <a:pt x="327" y="283"/>
                      <a:pt x="261" y="436"/>
                    </a:cubicBezTo>
                    <a:cubicBezTo>
                      <a:pt x="196" y="566"/>
                      <a:pt x="0" y="936"/>
                      <a:pt x="0" y="936"/>
                    </a:cubicBezTo>
                    <a:cubicBezTo>
                      <a:pt x="0" y="936"/>
                      <a:pt x="501" y="1154"/>
                      <a:pt x="762" y="1241"/>
                    </a:cubicBezTo>
                    <a:cubicBezTo>
                      <a:pt x="1197" y="1350"/>
                      <a:pt x="1436" y="1350"/>
                      <a:pt x="1436" y="1350"/>
                    </a:cubicBezTo>
                    <a:lnTo>
                      <a:pt x="1850" y="675"/>
                    </a:lnTo>
                    <a:cubicBezTo>
                      <a:pt x="1850" y="675"/>
                      <a:pt x="1197" y="196"/>
                      <a:pt x="1045" y="131"/>
                    </a:cubicBezTo>
                    <a:cubicBezTo>
                      <a:pt x="871" y="66"/>
                      <a:pt x="175" y="1"/>
                      <a:pt x="174" y="1"/>
                    </a:cubicBezTo>
                    <a:close/>
                  </a:path>
                </a:pathLst>
              </a:custGeom>
              <a:solidFill>
                <a:srgbClr val="DAAA8E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6511699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 3">
  <p:cSld name="Title only 3">
    <p:spTree>
      <p:nvGrpSpPr>
        <p:cNvPr id="1" name="Shape 2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9" name="Google Shape;279;p15"/>
          <p:cNvSpPr txBox="1">
            <a:spLocks noGrp="1"/>
          </p:cNvSpPr>
          <p:nvPr>
            <p:ph type="title"/>
          </p:nvPr>
        </p:nvSpPr>
        <p:spPr>
          <a:xfrm>
            <a:off x="720000" y="593367"/>
            <a:ext cx="7704000" cy="763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1pPr>
            <a:lvl2pPr lvl="1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9pPr>
          </a:lstStyle>
          <a:p>
            <a:endParaRPr/>
          </a:p>
        </p:txBody>
      </p:sp>
      <p:sp>
        <p:nvSpPr>
          <p:cNvPr id="280" name="Google Shape;280;p15"/>
          <p:cNvSpPr/>
          <p:nvPr/>
        </p:nvSpPr>
        <p:spPr>
          <a:xfrm>
            <a:off x="-25" y="6127167"/>
            <a:ext cx="9144017" cy="787955"/>
          </a:xfrm>
          <a:custGeom>
            <a:avLst/>
            <a:gdLst/>
            <a:ahLst/>
            <a:cxnLst/>
            <a:rect l="l" t="t" r="r" b="b"/>
            <a:pathLst>
              <a:path w="81572" h="31202" extrusionOk="0">
                <a:moveTo>
                  <a:pt x="0" y="0"/>
                </a:moveTo>
                <a:lnTo>
                  <a:pt x="0" y="31201"/>
                </a:lnTo>
                <a:lnTo>
                  <a:pt x="81572" y="31201"/>
                </a:lnTo>
                <a:lnTo>
                  <a:pt x="81572" y="0"/>
                </a:lnTo>
                <a:close/>
              </a:path>
            </a:pathLst>
          </a:custGeom>
          <a:solidFill>
            <a:schemeClr val="dk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/>
          </a:p>
        </p:txBody>
      </p:sp>
      <p:grpSp>
        <p:nvGrpSpPr>
          <p:cNvPr id="281" name="Google Shape;281;p15"/>
          <p:cNvGrpSpPr/>
          <p:nvPr/>
        </p:nvGrpSpPr>
        <p:grpSpPr>
          <a:xfrm>
            <a:off x="8065566" y="2943374"/>
            <a:ext cx="1627556" cy="4087532"/>
            <a:chOff x="8082604" y="2207530"/>
            <a:chExt cx="1627556" cy="3065649"/>
          </a:xfrm>
        </p:grpSpPr>
        <p:sp>
          <p:nvSpPr>
            <p:cNvPr id="282" name="Google Shape;282;p15"/>
            <p:cNvSpPr/>
            <p:nvPr/>
          </p:nvSpPr>
          <p:spPr>
            <a:xfrm>
              <a:off x="8082604" y="4811475"/>
              <a:ext cx="1627556" cy="461704"/>
            </a:xfrm>
            <a:custGeom>
              <a:avLst/>
              <a:gdLst/>
              <a:ahLst/>
              <a:cxnLst/>
              <a:rect l="l" t="t" r="r" b="b"/>
              <a:pathLst>
                <a:path w="64014" h="9771" extrusionOk="0">
                  <a:moveTo>
                    <a:pt x="31876" y="1"/>
                  </a:moveTo>
                  <a:cubicBezTo>
                    <a:pt x="14187" y="1"/>
                    <a:pt x="1" y="2155"/>
                    <a:pt x="1" y="4875"/>
                  </a:cubicBezTo>
                  <a:cubicBezTo>
                    <a:pt x="1" y="7573"/>
                    <a:pt x="14339" y="9770"/>
                    <a:pt x="32007" y="9770"/>
                  </a:cubicBezTo>
                  <a:cubicBezTo>
                    <a:pt x="49674" y="9770"/>
                    <a:pt x="64013" y="7573"/>
                    <a:pt x="64013" y="4875"/>
                  </a:cubicBezTo>
                  <a:cubicBezTo>
                    <a:pt x="64013" y="2155"/>
                    <a:pt x="49544" y="1"/>
                    <a:pt x="31876" y="1"/>
                  </a:cubicBezTo>
                  <a:close/>
                </a:path>
              </a:pathLst>
            </a:custGeom>
            <a:solidFill>
              <a:srgbClr val="191919">
                <a:alpha val="17610"/>
              </a:srgb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grpSp>
          <p:nvGrpSpPr>
            <p:cNvPr id="283" name="Google Shape;283;p15"/>
            <p:cNvGrpSpPr/>
            <p:nvPr/>
          </p:nvGrpSpPr>
          <p:grpSpPr>
            <a:xfrm>
              <a:off x="8459555" y="2207530"/>
              <a:ext cx="873636" cy="2848835"/>
              <a:chOff x="9498975" y="3401300"/>
              <a:chExt cx="368825" cy="1202700"/>
            </a:xfrm>
          </p:grpSpPr>
          <p:sp>
            <p:nvSpPr>
              <p:cNvPr id="284" name="Google Shape;284;p15"/>
              <p:cNvSpPr/>
              <p:nvPr/>
            </p:nvSpPr>
            <p:spPr>
              <a:xfrm>
                <a:off x="9515825" y="4098100"/>
                <a:ext cx="31575" cy="38150"/>
              </a:xfrm>
              <a:custGeom>
                <a:avLst/>
                <a:gdLst/>
                <a:ahLst/>
                <a:cxnLst/>
                <a:rect l="l" t="t" r="r" b="b"/>
                <a:pathLst>
                  <a:path w="1263" h="1526" extrusionOk="0">
                    <a:moveTo>
                      <a:pt x="371" y="0"/>
                    </a:moveTo>
                    <a:cubicBezTo>
                      <a:pt x="371" y="0"/>
                      <a:pt x="1" y="152"/>
                      <a:pt x="23" y="305"/>
                    </a:cubicBezTo>
                    <a:cubicBezTo>
                      <a:pt x="45" y="435"/>
                      <a:pt x="327" y="805"/>
                      <a:pt x="436" y="958"/>
                    </a:cubicBezTo>
                    <a:cubicBezTo>
                      <a:pt x="545" y="1088"/>
                      <a:pt x="763" y="1306"/>
                      <a:pt x="871" y="1393"/>
                    </a:cubicBezTo>
                    <a:cubicBezTo>
                      <a:pt x="932" y="1454"/>
                      <a:pt x="1057" y="1525"/>
                      <a:pt x="1149" y="1525"/>
                    </a:cubicBezTo>
                    <a:cubicBezTo>
                      <a:pt x="1189" y="1525"/>
                      <a:pt x="1222" y="1512"/>
                      <a:pt x="1241" y="1480"/>
                    </a:cubicBezTo>
                    <a:cubicBezTo>
                      <a:pt x="1263" y="1436"/>
                      <a:pt x="1176" y="1197"/>
                      <a:pt x="1045" y="1088"/>
                    </a:cubicBezTo>
                    <a:cubicBezTo>
                      <a:pt x="937" y="979"/>
                      <a:pt x="763" y="849"/>
                      <a:pt x="675" y="718"/>
                    </a:cubicBezTo>
                    <a:cubicBezTo>
                      <a:pt x="567" y="588"/>
                      <a:pt x="371" y="0"/>
                      <a:pt x="371" y="0"/>
                    </a:cubicBezTo>
                    <a:close/>
                  </a:path>
                </a:pathLst>
              </a:custGeom>
              <a:solidFill>
                <a:srgbClr val="C09378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85" name="Google Shape;285;p15"/>
              <p:cNvSpPr/>
              <p:nvPr/>
            </p:nvSpPr>
            <p:spPr>
              <a:xfrm>
                <a:off x="9515300" y="4094275"/>
                <a:ext cx="37825" cy="25100"/>
              </a:xfrm>
              <a:custGeom>
                <a:avLst/>
                <a:gdLst/>
                <a:ahLst/>
                <a:cxnLst/>
                <a:rect l="l" t="t" r="r" b="b"/>
                <a:pathLst>
                  <a:path w="1513" h="1004" extrusionOk="0">
                    <a:moveTo>
                      <a:pt x="283" y="1"/>
                    </a:moveTo>
                    <a:cubicBezTo>
                      <a:pt x="283" y="1"/>
                      <a:pt x="0" y="240"/>
                      <a:pt x="66" y="349"/>
                    </a:cubicBezTo>
                    <a:cubicBezTo>
                      <a:pt x="109" y="458"/>
                      <a:pt x="457" y="719"/>
                      <a:pt x="588" y="828"/>
                    </a:cubicBezTo>
                    <a:cubicBezTo>
                      <a:pt x="740" y="915"/>
                      <a:pt x="1001" y="980"/>
                      <a:pt x="1153" y="1002"/>
                    </a:cubicBezTo>
                    <a:cubicBezTo>
                      <a:pt x="1186" y="1002"/>
                      <a:pt x="1225" y="1003"/>
                      <a:pt x="1266" y="1003"/>
                    </a:cubicBezTo>
                    <a:cubicBezTo>
                      <a:pt x="1386" y="1003"/>
                      <a:pt x="1512" y="991"/>
                      <a:pt x="1480" y="893"/>
                    </a:cubicBezTo>
                    <a:cubicBezTo>
                      <a:pt x="1458" y="762"/>
                      <a:pt x="1284" y="675"/>
                      <a:pt x="1132" y="654"/>
                    </a:cubicBezTo>
                    <a:cubicBezTo>
                      <a:pt x="958" y="610"/>
                      <a:pt x="871" y="632"/>
                      <a:pt x="740" y="545"/>
                    </a:cubicBezTo>
                    <a:cubicBezTo>
                      <a:pt x="631" y="458"/>
                      <a:pt x="283" y="1"/>
                      <a:pt x="283" y="1"/>
                    </a:cubicBezTo>
                    <a:close/>
                  </a:path>
                </a:pathLst>
              </a:custGeom>
              <a:solidFill>
                <a:srgbClr val="C09378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86" name="Google Shape;286;p15"/>
              <p:cNvSpPr/>
              <p:nvPr/>
            </p:nvSpPr>
            <p:spPr>
              <a:xfrm>
                <a:off x="9516925" y="4092100"/>
                <a:ext cx="34300" cy="17650"/>
              </a:xfrm>
              <a:custGeom>
                <a:avLst/>
                <a:gdLst/>
                <a:ahLst/>
                <a:cxnLst/>
                <a:rect l="l" t="t" r="r" b="b"/>
                <a:pathLst>
                  <a:path w="1372" h="706" extrusionOk="0">
                    <a:moveTo>
                      <a:pt x="218" y="1"/>
                    </a:moveTo>
                    <a:cubicBezTo>
                      <a:pt x="218" y="1"/>
                      <a:pt x="1" y="240"/>
                      <a:pt x="66" y="327"/>
                    </a:cubicBezTo>
                    <a:cubicBezTo>
                      <a:pt x="131" y="414"/>
                      <a:pt x="457" y="567"/>
                      <a:pt x="588" y="632"/>
                    </a:cubicBezTo>
                    <a:cubicBezTo>
                      <a:pt x="686" y="681"/>
                      <a:pt x="845" y="705"/>
                      <a:pt x="974" y="705"/>
                    </a:cubicBezTo>
                    <a:cubicBezTo>
                      <a:pt x="1016" y="705"/>
                      <a:pt x="1056" y="703"/>
                      <a:pt x="1088" y="697"/>
                    </a:cubicBezTo>
                    <a:cubicBezTo>
                      <a:pt x="1197" y="675"/>
                      <a:pt x="1371" y="675"/>
                      <a:pt x="1350" y="567"/>
                    </a:cubicBezTo>
                    <a:cubicBezTo>
                      <a:pt x="1306" y="458"/>
                      <a:pt x="1132" y="414"/>
                      <a:pt x="1001" y="414"/>
                    </a:cubicBezTo>
                    <a:cubicBezTo>
                      <a:pt x="925" y="414"/>
                      <a:pt x="871" y="420"/>
                      <a:pt x="822" y="420"/>
                    </a:cubicBezTo>
                    <a:cubicBezTo>
                      <a:pt x="773" y="420"/>
                      <a:pt x="729" y="414"/>
                      <a:pt x="675" y="392"/>
                    </a:cubicBezTo>
                    <a:cubicBezTo>
                      <a:pt x="566" y="327"/>
                      <a:pt x="218" y="1"/>
                      <a:pt x="218" y="1"/>
                    </a:cubicBezTo>
                    <a:close/>
                  </a:path>
                </a:pathLst>
              </a:custGeom>
              <a:solidFill>
                <a:srgbClr val="C09378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87" name="Google Shape;287;p15"/>
              <p:cNvSpPr/>
              <p:nvPr/>
            </p:nvSpPr>
            <p:spPr>
              <a:xfrm>
                <a:off x="9506050" y="4012700"/>
                <a:ext cx="59850" cy="136675"/>
              </a:xfrm>
              <a:custGeom>
                <a:avLst/>
                <a:gdLst/>
                <a:ahLst/>
                <a:cxnLst/>
                <a:rect l="l" t="t" r="r" b="b"/>
                <a:pathLst>
                  <a:path w="2394" h="5467" extrusionOk="0">
                    <a:moveTo>
                      <a:pt x="1567" y="0"/>
                    </a:moveTo>
                    <a:lnTo>
                      <a:pt x="283" y="218"/>
                    </a:lnTo>
                    <a:cubicBezTo>
                      <a:pt x="283" y="218"/>
                      <a:pt x="240" y="1980"/>
                      <a:pt x="283" y="2067"/>
                    </a:cubicBezTo>
                    <a:cubicBezTo>
                      <a:pt x="327" y="2132"/>
                      <a:pt x="0" y="3307"/>
                      <a:pt x="44" y="3547"/>
                    </a:cubicBezTo>
                    <a:cubicBezTo>
                      <a:pt x="87" y="3764"/>
                      <a:pt x="283" y="4526"/>
                      <a:pt x="327" y="4569"/>
                    </a:cubicBezTo>
                    <a:cubicBezTo>
                      <a:pt x="348" y="4613"/>
                      <a:pt x="762" y="5004"/>
                      <a:pt x="979" y="5135"/>
                    </a:cubicBezTo>
                    <a:cubicBezTo>
                      <a:pt x="1179" y="5255"/>
                      <a:pt x="1306" y="5467"/>
                      <a:pt x="1359" y="5467"/>
                    </a:cubicBezTo>
                    <a:cubicBezTo>
                      <a:pt x="1363" y="5467"/>
                      <a:pt x="1368" y="5465"/>
                      <a:pt x="1371" y="5461"/>
                    </a:cubicBezTo>
                    <a:cubicBezTo>
                      <a:pt x="1436" y="5418"/>
                      <a:pt x="1502" y="5374"/>
                      <a:pt x="1458" y="5244"/>
                    </a:cubicBezTo>
                    <a:cubicBezTo>
                      <a:pt x="1436" y="5113"/>
                      <a:pt x="1284" y="4961"/>
                      <a:pt x="1175" y="4830"/>
                    </a:cubicBezTo>
                    <a:cubicBezTo>
                      <a:pt x="1066" y="4700"/>
                      <a:pt x="805" y="4439"/>
                      <a:pt x="740" y="4286"/>
                    </a:cubicBezTo>
                    <a:cubicBezTo>
                      <a:pt x="675" y="4112"/>
                      <a:pt x="740" y="3743"/>
                      <a:pt x="762" y="3460"/>
                    </a:cubicBezTo>
                    <a:cubicBezTo>
                      <a:pt x="784" y="3286"/>
                      <a:pt x="1132" y="2894"/>
                      <a:pt x="1262" y="2872"/>
                    </a:cubicBezTo>
                    <a:cubicBezTo>
                      <a:pt x="1274" y="2869"/>
                      <a:pt x="1285" y="2867"/>
                      <a:pt x="1296" y="2867"/>
                    </a:cubicBezTo>
                    <a:cubicBezTo>
                      <a:pt x="1434" y="2867"/>
                      <a:pt x="1547" y="3103"/>
                      <a:pt x="1567" y="3264"/>
                    </a:cubicBezTo>
                    <a:cubicBezTo>
                      <a:pt x="1610" y="3460"/>
                      <a:pt x="1785" y="3786"/>
                      <a:pt x="1959" y="3895"/>
                    </a:cubicBezTo>
                    <a:cubicBezTo>
                      <a:pt x="2053" y="3949"/>
                      <a:pt x="2172" y="3986"/>
                      <a:pt x="2254" y="3986"/>
                    </a:cubicBezTo>
                    <a:cubicBezTo>
                      <a:pt x="2305" y="3986"/>
                      <a:pt x="2342" y="3972"/>
                      <a:pt x="2350" y="3938"/>
                    </a:cubicBezTo>
                    <a:cubicBezTo>
                      <a:pt x="2394" y="3808"/>
                      <a:pt x="2111" y="3525"/>
                      <a:pt x="2067" y="3177"/>
                    </a:cubicBezTo>
                    <a:cubicBezTo>
                      <a:pt x="2024" y="2981"/>
                      <a:pt x="2024" y="2437"/>
                      <a:pt x="1806" y="2111"/>
                    </a:cubicBezTo>
                    <a:cubicBezTo>
                      <a:pt x="1676" y="1915"/>
                      <a:pt x="1523" y="1697"/>
                      <a:pt x="1458" y="1501"/>
                    </a:cubicBezTo>
                    <a:cubicBezTo>
                      <a:pt x="1371" y="1306"/>
                      <a:pt x="1567" y="0"/>
                      <a:pt x="1567" y="0"/>
                    </a:cubicBezTo>
                    <a:close/>
                  </a:path>
                </a:pathLst>
              </a:custGeom>
              <a:solidFill>
                <a:srgbClr val="DAAA8E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88" name="Google Shape;288;p15"/>
              <p:cNvSpPr/>
              <p:nvPr/>
            </p:nvSpPr>
            <p:spPr>
              <a:xfrm>
                <a:off x="9498975" y="3614525"/>
                <a:ext cx="75625" cy="440625"/>
              </a:xfrm>
              <a:custGeom>
                <a:avLst/>
                <a:gdLst/>
                <a:ahLst/>
                <a:cxnLst/>
                <a:rect l="l" t="t" r="r" b="b"/>
                <a:pathLst>
                  <a:path w="3025" h="17625" extrusionOk="0">
                    <a:moveTo>
                      <a:pt x="1654" y="0"/>
                    </a:moveTo>
                    <a:cubicBezTo>
                      <a:pt x="1654" y="0"/>
                      <a:pt x="958" y="109"/>
                      <a:pt x="784" y="1023"/>
                    </a:cubicBezTo>
                    <a:cubicBezTo>
                      <a:pt x="240" y="3569"/>
                      <a:pt x="175" y="9052"/>
                      <a:pt x="109" y="9356"/>
                    </a:cubicBezTo>
                    <a:cubicBezTo>
                      <a:pt x="66" y="9683"/>
                      <a:pt x="0" y="11597"/>
                      <a:pt x="0" y="12315"/>
                    </a:cubicBezTo>
                    <a:cubicBezTo>
                      <a:pt x="22" y="13033"/>
                      <a:pt x="262" y="17494"/>
                      <a:pt x="262" y="17494"/>
                    </a:cubicBezTo>
                    <a:lnTo>
                      <a:pt x="2046" y="17624"/>
                    </a:lnTo>
                    <a:cubicBezTo>
                      <a:pt x="2046" y="17624"/>
                      <a:pt x="2742" y="14078"/>
                      <a:pt x="2851" y="13033"/>
                    </a:cubicBezTo>
                    <a:cubicBezTo>
                      <a:pt x="2960" y="11967"/>
                      <a:pt x="3025" y="6136"/>
                      <a:pt x="3025" y="6136"/>
                    </a:cubicBezTo>
                    <a:cubicBezTo>
                      <a:pt x="3025" y="6136"/>
                      <a:pt x="2285" y="348"/>
                      <a:pt x="1654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89" name="Google Shape;289;p15"/>
              <p:cNvSpPr/>
              <p:nvPr/>
            </p:nvSpPr>
            <p:spPr>
              <a:xfrm>
                <a:off x="9637675" y="3572100"/>
                <a:ext cx="94675" cy="33200"/>
              </a:xfrm>
              <a:custGeom>
                <a:avLst/>
                <a:gdLst/>
                <a:ahLst/>
                <a:cxnLst/>
                <a:rect l="l" t="t" r="r" b="b"/>
                <a:pathLst>
                  <a:path w="3787" h="1328" extrusionOk="0">
                    <a:moveTo>
                      <a:pt x="1" y="0"/>
                    </a:moveTo>
                    <a:lnTo>
                      <a:pt x="1" y="1327"/>
                    </a:lnTo>
                    <a:lnTo>
                      <a:pt x="3787" y="1327"/>
                    </a:lnTo>
                    <a:lnTo>
                      <a:pt x="3787" y="0"/>
                    </a:lnTo>
                    <a:close/>
                  </a:path>
                </a:pathLst>
              </a:custGeom>
              <a:solidFill>
                <a:schemeClr val="l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90" name="Google Shape;290;p15"/>
              <p:cNvSpPr/>
              <p:nvPr/>
            </p:nvSpPr>
            <p:spPr>
              <a:xfrm>
                <a:off x="9528350" y="3588950"/>
                <a:ext cx="313350" cy="454775"/>
              </a:xfrm>
              <a:custGeom>
                <a:avLst/>
                <a:gdLst/>
                <a:ahLst/>
                <a:cxnLst/>
                <a:rect l="l" t="t" r="r" b="b"/>
                <a:pathLst>
                  <a:path w="12534" h="18191" extrusionOk="0">
                    <a:moveTo>
                      <a:pt x="6289" y="1"/>
                    </a:moveTo>
                    <a:lnTo>
                      <a:pt x="6289" y="66"/>
                    </a:lnTo>
                    <a:cubicBezTo>
                      <a:pt x="6289" y="66"/>
                      <a:pt x="2372" y="392"/>
                      <a:pt x="1023" y="1197"/>
                    </a:cubicBezTo>
                    <a:cubicBezTo>
                      <a:pt x="0" y="1828"/>
                      <a:pt x="1785" y="5592"/>
                      <a:pt x="2459" y="7681"/>
                    </a:cubicBezTo>
                    <a:cubicBezTo>
                      <a:pt x="2633" y="8182"/>
                      <a:pt x="2611" y="10444"/>
                      <a:pt x="2546" y="12446"/>
                    </a:cubicBezTo>
                    <a:cubicBezTo>
                      <a:pt x="2524" y="12925"/>
                      <a:pt x="2133" y="15188"/>
                      <a:pt x="2198" y="16145"/>
                    </a:cubicBezTo>
                    <a:cubicBezTo>
                      <a:pt x="2220" y="16406"/>
                      <a:pt x="5375" y="18147"/>
                      <a:pt x="6245" y="18190"/>
                    </a:cubicBezTo>
                    <a:lnTo>
                      <a:pt x="6245" y="18125"/>
                    </a:lnTo>
                    <a:cubicBezTo>
                      <a:pt x="7137" y="18082"/>
                      <a:pt x="10314" y="16363"/>
                      <a:pt x="10314" y="16080"/>
                    </a:cubicBezTo>
                    <a:cubicBezTo>
                      <a:pt x="10401" y="15144"/>
                      <a:pt x="9987" y="12881"/>
                      <a:pt x="9987" y="12381"/>
                    </a:cubicBezTo>
                    <a:cubicBezTo>
                      <a:pt x="9922" y="10379"/>
                      <a:pt x="9900" y="8138"/>
                      <a:pt x="10074" y="7638"/>
                    </a:cubicBezTo>
                    <a:cubicBezTo>
                      <a:pt x="10749" y="5527"/>
                      <a:pt x="12533" y="1937"/>
                      <a:pt x="11489" y="1328"/>
                    </a:cubicBezTo>
                    <a:cubicBezTo>
                      <a:pt x="10140" y="501"/>
                      <a:pt x="6289" y="1"/>
                      <a:pt x="6289" y="1"/>
                    </a:cubicBezTo>
                    <a:close/>
                  </a:path>
                </a:pathLst>
              </a:custGeom>
              <a:solidFill>
                <a:srgbClr val="DAAA8E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91" name="Google Shape;291;p15"/>
              <p:cNvSpPr/>
              <p:nvPr/>
            </p:nvSpPr>
            <p:spPr>
              <a:xfrm>
                <a:off x="9819375" y="4093200"/>
                <a:ext cx="31575" cy="38150"/>
              </a:xfrm>
              <a:custGeom>
                <a:avLst/>
                <a:gdLst/>
                <a:ahLst/>
                <a:cxnLst/>
                <a:rect l="l" t="t" r="r" b="b"/>
                <a:pathLst>
                  <a:path w="1263" h="1526" extrusionOk="0">
                    <a:moveTo>
                      <a:pt x="892" y="0"/>
                    </a:moveTo>
                    <a:cubicBezTo>
                      <a:pt x="892" y="0"/>
                      <a:pt x="696" y="588"/>
                      <a:pt x="588" y="718"/>
                    </a:cubicBezTo>
                    <a:cubicBezTo>
                      <a:pt x="500" y="849"/>
                      <a:pt x="326" y="979"/>
                      <a:pt x="218" y="1088"/>
                    </a:cubicBezTo>
                    <a:cubicBezTo>
                      <a:pt x="87" y="1197"/>
                      <a:pt x="0" y="1436"/>
                      <a:pt x="22" y="1480"/>
                    </a:cubicBezTo>
                    <a:cubicBezTo>
                      <a:pt x="41" y="1512"/>
                      <a:pt x="75" y="1526"/>
                      <a:pt x="114" y="1526"/>
                    </a:cubicBezTo>
                    <a:cubicBezTo>
                      <a:pt x="206" y="1526"/>
                      <a:pt x="331" y="1454"/>
                      <a:pt x="392" y="1393"/>
                    </a:cubicBezTo>
                    <a:cubicBezTo>
                      <a:pt x="500" y="1306"/>
                      <a:pt x="718" y="1110"/>
                      <a:pt x="827" y="958"/>
                    </a:cubicBezTo>
                    <a:cubicBezTo>
                      <a:pt x="936" y="805"/>
                      <a:pt x="1219" y="435"/>
                      <a:pt x="1240" y="305"/>
                    </a:cubicBezTo>
                    <a:cubicBezTo>
                      <a:pt x="1262" y="153"/>
                      <a:pt x="892" y="0"/>
                      <a:pt x="892" y="0"/>
                    </a:cubicBezTo>
                    <a:close/>
                  </a:path>
                </a:pathLst>
              </a:custGeom>
              <a:solidFill>
                <a:srgbClr val="C09378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92" name="Google Shape;292;p15"/>
              <p:cNvSpPr/>
              <p:nvPr/>
            </p:nvSpPr>
            <p:spPr>
              <a:xfrm>
                <a:off x="9813650" y="4089400"/>
                <a:ext cx="37825" cy="25075"/>
              </a:xfrm>
              <a:custGeom>
                <a:avLst/>
                <a:gdLst/>
                <a:ahLst/>
                <a:cxnLst/>
                <a:rect l="l" t="t" r="r" b="b"/>
                <a:pathLst>
                  <a:path w="1513" h="1003" extrusionOk="0">
                    <a:moveTo>
                      <a:pt x="1230" y="0"/>
                    </a:moveTo>
                    <a:cubicBezTo>
                      <a:pt x="1230" y="0"/>
                      <a:pt x="882" y="457"/>
                      <a:pt x="773" y="544"/>
                    </a:cubicBezTo>
                    <a:cubicBezTo>
                      <a:pt x="642" y="631"/>
                      <a:pt x="555" y="609"/>
                      <a:pt x="381" y="653"/>
                    </a:cubicBezTo>
                    <a:cubicBezTo>
                      <a:pt x="229" y="675"/>
                      <a:pt x="55" y="762"/>
                      <a:pt x="33" y="892"/>
                    </a:cubicBezTo>
                    <a:cubicBezTo>
                      <a:pt x="1" y="990"/>
                      <a:pt x="127" y="1002"/>
                      <a:pt x="238" y="1002"/>
                    </a:cubicBezTo>
                    <a:cubicBezTo>
                      <a:pt x="275" y="1002"/>
                      <a:pt x="311" y="1001"/>
                      <a:pt x="338" y="1001"/>
                    </a:cubicBezTo>
                    <a:cubicBezTo>
                      <a:pt x="512" y="1001"/>
                      <a:pt x="773" y="914"/>
                      <a:pt x="925" y="827"/>
                    </a:cubicBezTo>
                    <a:cubicBezTo>
                      <a:pt x="1056" y="718"/>
                      <a:pt x="1404" y="457"/>
                      <a:pt x="1448" y="348"/>
                    </a:cubicBezTo>
                    <a:cubicBezTo>
                      <a:pt x="1513" y="239"/>
                      <a:pt x="1230" y="0"/>
                      <a:pt x="1230" y="0"/>
                    </a:cubicBezTo>
                    <a:close/>
                  </a:path>
                </a:pathLst>
              </a:custGeom>
              <a:solidFill>
                <a:srgbClr val="C09378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93" name="Google Shape;293;p15"/>
              <p:cNvSpPr/>
              <p:nvPr/>
            </p:nvSpPr>
            <p:spPr>
              <a:xfrm>
                <a:off x="9815550" y="4087200"/>
                <a:ext cx="34300" cy="17650"/>
              </a:xfrm>
              <a:custGeom>
                <a:avLst/>
                <a:gdLst/>
                <a:ahLst/>
                <a:cxnLst/>
                <a:rect l="l" t="t" r="r" b="b"/>
                <a:pathLst>
                  <a:path w="1372" h="706" extrusionOk="0">
                    <a:moveTo>
                      <a:pt x="1154" y="1"/>
                    </a:moveTo>
                    <a:cubicBezTo>
                      <a:pt x="1154" y="1"/>
                      <a:pt x="806" y="327"/>
                      <a:pt x="697" y="393"/>
                    </a:cubicBezTo>
                    <a:cubicBezTo>
                      <a:pt x="643" y="414"/>
                      <a:pt x="599" y="420"/>
                      <a:pt x="550" y="420"/>
                    </a:cubicBezTo>
                    <a:cubicBezTo>
                      <a:pt x="501" y="420"/>
                      <a:pt x="447" y="414"/>
                      <a:pt x="371" y="414"/>
                    </a:cubicBezTo>
                    <a:cubicBezTo>
                      <a:pt x="240" y="414"/>
                      <a:pt x="66" y="458"/>
                      <a:pt x="23" y="567"/>
                    </a:cubicBezTo>
                    <a:cubicBezTo>
                      <a:pt x="1" y="675"/>
                      <a:pt x="175" y="675"/>
                      <a:pt x="284" y="697"/>
                    </a:cubicBezTo>
                    <a:cubicBezTo>
                      <a:pt x="316" y="703"/>
                      <a:pt x="356" y="705"/>
                      <a:pt x="399" y="705"/>
                    </a:cubicBezTo>
                    <a:cubicBezTo>
                      <a:pt x="527" y="705"/>
                      <a:pt x="686" y="681"/>
                      <a:pt x="784" y="632"/>
                    </a:cubicBezTo>
                    <a:cubicBezTo>
                      <a:pt x="915" y="567"/>
                      <a:pt x="1241" y="414"/>
                      <a:pt x="1306" y="327"/>
                    </a:cubicBezTo>
                    <a:cubicBezTo>
                      <a:pt x="1372" y="240"/>
                      <a:pt x="1154" y="1"/>
                      <a:pt x="1154" y="1"/>
                    </a:cubicBezTo>
                    <a:close/>
                  </a:path>
                </a:pathLst>
              </a:custGeom>
              <a:solidFill>
                <a:srgbClr val="C09378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94" name="Google Shape;294;p15"/>
              <p:cNvSpPr/>
              <p:nvPr/>
            </p:nvSpPr>
            <p:spPr>
              <a:xfrm>
                <a:off x="9800875" y="4007800"/>
                <a:ext cx="59850" cy="136675"/>
              </a:xfrm>
              <a:custGeom>
                <a:avLst/>
                <a:gdLst/>
                <a:ahLst/>
                <a:cxnLst/>
                <a:rect l="l" t="t" r="r" b="b"/>
                <a:pathLst>
                  <a:path w="2394" h="5467" extrusionOk="0">
                    <a:moveTo>
                      <a:pt x="805" y="0"/>
                    </a:moveTo>
                    <a:cubicBezTo>
                      <a:pt x="805" y="0"/>
                      <a:pt x="1023" y="1306"/>
                      <a:pt x="936" y="1502"/>
                    </a:cubicBezTo>
                    <a:cubicBezTo>
                      <a:pt x="871" y="1697"/>
                      <a:pt x="718" y="1915"/>
                      <a:pt x="588" y="2111"/>
                    </a:cubicBezTo>
                    <a:cubicBezTo>
                      <a:pt x="370" y="2437"/>
                      <a:pt x="370" y="2981"/>
                      <a:pt x="327" y="3177"/>
                    </a:cubicBezTo>
                    <a:cubicBezTo>
                      <a:pt x="283" y="3525"/>
                      <a:pt x="0" y="3808"/>
                      <a:pt x="44" y="3939"/>
                    </a:cubicBezTo>
                    <a:cubicBezTo>
                      <a:pt x="52" y="3972"/>
                      <a:pt x="89" y="3986"/>
                      <a:pt x="140" y="3986"/>
                    </a:cubicBezTo>
                    <a:cubicBezTo>
                      <a:pt x="222" y="3986"/>
                      <a:pt x="341" y="3949"/>
                      <a:pt x="435" y="3895"/>
                    </a:cubicBezTo>
                    <a:cubicBezTo>
                      <a:pt x="610" y="3786"/>
                      <a:pt x="784" y="3460"/>
                      <a:pt x="805" y="3264"/>
                    </a:cubicBezTo>
                    <a:cubicBezTo>
                      <a:pt x="846" y="3103"/>
                      <a:pt x="960" y="2868"/>
                      <a:pt x="1098" y="2868"/>
                    </a:cubicBezTo>
                    <a:cubicBezTo>
                      <a:pt x="1109" y="2868"/>
                      <a:pt x="1120" y="2869"/>
                      <a:pt x="1132" y="2872"/>
                    </a:cubicBezTo>
                    <a:cubicBezTo>
                      <a:pt x="1262" y="2894"/>
                      <a:pt x="1610" y="3286"/>
                      <a:pt x="1632" y="3460"/>
                    </a:cubicBezTo>
                    <a:cubicBezTo>
                      <a:pt x="1654" y="3743"/>
                      <a:pt x="1719" y="4113"/>
                      <a:pt x="1654" y="4287"/>
                    </a:cubicBezTo>
                    <a:cubicBezTo>
                      <a:pt x="1589" y="4439"/>
                      <a:pt x="1328" y="4700"/>
                      <a:pt x="1219" y="4831"/>
                    </a:cubicBezTo>
                    <a:cubicBezTo>
                      <a:pt x="1110" y="4961"/>
                      <a:pt x="958" y="5113"/>
                      <a:pt x="936" y="5244"/>
                    </a:cubicBezTo>
                    <a:cubicBezTo>
                      <a:pt x="892" y="5375"/>
                      <a:pt x="958" y="5418"/>
                      <a:pt x="1023" y="5462"/>
                    </a:cubicBezTo>
                    <a:cubicBezTo>
                      <a:pt x="1026" y="5465"/>
                      <a:pt x="1031" y="5467"/>
                      <a:pt x="1035" y="5467"/>
                    </a:cubicBezTo>
                    <a:cubicBezTo>
                      <a:pt x="1088" y="5467"/>
                      <a:pt x="1215" y="5255"/>
                      <a:pt x="1415" y="5135"/>
                    </a:cubicBezTo>
                    <a:cubicBezTo>
                      <a:pt x="1632" y="5005"/>
                      <a:pt x="2046" y="4613"/>
                      <a:pt x="2067" y="4570"/>
                    </a:cubicBezTo>
                    <a:cubicBezTo>
                      <a:pt x="2111" y="4526"/>
                      <a:pt x="2285" y="3764"/>
                      <a:pt x="2350" y="3547"/>
                    </a:cubicBezTo>
                    <a:cubicBezTo>
                      <a:pt x="2394" y="3308"/>
                      <a:pt x="2067" y="2133"/>
                      <a:pt x="2111" y="2067"/>
                    </a:cubicBezTo>
                    <a:cubicBezTo>
                      <a:pt x="2154" y="1980"/>
                      <a:pt x="2111" y="218"/>
                      <a:pt x="2111" y="218"/>
                    </a:cubicBezTo>
                    <a:lnTo>
                      <a:pt x="805" y="0"/>
                    </a:lnTo>
                    <a:close/>
                  </a:path>
                </a:pathLst>
              </a:custGeom>
              <a:solidFill>
                <a:srgbClr val="DAAA8E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95" name="Google Shape;295;p15"/>
              <p:cNvSpPr/>
              <p:nvPr/>
            </p:nvSpPr>
            <p:spPr>
              <a:xfrm>
                <a:off x="9792175" y="3609625"/>
                <a:ext cx="75625" cy="440625"/>
              </a:xfrm>
              <a:custGeom>
                <a:avLst/>
                <a:gdLst/>
                <a:ahLst/>
                <a:cxnLst/>
                <a:rect l="l" t="t" r="r" b="b"/>
                <a:pathLst>
                  <a:path w="3025" h="17625" extrusionOk="0">
                    <a:moveTo>
                      <a:pt x="1371" y="0"/>
                    </a:moveTo>
                    <a:cubicBezTo>
                      <a:pt x="740" y="349"/>
                      <a:pt x="0" y="6136"/>
                      <a:pt x="0" y="6136"/>
                    </a:cubicBezTo>
                    <a:cubicBezTo>
                      <a:pt x="0" y="6136"/>
                      <a:pt x="65" y="11967"/>
                      <a:pt x="174" y="13033"/>
                    </a:cubicBezTo>
                    <a:cubicBezTo>
                      <a:pt x="283" y="14078"/>
                      <a:pt x="979" y="17624"/>
                      <a:pt x="979" y="17624"/>
                    </a:cubicBezTo>
                    <a:lnTo>
                      <a:pt x="2763" y="17494"/>
                    </a:lnTo>
                    <a:cubicBezTo>
                      <a:pt x="2763" y="17494"/>
                      <a:pt x="3003" y="13033"/>
                      <a:pt x="3025" y="12315"/>
                    </a:cubicBezTo>
                    <a:cubicBezTo>
                      <a:pt x="3025" y="11597"/>
                      <a:pt x="2959" y="9683"/>
                      <a:pt x="2916" y="9356"/>
                    </a:cubicBezTo>
                    <a:cubicBezTo>
                      <a:pt x="2850" y="9052"/>
                      <a:pt x="2785" y="3569"/>
                      <a:pt x="2241" y="1023"/>
                    </a:cubicBezTo>
                    <a:cubicBezTo>
                      <a:pt x="2067" y="109"/>
                      <a:pt x="1371" y="0"/>
                      <a:pt x="1371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96" name="Google Shape;296;p15"/>
              <p:cNvSpPr/>
              <p:nvPr/>
            </p:nvSpPr>
            <p:spPr>
              <a:xfrm>
                <a:off x="9615925" y="3513875"/>
                <a:ext cx="138725" cy="85975"/>
              </a:xfrm>
              <a:custGeom>
                <a:avLst/>
                <a:gdLst/>
                <a:ahLst/>
                <a:cxnLst/>
                <a:rect l="l" t="t" r="r" b="b"/>
                <a:pathLst>
                  <a:path w="5549" h="3439" extrusionOk="0">
                    <a:moveTo>
                      <a:pt x="2786" y="1"/>
                    </a:moveTo>
                    <a:lnTo>
                      <a:pt x="2786" y="66"/>
                    </a:lnTo>
                    <a:lnTo>
                      <a:pt x="1480" y="66"/>
                    </a:lnTo>
                    <a:cubicBezTo>
                      <a:pt x="1480" y="66"/>
                      <a:pt x="1262" y="2046"/>
                      <a:pt x="1154" y="2438"/>
                    </a:cubicBezTo>
                    <a:cubicBezTo>
                      <a:pt x="1067" y="2851"/>
                      <a:pt x="0" y="3439"/>
                      <a:pt x="0" y="3439"/>
                    </a:cubicBezTo>
                    <a:lnTo>
                      <a:pt x="2786" y="3439"/>
                    </a:lnTo>
                    <a:lnTo>
                      <a:pt x="2786" y="3373"/>
                    </a:lnTo>
                    <a:lnTo>
                      <a:pt x="5549" y="3373"/>
                    </a:lnTo>
                    <a:cubicBezTo>
                      <a:pt x="5549" y="3373"/>
                      <a:pt x="4483" y="2786"/>
                      <a:pt x="4396" y="2373"/>
                    </a:cubicBezTo>
                    <a:cubicBezTo>
                      <a:pt x="4309" y="1981"/>
                      <a:pt x="4091" y="1"/>
                      <a:pt x="4091" y="1"/>
                    </a:cubicBezTo>
                    <a:close/>
                  </a:path>
                </a:pathLst>
              </a:custGeom>
              <a:solidFill>
                <a:srgbClr val="DAAA8E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97" name="Google Shape;297;p15"/>
              <p:cNvSpPr/>
              <p:nvPr/>
            </p:nvSpPr>
            <p:spPr>
              <a:xfrm>
                <a:off x="9615925" y="3513875"/>
                <a:ext cx="107725" cy="85975"/>
              </a:xfrm>
              <a:custGeom>
                <a:avLst/>
                <a:gdLst/>
                <a:ahLst/>
                <a:cxnLst/>
                <a:rect l="l" t="t" r="r" b="b"/>
                <a:pathLst>
                  <a:path w="4309" h="3439" extrusionOk="0">
                    <a:moveTo>
                      <a:pt x="2786" y="1"/>
                    </a:moveTo>
                    <a:lnTo>
                      <a:pt x="2786" y="66"/>
                    </a:lnTo>
                    <a:lnTo>
                      <a:pt x="1480" y="66"/>
                    </a:lnTo>
                    <a:cubicBezTo>
                      <a:pt x="1480" y="66"/>
                      <a:pt x="1262" y="2046"/>
                      <a:pt x="1154" y="2438"/>
                    </a:cubicBezTo>
                    <a:cubicBezTo>
                      <a:pt x="1067" y="2851"/>
                      <a:pt x="0" y="3439"/>
                      <a:pt x="0" y="3439"/>
                    </a:cubicBezTo>
                    <a:lnTo>
                      <a:pt x="131" y="3439"/>
                    </a:lnTo>
                    <a:cubicBezTo>
                      <a:pt x="1371" y="3112"/>
                      <a:pt x="2611" y="2786"/>
                      <a:pt x="2764" y="2742"/>
                    </a:cubicBezTo>
                    <a:cubicBezTo>
                      <a:pt x="3112" y="2634"/>
                      <a:pt x="4309" y="1829"/>
                      <a:pt x="4309" y="1829"/>
                    </a:cubicBezTo>
                    <a:cubicBezTo>
                      <a:pt x="4222" y="1219"/>
                      <a:pt x="4135" y="349"/>
                      <a:pt x="4091" y="88"/>
                    </a:cubicBezTo>
                    <a:lnTo>
                      <a:pt x="4004" y="1"/>
                    </a:lnTo>
                    <a:close/>
                  </a:path>
                </a:pathLst>
              </a:custGeom>
              <a:solidFill>
                <a:srgbClr val="191919">
                  <a:alpha val="1761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98" name="Google Shape;298;p15"/>
              <p:cNvSpPr/>
              <p:nvPr/>
            </p:nvSpPr>
            <p:spPr>
              <a:xfrm>
                <a:off x="9577325" y="3937625"/>
                <a:ext cx="107700" cy="315025"/>
              </a:xfrm>
              <a:custGeom>
                <a:avLst/>
                <a:gdLst/>
                <a:ahLst/>
                <a:cxnLst/>
                <a:rect l="l" t="t" r="r" b="b"/>
                <a:pathLst>
                  <a:path w="4308" h="12601" extrusionOk="0">
                    <a:moveTo>
                      <a:pt x="2174" y="0"/>
                    </a:moveTo>
                    <a:cubicBezTo>
                      <a:pt x="619" y="0"/>
                      <a:pt x="0" y="1121"/>
                      <a:pt x="43" y="4504"/>
                    </a:cubicBezTo>
                    <a:cubicBezTo>
                      <a:pt x="87" y="7920"/>
                      <a:pt x="587" y="11619"/>
                      <a:pt x="805" y="12163"/>
                    </a:cubicBezTo>
                    <a:cubicBezTo>
                      <a:pt x="931" y="12466"/>
                      <a:pt x="1746" y="12601"/>
                      <a:pt x="2450" y="12601"/>
                    </a:cubicBezTo>
                    <a:cubicBezTo>
                      <a:pt x="2960" y="12601"/>
                      <a:pt x="3411" y="12530"/>
                      <a:pt x="3503" y="12403"/>
                    </a:cubicBezTo>
                    <a:cubicBezTo>
                      <a:pt x="3720" y="12076"/>
                      <a:pt x="4286" y="5005"/>
                      <a:pt x="4286" y="3895"/>
                    </a:cubicBezTo>
                    <a:cubicBezTo>
                      <a:pt x="4308" y="2786"/>
                      <a:pt x="3960" y="1"/>
                      <a:pt x="2219" y="1"/>
                    </a:cubicBezTo>
                    <a:cubicBezTo>
                      <a:pt x="2204" y="0"/>
                      <a:pt x="2189" y="0"/>
                      <a:pt x="2174" y="0"/>
                    </a:cubicBezTo>
                    <a:close/>
                  </a:path>
                </a:pathLst>
              </a:custGeom>
              <a:solidFill>
                <a:srgbClr val="FFBD9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99" name="Google Shape;299;p15"/>
              <p:cNvSpPr/>
              <p:nvPr/>
            </p:nvSpPr>
            <p:spPr>
              <a:xfrm>
                <a:off x="9596350" y="4216650"/>
                <a:ext cx="69650" cy="93075"/>
              </a:xfrm>
              <a:custGeom>
                <a:avLst/>
                <a:gdLst/>
                <a:ahLst/>
                <a:cxnLst/>
                <a:rect l="l" t="t" r="r" b="b"/>
                <a:pathLst>
                  <a:path w="2786" h="3723" extrusionOk="0">
                    <a:moveTo>
                      <a:pt x="1201" y="1"/>
                    </a:moveTo>
                    <a:cubicBezTo>
                      <a:pt x="587" y="1"/>
                      <a:pt x="65" y="493"/>
                      <a:pt x="44" y="1111"/>
                    </a:cubicBezTo>
                    <a:lnTo>
                      <a:pt x="22" y="2547"/>
                    </a:lnTo>
                    <a:cubicBezTo>
                      <a:pt x="0" y="3178"/>
                      <a:pt x="501" y="3700"/>
                      <a:pt x="1132" y="3722"/>
                    </a:cubicBezTo>
                    <a:lnTo>
                      <a:pt x="1567" y="3722"/>
                    </a:lnTo>
                    <a:cubicBezTo>
                      <a:pt x="1580" y="3723"/>
                      <a:pt x="1593" y="3723"/>
                      <a:pt x="1606" y="3723"/>
                    </a:cubicBezTo>
                    <a:cubicBezTo>
                      <a:pt x="2219" y="3723"/>
                      <a:pt x="2720" y="3230"/>
                      <a:pt x="2742" y="2612"/>
                    </a:cubicBezTo>
                    <a:lnTo>
                      <a:pt x="2763" y="1198"/>
                    </a:lnTo>
                    <a:cubicBezTo>
                      <a:pt x="2785" y="545"/>
                      <a:pt x="2285" y="23"/>
                      <a:pt x="1654" y="1"/>
                    </a:cubicBezTo>
                    <a:lnTo>
                      <a:pt x="1240" y="1"/>
                    </a:lnTo>
                    <a:cubicBezTo>
                      <a:pt x="1227" y="1"/>
                      <a:pt x="1214" y="1"/>
                      <a:pt x="1201" y="1"/>
                    </a:cubicBezTo>
                    <a:close/>
                  </a:path>
                </a:pathLst>
              </a:custGeom>
              <a:solidFill>
                <a:srgbClr val="FFBD9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00" name="Google Shape;300;p15"/>
              <p:cNvSpPr/>
              <p:nvPr/>
            </p:nvSpPr>
            <p:spPr>
              <a:xfrm>
                <a:off x="9587650" y="4257475"/>
                <a:ext cx="80525" cy="272550"/>
              </a:xfrm>
              <a:custGeom>
                <a:avLst/>
                <a:gdLst/>
                <a:ahLst/>
                <a:cxnLst/>
                <a:rect l="l" t="t" r="r" b="b"/>
                <a:pathLst>
                  <a:path w="3221" h="10902" extrusionOk="0">
                    <a:moveTo>
                      <a:pt x="1675" y="0"/>
                    </a:moveTo>
                    <a:cubicBezTo>
                      <a:pt x="1197" y="0"/>
                      <a:pt x="0" y="174"/>
                      <a:pt x="65" y="3351"/>
                    </a:cubicBezTo>
                    <a:cubicBezTo>
                      <a:pt x="109" y="6528"/>
                      <a:pt x="1458" y="10901"/>
                      <a:pt x="1458" y="10901"/>
                    </a:cubicBezTo>
                    <a:lnTo>
                      <a:pt x="2611" y="10901"/>
                    </a:lnTo>
                    <a:cubicBezTo>
                      <a:pt x="2611" y="10901"/>
                      <a:pt x="3177" y="5005"/>
                      <a:pt x="3199" y="3873"/>
                    </a:cubicBezTo>
                    <a:cubicBezTo>
                      <a:pt x="3199" y="1306"/>
                      <a:pt x="3220" y="0"/>
                      <a:pt x="1675" y="0"/>
                    </a:cubicBezTo>
                    <a:close/>
                  </a:path>
                </a:pathLst>
              </a:custGeom>
              <a:solidFill>
                <a:srgbClr val="FFBD9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01" name="Google Shape;301;p15"/>
              <p:cNvSpPr/>
              <p:nvPr/>
            </p:nvSpPr>
            <p:spPr>
              <a:xfrm>
                <a:off x="9693700" y="3937725"/>
                <a:ext cx="118075" cy="315125"/>
              </a:xfrm>
              <a:custGeom>
                <a:avLst/>
                <a:gdLst/>
                <a:ahLst/>
                <a:cxnLst/>
                <a:rect l="l" t="t" r="r" b="b"/>
                <a:pathLst>
                  <a:path w="4723" h="12605" extrusionOk="0">
                    <a:moveTo>
                      <a:pt x="2081" y="0"/>
                    </a:moveTo>
                    <a:cubicBezTo>
                      <a:pt x="1979" y="0"/>
                      <a:pt x="1873" y="6"/>
                      <a:pt x="1763" y="18"/>
                    </a:cubicBezTo>
                    <a:cubicBezTo>
                      <a:pt x="44" y="192"/>
                      <a:pt x="1" y="3021"/>
                      <a:pt x="110" y="4109"/>
                    </a:cubicBezTo>
                    <a:cubicBezTo>
                      <a:pt x="218" y="5218"/>
                      <a:pt x="1502" y="12203"/>
                      <a:pt x="1763" y="12486"/>
                    </a:cubicBezTo>
                    <a:cubicBezTo>
                      <a:pt x="1838" y="12567"/>
                      <a:pt x="2075" y="12605"/>
                      <a:pt x="2379" y="12605"/>
                    </a:cubicBezTo>
                    <a:cubicBezTo>
                      <a:pt x="3136" y="12605"/>
                      <a:pt x="4309" y="12367"/>
                      <a:pt x="4418" y="11963"/>
                    </a:cubicBezTo>
                    <a:cubicBezTo>
                      <a:pt x="4592" y="11420"/>
                      <a:pt x="4722" y="7677"/>
                      <a:pt x="4396" y="4283"/>
                    </a:cubicBezTo>
                    <a:cubicBezTo>
                      <a:pt x="4113" y="1124"/>
                      <a:pt x="3452" y="0"/>
                      <a:pt x="2081" y="0"/>
                    </a:cubicBezTo>
                    <a:close/>
                  </a:path>
                </a:pathLst>
              </a:custGeom>
              <a:solidFill>
                <a:srgbClr val="FFBD9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02" name="Google Shape;302;p15"/>
              <p:cNvSpPr/>
              <p:nvPr/>
            </p:nvSpPr>
            <p:spPr>
              <a:xfrm>
                <a:off x="9735050" y="4214875"/>
                <a:ext cx="76175" cy="94450"/>
              </a:xfrm>
              <a:custGeom>
                <a:avLst/>
                <a:gdLst/>
                <a:ahLst/>
                <a:cxnLst/>
                <a:rect l="l" t="t" r="r" b="b"/>
                <a:pathLst>
                  <a:path w="3047" h="3778" extrusionOk="0">
                    <a:moveTo>
                      <a:pt x="1605" y="1"/>
                    </a:moveTo>
                    <a:cubicBezTo>
                      <a:pt x="1564" y="1"/>
                      <a:pt x="1522" y="3"/>
                      <a:pt x="1480" y="7"/>
                    </a:cubicBezTo>
                    <a:lnTo>
                      <a:pt x="1067" y="72"/>
                    </a:lnTo>
                    <a:cubicBezTo>
                      <a:pt x="436" y="159"/>
                      <a:pt x="1" y="725"/>
                      <a:pt x="88" y="1356"/>
                    </a:cubicBezTo>
                    <a:lnTo>
                      <a:pt x="262" y="2770"/>
                    </a:lnTo>
                    <a:cubicBezTo>
                      <a:pt x="343" y="3359"/>
                      <a:pt x="841" y="3778"/>
                      <a:pt x="1420" y="3778"/>
                    </a:cubicBezTo>
                    <a:cubicBezTo>
                      <a:pt x="1462" y="3778"/>
                      <a:pt x="1503" y="3776"/>
                      <a:pt x="1545" y="3771"/>
                    </a:cubicBezTo>
                    <a:lnTo>
                      <a:pt x="1959" y="3706"/>
                    </a:lnTo>
                    <a:cubicBezTo>
                      <a:pt x="2590" y="3619"/>
                      <a:pt x="3047" y="3053"/>
                      <a:pt x="2960" y="2422"/>
                    </a:cubicBezTo>
                    <a:lnTo>
                      <a:pt x="2786" y="1008"/>
                    </a:lnTo>
                    <a:cubicBezTo>
                      <a:pt x="2704" y="419"/>
                      <a:pt x="2187" y="1"/>
                      <a:pt x="1605" y="1"/>
                    </a:cubicBezTo>
                    <a:close/>
                  </a:path>
                </a:pathLst>
              </a:custGeom>
              <a:solidFill>
                <a:srgbClr val="FFBD9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03" name="Google Shape;303;p15"/>
              <p:cNvSpPr/>
              <p:nvPr/>
            </p:nvSpPr>
            <p:spPr>
              <a:xfrm>
                <a:off x="9735600" y="4256175"/>
                <a:ext cx="94125" cy="273300"/>
              </a:xfrm>
              <a:custGeom>
                <a:avLst/>
                <a:gdLst/>
                <a:ahLst/>
                <a:cxnLst/>
                <a:rect l="l" t="t" r="r" b="b"/>
                <a:pathLst>
                  <a:path w="3765" h="10932" extrusionOk="0">
                    <a:moveTo>
                      <a:pt x="1708" y="1"/>
                    </a:moveTo>
                    <a:cubicBezTo>
                      <a:pt x="1647" y="1"/>
                      <a:pt x="1593" y="4"/>
                      <a:pt x="1545" y="9"/>
                    </a:cubicBezTo>
                    <a:cubicBezTo>
                      <a:pt x="0" y="161"/>
                      <a:pt x="153" y="1445"/>
                      <a:pt x="435" y="4012"/>
                    </a:cubicBezTo>
                    <a:cubicBezTo>
                      <a:pt x="566" y="5122"/>
                      <a:pt x="1719" y="10931"/>
                      <a:pt x="1719" y="10931"/>
                    </a:cubicBezTo>
                    <a:lnTo>
                      <a:pt x="2872" y="10823"/>
                    </a:lnTo>
                    <a:cubicBezTo>
                      <a:pt x="2872" y="10823"/>
                      <a:pt x="3764" y="6340"/>
                      <a:pt x="3503" y="3164"/>
                    </a:cubicBezTo>
                    <a:cubicBezTo>
                      <a:pt x="3249" y="303"/>
                      <a:pt x="2253" y="1"/>
                      <a:pt x="1708" y="1"/>
                    </a:cubicBezTo>
                    <a:close/>
                  </a:path>
                </a:pathLst>
              </a:custGeom>
              <a:solidFill>
                <a:srgbClr val="FFBD9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04" name="Google Shape;304;p15"/>
              <p:cNvSpPr/>
              <p:nvPr/>
            </p:nvSpPr>
            <p:spPr>
              <a:xfrm>
                <a:off x="9570775" y="3920225"/>
                <a:ext cx="114250" cy="627200"/>
              </a:xfrm>
              <a:custGeom>
                <a:avLst/>
                <a:gdLst/>
                <a:ahLst/>
                <a:cxnLst/>
                <a:rect l="l" t="t" r="r" b="b"/>
                <a:pathLst>
                  <a:path w="4570" h="25088" extrusionOk="0">
                    <a:moveTo>
                      <a:pt x="762" y="0"/>
                    </a:moveTo>
                    <a:cubicBezTo>
                      <a:pt x="762" y="0"/>
                      <a:pt x="175" y="2807"/>
                      <a:pt x="88" y="4330"/>
                    </a:cubicBezTo>
                    <a:cubicBezTo>
                      <a:pt x="1" y="5875"/>
                      <a:pt x="740" y="12555"/>
                      <a:pt x="740" y="13294"/>
                    </a:cubicBezTo>
                    <a:cubicBezTo>
                      <a:pt x="740" y="14034"/>
                      <a:pt x="675" y="16297"/>
                      <a:pt x="719" y="18516"/>
                    </a:cubicBezTo>
                    <a:cubicBezTo>
                      <a:pt x="762" y="20714"/>
                      <a:pt x="1328" y="25087"/>
                      <a:pt x="1328" y="25087"/>
                    </a:cubicBezTo>
                    <a:lnTo>
                      <a:pt x="4178" y="25022"/>
                    </a:lnTo>
                    <a:cubicBezTo>
                      <a:pt x="4178" y="25022"/>
                      <a:pt x="4178" y="15644"/>
                      <a:pt x="4200" y="14187"/>
                    </a:cubicBezTo>
                    <a:cubicBezTo>
                      <a:pt x="4200" y="12707"/>
                      <a:pt x="4548" y="4939"/>
                      <a:pt x="4548" y="4939"/>
                    </a:cubicBezTo>
                    <a:lnTo>
                      <a:pt x="4570" y="131"/>
                    </a:lnTo>
                    <a:lnTo>
                      <a:pt x="762" y="0"/>
                    </a:ln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05" name="Google Shape;305;p15"/>
              <p:cNvSpPr/>
              <p:nvPr/>
            </p:nvSpPr>
            <p:spPr>
              <a:xfrm>
                <a:off x="9542500" y="3588950"/>
                <a:ext cx="285600" cy="334550"/>
              </a:xfrm>
              <a:custGeom>
                <a:avLst/>
                <a:gdLst/>
                <a:ahLst/>
                <a:cxnLst/>
                <a:rect l="l" t="t" r="r" b="b"/>
                <a:pathLst>
                  <a:path w="11424" h="13382" extrusionOk="0">
                    <a:moveTo>
                      <a:pt x="3590" y="1"/>
                    </a:moveTo>
                    <a:cubicBezTo>
                      <a:pt x="3590" y="1"/>
                      <a:pt x="2894" y="305"/>
                      <a:pt x="2132" y="545"/>
                    </a:cubicBezTo>
                    <a:cubicBezTo>
                      <a:pt x="1262" y="806"/>
                      <a:pt x="305" y="1045"/>
                      <a:pt x="152" y="1350"/>
                    </a:cubicBezTo>
                    <a:cubicBezTo>
                      <a:pt x="0" y="1654"/>
                      <a:pt x="1545" y="7616"/>
                      <a:pt x="1719" y="8138"/>
                    </a:cubicBezTo>
                    <a:cubicBezTo>
                      <a:pt x="1893" y="8639"/>
                      <a:pt x="1436" y="12185"/>
                      <a:pt x="1893" y="13251"/>
                    </a:cubicBezTo>
                    <a:lnTo>
                      <a:pt x="5679" y="13382"/>
                    </a:lnTo>
                    <a:lnTo>
                      <a:pt x="5701" y="13382"/>
                    </a:lnTo>
                    <a:lnTo>
                      <a:pt x="9508" y="13273"/>
                    </a:lnTo>
                    <a:cubicBezTo>
                      <a:pt x="9857" y="12055"/>
                      <a:pt x="9487" y="8573"/>
                      <a:pt x="9661" y="8073"/>
                    </a:cubicBezTo>
                    <a:cubicBezTo>
                      <a:pt x="9857" y="7572"/>
                      <a:pt x="11423" y="1676"/>
                      <a:pt x="11271" y="1350"/>
                    </a:cubicBezTo>
                    <a:cubicBezTo>
                      <a:pt x="11119" y="1045"/>
                      <a:pt x="10139" y="827"/>
                      <a:pt x="9291" y="566"/>
                    </a:cubicBezTo>
                    <a:cubicBezTo>
                      <a:pt x="8508" y="327"/>
                      <a:pt x="7833" y="22"/>
                      <a:pt x="7833" y="22"/>
                    </a:cubicBezTo>
                    <a:lnTo>
                      <a:pt x="5701" y="1219"/>
                    </a:lnTo>
                    <a:lnTo>
                      <a:pt x="3590" y="1"/>
                    </a:ln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06" name="Google Shape;306;p15"/>
              <p:cNvSpPr/>
              <p:nvPr/>
            </p:nvSpPr>
            <p:spPr>
              <a:xfrm>
                <a:off x="9684475" y="3918050"/>
                <a:ext cx="147425" cy="631550"/>
              </a:xfrm>
              <a:custGeom>
                <a:avLst/>
                <a:gdLst/>
                <a:ahLst/>
                <a:cxnLst/>
                <a:rect l="l" t="t" r="r" b="b"/>
                <a:pathLst>
                  <a:path w="5897" h="25262" extrusionOk="0">
                    <a:moveTo>
                      <a:pt x="3786" y="0"/>
                    </a:moveTo>
                    <a:lnTo>
                      <a:pt x="22" y="218"/>
                    </a:lnTo>
                    <a:lnTo>
                      <a:pt x="0" y="5266"/>
                    </a:lnTo>
                    <a:cubicBezTo>
                      <a:pt x="0" y="5266"/>
                      <a:pt x="1675" y="12990"/>
                      <a:pt x="1828" y="14469"/>
                    </a:cubicBezTo>
                    <a:cubicBezTo>
                      <a:pt x="1980" y="15927"/>
                      <a:pt x="2959" y="25261"/>
                      <a:pt x="2959" y="25261"/>
                    </a:cubicBezTo>
                    <a:lnTo>
                      <a:pt x="5788" y="25022"/>
                    </a:lnTo>
                    <a:cubicBezTo>
                      <a:pt x="5788" y="25022"/>
                      <a:pt x="5896" y="20627"/>
                      <a:pt x="5722" y="18408"/>
                    </a:cubicBezTo>
                    <a:cubicBezTo>
                      <a:pt x="5527" y="16210"/>
                      <a:pt x="5244" y="13969"/>
                      <a:pt x="5178" y="13229"/>
                    </a:cubicBezTo>
                    <a:cubicBezTo>
                      <a:pt x="5091" y="12489"/>
                      <a:pt x="5135" y="5766"/>
                      <a:pt x="4896" y="4265"/>
                    </a:cubicBezTo>
                    <a:cubicBezTo>
                      <a:pt x="4656" y="2742"/>
                      <a:pt x="3786" y="0"/>
                      <a:pt x="3786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07" name="Google Shape;307;p15"/>
              <p:cNvSpPr/>
              <p:nvPr/>
            </p:nvSpPr>
            <p:spPr>
              <a:xfrm>
                <a:off x="9587100" y="4545775"/>
                <a:ext cx="79975" cy="58225"/>
              </a:xfrm>
              <a:custGeom>
                <a:avLst/>
                <a:gdLst/>
                <a:ahLst/>
                <a:cxnLst/>
                <a:rect l="l" t="t" r="r" b="b"/>
                <a:pathLst>
                  <a:path w="3199" h="2329" extrusionOk="0">
                    <a:moveTo>
                      <a:pt x="3199" y="0"/>
                    </a:moveTo>
                    <a:lnTo>
                      <a:pt x="979" y="65"/>
                    </a:lnTo>
                    <a:cubicBezTo>
                      <a:pt x="979" y="65"/>
                      <a:pt x="0" y="1197"/>
                      <a:pt x="66" y="1501"/>
                    </a:cubicBezTo>
                    <a:cubicBezTo>
                      <a:pt x="87" y="1654"/>
                      <a:pt x="501" y="2285"/>
                      <a:pt x="1241" y="2328"/>
                    </a:cubicBezTo>
                    <a:cubicBezTo>
                      <a:pt x="1253" y="2329"/>
                      <a:pt x="1265" y="2329"/>
                      <a:pt x="1277" y="2329"/>
                    </a:cubicBezTo>
                    <a:cubicBezTo>
                      <a:pt x="1845" y="2329"/>
                      <a:pt x="2723" y="1849"/>
                      <a:pt x="2872" y="1828"/>
                    </a:cubicBezTo>
                    <a:cubicBezTo>
                      <a:pt x="3199" y="1806"/>
                      <a:pt x="3199" y="0"/>
                      <a:pt x="3199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08" name="Google Shape;308;p15"/>
              <p:cNvSpPr/>
              <p:nvPr/>
            </p:nvSpPr>
            <p:spPr>
              <a:xfrm>
                <a:off x="9763875" y="4544675"/>
                <a:ext cx="82175" cy="57050"/>
              </a:xfrm>
              <a:custGeom>
                <a:avLst/>
                <a:gdLst/>
                <a:ahLst/>
                <a:cxnLst/>
                <a:rect l="l" t="t" r="r" b="b"/>
                <a:pathLst>
                  <a:path w="3287" h="2282" extrusionOk="0">
                    <a:moveTo>
                      <a:pt x="2198" y="1"/>
                    </a:moveTo>
                    <a:lnTo>
                      <a:pt x="1" y="175"/>
                    </a:lnTo>
                    <a:cubicBezTo>
                      <a:pt x="1" y="175"/>
                      <a:pt x="175" y="1959"/>
                      <a:pt x="501" y="1959"/>
                    </a:cubicBezTo>
                    <a:cubicBezTo>
                      <a:pt x="636" y="1959"/>
                      <a:pt x="1416" y="2282"/>
                      <a:pt x="1971" y="2282"/>
                    </a:cubicBezTo>
                    <a:cubicBezTo>
                      <a:pt x="2044" y="2282"/>
                      <a:pt x="2113" y="2276"/>
                      <a:pt x="2177" y="2263"/>
                    </a:cubicBezTo>
                    <a:cubicBezTo>
                      <a:pt x="2916" y="2155"/>
                      <a:pt x="3264" y="1502"/>
                      <a:pt x="3264" y="1328"/>
                    </a:cubicBezTo>
                    <a:cubicBezTo>
                      <a:pt x="3286" y="1023"/>
                      <a:pt x="2198" y="1"/>
                      <a:pt x="2198" y="1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09" name="Google Shape;309;p15"/>
              <p:cNvSpPr/>
              <p:nvPr/>
            </p:nvSpPr>
            <p:spPr>
              <a:xfrm>
                <a:off x="9542500" y="3628650"/>
                <a:ext cx="237725" cy="294850"/>
              </a:xfrm>
              <a:custGeom>
                <a:avLst/>
                <a:gdLst/>
                <a:ahLst/>
                <a:cxnLst/>
                <a:rect l="l" t="t" r="r" b="b"/>
                <a:pathLst>
                  <a:path w="9509" h="11794" extrusionOk="0">
                    <a:moveTo>
                      <a:pt x="0" y="1"/>
                    </a:moveTo>
                    <a:lnTo>
                      <a:pt x="0" y="1"/>
                    </a:lnTo>
                    <a:cubicBezTo>
                      <a:pt x="414" y="1872"/>
                      <a:pt x="1610" y="6224"/>
                      <a:pt x="1719" y="6550"/>
                    </a:cubicBezTo>
                    <a:cubicBezTo>
                      <a:pt x="1893" y="7051"/>
                      <a:pt x="1436" y="10597"/>
                      <a:pt x="1893" y="11663"/>
                    </a:cubicBezTo>
                    <a:lnTo>
                      <a:pt x="5679" y="11794"/>
                    </a:lnTo>
                    <a:lnTo>
                      <a:pt x="5701" y="11794"/>
                    </a:lnTo>
                    <a:lnTo>
                      <a:pt x="9508" y="11685"/>
                    </a:lnTo>
                    <a:cubicBezTo>
                      <a:pt x="9508" y="11685"/>
                      <a:pt x="8660" y="11554"/>
                      <a:pt x="8334" y="11446"/>
                    </a:cubicBezTo>
                    <a:cubicBezTo>
                      <a:pt x="8228" y="11419"/>
                      <a:pt x="8036" y="11415"/>
                      <a:pt x="7808" y="11415"/>
                    </a:cubicBezTo>
                    <a:cubicBezTo>
                      <a:pt x="7692" y="11415"/>
                      <a:pt x="7566" y="11416"/>
                      <a:pt x="7439" y="11416"/>
                    </a:cubicBezTo>
                    <a:cubicBezTo>
                      <a:pt x="6989" y="11416"/>
                      <a:pt x="6511" y="11402"/>
                      <a:pt x="6310" y="11272"/>
                    </a:cubicBezTo>
                    <a:cubicBezTo>
                      <a:pt x="5962" y="11054"/>
                      <a:pt x="5396" y="10815"/>
                      <a:pt x="5070" y="10619"/>
                    </a:cubicBezTo>
                    <a:cubicBezTo>
                      <a:pt x="4743" y="10401"/>
                      <a:pt x="5070" y="9705"/>
                      <a:pt x="5070" y="9335"/>
                    </a:cubicBezTo>
                    <a:cubicBezTo>
                      <a:pt x="5048" y="8965"/>
                      <a:pt x="6071" y="8291"/>
                      <a:pt x="6745" y="8030"/>
                    </a:cubicBezTo>
                    <a:cubicBezTo>
                      <a:pt x="7441" y="7790"/>
                      <a:pt x="8638" y="7877"/>
                      <a:pt x="8899" y="7399"/>
                    </a:cubicBezTo>
                    <a:cubicBezTo>
                      <a:pt x="9182" y="6920"/>
                      <a:pt x="8442" y="6463"/>
                      <a:pt x="8138" y="6463"/>
                    </a:cubicBezTo>
                    <a:cubicBezTo>
                      <a:pt x="7823" y="6463"/>
                      <a:pt x="5885" y="5895"/>
                      <a:pt x="5477" y="5895"/>
                    </a:cubicBezTo>
                    <a:cubicBezTo>
                      <a:pt x="5463" y="5895"/>
                      <a:pt x="5450" y="5896"/>
                      <a:pt x="5440" y="5897"/>
                    </a:cubicBezTo>
                    <a:cubicBezTo>
                      <a:pt x="5230" y="5925"/>
                      <a:pt x="4159" y="6043"/>
                      <a:pt x="3316" y="6043"/>
                    </a:cubicBezTo>
                    <a:cubicBezTo>
                      <a:pt x="2846" y="6043"/>
                      <a:pt x="2447" y="6006"/>
                      <a:pt x="2307" y="5897"/>
                    </a:cubicBezTo>
                    <a:cubicBezTo>
                      <a:pt x="1915" y="5593"/>
                      <a:pt x="0" y="2"/>
                      <a:pt x="0" y="1"/>
                    </a:cubicBezTo>
                    <a:close/>
                  </a:path>
                </a:pathLst>
              </a:custGeom>
              <a:solidFill>
                <a:srgbClr val="191919">
                  <a:alpha val="1761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10" name="Google Shape;310;p15"/>
              <p:cNvSpPr/>
              <p:nvPr/>
            </p:nvSpPr>
            <p:spPr>
              <a:xfrm>
                <a:off x="9723075" y="3918050"/>
                <a:ext cx="108825" cy="627750"/>
              </a:xfrm>
              <a:custGeom>
                <a:avLst/>
                <a:gdLst/>
                <a:ahLst/>
                <a:cxnLst/>
                <a:rect l="l" t="t" r="r" b="b"/>
                <a:pathLst>
                  <a:path w="4353" h="25110" extrusionOk="0">
                    <a:moveTo>
                      <a:pt x="2242" y="0"/>
                    </a:moveTo>
                    <a:lnTo>
                      <a:pt x="1" y="174"/>
                    </a:lnTo>
                    <a:cubicBezTo>
                      <a:pt x="1" y="174"/>
                      <a:pt x="1742" y="4743"/>
                      <a:pt x="1916" y="5744"/>
                    </a:cubicBezTo>
                    <a:cubicBezTo>
                      <a:pt x="2068" y="6745"/>
                      <a:pt x="2242" y="13468"/>
                      <a:pt x="2285" y="13860"/>
                    </a:cubicBezTo>
                    <a:cubicBezTo>
                      <a:pt x="2307" y="14230"/>
                      <a:pt x="3265" y="24609"/>
                      <a:pt x="3308" y="25109"/>
                    </a:cubicBezTo>
                    <a:lnTo>
                      <a:pt x="4244" y="25022"/>
                    </a:lnTo>
                    <a:cubicBezTo>
                      <a:pt x="4244" y="25022"/>
                      <a:pt x="4352" y="20627"/>
                      <a:pt x="4178" y="18408"/>
                    </a:cubicBezTo>
                    <a:cubicBezTo>
                      <a:pt x="3983" y="16210"/>
                      <a:pt x="3700" y="13969"/>
                      <a:pt x="3634" y="13229"/>
                    </a:cubicBezTo>
                    <a:cubicBezTo>
                      <a:pt x="3547" y="12489"/>
                      <a:pt x="3591" y="5766"/>
                      <a:pt x="3352" y="4265"/>
                    </a:cubicBezTo>
                    <a:cubicBezTo>
                      <a:pt x="3112" y="2742"/>
                      <a:pt x="2242" y="0"/>
                      <a:pt x="2242" y="0"/>
                    </a:cubicBezTo>
                    <a:close/>
                  </a:path>
                </a:pathLst>
              </a:custGeom>
              <a:solidFill>
                <a:srgbClr val="FFFFFF">
                  <a:alpha val="1824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11" name="Google Shape;311;p15"/>
              <p:cNvSpPr/>
              <p:nvPr/>
            </p:nvSpPr>
            <p:spPr>
              <a:xfrm>
                <a:off x="9620275" y="3983500"/>
                <a:ext cx="65300" cy="563375"/>
              </a:xfrm>
              <a:custGeom>
                <a:avLst/>
                <a:gdLst/>
                <a:ahLst/>
                <a:cxnLst/>
                <a:rect l="l" t="t" r="r" b="b"/>
                <a:pathLst>
                  <a:path w="2612" h="22535" extrusionOk="0">
                    <a:moveTo>
                      <a:pt x="1195" y="1"/>
                    </a:moveTo>
                    <a:cubicBezTo>
                      <a:pt x="675" y="1"/>
                      <a:pt x="161" y="365"/>
                      <a:pt x="109" y="994"/>
                    </a:cubicBezTo>
                    <a:cubicBezTo>
                      <a:pt x="22" y="2082"/>
                      <a:pt x="1" y="2844"/>
                      <a:pt x="88" y="3344"/>
                    </a:cubicBezTo>
                    <a:cubicBezTo>
                      <a:pt x="327" y="4606"/>
                      <a:pt x="675" y="10807"/>
                      <a:pt x="632" y="10959"/>
                    </a:cubicBezTo>
                    <a:cubicBezTo>
                      <a:pt x="588" y="11133"/>
                      <a:pt x="610" y="22491"/>
                      <a:pt x="610" y="22491"/>
                    </a:cubicBezTo>
                    <a:lnTo>
                      <a:pt x="653" y="22535"/>
                    </a:lnTo>
                    <a:lnTo>
                      <a:pt x="2198" y="22491"/>
                    </a:lnTo>
                    <a:cubicBezTo>
                      <a:pt x="2198" y="22491"/>
                      <a:pt x="2198" y="13113"/>
                      <a:pt x="2220" y="11656"/>
                    </a:cubicBezTo>
                    <a:cubicBezTo>
                      <a:pt x="2220" y="10176"/>
                      <a:pt x="2568" y="2408"/>
                      <a:pt x="2568" y="2408"/>
                    </a:cubicBezTo>
                    <a:lnTo>
                      <a:pt x="2568" y="1995"/>
                    </a:lnTo>
                    <a:lnTo>
                      <a:pt x="2612" y="1386"/>
                    </a:lnTo>
                    <a:lnTo>
                      <a:pt x="2133" y="559"/>
                    </a:lnTo>
                    <a:cubicBezTo>
                      <a:pt x="1919" y="176"/>
                      <a:pt x="1555" y="1"/>
                      <a:pt x="1195" y="1"/>
                    </a:cubicBezTo>
                    <a:close/>
                  </a:path>
                </a:pathLst>
              </a:custGeom>
              <a:solidFill>
                <a:srgbClr val="FFFFFF">
                  <a:alpha val="1824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12" name="Google Shape;312;p15"/>
              <p:cNvSpPr/>
              <p:nvPr/>
            </p:nvSpPr>
            <p:spPr>
              <a:xfrm>
                <a:off x="9653450" y="3600375"/>
                <a:ext cx="31575" cy="20700"/>
              </a:xfrm>
              <a:custGeom>
                <a:avLst/>
                <a:gdLst/>
                <a:ahLst/>
                <a:cxnLst/>
                <a:rect l="l" t="t" r="r" b="b"/>
                <a:pathLst>
                  <a:path w="1263" h="828" extrusionOk="0">
                    <a:moveTo>
                      <a:pt x="741" y="1"/>
                    </a:moveTo>
                    <a:lnTo>
                      <a:pt x="1" y="349"/>
                    </a:lnTo>
                    <a:lnTo>
                      <a:pt x="1263" y="827"/>
                    </a:lnTo>
                    <a:lnTo>
                      <a:pt x="1263" y="827"/>
                    </a:lnTo>
                    <a:lnTo>
                      <a:pt x="1110" y="109"/>
                    </a:lnTo>
                    <a:lnTo>
                      <a:pt x="741" y="1"/>
                    </a:lnTo>
                    <a:close/>
                  </a:path>
                </a:pathLst>
              </a:custGeom>
              <a:solidFill>
                <a:schemeClr val="l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13" name="Google Shape;313;p15"/>
              <p:cNvSpPr/>
              <p:nvPr/>
            </p:nvSpPr>
            <p:spPr>
              <a:xfrm>
                <a:off x="9685000" y="3600375"/>
                <a:ext cx="32125" cy="20700"/>
              </a:xfrm>
              <a:custGeom>
                <a:avLst/>
                <a:gdLst/>
                <a:ahLst/>
                <a:cxnLst/>
                <a:rect l="l" t="t" r="r" b="b"/>
                <a:pathLst>
                  <a:path w="1285" h="828" extrusionOk="0">
                    <a:moveTo>
                      <a:pt x="545" y="1"/>
                    </a:moveTo>
                    <a:lnTo>
                      <a:pt x="153" y="109"/>
                    </a:lnTo>
                    <a:lnTo>
                      <a:pt x="1" y="827"/>
                    </a:lnTo>
                    <a:lnTo>
                      <a:pt x="1285" y="349"/>
                    </a:lnTo>
                    <a:lnTo>
                      <a:pt x="545" y="1"/>
                    </a:lnTo>
                    <a:close/>
                  </a:path>
                </a:pathLst>
              </a:custGeom>
              <a:solidFill>
                <a:schemeClr val="l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14" name="Google Shape;314;p15"/>
              <p:cNvSpPr/>
              <p:nvPr/>
            </p:nvSpPr>
            <p:spPr>
              <a:xfrm>
                <a:off x="9584925" y="3917500"/>
                <a:ext cx="200750" cy="28850"/>
              </a:xfrm>
              <a:custGeom>
                <a:avLst/>
                <a:gdLst/>
                <a:ahLst/>
                <a:cxnLst/>
                <a:rect l="l" t="t" r="r" b="b"/>
                <a:pathLst>
                  <a:path w="8030" h="1154" extrusionOk="0">
                    <a:moveTo>
                      <a:pt x="7833" y="0"/>
                    </a:moveTo>
                    <a:lnTo>
                      <a:pt x="4004" y="240"/>
                    </a:lnTo>
                    <a:lnTo>
                      <a:pt x="131" y="109"/>
                    </a:lnTo>
                    <a:lnTo>
                      <a:pt x="0" y="980"/>
                    </a:lnTo>
                    <a:lnTo>
                      <a:pt x="3982" y="1154"/>
                    </a:lnTo>
                    <a:lnTo>
                      <a:pt x="8029" y="849"/>
                    </a:lnTo>
                    <a:lnTo>
                      <a:pt x="7833" y="0"/>
                    </a:lnTo>
                    <a:close/>
                  </a:path>
                </a:pathLst>
              </a:custGeom>
              <a:solidFill>
                <a:schemeClr val="l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15" name="Google Shape;315;p15"/>
              <p:cNvSpPr/>
              <p:nvPr/>
            </p:nvSpPr>
            <p:spPr>
              <a:xfrm>
                <a:off x="9663250" y="3921850"/>
                <a:ext cx="42450" cy="24500"/>
              </a:xfrm>
              <a:custGeom>
                <a:avLst/>
                <a:gdLst/>
                <a:ahLst/>
                <a:cxnLst/>
                <a:rect l="l" t="t" r="r" b="b"/>
                <a:pathLst>
                  <a:path w="1698" h="980" extrusionOk="0">
                    <a:moveTo>
                      <a:pt x="479" y="1"/>
                    </a:moveTo>
                    <a:cubicBezTo>
                      <a:pt x="218" y="1"/>
                      <a:pt x="0" y="218"/>
                      <a:pt x="0" y="479"/>
                    </a:cubicBezTo>
                    <a:cubicBezTo>
                      <a:pt x="0" y="762"/>
                      <a:pt x="218" y="980"/>
                      <a:pt x="479" y="980"/>
                    </a:cubicBezTo>
                    <a:lnTo>
                      <a:pt x="1197" y="980"/>
                    </a:lnTo>
                    <a:cubicBezTo>
                      <a:pt x="1480" y="980"/>
                      <a:pt x="1698" y="762"/>
                      <a:pt x="1698" y="479"/>
                    </a:cubicBezTo>
                    <a:cubicBezTo>
                      <a:pt x="1698" y="218"/>
                      <a:pt x="1480" y="1"/>
                      <a:pt x="1197" y="1"/>
                    </a:cubicBezTo>
                    <a:close/>
                  </a:path>
                </a:pathLst>
              </a:custGeom>
              <a:solidFill>
                <a:schemeClr val="accen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16" name="Google Shape;316;p15"/>
              <p:cNvSpPr/>
              <p:nvPr/>
            </p:nvSpPr>
            <p:spPr>
              <a:xfrm>
                <a:off x="9669775" y="3608000"/>
                <a:ext cx="31025" cy="27225"/>
              </a:xfrm>
              <a:custGeom>
                <a:avLst/>
                <a:gdLst/>
                <a:ahLst/>
                <a:cxnLst/>
                <a:rect l="l" t="t" r="r" b="b"/>
                <a:pathLst>
                  <a:path w="1241" h="1089" extrusionOk="0">
                    <a:moveTo>
                      <a:pt x="1" y="0"/>
                    </a:moveTo>
                    <a:lnTo>
                      <a:pt x="392" y="1088"/>
                    </a:lnTo>
                    <a:lnTo>
                      <a:pt x="893" y="1088"/>
                    </a:lnTo>
                    <a:lnTo>
                      <a:pt x="1241" y="0"/>
                    </a:ln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17" name="Google Shape;317;p15"/>
              <p:cNvSpPr/>
              <p:nvPr/>
            </p:nvSpPr>
            <p:spPr>
              <a:xfrm>
                <a:off x="9663250" y="3635200"/>
                <a:ext cx="42450" cy="295925"/>
              </a:xfrm>
              <a:custGeom>
                <a:avLst/>
                <a:gdLst/>
                <a:ahLst/>
                <a:cxnLst/>
                <a:rect l="l" t="t" r="r" b="b"/>
                <a:pathLst>
                  <a:path w="1698" h="11837" extrusionOk="0">
                    <a:moveTo>
                      <a:pt x="653" y="0"/>
                    </a:moveTo>
                    <a:lnTo>
                      <a:pt x="0" y="10879"/>
                    </a:lnTo>
                    <a:lnTo>
                      <a:pt x="893" y="11836"/>
                    </a:lnTo>
                    <a:lnTo>
                      <a:pt x="1698" y="10836"/>
                    </a:lnTo>
                    <a:lnTo>
                      <a:pt x="1154" y="0"/>
                    </a:ln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18" name="Google Shape;318;p15"/>
              <p:cNvSpPr/>
              <p:nvPr/>
            </p:nvSpPr>
            <p:spPr>
              <a:xfrm>
                <a:off x="9532150" y="3593300"/>
                <a:ext cx="128950" cy="447500"/>
              </a:xfrm>
              <a:custGeom>
                <a:avLst/>
                <a:gdLst/>
                <a:ahLst/>
                <a:cxnLst/>
                <a:rect l="l" t="t" r="r" b="b"/>
                <a:pathLst>
                  <a:path w="5158" h="17900" extrusionOk="0">
                    <a:moveTo>
                      <a:pt x="4178" y="1"/>
                    </a:moveTo>
                    <a:cubicBezTo>
                      <a:pt x="4178" y="1"/>
                      <a:pt x="806" y="588"/>
                      <a:pt x="414" y="762"/>
                    </a:cubicBezTo>
                    <a:cubicBezTo>
                      <a:pt x="1" y="936"/>
                      <a:pt x="1284" y="6528"/>
                      <a:pt x="1350" y="7986"/>
                    </a:cubicBezTo>
                    <a:cubicBezTo>
                      <a:pt x="1393" y="9422"/>
                      <a:pt x="1372" y="17799"/>
                      <a:pt x="1372" y="17799"/>
                    </a:cubicBezTo>
                    <a:lnTo>
                      <a:pt x="2220" y="17886"/>
                    </a:lnTo>
                    <a:cubicBezTo>
                      <a:pt x="2309" y="17895"/>
                      <a:pt x="2398" y="17899"/>
                      <a:pt x="2486" y="17899"/>
                    </a:cubicBezTo>
                    <a:cubicBezTo>
                      <a:pt x="2831" y="17899"/>
                      <a:pt x="3170" y="17833"/>
                      <a:pt x="3482" y="17712"/>
                    </a:cubicBezTo>
                    <a:lnTo>
                      <a:pt x="5070" y="17190"/>
                    </a:lnTo>
                    <a:lnTo>
                      <a:pt x="5157" y="7790"/>
                    </a:lnTo>
                    <a:lnTo>
                      <a:pt x="4178" y="1"/>
                    </a:ln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19" name="Google Shape;319;p15"/>
              <p:cNvSpPr/>
              <p:nvPr/>
            </p:nvSpPr>
            <p:spPr>
              <a:xfrm>
                <a:off x="9705675" y="3596025"/>
                <a:ext cx="130025" cy="443925"/>
              </a:xfrm>
              <a:custGeom>
                <a:avLst/>
                <a:gdLst/>
                <a:ahLst/>
                <a:cxnLst/>
                <a:rect l="l" t="t" r="r" b="b"/>
                <a:pathLst>
                  <a:path w="5201" h="17757" extrusionOk="0">
                    <a:moveTo>
                      <a:pt x="1197" y="0"/>
                    </a:moveTo>
                    <a:lnTo>
                      <a:pt x="1" y="7920"/>
                    </a:lnTo>
                    <a:lnTo>
                      <a:pt x="436" y="17102"/>
                    </a:lnTo>
                    <a:lnTo>
                      <a:pt x="2089" y="17624"/>
                    </a:lnTo>
                    <a:cubicBezTo>
                      <a:pt x="2342" y="17709"/>
                      <a:pt x="2613" y="17757"/>
                      <a:pt x="2891" y="17757"/>
                    </a:cubicBezTo>
                    <a:cubicBezTo>
                      <a:pt x="3043" y="17757"/>
                      <a:pt x="3197" y="17742"/>
                      <a:pt x="3351" y="17712"/>
                    </a:cubicBezTo>
                    <a:lnTo>
                      <a:pt x="5201" y="17429"/>
                    </a:lnTo>
                    <a:cubicBezTo>
                      <a:pt x="5201" y="17429"/>
                      <a:pt x="3917" y="9226"/>
                      <a:pt x="3895" y="7768"/>
                    </a:cubicBezTo>
                    <a:cubicBezTo>
                      <a:pt x="3874" y="6332"/>
                      <a:pt x="5114" y="610"/>
                      <a:pt x="4722" y="457"/>
                    </a:cubicBezTo>
                    <a:cubicBezTo>
                      <a:pt x="4309" y="305"/>
                      <a:pt x="1197" y="0"/>
                      <a:pt x="1197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20" name="Google Shape;320;p15"/>
              <p:cNvSpPr/>
              <p:nvPr/>
            </p:nvSpPr>
            <p:spPr>
              <a:xfrm>
                <a:off x="9619200" y="3572100"/>
                <a:ext cx="62025" cy="60400"/>
              </a:xfrm>
              <a:custGeom>
                <a:avLst/>
                <a:gdLst/>
                <a:ahLst/>
                <a:cxnLst/>
                <a:rect l="l" t="t" r="r" b="b"/>
                <a:pathLst>
                  <a:path w="2481" h="2416" extrusionOk="0">
                    <a:moveTo>
                      <a:pt x="740" y="0"/>
                    </a:moveTo>
                    <a:lnTo>
                      <a:pt x="0" y="870"/>
                    </a:lnTo>
                    <a:lnTo>
                      <a:pt x="1849" y="2415"/>
                    </a:lnTo>
                    <a:lnTo>
                      <a:pt x="2480" y="1240"/>
                    </a:lnTo>
                    <a:lnTo>
                      <a:pt x="740" y="0"/>
                    </a:lnTo>
                    <a:close/>
                  </a:path>
                </a:pathLst>
              </a:custGeom>
              <a:solidFill>
                <a:schemeClr val="dk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21" name="Google Shape;321;p15"/>
              <p:cNvSpPr/>
              <p:nvPr/>
            </p:nvSpPr>
            <p:spPr>
              <a:xfrm>
                <a:off x="9688825" y="3572100"/>
                <a:ext cx="62025" cy="60400"/>
              </a:xfrm>
              <a:custGeom>
                <a:avLst/>
                <a:gdLst/>
                <a:ahLst/>
                <a:cxnLst/>
                <a:rect l="l" t="t" r="r" b="b"/>
                <a:pathLst>
                  <a:path w="2481" h="2416" extrusionOk="0">
                    <a:moveTo>
                      <a:pt x="1741" y="0"/>
                    </a:moveTo>
                    <a:lnTo>
                      <a:pt x="0" y="1240"/>
                    </a:lnTo>
                    <a:lnTo>
                      <a:pt x="631" y="2415"/>
                    </a:lnTo>
                    <a:lnTo>
                      <a:pt x="2481" y="870"/>
                    </a:lnTo>
                    <a:lnTo>
                      <a:pt x="1741" y="0"/>
                    </a:lnTo>
                    <a:close/>
                  </a:path>
                </a:pathLst>
              </a:custGeom>
              <a:solidFill>
                <a:schemeClr val="dk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22" name="Google Shape;322;p15"/>
              <p:cNvSpPr/>
              <p:nvPr/>
            </p:nvSpPr>
            <p:spPr>
              <a:xfrm>
                <a:off x="9627900" y="3405525"/>
                <a:ext cx="121850" cy="158475"/>
              </a:xfrm>
              <a:custGeom>
                <a:avLst/>
                <a:gdLst/>
                <a:ahLst/>
                <a:cxnLst/>
                <a:rect l="l" t="t" r="r" b="b"/>
                <a:pathLst>
                  <a:path w="4874" h="6339" extrusionOk="0">
                    <a:moveTo>
                      <a:pt x="2510" y="1"/>
                    </a:moveTo>
                    <a:cubicBezTo>
                      <a:pt x="1278" y="1"/>
                      <a:pt x="214" y="1256"/>
                      <a:pt x="109" y="2877"/>
                    </a:cubicBezTo>
                    <a:cubicBezTo>
                      <a:pt x="0" y="4531"/>
                      <a:pt x="1219" y="6271"/>
                      <a:pt x="2241" y="6337"/>
                    </a:cubicBezTo>
                    <a:cubicBezTo>
                      <a:pt x="2263" y="6338"/>
                      <a:pt x="2284" y="6339"/>
                      <a:pt x="2305" y="6339"/>
                    </a:cubicBezTo>
                    <a:cubicBezTo>
                      <a:pt x="3361" y="6339"/>
                      <a:pt x="4659" y="4781"/>
                      <a:pt x="4765" y="3160"/>
                    </a:cubicBezTo>
                    <a:cubicBezTo>
                      <a:pt x="4874" y="1485"/>
                      <a:pt x="3917" y="70"/>
                      <a:pt x="2633" y="5"/>
                    </a:cubicBezTo>
                    <a:cubicBezTo>
                      <a:pt x="2592" y="2"/>
                      <a:pt x="2551" y="1"/>
                      <a:pt x="2510" y="1"/>
                    </a:cubicBezTo>
                    <a:close/>
                  </a:path>
                </a:pathLst>
              </a:custGeom>
              <a:solidFill>
                <a:srgbClr val="DAAA8E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23" name="Google Shape;323;p15"/>
              <p:cNvSpPr/>
              <p:nvPr/>
            </p:nvSpPr>
            <p:spPr>
              <a:xfrm>
                <a:off x="9620275" y="3401300"/>
                <a:ext cx="136025" cy="94650"/>
              </a:xfrm>
              <a:custGeom>
                <a:avLst/>
                <a:gdLst/>
                <a:ahLst/>
                <a:cxnLst/>
                <a:rect l="l" t="t" r="r" b="b"/>
                <a:pathLst>
                  <a:path w="5441" h="3786" extrusionOk="0">
                    <a:moveTo>
                      <a:pt x="2372" y="0"/>
                    </a:moveTo>
                    <a:cubicBezTo>
                      <a:pt x="2198" y="22"/>
                      <a:pt x="958" y="544"/>
                      <a:pt x="806" y="762"/>
                    </a:cubicBezTo>
                    <a:cubicBezTo>
                      <a:pt x="653" y="979"/>
                      <a:pt x="196" y="1697"/>
                      <a:pt x="109" y="2045"/>
                    </a:cubicBezTo>
                    <a:cubicBezTo>
                      <a:pt x="1" y="2393"/>
                      <a:pt x="305" y="3177"/>
                      <a:pt x="392" y="3373"/>
                    </a:cubicBezTo>
                    <a:cubicBezTo>
                      <a:pt x="392" y="3373"/>
                      <a:pt x="893" y="1806"/>
                      <a:pt x="1088" y="1697"/>
                    </a:cubicBezTo>
                    <a:cubicBezTo>
                      <a:pt x="1120" y="1684"/>
                      <a:pt x="1216" y="1679"/>
                      <a:pt x="1356" y="1679"/>
                    </a:cubicBezTo>
                    <a:cubicBezTo>
                      <a:pt x="2166" y="1679"/>
                      <a:pt x="4461" y="1872"/>
                      <a:pt x="4461" y="2002"/>
                    </a:cubicBezTo>
                    <a:cubicBezTo>
                      <a:pt x="4483" y="2154"/>
                      <a:pt x="5005" y="3786"/>
                      <a:pt x="5005" y="3786"/>
                    </a:cubicBezTo>
                    <a:cubicBezTo>
                      <a:pt x="5005" y="3786"/>
                      <a:pt x="5114" y="3612"/>
                      <a:pt x="5135" y="3568"/>
                    </a:cubicBezTo>
                    <a:cubicBezTo>
                      <a:pt x="5157" y="3503"/>
                      <a:pt x="5375" y="2763"/>
                      <a:pt x="5418" y="2676"/>
                    </a:cubicBezTo>
                    <a:cubicBezTo>
                      <a:pt x="5440" y="2589"/>
                      <a:pt x="5266" y="1937"/>
                      <a:pt x="5157" y="1697"/>
                    </a:cubicBezTo>
                    <a:cubicBezTo>
                      <a:pt x="5048" y="1458"/>
                      <a:pt x="4700" y="1088"/>
                      <a:pt x="4570" y="762"/>
                    </a:cubicBezTo>
                    <a:cubicBezTo>
                      <a:pt x="4439" y="457"/>
                      <a:pt x="3786" y="152"/>
                      <a:pt x="3417" y="65"/>
                    </a:cubicBezTo>
                    <a:cubicBezTo>
                      <a:pt x="3047" y="0"/>
                      <a:pt x="2568" y="0"/>
                      <a:pt x="2372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45710539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 4">
  <p:cSld name="Title only 4">
    <p:spTree>
      <p:nvGrpSpPr>
        <p:cNvPr id="1" name="Shape 3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5" name="Google Shape;325;p16"/>
          <p:cNvSpPr txBox="1">
            <a:spLocks noGrp="1"/>
          </p:cNvSpPr>
          <p:nvPr>
            <p:ph type="title"/>
          </p:nvPr>
        </p:nvSpPr>
        <p:spPr>
          <a:xfrm>
            <a:off x="720000" y="593367"/>
            <a:ext cx="7704000" cy="763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1pPr>
            <a:lvl2pPr lvl="1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9pPr>
          </a:lstStyle>
          <a:p>
            <a:endParaRPr/>
          </a:p>
        </p:txBody>
      </p:sp>
      <p:sp>
        <p:nvSpPr>
          <p:cNvPr id="326" name="Google Shape;326;p16"/>
          <p:cNvSpPr/>
          <p:nvPr/>
        </p:nvSpPr>
        <p:spPr>
          <a:xfrm>
            <a:off x="-25" y="6127167"/>
            <a:ext cx="9144017" cy="787955"/>
          </a:xfrm>
          <a:custGeom>
            <a:avLst/>
            <a:gdLst/>
            <a:ahLst/>
            <a:cxnLst/>
            <a:rect l="l" t="t" r="r" b="b"/>
            <a:pathLst>
              <a:path w="81572" h="31202" extrusionOk="0">
                <a:moveTo>
                  <a:pt x="0" y="0"/>
                </a:moveTo>
                <a:lnTo>
                  <a:pt x="0" y="31201"/>
                </a:lnTo>
                <a:lnTo>
                  <a:pt x="81572" y="31201"/>
                </a:lnTo>
                <a:lnTo>
                  <a:pt x="81572" y="0"/>
                </a:lnTo>
                <a:close/>
              </a:path>
            </a:pathLst>
          </a:custGeom>
          <a:solidFill>
            <a:schemeClr val="dk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/>
          </a:p>
        </p:txBody>
      </p:sp>
      <p:grpSp>
        <p:nvGrpSpPr>
          <p:cNvPr id="327" name="Google Shape;327;p16"/>
          <p:cNvGrpSpPr/>
          <p:nvPr/>
        </p:nvGrpSpPr>
        <p:grpSpPr>
          <a:xfrm flipH="1">
            <a:off x="-536263" y="3001299"/>
            <a:ext cx="1627556" cy="4029607"/>
            <a:chOff x="8051179" y="2250974"/>
            <a:chExt cx="1627556" cy="3022205"/>
          </a:xfrm>
        </p:grpSpPr>
        <p:sp>
          <p:nvSpPr>
            <p:cNvPr id="328" name="Google Shape;328;p16"/>
            <p:cNvSpPr/>
            <p:nvPr/>
          </p:nvSpPr>
          <p:spPr>
            <a:xfrm>
              <a:off x="8051179" y="4811475"/>
              <a:ext cx="1627556" cy="461704"/>
            </a:xfrm>
            <a:custGeom>
              <a:avLst/>
              <a:gdLst/>
              <a:ahLst/>
              <a:cxnLst/>
              <a:rect l="l" t="t" r="r" b="b"/>
              <a:pathLst>
                <a:path w="64014" h="9771" extrusionOk="0">
                  <a:moveTo>
                    <a:pt x="31876" y="1"/>
                  </a:moveTo>
                  <a:cubicBezTo>
                    <a:pt x="14187" y="1"/>
                    <a:pt x="1" y="2155"/>
                    <a:pt x="1" y="4875"/>
                  </a:cubicBezTo>
                  <a:cubicBezTo>
                    <a:pt x="1" y="7573"/>
                    <a:pt x="14339" y="9770"/>
                    <a:pt x="32007" y="9770"/>
                  </a:cubicBezTo>
                  <a:cubicBezTo>
                    <a:pt x="49674" y="9770"/>
                    <a:pt x="64013" y="7573"/>
                    <a:pt x="64013" y="4875"/>
                  </a:cubicBezTo>
                  <a:cubicBezTo>
                    <a:pt x="64013" y="2155"/>
                    <a:pt x="49544" y="1"/>
                    <a:pt x="31876" y="1"/>
                  </a:cubicBezTo>
                  <a:close/>
                </a:path>
              </a:pathLst>
            </a:custGeom>
            <a:solidFill>
              <a:srgbClr val="191919">
                <a:alpha val="17610"/>
              </a:srgb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grpSp>
          <p:nvGrpSpPr>
            <p:cNvPr id="329" name="Google Shape;329;p16"/>
            <p:cNvGrpSpPr/>
            <p:nvPr/>
          </p:nvGrpSpPr>
          <p:grpSpPr>
            <a:xfrm flipH="1">
              <a:off x="8446873" y="2250974"/>
              <a:ext cx="798614" cy="2892524"/>
              <a:chOff x="-163725" y="2250975"/>
              <a:chExt cx="798614" cy="2892524"/>
            </a:xfrm>
          </p:grpSpPr>
          <p:sp>
            <p:nvSpPr>
              <p:cNvPr id="330" name="Google Shape;330;p16"/>
              <p:cNvSpPr/>
              <p:nvPr/>
            </p:nvSpPr>
            <p:spPr>
              <a:xfrm>
                <a:off x="212628" y="2758945"/>
                <a:ext cx="406911" cy="472834"/>
              </a:xfrm>
              <a:custGeom>
                <a:avLst/>
                <a:gdLst/>
                <a:ahLst/>
                <a:cxnLst/>
                <a:rect l="l" t="t" r="r" b="b"/>
                <a:pathLst>
                  <a:path w="5222" h="6068" extrusionOk="0">
                    <a:moveTo>
                      <a:pt x="1308" y="0"/>
                    </a:moveTo>
                    <a:cubicBezTo>
                      <a:pt x="1138" y="0"/>
                      <a:pt x="956" y="38"/>
                      <a:pt x="762" y="126"/>
                    </a:cubicBezTo>
                    <a:cubicBezTo>
                      <a:pt x="1" y="474"/>
                      <a:pt x="66" y="1214"/>
                      <a:pt x="458" y="1953"/>
                    </a:cubicBezTo>
                    <a:cubicBezTo>
                      <a:pt x="849" y="2671"/>
                      <a:pt x="3656" y="6022"/>
                      <a:pt x="3917" y="6066"/>
                    </a:cubicBezTo>
                    <a:cubicBezTo>
                      <a:pt x="3926" y="6067"/>
                      <a:pt x="3935" y="6068"/>
                      <a:pt x="3945" y="6068"/>
                    </a:cubicBezTo>
                    <a:cubicBezTo>
                      <a:pt x="4244" y="6068"/>
                      <a:pt x="5221" y="5445"/>
                      <a:pt x="5179" y="5087"/>
                    </a:cubicBezTo>
                    <a:cubicBezTo>
                      <a:pt x="5136" y="4695"/>
                      <a:pt x="3177" y="1496"/>
                      <a:pt x="2764" y="952"/>
                    </a:cubicBezTo>
                    <a:cubicBezTo>
                      <a:pt x="2421" y="524"/>
                      <a:pt x="1943" y="0"/>
                      <a:pt x="1308" y="0"/>
                    </a:cubicBezTo>
                    <a:close/>
                  </a:path>
                </a:pathLst>
              </a:custGeom>
              <a:solidFill>
                <a:schemeClr val="l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31" name="Google Shape;331;p16"/>
              <p:cNvSpPr/>
              <p:nvPr/>
            </p:nvSpPr>
            <p:spPr>
              <a:xfrm>
                <a:off x="-151881" y="2480454"/>
                <a:ext cx="562990" cy="1236085"/>
              </a:xfrm>
              <a:custGeom>
                <a:avLst/>
                <a:gdLst/>
                <a:ahLst/>
                <a:cxnLst/>
                <a:rect l="l" t="t" r="r" b="b"/>
                <a:pathLst>
                  <a:path w="7225" h="15863" extrusionOk="0">
                    <a:moveTo>
                      <a:pt x="2960" y="1"/>
                    </a:moveTo>
                    <a:cubicBezTo>
                      <a:pt x="2960" y="1"/>
                      <a:pt x="2851" y="2438"/>
                      <a:pt x="2699" y="2568"/>
                    </a:cubicBezTo>
                    <a:cubicBezTo>
                      <a:pt x="2264" y="2938"/>
                      <a:pt x="653" y="3243"/>
                      <a:pt x="371" y="3896"/>
                    </a:cubicBezTo>
                    <a:cubicBezTo>
                      <a:pt x="1" y="4657"/>
                      <a:pt x="2002" y="8138"/>
                      <a:pt x="2264" y="9292"/>
                    </a:cubicBezTo>
                    <a:cubicBezTo>
                      <a:pt x="2525" y="10445"/>
                      <a:pt x="1981" y="12229"/>
                      <a:pt x="1807" y="13360"/>
                    </a:cubicBezTo>
                    <a:cubicBezTo>
                      <a:pt x="1633" y="14492"/>
                      <a:pt x="5179" y="15862"/>
                      <a:pt x="5310" y="15862"/>
                    </a:cubicBezTo>
                    <a:cubicBezTo>
                      <a:pt x="5440" y="15862"/>
                      <a:pt x="6593" y="14796"/>
                      <a:pt x="6811" y="14426"/>
                    </a:cubicBezTo>
                    <a:cubicBezTo>
                      <a:pt x="7029" y="14057"/>
                      <a:pt x="6811" y="11163"/>
                      <a:pt x="6811" y="10423"/>
                    </a:cubicBezTo>
                    <a:cubicBezTo>
                      <a:pt x="6811" y="9683"/>
                      <a:pt x="6985" y="7094"/>
                      <a:pt x="7007" y="6920"/>
                    </a:cubicBezTo>
                    <a:cubicBezTo>
                      <a:pt x="7224" y="5788"/>
                      <a:pt x="6942" y="4896"/>
                      <a:pt x="6898" y="4657"/>
                    </a:cubicBezTo>
                    <a:cubicBezTo>
                      <a:pt x="6855" y="4418"/>
                      <a:pt x="6855" y="4026"/>
                      <a:pt x="6746" y="3874"/>
                    </a:cubicBezTo>
                    <a:cubicBezTo>
                      <a:pt x="6506" y="3569"/>
                      <a:pt x="5179" y="3156"/>
                      <a:pt x="5157" y="3003"/>
                    </a:cubicBezTo>
                    <a:cubicBezTo>
                      <a:pt x="5136" y="2851"/>
                      <a:pt x="4962" y="741"/>
                      <a:pt x="4962" y="741"/>
                    </a:cubicBezTo>
                    <a:lnTo>
                      <a:pt x="2960" y="1"/>
                    </a:lnTo>
                    <a:close/>
                  </a:path>
                </a:pathLst>
              </a:custGeom>
              <a:solidFill>
                <a:srgbClr val="FFBD9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32" name="Google Shape;332;p16"/>
              <p:cNvSpPr/>
              <p:nvPr/>
            </p:nvSpPr>
            <p:spPr>
              <a:xfrm>
                <a:off x="-138323" y="2680556"/>
                <a:ext cx="544367" cy="787173"/>
              </a:xfrm>
              <a:custGeom>
                <a:avLst/>
                <a:gdLst/>
                <a:ahLst/>
                <a:cxnLst/>
                <a:rect l="l" t="t" r="r" b="b"/>
                <a:pathLst>
                  <a:path w="6986" h="10102" extrusionOk="0">
                    <a:moveTo>
                      <a:pt x="2525" y="0"/>
                    </a:moveTo>
                    <a:cubicBezTo>
                      <a:pt x="2525" y="0"/>
                      <a:pt x="1132" y="631"/>
                      <a:pt x="697" y="849"/>
                    </a:cubicBezTo>
                    <a:cubicBezTo>
                      <a:pt x="284" y="1045"/>
                      <a:pt x="1" y="1415"/>
                      <a:pt x="23" y="1980"/>
                    </a:cubicBezTo>
                    <a:cubicBezTo>
                      <a:pt x="44" y="2546"/>
                      <a:pt x="1807" y="6789"/>
                      <a:pt x="1872" y="7028"/>
                    </a:cubicBezTo>
                    <a:cubicBezTo>
                      <a:pt x="1916" y="7267"/>
                      <a:pt x="1393" y="9509"/>
                      <a:pt x="1676" y="9726"/>
                    </a:cubicBezTo>
                    <a:cubicBezTo>
                      <a:pt x="1741" y="9791"/>
                      <a:pt x="3330" y="9987"/>
                      <a:pt x="4744" y="10074"/>
                    </a:cubicBezTo>
                    <a:cubicBezTo>
                      <a:pt x="5364" y="10096"/>
                      <a:pt x="5876" y="10101"/>
                      <a:pt x="6232" y="10101"/>
                    </a:cubicBezTo>
                    <a:cubicBezTo>
                      <a:pt x="6588" y="10101"/>
                      <a:pt x="6789" y="10096"/>
                      <a:pt x="6789" y="10096"/>
                    </a:cubicBezTo>
                    <a:cubicBezTo>
                      <a:pt x="6789" y="10096"/>
                      <a:pt x="6702" y="8007"/>
                      <a:pt x="6768" y="7180"/>
                    </a:cubicBezTo>
                    <a:cubicBezTo>
                      <a:pt x="6855" y="6201"/>
                      <a:pt x="6855" y="5440"/>
                      <a:pt x="6898" y="4874"/>
                    </a:cubicBezTo>
                    <a:cubicBezTo>
                      <a:pt x="6985" y="3873"/>
                      <a:pt x="6963" y="2764"/>
                      <a:pt x="6898" y="2502"/>
                    </a:cubicBezTo>
                    <a:cubicBezTo>
                      <a:pt x="6833" y="2263"/>
                      <a:pt x="6746" y="1610"/>
                      <a:pt x="6572" y="1306"/>
                    </a:cubicBezTo>
                    <a:cubicBezTo>
                      <a:pt x="6398" y="1001"/>
                      <a:pt x="5070" y="544"/>
                      <a:pt x="5070" y="544"/>
                    </a:cubicBezTo>
                    <a:lnTo>
                      <a:pt x="4679" y="1284"/>
                    </a:lnTo>
                    <a:lnTo>
                      <a:pt x="2525" y="0"/>
                    </a:lnTo>
                    <a:close/>
                  </a:path>
                </a:pathLst>
              </a:custGeom>
              <a:solidFill>
                <a:schemeClr val="dk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33" name="Google Shape;333;p16"/>
              <p:cNvSpPr/>
              <p:nvPr/>
            </p:nvSpPr>
            <p:spPr>
              <a:xfrm>
                <a:off x="-101057" y="2738218"/>
                <a:ext cx="501977" cy="713458"/>
              </a:xfrm>
              <a:custGeom>
                <a:avLst/>
                <a:gdLst/>
                <a:ahLst/>
                <a:cxnLst/>
                <a:rect l="l" t="t" r="r" b="b"/>
                <a:pathLst>
                  <a:path w="6442" h="9156" extrusionOk="0">
                    <a:moveTo>
                      <a:pt x="654" y="0"/>
                    </a:moveTo>
                    <a:lnTo>
                      <a:pt x="654" y="0"/>
                    </a:lnTo>
                    <a:cubicBezTo>
                      <a:pt x="653" y="0"/>
                      <a:pt x="1" y="1197"/>
                      <a:pt x="23" y="1632"/>
                    </a:cubicBezTo>
                    <a:cubicBezTo>
                      <a:pt x="23" y="2089"/>
                      <a:pt x="1132" y="4983"/>
                      <a:pt x="1350" y="5592"/>
                    </a:cubicBezTo>
                    <a:cubicBezTo>
                      <a:pt x="1568" y="6179"/>
                      <a:pt x="893" y="8507"/>
                      <a:pt x="1176" y="8899"/>
                    </a:cubicBezTo>
                    <a:cubicBezTo>
                      <a:pt x="1314" y="9106"/>
                      <a:pt x="1837" y="9155"/>
                      <a:pt x="2298" y="9155"/>
                    </a:cubicBezTo>
                    <a:cubicBezTo>
                      <a:pt x="2707" y="9155"/>
                      <a:pt x="3069" y="9117"/>
                      <a:pt x="3069" y="9117"/>
                    </a:cubicBezTo>
                    <a:cubicBezTo>
                      <a:pt x="3069" y="9117"/>
                      <a:pt x="2590" y="8573"/>
                      <a:pt x="2808" y="8246"/>
                    </a:cubicBezTo>
                    <a:cubicBezTo>
                      <a:pt x="3047" y="7920"/>
                      <a:pt x="6441" y="6810"/>
                      <a:pt x="6441" y="6810"/>
                    </a:cubicBezTo>
                    <a:cubicBezTo>
                      <a:pt x="6441" y="6810"/>
                      <a:pt x="3961" y="5418"/>
                      <a:pt x="3395" y="5309"/>
                    </a:cubicBezTo>
                    <a:cubicBezTo>
                      <a:pt x="2851" y="5200"/>
                      <a:pt x="1002" y="2459"/>
                      <a:pt x="545" y="1849"/>
                    </a:cubicBezTo>
                    <a:cubicBezTo>
                      <a:pt x="110" y="1240"/>
                      <a:pt x="654" y="0"/>
                      <a:pt x="654" y="0"/>
                    </a:cubicBezTo>
                    <a:close/>
                  </a:path>
                </a:pathLst>
              </a:custGeom>
              <a:solidFill>
                <a:srgbClr val="191919">
                  <a:alpha val="1761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34" name="Google Shape;334;p16"/>
              <p:cNvSpPr/>
              <p:nvPr/>
            </p:nvSpPr>
            <p:spPr>
              <a:xfrm>
                <a:off x="66840" y="2548323"/>
                <a:ext cx="172988" cy="132312"/>
              </a:xfrm>
              <a:custGeom>
                <a:avLst/>
                <a:gdLst/>
                <a:ahLst/>
                <a:cxnLst/>
                <a:rect l="l" t="t" r="r" b="b"/>
                <a:pathLst>
                  <a:path w="2220" h="1698" extrusionOk="0">
                    <a:moveTo>
                      <a:pt x="66" y="0"/>
                    </a:moveTo>
                    <a:lnTo>
                      <a:pt x="1" y="1284"/>
                    </a:lnTo>
                    <a:lnTo>
                      <a:pt x="675" y="1697"/>
                    </a:lnTo>
                    <a:lnTo>
                      <a:pt x="2220" y="1088"/>
                    </a:lnTo>
                    <a:lnTo>
                      <a:pt x="66" y="0"/>
                    </a:lnTo>
                    <a:close/>
                  </a:path>
                </a:pathLst>
              </a:custGeom>
              <a:solidFill>
                <a:srgbClr val="191919">
                  <a:alpha val="1761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35" name="Google Shape;335;p16"/>
              <p:cNvSpPr/>
              <p:nvPr/>
            </p:nvSpPr>
            <p:spPr>
              <a:xfrm>
                <a:off x="-163725" y="2754192"/>
                <a:ext cx="203534" cy="533457"/>
              </a:xfrm>
              <a:custGeom>
                <a:avLst/>
                <a:gdLst/>
                <a:ahLst/>
                <a:cxnLst/>
                <a:rect l="l" t="t" r="r" b="b"/>
                <a:pathLst>
                  <a:path w="2612" h="6846" extrusionOk="0">
                    <a:moveTo>
                      <a:pt x="1127" y="1"/>
                    </a:moveTo>
                    <a:cubicBezTo>
                      <a:pt x="411" y="1"/>
                      <a:pt x="126" y="619"/>
                      <a:pt x="66" y="1405"/>
                    </a:cubicBezTo>
                    <a:cubicBezTo>
                      <a:pt x="0" y="2232"/>
                      <a:pt x="588" y="6540"/>
                      <a:pt x="784" y="6714"/>
                    </a:cubicBezTo>
                    <a:cubicBezTo>
                      <a:pt x="868" y="6798"/>
                      <a:pt x="1139" y="6846"/>
                      <a:pt x="1436" y="6846"/>
                    </a:cubicBezTo>
                    <a:cubicBezTo>
                      <a:pt x="1832" y="6846"/>
                      <a:pt x="2273" y="6761"/>
                      <a:pt x="2372" y="6562"/>
                    </a:cubicBezTo>
                    <a:cubicBezTo>
                      <a:pt x="2546" y="6214"/>
                      <a:pt x="2611" y="2471"/>
                      <a:pt x="2546" y="1775"/>
                    </a:cubicBezTo>
                    <a:cubicBezTo>
                      <a:pt x="2459" y="1101"/>
                      <a:pt x="2285" y="143"/>
                      <a:pt x="1306" y="13"/>
                    </a:cubicBezTo>
                    <a:cubicBezTo>
                      <a:pt x="1244" y="5"/>
                      <a:pt x="1184" y="1"/>
                      <a:pt x="1127" y="1"/>
                    </a:cubicBezTo>
                    <a:close/>
                  </a:path>
                </a:pathLst>
              </a:custGeom>
              <a:solidFill>
                <a:schemeClr val="dk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36" name="Google Shape;336;p16"/>
              <p:cNvSpPr/>
              <p:nvPr/>
            </p:nvSpPr>
            <p:spPr>
              <a:xfrm>
                <a:off x="4115" y="2258222"/>
                <a:ext cx="332417" cy="373794"/>
              </a:xfrm>
              <a:custGeom>
                <a:avLst/>
                <a:gdLst/>
                <a:ahLst/>
                <a:cxnLst/>
                <a:rect l="l" t="t" r="r" b="b"/>
                <a:pathLst>
                  <a:path w="4266" h="4797" extrusionOk="0">
                    <a:moveTo>
                      <a:pt x="2013" y="0"/>
                    </a:moveTo>
                    <a:cubicBezTo>
                      <a:pt x="1610" y="0"/>
                      <a:pt x="1209" y="133"/>
                      <a:pt x="893" y="481"/>
                    </a:cubicBezTo>
                    <a:cubicBezTo>
                      <a:pt x="0" y="1417"/>
                      <a:pt x="196" y="2505"/>
                      <a:pt x="523" y="3201"/>
                    </a:cubicBezTo>
                    <a:cubicBezTo>
                      <a:pt x="784" y="3745"/>
                      <a:pt x="1067" y="4050"/>
                      <a:pt x="1632" y="4419"/>
                    </a:cubicBezTo>
                    <a:cubicBezTo>
                      <a:pt x="1752" y="4479"/>
                      <a:pt x="2700" y="4797"/>
                      <a:pt x="3038" y="4797"/>
                    </a:cubicBezTo>
                    <a:cubicBezTo>
                      <a:pt x="3068" y="4797"/>
                      <a:pt x="3093" y="4795"/>
                      <a:pt x="3112" y="4789"/>
                    </a:cubicBezTo>
                    <a:cubicBezTo>
                      <a:pt x="3264" y="4768"/>
                      <a:pt x="3525" y="3614"/>
                      <a:pt x="3591" y="3614"/>
                    </a:cubicBezTo>
                    <a:cubicBezTo>
                      <a:pt x="3598" y="3618"/>
                      <a:pt x="3608" y="3620"/>
                      <a:pt x="3619" y="3620"/>
                    </a:cubicBezTo>
                    <a:cubicBezTo>
                      <a:pt x="3675" y="3620"/>
                      <a:pt x="3768" y="3574"/>
                      <a:pt x="3786" y="3484"/>
                    </a:cubicBezTo>
                    <a:cubicBezTo>
                      <a:pt x="3808" y="3353"/>
                      <a:pt x="3765" y="2505"/>
                      <a:pt x="3808" y="2418"/>
                    </a:cubicBezTo>
                    <a:cubicBezTo>
                      <a:pt x="3852" y="2331"/>
                      <a:pt x="4265" y="1395"/>
                      <a:pt x="3721" y="764"/>
                    </a:cubicBezTo>
                    <a:cubicBezTo>
                      <a:pt x="3431" y="404"/>
                      <a:pt x="2717" y="0"/>
                      <a:pt x="2013" y="0"/>
                    </a:cubicBezTo>
                    <a:close/>
                  </a:path>
                </a:pathLst>
              </a:custGeom>
              <a:solidFill>
                <a:srgbClr val="FFBD9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37" name="Google Shape;337;p16"/>
              <p:cNvSpPr/>
              <p:nvPr/>
            </p:nvSpPr>
            <p:spPr>
              <a:xfrm>
                <a:off x="-4379" y="2250975"/>
                <a:ext cx="318859" cy="302495"/>
              </a:xfrm>
              <a:custGeom>
                <a:avLst/>
                <a:gdLst/>
                <a:ahLst/>
                <a:cxnLst/>
                <a:rect l="l" t="t" r="r" b="b"/>
                <a:pathLst>
                  <a:path w="4092" h="3882" extrusionOk="0">
                    <a:moveTo>
                      <a:pt x="2362" y="0"/>
                    </a:moveTo>
                    <a:cubicBezTo>
                      <a:pt x="1844" y="0"/>
                      <a:pt x="1024" y="197"/>
                      <a:pt x="588" y="1053"/>
                    </a:cubicBezTo>
                    <a:cubicBezTo>
                      <a:pt x="1" y="2228"/>
                      <a:pt x="697" y="3860"/>
                      <a:pt x="980" y="3881"/>
                    </a:cubicBezTo>
                    <a:cubicBezTo>
                      <a:pt x="1089" y="3881"/>
                      <a:pt x="1502" y="3337"/>
                      <a:pt x="1306" y="2228"/>
                    </a:cubicBezTo>
                    <a:cubicBezTo>
                      <a:pt x="1306" y="2221"/>
                      <a:pt x="1309" y="2218"/>
                      <a:pt x="1313" y="2218"/>
                    </a:cubicBezTo>
                    <a:cubicBezTo>
                      <a:pt x="1382" y="2218"/>
                      <a:pt x="1945" y="2908"/>
                      <a:pt x="2054" y="2908"/>
                    </a:cubicBezTo>
                    <a:cubicBezTo>
                      <a:pt x="2060" y="2908"/>
                      <a:pt x="2065" y="2906"/>
                      <a:pt x="2068" y="2902"/>
                    </a:cubicBezTo>
                    <a:cubicBezTo>
                      <a:pt x="2133" y="2837"/>
                      <a:pt x="1807" y="1858"/>
                      <a:pt x="2068" y="1662"/>
                    </a:cubicBezTo>
                    <a:cubicBezTo>
                      <a:pt x="2575" y="1299"/>
                      <a:pt x="3011" y="1194"/>
                      <a:pt x="3347" y="1194"/>
                    </a:cubicBezTo>
                    <a:cubicBezTo>
                      <a:pt x="3817" y="1194"/>
                      <a:pt x="4091" y="1401"/>
                      <a:pt x="4091" y="1401"/>
                    </a:cubicBezTo>
                    <a:cubicBezTo>
                      <a:pt x="3982" y="357"/>
                      <a:pt x="3069" y="161"/>
                      <a:pt x="2764" y="52"/>
                    </a:cubicBezTo>
                    <a:cubicBezTo>
                      <a:pt x="2685" y="24"/>
                      <a:pt x="2542" y="0"/>
                      <a:pt x="2362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38" name="Google Shape;338;p16"/>
              <p:cNvSpPr/>
              <p:nvPr/>
            </p:nvSpPr>
            <p:spPr>
              <a:xfrm>
                <a:off x="85463" y="2414142"/>
                <a:ext cx="54390" cy="100442"/>
              </a:xfrm>
              <a:custGeom>
                <a:avLst/>
                <a:gdLst/>
                <a:ahLst/>
                <a:cxnLst/>
                <a:rect l="l" t="t" r="r" b="b"/>
                <a:pathLst>
                  <a:path w="698" h="1289" extrusionOk="0">
                    <a:moveTo>
                      <a:pt x="329" y="1"/>
                    </a:moveTo>
                    <a:cubicBezTo>
                      <a:pt x="315" y="1"/>
                      <a:pt x="300" y="1"/>
                      <a:pt x="284" y="3"/>
                    </a:cubicBezTo>
                    <a:cubicBezTo>
                      <a:pt x="110" y="25"/>
                      <a:pt x="1" y="351"/>
                      <a:pt x="66" y="700"/>
                    </a:cubicBezTo>
                    <a:cubicBezTo>
                      <a:pt x="108" y="1034"/>
                      <a:pt x="311" y="1288"/>
                      <a:pt x="481" y="1288"/>
                    </a:cubicBezTo>
                    <a:cubicBezTo>
                      <a:pt x="488" y="1288"/>
                      <a:pt x="495" y="1288"/>
                      <a:pt x="501" y="1287"/>
                    </a:cubicBezTo>
                    <a:cubicBezTo>
                      <a:pt x="697" y="1265"/>
                      <a:pt x="697" y="787"/>
                      <a:pt x="632" y="438"/>
                    </a:cubicBezTo>
                    <a:cubicBezTo>
                      <a:pt x="592" y="118"/>
                      <a:pt x="497" y="1"/>
                      <a:pt x="329" y="1"/>
                    </a:cubicBezTo>
                    <a:close/>
                  </a:path>
                </a:pathLst>
              </a:custGeom>
              <a:solidFill>
                <a:srgbClr val="FFBD9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39" name="Google Shape;339;p16"/>
              <p:cNvSpPr/>
              <p:nvPr/>
            </p:nvSpPr>
            <p:spPr>
              <a:xfrm>
                <a:off x="141409" y="5055834"/>
                <a:ext cx="108624" cy="20416"/>
              </a:xfrm>
              <a:custGeom>
                <a:avLst/>
                <a:gdLst/>
                <a:ahLst/>
                <a:cxnLst/>
                <a:rect l="l" t="t" r="r" b="b"/>
                <a:pathLst>
                  <a:path w="1394" h="262" extrusionOk="0">
                    <a:moveTo>
                      <a:pt x="1" y="0"/>
                    </a:moveTo>
                    <a:lnTo>
                      <a:pt x="1" y="261"/>
                    </a:lnTo>
                    <a:lnTo>
                      <a:pt x="1393" y="261"/>
                    </a:lnTo>
                    <a:lnTo>
                      <a:pt x="1393" y="0"/>
                    </a:lnTo>
                    <a:close/>
                  </a:path>
                </a:pathLst>
              </a:custGeom>
              <a:solidFill>
                <a:srgbClr val="191919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40" name="Google Shape;340;p16"/>
              <p:cNvSpPr/>
              <p:nvPr/>
            </p:nvSpPr>
            <p:spPr>
              <a:xfrm>
                <a:off x="119436" y="4912459"/>
                <a:ext cx="412054" cy="180780"/>
              </a:xfrm>
              <a:custGeom>
                <a:avLst/>
                <a:gdLst/>
                <a:ahLst/>
                <a:cxnLst/>
                <a:rect l="l" t="t" r="r" b="b"/>
                <a:pathLst>
                  <a:path w="5288" h="2320" extrusionOk="0">
                    <a:moveTo>
                      <a:pt x="501" y="0"/>
                    </a:moveTo>
                    <a:cubicBezTo>
                      <a:pt x="411" y="0"/>
                      <a:pt x="353" y="4"/>
                      <a:pt x="348" y="13"/>
                    </a:cubicBezTo>
                    <a:cubicBezTo>
                      <a:pt x="152" y="274"/>
                      <a:pt x="44" y="752"/>
                      <a:pt x="22" y="992"/>
                    </a:cubicBezTo>
                    <a:cubicBezTo>
                      <a:pt x="0" y="1253"/>
                      <a:pt x="152" y="1840"/>
                      <a:pt x="348" y="1840"/>
                    </a:cubicBezTo>
                    <a:cubicBezTo>
                      <a:pt x="870" y="1840"/>
                      <a:pt x="1480" y="1862"/>
                      <a:pt x="2024" y="1927"/>
                    </a:cubicBezTo>
                    <a:cubicBezTo>
                      <a:pt x="2568" y="1993"/>
                      <a:pt x="2763" y="2319"/>
                      <a:pt x="4156" y="2319"/>
                    </a:cubicBezTo>
                    <a:cubicBezTo>
                      <a:pt x="4548" y="2319"/>
                      <a:pt x="5287" y="2276"/>
                      <a:pt x="5266" y="2123"/>
                    </a:cubicBezTo>
                    <a:cubicBezTo>
                      <a:pt x="5244" y="1949"/>
                      <a:pt x="3938" y="1666"/>
                      <a:pt x="3525" y="1275"/>
                    </a:cubicBezTo>
                    <a:cubicBezTo>
                      <a:pt x="2459" y="296"/>
                      <a:pt x="1741" y="56"/>
                      <a:pt x="1741" y="56"/>
                    </a:cubicBezTo>
                    <a:cubicBezTo>
                      <a:pt x="1741" y="56"/>
                      <a:pt x="863" y="0"/>
                      <a:pt x="501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41" name="Google Shape;341;p16"/>
              <p:cNvSpPr/>
              <p:nvPr/>
            </p:nvSpPr>
            <p:spPr>
              <a:xfrm>
                <a:off x="39724" y="3463978"/>
                <a:ext cx="359534" cy="1502502"/>
              </a:xfrm>
              <a:custGeom>
                <a:avLst/>
                <a:gdLst/>
                <a:ahLst/>
                <a:cxnLst/>
                <a:rect l="l" t="t" r="r" b="b"/>
                <a:pathLst>
                  <a:path w="4614" h="19282" extrusionOk="0">
                    <a:moveTo>
                      <a:pt x="4380" y="0"/>
                    </a:moveTo>
                    <a:cubicBezTo>
                      <a:pt x="3680" y="0"/>
                      <a:pt x="262" y="999"/>
                      <a:pt x="262" y="999"/>
                    </a:cubicBezTo>
                    <a:cubicBezTo>
                      <a:pt x="262" y="999"/>
                      <a:pt x="174" y="1565"/>
                      <a:pt x="87" y="2370"/>
                    </a:cubicBezTo>
                    <a:cubicBezTo>
                      <a:pt x="0" y="3175"/>
                      <a:pt x="784" y="5743"/>
                      <a:pt x="1067" y="7766"/>
                    </a:cubicBezTo>
                    <a:cubicBezTo>
                      <a:pt x="1328" y="9790"/>
                      <a:pt x="1502" y="10203"/>
                      <a:pt x="1436" y="10682"/>
                    </a:cubicBezTo>
                    <a:cubicBezTo>
                      <a:pt x="1371" y="11160"/>
                      <a:pt x="762" y="13097"/>
                      <a:pt x="849" y="14381"/>
                    </a:cubicBezTo>
                    <a:cubicBezTo>
                      <a:pt x="914" y="15686"/>
                      <a:pt x="1175" y="19059"/>
                      <a:pt x="1175" y="19059"/>
                    </a:cubicBezTo>
                    <a:cubicBezTo>
                      <a:pt x="1175" y="19059"/>
                      <a:pt x="1567" y="19233"/>
                      <a:pt x="2220" y="19276"/>
                    </a:cubicBezTo>
                    <a:cubicBezTo>
                      <a:pt x="2257" y="19280"/>
                      <a:pt x="2293" y="19281"/>
                      <a:pt x="2328" y="19281"/>
                    </a:cubicBezTo>
                    <a:cubicBezTo>
                      <a:pt x="2943" y="19281"/>
                      <a:pt x="3351" y="18776"/>
                      <a:pt x="3351" y="18776"/>
                    </a:cubicBezTo>
                    <a:cubicBezTo>
                      <a:pt x="3351" y="18776"/>
                      <a:pt x="3873" y="11247"/>
                      <a:pt x="3960" y="10464"/>
                    </a:cubicBezTo>
                    <a:cubicBezTo>
                      <a:pt x="4026" y="9942"/>
                      <a:pt x="4439" y="6395"/>
                      <a:pt x="4570" y="3502"/>
                    </a:cubicBezTo>
                    <a:cubicBezTo>
                      <a:pt x="4613" y="2566"/>
                      <a:pt x="4504" y="412"/>
                      <a:pt x="4504" y="42"/>
                    </a:cubicBezTo>
                    <a:cubicBezTo>
                      <a:pt x="4504" y="13"/>
                      <a:pt x="4460" y="0"/>
                      <a:pt x="4380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42" name="Google Shape;342;p16"/>
              <p:cNvSpPr/>
              <p:nvPr/>
            </p:nvSpPr>
            <p:spPr>
              <a:xfrm>
                <a:off x="-41624" y="3440056"/>
                <a:ext cx="371379" cy="1526736"/>
              </a:xfrm>
              <a:custGeom>
                <a:avLst/>
                <a:gdLst/>
                <a:ahLst/>
                <a:cxnLst/>
                <a:rect l="l" t="t" r="r" b="b"/>
                <a:pathLst>
                  <a:path w="4766" h="19593" extrusionOk="0">
                    <a:moveTo>
                      <a:pt x="457" y="1"/>
                    </a:moveTo>
                    <a:cubicBezTo>
                      <a:pt x="457" y="1"/>
                      <a:pt x="0" y="1198"/>
                      <a:pt x="0" y="2198"/>
                    </a:cubicBezTo>
                    <a:cubicBezTo>
                      <a:pt x="22" y="3004"/>
                      <a:pt x="239" y="4505"/>
                      <a:pt x="522" y="6528"/>
                    </a:cubicBezTo>
                    <a:cubicBezTo>
                      <a:pt x="805" y="8552"/>
                      <a:pt x="827" y="10423"/>
                      <a:pt x="762" y="10902"/>
                    </a:cubicBezTo>
                    <a:cubicBezTo>
                      <a:pt x="696" y="11380"/>
                      <a:pt x="44" y="13404"/>
                      <a:pt x="131" y="14688"/>
                    </a:cubicBezTo>
                    <a:cubicBezTo>
                      <a:pt x="196" y="15993"/>
                      <a:pt x="544" y="19170"/>
                      <a:pt x="544" y="19170"/>
                    </a:cubicBezTo>
                    <a:cubicBezTo>
                      <a:pt x="544" y="19170"/>
                      <a:pt x="957" y="19518"/>
                      <a:pt x="1610" y="19583"/>
                    </a:cubicBezTo>
                    <a:cubicBezTo>
                      <a:pt x="1680" y="19590"/>
                      <a:pt x="1747" y="19593"/>
                      <a:pt x="1810" y="19593"/>
                    </a:cubicBezTo>
                    <a:cubicBezTo>
                      <a:pt x="2361" y="19593"/>
                      <a:pt x="2676" y="19366"/>
                      <a:pt x="2676" y="19366"/>
                    </a:cubicBezTo>
                    <a:cubicBezTo>
                      <a:pt x="2676" y="19366"/>
                      <a:pt x="3438" y="11816"/>
                      <a:pt x="3742" y="11076"/>
                    </a:cubicBezTo>
                    <a:cubicBezTo>
                      <a:pt x="4221" y="9901"/>
                      <a:pt x="4308" y="6158"/>
                      <a:pt x="4635" y="3613"/>
                    </a:cubicBezTo>
                    <a:cubicBezTo>
                      <a:pt x="4765" y="2590"/>
                      <a:pt x="4678" y="306"/>
                      <a:pt x="4678" y="306"/>
                    </a:cubicBezTo>
                    <a:lnTo>
                      <a:pt x="457" y="1"/>
                    </a:ln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43" name="Google Shape;343;p16"/>
              <p:cNvSpPr/>
              <p:nvPr/>
            </p:nvSpPr>
            <p:spPr>
              <a:xfrm>
                <a:off x="-41637" y="3440056"/>
                <a:ext cx="371379" cy="1526736"/>
              </a:xfrm>
              <a:custGeom>
                <a:avLst/>
                <a:gdLst/>
                <a:ahLst/>
                <a:cxnLst/>
                <a:rect l="l" t="t" r="r" b="b"/>
                <a:pathLst>
                  <a:path w="4766" h="19593" extrusionOk="0">
                    <a:moveTo>
                      <a:pt x="457" y="1"/>
                    </a:moveTo>
                    <a:cubicBezTo>
                      <a:pt x="457" y="1"/>
                      <a:pt x="0" y="1198"/>
                      <a:pt x="0" y="2198"/>
                    </a:cubicBezTo>
                    <a:cubicBezTo>
                      <a:pt x="22" y="3004"/>
                      <a:pt x="239" y="4505"/>
                      <a:pt x="522" y="6528"/>
                    </a:cubicBezTo>
                    <a:cubicBezTo>
                      <a:pt x="805" y="8552"/>
                      <a:pt x="827" y="10423"/>
                      <a:pt x="762" y="10902"/>
                    </a:cubicBezTo>
                    <a:cubicBezTo>
                      <a:pt x="696" y="11380"/>
                      <a:pt x="44" y="13404"/>
                      <a:pt x="131" y="14688"/>
                    </a:cubicBezTo>
                    <a:cubicBezTo>
                      <a:pt x="196" y="15993"/>
                      <a:pt x="544" y="19170"/>
                      <a:pt x="544" y="19170"/>
                    </a:cubicBezTo>
                    <a:cubicBezTo>
                      <a:pt x="544" y="19170"/>
                      <a:pt x="957" y="19518"/>
                      <a:pt x="1610" y="19583"/>
                    </a:cubicBezTo>
                    <a:cubicBezTo>
                      <a:pt x="1680" y="19590"/>
                      <a:pt x="1747" y="19593"/>
                      <a:pt x="1810" y="19593"/>
                    </a:cubicBezTo>
                    <a:cubicBezTo>
                      <a:pt x="2361" y="19593"/>
                      <a:pt x="2676" y="19366"/>
                      <a:pt x="2676" y="19366"/>
                    </a:cubicBezTo>
                    <a:cubicBezTo>
                      <a:pt x="2676" y="19366"/>
                      <a:pt x="3438" y="11816"/>
                      <a:pt x="3742" y="11076"/>
                    </a:cubicBezTo>
                    <a:cubicBezTo>
                      <a:pt x="4221" y="9901"/>
                      <a:pt x="4308" y="6158"/>
                      <a:pt x="4635" y="3613"/>
                    </a:cubicBezTo>
                    <a:cubicBezTo>
                      <a:pt x="4765" y="2590"/>
                      <a:pt x="4678" y="306"/>
                      <a:pt x="4678" y="306"/>
                    </a:cubicBezTo>
                    <a:lnTo>
                      <a:pt x="457" y="1"/>
                    </a:lnTo>
                    <a:close/>
                  </a:path>
                </a:pathLst>
              </a:custGeom>
              <a:solidFill>
                <a:srgbClr val="FFFFFF">
                  <a:alpha val="1824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44" name="Google Shape;344;p16"/>
              <p:cNvSpPr/>
              <p:nvPr/>
            </p:nvSpPr>
            <p:spPr>
              <a:xfrm>
                <a:off x="-2677" y="5084665"/>
                <a:ext cx="108546" cy="28909"/>
              </a:xfrm>
              <a:custGeom>
                <a:avLst/>
                <a:gdLst/>
                <a:ahLst/>
                <a:cxnLst/>
                <a:rect l="l" t="t" r="r" b="b"/>
                <a:pathLst>
                  <a:path w="1393" h="371" extrusionOk="0">
                    <a:moveTo>
                      <a:pt x="22" y="0"/>
                    </a:moveTo>
                    <a:lnTo>
                      <a:pt x="0" y="283"/>
                    </a:lnTo>
                    <a:lnTo>
                      <a:pt x="1371" y="370"/>
                    </a:lnTo>
                    <a:lnTo>
                      <a:pt x="1393" y="87"/>
                    </a:lnTo>
                    <a:lnTo>
                      <a:pt x="22" y="0"/>
                    </a:lnTo>
                    <a:close/>
                  </a:path>
                </a:pathLst>
              </a:custGeom>
              <a:solidFill>
                <a:srgbClr val="FFFFFF">
                  <a:alpha val="1824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45" name="Google Shape;345;p16"/>
              <p:cNvSpPr/>
              <p:nvPr/>
            </p:nvSpPr>
            <p:spPr>
              <a:xfrm>
                <a:off x="-21300" y="4938329"/>
                <a:ext cx="406366" cy="205170"/>
              </a:xfrm>
              <a:custGeom>
                <a:avLst/>
                <a:gdLst/>
                <a:ahLst/>
                <a:cxnLst/>
                <a:rect l="l" t="t" r="r" b="b"/>
                <a:pathLst>
                  <a:path w="5215" h="2633" extrusionOk="0">
                    <a:moveTo>
                      <a:pt x="495" y="0"/>
                    </a:moveTo>
                    <a:cubicBezTo>
                      <a:pt x="461" y="0"/>
                      <a:pt x="440" y="2"/>
                      <a:pt x="435" y="7"/>
                    </a:cubicBezTo>
                    <a:cubicBezTo>
                      <a:pt x="239" y="268"/>
                      <a:pt x="65" y="769"/>
                      <a:pt x="44" y="986"/>
                    </a:cubicBezTo>
                    <a:cubicBezTo>
                      <a:pt x="0" y="1269"/>
                      <a:pt x="131" y="1878"/>
                      <a:pt x="305" y="1900"/>
                    </a:cubicBezTo>
                    <a:cubicBezTo>
                      <a:pt x="827" y="1922"/>
                      <a:pt x="1458" y="1987"/>
                      <a:pt x="1980" y="2096"/>
                    </a:cubicBezTo>
                    <a:cubicBezTo>
                      <a:pt x="2524" y="2205"/>
                      <a:pt x="2698" y="2531"/>
                      <a:pt x="4091" y="2618"/>
                    </a:cubicBezTo>
                    <a:cubicBezTo>
                      <a:pt x="4221" y="2625"/>
                      <a:pt x="4390" y="2633"/>
                      <a:pt x="4557" y="2633"/>
                    </a:cubicBezTo>
                    <a:cubicBezTo>
                      <a:pt x="4891" y="2633"/>
                      <a:pt x="5215" y="2604"/>
                      <a:pt x="5200" y="2487"/>
                    </a:cubicBezTo>
                    <a:cubicBezTo>
                      <a:pt x="5200" y="2313"/>
                      <a:pt x="3917" y="1922"/>
                      <a:pt x="3525" y="1508"/>
                    </a:cubicBezTo>
                    <a:cubicBezTo>
                      <a:pt x="2524" y="420"/>
                      <a:pt x="1828" y="138"/>
                      <a:pt x="1828" y="138"/>
                    </a:cubicBezTo>
                    <a:cubicBezTo>
                      <a:pt x="1828" y="138"/>
                      <a:pt x="762" y="0"/>
                      <a:pt x="495" y="0"/>
                    </a:cubicBezTo>
                    <a:close/>
                  </a:path>
                </a:pathLst>
              </a:custGeom>
              <a:solidFill>
                <a:srgbClr val="FFFFFF">
                  <a:alpha val="1824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46" name="Google Shape;346;p16"/>
              <p:cNvSpPr/>
              <p:nvPr/>
            </p:nvSpPr>
            <p:spPr>
              <a:xfrm>
                <a:off x="-2665" y="5084665"/>
                <a:ext cx="108546" cy="28909"/>
              </a:xfrm>
              <a:custGeom>
                <a:avLst/>
                <a:gdLst/>
                <a:ahLst/>
                <a:cxnLst/>
                <a:rect l="l" t="t" r="r" b="b"/>
                <a:pathLst>
                  <a:path w="1393" h="371" extrusionOk="0">
                    <a:moveTo>
                      <a:pt x="22" y="0"/>
                    </a:moveTo>
                    <a:lnTo>
                      <a:pt x="0" y="283"/>
                    </a:lnTo>
                    <a:lnTo>
                      <a:pt x="1371" y="370"/>
                    </a:lnTo>
                    <a:lnTo>
                      <a:pt x="1393" y="87"/>
                    </a:lnTo>
                    <a:lnTo>
                      <a:pt x="22" y="0"/>
                    </a:ln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47" name="Google Shape;347;p16"/>
              <p:cNvSpPr/>
              <p:nvPr/>
            </p:nvSpPr>
            <p:spPr>
              <a:xfrm>
                <a:off x="-21287" y="4938329"/>
                <a:ext cx="406366" cy="205170"/>
              </a:xfrm>
              <a:custGeom>
                <a:avLst/>
                <a:gdLst/>
                <a:ahLst/>
                <a:cxnLst/>
                <a:rect l="l" t="t" r="r" b="b"/>
                <a:pathLst>
                  <a:path w="5215" h="2633" extrusionOk="0">
                    <a:moveTo>
                      <a:pt x="495" y="0"/>
                    </a:moveTo>
                    <a:cubicBezTo>
                      <a:pt x="461" y="0"/>
                      <a:pt x="440" y="2"/>
                      <a:pt x="435" y="7"/>
                    </a:cubicBezTo>
                    <a:cubicBezTo>
                      <a:pt x="239" y="268"/>
                      <a:pt x="65" y="769"/>
                      <a:pt x="44" y="986"/>
                    </a:cubicBezTo>
                    <a:cubicBezTo>
                      <a:pt x="0" y="1269"/>
                      <a:pt x="131" y="1878"/>
                      <a:pt x="305" y="1900"/>
                    </a:cubicBezTo>
                    <a:cubicBezTo>
                      <a:pt x="827" y="1922"/>
                      <a:pt x="1458" y="1987"/>
                      <a:pt x="1980" y="2096"/>
                    </a:cubicBezTo>
                    <a:cubicBezTo>
                      <a:pt x="2524" y="2205"/>
                      <a:pt x="2698" y="2531"/>
                      <a:pt x="4091" y="2618"/>
                    </a:cubicBezTo>
                    <a:cubicBezTo>
                      <a:pt x="4221" y="2625"/>
                      <a:pt x="4390" y="2633"/>
                      <a:pt x="4557" y="2633"/>
                    </a:cubicBezTo>
                    <a:cubicBezTo>
                      <a:pt x="4891" y="2633"/>
                      <a:pt x="5215" y="2604"/>
                      <a:pt x="5200" y="2487"/>
                    </a:cubicBezTo>
                    <a:cubicBezTo>
                      <a:pt x="5200" y="2313"/>
                      <a:pt x="3917" y="1922"/>
                      <a:pt x="3525" y="1508"/>
                    </a:cubicBezTo>
                    <a:cubicBezTo>
                      <a:pt x="2524" y="420"/>
                      <a:pt x="1828" y="138"/>
                      <a:pt x="1828" y="138"/>
                    </a:cubicBezTo>
                    <a:cubicBezTo>
                      <a:pt x="1828" y="138"/>
                      <a:pt x="762" y="0"/>
                      <a:pt x="495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48" name="Google Shape;348;p16"/>
              <p:cNvSpPr/>
              <p:nvPr/>
            </p:nvSpPr>
            <p:spPr>
              <a:xfrm>
                <a:off x="138059" y="2728010"/>
                <a:ext cx="88208" cy="52598"/>
              </a:xfrm>
              <a:custGeom>
                <a:avLst/>
                <a:gdLst/>
                <a:ahLst/>
                <a:cxnLst/>
                <a:rect l="l" t="t" r="r" b="b"/>
                <a:pathLst>
                  <a:path w="1132" h="675" extrusionOk="0">
                    <a:moveTo>
                      <a:pt x="0" y="0"/>
                    </a:moveTo>
                    <a:lnTo>
                      <a:pt x="1132" y="675"/>
                    </a:lnTo>
                    <a:lnTo>
                      <a:pt x="1023" y="15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B8D1FF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49" name="Google Shape;349;p16"/>
              <p:cNvSpPr/>
              <p:nvPr/>
            </p:nvSpPr>
            <p:spPr>
              <a:xfrm>
                <a:off x="226186" y="2734789"/>
                <a:ext cx="33974" cy="45818"/>
              </a:xfrm>
              <a:custGeom>
                <a:avLst/>
                <a:gdLst/>
                <a:ahLst/>
                <a:cxnLst/>
                <a:rect l="l" t="t" r="r" b="b"/>
                <a:pathLst>
                  <a:path w="436" h="588" extrusionOk="0">
                    <a:moveTo>
                      <a:pt x="262" y="1"/>
                    </a:moveTo>
                    <a:lnTo>
                      <a:pt x="1" y="588"/>
                    </a:lnTo>
                    <a:lnTo>
                      <a:pt x="1" y="588"/>
                    </a:lnTo>
                    <a:lnTo>
                      <a:pt x="436" y="153"/>
                    </a:lnTo>
                    <a:lnTo>
                      <a:pt x="262" y="1"/>
                    </a:lnTo>
                    <a:close/>
                  </a:path>
                </a:pathLst>
              </a:custGeom>
              <a:solidFill>
                <a:srgbClr val="B8D1FF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50" name="Google Shape;350;p16"/>
              <p:cNvSpPr/>
              <p:nvPr/>
            </p:nvSpPr>
            <p:spPr>
              <a:xfrm>
                <a:off x="-21287" y="3440056"/>
                <a:ext cx="413768" cy="62026"/>
              </a:xfrm>
              <a:custGeom>
                <a:avLst/>
                <a:gdLst/>
                <a:ahLst/>
                <a:cxnLst/>
                <a:rect l="l" t="t" r="r" b="b"/>
                <a:pathLst>
                  <a:path w="5310" h="796" extrusionOk="0">
                    <a:moveTo>
                      <a:pt x="152" y="1"/>
                    </a:moveTo>
                    <a:lnTo>
                      <a:pt x="0" y="523"/>
                    </a:lnTo>
                    <a:cubicBezTo>
                      <a:pt x="0" y="523"/>
                      <a:pt x="849" y="654"/>
                      <a:pt x="2328" y="741"/>
                    </a:cubicBezTo>
                    <a:cubicBezTo>
                      <a:pt x="3090" y="784"/>
                      <a:pt x="3835" y="795"/>
                      <a:pt x="4390" y="795"/>
                    </a:cubicBezTo>
                    <a:cubicBezTo>
                      <a:pt x="4945" y="795"/>
                      <a:pt x="5309" y="784"/>
                      <a:pt x="5309" y="784"/>
                    </a:cubicBezTo>
                    <a:lnTo>
                      <a:pt x="5309" y="240"/>
                    </a:lnTo>
                    <a:cubicBezTo>
                      <a:pt x="5309" y="240"/>
                      <a:pt x="4439" y="197"/>
                      <a:pt x="3003" y="153"/>
                    </a:cubicBezTo>
                    <a:cubicBezTo>
                      <a:pt x="1588" y="88"/>
                      <a:pt x="152" y="1"/>
                      <a:pt x="152" y="1"/>
                    </a:cubicBez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51" name="Google Shape;351;p16"/>
              <p:cNvSpPr/>
              <p:nvPr/>
            </p:nvSpPr>
            <p:spPr>
              <a:xfrm>
                <a:off x="339794" y="3457043"/>
                <a:ext cx="50961" cy="50961"/>
              </a:xfrm>
              <a:custGeom>
                <a:avLst/>
                <a:gdLst/>
                <a:ahLst/>
                <a:cxnLst/>
                <a:rect l="l" t="t" r="r" b="b"/>
                <a:pathLst>
                  <a:path w="654" h="654" extrusionOk="0">
                    <a:moveTo>
                      <a:pt x="175" y="0"/>
                    </a:moveTo>
                    <a:cubicBezTo>
                      <a:pt x="66" y="0"/>
                      <a:pt x="1" y="88"/>
                      <a:pt x="1" y="175"/>
                    </a:cubicBezTo>
                    <a:lnTo>
                      <a:pt x="1" y="479"/>
                    </a:lnTo>
                    <a:cubicBezTo>
                      <a:pt x="1" y="566"/>
                      <a:pt x="66" y="653"/>
                      <a:pt x="175" y="653"/>
                    </a:cubicBezTo>
                    <a:lnTo>
                      <a:pt x="479" y="653"/>
                    </a:lnTo>
                    <a:cubicBezTo>
                      <a:pt x="588" y="653"/>
                      <a:pt x="653" y="566"/>
                      <a:pt x="653" y="479"/>
                    </a:cubicBezTo>
                    <a:lnTo>
                      <a:pt x="653" y="175"/>
                    </a:lnTo>
                    <a:cubicBezTo>
                      <a:pt x="653" y="88"/>
                      <a:pt x="588" y="0"/>
                      <a:pt x="479" y="0"/>
                    </a:cubicBezTo>
                    <a:close/>
                  </a:path>
                </a:pathLst>
              </a:custGeom>
              <a:solidFill>
                <a:schemeClr val="accen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52" name="Google Shape;352;p16"/>
              <p:cNvSpPr/>
              <p:nvPr/>
            </p:nvSpPr>
            <p:spPr>
              <a:xfrm>
                <a:off x="194005" y="2746633"/>
                <a:ext cx="71299" cy="45896"/>
              </a:xfrm>
              <a:custGeom>
                <a:avLst/>
                <a:gdLst/>
                <a:ahLst/>
                <a:cxnLst/>
                <a:rect l="l" t="t" r="r" b="b"/>
                <a:pathLst>
                  <a:path w="915" h="589" extrusionOk="0">
                    <a:moveTo>
                      <a:pt x="914" y="1"/>
                    </a:moveTo>
                    <a:lnTo>
                      <a:pt x="0" y="110"/>
                    </a:lnTo>
                    <a:lnTo>
                      <a:pt x="457" y="588"/>
                    </a:lnTo>
                    <a:lnTo>
                      <a:pt x="849" y="523"/>
                    </a:lnTo>
                    <a:lnTo>
                      <a:pt x="914" y="1"/>
                    </a:ln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53" name="Google Shape;353;p16"/>
              <p:cNvSpPr/>
              <p:nvPr/>
            </p:nvSpPr>
            <p:spPr>
              <a:xfrm>
                <a:off x="229615" y="2787386"/>
                <a:ext cx="144157" cy="717199"/>
              </a:xfrm>
              <a:custGeom>
                <a:avLst/>
                <a:gdLst/>
                <a:ahLst/>
                <a:cxnLst/>
                <a:rect l="l" t="t" r="r" b="b"/>
                <a:pathLst>
                  <a:path w="1850" h="9204" extrusionOk="0">
                    <a:moveTo>
                      <a:pt x="392" y="0"/>
                    </a:moveTo>
                    <a:lnTo>
                      <a:pt x="0" y="65"/>
                    </a:lnTo>
                    <a:cubicBezTo>
                      <a:pt x="0" y="65"/>
                      <a:pt x="610" y="3394"/>
                      <a:pt x="784" y="5004"/>
                    </a:cubicBezTo>
                    <a:cubicBezTo>
                      <a:pt x="979" y="6614"/>
                      <a:pt x="979" y="8703"/>
                      <a:pt x="979" y="8703"/>
                    </a:cubicBezTo>
                    <a:lnTo>
                      <a:pt x="1567" y="9204"/>
                    </a:lnTo>
                    <a:lnTo>
                      <a:pt x="1850" y="8747"/>
                    </a:lnTo>
                    <a:cubicBezTo>
                      <a:pt x="1850" y="8747"/>
                      <a:pt x="1632" y="7376"/>
                      <a:pt x="1349" y="4917"/>
                    </a:cubicBezTo>
                    <a:cubicBezTo>
                      <a:pt x="1045" y="2459"/>
                      <a:pt x="392" y="0"/>
                      <a:pt x="392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54" name="Google Shape;354;p16"/>
              <p:cNvSpPr/>
              <p:nvPr/>
            </p:nvSpPr>
            <p:spPr>
              <a:xfrm>
                <a:off x="36295" y="2648296"/>
                <a:ext cx="181559" cy="145949"/>
              </a:xfrm>
              <a:custGeom>
                <a:avLst/>
                <a:gdLst/>
                <a:ahLst/>
                <a:cxnLst/>
                <a:rect l="l" t="t" r="r" b="b"/>
                <a:pathLst>
                  <a:path w="2330" h="1873" extrusionOk="0">
                    <a:moveTo>
                      <a:pt x="393" y="1"/>
                    </a:moveTo>
                    <a:lnTo>
                      <a:pt x="1" y="545"/>
                    </a:lnTo>
                    <a:lnTo>
                      <a:pt x="2024" y="1872"/>
                    </a:lnTo>
                    <a:lnTo>
                      <a:pt x="2329" y="1176"/>
                    </a:lnTo>
                    <a:lnTo>
                      <a:pt x="393" y="1"/>
                    </a:lnTo>
                    <a:close/>
                  </a:path>
                </a:pathLst>
              </a:custGeom>
              <a:solidFill>
                <a:schemeClr val="dk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55" name="Google Shape;355;p16"/>
              <p:cNvSpPr/>
              <p:nvPr/>
            </p:nvSpPr>
            <p:spPr>
              <a:xfrm>
                <a:off x="136345" y="2875515"/>
                <a:ext cx="351041" cy="507042"/>
              </a:xfrm>
              <a:custGeom>
                <a:avLst/>
                <a:gdLst/>
                <a:ahLst/>
                <a:cxnLst/>
                <a:rect l="l" t="t" r="r" b="b"/>
                <a:pathLst>
                  <a:path w="4505" h="6507" extrusionOk="0">
                    <a:moveTo>
                      <a:pt x="4265" y="0"/>
                    </a:moveTo>
                    <a:lnTo>
                      <a:pt x="1" y="566"/>
                    </a:lnTo>
                    <a:lnTo>
                      <a:pt x="262" y="6506"/>
                    </a:lnTo>
                    <a:lnTo>
                      <a:pt x="4505" y="5832"/>
                    </a:lnTo>
                    <a:lnTo>
                      <a:pt x="4265" y="0"/>
                    </a:ln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56" name="Google Shape;356;p16"/>
              <p:cNvSpPr/>
              <p:nvPr/>
            </p:nvSpPr>
            <p:spPr>
              <a:xfrm>
                <a:off x="246523" y="2704244"/>
                <a:ext cx="34052" cy="67948"/>
              </a:xfrm>
              <a:custGeom>
                <a:avLst/>
                <a:gdLst/>
                <a:ahLst/>
                <a:cxnLst/>
                <a:rect l="l" t="t" r="r" b="b"/>
                <a:pathLst>
                  <a:path w="437" h="872" extrusionOk="0">
                    <a:moveTo>
                      <a:pt x="23" y="1"/>
                    </a:moveTo>
                    <a:lnTo>
                      <a:pt x="1" y="393"/>
                    </a:lnTo>
                    <a:lnTo>
                      <a:pt x="371" y="871"/>
                    </a:lnTo>
                    <a:lnTo>
                      <a:pt x="436" y="305"/>
                    </a:lnTo>
                    <a:lnTo>
                      <a:pt x="23" y="1"/>
                    </a:lnTo>
                    <a:close/>
                  </a:path>
                </a:pathLst>
              </a:custGeom>
              <a:solidFill>
                <a:schemeClr val="dk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57" name="Google Shape;357;p16"/>
              <p:cNvSpPr/>
              <p:nvPr/>
            </p:nvSpPr>
            <p:spPr>
              <a:xfrm>
                <a:off x="-133180" y="3036579"/>
                <a:ext cx="498470" cy="250365"/>
              </a:xfrm>
              <a:custGeom>
                <a:avLst/>
                <a:gdLst/>
                <a:ahLst/>
                <a:cxnLst/>
                <a:rect l="l" t="t" r="r" b="b"/>
                <a:pathLst>
                  <a:path w="6397" h="3213" extrusionOk="0">
                    <a:moveTo>
                      <a:pt x="6049" y="0"/>
                    </a:moveTo>
                    <a:cubicBezTo>
                      <a:pt x="6049" y="0"/>
                      <a:pt x="3568" y="305"/>
                      <a:pt x="1153" y="1175"/>
                    </a:cubicBezTo>
                    <a:cubicBezTo>
                      <a:pt x="914" y="1262"/>
                      <a:pt x="0" y="1850"/>
                      <a:pt x="239" y="2764"/>
                    </a:cubicBezTo>
                    <a:cubicBezTo>
                      <a:pt x="328" y="3093"/>
                      <a:pt x="627" y="3212"/>
                      <a:pt x="1013" y="3212"/>
                    </a:cubicBezTo>
                    <a:cubicBezTo>
                      <a:pt x="1672" y="3212"/>
                      <a:pt x="2585" y="2866"/>
                      <a:pt x="3133" y="2633"/>
                    </a:cubicBezTo>
                    <a:cubicBezTo>
                      <a:pt x="3982" y="2263"/>
                      <a:pt x="6397" y="958"/>
                      <a:pt x="6397" y="958"/>
                    </a:cubicBezTo>
                    <a:lnTo>
                      <a:pt x="6049" y="0"/>
                    </a:lnTo>
                    <a:close/>
                  </a:path>
                </a:pathLst>
              </a:custGeom>
              <a:solidFill>
                <a:schemeClr val="dk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58" name="Google Shape;358;p16"/>
              <p:cNvSpPr/>
              <p:nvPr/>
            </p:nvSpPr>
            <p:spPr>
              <a:xfrm>
                <a:off x="407584" y="3075228"/>
                <a:ext cx="84858" cy="36000"/>
              </a:xfrm>
              <a:custGeom>
                <a:avLst/>
                <a:gdLst/>
                <a:ahLst/>
                <a:cxnLst/>
                <a:rect l="l" t="t" r="r" b="b"/>
                <a:pathLst>
                  <a:path w="1089" h="462" extrusionOk="0">
                    <a:moveTo>
                      <a:pt x="913" y="1"/>
                    </a:moveTo>
                    <a:cubicBezTo>
                      <a:pt x="900" y="1"/>
                      <a:pt x="886" y="2"/>
                      <a:pt x="871" y="5"/>
                    </a:cubicBezTo>
                    <a:lnTo>
                      <a:pt x="153" y="114"/>
                    </a:lnTo>
                    <a:cubicBezTo>
                      <a:pt x="66" y="135"/>
                      <a:pt x="1" y="222"/>
                      <a:pt x="23" y="310"/>
                    </a:cubicBezTo>
                    <a:cubicBezTo>
                      <a:pt x="44" y="397"/>
                      <a:pt x="131" y="462"/>
                      <a:pt x="219" y="462"/>
                    </a:cubicBezTo>
                    <a:lnTo>
                      <a:pt x="937" y="331"/>
                    </a:lnTo>
                    <a:cubicBezTo>
                      <a:pt x="1024" y="331"/>
                      <a:pt x="1089" y="244"/>
                      <a:pt x="1067" y="135"/>
                    </a:cubicBezTo>
                    <a:cubicBezTo>
                      <a:pt x="1067" y="60"/>
                      <a:pt x="1001" y="1"/>
                      <a:pt x="913" y="1"/>
                    </a:cubicBezTo>
                    <a:close/>
                  </a:path>
                </a:pathLst>
              </a:custGeom>
              <a:solidFill>
                <a:srgbClr val="FFBD9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59" name="Google Shape;359;p16"/>
              <p:cNvSpPr/>
              <p:nvPr/>
            </p:nvSpPr>
            <p:spPr>
              <a:xfrm>
                <a:off x="405948" y="3050137"/>
                <a:ext cx="84858" cy="36000"/>
              </a:xfrm>
              <a:custGeom>
                <a:avLst/>
                <a:gdLst/>
                <a:ahLst/>
                <a:cxnLst/>
                <a:rect l="l" t="t" r="r" b="b"/>
                <a:pathLst>
                  <a:path w="1089" h="462" extrusionOk="0">
                    <a:moveTo>
                      <a:pt x="871" y="1"/>
                    </a:moveTo>
                    <a:lnTo>
                      <a:pt x="152" y="131"/>
                    </a:lnTo>
                    <a:cubicBezTo>
                      <a:pt x="65" y="131"/>
                      <a:pt x="0" y="218"/>
                      <a:pt x="22" y="305"/>
                    </a:cubicBezTo>
                    <a:lnTo>
                      <a:pt x="22" y="327"/>
                    </a:lnTo>
                    <a:cubicBezTo>
                      <a:pt x="41" y="402"/>
                      <a:pt x="109" y="462"/>
                      <a:pt x="184" y="462"/>
                    </a:cubicBezTo>
                    <a:cubicBezTo>
                      <a:pt x="195" y="462"/>
                      <a:pt x="206" y="460"/>
                      <a:pt x="218" y="457"/>
                    </a:cubicBezTo>
                    <a:lnTo>
                      <a:pt x="936" y="349"/>
                    </a:lnTo>
                    <a:cubicBezTo>
                      <a:pt x="1023" y="327"/>
                      <a:pt x="1088" y="240"/>
                      <a:pt x="1066" y="153"/>
                    </a:cubicBezTo>
                    <a:cubicBezTo>
                      <a:pt x="1066" y="44"/>
                      <a:pt x="979" y="1"/>
                      <a:pt x="871" y="1"/>
                    </a:cubicBezTo>
                    <a:close/>
                  </a:path>
                </a:pathLst>
              </a:custGeom>
              <a:solidFill>
                <a:srgbClr val="FFBD9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60" name="Google Shape;360;p16"/>
              <p:cNvSpPr/>
              <p:nvPr/>
            </p:nvSpPr>
            <p:spPr>
              <a:xfrm>
                <a:off x="404233" y="3026059"/>
                <a:ext cx="83143" cy="36000"/>
              </a:xfrm>
              <a:custGeom>
                <a:avLst/>
                <a:gdLst/>
                <a:ahLst/>
                <a:cxnLst/>
                <a:rect l="l" t="t" r="r" b="b"/>
                <a:pathLst>
                  <a:path w="1067" h="462" extrusionOk="0">
                    <a:moveTo>
                      <a:pt x="905" y="1"/>
                    </a:moveTo>
                    <a:cubicBezTo>
                      <a:pt x="894" y="1"/>
                      <a:pt x="882" y="2"/>
                      <a:pt x="871" y="5"/>
                    </a:cubicBezTo>
                    <a:lnTo>
                      <a:pt x="153" y="114"/>
                    </a:lnTo>
                    <a:cubicBezTo>
                      <a:pt x="44" y="135"/>
                      <a:pt x="0" y="223"/>
                      <a:pt x="0" y="310"/>
                    </a:cubicBezTo>
                    <a:cubicBezTo>
                      <a:pt x="22" y="418"/>
                      <a:pt x="109" y="462"/>
                      <a:pt x="196" y="462"/>
                    </a:cubicBezTo>
                    <a:lnTo>
                      <a:pt x="914" y="331"/>
                    </a:lnTo>
                    <a:cubicBezTo>
                      <a:pt x="1001" y="331"/>
                      <a:pt x="1067" y="244"/>
                      <a:pt x="1067" y="135"/>
                    </a:cubicBezTo>
                    <a:cubicBezTo>
                      <a:pt x="1048" y="60"/>
                      <a:pt x="980" y="1"/>
                      <a:pt x="905" y="1"/>
                    </a:cubicBezTo>
                    <a:close/>
                  </a:path>
                </a:pathLst>
              </a:custGeom>
              <a:solidFill>
                <a:srgbClr val="FFBD9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61" name="Google Shape;361;p16"/>
              <p:cNvSpPr/>
              <p:nvPr/>
            </p:nvSpPr>
            <p:spPr>
              <a:xfrm>
                <a:off x="399169" y="3004008"/>
                <a:ext cx="83143" cy="34676"/>
              </a:xfrm>
              <a:custGeom>
                <a:avLst/>
                <a:gdLst/>
                <a:ahLst/>
                <a:cxnLst/>
                <a:rect l="l" t="t" r="r" b="b"/>
                <a:pathLst>
                  <a:path w="1067" h="445" extrusionOk="0">
                    <a:moveTo>
                      <a:pt x="905" y="1"/>
                    </a:moveTo>
                    <a:cubicBezTo>
                      <a:pt x="893" y="1"/>
                      <a:pt x="882" y="2"/>
                      <a:pt x="870" y="5"/>
                    </a:cubicBezTo>
                    <a:lnTo>
                      <a:pt x="152" y="114"/>
                    </a:lnTo>
                    <a:cubicBezTo>
                      <a:pt x="44" y="114"/>
                      <a:pt x="0" y="223"/>
                      <a:pt x="0" y="310"/>
                    </a:cubicBezTo>
                    <a:cubicBezTo>
                      <a:pt x="19" y="385"/>
                      <a:pt x="87" y="444"/>
                      <a:pt x="162" y="444"/>
                    </a:cubicBezTo>
                    <a:cubicBezTo>
                      <a:pt x="173" y="444"/>
                      <a:pt x="185" y="443"/>
                      <a:pt x="196" y="440"/>
                    </a:cubicBezTo>
                    <a:lnTo>
                      <a:pt x="914" y="331"/>
                    </a:lnTo>
                    <a:cubicBezTo>
                      <a:pt x="1001" y="310"/>
                      <a:pt x="1066" y="223"/>
                      <a:pt x="1066" y="136"/>
                    </a:cubicBezTo>
                    <a:cubicBezTo>
                      <a:pt x="1047" y="60"/>
                      <a:pt x="979" y="1"/>
                      <a:pt x="905" y="1"/>
                    </a:cubicBezTo>
                    <a:close/>
                  </a:path>
                </a:pathLst>
              </a:custGeom>
              <a:solidFill>
                <a:srgbClr val="FFBD9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62" name="Google Shape;362;p16"/>
              <p:cNvSpPr/>
              <p:nvPr/>
            </p:nvSpPr>
            <p:spPr>
              <a:xfrm>
                <a:off x="287276" y="3003228"/>
                <a:ext cx="193326" cy="127871"/>
              </a:xfrm>
              <a:custGeom>
                <a:avLst/>
                <a:gdLst/>
                <a:ahLst/>
                <a:cxnLst/>
                <a:rect l="l" t="t" r="r" b="b"/>
                <a:pathLst>
                  <a:path w="2481" h="1641" extrusionOk="0">
                    <a:moveTo>
                      <a:pt x="1777" y="1"/>
                    </a:moveTo>
                    <a:cubicBezTo>
                      <a:pt x="1555" y="1"/>
                      <a:pt x="1334" y="9"/>
                      <a:pt x="1240" y="37"/>
                    </a:cubicBezTo>
                    <a:cubicBezTo>
                      <a:pt x="1001" y="124"/>
                      <a:pt x="0" y="777"/>
                      <a:pt x="0" y="777"/>
                    </a:cubicBezTo>
                    <a:lnTo>
                      <a:pt x="653" y="1603"/>
                    </a:lnTo>
                    <a:cubicBezTo>
                      <a:pt x="653" y="1603"/>
                      <a:pt x="861" y="1640"/>
                      <a:pt x="1121" y="1640"/>
                    </a:cubicBezTo>
                    <a:cubicBezTo>
                      <a:pt x="1208" y="1640"/>
                      <a:pt x="1300" y="1636"/>
                      <a:pt x="1393" y="1625"/>
                    </a:cubicBezTo>
                    <a:cubicBezTo>
                      <a:pt x="1763" y="1582"/>
                      <a:pt x="2481" y="1255"/>
                      <a:pt x="2481" y="1255"/>
                    </a:cubicBezTo>
                    <a:cubicBezTo>
                      <a:pt x="2481" y="1255"/>
                      <a:pt x="2263" y="755"/>
                      <a:pt x="2219" y="559"/>
                    </a:cubicBezTo>
                    <a:cubicBezTo>
                      <a:pt x="2154" y="363"/>
                      <a:pt x="2372" y="15"/>
                      <a:pt x="2372" y="15"/>
                    </a:cubicBezTo>
                    <a:cubicBezTo>
                      <a:pt x="2372" y="15"/>
                      <a:pt x="2073" y="1"/>
                      <a:pt x="1777" y="1"/>
                    </a:cubicBezTo>
                    <a:close/>
                  </a:path>
                </a:pathLst>
              </a:custGeom>
              <a:solidFill>
                <a:srgbClr val="FFBD9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63" name="Google Shape;363;p16"/>
              <p:cNvSpPr/>
              <p:nvPr/>
            </p:nvSpPr>
            <p:spPr>
              <a:xfrm>
                <a:off x="261796" y="3024735"/>
                <a:ext cx="103481" cy="127247"/>
              </a:xfrm>
              <a:custGeom>
                <a:avLst/>
                <a:gdLst/>
                <a:ahLst/>
                <a:cxnLst/>
                <a:rect l="l" t="t" r="r" b="b"/>
                <a:pathLst>
                  <a:path w="1328" h="1633" extrusionOk="0">
                    <a:moveTo>
                      <a:pt x="871" y="0"/>
                    </a:moveTo>
                    <a:lnTo>
                      <a:pt x="1" y="283"/>
                    </a:lnTo>
                    <a:lnTo>
                      <a:pt x="436" y="1632"/>
                    </a:lnTo>
                    <a:lnTo>
                      <a:pt x="1328" y="1327"/>
                    </a:lnTo>
                    <a:lnTo>
                      <a:pt x="871" y="0"/>
                    </a:lnTo>
                    <a:close/>
                  </a:path>
                </a:pathLst>
              </a:custGeom>
              <a:solidFill>
                <a:schemeClr val="dk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64" name="Google Shape;364;p16"/>
              <p:cNvSpPr/>
              <p:nvPr/>
            </p:nvSpPr>
            <p:spPr>
              <a:xfrm>
                <a:off x="263510" y="3116526"/>
                <a:ext cx="371379" cy="233767"/>
              </a:xfrm>
              <a:custGeom>
                <a:avLst/>
                <a:gdLst/>
                <a:ahLst/>
                <a:cxnLst/>
                <a:rect l="l" t="t" r="r" b="b"/>
                <a:pathLst>
                  <a:path w="4766" h="3000" extrusionOk="0">
                    <a:moveTo>
                      <a:pt x="3897" y="0"/>
                    </a:moveTo>
                    <a:cubicBezTo>
                      <a:pt x="3372" y="0"/>
                      <a:pt x="2639" y="458"/>
                      <a:pt x="2155" y="737"/>
                    </a:cubicBezTo>
                    <a:cubicBezTo>
                      <a:pt x="1437" y="1150"/>
                      <a:pt x="0" y="2086"/>
                      <a:pt x="0" y="2086"/>
                    </a:cubicBezTo>
                    <a:lnTo>
                      <a:pt x="392" y="3000"/>
                    </a:lnTo>
                    <a:cubicBezTo>
                      <a:pt x="392" y="3000"/>
                      <a:pt x="2611" y="2565"/>
                      <a:pt x="3830" y="2021"/>
                    </a:cubicBezTo>
                    <a:cubicBezTo>
                      <a:pt x="4026" y="1912"/>
                      <a:pt x="4766" y="1281"/>
                      <a:pt x="4461" y="389"/>
                    </a:cubicBezTo>
                    <a:cubicBezTo>
                      <a:pt x="4355" y="106"/>
                      <a:pt x="4150" y="0"/>
                      <a:pt x="3897" y="0"/>
                    </a:cubicBezTo>
                    <a:close/>
                  </a:path>
                </a:pathLst>
              </a:custGeom>
              <a:solidFill>
                <a:schemeClr val="dk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65" name="Google Shape;365;p16"/>
              <p:cNvSpPr/>
              <p:nvPr/>
            </p:nvSpPr>
            <p:spPr>
              <a:xfrm>
                <a:off x="139773" y="3357381"/>
                <a:ext cx="81429" cy="48546"/>
              </a:xfrm>
              <a:custGeom>
                <a:avLst/>
                <a:gdLst/>
                <a:ahLst/>
                <a:cxnLst/>
                <a:rect l="l" t="t" r="r" b="b"/>
                <a:pathLst>
                  <a:path w="1045" h="623" extrusionOk="0">
                    <a:moveTo>
                      <a:pt x="856" y="0"/>
                    </a:moveTo>
                    <a:cubicBezTo>
                      <a:pt x="832" y="0"/>
                      <a:pt x="807" y="6"/>
                      <a:pt x="783" y="18"/>
                    </a:cubicBezTo>
                    <a:lnTo>
                      <a:pt x="109" y="300"/>
                    </a:lnTo>
                    <a:cubicBezTo>
                      <a:pt x="44" y="344"/>
                      <a:pt x="0" y="431"/>
                      <a:pt x="22" y="518"/>
                    </a:cubicBezTo>
                    <a:cubicBezTo>
                      <a:pt x="54" y="582"/>
                      <a:pt x="121" y="622"/>
                      <a:pt x="188" y="622"/>
                    </a:cubicBezTo>
                    <a:cubicBezTo>
                      <a:pt x="213" y="622"/>
                      <a:pt x="238" y="617"/>
                      <a:pt x="261" y="605"/>
                    </a:cubicBezTo>
                    <a:lnTo>
                      <a:pt x="914" y="322"/>
                    </a:lnTo>
                    <a:cubicBezTo>
                      <a:pt x="1001" y="279"/>
                      <a:pt x="1045" y="192"/>
                      <a:pt x="1001" y="105"/>
                    </a:cubicBezTo>
                    <a:cubicBezTo>
                      <a:pt x="985" y="41"/>
                      <a:pt x="923" y="0"/>
                      <a:pt x="856" y="0"/>
                    </a:cubicBezTo>
                    <a:close/>
                  </a:path>
                </a:pathLst>
              </a:custGeom>
              <a:solidFill>
                <a:srgbClr val="FFA47C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66" name="Google Shape;366;p16"/>
              <p:cNvSpPr/>
              <p:nvPr/>
            </p:nvSpPr>
            <p:spPr>
              <a:xfrm>
                <a:off x="127851" y="3335329"/>
                <a:ext cx="81507" cy="49481"/>
              </a:xfrm>
              <a:custGeom>
                <a:avLst/>
                <a:gdLst/>
                <a:ahLst/>
                <a:cxnLst/>
                <a:rect l="l" t="t" r="r" b="b"/>
                <a:pathLst>
                  <a:path w="1046" h="635" extrusionOk="0">
                    <a:moveTo>
                      <a:pt x="853" y="1"/>
                    </a:moveTo>
                    <a:cubicBezTo>
                      <a:pt x="831" y="1"/>
                      <a:pt x="807" y="6"/>
                      <a:pt x="784" y="18"/>
                    </a:cubicBezTo>
                    <a:lnTo>
                      <a:pt x="110" y="301"/>
                    </a:lnTo>
                    <a:cubicBezTo>
                      <a:pt x="23" y="344"/>
                      <a:pt x="1" y="453"/>
                      <a:pt x="23" y="540"/>
                    </a:cubicBezTo>
                    <a:cubicBezTo>
                      <a:pt x="56" y="606"/>
                      <a:pt x="127" y="635"/>
                      <a:pt x="198" y="635"/>
                    </a:cubicBezTo>
                    <a:cubicBezTo>
                      <a:pt x="220" y="635"/>
                      <a:pt x="241" y="632"/>
                      <a:pt x="262" y="627"/>
                    </a:cubicBezTo>
                    <a:lnTo>
                      <a:pt x="915" y="322"/>
                    </a:lnTo>
                    <a:cubicBezTo>
                      <a:pt x="1002" y="301"/>
                      <a:pt x="1045" y="192"/>
                      <a:pt x="1002" y="105"/>
                    </a:cubicBezTo>
                    <a:cubicBezTo>
                      <a:pt x="970" y="41"/>
                      <a:pt x="915" y="1"/>
                      <a:pt x="853" y="1"/>
                    </a:cubicBezTo>
                    <a:close/>
                  </a:path>
                </a:pathLst>
              </a:custGeom>
              <a:solidFill>
                <a:srgbClr val="FFA47C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67" name="Google Shape;367;p16"/>
              <p:cNvSpPr/>
              <p:nvPr/>
            </p:nvSpPr>
            <p:spPr>
              <a:xfrm>
                <a:off x="116008" y="3313278"/>
                <a:ext cx="83143" cy="50260"/>
              </a:xfrm>
              <a:custGeom>
                <a:avLst/>
                <a:gdLst/>
                <a:ahLst/>
                <a:cxnLst/>
                <a:rect l="l" t="t" r="r" b="b"/>
                <a:pathLst>
                  <a:path w="1067" h="645" extrusionOk="0">
                    <a:moveTo>
                      <a:pt x="875" y="1"/>
                    </a:moveTo>
                    <a:cubicBezTo>
                      <a:pt x="852" y="1"/>
                      <a:pt x="829" y="6"/>
                      <a:pt x="806" y="18"/>
                    </a:cubicBezTo>
                    <a:lnTo>
                      <a:pt x="131" y="301"/>
                    </a:lnTo>
                    <a:cubicBezTo>
                      <a:pt x="44" y="344"/>
                      <a:pt x="1" y="453"/>
                      <a:pt x="44" y="540"/>
                    </a:cubicBezTo>
                    <a:cubicBezTo>
                      <a:pt x="76" y="604"/>
                      <a:pt x="143" y="644"/>
                      <a:pt x="202" y="644"/>
                    </a:cubicBezTo>
                    <a:cubicBezTo>
                      <a:pt x="224" y="644"/>
                      <a:pt x="244" y="639"/>
                      <a:pt x="262" y="627"/>
                    </a:cubicBezTo>
                    <a:lnTo>
                      <a:pt x="936" y="322"/>
                    </a:lnTo>
                    <a:cubicBezTo>
                      <a:pt x="1023" y="301"/>
                      <a:pt x="1067" y="192"/>
                      <a:pt x="1023" y="105"/>
                    </a:cubicBezTo>
                    <a:cubicBezTo>
                      <a:pt x="991" y="41"/>
                      <a:pt x="936" y="1"/>
                      <a:pt x="875" y="1"/>
                    </a:cubicBezTo>
                    <a:close/>
                  </a:path>
                </a:pathLst>
              </a:custGeom>
              <a:solidFill>
                <a:srgbClr val="FFA47C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68" name="Google Shape;368;p16"/>
              <p:cNvSpPr/>
              <p:nvPr/>
            </p:nvSpPr>
            <p:spPr>
              <a:xfrm>
                <a:off x="109229" y="3291226"/>
                <a:ext cx="81429" cy="50260"/>
              </a:xfrm>
              <a:custGeom>
                <a:avLst/>
                <a:gdLst/>
                <a:ahLst/>
                <a:cxnLst/>
                <a:rect l="l" t="t" r="r" b="b"/>
                <a:pathLst>
                  <a:path w="1045" h="645" extrusionOk="0">
                    <a:moveTo>
                      <a:pt x="853" y="1"/>
                    </a:moveTo>
                    <a:cubicBezTo>
                      <a:pt x="830" y="1"/>
                      <a:pt x="807" y="6"/>
                      <a:pt x="784" y="18"/>
                    </a:cubicBezTo>
                    <a:lnTo>
                      <a:pt x="109" y="301"/>
                    </a:lnTo>
                    <a:cubicBezTo>
                      <a:pt x="22" y="344"/>
                      <a:pt x="1" y="453"/>
                      <a:pt x="22" y="540"/>
                    </a:cubicBezTo>
                    <a:cubicBezTo>
                      <a:pt x="54" y="604"/>
                      <a:pt x="121" y="644"/>
                      <a:pt x="189" y="644"/>
                    </a:cubicBezTo>
                    <a:cubicBezTo>
                      <a:pt x="213" y="644"/>
                      <a:pt x="238" y="639"/>
                      <a:pt x="262" y="627"/>
                    </a:cubicBezTo>
                    <a:lnTo>
                      <a:pt x="914" y="323"/>
                    </a:lnTo>
                    <a:cubicBezTo>
                      <a:pt x="1001" y="301"/>
                      <a:pt x="1045" y="192"/>
                      <a:pt x="1001" y="105"/>
                    </a:cubicBezTo>
                    <a:cubicBezTo>
                      <a:pt x="970" y="41"/>
                      <a:pt x="914" y="1"/>
                      <a:pt x="853" y="1"/>
                    </a:cubicBezTo>
                    <a:close/>
                  </a:path>
                </a:pathLst>
              </a:custGeom>
              <a:solidFill>
                <a:srgbClr val="FFA47C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69" name="Google Shape;369;p16"/>
              <p:cNvSpPr/>
              <p:nvPr/>
            </p:nvSpPr>
            <p:spPr>
              <a:xfrm>
                <a:off x="114293" y="3268629"/>
                <a:ext cx="186624" cy="135897"/>
              </a:xfrm>
              <a:custGeom>
                <a:avLst/>
                <a:gdLst/>
                <a:ahLst/>
                <a:cxnLst/>
                <a:rect l="l" t="t" r="r" b="b"/>
                <a:pathLst>
                  <a:path w="2395" h="1744" extrusionOk="0">
                    <a:moveTo>
                      <a:pt x="2076" y="1"/>
                    </a:moveTo>
                    <a:cubicBezTo>
                      <a:pt x="1705" y="1"/>
                      <a:pt x="1125" y="11"/>
                      <a:pt x="980" y="69"/>
                    </a:cubicBezTo>
                    <a:cubicBezTo>
                      <a:pt x="741" y="134"/>
                      <a:pt x="1" y="656"/>
                      <a:pt x="1" y="656"/>
                    </a:cubicBezTo>
                    <a:cubicBezTo>
                      <a:pt x="1" y="656"/>
                      <a:pt x="371" y="808"/>
                      <a:pt x="436" y="1026"/>
                    </a:cubicBezTo>
                    <a:cubicBezTo>
                      <a:pt x="479" y="1222"/>
                      <a:pt x="588" y="1744"/>
                      <a:pt x="588" y="1744"/>
                    </a:cubicBezTo>
                    <a:cubicBezTo>
                      <a:pt x="588" y="1744"/>
                      <a:pt x="1372" y="1635"/>
                      <a:pt x="1698" y="1461"/>
                    </a:cubicBezTo>
                    <a:cubicBezTo>
                      <a:pt x="2024" y="1287"/>
                      <a:pt x="2307" y="1048"/>
                      <a:pt x="2307" y="1048"/>
                    </a:cubicBezTo>
                    <a:lnTo>
                      <a:pt x="2394" y="3"/>
                    </a:lnTo>
                    <a:cubicBezTo>
                      <a:pt x="2394" y="3"/>
                      <a:pt x="2261" y="1"/>
                      <a:pt x="2076" y="1"/>
                    </a:cubicBezTo>
                    <a:close/>
                  </a:path>
                </a:pathLst>
              </a:custGeom>
              <a:solidFill>
                <a:srgbClr val="FFA47C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70" name="Google Shape;370;p16"/>
              <p:cNvSpPr/>
              <p:nvPr/>
            </p:nvSpPr>
            <p:spPr>
              <a:xfrm>
                <a:off x="239744" y="3240032"/>
                <a:ext cx="105195" cy="127247"/>
              </a:xfrm>
              <a:custGeom>
                <a:avLst/>
                <a:gdLst/>
                <a:ahLst/>
                <a:cxnLst/>
                <a:rect l="l" t="t" r="r" b="b"/>
                <a:pathLst>
                  <a:path w="1350" h="1633" extrusionOk="0">
                    <a:moveTo>
                      <a:pt x="893" y="0"/>
                    </a:moveTo>
                    <a:lnTo>
                      <a:pt x="1" y="305"/>
                    </a:lnTo>
                    <a:lnTo>
                      <a:pt x="458" y="1632"/>
                    </a:lnTo>
                    <a:lnTo>
                      <a:pt x="1350" y="1328"/>
                    </a:lnTo>
                    <a:lnTo>
                      <a:pt x="893" y="0"/>
                    </a:lnTo>
                    <a:close/>
                  </a:path>
                </a:pathLst>
              </a:custGeom>
              <a:solidFill>
                <a:schemeClr val="dk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95185290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 5">
  <p:cSld name="Title only 5">
    <p:spTree>
      <p:nvGrpSpPr>
        <p:cNvPr id="1" name="Shape 3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2" name="Google Shape;372;p17"/>
          <p:cNvSpPr/>
          <p:nvPr/>
        </p:nvSpPr>
        <p:spPr>
          <a:xfrm>
            <a:off x="-25" y="6127167"/>
            <a:ext cx="9144017" cy="787955"/>
          </a:xfrm>
          <a:custGeom>
            <a:avLst/>
            <a:gdLst/>
            <a:ahLst/>
            <a:cxnLst/>
            <a:rect l="l" t="t" r="r" b="b"/>
            <a:pathLst>
              <a:path w="81572" h="31202" extrusionOk="0">
                <a:moveTo>
                  <a:pt x="0" y="0"/>
                </a:moveTo>
                <a:lnTo>
                  <a:pt x="0" y="31201"/>
                </a:lnTo>
                <a:lnTo>
                  <a:pt x="81572" y="31201"/>
                </a:lnTo>
                <a:lnTo>
                  <a:pt x="81572" y="0"/>
                </a:lnTo>
                <a:close/>
              </a:path>
            </a:pathLst>
          </a:custGeom>
          <a:solidFill>
            <a:schemeClr val="dk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/>
          </a:p>
        </p:txBody>
      </p:sp>
      <p:sp>
        <p:nvSpPr>
          <p:cNvPr id="373" name="Google Shape;373;p17"/>
          <p:cNvSpPr txBox="1">
            <a:spLocks noGrp="1"/>
          </p:cNvSpPr>
          <p:nvPr>
            <p:ph type="title"/>
          </p:nvPr>
        </p:nvSpPr>
        <p:spPr>
          <a:xfrm>
            <a:off x="720000" y="593367"/>
            <a:ext cx="7704000" cy="763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1pPr>
            <a:lvl2pPr lvl="1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9pPr>
          </a:lstStyle>
          <a:p>
            <a:endParaRPr/>
          </a:p>
        </p:txBody>
      </p:sp>
      <p:grpSp>
        <p:nvGrpSpPr>
          <p:cNvPr id="374" name="Google Shape;374;p17"/>
          <p:cNvGrpSpPr/>
          <p:nvPr/>
        </p:nvGrpSpPr>
        <p:grpSpPr>
          <a:xfrm>
            <a:off x="-678583" y="3001303"/>
            <a:ext cx="10357318" cy="4029603"/>
            <a:chOff x="-678583" y="2250977"/>
            <a:chExt cx="10357318" cy="3022202"/>
          </a:xfrm>
        </p:grpSpPr>
        <p:sp>
          <p:nvSpPr>
            <p:cNvPr id="375" name="Google Shape;375;p17"/>
            <p:cNvSpPr/>
            <p:nvPr/>
          </p:nvSpPr>
          <p:spPr>
            <a:xfrm>
              <a:off x="-578183" y="4811475"/>
              <a:ext cx="1627556" cy="461704"/>
            </a:xfrm>
            <a:custGeom>
              <a:avLst/>
              <a:gdLst/>
              <a:ahLst/>
              <a:cxnLst/>
              <a:rect l="l" t="t" r="r" b="b"/>
              <a:pathLst>
                <a:path w="64014" h="9771" extrusionOk="0">
                  <a:moveTo>
                    <a:pt x="31876" y="1"/>
                  </a:moveTo>
                  <a:cubicBezTo>
                    <a:pt x="14187" y="1"/>
                    <a:pt x="1" y="2155"/>
                    <a:pt x="1" y="4875"/>
                  </a:cubicBezTo>
                  <a:cubicBezTo>
                    <a:pt x="1" y="7573"/>
                    <a:pt x="14339" y="9770"/>
                    <a:pt x="32007" y="9770"/>
                  </a:cubicBezTo>
                  <a:cubicBezTo>
                    <a:pt x="49674" y="9770"/>
                    <a:pt x="64013" y="7573"/>
                    <a:pt x="64013" y="4875"/>
                  </a:cubicBezTo>
                  <a:cubicBezTo>
                    <a:pt x="64013" y="2155"/>
                    <a:pt x="49544" y="1"/>
                    <a:pt x="31876" y="1"/>
                  </a:cubicBezTo>
                  <a:close/>
                </a:path>
              </a:pathLst>
            </a:custGeom>
            <a:solidFill>
              <a:srgbClr val="191919">
                <a:alpha val="17610"/>
              </a:srgb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grpSp>
          <p:nvGrpSpPr>
            <p:cNvPr id="376" name="Google Shape;376;p17"/>
            <p:cNvGrpSpPr/>
            <p:nvPr/>
          </p:nvGrpSpPr>
          <p:grpSpPr>
            <a:xfrm>
              <a:off x="-678583" y="3799240"/>
              <a:ext cx="1339803" cy="1344562"/>
              <a:chOff x="1788276" y="3614658"/>
              <a:chExt cx="1383523" cy="1388437"/>
            </a:xfrm>
          </p:grpSpPr>
          <p:sp>
            <p:nvSpPr>
              <p:cNvPr id="377" name="Google Shape;377;p17"/>
              <p:cNvSpPr/>
              <p:nvPr/>
            </p:nvSpPr>
            <p:spPr>
              <a:xfrm>
                <a:off x="1898398" y="3617934"/>
                <a:ext cx="90835" cy="1385161"/>
              </a:xfrm>
              <a:custGeom>
                <a:avLst/>
                <a:gdLst/>
                <a:ahLst/>
                <a:cxnLst/>
                <a:rect l="l" t="t" r="r" b="b"/>
                <a:pathLst>
                  <a:path w="1220" h="18604" extrusionOk="0">
                    <a:moveTo>
                      <a:pt x="1" y="0"/>
                    </a:moveTo>
                    <a:lnTo>
                      <a:pt x="1" y="18604"/>
                    </a:lnTo>
                    <a:lnTo>
                      <a:pt x="1219" y="18604"/>
                    </a:lnTo>
                    <a:lnTo>
                      <a:pt x="1219" y="0"/>
                    </a:lnTo>
                    <a:close/>
                  </a:path>
                </a:pathLst>
              </a:custGeom>
              <a:solidFill>
                <a:schemeClr val="accen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78" name="Google Shape;378;p17"/>
              <p:cNvSpPr/>
              <p:nvPr/>
            </p:nvSpPr>
            <p:spPr>
              <a:xfrm>
                <a:off x="2967667" y="3617934"/>
                <a:ext cx="90761" cy="1385161"/>
              </a:xfrm>
              <a:custGeom>
                <a:avLst/>
                <a:gdLst/>
                <a:ahLst/>
                <a:cxnLst/>
                <a:rect l="l" t="t" r="r" b="b"/>
                <a:pathLst>
                  <a:path w="1219" h="18604" extrusionOk="0">
                    <a:moveTo>
                      <a:pt x="0" y="0"/>
                    </a:moveTo>
                    <a:lnTo>
                      <a:pt x="0" y="18604"/>
                    </a:lnTo>
                    <a:lnTo>
                      <a:pt x="1218" y="18604"/>
                    </a:lnTo>
                    <a:lnTo>
                      <a:pt x="1218" y="0"/>
                    </a:lnTo>
                    <a:close/>
                  </a:path>
                </a:pathLst>
              </a:custGeom>
              <a:solidFill>
                <a:schemeClr val="accen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79" name="Google Shape;379;p17"/>
              <p:cNvSpPr/>
              <p:nvPr/>
            </p:nvSpPr>
            <p:spPr>
              <a:xfrm>
                <a:off x="1911353" y="3643845"/>
                <a:ext cx="1130823" cy="225226"/>
              </a:xfrm>
              <a:custGeom>
                <a:avLst/>
                <a:gdLst/>
                <a:ahLst/>
                <a:cxnLst/>
                <a:rect l="l" t="t" r="r" b="b"/>
                <a:pathLst>
                  <a:path w="15188" h="3025" extrusionOk="0">
                    <a:moveTo>
                      <a:pt x="1" y="0"/>
                    </a:moveTo>
                    <a:lnTo>
                      <a:pt x="1" y="3025"/>
                    </a:lnTo>
                    <a:lnTo>
                      <a:pt x="15188" y="3025"/>
                    </a:lnTo>
                    <a:lnTo>
                      <a:pt x="15188" y="0"/>
                    </a:lnTo>
                    <a:close/>
                  </a:path>
                </a:pathLst>
              </a:custGeom>
              <a:solidFill>
                <a:schemeClr val="accen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80" name="Google Shape;380;p17"/>
              <p:cNvSpPr/>
              <p:nvPr/>
            </p:nvSpPr>
            <p:spPr>
              <a:xfrm>
                <a:off x="1898398" y="3744286"/>
                <a:ext cx="1158371" cy="74604"/>
              </a:xfrm>
              <a:custGeom>
                <a:avLst/>
                <a:gdLst/>
                <a:ahLst/>
                <a:cxnLst/>
                <a:rect l="l" t="t" r="r" b="b"/>
                <a:pathLst>
                  <a:path w="15558" h="1002" extrusionOk="0">
                    <a:moveTo>
                      <a:pt x="1" y="0"/>
                    </a:moveTo>
                    <a:lnTo>
                      <a:pt x="1" y="1001"/>
                    </a:lnTo>
                    <a:lnTo>
                      <a:pt x="15558" y="697"/>
                    </a:lnTo>
                    <a:lnTo>
                      <a:pt x="15558" y="0"/>
                    </a:lnTo>
                    <a:close/>
                  </a:path>
                </a:pathLst>
              </a:custGeom>
              <a:solidFill>
                <a:srgbClr val="191919">
                  <a:alpha val="1761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81" name="Google Shape;381;p17"/>
              <p:cNvSpPr/>
              <p:nvPr/>
            </p:nvSpPr>
            <p:spPr>
              <a:xfrm>
                <a:off x="1788276" y="3614658"/>
                <a:ext cx="1383523" cy="131339"/>
              </a:xfrm>
              <a:custGeom>
                <a:avLst/>
                <a:gdLst/>
                <a:ahLst/>
                <a:cxnLst/>
                <a:rect l="l" t="t" r="r" b="b"/>
                <a:pathLst>
                  <a:path w="18582" h="1764" extrusionOk="0">
                    <a:moveTo>
                      <a:pt x="0" y="1"/>
                    </a:moveTo>
                    <a:lnTo>
                      <a:pt x="0" y="1763"/>
                    </a:lnTo>
                    <a:lnTo>
                      <a:pt x="18582" y="1763"/>
                    </a:lnTo>
                    <a:lnTo>
                      <a:pt x="18582" y="1"/>
                    </a:lnTo>
                    <a:close/>
                  </a:path>
                </a:pathLst>
              </a:custGeom>
              <a:solidFill>
                <a:schemeClr val="accen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</p:grpSp>
        <p:sp>
          <p:nvSpPr>
            <p:cNvPr id="382" name="Google Shape;382;p17"/>
            <p:cNvSpPr/>
            <p:nvPr/>
          </p:nvSpPr>
          <p:spPr>
            <a:xfrm>
              <a:off x="8051179" y="4811475"/>
              <a:ext cx="1627556" cy="461704"/>
            </a:xfrm>
            <a:custGeom>
              <a:avLst/>
              <a:gdLst/>
              <a:ahLst/>
              <a:cxnLst/>
              <a:rect l="l" t="t" r="r" b="b"/>
              <a:pathLst>
                <a:path w="64014" h="9771" extrusionOk="0">
                  <a:moveTo>
                    <a:pt x="31876" y="1"/>
                  </a:moveTo>
                  <a:cubicBezTo>
                    <a:pt x="14187" y="1"/>
                    <a:pt x="1" y="2155"/>
                    <a:pt x="1" y="4875"/>
                  </a:cubicBezTo>
                  <a:cubicBezTo>
                    <a:pt x="1" y="7573"/>
                    <a:pt x="14339" y="9770"/>
                    <a:pt x="32007" y="9770"/>
                  </a:cubicBezTo>
                  <a:cubicBezTo>
                    <a:pt x="49674" y="9770"/>
                    <a:pt x="64013" y="7573"/>
                    <a:pt x="64013" y="4875"/>
                  </a:cubicBezTo>
                  <a:cubicBezTo>
                    <a:pt x="64013" y="2155"/>
                    <a:pt x="49544" y="1"/>
                    <a:pt x="31876" y="1"/>
                  </a:cubicBezTo>
                  <a:close/>
                </a:path>
              </a:pathLst>
            </a:custGeom>
            <a:solidFill>
              <a:srgbClr val="191919">
                <a:alpha val="17610"/>
              </a:srgb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grpSp>
          <p:nvGrpSpPr>
            <p:cNvPr id="383" name="Google Shape;383;p17"/>
            <p:cNvGrpSpPr/>
            <p:nvPr/>
          </p:nvGrpSpPr>
          <p:grpSpPr>
            <a:xfrm>
              <a:off x="8430825" y="2250977"/>
              <a:ext cx="868271" cy="2892522"/>
              <a:chOff x="-1434450" y="2250977"/>
              <a:chExt cx="868271" cy="2892522"/>
            </a:xfrm>
          </p:grpSpPr>
          <p:sp>
            <p:nvSpPr>
              <p:cNvPr id="384" name="Google Shape;384;p17"/>
              <p:cNvSpPr/>
              <p:nvPr/>
            </p:nvSpPr>
            <p:spPr>
              <a:xfrm>
                <a:off x="-1301572" y="2770032"/>
                <a:ext cx="359138" cy="275989"/>
              </a:xfrm>
              <a:custGeom>
                <a:avLst/>
                <a:gdLst/>
                <a:ahLst/>
                <a:cxnLst/>
                <a:rect l="l" t="t" r="r" b="b"/>
                <a:pathLst>
                  <a:path w="4527" h="3479" extrusionOk="0">
                    <a:moveTo>
                      <a:pt x="4178" y="0"/>
                    </a:moveTo>
                    <a:cubicBezTo>
                      <a:pt x="4178" y="0"/>
                      <a:pt x="2046" y="1001"/>
                      <a:pt x="1023" y="1654"/>
                    </a:cubicBezTo>
                    <a:cubicBezTo>
                      <a:pt x="23" y="2329"/>
                      <a:pt x="1" y="2742"/>
                      <a:pt x="218" y="3112"/>
                    </a:cubicBezTo>
                    <a:cubicBezTo>
                      <a:pt x="375" y="3377"/>
                      <a:pt x="593" y="3479"/>
                      <a:pt x="839" y="3479"/>
                    </a:cubicBezTo>
                    <a:cubicBezTo>
                      <a:pt x="1480" y="3479"/>
                      <a:pt x="2305" y="2786"/>
                      <a:pt x="2699" y="2503"/>
                    </a:cubicBezTo>
                    <a:cubicBezTo>
                      <a:pt x="3243" y="2133"/>
                      <a:pt x="4527" y="610"/>
                      <a:pt x="4527" y="610"/>
                    </a:cubicBezTo>
                    <a:lnTo>
                      <a:pt x="4178" y="0"/>
                    </a:lnTo>
                    <a:close/>
                  </a:path>
                </a:pathLst>
              </a:custGeom>
              <a:solidFill>
                <a:srgbClr val="3183B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85" name="Google Shape;385;p17"/>
              <p:cNvSpPr/>
              <p:nvPr/>
            </p:nvSpPr>
            <p:spPr>
              <a:xfrm>
                <a:off x="-1325689" y="2782090"/>
                <a:ext cx="367706" cy="285350"/>
              </a:xfrm>
              <a:custGeom>
                <a:avLst/>
                <a:gdLst/>
                <a:ahLst/>
                <a:cxnLst/>
                <a:rect l="l" t="t" r="r" b="b"/>
                <a:pathLst>
                  <a:path w="4635" h="3597" extrusionOk="0">
                    <a:moveTo>
                      <a:pt x="3873" y="1"/>
                    </a:moveTo>
                    <a:cubicBezTo>
                      <a:pt x="3873" y="1"/>
                      <a:pt x="2002" y="893"/>
                      <a:pt x="1001" y="1546"/>
                    </a:cubicBezTo>
                    <a:cubicBezTo>
                      <a:pt x="0" y="2177"/>
                      <a:pt x="44" y="2851"/>
                      <a:pt x="261" y="3221"/>
                    </a:cubicBezTo>
                    <a:cubicBezTo>
                      <a:pt x="416" y="3493"/>
                      <a:pt x="636" y="3596"/>
                      <a:pt x="883" y="3596"/>
                    </a:cubicBezTo>
                    <a:cubicBezTo>
                      <a:pt x="1506" y="3596"/>
                      <a:pt x="2303" y="2942"/>
                      <a:pt x="2676" y="2677"/>
                    </a:cubicBezTo>
                    <a:cubicBezTo>
                      <a:pt x="3220" y="2307"/>
                      <a:pt x="4635" y="1284"/>
                      <a:pt x="4635" y="1284"/>
                    </a:cubicBezTo>
                    <a:lnTo>
                      <a:pt x="3873" y="1"/>
                    </a:lnTo>
                    <a:close/>
                  </a:path>
                </a:pathLst>
              </a:custGeom>
              <a:solidFill>
                <a:srgbClr val="3183B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86" name="Google Shape;386;p17"/>
              <p:cNvSpPr/>
              <p:nvPr/>
            </p:nvSpPr>
            <p:spPr>
              <a:xfrm>
                <a:off x="-987426" y="2766303"/>
                <a:ext cx="129550" cy="74967"/>
              </a:xfrm>
              <a:custGeom>
                <a:avLst/>
                <a:gdLst/>
                <a:ahLst/>
                <a:cxnLst/>
                <a:rect l="l" t="t" r="r" b="b"/>
                <a:pathLst>
                  <a:path w="1633" h="945" extrusionOk="0">
                    <a:moveTo>
                      <a:pt x="562" y="0"/>
                    </a:moveTo>
                    <a:cubicBezTo>
                      <a:pt x="289" y="0"/>
                      <a:pt x="1" y="156"/>
                      <a:pt x="1" y="156"/>
                    </a:cubicBezTo>
                    <a:lnTo>
                      <a:pt x="284" y="809"/>
                    </a:lnTo>
                    <a:cubicBezTo>
                      <a:pt x="284" y="809"/>
                      <a:pt x="1067" y="918"/>
                      <a:pt x="1176" y="939"/>
                    </a:cubicBezTo>
                    <a:cubicBezTo>
                      <a:pt x="1184" y="943"/>
                      <a:pt x="1194" y="944"/>
                      <a:pt x="1205" y="944"/>
                    </a:cubicBezTo>
                    <a:cubicBezTo>
                      <a:pt x="1336" y="944"/>
                      <a:pt x="1633" y="722"/>
                      <a:pt x="1633" y="722"/>
                    </a:cubicBezTo>
                    <a:cubicBezTo>
                      <a:pt x="1633" y="722"/>
                      <a:pt x="1132" y="265"/>
                      <a:pt x="828" y="69"/>
                    </a:cubicBezTo>
                    <a:cubicBezTo>
                      <a:pt x="749" y="19"/>
                      <a:pt x="657" y="0"/>
                      <a:pt x="562" y="0"/>
                    </a:cubicBezTo>
                    <a:close/>
                  </a:path>
                </a:pathLst>
              </a:custGeom>
              <a:solidFill>
                <a:srgbClr val="3183B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87" name="Google Shape;387;p17"/>
              <p:cNvSpPr/>
              <p:nvPr/>
            </p:nvSpPr>
            <p:spPr>
              <a:xfrm>
                <a:off x="-964975" y="2742425"/>
                <a:ext cx="100197" cy="55610"/>
              </a:xfrm>
              <a:custGeom>
                <a:avLst/>
                <a:gdLst/>
                <a:ahLst/>
                <a:cxnLst/>
                <a:rect l="l" t="t" r="r" b="b"/>
                <a:pathLst>
                  <a:path w="1263" h="701" extrusionOk="0">
                    <a:moveTo>
                      <a:pt x="1219" y="0"/>
                    </a:moveTo>
                    <a:cubicBezTo>
                      <a:pt x="1176" y="0"/>
                      <a:pt x="849" y="196"/>
                      <a:pt x="740" y="196"/>
                    </a:cubicBezTo>
                    <a:cubicBezTo>
                      <a:pt x="109" y="240"/>
                      <a:pt x="1" y="392"/>
                      <a:pt x="1" y="392"/>
                    </a:cubicBezTo>
                    <a:cubicBezTo>
                      <a:pt x="1" y="392"/>
                      <a:pt x="348" y="700"/>
                      <a:pt x="588" y="700"/>
                    </a:cubicBezTo>
                    <a:cubicBezTo>
                      <a:pt x="603" y="700"/>
                      <a:pt x="618" y="699"/>
                      <a:pt x="632" y="697"/>
                    </a:cubicBezTo>
                    <a:cubicBezTo>
                      <a:pt x="849" y="653"/>
                      <a:pt x="871" y="566"/>
                      <a:pt x="914" y="479"/>
                    </a:cubicBezTo>
                    <a:cubicBezTo>
                      <a:pt x="958" y="392"/>
                      <a:pt x="1045" y="370"/>
                      <a:pt x="1154" y="261"/>
                    </a:cubicBezTo>
                    <a:cubicBezTo>
                      <a:pt x="1241" y="174"/>
                      <a:pt x="1263" y="0"/>
                      <a:pt x="1219" y="0"/>
                    </a:cubicBezTo>
                    <a:close/>
                  </a:path>
                </a:pathLst>
              </a:custGeom>
              <a:solidFill>
                <a:srgbClr val="3183B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88" name="Google Shape;388;p17"/>
              <p:cNvSpPr/>
              <p:nvPr/>
            </p:nvSpPr>
            <p:spPr>
              <a:xfrm>
                <a:off x="-933878" y="2795655"/>
                <a:ext cx="157158" cy="55055"/>
              </a:xfrm>
              <a:custGeom>
                <a:avLst/>
                <a:gdLst/>
                <a:ahLst/>
                <a:cxnLst/>
                <a:rect l="l" t="t" r="r" b="b"/>
                <a:pathLst>
                  <a:path w="1981" h="694" extrusionOk="0">
                    <a:moveTo>
                      <a:pt x="1867" y="1"/>
                    </a:moveTo>
                    <a:cubicBezTo>
                      <a:pt x="1811" y="1"/>
                      <a:pt x="1736" y="21"/>
                      <a:pt x="1654" y="91"/>
                    </a:cubicBezTo>
                    <a:cubicBezTo>
                      <a:pt x="1522" y="185"/>
                      <a:pt x="1358" y="295"/>
                      <a:pt x="1344" y="295"/>
                    </a:cubicBezTo>
                    <a:cubicBezTo>
                      <a:pt x="1342" y="295"/>
                      <a:pt x="1343" y="293"/>
                      <a:pt x="1349" y="287"/>
                    </a:cubicBezTo>
                    <a:lnTo>
                      <a:pt x="1349" y="287"/>
                    </a:lnTo>
                    <a:cubicBezTo>
                      <a:pt x="1284" y="308"/>
                      <a:pt x="1219" y="352"/>
                      <a:pt x="1153" y="352"/>
                    </a:cubicBezTo>
                    <a:cubicBezTo>
                      <a:pt x="1001" y="330"/>
                      <a:pt x="675" y="113"/>
                      <a:pt x="675" y="113"/>
                    </a:cubicBezTo>
                    <a:cubicBezTo>
                      <a:pt x="675" y="113"/>
                      <a:pt x="675" y="91"/>
                      <a:pt x="653" y="91"/>
                    </a:cubicBezTo>
                    <a:cubicBezTo>
                      <a:pt x="615" y="166"/>
                      <a:pt x="561" y="226"/>
                      <a:pt x="505" y="226"/>
                    </a:cubicBezTo>
                    <a:cubicBezTo>
                      <a:pt x="496" y="226"/>
                      <a:pt x="488" y="224"/>
                      <a:pt x="479" y="221"/>
                    </a:cubicBezTo>
                    <a:cubicBezTo>
                      <a:pt x="461" y="210"/>
                      <a:pt x="424" y="203"/>
                      <a:pt x="378" y="203"/>
                    </a:cubicBezTo>
                    <a:cubicBezTo>
                      <a:pt x="254" y="203"/>
                      <a:pt x="64" y="253"/>
                      <a:pt x="0" y="395"/>
                    </a:cubicBezTo>
                    <a:cubicBezTo>
                      <a:pt x="0" y="395"/>
                      <a:pt x="218" y="526"/>
                      <a:pt x="522" y="591"/>
                    </a:cubicBezTo>
                    <a:cubicBezTo>
                      <a:pt x="566" y="591"/>
                      <a:pt x="610" y="613"/>
                      <a:pt x="653" y="635"/>
                    </a:cubicBezTo>
                    <a:lnTo>
                      <a:pt x="762" y="635"/>
                    </a:lnTo>
                    <a:cubicBezTo>
                      <a:pt x="784" y="635"/>
                      <a:pt x="805" y="657"/>
                      <a:pt x="827" y="657"/>
                    </a:cubicBezTo>
                    <a:cubicBezTo>
                      <a:pt x="842" y="657"/>
                      <a:pt x="866" y="647"/>
                      <a:pt x="893" y="647"/>
                    </a:cubicBezTo>
                    <a:cubicBezTo>
                      <a:pt x="907" y="647"/>
                      <a:pt x="921" y="649"/>
                      <a:pt x="936" y="657"/>
                    </a:cubicBezTo>
                    <a:cubicBezTo>
                      <a:pt x="958" y="657"/>
                      <a:pt x="1001" y="678"/>
                      <a:pt x="1023" y="678"/>
                    </a:cubicBezTo>
                    <a:cubicBezTo>
                      <a:pt x="1045" y="689"/>
                      <a:pt x="1062" y="693"/>
                      <a:pt x="1077" y="693"/>
                    </a:cubicBezTo>
                    <a:cubicBezTo>
                      <a:pt x="1121" y="693"/>
                      <a:pt x="1137" y="657"/>
                      <a:pt x="1153" y="657"/>
                    </a:cubicBezTo>
                    <a:cubicBezTo>
                      <a:pt x="1241" y="678"/>
                      <a:pt x="1284" y="678"/>
                      <a:pt x="1306" y="678"/>
                    </a:cubicBezTo>
                    <a:cubicBezTo>
                      <a:pt x="1371" y="657"/>
                      <a:pt x="1676" y="417"/>
                      <a:pt x="1697" y="374"/>
                    </a:cubicBezTo>
                    <a:cubicBezTo>
                      <a:pt x="1741" y="308"/>
                      <a:pt x="1980" y="69"/>
                      <a:pt x="1959" y="26"/>
                    </a:cubicBezTo>
                    <a:cubicBezTo>
                      <a:pt x="1948" y="15"/>
                      <a:pt x="1915" y="1"/>
                      <a:pt x="1867" y="1"/>
                    </a:cubicBezTo>
                    <a:close/>
                  </a:path>
                </a:pathLst>
              </a:custGeom>
              <a:solidFill>
                <a:srgbClr val="3183B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89" name="Google Shape;389;p17"/>
              <p:cNvSpPr/>
              <p:nvPr/>
            </p:nvSpPr>
            <p:spPr>
              <a:xfrm>
                <a:off x="-882075" y="2783835"/>
                <a:ext cx="65608" cy="39744"/>
              </a:xfrm>
              <a:custGeom>
                <a:avLst/>
                <a:gdLst/>
                <a:ahLst/>
                <a:cxnLst/>
                <a:rect l="l" t="t" r="r" b="b"/>
                <a:pathLst>
                  <a:path w="827" h="501" extrusionOk="0">
                    <a:moveTo>
                      <a:pt x="718" y="0"/>
                    </a:moveTo>
                    <a:cubicBezTo>
                      <a:pt x="675" y="0"/>
                      <a:pt x="544" y="131"/>
                      <a:pt x="544" y="131"/>
                    </a:cubicBezTo>
                    <a:cubicBezTo>
                      <a:pt x="544" y="131"/>
                      <a:pt x="500" y="22"/>
                      <a:pt x="479" y="22"/>
                    </a:cubicBezTo>
                    <a:cubicBezTo>
                      <a:pt x="472" y="21"/>
                      <a:pt x="466" y="20"/>
                      <a:pt x="459" y="20"/>
                    </a:cubicBezTo>
                    <a:cubicBezTo>
                      <a:pt x="382" y="20"/>
                      <a:pt x="323" y="133"/>
                      <a:pt x="283" y="153"/>
                    </a:cubicBezTo>
                    <a:cubicBezTo>
                      <a:pt x="280" y="158"/>
                      <a:pt x="278" y="161"/>
                      <a:pt x="276" y="161"/>
                    </a:cubicBezTo>
                    <a:cubicBezTo>
                      <a:pt x="260" y="161"/>
                      <a:pt x="256" y="44"/>
                      <a:pt x="218" y="44"/>
                    </a:cubicBezTo>
                    <a:cubicBezTo>
                      <a:pt x="131" y="44"/>
                      <a:pt x="65" y="153"/>
                      <a:pt x="0" y="240"/>
                    </a:cubicBezTo>
                    <a:cubicBezTo>
                      <a:pt x="22" y="240"/>
                      <a:pt x="22" y="262"/>
                      <a:pt x="22" y="262"/>
                    </a:cubicBezTo>
                    <a:cubicBezTo>
                      <a:pt x="22" y="262"/>
                      <a:pt x="348" y="479"/>
                      <a:pt x="500" y="501"/>
                    </a:cubicBezTo>
                    <a:cubicBezTo>
                      <a:pt x="566" y="501"/>
                      <a:pt x="631" y="457"/>
                      <a:pt x="696" y="436"/>
                    </a:cubicBezTo>
                    <a:cubicBezTo>
                      <a:pt x="718" y="414"/>
                      <a:pt x="805" y="196"/>
                      <a:pt x="805" y="87"/>
                    </a:cubicBezTo>
                    <a:cubicBezTo>
                      <a:pt x="827" y="22"/>
                      <a:pt x="762" y="0"/>
                      <a:pt x="718" y="0"/>
                    </a:cubicBezTo>
                    <a:close/>
                  </a:path>
                </a:pathLst>
              </a:custGeom>
              <a:solidFill>
                <a:srgbClr val="3183B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90" name="Google Shape;390;p17"/>
              <p:cNvSpPr/>
              <p:nvPr/>
            </p:nvSpPr>
            <p:spPr>
              <a:xfrm>
                <a:off x="-973622" y="2275252"/>
                <a:ext cx="184765" cy="339612"/>
              </a:xfrm>
              <a:custGeom>
                <a:avLst/>
                <a:gdLst/>
                <a:ahLst/>
                <a:cxnLst/>
                <a:rect l="l" t="t" r="r" b="b"/>
                <a:pathLst>
                  <a:path w="2329" h="4281" extrusionOk="0">
                    <a:moveTo>
                      <a:pt x="1216" y="0"/>
                    </a:moveTo>
                    <a:cubicBezTo>
                      <a:pt x="753" y="0"/>
                      <a:pt x="393" y="515"/>
                      <a:pt x="393" y="515"/>
                    </a:cubicBezTo>
                    <a:lnTo>
                      <a:pt x="305" y="1821"/>
                    </a:lnTo>
                    <a:cubicBezTo>
                      <a:pt x="305" y="1821"/>
                      <a:pt x="480" y="2408"/>
                      <a:pt x="240" y="3170"/>
                    </a:cubicBezTo>
                    <a:cubicBezTo>
                      <a:pt x="1" y="3931"/>
                      <a:pt x="675" y="4236"/>
                      <a:pt x="915" y="4279"/>
                    </a:cubicBezTo>
                    <a:cubicBezTo>
                      <a:pt x="925" y="4280"/>
                      <a:pt x="935" y="4281"/>
                      <a:pt x="945" y="4281"/>
                    </a:cubicBezTo>
                    <a:cubicBezTo>
                      <a:pt x="1165" y="4281"/>
                      <a:pt x="1281" y="4060"/>
                      <a:pt x="1198" y="4018"/>
                    </a:cubicBezTo>
                    <a:cubicBezTo>
                      <a:pt x="1089" y="3996"/>
                      <a:pt x="1633" y="2473"/>
                      <a:pt x="1959" y="2125"/>
                    </a:cubicBezTo>
                    <a:cubicBezTo>
                      <a:pt x="2285" y="1777"/>
                      <a:pt x="2329" y="667"/>
                      <a:pt x="1654" y="167"/>
                    </a:cubicBezTo>
                    <a:cubicBezTo>
                      <a:pt x="1504" y="46"/>
                      <a:pt x="1356" y="0"/>
                      <a:pt x="1216" y="0"/>
                    </a:cubicBezTo>
                    <a:close/>
                  </a:path>
                </a:pathLst>
              </a:custGeom>
              <a:solidFill>
                <a:schemeClr val="accent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91" name="Google Shape;391;p17"/>
              <p:cNvSpPr/>
              <p:nvPr/>
            </p:nvSpPr>
            <p:spPr>
              <a:xfrm>
                <a:off x="-1220418" y="4837604"/>
                <a:ext cx="260687" cy="252587"/>
              </a:xfrm>
              <a:custGeom>
                <a:avLst/>
                <a:gdLst/>
                <a:ahLst/>
                <a:cxnLst/>
                <a:rect l="l" t="t" r="r" b="b"/>
                <a:pathLst>
                  <a:path w="3286" h="3184" extrusionOk="0">
                    <a:moveTo>
                      <a:pt x="2838" y="0"/>
                    </a:moveTo>
                    <a:cubicBezTo>
                      <a:pt x="2714" y="0"/>
                      <a:pt x="1763" y="330"/>
                      <a:pt x="1763" y="330"/>
                    </a:cubicBezTo>
                    <a:cubicBezTo>
                      <a:pt x="1763" y="330"/>
                      <a:pt x="1676" y="983"/>
                      <a:pt x="697" y="2375"/>
                    </a:cubicBezTo>
                    <a:cubicBezTo>
                      <a:pt x="697" y="2375"/>
                      <a:pt x="0" y="2941"/>
                      <a:pt x="66" y="3071"/>
                    </a:cubicBezTo>
                    <a:cubicBezTo>
                      <a:pt x="88" y="3151"/>
                      <a:pt x="290" y="3183"/>
                      <a:pt x="517" y="3183"/>
                    </a:cubicBezTo>
                    <a:cubicBezTo>
                      <a:pt x="724" y="3183"/>
                      <a:pt x="953" y="3157"/>
                      <a:pt x="1088" y="3115"/>
                    </a:cubicBezTo>
                    <a:cubicBezTo>
                      <a:pt x="1393" y="3028"/>
                      <a:pt x="1872" y="2179"/>
                      <a:pt x="2220" y="1940"/>
                    </a:cubicBezTo>
                    <a:cubicBezTo>
                      <a:pt x="2568" y="1701"/>
                      <a:pt x="2916" y="1788"/>
                      <a:pt x="3177" y="1483"/>
                    </a:cubicBezTo>
                    <a:cubicBezTo>
                      <a:pt x="3286" y="1374"/>
                      <a:pt x="3286" y="1004"/>
                      <a:pt x="3155" y="787"/>
                    </a:cubicBezTo>
                    <a:cubicBezTo>
                      <a:pt x="3047" y="613"/>
                      <a:pt x="2894" y="373"/>
                      <a:pt x="2851" y="4"/>
                    </a:cubicBezTo>
                    <a:cubicBezTo>
                      <a:pt x="2850" y="1"/>
                      <a:pt x="2845" y="0"/>
                      <a:pt x="2838" y="0"/>
                    </a:cubicBezTo>
                    <a:close/>
                  </a:path>
                </a:pathLst>
              </a:custGeom>
              <a:solidFill>
                <a:srgbClr val="E9CAB7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92" name="Google Shape;392;p17"/>
              <p:cNvSpPr/>
              <p:nvPr/>
            </p:nvSpPr>
            <p:spPr>
              <a:xfrm>
                <a:off x="-1232476" y="4875841"/>
                <a:ext cx="276236" cy="225377"/>
              </a:xfrm>
              <a:custGeom>
                <a:avLst/>
                <a:gdLst/>
                <a:ahLst/>
                <a:cxnLst/>
                <a:rect l="l" t="t" r="r" b="b"/>
                <a:pathLst>
                  <a:path w="3482" h="2841" extrusionOk="0">
                    <a:moveTo>
                      <a:pt x="3133" y="0"/>
                    </a:moveTo>
                    <a:cubicBezTo>
                      <a:pt x="3133" y="0"/>
                      <a:pt x="3133" y="283"/>
                      <a:pt x="2937" y="566"/>
                    </a:cubicBezTo>
                    <a:cubicBezTo>
                      <a:pt x="2763" y="827"/>
                      <a:pt x="1828" y="1676"/>
                      <a:pt x="1132" y="2111"/>
                    </a:cubicBezTo>
                    <a:cubicBezTo>
                      <a:pt x="1077" y="2138"/>
                      <a:pt x="934" y="2166"/>
                      <a:pt x="826" y="2166"/>
                    </a:cubicBezTo>
                    <a:cubicBezTo>
                      <a:pt x="764" y="2166"/>
                      <a:pt x="712" y="2157"/>
                      <a:pt x="696" y="2133"/>
                    </a:cubicBezTo>
                    <a:cubicBezTo>
                      <a:pt x="653" y="2067"/>
                      <a:pt x="849" y="1893"/>
                      <a:pt x="849" y="1893"/>
                    </a:cubicBezTo>
                    <a:lnTo>
                      <a:pt x="849" y="1893"/>
                    </a:lnTo>
                    <a:cubicBezTo>
                      <a:pt x="522" y="2133"/>
                      <a:pt x="0" y="2633"/>
                      <a:pt x="44" y="2742"/>
                    </a:cubicBezTo>
                    <a:cubicBezTo>
                      <a:pt x="64" y="2812"/>
                      <a:pt x="290" y="2840"/>
                      <a:pt x="556" y="2840"/>
                    </a:cubicBezTo>
                    <a:cubicBezTo>
                      <a:pt x="870" y="2840"/>
                      <a:pt x="1240" y="2801"/>
                      <a:pt x="1393" y="2742"/>
                    </a:cubicBezTo>
                    <a:cubicBezTo>
                      <a:pt x="1697" y="2655"/>
                      <a:pt x="2132" y="1828"/>
                      <a:pt x="2481" y="1589"/>
                    </a:cubicBezTo>
                    <a:cubicBezTo>
                      <a:pt x="2633" y="1480"/>
                      <a:pt x="3177" y="1175"/>
                      <a:pt x="3329" y="1001"/>
                    </a:cubicBezTo>
                    <a:cubicBezTo>
                      <a:pt x="3373" y="958"/>
                      <a:pt x="3438" y="784"/>
                      <a:pt x="3438" y="718"/>
                    </a:cubicBezTo>
                    <a:cubicBezTo>
                      <a:pt x="3481" y="414"/>
                      <a:pt x="3199" y="0"/>
                      <a:pt x="3133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93" name="Google Shape;393;p17"/>
              <p:cNvSpPr/>
              <p:nvPr/>
            </p:nvSpPr>
            <p:spPr>
              <a:xfrm>
                <a:off x="-1040894" y="4927643"/>
                <a:ext cx="81157" cy="136368"/>
              </a:xfrm>
              <a:custGeom>
                <a:avLst/>
                <a:gdLst/>
                <a:ahLst/>
                <a:cxnLst/>
                <a:rect l="l" t="t" r="r" b="b"/>
                <a:pathLst>
                  <a:path w="1023" h="1719" extrusionOk="0">
                    <a:moveTo>
                      <a:pt x="1023" y="0"/>
                    </a:moveTo>
                    <a:cubicBezTo>
                      <a:pt x="1023" y="0"/>
                      <a:pt x="1" y="944"/>
                      <a:pt x="49" y="944"/>
                    </a:cubicBezTo>
                    <a:cubicBezTo>
                      <a:pt x="52" y="944"/>
                      <a:pt x="57" y="941"/>
                      <a:pt x="66" y="936"/>
                    </a:cubicBezTo>
                    <a:cubicBezTo>
                      <a:pt x="155" y="875"/>
                      <a:pt x="229" y="849"/>
                      <a:pt x="291" y="849"/>
                    </a:cubicBezTo>
                    <a:cubicBezTo>
                      <a:pt x="645" y="849"/>
                      <a:pt x="566" y="1719"/>
                      <a:pt x="566" y="1719"/>
                    </a:cubicBezTo>
                    <a:lnTo>
                      <a:pt x="697" y="1719"/>
                    </a:lnTo>
                    <a:cubicBezTo>
                      <a:pt x="697" y="1719"/>
                      <a:pt x="718" y="1088"/>
                      <a:pt x="805" y="805"/>
                    </a:cubicBezTo>
                    <a:cubicBezTo>
                      <a:pt x="849" y="588"/>
                      <a:pt x="1023" y="0"/>
                      <a:pt x="1023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94" name="Google Shape;394;p17"/>
              <p:cNvSpPr/>
              <p:nvPr/>
            </p:nvSpPr>
            <p:spPr>
              <a:xfrm>
                <a:off x="-1138311" y="4121018"/>
                <a:ext cx="220068" cy="762282"/>
              </a:xfrm>
              <a:custGeom>
                <a:avLst/>
                <a:gdLst/>
                <a:ahLst/>
                <a:cxnLst/>
                <a:rect l="l" t="t" r="r" b="b"/>
                <a:pathLst>
                  <a:path w="2774" h="9609" extrusionOk="0">
                    <a:moveTo>
                      <a:pt x="554" y="1"/>
                    </a:moveTo>
                    <a:cubicBezTo>
                      <a:pt x="240" y="1"/>
                      <a:pt x="0" y="152"/>
                      <a:pt x="10" y="573"/>
                    </a:cubicBezTo>
                    <a:cubicBezTo>
                      <a:pt x="10" y="747"/>
                      <a:pt x="227" y="2683"/>
                      <a:pt x="293" y="3097"/>
                    </a:cubicBezTo>
                    <a:cubicBezTo>
                      <a:pt x="358" y="3510"/>
                      <a:pt x="815" y="7775"/>
                      <a:pt x="728" y="9363"/>
                    </a:cubicBezTo>
                    <a:cubicBezTo>
                      <a:pt x="728" y="9476"/>
                      <a:pt x="1199" y="9608"/>
                      <a:pt x="1509" y="9608"/>
                    </a:cubicBezTo>
                    <a:cubicBezTo>
                      <a:pt x="1675" y="9608"/>
                      <a:pt x="1795" y="9570"/>
                      <a:pt x="1772" y="9472"/>
                    </a:cubicBezTo>
                    <a:cubicBezTo>
                      <a:pt x="1729" y="9189"/>
                      <a:pt x="2686" y="4990"/>
                      <a:pt x="2730" y="4185"/>
                    </a:cubicBezTo>
                    <a:cubicBezTo>
                      <a:pt x="2773" y="3401"/>
                      <a:pt x="2599" y="1334"/>
                      <a:pt x="1794" y="529"/>
                    </a:cubicBezTo>
                    <a:cubicBezTo>
                      <a:pt x="1521" y="268"/>
                      <a:pt x="971" y="1"/>
                      <a:pt x="554" y="1"/>
                    </a:cubicBezTo>
                    <a:close/>
                  </a:path>
                </a:pathLst>
              </a:custGeom>
              <a:solidFill>
                <a:srgbClr val="E9CAB7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95" name="Google Shape;395;p17"/>
              <p:cNvSpPr/>
              <p:nvPr/>
            </p:nvSpPr>
            <p:spPr>
              <a:xfrm>
                <a:off x="-685337" y="4967308"/>
                <a:ext cx="119157" cy="176192"/>
              </a:xfrm>
              <a:custGeom>
                <a:avLst/>
                <a:gdLst/>
                <a:ahLst/>
                <a:cxnLst/>
                <a:rect l="l" t="t" r="r" b="b"/>
                <a:pathLst>
                  <a:path w="1502" h="2221" extrusionOk="0">
                    <a:moveTo>
                      <a:pt x="1088" y="0"/>
                    </a:moveTo>
                    <a:lnTo>
                      <a:pt x="0" y="327"/>
                    </a:lnTo>
                    <a:cubicBezTo>
                      <a:pt x="0" y="327"/>
                      <a:pt x="22" y="1241"/>
                      <a:pt x="370" y="1676"/>
                    </a:cubicBezTo>
                    <a:cubicBezTo>
                      <a:pt x="434" y="1761"/>
                      <a:pt x="935" y="2220"/>
                      <a:pt x="1140" y="2220"/>
                    </a:cubicBezTo>
                    <a:cubicBezTo>
                      <a:pt x="1145" y="2220"/>
                      <a:pt x="1149" y="2220"/>
                      <a:pt x="1154" y="2220"/>
                    </a:cubicBezTo>
                    <a:cubicBezTo>
                      <a:pt x="1371" y="2176"/>
                      <a:pt x="1502" y="1545"/>
                      <a:pt x="1502" y="1262"/>
                    </a:cubicBezTo>
                    <a:cubicBezTo>
                      <a:pt x="1502" y="1001"/>
                      <a:pt x="1088" y="0"/>
                      <a:pt x="1088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96" name="Google Shape;396;p17"/>
              <p:cNvSpPr/>
              <p:nvPr/>
            </p:nvSpPr>
            <p:spPr>
              <a:xfrm>
                <a:off x="-687082" y="4922407"/>
                <a:ext cx="103688" cy="164134"/>
              </a:xfrm>
              <a:custGeom>
                <a:avLst/>
                <a:gdLst/>
                <a:ahLst/>
                <a:cxnLst/>
                <a:rect l="l" t="t" r="r" b="b"/>
                <a:pathLst>
                  <a:path w="1307" h="2069" extrusionOk="0">
                    <a:moveTo>
                      <a:pt x="893" y="1"/>
                    </a:moveTo>
                    <a:lnTo>
                      <a:pt x="44" y="88"/>
                    </a:lnTo>
                    <a:cubicBezTo>
                      <a:pt x="44" y="88"/>
                      <a:pt x="44" y="458"/>
                      <a:pt x="22" y="784"/>
                    </a:cubicBezTo>
                    <a:cubicBezTo>
                      <a:pt x="1" y="1128"/>
                      <a:pt x="447" y="2068"/>
                      <a:pt x="983" y="2068"/>
                    </a:cubicBezTo>
                    <a:cubicBezTo>
                      <a:pt x="989" y="2068"/>
                      <a:pt x="995" y="2068"/>
                      <a:pt x="1002" y="2068"/>
                    </a:cubicBezTo>
                    <a:cubicBezTo>
                      <a:pt x="1219" y="2068"/>
                      <a:pt x="1306" y="1502"/>
                      <a:pt x="1284" y="1350"/>
                    </a:cubicBezTo>
                    <a:cubicBezTo>
                      <a:pt x="1219" y="741"/>
                      <a:pt x="893" y="1"/>
                      <a:pt x="893" y="1"/>
                    </a:cubicBezTo>
                    <a:close/>
                  </a:path>
                </a:pathLst>
              </a:custGeom>
              <a:solidFill>
                <a:srgbClr val="FAD9C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97" name="Google Shape;397;p17"/>
              <p:cNvSpPr/>
              <p:nvPr/>
            </p:nvSpPr>
            <p:spPr>
              <a:xfrm>
                <a:off x="-852803" y="4153067"/>
                <a:ext cx="252119" cy="847086"/>
              </a:xfrm>
              <a:custGeom>
                <a:avLst/>
                <a:gdLst/>
                <a:ahLst/>
                <a:cxnLst/>
                <a:rect l="l" t="t" r="r" b="b"/>
                <a:pathLst>
                  <a:path w="3178" h="10678" extrusionOk="0">
                    <a:moveTo>
                      <a:pt x="1071" y="0"/>
                    </a:moveTo>
                    <a:cubicBezTo>
                      <a:pt x="1020" y="0"/>
                      <a:pt x="968" y="5"/>
                      <a:pt x="915" y="16"/>
                    </a:cubicBezTo>
                    <a:cubicBezTo>
                      <a:pt x="175" y="147"/>
                      <a:pt x="1" y="669"/>
                      <a:pt x="349" y="2801"/>
                    </a:cubicBezTo>
                    <a:cubicBezTo>
                      <a:pt x="632" y="4433"/>
                      <a:pt x="1633" y="8089"/>
                      <a:pt x="2111" y="9786"/>
                    </a:cubicBezTo>
                    <a:cubicBezTo>
                      <a:pt x="2286" y="10330"/>
                      <a:pt x="2220" y="10678"/>
                      <a:pt x="2264" y="10678"/>
                    </a:cubicBezTo>
                    <a:cubicBezTo>
                      <a:pt x="2481" y="10678"/>
                      <a:pt x="3091" y="10678"/>
                      <a:pt x="3156" y="10199"/>
                    </a:cubicBezTo>
                    <a:cubicBezTo>
                      <a:pt x="3178" y="10090"/>
                      <a:pt x="2938" y="9720"/>
                      <a:pt x="2938" y="9438"/>
                    </a:cubicBezTo>
                    <a:cubicBezTo>
                      <a:pt x="2938" y="7762"/>
                      <a:pt x="2917" y="3541"/>
                      <a:pt x="2829" y="2932"/>
                    </a:cubicBezTo>
                    <a:cubicBezTo>
                      <a:pt x="2705" y="2268"/>
                      <a:pt x="2125" y="0"/>
                      <a:pt x="1071" y="0"/>
                    </a:cubicBezTo>
                    <a:close/>
                  </a:path>
                </a:pathLst>
              </a:custGeom>
              <a:solidFill>
                <a:srgbClr val="FAD9C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98" name="Google Shape;398;p17"/>
              <p:cNvSpPr/>
              <p:nvPr/>
            </p:nvSpPr>
            <p:spPr>
              <a:xfrm>
                <a:off x="-1434450" y="2706965"/>
                <a:ext cx="347000" cy="513503"/>
              </a:xfrm>
              <a:custGeom>
                <a:avLst/>
                <a:gdLst/>
                <a:ahLst/>
                <a:cxnLst/>
                <a:rect l="l" t="t" r="r" b="b"/>
                <a:pathLst>
                  <a:path w="4374" h="6473" extrusionOk="0">
                    <a:moveTo>
                      <a:pt x="3338" y="0"/>
                    </a:moveTo>
                    <a:cubicBezTo>
                      <a:pt x="2854" y="0"/>
                      <a:pt x="2108" y="1267"/>
                      <a:pt x="1654" y="2710"/>
                    </a:cubicBezTo>
                    <a:cubicBezTo>
                      <a:pt x="805" y="5386"/>
                      <a:pt x="0" y="5822"/>
                      <a:pt x="893" y="6322"/>
                    </a:cubicBezTo>
                    <a:cubicBezTo>
                      <a:pt x="1088" y="6424"/>
                      <a:pt x="1251" y="6473"/>
                      <a:pt x="1391" y="6473"/>
                    </a:cubicBezTo>
                    <a:cubicBezTo>
                      <a:pt x="2061" y="6473"/>
                      <a:pt x="2223" y="5358"/>
                      <a:pt x="3068" y="3559"/>
                    </a:cubicBezTo>
                    <a:cubicBezTo>
                      <a:pt x="3852" y="1840"/>
                      <a:pt x="4374" y="338"/>
                      <a:pt x="3416" y="12"/>
                    </a:cubicBezTo>
                    <a:cubicBezTo>
                      <a:pt x="3391" y="4"/>
                      <a:pt x="3365" y="0"/>
                      <a:pt x="3338" y="0"/>
                    </a:cubicBezTo>
                    <a:close/>
                  </a:path>
                </a:pathLst>
              </a:custGeom>
              <a:solidFill>
                <a:schemeClr val="dk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399" name="Google Shape;399;p17"/>
              <p:cNvSpPr/>
              <p:nvPr/>
            </p:nvSpPr>
            <p:spPr>
              <a:xfrm>
                <a:off x="-1229065" y="3487490"/>
                <a:ext cx="274570" cy="812657"/>
              </a:xfrm>
              <a:custGeom>
                <a:avLst/>
                <a:gdLst/>
                <a:ahLst/>
                <a:cxnLst/>
                <a:rect l="l" t="t" r="r" b="b"/>
                <a:pathLst>
                  <a:path w="3461" h="10244" extrusionOk="0">
                    <a:moveTo>
                      <a:pt x="1571" y="0"/>
                    </a:moveTo>
                    <a:cubicBezTo>
                      <a:pt x="1113" y="0"/>
                      <a:pt x="614" y="197"/>
                      <a:pt x="349" y="682"/>
                    </a:cubicBezTo>
                    <a:cubicBezTo>
                      <a:pt x="1" y="1313"/>
                      <a:pt x="22" y="2423"/>
                      <a:pt x="196" y="3881"/>
                    </a:cubicBezTo>
                    <a:cubicBezTo>
                      <a:pt x="414" y="5861"/>
                      <a:pt x="1067" y="8994"/>
                      <a:pt x="1154" y="9277"/>
                    </a:cubicBezTo>
                    <a:cubicBezTo>
                      <a:pt x="1334" y="9940"/>
                      <a:pt x="1758" y="10243"/>
                      <a:pt x="2152" y="10243"/>
                    </a:cubicBezTo>
                    <a:cubicBezTo>
                      <a:pt x="2521" y="10243"/>
                      <a:pt x="2865" y="9978"/>
                      <a:pt x="2960" y="9494"/>
                    </a:cubicBezTo>
                    <a:cubicBezTo>
                      <a:pt x="3025" y="9211"/>
                      <a:pt x="3460" y="3533"/>
                      <a:pt x="3373" y="2902"/>
                    </a:cubicBezTo>
                    <a:cubicBezTo>
                      <a:pt x="3308" y="2271"/>
                      <a:pt x="2960" y="1117"/>
                      <a:pt x="2503" y="399"/>
                    </a:cubicBezTo>
                    <a:cubicBezTo>
                      <a:pt x="2350" y="154"/>
                      <a:pt x="1976" y="0"/>
                      <a:pt x="1571" y="0"/>
                    </a:cubicBezTo>
                    <a:close/>
                  </a:path>
                </a:pathLst>
              </a:custGeom>
              <a:solidFill>
                <a:srgbClr val="E9CAB7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00" name="Google Shape;400;p17"/>
              <p:cNvSpPr/>
              <p:nvPr/>
            </p:nvSpPr>
            <p:spPr>
              <a:xfrm>
                <a:off x="-970132" y="3505102"/>
                <a:ext cx="300432" cy="796156"/>
              </a:xfrm>
              <a:custGeom>
                <a:avLst/>
                <a:gdLst/>
                <a:ahLst/>
                <a:cxnLst/>
                <a:rect l="l" t="t" r="r" b="b"/>
                <a:pathLst>
                  <a:path w="3787" h="10036" extrusionOk="0">
                    <a:moveTo>
                      <a:pt x="1536" y="0"/>
                    </a:moveTo>
                    <a:cubicBezTo>
                      <a:pt x="966" y="0"/>
                      <a:pt x="434" y="209"/>
                      <a:pt x="305" y="526"/>
                    </a:cubicBezTo>
                    <a:cubicBezTo>
                      <a:pt x="0" y="1309"/>
                      <a:pt x="153" y="2462"/>
                      <a:pt x="218" y="3093"/>
                    </a:cubicBezTo>
                    <a:cubicBezTo>
                      <a:pt x="261" y="3724"/>
                      <a:pt x="1589" y="9185"/>
                      <a:pt x="1698" y="9446"/>
                    </a:cubicBezTo>
                    <a:cubicBezTo>
                      <a:pt x="1859" y="9841"/>
                      <a:pt x="2209" y="10036"/>
                      <a:pt x="2572" y="10036"/>
                    </a:cubicBezTo>
                    <a:cubicBezTo>
                      <a:pt x="3090" y="10036"/>
                      <a:pt x="3635" y="9639"/>
                      <a:pt x="3699" y="8859"/>
                    </a:cubicBezTo>
                    <a:cubicBezTo>
                      <a:pt x="3721" y="8576"/>
                      <a:pt x="3786" y="5595"/>
                      <a:pt x="3634" y="3615"/>
                    </a:cubicBezTo>
                    <a:cubicBezTo>
                      <a:pt x="3503" y="2157"/>
                      <a:pt x="3308" y="1048"/>
                      <a:pt x="2851" y="526"/>
                    </a:cubicBezTo>
                    <a:cubicBezTo>
                      <a:pt x="2539" y="154"/>
                      <a:pt x="2024" y="0"/>
                      <a:pt x="1536" y="0"/>
                    </a:cubicBezTo>
                    <a:close/>
                  </a:path>
                </a:pathLst>
              </a:custGeom>
              <a:solidFill>
                <a:srgbClr val="FAD9C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01" name="Google Shape;401;p17"/>
              <p:cNvSpPr/>
              <p:nvPr/>
            </p:nvSpPr>
            <p:spPr>
              <a:xfrm>
                <a:off x="-1218672" y="3469086"/>
                <a:ext cx="250373" cy="248620"/>
              </a:xfrm>
              <a:custGeom>
                <a:avLst/>
                <a:gdLst/>
                <a:ahLst/>
                <a:cxnLst/>
                <a:rect l="l" t="t" r="r" b="b"/>
                <a:pathLst>
                  <a:path w="3156" h="3134" extrusionOk="0">
                    <a:moveTo>
                      <a:pt x="414" y="0"/>
                    </a:moveTo>
                    <a:cubicBezTo>
                      <a:pt x="174" y="610"/>
                      <a:pt x="0" y="1154"/>
                      <a:pt x="87" y="1458"/>
                    </a:cubicBezTo>
                    <a:cubicBezTo>
                      <a:pt x="327" y="2372"/>
                      <a:pt x="2981" y="3134"/>
                      <a:pt x="2981" y="3134"/>
                    </a:cubicBezTo>
                    <a:lnTo>
                      <a:pt x="3155" y="3134"/>
                    </a:lnTo>
                    <a:lnTo>
                      <a:pt x="3155" y="218"/>
                    </a:lnTo>
                    <a:cubicBezTo>
                      <a:pt x="2133" y="218"/>
                      <a:pt x="1436" y="0"/>
                      <a:pt x="414" y="0"/>
                    </a:cubicBezTo>
                    <a:close/>
                  </a:path>
                </a:pathLst>
              </a:custGeom>
              <a:solidFill>
                <a:srgbClr val="27547C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02" name="Google Shape;402;p17"/>
              <p:cNvSpPr/>
              <p:nvPr/>
            </p:nvSpPr>
            <p:spPr>
              <a:xfrm>
                <a:off x="-1268730" y="2694113"/>
                <a:ext cx="581745" cy="792269"/>
              </a:xfrm>
              <a:custGeom>
                <a:avLst/>
                <a:gdLst/>
                <a:ahLst/>
                <a:cxnLst/>
                <a:rect l="l" t="t" r="r" b="b"/>
                <a:pathLst>
                  <a:path w="7333" h="9987" extrusionOk="0">
                    <a:moveTo>
                      <a:pt x="3786" y="0"/>
                    </a:moveTo>
                    <a:cubicBezTo>
                      <a:pt x="3786" y="0"/>
                      <a:pt x="1931" y="176"/>
                      <a:pt x="1366" y="176"/>
                    </a:cubicBezTo>
                    <a:cubicBezTo>
                      <a:pt x="1334" y="176"/>
                      <a:pt x="1307" y="175"/>
                      <a:pt x="1284" y="174"/>
                    </a:cubicBezTo>
                    <a:cubicBezTo>
                      <a:pt x="1088" y="174"/>
                      <a:pt x="958" y="849"/>
                      <a:pt x="892" y="1044"/>
                    </a:cubicBezTo>
                    <a:cubicBezTo>
                      <a:pt x="479" y="2132"/>
                      <a:pt x="0" y="3394"/>
                      <a:pt x="1023" y="4265"/>
                    </a:cubicBezTo>
                    <a:cubicBezTo>
                      <a:pt x="1240" y="4460"/>
                      <a:pt x="1458" y="6745"/>
                      <a:pt x="1458" y="7811"/>
                    </a:cubicBezTo>
                    <a:cubicBezTo>
                      <a:pt x="1458" y="8246"/>
                      <a:pt x="1349" y="8943"/>
                      <a:pt x="1045" y="9769"/>
                    </a:cubicBezTo>
                    <a:cubicBezTo>
                      <a:pt x="2067" y="9769"/>
                      <a:pt x="2764" y="9987"/>
                      <a:pt x="3786" y="9987"/>
                    </a:cubicBezTo>
                    <a:lnTo>
                      <a:pt x="6854" y="9987"/>
                    </a:lnTo>
                    <a:cubicBezTo>
                      <a:pt x="6528" y="9160"/>
                      <a:pt x="6201" y="8246"/>
                      <a:pt x="6114" y="7811"/>
                    </a:cubicBezTo>
                    <a:cubicBezTo>
                      <a:pt x="5527" y="4547"/>
                      <a:pt x="7333" y="1501"/>
                      <a:pt x="7072" y="892"/>
                    </a:cubicBezTo>
                    <a:cubicBezTo>
                      <a:pt x="6876" y="479"/>
                      <a:pt x="5940" y="305"/>
                      <a:pt x="5527" y="174"/>
                    </a:cubicBezTo>
                    <a:cubicBezTo>
                      <a:pt x="5070" y="44"/>
                      <a:pt x="3786" y="0"/>
                      <a:pt x="3786" y="0"/>
                    </a:cubicBezTo>
                    <a:close/>
                  </a:path>
                </a:pathLst>
              </a:custGeom>
              <a:solidFill>
                <a:schemeClr val="dk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03" name="Google Shape;403;p17"/>
              <p:cNvSpPr/>
              <p:nvPr/>
            </p:nvSpPr>
            <p:spPr>
              <a:xfrm>
                <a:off x="-968386" y="3486380"/>
                <a:ext cx="274490" cy="231326"/>
              </a:xfrm>
              <a:custGeom>
                <a:avLst/>
                <a:gdLst/>
                <a:ahLst/>
                <a:cxnLst/>
                <a:rect l="l" t="t" r="r" b="b"/>
                <a:pathLst>
                  <a:path w="3460" h="2916" extrusionOk="0">
                    <a:moveTo>
                      <a:pt x="0" y="0"/>
                    </a:moveTo>
                    <a:lnTo>
                      <a:pt x="0" y="2916"/>
                    </a:lnTo>
                    <a:lnTo>
                      <a:pt x="174" y="2916"/>
                    </a:lnTo>
                    <a:cubicBezTo>
                      <a:pt x="174" y="2916"/>
                      <a:pt x="3155" y="2350"/>
                      <a:pt x="3394" y="1458"/>
                    </a:cubicBezTo>
                    <a:cubicBezTo>
                      <a:pt x="3460" y="1153"/>
                      <a:pt x="3286" y="587"/>
                      <a:pt x="3068" y="0"/>
                    </a:cubicBezTo>
                    <a:close/>
                  </a:path>
                </a:pathLst>
              </a:custGeom>
              <a:solidFill>
                <a:srgbClr val="27547C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04" name="Google Shape;404;p17"/>
              <p:cNvSpPr/>
              <p:nvPr/>
            </p:nvSpPr>
            <p:spPr>
              <a:xfrm>
                <a:off x="-1094442" y="2511100"/>
                <a:ext cx="233158" cy="234817"/>
              </a:xfrm>
              <a:custGeom>
                <a:avLst/>
                <a:gdLst/>
                <a:ahLst/>
                <a:cxnLst/>
                <a:rect l="l" t="t" r="r" b="b"/>
                <a:pathLst>
                  <a:path w="2939" h="2960" extrusionOk="0">
                    <a:moveTo>
                      <a:pt x="762" y="1"/>
                    </a:moveTo>
                    <a:cubicBezTo>
                      <a:pt x="762" y="1"/>
                      <a:pt x="784" y="1284"/>
                      <a:pt x="654" y="1633"/>
                    </a:cubicBezTo>
                    <a:cubicBezTo>
                      <a:pt x="523" y="1981"/>
                      <a:pt x="1" y="2394"/>
                      <a:pt x="1" y="2394"/>
                    </a:cubicBezTo>
                    <a:lnTo>
                      <a:pt x="1197" y="2960"/>
                    </a:lnTo>
                    <a:lnTo>
                      <a:pt x="2938" y="2307"/>
                    </a:lnTo>
                    <a:cubicBezTo>
                      <a:pt x="2938" y="2307"/>
                      <a:pt x="2655" y="1981"/>
                      <a:pt x="2525" y="1633"/>
                    </a:cubicBezTo>
                    <a:cubicBezTo>
                      <a:pt x="2394" y="1284"/>
                      <a:pt x="2394" y="1"/>
                      <a:pt x="2394" y="1"/>
                    </a:cubicBezTo>
                    <a:close/>
                  </a:path>
                </a:pathLst>
              </a:custGeom>
              <a:solidFill>
                <a:srgbClr val="FAD9C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05" name="Google Shape;405;p17"/>
              <p:cNvSpPr/>
              <p:nvPr/>
            </p:nvSpPr>
            <p:spPr>
              <a:xfrm>
                <a:off x="-1106500" y="2511100"/>
                <a:ext cx="203726" cy="196897"/>
              </a:xfrm>
              <a:custGeom>
                <a:avLst/>
                <a:gdLst/>
                <a:ahLst/>
                <a:cxnLst/>
                <a:rect l="l" t="t" r="r" b="b"/>
                <a:pathLst>
                  <a:path w="2568" h="2482" extrusionOk="0">
                    <a:moveTo>
                      <a:pt x="914" y="1"/>
                    </a:moveTo>
                    <a:cubicBezTo>
                      <a:pt x="914" y="1"/>
                      <a:pt x="936" y="1284"/>
                      <a:pt x="806" y="1633"/>
                    </a:cubicBezTo>
                    <a:cubicBezTo>
                      <a:pt x="675" y="1981"/>
                      <a:pt x="0" y="2481"/>
                      <a:pt x="0" y="2481"/>
                    </a:cubicBezTo>
                    <a:lnTo>
                      <a:pt x="2568" y="653"/>
                    </a:lnTo>
                    <a:cubicBezTo>
                      <a:pt x="2546" y="305"/>
                      <a:pt x="2546" y="1"/>
                      <a:pt x="2546" y="1"/>
                    </a:cubicBezTo>
                    <a:close/>
                  </a:path>
                </a:pathLst>
              </a:custGeom>
              <a:solidFill>
                <a:srgbClr val="191919">
                  <a:alpha val="1761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06" name="Google Shape;406;p17"/>
              <p:cNvSpPr/>
              <p:nvPr/>
            </p:nvSpPr>
            <p:spPr>
              <a:xfrm>
                <a:off x="-1132361" y="2262083"/>
                <a:ext cx="307334" cy="346672"/>
              </a:xfrm>
              <a:custGeom>
                <a:avLst/>
                <a:gdLst/>
                <a:ahLst/>
                <a:cxnLst/>
                <a:rect l="l" t="t" r="r" b="b"/>
                <a:pathLst>
                  <a:path w="3874" h="4370" extrusionOk="0">
                    <a:moveTo>
                      <a:pt x="1962" y="0"/>
                    </a:moveTo>
                    <a:cubicBezTo>
                      <a:pt x="1191" y="0"/>
                      <a:pt x="478" y="568"/>
                      <a:pt x="261" y="1617"/>
                    </a:cubicBezTo>
                    <a:cubicBezTo>
                      <a:pt x="0" y="2900"/>
                      <a:pt x="522" y="4162"/>
                      <a:pt x="1132" y="4336"/>
                    </a:cubicBezTo>
                    <a:cubicBezTo>
                      <a:pt x="1204" y="4359"/>
                      <a:pt x="1286" y="4370"/>
                      <a:pt x="1375" y="4370"/>
                    </a:cubicBezTo>
                    <a:cubicBezTo>
                      <a:pt x="2064" y="4370"/>
                      <a:pt x="3176" y="3715"/>
                      <a:pt x="3503" y="2617"/>
                    </a:cubicBezTo>
                    <a:cubicBezTo>
                      <a:pt x="3873" y="1399"/>
                      <a:pt x="3373" y="355"/>
                      <a:pt x="2437" y="72"/>
                    </a:cubicBezTo>
                    <a:cubicBezTo>
                      <a:pt x="2279" y="24"/>
                      <a:pt x="2119" y="0"/>
                      <a:pt x="1962" y="0"/>
                    </a:cubicBezTo>
                    <a:close/>
                  </a:path>
                </a:pathLst>
              </a:custGeom>
              <a:solidFill>
                <a:srgbClr val="FAD9C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07" name="Google Shape;407;p17"/>
              <p:cNvSpPr/>
              <p:nvPr/>
            </p:nvSpPr>
            <p:spPr>
              <a:xfrm>
                <a:off x="-1035737" y="2250977"/>
                <a:ext cx="252119" cy="287809"/>
              </a:xfrm>
              <a:custGeom>
                <a:avLst/>
                <a:gdLst/>
                <a:ahLst/>
                <a:cxnLst/>
                <a:rect l="l" t="t" r="r" b="b"/>
                <a:pathLst>
                  <a:path w="3178" h="3628" extrusionOk="0">
                    <a:moveTo>
                      <a:pt x="773" y="0"/>
                    </a:moveTo>
                    <a:cubicBezTo>
                      <a:pt x="351" y="0"/>
                      <a:pt x="33" y="172"/>
                      <a:pt x="22" y="234"/>
                    </a:cubicBezTo>
                    <a:cubicBezTo>
                      <a:pt x="1" y="342"/>
                      <a:pt x="109" y="778"/>
                      <a:pt x="153" y="952"/>
                    </a:cubicBezTo>
                    <a:cubicBezTo>
                      <a:pt x="240" y="1321"/>
                      <a:pt x="566" y="1583"/>
                      <a:pt x="1328" y="1757"/>
                    </a:cubicBezTo>
                    <a:cubicBezTo>
                      <a:pt x="1850" y="1865"/>
                      <a:pt x="2111" y="2692"/>
                      <a:pt x="2068" y="2975"/>
                    </a:cubicBezTo>
                    <a:cubicBezTo>
                      <a:pt x="2046" y="3106"/>
                      <a:pt x="1828" y="3628"/>
                      <a:pt x="1828" y="3628"/>
                    </a:cubicBezTo>
                    <a:cubicBezTo>
                      <a:pt x="1828" y="3628"/>
                      <a:pt x="3177" y="2670"/>
                      <a:pt x="2307" y="1060"/>
                    </a:cubicBezTo>
                    <a:cubicBezTo>
                      <a:pt x="1857" y="219"/>
                      <a:pt x="1249" y="0"/>
                      <a:pt x="773" y="0"/>
                    </a:cubicBezTo>
                    <a:close/>
                  </a:path>
                </a:pathLst>
              </a:custGeom>
              <a:solidFill>
                <a:schemeClr val="accent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08" name="Google Shape;408;p17"/>
              <p:cNvSpPr/>
              <p:nvPr/>
            </p:nvSpPr>
            <p:spPr>
              <a:xfrm>
                <a:off x="-1113402" y="2267557"/>
                <a:ext cx="144702" cy="112490"/>
              </a:xfrm>
              <a:custGeom>
                <a:avLst/>
                <a:gdLst/>
                <a:ahLst/>
                <a:cxnLst/>
                <a:rect l="l" t="t" r="r" b="b"/>
                <a:pathLst>
                  <a:path w="1824" h="1418" extrusionOk="0">
                    <a:moveTo>
                      <a:pt x="1258" y="0"/>
                    </a:moveTo>
                    <a:cubicBezTo>
                      <a:pt x="1188" y="0"/>
                      <a:pt x="1103" y="8"/>
                      <a:pt x="1001" y="25"/>
                    </a:cubicBezTo>
                    <a:cubicBezTo>
                      <a:pt x="87" y="155"/>
                      <a:pt x="0" y="1417"/>
                      <a:pt x="0" y="1417"/>
                    </a:cubicBezTo>
                    <a:cubicBezTo>
                      <a:pt x="0" y="1417"/>
                      <a:pt x="479" y="1112"/>
                      <a:pt x="936" y="1069"/>
                    </a:cubicBezTo>
                    <a:cubicBezTo>
                      <a:pt x="1415" y="1025"/>
                      <a:pt x="1480" y="481"/>
                      <a:pt x="1480" y="481"/>
                    </a:cubicBezTo>
                    <a:cubicBezTo>
                      <a:pt x="1480" y="481"/>
                      <a:pt x="1824" y="0"/>
                      <a:pt x="1258" y="0"/>
                    </a:cubicBezTo>
                    <a:close/>
                  </a:path>
                </a:pathLst>
              </a:custGeom>
              <a:solidFill>
                <a:schemeClr val="accent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09" name="Google Shape;409;p17"/>
              <p:cNvSpPr/>
              <p:nvPr/>
            </p:nvSpPr>
            <p:spPr>
              <a:xfrm>
                <a:off x="-1246279" y="2849441"/>
                <a:ext cx="474726" cy="631784"/>
              </a:xfrm>
              <a:custGeom>
                <a:avLst/>
                <a:gdLst/>
                <a:ahLst/>
                <a:cxnLst/>
                <a:rect l="l" t="t" r="r" b="b"/>
                <a:pathLst>
                  <a:path w="5984" h="7964" extrusionOk="0">
                    <a:moveTo>
                      <a:pt x="283" y="0"/>
                    </a:moveTo>
                    <a:cubicBezTo>
                      <a:pt x="44" y="827"/>
                      <a:pt x="0" y="1676"/>
                      <a:pt x="740" y="2307"/>
                    </a:cubicBezTo>
                    <a:cubicBezTo>
                      <a:pt x="957" y="2502"/>
                      <a:pt x="1175" y="4787"/>
                      <a:pt x="1175" y="5853"/>
                    </a:cubicBezTo>
                    <a:cubicBezTo>
                      <a:pt x="1175" y="6288"/>
                      <a:pt x="1066" y="6985"/>
                      <a:pt x="762" y="7811"/>
                    </a:cubicBezTo>
                    <a:cubicBezTo>
                      <a:pt x="1414" y="7811"/>
                      <a:pt x="1915" y="7898"/>
                      <a:pt x="2481" y="7964"/>
                    </a:cubicBezTo>
                    <a:cubicBezTo>
                      <a:pt x="2481" y="7964"/>
                      <a:pt x="2285" y="7202"/>
                      <a:pt x="2285" y="6789"/>
                    </a:cubicBezTo>
                    <a:cubicBezTo>
                      <a:pt x="2296" y="6007"/>
                      <a:pt x="3098" y="5907"/>
                      <a:pt x="3921" y="5907"/>
                    </a:cubicBezTo>
                    <a:cubicBezTo>
                      <a:pt x="4202" y="5907"/>
                      <a:pt x="4485" y="5919"/>
                      <a:pt x="4740" y="5919"/>
                    </a:cubicBezTo>
                    <a:cubicBezTo>
                      <a:pt x="5192" y="5919"/>
                      <a:pt x="5556" y="5882"/>
                      <a:pt x="5657" y="5679"/>
                    </a:cubicBezTo>
                    <a:cubicBezTo>
                      <a:pt x="5984" y="5026"/>
                      <a:pt x="4482" y="3438"/>
                      <a:pt x="4635" y="3220"/>
                    </a:cubicBezTo>
                    <a:cubicBezTo>
                      <a:pt x="4809" y="3003"/>
                      <a:pt x="4635" y="2720"/>
                      <a:pt x="4373" y="2589"/>
                    </a:cubicBezTo>
                    <a:cubicBezTo>
                      <a:pt x="4091" y="2481"/>
                      <a:pt x="3503" y="2524"/>
                      <a:pt x="2089" y="2459"/>
                    </a:cubicBezTo>
                    <a:cubicBezTo>
                      <a:pt x="696" y="2372"/>
                      <a:pt x="501" y="1676"/>
                      <a:pt x="283" y="1371"/>
                    </a:cubicBezTo>
                    <a:cubicBezTo>
                      <a:pt x="87" y="1066"/>
                      <a:pt x="283" y="66"/>
                      <a:pt x="283" y="0"/>
                    </a:cubicBezTo>
                    <a:close/>
                  </a:path>
                </a:pathLst>
              </a:custGeom>
              <a:solidFill>
                <a:srgbClr val="191919">
                  <a:alpha val="1761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10" name="Google Shape;410;p17"/>
              <p:cNvSpPr/>
              <p:nvPr/>
            </p:nvSpPr>
            <p:spPr>
              <a:xfrm>
                <a:off x="-1059933" y="2711328"/>
                <a:ext cx="60531" cy="34588"/>
              </a:xfrm>
              <a:custGeom>
                <a:avLst/>
                <a:gdLst/>
                <a:ahLst/>
                <a:cxnLst/>
                <a:rect l="l" t="t" r="r" b="b"/>
                <a:pathLst>
                  <a:path w="763" h="436" extrusionOk="0">
                    <a:moveTo>
                      <a:pt x="610" y="1"/>
                    </a:moveTo>
                    <a:lnTo>
                      <a:pt x="1" y="109"/>
                    </a:lnTo>
                    <a:lnTo>
                      <a:pt x="762" y="436"/>
                    </a:lnTo>
                    <a:lnTo>
                      <a:pt x="610" y="1"/>
                    </a:lnTo>
                    <a:close/>
                  </a:path>
                </a:pathLst>
              </a:custGeom>
              <a:solidFill>
                <a:schemeClr val="l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11" name="Google Shape;411;p17"/>
              <p:cNvSpPr/>
              <p:nvPr/>
            </p:nvSpPr>
            <p:spPr>
              <a:xfrm>
                <a:off x="-999484" y="2711328"/>
                <a:ext cx="48393" cy="34588"/>
              </a:xfrm>
              <a:custGeom>
                <a:avLst/>
                <a:gdLst/>
                <a:ahLst/>
                <a:cxnLst/>
                <a:rect l="l" t="t" r="r" b="b"/>
                <a:pathLst>
                  <a:path w="610" h="436" extrusionOk="0">
                    <a:moveTo>
                      <a:pt x="153" y="1"/>
                    </a:moveTo>
                    <a:lnTo>
                      <a:pt x="0" y="436"/>
                    </a:lnTo>
                    <a:lnTo>
                      <a:pt x="610" y="218"/>
                    </a:lnTo>
                    <a:lnTo>
                      <a:pt x="153" y="1"/>
                    </a:lnTo>
                    <a:close/>
                  </a:path>
                </a:pathLst>
              </a:custGeom>
              <a:solidFill>
                <a:schemeClr val="l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12" name="Google Shape;412;p17"/>
              <p:cNvSpPr/>
              <p:nvPr/>
            </p:nvSpPr>
            <p:spPr>
              <a:xfrm>
                <a:off x="-1235966" y="3469086"/>
                <a:ext cx="576589" cy="785446"/>
              </a:xfrm>
              <a:custGeom>
                <a:avLst/>
                <a:gdLst/>
                <a:ahLst/>
                <a:cxnLst/>
                <a:rect l="l" t="t" r="r" b="b"/>
                <a:pathLst>
                  <a:path w="7268" h="9901" extrusionOk="0">
                    <a:moveTo>
                      <a:pt x="632" y="0"/>
                    </a:moveTo>
                    <a:cubicBezTo>
                      <a:pt x="632" y="0"/>
                      <a:pt x="175" y="762"/>
                      <a:pt x="88" y="2111"/>
                    </a:cubicBezTo>
                    <a:cubicBezTo>
                      <a:pt x="1" y="3482"/>
                      <a:pt x="980" y="9748"/>
                      <a:pt x="980" y="9748"/>
                    </a:cubicBezTo>
                    <a:lnTo>
                      <a:pt x="3678" y="9900"/>
                    </a:lnTo>
                    <a:lnTo>
                      <a:pt x="7268" y="9618"/>
                    </a:lnTo>
                    <a:cubicBezTo>
                      <a:pt x="7268" y="9618"/>
                      <a:pt x="7181" y="3895"/>
                      <a:pt x="7029" y="2176"/>
                    </a:cubicBezTo>
                    <a:cubicBezTo>
                      <a:pt x="6854" y="479"/>
                      <a:pt x="6376" y="44"/>
                      <a:pt x="6376" y="44"/>
                    </a:cubicBezTo>
                    <a:lnTo>
                      <a:pt x="3112" y="174"/>
                    </a:lnTo>
                    <a:lnTo>
                      <a:pt x="632" y="0"/>
                    </a:lnTo>
                    <a:close/>
                  </a:path>
                </a:pathLst>
              </a:custGeom>
              <a:solidFill>
                <a:schemeClr val="accent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13" name="Google Shape;413;p17"/>
              <p:cNvSpPr/>
              <p:nvPr/>
            </p:nvSpPr>
            <p:spPr>
              <a:xfrm>
                <a:off x="-987426" y="2652624"/>
                <a:ext cx="157158" cy="117488"/>
              </a:xfrm>
              <a:custGeom>
                <a:avLst/>
                <a:gdLst/>
                <a:ahLst/>
                <a:cxnLst/>
                <a:rect l="l" t="t" r="r" b="b"/>
                <a:pathLst>
                  <a:path w="1981" h="1481" extrusionOk="0">
                    <a:moveTo>
                      <a:pt x="1437" y="1"/>
                    </a:moveTo>
                    <a:lnTo>
                      <a:pt x="1" y="741"/>
                    </a:lnTo>
                    <a:lnTo>
                      <a:pt x="501" y="1480"/>
                    </a:lnTo>
                    <a:lnTo>
                      <a:pt x="1981" y="697"/>
                    </a:lnTo>
                    <a:lnTo>
                      <a:pt x="1437" y="1"/>
                    </a:lnTo>
                    <a:close/>
                  </a:path>
                </a:pathLst>
              </a:custGeom>
              <a:solidFill>
                <a:schemeClr val="accent6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14" name="Google Shape;414;p17"/>
              <p:cNvSpPr/>
              <p:nvPr/>
            </p:nvSpPr>
            <p:spPr>
              <a:xfrm>
                <a:off x="-1123794" y="2661271"/>
                <a:ext cx="112335" cy="103684"/>
              </a:xfrm>
              <a:custGeom>
                <a:avLst/>
                <a:gdLst/>
                <a:ahLst/>
                <a:cxnLst/>
                <a:rect l="l" t="t" r="r" b="b"/>
                <a:pathLst>
                  <a:path w="1416" h="1307" extrusionOk="0">
                    <a:moveTo>
                      <a:pt x="654" y="1"/>
                    </a:moveTo>
                    <a:lnTo>
                      <a:pt x="1" y="588"/>
                    </a:lnTo>
                    <a:lnTo>
                      <a:pt x="871" y="1306"/>
                    </a:lnTo>
                    <a:lnTo>
                      <a:pt x="1415" y="632"/>
                    </a:lnTo>
                    <a:lnTo>
                      <a:pt x="654" y="1"/>
                    </a:lnTo>
                    <a:close/>
                  </a:path>
                </a:pathLst>
              </a:custGeom>
              <a:solidFill>
                <a:schemeClr val="accent6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15" name="Google Shape;415;p17"/>
              <p:cNvSpPr/>
              <p:nvPr/>
            </p:nvSpPr>
            <p:spPr>
              <a:xfrm>
                <a:off x="-1235966" y="3469086"/>
                <a:ext cx="338432" cy="785446"/>
              </a:xfrm>
              <a:custGeom>
                <a:avLst/>
                <a:gdLst/>
                <a:ahLst/>
                <a:cxnLst/>
                <a:rect l="l" t="t" r="r" b="b"/>
                <a:pathLst>
                  <a:path w="4266" h="9901" extrusionOk="0">
                    <a:moveTo>
                      <a:pt x="632" y="0"/>
                    </a:moveTo>
                    <a:cubicBezTo>
                      <a:pt x="632" y="0"/>
                      <a:pt x="175" y="762"/>
                      <a:pt x="88" y="2111"/>
                    </a:cubicBezTo>
                    <a:cubicBezTo>
                      <a:pt x="1" y="3482"/>
                      <a:pt x="980" y="9748"/>
                      <a:pt x="980" y="9748"/>
                    </a:cubicBezTo>
                    <a:lnTo>
                      <a:pt x="3678" y="9900"/>
                    </a:lnTo>
                    <a:lnTo>
                      <a:pt x="4265" y="9879"/>
                    </a:lnTo>
                    <a:cubicBezTo>
                      <a:pt x="4265" y="9879"/>
                      <a:pt x="3612" y="9748"/>
                      <a:pt x="3525" y="9161"/>
                    </a:cubicBezTo>
                    <a:cubicBezTo>
                      <a:pt x="3337" y="8007"/>
                      <a:pt x="3148" y="5801"/>
                      <a:pt x="2978" y="5801"/>
                    </a:cubicBezTo>
                    <a:cubicBezTo>
                      <a:pt x="2972" y="5801"/>
                      <a:pt x="2966" y="5804"/>
                      <a:pt x="2960" y="5810"/>
                    </a:cubicBezTo>
                    <a:cubicBezTo>
                      <a:pt x="2786" y="6027"/>
                      <a:pt x="2873" y="7746"/>
                      <a:pt x="2568" y="8073"/>
                    </a:cubicBezTo>
                    <a:cubicBezTo>
                      <a:pt x="2444" y="8224"/>
                      <a:pt x="2294" y="8302"/>
                      <a:pt x="2141" y="8302"/>
                    </a:cubicBezTo>
                    <a:cubicBezTo>
                      <a:pt x="1919" y="8302"/>
                      <a:pt x="1691" y="8137"/>
                      <a:pt x="1524" y="7790"/>
                    </a:cubicBezTo>
                    <a:cubicBezTo>
                      <a:pt x="1263" y="7181"/>
                      <a:pt x="566" y="2938"/>
                      <a:pt x="1132" y="1436"/>
                    </a:cubicBezTo>
                    <a:cubicBezTo>
                      <a:pt x="1524" y="392"/>
                      <a:pt x="2351" y="153"/>
                      <a:pt x="2351" y="153"/>
                    </a:cubicBezTo>
                    <a:lnTo>
                      <a:pt x="2242" y="131"/>
                    </a:lnTo>
                    <a:lnTo>
                      <a:pt x="632" y="0"/>
                    </a:lnTo>
                    <a:close/>
                  </a:path>
                </a:pathLst>
              </a:custGeom>
              <a:solidFill>
                <a:srgbClr val="191919">
                  <a:alpha val="1761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16" name="Google Shape;416;p17"/>
              <p:cNvSpPr/>
              <p:nvPr/>
            </p:nvSpPr>
            <p:spPr>
              <a:xfrm>
                <a:off x="-1027090" y="2734413"/>
                <a:ext cx="50138" cy="45853"/>
              </a:xfrm>
              <a:custGeom>
                <a:avLst/>
                <a:gdLst/>
                <a:ahLst/>
                <a:cxnLst/>
                <a:rect l="l" t="t" r="r" b="b"/>
                <a:pathLst>
                  <a:path w="632" h="578" extrusionOk="0">
                    <a:moveTo>
                      <a:pt x="329" y="0"/>
                    </a:moveTo>
                    <a:cubicBezTo>
                      <a:pt x="207" y="0"/>
                      <a:pt x="79" y="23"/>
                      <a:pt x="44" y="58"/>
                    </a:cubicBezTo>
                    <a:cubicBezTo>
                      <a:pt x="0" y="145"/>
                      <a:pt x="44" y="471"/>
                      <a:pt x="66" y="536"/>
                    </a:cubicBezTo>
                    <a:cubicBezTo>
                      <a:pt x="90" y="560"/>
                      <a:pt x="179" y="578"/>
                      <a:pt x="265" y="578"/>
                    </a:cubicBezTo>
                    <a:cubicBezTo>
                      <a:pt x="337" y="578"/>
                      <a:pt x="406" y="566"/>
                      <a:pt x="436" y="536"/>
                    </a:cubicBezTo>
                    <a:cubicBezTo>
                      <a:pt x="501" y="471"/>
                      <a:pt x="631" y="167"/>
                      <a:pt x="566" y="58"/>
                    </a:cubicBezTo>
                    <a:cubicBezTo>
                      <a:pt x="536" y="17"/>
                      <a:pt x="435" y="0"/>
                      <a:pt x="329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17" name="Google Shape;417;p17"/>
              <p:cNvSpPr/>
              <p:nvPr/>
            </p:nvSpPr>
            <p:spPr>
              <a:xfrm>
                <a:off x="-1087540" y="2776934"/>
                <a:ext cx="98531" cy="274482"/>
              </a:xfrm>
              <a:custGeom>
                <a:avLst/>
                <a:gdLst/>
                <a:ahLst/>
                <a:cxnLst/>
                <a:rect l="l" t="t" r="r" b="b"/>
                <a:pathLst>
                  <a:path w="1242" h="3460" extrusionOk="0">
                    <a:moveTo>
                      <a:pt x="828" y="0"/>
                    </a:moveTo>
                    <a:lnTo>
                      <a:pt x="1" y="2350"/>
                    </a:lnTo>
                    <a:lnTo>
                      <a:pt x="501" y="3460"/>
                    </a:lnTo>
                    <a:lnTo>
                      <a:pt x="1241" y="2481"/>
                    </a:lnTo>
                    <a:lnTo>
                      <a:pt x="1198" y="0"/>
                    </a:ln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18" name="Google Shape;418;p17"/>
              <p:cNvSpPr/>
              <p:nvPr/>
            </p:nvSpPr>
            <p:spPr>
              <a:xfrm>
                <a:off x="-845901" y="2739887"/>
                <a:ext cx="171041" cy="541269"/>
              </a:xfrm>
              <a:custGeom>
                <a:avLst/>
                <a:gdLst/>
                <a:ahLst/>
                <a:cxnLst/>
                <a:rect l="l" t="t" r="r" b="b"/>
                <a:pathLst>
                  <a:path w="2156" h="6823" extrusionOk="0">
                    <a:moveTo>
                      <a:pt x="1243" y="0"/>
                    </a:moveTo>
                    <a:cubicBezTo>
                      <a:pt x="225" y="0"/>
                      <a:pt x="67" y="1509"/>
                      <a:pt x="88" y="3296"/>
                    </a:cubicBezTo>
                    <a:cubicBezTo>
                      <a:pt x="110" y="5668"/>
                      <a:pt x="1" y="6799"/>
                      <a:pt x="893" y="6821"/>
                    </a:cubicBezTo>
                    <a:cubicBezTo>
                      <a:pt x="914" y="6822"/>
                      <a:pt x="935" y="6822"/>
                      <a:pt x="955" y="6822"/>
                    </a:cubicBezTo>
                    <a:cubicBezTo>
                      <a:pt x="1858" y="6822"/>
                      <a:pt x="1554" y="5848"/>
                      <a:pt x="1937" y="3165"/>
                    </a:cubicBezTo>
                    <a:cubicBezTo>
                      <a:pt x="2155" y="1599"/>
                      <a:pt x="1937" y="76"/>
                      <a:pt x="1393" y="11"/>
                    </a:cubicBezTo>
                    <a:cubicBezTo>
                      <a:pt x="1341" y="4"/>
                      <a:pt x="1291" y="0"/>
                      <a:pt x="1243" y="0"/>
                    </a:cubicBezTo>
                    <a:close/>
                  </a:path>
                </a:pathLst>
              </a:custGeom>
              <a:solidFill>
                <a:schemeClr val="dk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19" name="Google Shape;419;p17"/>
              <p:cNvSpPr/>
              <p:nvPr/>
            </p:nvSpPr>
            <p:spPr>
              <a:xfrm>
                <a:off x="-1217006" y="2835638"/>
                <a:ext cx="333276" cy="440202"/>
              </a:xfrm>
              <a:custGeom>
                <a:avLst/>
                <a:gdLst/>
                <a:ahLst/>
                <a:cxnLst/>
                <a:rect l="l" t="t" r="r" b="b"/>
                <a:pathLst>
                  <a:path w="4201" h="5549" extrusionOk="0">
                    <a:moveTo>
                      <a:pt x="4113" y="0"/>
                    </a:moveTo>
                    <a:lnTo>
                      <a:pt x="1" y="65"/>
                    </a:lnTo>
                    <a:lnTo>
                      <a:pt x="88" y="5549"/>
                    </a:lnTo>
                    <a:lnTo>
                      <a:pt x="4200" y="5483"/>
                    </a:lnTo>
                    <a:lnTo>
                      <a:pt x="4113" y="0"/>
                    </a:ln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20" name="Google Shape;420;p17"/>
              <p:cNvSpPr/>
              <p:nvPr/>
            </p:nvSpPr>
            <p:spPr>
              <a:xfrm>
                <a:off x="-1217006" y="2840794"/>
                <a:ext cx="333276" cy="435046"/>
              </a:xfrm>
              <a:custGeom>
                <a:avLst/>
                <a:gdLst/>
                <a:ahLst/>
                <a:cxnLst/>
                <a:rect l="l" t="t" r="r" b="b"/>
                <a:pathLst>
                  <a:path w="4201" h="5484" extrusionOk="0">
                    <a:moveTo>
                      <a:pt x="1" y="0"/>
                    </a:moveTo>
                    <a:lnTo>
                      <a:pt x="88" y="5484"/>
                    </a:lnTo>
                    <a:lnTo>
                      <a:pt x="4200" y="5418"/>
                    </a:lnTo>
                    <a:lnTo>
                      <a:pt x="4179" y="3917"/>
                    </a:lnTo>
                    <a:cubicBezTo>
                      <a:pt x="4179" y="3917"/>
                      <a:pt x="2351" y="3656"/>
                      <a:pt x="1633" y="2786"/>
                    </a:cubicBezTo>
                    <a:cubicBezTo>
                      <a:pt x="915" y="1915"/>
                      <a:pt x="675" y="22"/>
                      <a:pt x="675" y="22"/>
                    </a:cubicBezTo>
                    <a:lnTo>
                      <a:pt x="1" y="0"/>
                    </a:lnTo>
                    <a:close/>
                  </a:path>
                </a:pathLst>
              </a:custGeom>
              <a:solidFill>
                <a:srgbClr val="191919">
                  <a:alpha val="1761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21" name="Google Shape;421;p17"/>
              <p:cNvSpPr/>
              <p:nvPr/>
            </p:nvSpPr>
            <p:spPr>
              <a:xfrm>
                <a:off x="-1410254" y="3090286"/>
                <a:ext cx="485118" cy="145253"/>
              </a:xfrm>
              <a:custGeom>
                <a:avLst/>
                <a:gdLst/>
                <a:ahLst/>
                <a:cxnLst/>
                <a:rect l="l" t="t" r="r" b="b"/>
                <a:pathLst>
                  <a:path w="6115" h="1831" extrusionOk="0">
                    <a:moveTo>
                      <a:pt x="4965" y="0"/>
                    </a:moveTo>
                    <a:cubicBezTo>
                      <a:pt x="4233" y="0"/>
                      <a:pt x="3221" y="116"/>
                      <a:pt x="2306" y="141"/>
                    </a:cubicBezTo>
                    <a:cubicBezTo>
                      <a:pt x="696" y="184"/>
                      <a:pt x="0" y="446"/>
                      <a:pt x="218" y="1359"/>
                    </a:cubicBezTo>
                    <a:cubicBezTo>
                      <a:pt x="288" y="1640"/>
                      <a:pt x="630" y="1831"/>
                      <a:pt x="1215" y="1831"/>
                    </a:cubicBezTo>
                    <a:cubicBezTo>
                      <a:pt x="1537" y="1831"/>
                      <a:pt x="1931" y="1773"/>
                      <a:pt x="2393" y="1642"/>
                    </a:cubicBezTo>
                    <a:cubicBezTo>
                      <a:pt x="3917" y="1229"/>
                      <a:pt x="6114" y="663"/>
                      <a:pt x="5984" y="293"/>
                    </a:cubicBezTo>
                    <a:cubicBezTo>
                      <a:pt x="5918" y="68"/>
                      <a:pt x="5523" y="0"/>
                      <a:pt x="4965" y="0"/>
                    </a:cubicBezTo>
                    <a:close/>
                  </a:path>
                </a:pathLst>
              </a:custGeom>
              <a:solidFill>
                <a:srgbClr val="E9CAB7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22" name="Google Shape;422;p17"/>
              <p:cNvSpPr/>
              <p:nvPr/>
            </p:nvSpPr>
            <p:spPr>
              <a:xfrm>
                <a:off x="-937368" y="3125588"/>
                <a:ext cx="63942" cy="22530"/>
              </a:xfrm>
              <a:custGeom>
                <a:avLst/>
                <a:gdLst/>
                <a:ahLst/>
                <a:cxnLst/>
                <a:rect l="l" t="t" r="r" b="b"/>
                <a:pathLst>
                  <a:path w="806" h="284" extrusionOk="0">
                    <a:moveTo>
                      <a:pt x="131" y="1"/>
                    </a:moveTo>
                    <a:cubicBezTo>
                      <a:pt x="44" y="1"/>
                      <a:pt x="1" y="66"/>
                      <a:pt x="1" y="131"/>
                    </a:cubicBezTo>
                    <a:cubicBezTo>
                      <a:pt x="1" y="218"/>
                      <a:pt x="44" y="262"/>
                      <a:pt x="110" y="262"/>
                    </a:cubicBezTo>
                    <a:lnTo>
                      <a:pt x="675" y="283"/>
                    </a:lnTo>
                    <a:cubicBezTo>
                      <a:pt x="741" y="283"/>
                      <a:pt x="806" y="218"/>
                      <a:pt x="806" y="153"/>
                    </a:cubicBezTo>
                    <a:cubicBezTo>
                      <a:pt x="806" y="88"/>
                      <a:pt x="741" y="22"/>
                      <a:pt x="675" y="22"/>
                    </a:cubicBezTo>
                    <a:lnTo>
                      <a:pt x="131" y="1"/>
                    </a:lnTo>
                    <a:close/>
                  </a:path>
                </a:pathLst>
              </a:custGeom>
              <a:solidFill>
                <a:srgbClr val="FFA47C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23" name="Google Shape;423;p17"/>
              <p:cNvSpPr/>
              <p:nvPr/>
            </p:nvSpPr>
            <p:spPr>
              <a:xfrm>
                <a:off x="-935623" y="3106628"/>
                <a:ext cx="63942" cy="22530"/>
              </a:xfrm>
              <a:custGeom>
                <a:avLst/>
                <a:gdLst/>
                <a:ahLst/>
                <a:cxnLst/>
                <a:rect l="l" t="t" r="r" b="b"/>
                <a:pathLst>
                  <a:path w="806" h="284" extrusionOk="0">
                    <a:moveTo>
                      <a:pt x="131" y="0"/>
                    </a:moveTo>
                    <a:cubicBezTo>
                      <a:pt x="66" y="0"/>
                      <a:pt x="1" y="66"/>
                      <a:pt x="1" y="131"/>
                    </a:cubicBezTo>
                    <a:cubicBezTo>
                      <a:pt x="1" y="218"/>
                      <a:pt x="44" y="261"/>
                      <a:pt x="131" y="261"/>
                    </a:cubicBezTo>
                    <a:lnTo>
                      <a:pt x="675" y="283"/>
                    </a:lnTo>
                    <a:cubicBezTo>
                      <a:pt x="740" y="283"/>
                      <a:pt x="806" y="218"/>
                      <a:pt x="806" y="153"/>
                    </a:cubicBezTo>
                    <a:cubicBezTo>
                      <a:pt x="806" y="87"/>
                      <a:pt x="740" y="22"/>
                      <a:pt x="675" y="22"/>
                    </a:cubicBezTo>
                    <a:lnTo>
                      <a:pt x="131" y="0"/>
                    </a:lnTo>
                    <a:close/>
                  </a:path>
                </a:pathLst>
              </a:custGeom>
              <a:solidFill>
                <a:srgbClr val="E9CAB7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24" name="Google Shape;424;p17"/>
              <p:cNvSpPr/>
              <p:nvPr/>
            </p:nvSpPr>
            <p:spPr>
              <a:xfrm>
                <a:off x="-935623" y="3089334"/>
                <a:ext cx="63942" cy="20784"/>
              </a:xfrm>
              <a:custGeom>
                <a:avLst/>
                <a:gdLst/>
                <a:ahLst/>
                <a:cxnLst/>
                <a:rect l="l" t="t" r="r" b="b"/>
                <a:pathLst>
                  <a:path w="806" h="262" extrusionOk="0">
                    <a:moveTo>
                      <a:pt x="131" y="1"/>
                    </a:moveTo>
                    <a:cubicBezTo>
                      <a:pt x="66" y="1"/>
                      <a:pt x="1" y="44"/>
                      <a:pt x="1" y="131"/>
                    </a:cubicBezTo>
                    <a:cubicBezTo>
                      <a:pt x="1" y="196"/>
                      <a:pt x="66" y="240"/>
                      <a:pt x="131" y="240"/>
                    </a:cubicBezTo>
                    <a:lnTo>
                      <a:pt x="675" y="262"/>
                    </a:lnTo>
                    <a:cubicBezTo>
                      <a:pt x="762" y="262"/>
                      <a:pt x="806" y="196"/>
                      <a:pt x="806" y="131"/>
                    </a:cubicBezTo>
                    <a:cubicBezTo>
                      <a:pt x="806" y="66"/>
                      <a:pt x="762" y="1"/>
                      <a:pt x="697" y="1"/>
                    </a:cubicBezTo>
                    <a:close/>
                  </a:path>
                </a:pathLst>
              </a:custGeom>
              <a:solidFill>
                <a:srgbClr val="E9CAB7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25" name="Google Shape;425;p17"/>
              <p:cNvSpPr/>
              <p:nvPr/>
            </p:nvSpPr>
            <p:spPr>
              <a:xfrm>
                <a:off x="-935623" y="3070374"/>
                <a:ext cx="63942" cy="20784"/>
              </a:xfrm>
              <a:custGeom>
                <a:avLst/>
                <a:gdLst/>
                <a:ahLst/>
                <a:cxnLst/>
                <a:rect l="l" t="t" r="r" b="b"/>
                <a:pathLst>
                  <a:path w="806" h="262" extrusionOk="0">
                    <a:moveTo>
                      <a:pt x="131" y="0"/>
                    </a:moveTo>
                    <a:cubicBezTo>
                      <a:pt x="66" y="0"/>
                      <a:pt x="1" y="66"/>
                      <a:pt x="1" y="131"/>
                    </a:cubicBezTo>
                    <a:cubicBezTo>
                      <a:pt x="1" y="196"/>
                      <a:pt x="66" y="261"/>
                      <a:pt x="131" y="261"/>
                    </a:cubicBezTo>
                    <a:lnTo>
                      <a:pt x="675" y="261"/>
                    </a:lnTo>
                    <a:cubicBezTo>
                      <a:pt x="740" y="261"/>
                      <a:pt x="806" y="218"/>
                      <a:pt x="806" y="153"/>
                    </a:cubicBezTo>
                    <a:cubicBezTo>
                      <a:pt x="806" y="66"/>
                      <a:pt x="740" y="22"/>
                      <a:pt x="675" y="22"/>
                    </a:cubicBezTo>
                    <a:lnTo>
                      <a:pt x="131" y="0"/>
                    </a:lnTo>
                    <a:close/>
                  </a:path>
                </a:pathLst>
              </a:custGeom>
              <a:solidFill>
                <a:srgbClr val="E9CAB7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26" name="Google Shape;426;p17"/>
              <p:cNvSpPr/>
              <p:nvPr/>
            </p:nvSpPr>
            <p:spPr>
              <a:xfrm>
                <a:off x="-1025345" y="3063235"/>
                <a:ext cx="148510" cy="93689"/>
              </a:xfrm>
              <a:custGeom>
                <a:avLst/>
                <a:gdLst/>
                <a:ahLst/>
                <a:cxnLst/>
                <a:rect l="l" t="t" r="r" b="b"/>
                <a:pathLst>
                  <a:path w="1872" h="1181" extrusionOk="0">
                    <a:moveTo>
                      <a:pt x="1050" y="1"/>
                    </a:moveTo>
                    <a:cubicBezTo>
                      <a:pt x="1031" y="1"/>
                      <a:pt x="1014" y="2"/>
                      <a:pt x="1001" y="3"/>
                    </a:cubicBezTo>
                    <a:cubicBezTo>
                      <a:pt x="827" y="25"/>
                      <a:pt x="0" y="373"/>
                      <a:pt x="0" y="373"/>
                    </a:cubicBezTo>
                    <a:lnTo>
                      <a:pt x="370" y="1091"/>
                    </a:lnTo>
                    <a:cubicBezTo>
                      <a:pt x="370" y="1091"/>
                      <a:pt x="631" y="1156"/>
                      <a:pt x="914" y="1178"/>
                    </a:cubicBezTo>
                    <a:cubicBezTo>
                      <a:pt x="936" y="1180"/>
                      <a:pt x="959" y="1181"/>
                      <a:pt x="984" y="1181"/>
                    </a:cubicBezTo>
                    <a:cubicBezTo>
                      <a:pt x="1284" y="1181"/>
                      <a:pt x="1784" y="1069"/>
                      <a:pt x="1784" y="1069"/>
                    </a:cubicBezTo>
                    <a:cubicBezTo>
                      <a:pt x="1784" y="1069"/>
                      <a:pt x="1697" y="656"/>
                      <a:pt x="1675" y="504"/>
                    </a:cubicBezTo>
                    <a:cubicBezTo>
                      <a:pt x="1654" y="351"/>
                      <a:pt x="1871" y="112"/>
                      <a:pt x="1871" y="112"/>
                    </a:cubicBezTo>
                    <a:cubicBezTo>
                      <a:pt x="1871" y="112"/>
                      <a:pt x="1278" y="1"/>
                      <a:pt x="1050" y="1"/>
                    </a:cubicBezTo>
                    <a:close/>
                  </a:path>
                </a:pathLst>
              </a:custGeom>
              <a:solidFill>
                <a:srgbClr val="E9CAB7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27" name="Google Shape;427;p17"/>
              <p:cNvSpPr/>
              <p:nvPr/>
            </p:nvSpPr>
            <p:spPr>
              <a:xfrm>
                <a:off x="-1172106" y="3066249"/>
                <a:ext cx="461001" cy="219347"/>
              </a:xfrm>
              <a:custGeom>
                <a:avLst/>
                <a:gdLst/>
                <a:ahLst/>
                <a:cxnLst/>
                <a:rect l="l" t="t" r="r" b="b"/>
                <a:pathLst>
                  <a:path w="5811" h="2765" extrusionOk="0">
                    <a:moveTo>
                      <a:pt x="433" y="0"/>
                    </a:moveTo>
                    <a:cubicBezTo>
                      <a:pt x="246" y="0"/>
                      <a:pt x="129" y="35"/>
                      <a:pt x="109" y="118"/>
                    </a:cubicBezTo>
                    <a:cubicBezTo>
                      <a:pt x="1" y="640"/>
                      <a:pt x="1741" y="1293"/>
                      <a:pt x="3090" y="2054"/>
                    </a:cubicBezTo>
                    <a:cubicBezTo>
                      <a:pt x="3857" y="2487"/>
                      <a:pt x="4518" y="2765"/>
                      <a:pt x="4990" y="2765"/>
                    </a:cubicBezTo>
                    <a:cubicBezTo>
                      <a:pt x="5348" y="2765"/>
                      <a:pt x="5598" y="2604"/>
                      <a:pt x="5701" y="2228"/>
                    </a:cubicBezTo>
                    <a:cubicBezTo>
                      <a:pt x="5810" y="1815"/>
                      <a:pt x="4983" y="1075"/>
                      <a:pt x="3721" y="749"/>
                    </a:cubicBezTo>
                    <a:cubicBezTo>
                      <a:pt x="2588" y="427"/>
                      <a:pt x="1086" y="0"/>
                      <a:pt x="433" y="0"/>
                    </a:cubicBezTo>
                    <a:close/>
                  </a:path>
                </a:pathLst>
              </a:custGeom>
              <a:solidFill>
                <a:srgbClr val="FAD9C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28" name="Google Shape;428;p17"/>
              <p:cNvSpPr/>
              <p:nvPr/>
            </p:nvSpPr>
            <p:spPr>
              <a:xfrm>
                <a:off x="-1234221" y="3018572"/>
                <a:ext cx="146765" cy="107095"/>
              </a:xfrm>
              <a:custGeom>
                <a:avLst/>
                <a:gdLst/>
                <a:ahLst/>
                <a:cxnLst/>
                <a:rect l="l" t="t" r="r" b="b"/>
                <a:pathLst>
                  <a:path w="1850" h="1350" extrusionOk="0">
                    <a:moveTo>
                      <a:pt x="174" y="1"/>
                    </a:moveTo>
                    <a:cubicBezTo>
                      <a:pt x="174" y="1"/>
                      <a:pt x="327" y="283"/>
                      <a:pt x="261" y="436"/>
                    </a:cubicBezTo>
                    <a:cubicBezTo>
                      <a:pt x="196" y="566"/>
                      <a:pt x="0" y="936"/>
                      <a:pt x="0" y="936"/>
                    </a:cubicBezTo>
                    <a:cubicBezTo>
                      <a:pt x="0" y="936"/>
                      <a:pt x="501" y="1154"/>
                      <a:pt x="762" y="1241"/>
                    </a:cubicBezTo>
                    <a:cubicBezTo>
                      <a:pt x="1197" y="1350"/>
                      <a:pt x="1436" y="1350"/>
                      <a:pt x="1436" y="1350"/>
                    </a:cubicBezTo>
                    <a:lnTo>
                      <a:pt x="1850" y="675"/>
                    </a:lnTo>
                    <a:cubicBezTo>
                      <a:pt x="1850" y="675"/>
                      <a:pt x="1197" y="196"/>
                      <a:pt x="1045" y="131"/>
                    </a:cubicBezTo>
                    <a:cubicBezTo>
                      <a:pt x="871" y="66"/>
                      <a:pt x="175" y="1"/>
                      <a:pt x="174" y="1"/>
                    </a:cubicBezTo>
                    <a:close/>
                  </a:path>
                </a:pathLst>
              </a:custGeom>
              <a:solidFill>
                <a:srgbClr val="FAD9C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298532769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 7">
  <p:cSld name="Title only 7">
    <p:spTree>
      <p:nvGrpSpPr>
        <p:cNvPr id="1" name="Shape 4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5" name="Google Shape;445;p19"/>
          <p:cNvSpPr txBox="1">
            <a:spLocks noGrp="1"/>
          </p:cNvSpPr>
          <p:nvPr>
            <p:ph type="title"/>
          </p:nvPr>
        </p:nvSpPr>
        <p:spPr>
          <a:xfrm>
            <a:off x="720000" y="593367"/>
            <a:ext cx="7704000" cy="763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1pPr>
            <a:lvl2pPr lvl="1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9pPr>
          </a:lstStyle>
          <a:p>
            <a:endParaRPr/>
          </a:p>
        </p:txBody>
      </p:sp>
      <p:sp>
        <p:nvSpPr>
          <p:cNvPr id="446" name="Google Shape;446;p19"/>
          <p:cNvSpPr/>
          <p:nvPr/>
        </p:nvSpPr>
        <p:spPr>
          <a:xfrm>
            <a:off x="-25" y="6127167"/>
            <a:ext cx="9144017" cy="787955"/>
          </a:xfrm>
          <a:custGeom>
            <a:avLst/>
            <a:gdLst/>
            <a:ahLst/>
            <a:cxnLst/>
            <a:rect l="l" t="t" r="r" b="b"/>
            <a:pathLst>
              <a:path w="81572" h="31202" extrusionOk="0">
                <a:moveTo>
                  <a:pt x="0" y="0"/>
                </a:moveTo>
                <a:lnTo>
                  <a:pt x="0" y="31201"/>
                </a:lnTo>
                <a:lnTo>
                  <a:pt x="81572" y="31201"/>
                </a:lnTo>
                <a:lnTo>
                  <a:pt x="81572" y="0"/>
                </a:lnTo>
                <a:close/>
              </a:path>
            </a:pathLst>
          </a:custGeom>
          <a:solidFill>
            <a:schemeClr val="dk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/>
          </a:p>
        </p:txBody>
      </p:sp>
    </p:spTree>
    <p:extLst>
      <p:ext uri="{BB962C8B-B14F-4D97-AF65-F5344CB8AC3E}">
        <p14:creationId xmlns:p14="http://schemas.microsoft.com/office/powerpoint/2010/main" val="340308633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 8">
  <p:cSld name="Title only 8">
    <p:spTree>
      <p:nvGrpSpPr>
        <p:cNvPr id="1" name="Shape 44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8" name="Google Shape;448;p20"/>
          <p:cNvSpPr txBox="1">
            <a:spLocks noGrp="1"/>
          </p:cNvSpPr>
          <p:nvPr>
            <p:ph type="title"/>
          </p:nvPr>
        </p:nvSpPr>
        <p:spPr>
          <a:xfrm>
            <a:off x="720000" y="593367"/>
            <a:ext cx="7704000" cy="763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1pPr>
            <a:lvl2pPr lvl="1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9pPr>
          </a:lstStyle>
          <a:p>
            <a:endParaRPr/>
          </a:p>
        </p:txBody>
      </p:sp>
      <p:sp>
        <p:nvSpPr>
          <p:cNvPr id="449" name="Google Shape;449;p20"/>
          <p:cNvSpPr/>
          <p:nvPr/>
        </p:nvSpPr>
        <p:spPr>
          <a:xfrm>
            <a:off x="-25" y="6127167"/>
            <a:ext cx="9144017" cy="787955"/>
          </a:xfrm>
          <a:custGeom>
            <a:avLst/>
            <a:gdLst/>
            <a:ahLst/>
            <a:cxnLst/>
            <a:rect l="l" t="t" r="r" b="b"/>
            <a:pathLst>
              <a:path w="81572" h="31202" extrusionOk="0">
                <a:moveTo>
                  <a:pt x="0" y="0"/>
                </a:moveTo>
                <a:lnTo>
                  <a:pt x="0" y="31201"/>
                </a:lnTo>
                <a:lnTo>
                  <a:pt x="81572" y="31201"/>
                </a:lnTo>
                <a:lnTo>
                  <a:pt x="81572" y="0"/>
                </a:lnTo>
                <a:close/>
              </a:path>
            </a:pathLst>
          </a:custGeom>
          <a:solidFill>
            <a:schemeClr val="dk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/>
          </a:p>
        </p:txBody>
      </p:sp>
      <p:grpSp>
        <p:nvGrpSpPr>
          <p:cNvPr id="450" name="Google Shape;450;p20"/>
          <p:cNvGrpSpPr/>
          <p:nvPr/>
        </p:nvGrpSpPr>
        <p:grpSpPr>
          <a:xfrm flipH="1">
            <a:off x="8095771" y="5065654"/>
            <a:ext cx="1727956" cy="1965252"/>
            <a:chOff x="-678583" y="3799240"/>
            <a:chExt cx="1727956" cy="1473939"/>
          </a:xfrm>
        </p:grpSpPr>
        <p:sp>
          <p:nvSpPr>
            <p:cNvPr id="451" name="Google Shape;451;p20"/>
            <p:cNvSpPr/>
            <p:nvPr/>
          </p:nvSpPr>
          <p:spPr>
            <a:xfrm>
              <a:off x="-578183" y="4811475"/>
              <a:ext cx="1627556" cy="461704"/>
            </a:xfrm>
            <a:custGeom>
              <a:avLst/>
              <a:gdLst/>
              <a:ahLst/>
              <a:cxnLst/>
              <a:rect l="l" t="t" r="r" b="b"/>
              <a:pathLst>
                <a:path w="64014" h="9771" extrusionOk="0">
                  <a:moveTo>
                    <a:pt x="31876" y="1"/>
                  </a:moveTo>
                  <a:cubicBezTo>
                    <a:pt x="14187" y="1"/>
                    <a:pt x="1" y="2155"/>
                    <a:pt x="1" y="4875"/>
                  </a:cubicBezTo>
                  <a:cubicBezTo>
                    <a:pt x="1" y="7573"/>
                    <a:pt x="14339" y="9770"/>
                    <a:pt x="32007" y="9770"/>
                  </a:cubicBezTo>
                  <a:cubicBezTo>
                    <a:pt x="49674" y="9770"/>
                    <a:pt x="64013" y="7573"/>
                    <a:pt x="64013" y="4875"/>
                  </a:cubicBezTo>
                  <a:cubicBezTo>
                    <a:pt x="64013" y="2155"/>
                    <a:pt x="49544" y="1"/>
                    <a:pt x="31876" y="1"/>
                  </a:cubicBezTo>
                  <a:close/>
                </a:path>
              </a:pathLst>
            </a:custGeom>
            <a:solidFill>
              <a:srgbClr val="191919">
                <a:alpha val="17610"/>
              </a:srgb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grpSp>
          <p:nvGrpSpPr>
            <p:cNvPr id="452" name="Google Shape;452;p20"/>
            <p:cNvGrpSpPr/>
            <p:nvPr/>
          </p:nvGrpSpPr>
          <p:grpSpPr>
            <a:xfrm>
              <a:off x="-678583" y="3799240"/>
              <a:ext cx="1339803" cy="1344562"/>
              <a:chOff x="1788276" y="3614658"/>
              <a:chExt cx="1383523" cy="1388437"/>
            </a:xfrm>
          </p:grpSpPr>
          <p:sp>
            <p:nvSpPr>
              <p:cNvPr id="453" name="Google Shape;453;p20"/>
              <p:cNvSpPr/>
              <p:nvPr/>
            </p:nvSpPr>
            <p:spPr>
              <a:xfrm>
                <a:off x="1898398" y="3617934"/>
                <a:ext cx="90835" cy="1385161"/>
              </a:xfrm>
              <a:custGeom>
                <a:avLst/>
                <a:gdLst/>
                <a:ahLst/>
                <a:cxnLst/>
                <a:rect l="l" t="t" r="r" b="b"/>
                <a:pathLst>
                  <a:path w="1220" h="18604" extrusionOk="0">
                    <a:moveTo>
                      <a:pt x="1" y="0"/>
                    </a:moveTo>
                    <a:lnTo>
                      <a:pt x="1" y="18604"/>
                    </a:lnTo>
                    <a:lnTo>
                      <a:pt x="1219" y="18604"/>
                    </a:lnTo>
                    <a:lnTo>
                      <a:pt x="1219" y="0"/>
                    </a:lnTo>
                    <a:close/>
                  </a:path>
                </a:pathLst>
              </a:custGeom>
              <a:solidFill>
                <a:schemeClr val="accen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54" name="Google Shape;454;p20"/>
              <p:cNvSpPr/>
              <p:nvPr/>
            </p:nvSpPr>
            <p:spPr>
              <a:xfrm>
                <a:off x="2967667" y="3617934"/>
                <a:ext cx="90761" cy="1385161"/>
              </a:xfrm>
              <a:custGeom>
                <a:avLst/>
                <a:gdLst/>
                <a:ahLst/>
                <a:cxnLst/>
                <a:rect l="l" t="t" r="r" b="b"/>
                <a:pathLst>
                  <a:path w="1219" h="18604" extrusionOk="0">
                    <a:moveTo>
                      <a:pt x="0" y="0"/>
                    </a:moveTo>
                    <a:lnTo>
                      <a:pt x="0" y="18604"/>
                    </a:lnTo>
                    <a:lnTo>
                      <a:pt x="1218" y="18604"/>
                    </a:lnTo>
                    <a:lnTo>
                      <a:pt x="1218" y="0"/>
                    </a:lnTo>
                    <a:close/>
                  </a:path>
                </a:pathLst>
              </a:custGeom>
              <a:solidFill>
                <a:schemeClr val="accen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55" name="Google Shape;455;p20"/>
              <p:cNvSpPr/>
              <p:nvPr/>
            </p:nvSpPr>
            <p:spPr>
              <a:xfrm>
                <a:off x="1911353" y="3643845"/>
                <a:ext cx="1130823" cy="225226"/>
              </a:xfrm>
              <a:custGeom>
                <a:avLst/>
                <a:gdLst/>
                <a:ahLst/>
                <a:cxnLst/>
                <a:rect l="l" t="t" r="r" b="b"/>
                <a:pathLst>
                  <a:path w="15188" h="3025" extrusionOk="0">
                    <a:moveTo>
                      <a:pt x="1" y="0"/>
                    </a:moveTo>
                    <a:lnTo>
                      <a:pt x="1" y="3025"/>
                    </a:lnTo>
                    <a:lnTo>
                      <a:pt x="15188" y="3025"/>
                    </a:lnTo>
                    <a:lnTo>
                      <a:pt x="15188" y="0"/>
                    </a:lnTo>
                    <a:close/>
                  </a:path>
                </a:pathLst>
              </a:custGeom>
              <a:solidFill>
                <a:schemeClr val="accen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56" name="Google Shape;456;p20"/>
              <p:cNvSpPr/>
              <p:nvPr/>
            </p:nvSpPr>
            <p:spPr>
              <a:xfrm>
                <a:off x="1898398" y="3744286"/>
                <a:ext cx="1158371" cy="74604"/>
              </a:xfrm>
              <a:custGeom>
                <a:avLst/>
                <a:gdLst/>
                <a:ahLst/>
                <a:cxnLst/>
                <a:rect l="l" t="t" r="r" b="b"/>
                <a:pathLst>
                  <a:path w="15558" h="1002" extrusionOk="0">
                    <a:moveTo>
                      <a:pt x="1" y="0"/>
                    </a:moveTo>
                    <a:lnTo>
                      <a:pt x="1" y="1001"/>
                    </a:lnTo>
                    <a:lnTo>
                      <a:pt x="15558" y="697"/>
                    </a:lnTo>
                    <a:lnTo>
                      <a:pt x="15558" y="0"/>
                    </a:lnTo>
                    <a:close/>
                  </a:path>
                </a:pathLst>
              </a:custGeom>
              <a:solidFill>
                <a:srgbClr val="191919">
                  <a:alpha val="1761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57" name="Google Shape;457;p20"/>
              <p:cNvSpPr/>
              <p:nvPr/>
            </p:nvSpPr>
            <p:spPr>
              <a:xfrm>
                <a:off x="1788276" y="3614658"/>
                <a:ext cx="1383523" cy="131339"/>
              </a:xfrm>
              <a:custGeom>
                <a:avLst/>
                <a:gdLst/>
                <a:ahLst/>
                <a:cxnLst/>
                <a:rect l="l" t="t" r="r" b="b"/>
                <a:pathLst>
                  <a:path w="18582" h="1764" extrusionOk="0">
                    <a:moveTo>
                      <a:pt x="0" y="1"/>
                    </a:moveTo>
                    <a:lnTo>
                      <a:pt x="0" y="1763"/>
                    </a:lnTo>
                    <a:lnTo>
                      <a:pt x="18582" y="1763"/>
                    </a:lnTo>
                    <a:lnTo>
                      <a:pt x="18582" y="1"/>
                    </a:lnTo>
                    <a:close/>
                  </a:path>
                </a:pathLst>
              </a:custGeom>
              <a:solidFill>
                <a:schemeClr val="accen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58260177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ackground">
  <p:cSld name="Background">
    <p:spTree>
      <p:nvGrpSpPr>
        <p:cNvPr id="1" name="Shape 4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9" name="Google Shape;459;p21"/>
          <p:cNvSpPr/>
          <p:nvPr/>
        </p:nvSpPr>
        <p:spPr>
          <a:xfrm>
            <a:off x="-25" y="6127167"/>
            <a:ext cx="9144017" cy="787955"/>
          </a:xfrm>
          <a:custGeom>
            <a:avLst/>
            <a:gdLst/>
            <a:ahLst/>
            <a:cxnLst/>
            <a:rect l="l" t="t" r="r" b="b"/>
            <a:pathLst>
              <a:path w="81572" h="31202" extrusionOk="0">
                <a:moveTo>
                  <a:pt x="0" y="0"/>
                </a:moveTo>
                <a:lnTo>
                  <a:pt x="0" y="31201"/>
                </a:lnTo>
                <a:lnTo>
                  <a:pt x="81572" y="31201"/>
                </a:lnTo>
                <a:lnTo>
                  <a:pt x="81572" y="0"/>
                </a:lnTo>
                <a:close/>
              </a:path>
            </a:pathLst>
          </a:custGeom>
          <a:solidFill>
            <a:schemeClr val="dk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/>
          </a:p>
        </p:txBody>
      </p:sp>
      <p:grpSp>
        <p:nvGrpSpPr>
          <p:cNvPr id="460" name="Google Shape;460;p21"/>
          <p:cNvGrpSpPr/>
          <p:nvPr/>
        </p:nvGrpSpPr>
        <p:grpSpPr>
          <a:xfrm>
            <a:off x="-450521" y="4144134"/>
            <a:ext cx="1627556" cy="2886772"/>
            <a:chOff x="-450521" y="3108100"/>
            <a:chExt cx="1627556" cy="2165079"/>
          </a:xfrm>
        </p:grpSpPr>
        <p:sp>
          <p:nvSpPr>
            <p:cNvPr id="461" name="Google Shape;461;p21"/>
            <p:cNvSpPr/>
            <p:nvPr/>
          </p:nvSpPr>
          <p:spPr>
            <a:xfrm flipH="1">
              <a:off x="-450521" y="4811475"/>
              <a:ext cx="1627556" cy="461704"/>
            </a:xfrm>
            <a:custGeom>
              <a:avLst/>
              <a:gdLst/>
              <a:ahLst/>
              <a:cxnLst/>
              <a:rect l="l" t="t" r="r" b="b"/>
              <a:pathLst>
                <a:path w="64014" h="9771" extrusionOk="0">
                  <a:moveTo>
                    <a:pt x="31876" y="1"/>
                  </a:moveTo>
                  <a:cubicBezTo>
                    <a:pt x="14187" y="1"/>
                    <a:pt x="1" y="2155"/>
                    <a:pt x="1" y="4875"/>
                  </a:cubicBezTo>
                  <a:cubicBezTo>
                    <a:pt x="1" y="7573"/>
                    <a:pt x="14339" y="9770"/>
                    <a:pt x="32007" y="9770"/>
                  </a:cubicBezTo>
                  <a:cubicBezTo>
                    <a:pt x="49674" y="9770"/>
                    <a:pt x="64013" y="7573"/>
                    <a:pt x="64013" y="4875"/>
                  </a:cubicBezTo>
                  <a:cubicBezTo>
                    <a:pt x="64013" y="2155"/>
                    <a:pt x="49544" y="1"/>
                    <a:pt x="31876" y="1"/>
                  </a:cubicBezTo>
                  <a:close/>
                </a:path>
              </a:pathLst>
            </a:custGeom>
            <a:solidFill>
              <a:srgbClr val="191919">
                <a:alpha val="17610"/>
              </a:srgb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grpSp>
          <p:nvGrpSpPr>
            <p:cNvPr id="462" name="Google Shape;462;p21"/>
            <p:cNvGrpSpPr/>
            <p:nvPr/>
          </p:nvGrpSpPr>
          <p:grpSpPr>
            <a:xfrm>
              <a:off x="-305475" y="3108100"/>
              <a:ext cx="800061" cy="1894999"/>
              <a:chOff x="7131700" y="3058575"/>
              <a:chExt cx="800061" cy="1894999"/>
            </a:xfrm>
          </p:grpSpPr>
          <p:sp>
            <p:nvSpPr>
              <p:cNvPr id="463" name="Google Shape;463;p21"/>
              <p:cNvSpPr/>
              <p:nvPr/>
            </p:nvSpPr>
            <p:spPr>
              <a:xfrm>
                <a:off x="7385008" y="3940203"/>
                <a:ext cx="101721" cy="80042"/>
              </a:xfrm>
              <a:custGeom>
                <a:avLst/>
                <a:gdLst/>
                <a:ahLst/>
                <a:cxnLst/>
                <a:rect l="l" t="t" r="r" b="b"/>
                <a:pathLst>
                  <a:path w="1328" h="1045" extrusionOk="0">
                    <a:moveTo>
                      <a:pt x="0" y="0"/>
                    </a:moveTo>
                    <a:lnTo>
                      <a:pt x="0" y="1045"/>
                    </a:lnTo>
                    <a:lnTo>
                      <a:pt x="1328" y="1045"/>
                    </a:lnTo>
                    <a:lnTo>
                      <a:pt x="1328" y="0"/>
                    </a:lnTo>
                    <a:close/>
                  </a:path>
                </a:pathLst>
              </a:custGeom>
              <a:solidFill>
                <a:schemeClr val="accen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64" name="Google Shape;464;p21"/>
              <p:cNvSpPr/>
              <p:nvPr/>
            </p:nvSpPr>
            <p:spPr>
              <a:xfrm>
                <a:off x="7495003" y="4095158"/>
                <a:ext cx="101721" cy="716699"/>
              </a:xfrm>
              <a:custGeom>
                <a:avLst/>
                <a:gdLst/>
                <a:ahLst/>
                <a:cxnLst/>
                <a:rect l="l" t="t" r="r" b="b"/>
                <a:pathLst>
                  <a:path w="1328" h="9357" extrusionOk="0">
                    <a:moveTo>
                      <a:pt x="0" y="1"/>
                    </a:moveTo>
                    <a:lnTo>
                      <a:pt x="0" y="9357"/>
                    </a:lnTo>
                    <a:lnTo>
                      <a:pt x="1328" y="9357"/>
                    </a:lnTo>
                    <a:lnTo>
                      <a:pt x="1328" y="1"/>
                    </a:lnTo>
                    <a:close/>
                  </a:path>
                </a:pathLst>
              </a:custGeom>
              <a:solidFill>
                <a:schemeClr val="accen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65" name="Google Shape;465;p21"/>
              <p:cNvSpPr/>
              <p:nvPr/>
            </p:nvSpPr>
            <p:spPr>
              <a:xfrm>
                <a:off x="7746626" y="4835158"/>
                <a:ext cx="116735" cy="118416"/>
              </a:xfrm>
              <a:custGeom>
                <a:avLst/>
                <a:gdLst/>
                <a:ahLst/>
                <a:cxnLst/>
                <a:rect l="l" t="t" r="r" b="b"/>
                <a:pathLst>
                  <a:path w="1524" h="1546" extrusionOk="0">
                    <a:moveTo>
                      <a:pt x="762" y="1"/>
                    </a:moveTo>
                    <a:cubicBezTo>
                      <a:pt x="327" y="1"/>
                      <a:pt x="1" y="349"/>
                      <a:pt x="1" y="784"/>
                    </a:cubicBezTo>
                    <a:cubicBezTo>
                      <a:pt x="1" y="1197"/>
                      <a:pt x="327" y="1545"/>
                      <a:pt x="762" y="1545"/>
                    </a:cubicBezTo>
                    <a:cubicBezTo>
                      <a:pt x="1176" y="1545"/>
                      <a:pt x="1524" y="1197"/>
                      <a:pt x="1524" y="784"/>
                    </a:cubicBezTo>
                    <a:cubicBezTo>
                      <a:pt x="1524" y="349"/>
                      <a:pt x="1176" y="1"/>
                      <a:pt x="762" y="1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66" name="Google Shape;466;p21"/>
              <p:cNvSpPr/>
              <p:nvPr/>
            </p:nvSpPr>
            <p:spPr>
              <a:xfrm>
                <a:off x="7215038" y="4835158"/>
                <a:ext cx="116735" cy="118416"/>
              </a:xfrm>
              <a:custGeom>
                <a:avLst/>
                <a:gdLst/>
                <a:ahLst/>
                <a:cxnLst/>
                <a:rect l="l" t="t" r="r" b="b"/>
                <a:pathLst>
                  <a:path w="1524" h="1546" extrusionOk="0">
                    <a:moveTo>
                      <a:pt x="762" y="1"/>
                    </a:moveTo>
                    <a:cubicBezTo>
                      <a:pt x="348" y="1"/>
                      <a:pt x="0" y="349"/>
                      <a:pt x="0" y="784"/>
                    </a:cubicBezTo>
                    <a:cubicBezTo>
                      <a:pt x="0" y="1197"/>
                      <a:pt x="348" y="1545"/>
                      <a:pt x="762" y="1545"/>
                    </a:cubicBezTo>
                    <a:cubicBezTo>
                      <a:pt x="1197" y="1545"/>
                      <a:pt x="1523" y="1197"/>
                      <a:pt x="1523" y="784"/>
                    </a:cubicBezTo>
                    <a:cubicBezTo>
                      <a:pt x="1523" y="349"/>
                      <a:pt x="1197" y="1"/>
                      <a:pt x="762" y="1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67" name="Google Shape;467;p21"/>
              <p:cNvSpPr/>
              <p:nvPr/>
            </p:nvSpPr>
            <p:spPr>
              <a:xfrm>
                <a:off x="7196655" y="4811796"/>
                <a:ext cx="698416" cy="48408"/>
              </a:xfrm>
              <a:custGeom>
                <a:avLst/>
                <a:gdLst/>
                <a:ahLst/>
                <a:cxnLst/>
                <a:rect l="l" t="t" r="r" b="b"/>
                <a:pathLst>
                  <a:path w="9118" h="632" extrusionOk="0">
                    <a:moveTo>
                      <a:pt x="632" y="1"/>
                    </a:moveTo>
                    <a:cubicBezTo>
                      <a:pt x="284" y="1"/>
                      <a:pt x="1" y="284"/>
                      <a:pt x="1" y="632"/>
                    </a:cubicBezTo>
                    <a:lnTo>
                      <a:pt x="9117" y="632"/>
                    </a:lnTo>
                    <a:cubicBezTo>
                      <a:pt x="9117" y="284"/>
                      <a:pt x="8834" y="1"/>
                      <a:pt x="8486" y="1"/>
                    </a:cubicBezTo>
                    <a:close/>
                  </a:path>
                </a:pathLst>
              </a:custGeom>
              <a:solidFill>
                <a:schemeClr val="accen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68" name="Google Shape;468;p21"/>
              <p:cNvSpPr/>
              <p:nvPr/>
            </p:nvSpPr>
            <p:spPr>
              <a:xfrm>
                <a:off x="7511624" y="4158503"/>
                <a:ext cx="25124" cy="653355"/>
              </a:xfrm>
              <a:custGeom>
                <a:avLst/>
                <a:gdLst/>
                <a:ahLst/>
                <a:cxnLst/>
                <a:rect l="l" t="t" r="r" b="b"/>
                <a:pathLst>
                  <a:path w="328" h="8530" extrusionOk="0">
                    <a:moveTo>
                      <a:pt x="1" y="1"/>
                    </a:moveTo>
                    <a:lnTo>
                      <a:pt x="1" y="8530"/>
                    </a:lnTo>
                    <a:lnTo>
                      <a:pt x="327" y="8530"/>
                    </a:lnTo>
                    <a:lnTo>
                      <a:pt x="327" y="1"/>
                    </a:lnTo>
                    <a:close/>
                  </a:path>
                </a:pathLst>
              </a:custGeom>
              <a:solidFill>
                <a:srgbClr val="191919">
                  <a:alpha val="1761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69" name="Google Shape;469;p21"/>
              <p:cNvSpPr/>
              <p:nvPr/>
            </p:nvSpPr>
            <p:spPr>
              <a:xfrm>
                <a:off x="7160041" y="4015191"/>
                <a:ext cx="771720" cy="145071"/>
              </a:xfrm>
              <a:custGeom>
                <a:avLst/>
                <a:gdLst/>
                <a:ahLst/>
                <a:cxnLst/>
                <a:rect l="l" t="t" r="r" b="b"/>
                <a:pathLst>
                  <a:path w="10075" h="1894" extrusionOk="0">
                    <a:moveTo>
                      <a:pt x="740" y="1"/>
                    </a:moveTo>
                    <a:cubicBezTo>
                      <a:pt x="326" y="1"/>
                      <a:pt x="0" y="327"/>
                      <a:pt x="0" y="740"/>
                    </a:cubicBezTo>
                    <a:lnTo>
                      <a:pt x="0" y="1154"/>
                    </a:lnTo>
                    <a:cubicBezTo>
                      <a:pt x="0" y="1567"/>
                      <a:pt x="326" y="1893"/>
                      <a:pt x="740" y="1893"/>
                    </a:cubicBezTo>
                    <a:lnTo>
                      <a:pt x="9334" y="1893"/>
                    </a:lnTo>
                    <a:cubicBezTo>
                      <a:pt x="9748" y="1893"/>
                      <a:pt x="10074" y="1567"/>
                      <a:pt x="10074" y="1154"/>
                    </a:cubicBezTo>
                    <a:lnTo>
                      <a:pt x="10074" y="740"/>
                    </a:lnTo>
                    <a:cubicBezTo>
                      <a:pt x="10074" y="327"/>
                      <a:pt x="9748" y="1"/>
                      <a:pt x="9334" y="1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70" name="Google Shape;470;p21"/>
              <p:cNvSpPr/>
              <p:nvPr/>
            </p:nvSpPr>
            <p:spPr>
              <a:xfrm>
                <a:off x="7131700" y="3058575"/>
                <a:ext cx="601673" cy="890034"/>
              </a:xfrm>
              <a:custGeom>
                <a:avLst/>
                <a:gdLst/>
                <a:ahLst/>
                <a:cxnLst/>
                <a:rect l="l" t="t" r="r" b="b"/>
                <a:pathLst>
                  <a:path w="7855" h="11620" extrusionOk="0">
                    <a:moveTo>
                      <a:pt x="3917" y="0"/>
                    </a:moveTo>
                    <a:cubicBezTo>
                      <a:pt x="1763" y="0"/>
                      <a:pt x="0" y="1785"/>
                      <a:pt x="0" y="3939"/>
                    </a:cubicBezTo>
                    <a:lnTo>
                      <a:pt x="0" y="9835"/>
                    </a:lnTo>
                    <a:cubicBezTo>
                      <a:pt x="0" y="10814"/>
                      <a:pt x="805" y="11619"/>
                      <a:pt x="1784" y="11619"/>
                    </a:cubicBezTo>
                    <a:lnTo>
                      <a:pt x="6071" y="11619"/>
                    </a:lnTo>
                    <a:cubicBezTo>
                      <a:pt x="7050" y="11619"/>
                      <a:pt x="7855" y="10814"/>
                      <a:pt x="7855" y="9835"/>
                    </a:cubicBezTo>
                    <a:lnTo>
                      <a:pt x="7855" y="3939"/>
                    </a:lnTo>
                    <a:cubicBezTo>
                      <a:pt x="7855" y="1785"/>
                      <a:pt x="6071" y="0"/>
                      <a:pt x="3917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71" name="Google Shape;471;p21"/>
              <p:cNvSpPr/>
              <p:nvPr/>
            </p:nvSpPr>
            <p:spPr>
              <a:xfrm>
                <a:off x="7238324" y="3111886"/>
                <a:ext cx="468394" cy="785022"/>
              </a:xfrm>
              <a:custGeom>
                <a:avLst/>
                <a:gdLst/>
                <a:ahLst/>
                <a:cxnLst/>
                <a:rect l="l" t="t" r="r" b="b"/>
                <a:pathLst>
                  <a:path w="6115" h="10249" extrusionOk="0">
                    <a:moveTo>
                      <a:pt x="3069" y="1"/>
                    </a:moveTo>
                    <a:cubicBezTo>
                      <a:pt x="1371" y="1"/>
                      <a:pt x="1" y="1371"/>
                      <a:pt x="1" y="3047"/>
                    </a:cubicBezTo>
                    <a:lnTo>
                      <a:pt x="1" y="8856"/>
                    </a:lnTo>
                    <a:cubicBezTo>
                      <a:pt x="1" y="9618"/>
                      <a:pt x="632" y="10249"/>
                      <a:pt x="1393" y="10249"/>
                    </a:cubicBezTo>
                    <a:lnTo>
                      <a:pt x="4722" y="10249"/>
                    </a:lnTo>
                    <a:cubicBezTo>
                      <a:pt x="5484" y="10249"/>
                      <a:pt x="6115" y="9618"/>
                      <a:pt x="6115" y="8856"/>
                    </a:cubicBezTo>
                    <a:lnTo>
                      <a:pt x="6115" y="3047"/>
                    </a:lnTo>
                    <a:cubicBezTo>
                      <a:pt x="6115" y="1371"/>
                      <a:pt x="4744" y="1"/>
                      <a:pt x="3069" y="1"/>
                    </a:cubicBezTo>
                    <a:close/>
                  </a:path>
                </a:pathLst>
              </a:custGeom>
              <a:solidFill>
                <a:srgbClr val="FFFFFF">
                  <a:alpha val="1824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447308353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ackground 1">
  <p:cSld name="Background 1">
    <p:spTree>
      <p:nvGrpSpPr>
        <p:cNvPr id="1" name="Shape 4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3" name="Google Shape;473;p22"/>
          <p:cNvSpPr/>
          <p:nvPr/>
        </p:nvSpPr>
        <p:spPr>
          <a:xfrm>
            <a:off x="-25" y="6127167"/>
            <a:ext cx="9144017" cy="787955"/>
          </a:xfrm>
          <a:custGeom>
            <a:avLst/>
            <a:gdLst/>
            <a:ahLst/>
            <a:cxnLst/>
            <a:rect l="l" t="t" r="r" b="b"/>
            <a:pathLst>
              <a:path w="81572" h="31202" extrusionOk="0">
                <a:moveTo>
                  <a:pt x="0" y="0"/>
                </a:moveTo>
                <a:lnTo>
                  <a:pt x="0" y="31201"/>
                </a:lnTo>
                <a:lnTo>
                  <a:pt x="81572" y="31201"/>
                </a:lnTo>
                <a:lnTo>
                  <a:pt x="81572" y="0"/>
                </a:lnTo>
                <a:close/>
              </a:path>
            </a:pathLst>
          </a:custGeom>
          <a:solidFill>
            <a:schemeClr val="dk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/>
          </a:p>
        </p:txBody>
      </p:sp>
      <p:grpSp>
        <p:nvGrpSpPr>
          <p:cNvPr id="474" name="Google Shape;474;p22"/>
          <p:cNvGrpSpPr/>
          <p:nvPr/>
        </p:nvGrpSpPr>
        <p:grpSpPr>
          <a:xfrm>
            <a:off x="-519608" y="2943374"/>
            <a:ext cx="10229768" cy="4087532"/>
            <a:chOff x="-519608" y="2207530"/>
            <a:chExt cx="10229768" cy="3065649"/>
          </a:xfrm>
        </p:grpSpPr>
        <p:sp>
          <p:nvSpPr>
            <p:cNvPr id="475" name="Google Shape;475;p22"/>
            <p:cNvSpPr/>
            <p:nvPr/>
          </p:nvSpPr>
          <p:spPr>
            <a:xfrm>
              <a:off x="8082604" y="4811475"/>
              <a:ext cx="1627556" cy="461704"/>
            </a:xfrm>
            <a:custGeom>
              <a:avLst/>
              <a:gdLst/>
              <a:ahLst/>
              <a:cxnLst/>
              <a:rect l="l" t="t" r="r" b="b"/>
              <a:pathLst>
                <a:path w="64014" h="9771" extrusionOk="0">
                  <a:moveTo>
                    <a:pt x="31876" y="1"/>
                  </a:moveTo>
                  <a:cubicBezTo>
                    <a:pt x="14187" y="1"/>
                    <a:pt x="1" y="2155"/>
                    <a:pt x="1" y="4875"/>
                  </a:cubicBezTo>
                  <a:cubicBezTo>
                    <a:pt x="1" y="7573"/>
                    <a:pt x="14339" y="9770"/>
                    <a:pt x="32007" y="9770"/>
                  </a:cubicBezTo>
                  <a:cubicBezTo>
                    <a:pt x="49674" y="9770"/>
                    <a:pt x="64013" y="7573"/>
                    <a:pt x="64013" y="4875"/>
                  </a:cubicBezTo>
                  <a:cubicBezTo>
                    <a:pt x="64013" y="2155"/>
                    <a:pt x="49544" y="1"/>
                    <a:pt x="31876" y="1"/>
                  </a:cubicBezTo>
                  <a:close/>
                </a:path>
              </a:pathLst>
            </a:custGeom>
            <a:solidFill>
              <a:srgbClr val="191919">
                <a:alpha val="17610"/>
              </a:srgb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grpSp>
          <p:nvGrpSpPr>
            <p:cNvPr id="476" name="Google Shape;476;p22"/>
            <p:cNvGrpSpPr/>
            <p:nvPr/>
          </p:nvGrpSpPr>
          <p:grpSpPr>
            <a:xfrm>
              <a:off x="8459568" y="2207530"/>
              <a:ext cx="873636" cy="2848835"/>
              <a:chOff x="9498975" y="3401300"/>
              <a:chExt cx="368825" cy="1202700"/>
            </a:xfrm>
          </p:grpSpPr>
          <p:sp>
            <p:nvSpPr>
              <p:cNvPr id="477" name="Google Shape;477;p22"/>
              <p:cNvSpPr/>
              <p:nvPr/>
            </p:nvSpPr>
            <p:spPr>
              <a:xfrm>
                <a:off x="9515825" y="4098100"/>
                <a:ext cx="31575" cy="38150"/>
              </a:xfrm>
              <a:custGeom>
                <a:avLst/>
                <a:gdLst/>
                <a:ahLst/>
                <a:cxnLst/>
                <a:rect l="l" t="t" r="r" b="b"/>
                <a:pathLst>
                  <a:path w="1263" h="1526" extrusionOk="0">
                    <a:moveTo>
                      <a:pt x="371" y="0"/>
                    </a:moveTo>
                    <a:cubicBezTo>
                      <a:pt x="371" y="0"/>
                      <a:pt x="1" y="152"/>
                      <a:pt x="23" y="305"/>
                    </a:cubicBezTo>
                    <a:cubicBezTo>
                      <a:pt x="45" y="435"/>
                      <a:pt x="327" y="805"/>
                      <a:pt x="436" y="958"/>
                    </a:cubicBezTo>
                    <a:cubicBezTo>
                      <a:pt x="545" y="1088"/>
                      <a:pt x="763" y="1306"/>
                      <a:pt x="871" y="1393"/>
                    </a:cubicBezTo>
                    <a:cubicBezTo>
                      <a:pt x="932" y="1454"/>
                      <a:pt x="1057" y="1525"/>
                      <a:pt x="1149" y="1525"/>
                    </a:cubicBezTo>
                    <a:cubicBezTo>
                      <a:pt x="1189" y="1525"/>
                      <a:pt x="1222" y="1512"/>
                      <a:pt x="1241" y="1480"/>
                    </a:cubicBezTo>
                    <a:cubicBezTo>
                      <a:pt x="1263" y="1436"/>
                      <a:pt x="1176" y="1197"/>
                      <a:pt x="1045" y="1088"/>
                    </a:cubicBezTo>
                    <a:cubicBezTo>
                      <a:pt x="937" y="979"/>
                      <a:pt x="763" y="849"/>
                      <a:pt x="675" y="718"/>
                    </a:cubicBezTo>
                    <a:cubicBezTo>
                      <a:pt x="567" y="588"/>
                      <a:pt x="371" y="0"/>
                      <a:pt x="371" y="0"/>
                    </a:cubicBezTo>
                    <a:close/>
                  </a:path>
                </a:pathLst>
              </a:custGeom>
              <a:solidFill>
                <a:srgbClr val="C09378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78" name="Google Shape;478;p22"/>
              <p:cNvSpPr/>
              <p:nvPr/>
            </p:nvSpPr>
            <p:spPr>
              <a:xfrm>
                <a:off x="9515300" y="4094275"/>
                <a:ext cx="37825" cy="25100"/>
              </a:xfrm>
              <a:custGeom>
                <a:avLst/>
                <a:gdLst/>
                <a:ahLst/>
                <a:cxnLst/>
                <a:rect l="l" t="t" r="r" b="b"/>
                <a:pathLst>
                  <a:path w="1513" h="1004" extrusionOk="0">
                    <a:moveTo>
                      <a:pt x="283" y="1"/>
                    </a:moveTo>
                    <a:cubicBezTo>
                      <a:pt x="283" y="1"/>
                      <a:pt x="0" y="240"/>
                      <a:pt x="66" y="349"/>
                    </a:cubicBezTo>
                    <a:cubicBezTo>
                      <a:pt x="109" y="458"/>
                      <a:pt x="457" y="719"/>
                      <a:pt x="588" y="828"/>
                    </a:cubicBezTo>
                    <a:cubicBezTo>
                      <a:pt x="740" y="915"/>
                      <a:pt x="1001" y="980"/>
                      <a:pt x="1153" y="1002"/>
                    </a:cubicBezTo>
                    <a:cubicBezTo>
                      <a:pt x="1186" y="1002"/>
                      <a:pt x="1225" y="1003"/>
                      <a:pt x="1266" y="1003"/>
                    </a:cubicBezTo>
                    <a:cubicBezTo>
                      <a:pt x="1386" y="1003"/>
                      <a:pt x="1512" y="991"/>
                      <a:pt x="1480" y="893"/>
                    </a:cubicBezTo>
                    <a:cubicBezTo>
                      <a:pt x="1458" y="762"/>
                      <a:pt x="1284" y="675"/>
                      <a:pt x="1132" y="654"/>
                    </a:cubicBezTo>
                    <a:cubicBezTo>
                      <a:pt x="958" y="610"/>
                      <a:pt x="871" y="632"/>
                      <a:pt x="740" y="545"/>
                    </a:cubicBezTo>
                    <a:cubicBezTo>
                      <a:pt x="631" y="458"/>
                      <a:pt x="283" y="1"/>
                      <a:pt x="283" y="1"/>
                    </a:cubicBezTo>
                    <a:close/>
                  </a:path>
                </a:pathLst>
              </a:custGeom>
              <a:solidFill>
                <a:srgbClr val="C09378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79" name="Google Shape;479;p22"/>
              <p:cNvSpPr/>
              <p:nvPr/>
            </p:nvSpPr>
            <p:spPr>
              <a:xfrm>
                <a:off x="9516925" y="4092100"/>
                <a:ext cx="34300" cy="17650"/>
              </a:xfrm>
              <a:custGeom>
                <a:avLst/>
                <a:gdLst/>
                <a:ahLst/>
                <a:cxnLst/>
                <a:rect l="l" t="t" r="r" b="b"/>
                <a:pathLst>
                  <a:path w="1372" h="706" extrusionOk="0">
                    <a:moveTo>
                      <a:pt x="218" y="1"/>
                    </a:moveTo>
                    <a:cubicBezTo>
                      <a:pt x="218" y="1"/>
                      <a:pt x="1" y="240"/>
                      <a:pt x="66" y="327"/>
                    </a:cubicBezTo>
                    <a:cubicBezTo>
                      <a:pt x="131" y="414"/>
                      <a:pt x="457" y="567"/>
                      <a:pt x="588" y="632"/>
                    </a:cubicBezTo>
                    <a:cubicBezTo>
                      <a:pt x="686" y="681"/>
                      <a:pt x="845" y="705"/>
                      <a:pt x="974" y="705"/>
                    </a:cubicBezTo>
                    <a:cubicBezTo>
                      <a:pt x="1016" y="705"/>
                      <a:pt x="1056" y="703"/>
                      <a:pt x="1088" y="697"/>
                    </a:cubicBezTo>
                    <a:cubicBezTo>
                      <a:pt x="1197" y="675"/>
                      <a:pt x="1371" y="675"/>
                      <a:pt x="1350" y="567"/>
                    </a:cubicBezTo>
                    <a:cubicBezTo>
                      <a:pt x="1306" y="458"/>
                      <a:pt x="1132" y="414"/>
                      <a:pt x="1001" y="414"/>
                    </a:cubicBezTo>
                    <a:cubicBezTo>
                      <a:pt x="925" y="414"/>
                      <a:pt x="871" y="420"/>
                      <a:pt x="822" y="420"/>
                    </a:cubicBezTo>
                    <a:cubicBezTo>
                      <a:pt x="773" y="420"/>
                      <a:pt x="729" y="414"/>
                      <a:pt x="675" y="392"/>
                    </a:cubicBezTo>
                    <a:cubicBezTo>
                      <a:pt x="566" y="327"/>
                      <a:pt x="218" y="1"/>
                      <a:pt x="218" y="1"/>
                    </a:cubicBezTo>
                    <a:close/>
                  </a:path>
                </a:pathLst>
              </a:custGeom>
              <a:solidFill>
                <a:srgbClr val="C09378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80" name="Google Shape;480;p22"/>
              <p:cNvSpPr/>
              <p:nvPr/>
            </p:nvSpPr>
            <p:spPr>
              <a:xfrm>
                <a:off x="9506050" y="4012700"/>
                <a:ext cx="59850" cy="136675"/>
              </a:xfrm>
              <a:custGeom>
                <a:avLst/>
                <a:gdLst/>
                <a:ahLst/>
                <a:cxnLst/>
                <a:rect l="l" t="t" r="r" b="b"/>
                <a:pathLst>
                  <a:path w="2394" h="5467" extrusionOk="0">
                    <a:moveTo>
                      <a:pt x="1567" y="0"/>
                    </a:moveTo>
                    <a:lnTo>
                      <a:pt x="283" y="218"/>
                    </a:lnTo>
                    <a:cubicBezTo>
                      <a:pt x="283" y="218"/>
                      <a:pt x="240" y="1980"/>
                      <a:pt x="283" y="2067"/>
                    </a:cubicBezTo>
                    <a:cubicBezTo>
                      <a:pt x="327" y="2132"/>
                      <a:pt x="0" y="3307"/>
                      <a:pt x="44" y="3547"/>
                    </a:cubicBezTo>
                    <a:cubicBezTo>
                      <a:pt x="87" y="3764"/>
                      <a:pt x="283" y="4526"/>
                      <a:pt x="327" y="4569"/>
                    </a:cubicBezTo>
                    <a:cubicBezTo>
                      <a:pt x="348" y="4613"/>
                      <a:pt x="762" y="5004"/>
                      <a:pt x="979" y="5135"/>
                    </a:cubicBezTo>
                    <a:cubicBezTo>
                      <a:pt x="1179" y="5255"/>
                      <a:pt x="1306" y="5467"/>
                      <a:pt x="1359" y="5467"/>
                    </a:cubicBezTo>
                    <a:cubicBezTo>
                      <a:pt x="1363" y="5467"/>
                      <a:pt x="1368" y="5465"/>
                      <a:pt x="1371" y="5461"/>
                    </a:cubicBezTo>
                    <a:cubicBezTo>
                      <a:pt x="1436" y="5418"/>
                      <a:pt x="1502" y="5374"/>
                      <a:pt x="1458" y="5244"/>
                    </a:cubicBezTo>
                    <a:cubicBezTo>
                      <a:pt x="1436" y="5113"/>
                      <a:pt x="1284" y="4961"/>
                      <a:pt x="1175" y="4830"/>
                    </a:cubicBezTo>
                    <a:cubicBezTo>
                      <a:pt x="1066" y="4700"/>
                      <a:pt x="805" y="4439"/>
                      <a:pt x="740" y="4286"/>
                    </a:cubicBezTo>
                    <a:cubicBezTo>
                      <a:pt x="675" y="4112"/>
                      <a:pt x="740" y="3743"/>
                      <a:pt x="762" y="3460"/>
                    </a:cubicBezTo>
                    <a:cubicBezTo>
                      <a:pt x="784" y="3286"/>
                      <a:pt x="1132" y="2894"/>
                      <a:pt x="1262" y="2872"/>
                    </a:cubicBezTo>
                    <a:cubicBezTo>
                      <a:pt x="1274" y="2869"/>
                      <a:pt x="1285" y="2867"/>
                      <a:pt x="1296" y="2867"/>
                    </a:cubicBezTo>
                    <a:cubicBezTo>
                      <a:pt x="1434" y="2867"/>
                      <a:pt x="1547" y="3103"/>
                      <a:pt x="1567" y="3264"/>
                    </a:cubicBezTo>
                    <a:cubicBezTo>
                      <a:pt x="1610" y="3460"/>
                      <a:pt x="1785" y="3786"/>
                      <a:pt x="1959" y="3895"/>
                    </a:cubicBezTo>
                    <a:cubicBezTo>
                      <a:pt x="2053" y="3949"/>
                      <a:pt x="2172" y="3986"/>
                      <a:pt x="2254" y="3986"/>
                    </a:cubicBezTo>
                    <a:cubicBezTo>
                      <a:pt x="2305" y="3986"/>
                      <a:pt x="2342" y="3972"/>
                      <a:pt x="2350" y="3938"/>
                    </a:cubicBezTo>
                    <a:cubicBezTo>
                      <a:pt x="2394" y="3808"/>
                      <a:pt x="2111" y="3525"/>
                      <a:pt x="2067" y="3177"/>
                    </a:cubicBezTo>
                    <a:cubicBezTo>
                      <a:pt x="2024" y="2981"/>
                      <a:pt x="2024" y="2437"/>
                      <a:pt x="1806" y="2111"/>
                    </a:cubicBezTo>
                    <a:cubicBezTo>
                      <a:pt x="1676" y="1915"/>
                      <a:pt x="1523" y="1697"/>
                      <a:pt x="1458" y="1501"/>
                    </a:cubicBezTo>
                    <a:cubicBezTo>
                      <a:pt x="1371" y="1306"/>
                      <a:pt x="1567" y="0"/>
                      <a:pt x="1567" y="0"/>
                    </a:cubicBezTo>
                    <a:close/>
                  </a:path>
                </a:pathLst>
              </a:custGeom>
              <a:solidFill>
                <a:srgbClr val="DAAA8E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81" name="Google Shape;481;p22"/>
              <p:cNvSpPr/>
              <p:nvPr/>
            </p:nvSpPr>
            <p:spPr>
              <a:xfrm>
                <a:off x="9498975" y="3614525"/>
                <a:ext cx="75625" cy="440625"/>
              </a:xfrm>
              <a:custGeom>
                <a:avLst/>
                <a:gdLst/>
                <a:ahLst/>
                <a:cxnLst/>
                <a:rect l="l" t="t" r="r" b="b"/>
                <a:pathLst>
                  <a:path w="3025" h="17625" extrusionOk="0">
                    <a:moveTo>
                      <a:pt x="1654" y="0"/>
                    </a:moveTo>
                    <a:cubicBezTo>
                      <a:pt x="1654" y="0"/>
                      <a:pt x="958" y="109"/>
                      <a:pt x="784" y="1023"/>
                    </a:cubicBezTo>
                    <a:cubicBezTo>
                      <a:pt x="240" y="3569"/>
                      <a:pt x="175" y="9052"/>
                      <a:pt x="109" y="9356"/>
                    </a:cubicBezTo>
                    <a:cubicBezTo>
                      <a:pt x="66" y="9683"/>
                      <a:pt x="0" y="11597"/>
                      <a:pt x="0" y="12315"/>
                    </a:cubicBezTo>
                    <a:cubicBezTo>
                      <a:pt x="22" y="13033"/>
                      <a:pt x="262" y="17494"/>
                      <a:pt x="262" y="17494"/>
                    </a:cubicBezTo>
                    <a:lnTo>
                      <a:pt x="2046" y="17624"/>
                    </a:lnTo>
                    <a:cubicBezTo>
                      <a:pt x="2046" y="17624"/>
                      <a:pt x="2742" y="14078"/>
                      <a:pt x="2851" y="13033"/>
                    </a:cubicBezTo>
                    <a:cubicBezTo>
                      <a:pt x="2960" y="11967"/>
                      <a:pt x="3025" y="6136"/>
                      <a:pt x="3025" y="6136"/>
                    </a:cubicBezTo>
                    <a:cubicBezTo>
                      <a:pt x="3025" y="6136"/>
                      <a:pt x="2285" y="348"/>
                      <a:pt x="1654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82" name="Google Shape;482;p22"/>
              <p:cNvSpPr/>
              <p:nvPr/>
            </p:nvSpPr>
            <p:spPr>
              <a:xfrm>
                <a:off x="9637675" y="3572100"/>
                <a:ext cx="94675" cy="33200"/>
              </a:xfrm>
              <a:custGeom>
                <a:avLst/>
                <a:gdLst/>
                <a:ahLst/>
                <a:cxnLst/>
                <a:rect l="l" t="t" r="r" b="b"/>
                <a:pathLst>
                  <a:path w="3787" h="1328" extrusionOk="0">
                    <a:moveTo>
                      <a:pt x="1" y="0"/>
                    </a:moveTo>
                    <a:lnTo>
                      <a:pt x="1" y="1327"/>
                    </a:lnTo>
                    <a:lnTo>
                      <a:pt x="3787" y="1327"/>
                    </a:lnTo>
                    <a:lnTo>
                      <a:pt x="3787" y="0"/>
                    </a:lnTo>
                    <a:close/>
                  </a:path>
                </a:pathLst>
              </a:custGeom>
              <a:solidFill>
                <a:schemeClr val="l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83" name="Google Shape;483;p22"/>
              <p:cNvSpPr/>
              <p:nvPr/>
            </p:nvSpPr>
            <p:spPr>
              <a:xfrm>
                <a:off x="9528350" y="3588950"/>
                <a:ext cx="313350" cy="454775"/>
              </a:xfrm>
              <a:custGeom>
                <a:avLst/>
                <a:gdLst/>
                <a:ahLst/>
                <a:cxnLst/>
                <a:rect l="l" t="t" r="r" b="b"/>
                <a:pathLst>
                  <a:path w="12534" h="18191" extrusionOk="0">
                    <a:moveTo>
                      <a:pt x="6289" y="1"/>
                    </a:moveTo>
                    <a:lnTo>
                      <a:pt x="6289" y="66"/>
                    </a:lnTo>
                    <a:cubicBezTo>
                      <a:pt x="6289" y="66"/>
                      <a:pt x="2372" y="392"/>
                      <a:pt x="1023" y="1197"/>
                    </a:cubicBezTo>
                    <a:cubicBezTo>
                      <a:pt x="0" y="1828"/>
                      <a:pt x="1785" y="5592"/>
                      <a:pt x="2459" y="7681"/>
                    </a:cubicBezTo>
                    <a:cubicBezTo>
                      <a:pt x="2633" y="8182"/>
                      <a:pt x="2611" y="10444"/>
                      <a:pt x="2546" y="12446"/>
                    </a:cubicBezTo>
                    <a:cubicBezTo>
                      <a:pt x="2524" y="12925"/>
                      <a:pt x="2133" y="15188"/>
                      <a:pt x="2198" y="16145"/>
                    </a:cubicBezTo>
                    <a:cubicBezTo>
                      <a:pt x="2220" y="16406"/>
                      <a:pt x="5375" y="18147"/>
                      <a:pt x="6245" y="18190"/>
                    </a:cubicBezTo>
                    <a:lnTo>
                      <a:pt x="6245" y="18125"/>
                    </a:lnTo>
                    <a:cubicBezTo>
                      <a:pt x="7137" y="18082"/>
                      <a:pt x="10314" y="16363"/>
                      <a:pt x="10314" y="16080"/>
                    </a:cubicBezTo>
                    <a:cubicBezTo>
                      <a:pt x="10401" y="15144"/>
                      <a:pt x="9987" y="12881"/>
                      <a:pt x="9987" y="12381"/>
                    </a:cubicBezTo>
                    <a:cubicBezTo>
                      <a:pt x="9922" y="10379"/>
                      <a:pt x="9900" y="8138"/>
                      <a:pt x="10074" y="7638"/>
                    </a:cubicBezTo>
                    <a:cubicBezTo>
                      <a:pt x="10749" y="5527"/>
                      <a:pt x="12533" y="1937"/>
                      <a:pt x="11489" y="1328"/>
                    </a:cubicBezTo>
                    <a:cubicBezTo>
                      <a:pt x="10140" y="501"/>
                      <a:pt x="6289" y="1"/>
                      <a:pt x="6289" y="1"/>
                    </a:cubicBezTo>
                    <a:close/>
                  </a:path>
                </a:pathLst>
              </a:custGeom>
              <a:solidFill>
                <a:srgbClr val="DAAA8E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84" name="Google Shape;484;p22"/>
              <p:cNvSpPr/>
              <p:nvPr/>
            </p:nvSpPr>
            <p:spPr>
              <a:xfrm>
                <a:off x="9819375" y="4093200"/>
                <a:ext cx="31575" cy="38150"/>
              </a:xfrm>
              <a:custGeom>
                <a:avLst/>
                <a:gdLst/>
                <a:ahLst/>
                <a:cxnLst/>
                <a:rect l="l" t="t" r="r" b="b"/>
                <a:pathLst>
                  <a:path w="1263" h="1526" extrusionOk="0">
                    <a:moveTo>
                      <a:pt x="892" y="0"/>
                    </a:moveTo>
                    <a:cubicBezTo>
                      <a:pt x="892" y="0"/>
                      <a:pt x="696" y="588"/>
                      <a:pt x="588" y="718"/>
                    </a:cubicBezTo>
                    <a:cubicBezTo>
                      <a:pt x="500" y="849"/>
                      <a:pt x="326" y="979"/>
                      <a:pt x="218" y="1088"/>
                    </a:cubicBezTo>
                    <a:cubicBezTo>
                      <a:pt x="87" y="1197"/>
                      <a:pt x="0" y="1436"/>
                      <a:pt x="22" y="1480"/>
                    </a:cubicBezTo>
                    <a:cubicBezTo>
                      <a:pt x="41" y="1512"/>
                      <a:pt x="75" y="1526"/>
                      <a:pt x="114" y="1526"/>
                    </a:cubicBezTo>
                    <a:cubicBezTo>
                      <a:pt x="206" y="1526"/>
                      <a:pt x="331" y="1454"/>
                      <a:pt x="392" y="1393"/>
                    </a:cubicBezTo>
                    <a:cubicBezTo>
                      <a:pt x="500" y="1306"/>
                      <a:pt x="718" y="1110"/>
                      <a:pt x="827" y="958"/>
                    </a:cubicBezTo>
                    <a:cubicBezTo>
                      <a:pt x="936" y="805"/>
                      <a:pt x="1219" y="435"/>
                      <a:pt x="1240" y="305"/>
                    </a:cubicBezTo>
                    <a:cubicBezTo>
                      <a:pt x="1262" y="153"/>
                      <a:pt x="892" y="0"/>
                      <a:pt x="892" y="0"/>
                    </a:cubicBezTo>
                    <a:close/>
                  </a:path>
                </a:pathLst>
              </a:custGeom>
              <a:solidFill>
                <a:srgbClr val="C09378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85" name="Google Shape;485;p22"/>
              <p:cNvSpPr/>
              <p:nvPr/>
            </p:nvSpPr>
            <p:spPr>
              <a:xfrm>
                <a:off x="9813650" y="4089400"/>
                <a:ext cx="37825" cy="25075"/>
              </a:xfrm>
              <a:custGeom>
                <a:avLst/>
                <a:gdLst/>
                <a:ahLst/>
                <a:cxnLst/>
                <a:rect l="l" t="t" r="r" b="b"/>
                <a:pathLst>
                  <a:path w="1513" h="1003" extrusionOk="0">
                    <a:moveTo>
                      <a:pt x="1230" y="0"/>
                    </a:moveTo>
                    <a:cubicBezTo>
                      <a:pt x="1230" y="0"/>
                      <a:pt x="882" y="457"/>
                      <a:pt x="773" y="544"/>
                    </a:cubicBezTo>
                    <a:cubicBezTo>
                      <a:pt x="642" y="631"/>
                      <a:pt x="555" y="609"/>
                      <a:pt x="381" y="653"/>
                    </a:cubicBezTo>
                    <a:cubicBezTo>
                      <a:pt x="229" y="675"/>
                      <a:pt x="55" y="762"/>
                      <a:pt x="33" y="892"/>
                    </a:cubicBezTo>
                    <a:cubicBezTo>
                      <a:pt x="1" y="990"/>
                      <a:pt x="127" y="1002"/>
                      <a:pt x="238" y="1002"/>
                    </a:cubicBezTo>
                    <a:cubicBezTo>
                      <a:pt x="275" y="1002"/>
                      <a:pt x="311" y="1001"/>
                      <a:pt x="338" y="1001"/>
                    </a:cubicBezTo>
                    <a:cubicBezTo>
                      <a:pt x="512" y="1001"/>
                      <a:pt x="773" y="914"/>
                      <a:pt x="925" y="827"/>
                    </a:cubicBezTo>
                    <a:cubicBezTo>
                      <a:pt x="1056" y="718"/>
                      <a:pt x="1404" y="457"/>
                      <a:pt x="1448" y="348"/>
                    </a:cubicBezTo>
                    <a:cubicBezTo>
                      <a:pt x="1513" y="239"/>
                      <a:pt x="1230" y="0"/>
                      <a:pt x="1230" y="0"/>
                    </a:cubicBezTo>
                    <a:close/>
                  </a:path>
                </a:pathLst>
              </a:custGeom>
              <a:solidFill>
                <a:srgbClr val="C09378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86" name="Google Shape;486;p22"/>
              <p:cNvSpPr/>
              <p:nvPr/>
            </p:nvSpPr>
            <p:spPr>
              <a:xfrm>
                <a:off x="9815550" y="4087200"/>
                <a:ext cx="34300" cy="17650"/>
              </a:xfrm>
              <a:custGeom>
                <a:avLst/>
                <a:gdLst/>
                <a:ahLst/>
                <a:cxnLst/>
                <a:rect l="l" t="t" r="r" b="b"/>
                <a:pathLst>
                  <a:path w="1372" h="706" extrusionOk="0">
                    <a:moveTo>
                      <a:pt x="1154" y="1"/>
                    </a:moveTo>
                    <a:cubicBezTo>
                      <a:pt x="1154" y="1"/>
                      <a:pt x="806" y="327"/>
                      <a:pt x="697" y="393"/>
                    </a:cubicBezTo>
                    <a:cubicBezTo>
                      <a:pt x="643" y="414"/>
                      <a:pt x="599" y="420"/>
                      <a:pt x="550" y="420"/>
                    </a:cubicBezTo>
                    <a:cubicBezTo>
                      <a:pt x="501" y="420"/>
                      <a:pt x="447" y="414"/>
                      <a:pt x="371" y="414"/>
                    </a:cubicBezTo>
                    <a:cubicBezTo>
                      <a:pt x="240" y="414"/>
                      <a:pt x="66" y="458"/>
                      <a:pt x="23" y="567"/>
                    </a:cubicBezTo>
                    <a:cubicBezTo>
                      <a:pt x="1" y="675"/>
                      <a:pt x="175" y="675"/>
                      <a:pt x="284" y="697"/>
                    </a:cubicBezTo>
                    <a:cubicBezTo>
                      <a:pt x="316" y="703"/>
                      <a:pt x="356" y="705"/>
                      <a:pt x="399" y="705"/>
                    </a:cubicBezTo>
                    <a:cubicBezTo>
                      <a:pt x="527" y="705"/>
                      <a:pt x="686" y="681"/>
                      <a:pt x="784" y="632"/>
                    </a:cubicBezTo>
                    <a:cubicBezTo>
                      <a:pt x="915" y="567"/>
                      <a:pt x="1241" y="414"/>
                      <a:pt x="1306" y="327"/>
                    </a:cubicBezTo>
                    <a:cubicBezTo>
                      <a:pt x="1372" y="240"/>
                      <a:pt x="1154" y="1"/>
                      <a:pt x="1154" y="1"/>
                    </a:cubicBezTo>
                    <a:close/>
                  </a:path>
                </a:pathLst>
              </a:custGeom>
              <a:solidFill>
                <a:srgbClr val="C09378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87" name="Google Shape;487;p22"/>
              <p:cNvSpPr/>
              <p:nvPr/>
            </p:nvSpPr>
            <p:spPr>
              <a:xfrm>
                <a:off x="9800875" y="4007800"/>
                <a:ext cx="59850" cy="136675"/>
              </a:xfrm>
              <a:custGeom>
                <a:avLst/>
                <a:gdLst/>
                <a:ahLst/>
                <a:cxnLst/>
                <a:rect l="l" t="t" r="r" b="b"/>
                <a:pathLst>
                  <a:path w="2394" h="5467" extrusionOk="0">
                    <a:moveTo>
                      <a:pt x="805" y="0"/>
                    </a:moveTo>
                    <a:cubicBezTo>
                      <a:pt x="805" y="0"/>
                      <a:pt x="1023" y="1306"/>
                      <a:pt x="936" y="1502"/>
                    </a:cubicBezTo>
                    <a:cubicBezTo>
                      <a:pt x="871" y="1697"/>
                      <a:pt x="718" y="1915"/>
                      <a:pt x="588" y="2111"/>
                    </a:cubicBezTo>
                    <a:cubicBezTo>
                      <a:pt x="370" y="2437"/>
                      <a:pt x="370" y="2981"/>
                      <a:pt x="327" y="3177"/>
                    </a:cubicBezTo>
                    <a:cubicBezTo>
                      <a:pt x="283" y="3525"/>
                      <a:pt x="0" y="3808"/>
                      <a:pt x="44" y="3939"/>
                    </a:cubicBezTo>
                    <a:cubicBezTo>
                      <a:pt x="52" y="3972"/>
                      <a:pt x="89" y="3986"/>
                      <a:pt x="140" y="3986"/>
                    </a:cubicBezTo>
                    <a:cubicBezTo>
                      <a:pt x="222" y="3986"/>
                      <a:pt x="341" y="3949"/>
                      <a:pt x="435" y="3895"/>
                    </a:cubicBezTo>
                    <a:cubicBezTo>
                      <a:pt x="610" y="3786"/>
                      <a:pt x="784" y="3460"/>
                      <a:pt x="805" y="3264"/>
                    </a:cubicBezTo>
                    <a:cubicBezTo>
                      <a:pt x="846" y="3103"/>
                      <a:pt x="960" y="2868"/>
                      <a:pt x="1098" y="2868"/>
                    </a:cubicBezTo>
                    <a:cubicBezTo>
                      <a:pt x="1109" y="2868"/>
                      <a:pt x="1120" y="2869"/>
                      <a:pt x="1132" y="2872"/>
                    </a:cubicBezTo>
                    <a:cubicBezTo>
                      <a:pt x="1262" y="2894"/>
                      <a:pt x="1610" y="3286"/>
                      <a:pt x="1632" y="3460"/>
                    </a:cubicBezTo>
                    <a:cubicBezTo>
                      <a:pt x="1654" y="3743"/>
                      <a:pt x="1719" y="4113"/>
                      <a:pt x="1654" y="4287"/>
                    </a:cubicBezTo>
                    <a:cubicBezTo>
                      <a:pt x="1589" y="4439"/>
                      <a:pt x="1328" y="4700"/>
                      <a:pt x="1219" y="4831"/>
                    </a:cubicBezTo>
                    <a:cubicBezTo>
                      <a:pt x="1110" y="4961"/>
                      <a:pt x="958" y="5113"/>
                      <a:pt x="936" y="5244"/>
                    </a:cubicBezTo>
                    <a:cubicBezTo>
                      <a:pt x="892" y="5375"/>
                      <a:pt x="958" y="5418"/>
                      <a:pt x="1023" y="5462"/>
                    </a:cubicBezTo>
                    <a:cubicBezTo>
                      <a:pt x="1026" y="5465"/>
                      <a:pt x="1031" y="5467"/>
                      <a:pt x="1035" y="5467"/>
                    </a:cubicBezTo>
                    <a:cubicBezTo>
                      <a:pt x="1088" y="5467"/>
                      <a:pt x="1215" y="5255"/>
                      <a:pt x="1415" y="5135"/>
                    </a:cubicBezTo>
                    <a:cubicBezTo>
                      <a:pt x="1632" y="5005"/>
                      <a:pt x="2046" y="4613"/>
                      <a:pt x="2067" y="4570"/>
                    </a:cubicBezTo>
                    <a:cubicBezTo>
                      <a:pt x="2111" y="4526"/>
                      <a:pt x="2285" y="3764"/>
                      <a:pt x="2350" y="3547"/>
                    </a:cubicBezTo>
                    <a:cubicBezTo>
                      <a:pt x="2394" y="3308"/>
                      <a:pt x="2067" y="2133"/>
                      <a:pt x="2111" y="2067"/>
                    </a:cubicBezTo>
                    <a:cubicBezTo>
                      <a:pt x="2154" y="1980"/>
                      <a:pt x="2111" y="218"/>
                      <a:pt x="2111" y="218"/>
                    </a:cubicBezTo>
                    <a:lnTo>
                      <a:pt x="805" y="0"/>
                    </a:lnTo>
                    <a:close/>
                  </a:path>
                </a:pathLst>
              </a:custGeom>
              <a:solidFill>
                <a:srgbClr val="DAAA8E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88" name="Google Shape;488;p22"/>
              <p:cNvSpPr/>
              <p:nvPr/>
            </p:nvSpPr>
            <p:spPr>
              <a:xfrm>
                <a:off x="9792175" y="3609625"/>
                <a:ext cx="75625" cy="440625"/>
              </a:xfrm>
              <a:custGeom>
                <a:avLst/>
                <a:gdLst/>
                <a:ahLst/>
                <a:cxnLst/>
                <a:rect l="l" t="t" r="r" b="b"/>
                <a:pathLst>
                  <a:path w="3025" h="17625" extrusionOk="0">
                    <a:moveTo>
                      <a:pt x="1371" y="0"/>
                    </a:moveTo>
                    <a:cubicBezTo>
                      <a:pt x="740" y="349"/>
                      <a:pt x="0" y="6136"/>
                      <a:pt x="0" y="6136"/>
                    </a:cubicBezTo>
                    <a:cubicBezTo>
                      <a:pt x="0" y="6136"/>
                      <a:pt x="65" y="11967"/>
                      <a:pt x="174" y="13033"/>
                    </a:cubicBezTo>
                    <a:cubicBezTo>
                      <a:pt x="283" y="14078"/>
                      <a:pt x="979" y="17624"/>
                      <a:pt x="979" y="17624"/>
                    </a:cubicBezTo>
                    <a:lnTo>
                      <a:pt x="2763" y="17494"/>
                    </a:lnTo>
                    <a:cubicBezTo>
                      <a:pt x="2763" y="17494"/>
                      <a:pt x="3003" y="13033"/>
                      <a:pt x="3025" y="12315"/>
                    </a:cubicBezTo>
                    <a:cubicBezTo>
                      <a:pt x="3025" y="11597"/>
                      <a:pt x="2959" y="9683"/>
                      <a:pt x="2916" y="9356"/>
                    </a:cubicBezTo>
                    <a:cubicBezTo>
                      <a:pt x="2850" y="9052"/>
                      <a:pt x="2785" y="3569"/>
                      <a:pt x="2241" y="1023"/>
                    </a:cubicBezTo>
                    <a:cubicBezTo>
                      <a:pt x="2067" y="109"/>
                      <a:pt x="1371" y="0"/>
                      <a:pt x="1371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89" name="Google Shape;489;p22"/>
              <p:cNvSpPr/>
              <p:nvPr/>
            </p:nvSpPr>
            <p:spPr>
              <a:xfrm>
                <a:off x="9615925" y="3513875"/>
                <a:ext cx="138725" cy="85975"/>
              </a:xfrm>
              <a:custGeom>
                <a:avLst/>
                <a:gdLst/>
                <a:ahLst/>
                <a:cxnLst/>
                <a:rect l="l" t="t" r="r" b="b"/>
                <a:pathLst>
                  <a:path w="5549" h="3439" extrusionOk="0">
                    <a:moveTo>
                      <a:pt x="2786" y="1"/>
                    </a:moveTo>
                    <a:lnTo>
                      <a:pt x="2786" y="66"/>
                    </a:lnTo>
                    <a:lnTo>
                      <a:pt x="1480" y="66"/>
                    </a:lnTo>
                    <a:cubicBezTo>
                      <a:pt x="1480" y="66"/>
                      <a:pt x="1262" y="2046"/>
                      <a:pt x="1154" y="2438"/>
                    </a:cubicBezTo>
                    <a:cubicBezTo>
                      <a:pt x="1067" y="2851"/>
                      <a:pt x="0" y="3439"/>
                      <a:pt x="0" y="3439"/>
                    </a:cubicBezTo>
                    <a:lnTo>
                      <a:pt x="2786" y="3439"/>
                    </a:lnTo>
                    <a:lnTo>
                      <a:pt x="2786" y="3373"/>
                    </a:lnTo>
                    <a:lnTo>
                      <a:pt x="5549" y="3373"/>
                    </a:lnTo>
                    <a:cubicBezTo>
                      <a:pt x="5549" y="3373"/>
                      <a:pt x="4483" y="2786"/>
                      <a:pt x="4396" y="2373"/>
                    </a:cubicBezTo>
                    <a:cubicBezTo>
                      <a:pt x="4309" y="1981"/>
                      <a:pt x="4091" y="1"/>
                      <a:pt x="4091" y="1"/>
                    </a:cubicBezTo>
                    <a:close/>
                  </a:path>
                </a:pathLst>
              </a:custGeom>
              <a:solidFill>
                <a:srgbClr val="DAAA8E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90" name="Google Shape;490;p22"/>
              <p:cNvSpPr/>
              <p:nvPr/>
            </p:nvSpPr>
            <p:spPr>
              <a:xfrm>
                <a:off x="9615925" y="3513875"/>
                <a:ext cx="107725" cy="85975"/>
              </a:xfrm>
              <a:custGeom>
                <a:avLst/>
                <a:gdLst/>
                <a:ahLst/>
                <a:cxnLst/>
                <a:rect l="l" t="t" r="r" b="b"/>
                <a:pathLst>
                  <a:path w="4309" h="3439" extrusionOk="0">
                    <a:moveTo>
                      <a:pt x="2786" y="1"/>
                    </a:moveTo>
                    <a:lnTo>
                      <a:pt x="2786" y="66"/>
                    </a:lnTo>
                    <a:lnTo>
                      <a:pt x="1480" y="66"/>
                    </a:lnTo>
                    <a:cubicBezTo>
                      <a:pt x="1480" y="66"/>
                      <a:pt x="1262" y="2046"/>
                      <a:pt x="1154" y="2438"/>
                    </a:cubicBezTo>
                    <a:cubicBezTo>
                      <a:pt x="1067" y="2851"/>
                      <a:pt x="0" y="3439"/>
                      <a:pt x="0" y="3439"/>
                    </a:cubicBezTo>
                    <a:lnTo>
                      <a:pt x="131" y="3439"/>
                    </a:lnTo>
                    <a:cubicBezTo>
                      <a:pt x="1371" y="3112"/>
                      <a:pt x="2611" y="2786"/>
                      <a:pt x="2764" y="2742"/>
                    </a:cubicBezTo>
                    <a:cubicBezTo>
                      <a:pt x="3112" y="2634"/>
                      <a:pt x="4309" y="1829"/>
                      <a:pt x="4309" y="1829"/>
                    </a:cubicBezTo>
                    <a:cubicBezTo>
                      <a:pt x="4222" y="1219"/>
                      <a:pt x="4135" y="349"/>
                      <a:pt x="4091" y="88"/>
                    </a:cubicBezTo>
                    <a:lnTo>
                      <a:pt x="4004" y="1"/>
                    </a:lnTo>
                    <a:close/>
                  </a:path>
                </a:pathLst>
              </a:custGeom>
              <a:solidFill>
                <a:srgbClr val="191919">
                  <a:alpha val="1761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91" name="Google Shape;491;p22"/>
              <p:cNvSpPr/>
              <p:nvPr/>
            </p:nvSpPr>
            <p:spPr>
              <a:xfrm>
                <a:off x="9577325" y="3937625"/>
                <a:ext cx="107700" cy="315025"/>
              </a:xfrm>
              <a:custGeom>
                <a:avLst/>
                <a:gdLst/>
                <a:ahLst/>
                <a:cxnLst/>
                <a:rect l="l" t="t" r="r" b="b"/>
                <a:pathLst>
                  <a:path w="4308" h="12601" extrusionOk="0">
                    <a:moveTo>
                      <a:pt x="2174" y="0"/>
                    </a:moveTo>
                    <a:cubicBezTo>
                      <a:pt x="619" y="0"/>
                      <a:pt x="0" y="1121"/>
                      <a:pt x="43" y="4504"/>
                    </a:cubicBezTo>
                    <a:cubicBezTo>
                      <a:pt x="87" y="7920"/>
                      <a:pt x="587" y="11619"/>
                      <a:pt x="805" y="12163"/>
                    </a:cubicBezTo>
                    <a:cubicBezTo>
                      <a:pt x="931" y="12466"/>
                      <a:pt x="1746" y="12601"/>
                      <a:pt x="2450" y="12601"/>
                    </a:cubicBezTo>
                    <a:cubicBezTo>
                      <a:pt x="2960" y="12601"/>
                      <a:pt x="3411" y="12530"/>
                      <a:pt x="3503" y="12403"/>
                    </a:cubicBezTo>
                    <a:cubicBezTo>
                      <a:pt x="3720" y="12076"/>
                      <a:pt x="4286" y="5005"/>
                      <a:pt x="4286" y="3895"/>
                    </a:cubicBezTo>
                    <a:cubicBezTo>
                      <a:pt x="4308" y="2786"/>
                      <a:pt x="3960" y="1"/>
                      <a:pt x="2219" y="1"/>
                    </a:cubicBezTo>
                    <a:cubicBezTo>
                      <a:pt x="2204" y="0"/>
                      <a:pt x="2189" y="0"/>
                      <a:pt x="2174" y="0"/>
                    </a:cubicBezTo>
                    <a:close/>
                  </a:path>
                </a:pathLst>
              </a:custGeom>
              <a:solidFill>
                <a:srgbClr val="FFBD9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92" name="Google Shape;492;p22"/>
              <p:cNvSpPr/>
              <p:nvPr/>
            </p:nvSpPr>
            <p:spPr>
              <a:xfrm>
                <a:off x="9596350" y="4216650"/>
                <a:ext cx="69650" cy="93075"/>
              </a:xfrm>
              <a:custGeom>
                <a:avLst/>
                <a:gdLst/>
                <a:ahLst/>
                <a:cxnLst/>
                <a:rect l="l" t="t" r="r" b="b"/>
                <a:pathLst>
                  <a:path w="2786" h="3723" extrusionOk="0">
                    <a:moveTo>
                      <a:pt x="1201" y="1"/>
                    </a:moveTo>
                    <a:cubicBezTo>
                      <a:pt x="587" y="1"/>
                      <a:pt x="65" y="493"/>
                      <a:pt x="44" y="1111"/>
                    </a:cubicBezTo>
                    <a:lnTo>
                      <a:pt x="22" y="2547"/>
                    </a:lnTo>
                    <a:cubicBezTo>
                      <a:pt x="0" y="3178"/>
                      <a:pt x="501" y="3700"/>
                      <a:pt x="1132" y="3722"/>
                    </a:cubicBezTo>
                    <a:lnTo>
                      <a:pt x="1567" y="3722"/>
                    </a:lnTo>
                    <a:cubicBezTo>
                      <a:pt x="1580" y="3723"/>
                      <a:pt x="1593" y="3723"/>
                      <a:pt x="1606" y="3723"/>
                    </a:cubicBezTo>
                    <a:cubicBezTo>
                      <a:pt x="2219" y="3723"/>
                      <a:pt x="2720" y="3230"/>
                      <a:pt x="2742" y="2612"/>
                    </a:cubicBezTo>
                    <a:lnTo>
                      <a:pt x="2763" y="1198"/>
                    </a:lnTo>
                    <a:cubicBezTo>
                      <a:pt x="2785" y="545"/>
                      <a:pt x="2285" y="23"/>
                      <a:pt x="1654" y="1"/>
                    </a:cubicBezTo>
                    <a:lnTo>
                      <a:pt x="1240" y="1"/>
                    </a:lnTo>
                    <a:cubicBezTo>
                      <a:pt x="1227" y="1"/>
                      <a:pt x="1214" y="1"/>
                      <a:pt x="1201" y="1"/>
                    </a:cubicBezTo>
                    <a:close/>
                  </a:path>
                </a:pathLst>
              </a:custGeom>
              <a:solidFill>
                <a:srgbClr val="FFBD9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93" name="Google Shape;493;p22"/>
              <p:cNvSpPr/>
              <p:nvPr/>
            </p:nvSpPr>
            <p:spPr>
              <a:xfrm>
                <a:off x="9587650" y="4257475"/>
                <a:ext cx="80525" cy="272550"/>
              </a:xfrm>
              <a:custGeom>
                <a:avLst/>
                <a:gdLst/>
                <a:ahLst/>
                <a:cxnLst/>
                <a:rect l="l" t="t" r="r" b="b"/>
                <a:pathLst>
                  <a:path w="3221" h="10902" extrusionOk="0">
                    <a:moveTo>
                      <a:pt x="1675" y="0"/>
                    </a:moveTo>
                    <a:cubicBezTo>
                      <a:pt x="1197" y="0"/>
                      <a:pt x="0" y="174"/>
                      <a:pt x="65" y="3351"/>
                    </a:cubicBezTo>
                    <a:cubicBezTo>
                      <a:pt x="109" y="6528"/>
                      <a:pt x="1458" y="10901"/>
                      <a:pt x="1458" y="10901"/>
                    </a:cubicBezTo>
                    <a:lnTo>
                      <a:pt x="2611" y="10901"/>
                    </a:lnTo>
                    <a:cubicBezTo>
                      <a:pt x="2611" y="10901"/>
                      <a:pt x="3177" y="5005"/>
                      <a:pt x="3199" y="3873"/>
                    </a:cubicBezTo>
                    <a:cubicBezTo>
                      <a:pt x="3199" y="1306"/>
                      <a:pt x="3220" y="0"/>
                      <a:pt x="1675" y="0"/>
                    </a:cubicBezTo>
                    <a:close/>
                  </a:path>
                </a:pathLst>
              </a:custGeom>
              <a:solidFill>
                <a:srgbClr val="FFBD9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94" name="Google Shape;494;p22"/>
              <p:cNvSpPr/>
              <p:nvPr/>
            </p:nvSpPr>
            <p:spPr>
              <a:xfrm>
                <a:off x="9693700" y="3937725"/>
                <a:ext cx="118075" cy="315125"/>
              </a:xfrm>
              <a:custGeom>
                <a:avLst/>
                <a:gdLst/>
                <a:ahLst/>
                <a:cxnLst/>
                <a:rect l="l" t="t" r="r" b="b"/>
                <a:pathLst>
                  <a:path w="4723" h="12605" extrusionOk="0">
                    <a:moveTo>
                      <a:pt x="2081" y="0"/>
                    </a:moveTo>
                    <a:cubicBezTo>
                      <a:pt x="1979" y="0"/>
                      <a:pt x="1873" y="6"/>
                      <a:pt x="1763" y="18"/>
                    </a:cubicBezTo>
                    <a:cubicBezTo>
                      <a:pt x="44" y="192"/>
                      <a:pt x="1" y="3021"/>
                      <a:pt x="110" y="4109"/>
                    </a:cubicBezTo>
                    <a:cubicBezTo>
                      <a:pt x="218" y="5218"/>
                      <a:pt x="1502" y="12203"/>
                      <a:pt x="1763" y="12486"/>
                    </a:cubicBezTo>
                    <a:cubicBezTo>
                      <a:pt x="1838" y="12567"/>
                      <a:pt x="2075" y="12605"/>
                      <a:pt x="2379" y="12605"/>
                    </a:cubicBezTo>
                    <a:cubicBezTo>
                      <a:pt x="3136" y="12605"/>
                      <a:pt x="4309" y="12367"/>
                      <a:pt x="4418" y="11963"/>
                    </a:cubicBezTo>
                    <a:cubicBezTo>
                      <a:pt x="4592" y="11420"/>
                      <a:pt x="4722" y="7677"/>
                      <a:pt x="4396" y="4283"/>
                    </a:cubicBezTo>
                    <a:cubicBezTo>
                      <a:pt x="4113" y="1124"/>
                      <a:pt x="3452" y="0"/>
                      <a:pt x="2081" y="0"/>
                    </a:cubicBezTo>
                    <a:close/>
                  </a:path>
                </a:pathLst>
              </a:custGeom>
              <a:solidFill>
                <a:srgbClr val="FFBD9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95" name="Google Shape;495;p22"/>
              <p:cNvSpPr/>
              <p:nvPr/>
            </p:nvSpPr>
            <p:spPr>
              <a:xfrm>
                <a:off x="9735050" y="4214875"/>
                <a:ext cx="76175" cy="94450"/>
              </a:xfrm>
              <a:custGeom>
                <a:avLst/>
                <a:gdLst/>
                <a:ahLst/>
                <a:cxnLst/>
                <a:rect l="l" t="t" r="r" b="b"/>
                <a:pathLst>
                  <a:path w="3047" h="3778" extrusionOk="0">
                    <a:moveTo>
                      <a:pt x="1605" y="1"/>
                    </a:moveTo>
                    <a:cubicBezTo>
                      <a:pt x="1564" y="1"/>
                      <a:pt x="1522" y="3"/>
                      <a:pt x="1480" y="7"/>
                    </a:cubicBezTo>
                    <a:lnTo>
                      <a:pt x="1067" y="72"/>
                    </a:lnTo>
                    <a:cubicBezTo>
                      <a:pt x="436" y="159"/>
                      <a:pt x="1" y="725"/>
                      <a:pt x="88" y="1356"/>
                    </a:cubicBezTo>
                    <a:lnTo>
                      <a:pt x="262" y="2770"/>
                    </a:lnTo>
                    <a:cubicBezTo>
                      <a:pt x="343" y="3359"/>
                      <a:pt x="841" y="3778"/>
                      <a:pt x="1420" y="3778"/>
                    </a:cubicBezTo>
                    <a:cubicBezTo>
                      <a:pt x="1462" y="3778"/>
                      <a:pt x="1503" y="3776"/>
                      <a:pt x="1545" y="3771"/>
                    </a:cubicBezTo>
                    <a:lnTo>
                      <a:pt x="1959" y="3706"/>
                    </a:lnTo>
                    <a:cubicBezTo>
                      <a:pt x="2590" y="3619"/>
                      <a:pt x="3047" y="3053"/>
                      <a:pt x="2960" y="2422"/>
                    </a:cubicBezTo>
                    <a:lnTo>
                      <a:pt x="2786" y="1008"/>
                    </a:lnTo>
                    <a:cubicBezTo>
                      <a:pt x="2704" y="419"/>
                      <a:pt x="2187" y="1"/>
                      <a:pt x="1605" y="1"/>
                    </a:cubicBezTo>
                    <a:close/>
                  </a:path>
                </a:pathLst>
              </a:custGeom>
              <a:solidFill>
                <a:srgbClr val="FFBD9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96" name="Google Shape;496;p22"/>
              <p:cNvSpPr/>
              <p:nvPr/>
            </p:nvSpPr>
            <p:spPr>
              <a:xfrm>
                <a:off x="9735600" y="4256175"/>
                <a:ext cx="94125" cy="273300"/>
              </a:xfrm>
              <a:custGeom>
                <a:avLst/>
                <a:gdLst/>
                <a:ahLst/>
                <a:cxnLst/>
                <a:rect l="l" t="t" r="r" b="b"/>
                <a:pathLst>
                  <a:path w="3765" h="10932" extrusionOk="0">
                    <a:moveTo>
                      <a:pt x="1708" y="1"/>
                    </a:moveTo>
                    <a:cubicBezTo>
                      <a:pt x="1647" y="1"/>
                      <a:pt x="1593" y="4"/>
                      <a:pt x="1545" y="9"/>
                    </a:cubicBezTo>
                    <a:cubicBezTo>
                      <a:pt x="0" y="161"/>
                      <a:pt x="153" y="1445"/>
                      <a:pt x="435" y="4012"/>
                    </a:cubicBezTo>
                    <a:cubicBezTo>
                      <a:pt x="566" y="5122"/>
                      <a:pt x="1719" y="10931"/>
                      <a:pt x="1719" y="10931"/>
                    </a:cubicBezTo>
                    <a:lnTo>
                      <a:pt x="2872" y="10823"/>
                    </a:lnTo>
                    <a:cubicBezTo>
                      <a:pt x="2872" y="10823"/>
                      <a:pt x="3764" y="6340"/>
                      <a:pt x="3503" y="3164"/>
                    </a:cubicBezTo>
                    <a:cubicBezTo>
                      <a:pt x="3249" y="303"/>
                      <a:pt x="2253" y="1"/>
                      <a:pt x="1708" y="1"/>
                    </a:cubicBezTo>
                    <a:close/>
                  </a:path>
                </a:pathLst>
              </a:custGeom>
              <a:solidFill>
                <a:srgbClr val="FFBD9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97" name="Google Shape;497;p22"/>
              <p:cNvSpPr/>
              <p:nvPr/>
            </p:nvSpPr>
            <p:spPr>
              <a:xfrm>
                <a:off x="9570775" y="3920225"/>
                <a:ext cx="114250" cy="627200"/>
              </a:xfrm>
              <a:custGeom>
                <a:avLst/>
                <a:gdLst/>
                <a:ahLst/>
                <a:cxnLst/>
                <a:rect l="l" t="t" r="r" b="b"/>
                <a:pathLst>
                  <a:path w="4570" h="25088" extrusionOk="0">
                    <a:moveTo>
                      <a:pt x="762" y="0"/>
                    </a:moveTo>
                    <a:cubicBezTo>
                      <a:pt x="762" y="0"/>
                      <a:pt x="175" y="2807"/>
                      <a:pt x="88" y="4330"/>
                    </a:cubicBezTo>
                    <a:cubicBezTo>
                      <a:pt x="1" y="5875"/>
                      <a:pt x="740" y="12555"/>
                      <a:pt x="740" y="13294"/>
                    </a:cubicBezTo>
                    <a:cubicBezTo>
                      <a:pt x="740" y="14034"/>
                      <a:pt x="675" y="16297"/>
                      <a:pt x="719" y="18516"/>
                    </a:cubicBezTo>
                    <a:cubicBezTo>
                      <a:pt x="762" y="20714"/>
                      <a:pt x="1328" y="25087"/>
                      <a:pt x="1328" y="25087"/>
                    </a:cubicBezTo>
                    <a:lnTo>
                      <a:pt x="4178" y="25022"/>
                    </a:lnTo>
                    <a:cubicBezTo>
                      <a:pt x="4178" y="25022"/>
                      <a:pt x="4178" y="15644"/>
                      <a:pt x="4200" y="14187"/>
                    </a:cubicBezTo>
                    <a:cubicBezTo>
                      <a:pt x="4200" y="12707"/>
                      <a:pt x="4548" y="4939"/>
                      <a:pt x="4548" y="4939"/>
                    </a:cubicBezTo>
                    <a:lnTo>
                      <a:pt x="4570" y="131"/>
                    </a:lnTo>
                    <a:lnTo>
                      <a:pt x="762" y="0"/>
                    </a:ln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98" name="Google Shape;498;p22"/>
              <p:cNvSpPr/>
              <p:nvPr/>
            </p:nvSpPr>
            <p:spPr>
              <a:xfrm>
                <a:off x="9542500" y="3588950"/>
                <a:ext cx="285600" cy="334550"/>
              </a:xfrm>
              <a:custGeom>
                <a:avLst/>
                <a:gdLst/>
                <a:ahLst/>
                <a:cxnLst/>
                <a:rect l="l" t="t" r="r" b="b"/>
                <a:pathLst>
                  <a:path w="11424" h="13382" extrusionOk="0">
                    <a:moveTo>
                      <a:pt x="3590" y="1"/>
                    </a:moveTo>
                    <a:cubicBezTo>
                      <a:pt x="3590" y="1"/>
                      <a:pt x="2894" y="305"/>
                      <a:pt x="2132" y="545"/>
                    </a:cubicBezTo>
                    <a:cubicBezTo>
                      <a:pt x="1262" y="806"/>
                      <a:pt x="305" y="1045"/>
                      <a:pt x="152" y="1350"/>
                    </a:cubicBezTo>
                    <a:cubicBezTo>
                      <a:pt x="0" y="1654"/>
                      <a:pt x="1545" y="7616"/>
                      <a:pt x="1719" y="8138"/>
                    </a:cubicBezTo>
                    <a:cubicBezTo>
                      <a:pt x="1893" y="8639"/>
                      <a:pt x="1436" y="12185"/>
                      <a:pt x="1893" y="13251"/>
                    </a:cubicBezTo>
                    <a:lnTo>
                      <a:pt x="5679" y="13382"/>
                    </a:lnTo>
                    <a:lnTo>
                      <a:pt x="5701" y="13382"/>
                    </a:lnTo>
                    <a:lnTo>
                      <a:pt x="9508" y="13273"/>
                    </a:lnTo>
                    <a:cubicBezTo>
                      <a:pt x="9857" y="12055"/>
                      <a:pt x="9487" y="8573"/>
                      <a:pt x="9661" y="8073"/>
                    </a:cubicBezTo>
                    <a:cubicBezTo>
                      <a:pt x="9857" y="7572"/>
                      <a:pt x="11423" y="1676"/>
                      <a:pt x="11271" y="1350"/>
                    </a:cubicBezTo>
                    <a:cubicBezTo>
                      <a:pt x="11119" y="1045"/>
                      <a:pt x="10139" y="827"/>
                      <a:pt x="9291" y="566"/>
                    </a:cubicBezTo>
                    <a:cubicBezTo>
                      <a:pt x="8508" y="327"/>
                      <a:pt x="7833" y="22"/>
                      <a:pt x="7833" y="22"/>
                    </a:cubicBezTo>
                    <a:lnTo>
                      <a:pt x="5701" y="1219"/>
                    </a:lnTo>
                    <a:lnTo>
                      <a:pt x="3590" y="1"/>
                    </a:ln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499" name="Google Shape;499;p22"/>
              <p:cNvSpPr/>
              <p:nvPr/>
            </p:nvSpPr>
            <p:spPr>
              <a:xfrm>
                <a:off x="9684475" y="3918050"/>
                <a:ext cx="147425" cy="631550"/>
              </a:xfrm>
              <a:custGeom>
                <a:avLst/>
                <a:gdLst/>
                <a:ahLst/>
                <a:cxnLst/>
                <a:rect l="l" t="t" r="r" b="b"/>
                <a:pathLst>
                  <a:path w="5897" h="25262" extrusionOk="0">
                    <a:moveTo>
                      <a:pt x="3786" y="0"/>
                    </a:moveTo>
                    <a:lnTo>
                      <a:pt x="22" y="218"/>
                    </a:lnTo>
                    <a:lnTo>
                      <a:pt x="0" y="5266"/>
                    </a:lnTo>
                    <a:cubicBezTo>
                      <a:pt x="0" y="5266"/>
                      <a:pt x="1675" y="12990"/>
                      <a:pt x="1828" y="14469"/>
                    </a:cubicBezTo>
                    <a:cubicBezTo>
                      <a:pt x="1980" y="15927"/>
                      <a:pt x="2959" y="25261"/>
                      <a:pt x="2959" y="25261"/>
                    </a:cubicBezTo>
                    <a:lnTo>
                      <a:pt x="5788" y="25022"/>
                    </a:lnTo>
                    <a:cubicBezTo>
                      <a:pt x="5788" y="25022"/>
                      <a:pt x="5896" y="20627"/>
                      <a:pt x="5722" y="18408"/>
                    </a:cubicBezTo>
                    <a:cubicBezTo>
                      <a:pt x="5527" y="16210"/>
                      <a:pt x="5244" y="13969"/>
                      <a:pt x="5178" y="13229"/>
                    </a:cubicBezTo>
                    <a:cubicBezTo>
                      <a:pt x="5091" y="12489"/>
                      <a:pt x="5135" y="5766"/>
                      <a:pt x="4896" y="4265"/>
                    </a:cubicBezTo>
                    <a:cubicBezTo>
                      <a:pt x="4656" y="2742"/>
                      <a:pt x="3786" y="0"/>
                      <a:pt x="3786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00" name="Google Shape;500;p22"/>
              <p:cNvSpPr/>
              <p:nvPr/>
            </p:nvSpPr>
            <p:spPr>
              <a:xfrm>
                <a:off x="9587100" y="4545775"/>
                <a:ext cx="79975" cy="58225"/>
              </a:xfrm>
              <a:custGeom>
                <a:avLst/>
                <a:gdLst/>
                <a:ahLst/>
                <a:cxnLst/>
                <a:rect l="l" t="t" r="r" b="b"/>
                <a:pathLst>
                  <a:path w="3199" h="2329" extrusionOk="0">
                    <a:moveTo>
                      <a:pt x="3199" y="0"/>
                    </a:moveTo>
                    <a:lnTo>
                      <a:pt x="979" y="65"/>
                    </a:lnTo>
                    <a:cubicBezTo>
                      <a:pt x="979" y="65"/>
                      <a:pt x="0" y="1197"/>
                      <a:pt x="66" y="1501"/>
                    </a:cubicBezTo>
                    <a:cubicBezTo>
                      <a:pt x="87" y="1654"/>
                      <a:pt x="501" y="2285"/>
                      <a:pt x="1241" y="2328"/>
                    </a:cubicBezTo>
                    <a:cubicBezTo>
                      <a:pt x="1253" y="2329"/>
                      <a:pt x="1265" y="2329"/>
                      <a:pt x="1277" y="2329"/>
                    </a:cubicBezTo>
                    <a:cubicBezTo>
                      <a:pt x="1845" y="2329"/>
                      <a:pt x="2723" y="1849"/>
                      <a:pt x="2872" y="1828"/>
                    </a:cubicBezTo>
                    <a:cubicBezTo>
                      <a:pt x="3199" y="1806"/>
                      <a:pt x="3199" y="0"/>
                      <a:pt x="3199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01" name="Google Shape;501;p22"/>
              <p:cNvSpPr/>
              <p:nvPr/>
            </p:nvSpPr>
            <p:spPr>
              <a:xfrm>
                <a:off x="9763875" y="4544675"/>
                <a:ext cx="82175" cy="57050"/>
              </a:xfrm>
              <a:custGeom>
                <a:avLst/>
                <a:gdLst/>
                <a:ahLst/>
                <a:cxnLst/>
                <a:rect l="l" t="t" r="r" b="b"/>
                <a:pathLst>
                  <a:path w="3287" h="2282" extrusionOk="0">
                    <a:moveTo>
                      <a:pt x="2198" y="1"/>
                    </a:moveTo>
                    <a:lnTo>
                      <a:pt x="1" y="175"/>
                    </a:lnTo>
                    <a:cubicBezTo>
                      <a:pt x="1" y="175"/>
                      <a:pt x="175" y="1959"/>
                      <a:pt x="501" y="1959"/>
                    </a:cubicBezTo>
                    <a:cubicBezTo>
                      <a:pt x="636" y="1959"/>
                      <a:pt x="1416" y="2282"/>
                      <a:pt x="1971" y="2282"/>
                    </a:cubicBezTo>
                    <a:cubicBezTo>
                      <a:pt x="2044" y="2282"/>
                      <a:pt x="2113" y="2276"/>
                      <a:pt x="2177" y="2263"/>
                    </a:cubicBezTo>
                    <a:cubicBezTo>
                      <a:pt x="2916" y="2155"/>
                      <a:pt x="3264" y="1502"/>
                      <a:pt x="3264" y="1328"/>
                    </a:cubicBezTo>
                    <a:cubicBezTo>
                      <a:pt x="3286" y="1023"/>
                      <a:pt x="2198" y="1"/>
                      <a:pt x="2198" y="1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02" name="Google Shape;502;p22"/>
              <p:cNvSpPr/>
              <p:nvPr/>
            </p:nvSpPr>
            <p:spPr>
              <a:xfrm>
                <a:off x="9542500" y="3628650"/>
                <a:ext cx="237725" cy="294850"/>
              </a:xfrm>
              <a:custGeom>
                <a:avLst/>
                <a:gdLst/>
                <a:ahLst/>
                <a:cxnLst/>
                <a:rect l="l" t="t" r="r" b="b"/>
                <a:pathLst>
                  <a:path w="9509" h="11794" extrusionOk="0">
                    <a:moveTo>
                      <a:pt x="0" y="1"/>
                    </a:moveTo>
                    <a:lnTo>
                      <a:pt x="0" y="1"/>
                    </a:lnTo>
                    <a:cubicBezTo>
                      <a:pt x="414" y="1872"/>
                      <a:pt x="1610" y="6224"/>
                      <a:pt x="1719" y="6550"/>
                    </a:cubicBezTo>
                    <a:cubicBezTo>
                      <a:pt x="1893" y="7051"/>
                      <a:pt x="1436" y="10597"/>
                      <a:pt x="1893" y="11663"/>
                    </a:cubicBezTo>
                    <a:lnTo>
                      <a:pt x="5679" y="11794"/>
                    </a:lnTo>
                    <a:lnTo>
                      <a:pt x="5701" y="11794"/>
                    </a:lnTo>
                    <a:lnTo>
                      <a:pt x="9508" y="11685"/>
                    </a:lnTo>
                    <a:cubicBezTo>
                      <a:pt x="9508" y="11685"/>
                      <a:pt x="8660" y="11554"/>
                      <a:pt x="8334" y="11446"/>
                    </a:cubicBezTo>
                    <a:cubicBezTo>
                      <a:pt x="8228" y="11419"/>
                      <a:pt x="8036" y="11415"/>
                      <a:pt x="7808" y="11415"/>
                    </a:cubicBezTo>
                    <a:cubicBezTo>
                      <a:pt x="7692" y="11415"/>
                      <a:pt x="7566" y="11416"/>
                      <a:pt x="7439" y="11416"/>
                    </a:cubicBezTo>
                    <a:cubicBezTo>
                      <a:pt x="6989" y="11416"/>
                      <a:pt x="6511" y="11402"/>
                      <a:pt x="6310" y="11272"/>
                    </a:cubicBezTo>
                    <a:cubicBezTo>
                      <a:pt x="5962" y="11054"/>
                      <a:pt x="5396" y="10815"/>
                      <a:pt x="5070" y="10619"/>
                    </a:cubicBezTo>
                    <a:cubicBezTo>
                      <a:pt x="4743" y="10401"/>
                      <a:pt x="5070" y="9705"/>
                      <a:pt x="5070" y="9335"/>
                    </a:cubicBezTo>
                    <a:cubicBezTo>
                      <a:pt x="5048" y="8965"/>
                      <a:pt x="6071" y="8291"/>
                      <a:pt x="6745" y="8030"/>
                    </a:cubicBezTo>
                    <a:cubicBezTo>
                      <a:pt x="7441" y="7790"/>
                      <a:pt x="8638" y="7877"/>
                      <a:pt x="8899" y="7399"/>
                    </a:cubicBezTo>
                    <a:cubicBezTo>
                      <a:pt x="9182" y="6920"/>
                      <a:pt x="8442" y="6463"/>
                      <a:pt x="8138" y="6463"/>
                    </a:cubicBezTo>
                    <a:cubicBezTo>
                      <a:pt x="7823" y="6463"/>
                      <a:pt x="5885" y="5895"/>
                      <a:pt x="5477" y="5895"/>
                    </a:cubicBezTo>
                    <a:cubicBezTo>
                      <a:pt x="5463" y="5895"/>
                      <a:pt x="5450" y="5896"/>
                      <a:pt x="5440" y="5897"/>
                    </a:cubicBezTo>
                    <a:cubicBezTo>
                      <a:pt x="5230" y="5925"/>
                      <a:pt x="4159" y="6043"/>
                      <a:pt x="3316" y="6043"/>
                    </a:cubicBezTo>
                    <a:cubicBezTo>
                      <a:pt x="2846" y="6043"/>
                      <a:pt x="2447" y="6006"/>
                      <a:pt x="2307" y="5897"/>
                    </a:cubicBezTo>
                    <a:cubicBezTo>
                      <a:pt x="1915" y="5593"/>
                      <a:pt x="0" y="2"/>
                      <a:pt x="0" y="1"/>
                    </a:cubicBezTo>
                    <a:close/>
                  </a:path>
                </a:pathLst>
              </a:custGeom>
              <a:solidFill>
                <a:srgbClr val="191919">
                  <a:alpha val="1761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03" name="Google Shape;503;p22"/>
              <p:cNvSpPr/>
              <p:nvPr/>
            </p:nvSpPr>
            <p:spPr>
              <a:xfrm>
                <a:off x="9723075" y="3918050"/>
                <a:ext cx="108825" cy="627750"/>
              </a:xfrm>
              <a:custGeom>
                <a:avLst/>
                <a:gdLst/>
                <a:ahLst/>
                <a:cxnLst/>
                <a:rect l="l" t="t" r="r" b="b"/>
                <a:pathLst>
                  <a:path w="4353" h="25110" extrusionOk="0">
                    <a:moveTo>
                      <a:pt x="2242" y="0"/>
                    </a:moveTo>
                    <a:lnTo>
                      <a:pt x="1" y="174"/>
                    </a:lnTo>
                    <a:cubicBezTo>
                      <a:pt x="1" y="174"/>
                      <a:pt x="1742" y="4743"/>
                      <a:pt x="1916" y="5744"/>
                    </a:cubicBezTo>
                    <a:cubicBezTo>
                      <a:pt x="2068" y="6745"/>
                      <a:pt x="2242" y="13468"/>
                      <a:pt x="2285" y="13860"/>
                    </a:cubicBezTo>
                    <a:cubicBezTo>
                      <a:pt x="2307" y="14230"/>
                      <a:pt x="3265" y="24609"/>
                      <a:pt x="3308" y="25109"/>
                    </a:cubicBezTo>
                    <a:lnTo>
                      <a:pt x="4244" y="25022"/>
                    </a:lnTo>
                    <a:cubicBezTo>
                      <a:pt x="4244" y="25022"/>
                      <a:pt x="4352" y="20627"/>
                      <a:pt x="4178" y="18408"/>
                    </a:cubicBezTo>
                    <a:cubicBezTo>
                      <a:pt x="3983" y="16210"/>
                      <a:pt x="3700" y="13969"/>
                      <a:pt x="3634" y="13229"/>
                    </a:cubicBezTo>
                    <a:cubicBezTo>
                      <a:pt x="3547" y="12489"/>
                      <a:pt x="3591" y="5766"/>
                      <a:pt x="3352" y="4265"/>
                    </a:cubicBezTo>
                    <a:cubicBezTo>
                      <a:pt x="3112" y="2742"/>
                      <a:pt x="2242" y="0"/>
                      <a:pt x="2242" y="0"/>
                    </a:cubicBezTo>
                    <a:close/>
                  </a:path>
                </a:pathLst>
              </a:custGeom>
              <a:solidFill>
                <a:srgbClr val="FFFFFF">
                  <a:alpha val="1824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04" name="Google Shape;504;p22"/>
              <p:cNvSpPr/>
              <p:nvPr/>
            </p:nvSpPr>
            <p:spPr>
              <a:xfrm>
                <a:off x="9620275" y="3983500"/>
                <a:ext cx="65300" cy="563375"/>
              </a:xfrm>
              <a:custGeom>
                <a:avLst/>
                <a:gdLst/>
                <a:ahLst/>
                <a:cxnLst/>
                <a:rect l="l" t="t" r="r" b="b"/>
                <a:pathLst>
                  <a:path w="2612" h="22535" extrusionOk="0">
                    <a:moveTo>
                      <a:pt x="1195" y="1"/>
                    </a:moveTo>
                    <a:cubicBezTo>
                      <a:pt x="675" y="1"/>
                      <a:pt x="161" y="365"/>
                      <a:pt x="109" y="994"/>
                    </a:cubicBezTo>
                    <a:cubicBezTo>
                      <a:pt x="22" y="2082"/>
                      <a:pt x="1" y="2844"/>
                      <a:pt x="88" y="3344"/>
                    </a:cubicBezTo>
                    <a:cubicBezTo>
                      <a:pt x="327" y="4606"/>
                      <a:pt x="675" y="10807"/>
                      <a:pt x="632" y="10959"/>
                    </a:cubicBezTo>
                    <a:cubicBezTo>
                      <a:pt x="588" y="11133"/>
                      <a:pt x="610" y="22491"/>
                      <a:pt x="610" y="22491"/>
                    </a:cubicBezTo>
                    <a:lnTo>
                      <a:pt x="653" y="22535"/>
                    </a:lnTo>
                    <a:lnTo>
                      <a:pt x="2198" y="22491"/>
                    </a:lnTo>
                    <a:cubicBezTo>
                      <a:pt x="2198" y="22491"/>
                      <a:pt x="2198" y="13113"/>
                      <a:pt x="2220" y="11656"/>
                    </a:cubicBezTo>
                    <a:cubicBezTo>
                      <a:pt x="2220" y="10176"/>
                      <a:pt x="2568" y="2408"/>
                      <a:pt x="2568" y="2408"/>
                    </a:cubicBezTo>
                    <a:lnTo>
                      <a:pt x="2568" y="1995"/>
                    </a:lnTo>
                    <a:lnTo>
                      <a:pt x="2612" y="1386"/>
                    </a:lnTo>
                    <a:lnTo>
                      <a:pt x="2133" y="559"/>
                    </a:lnTo>
                    <a:cubicBezTo>
                      <a:pt x="1919" y="176"/>
                      <a:pt x="1555" y="1"/>
                      <a:pt x="1195" y="1"/>
                    </a:cubicBezTo>
                    <a:close/>
                  </a:path>
                </a:pathLst>
              </a:custGeom>
              <a:solidFill>
                <a:srgbClr val="FFFFFF">
                  <a:alpha val="1824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05" name="Google Shape;505;p22"/>
              <p:cNvSpPr/>
              <p:nvPr/>
            </p:nvSpPr>
            <p:spPr>
              <a:xfrm>
                <a:off x="9653450" y="3600375"/>
                <a:ext cx="31575" cy="20700"/>
              </a:xfrm>
              <a:custGeom>
                <a:avLst/>
                <a:gdLst/>
                <a:ahLst/>
                <a:cxnLst/>
                <a:rect l="l" t="t" r="r" b="b"/>
                <a:pathLst>
                  <a:path w="1263" h="828" extrusionOk="0">
                    <a:moveTo>
                      <a:pt x="741" y="1"/>
                    </a:moveTo>
                    <a:lnTo>
                      <a:pt x="1" y="349"/>
                    </a:lnTo>
                    <a:lnTo>
                      <a:pt x="1263" y="827"/>
                    </a:lnTo>
                    <a:lnTo>
                      <a:pt x="1263" y="827"/>
                    </a:lnTo>
                    <a:lnTo>
                      <a:pt x="1110" y="109"/>
                    </a:lnTo>
                    <a:lnTo>
                      <a:pt x="741" y="1"/>
                    </a:lnTo>
                    <a:close/>
                  </a:path>
                </a:pathLst>
              </a:custGeom>
              <a:solidFill>
                <a:schemeClr val="l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06" name="Google Shape;506;p22"/>
              <p:cNvSpPr/>
              <p:nvPr/>
            </p:nvSpPr>
            <p:spPr>
              <a:xfrm>
                <a:off x="9685000" y="3600375"/>
                <a:ext cx="32125" cy="20700"/>
              </a:xfrm>
              <a:custGeom>
                <a:avLst/>
                <a:gdLst/>
                <a:ahLst/>
                <a:cxnLst/>
                <a:rect l="l" t="t" r="r" b="b"/>
                <a:pathLst>
                  <a:path w="1285" h="828" extrusionOk="0">
                    <a:moveTo>
                      <a:pt x="545" y="1"/>
                    </a:moveTo>
                    <a:lnTo>
                      <a:pt x="153" y="109"/>
                    </a:lnTo>
                    <a:lnTo>
                      <a:pt x="1" y="827"/>
                    </a:lnTo>
                    <a:lnTo>
                      <a:pt x="1285" y="349"/>
                    </a:lnTo>
                    <a:lnTo>
                      <a:pt x="545" y="1"/>
                    </a:lnTo>
                    <a:close/>
                  </a:path>
                </a:pathLst>
              </a:custGeom>
              <a:solidFill>
                <a:schemeClr val="l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07" name="Google Shape;507;p22"/>
              <p:cNvSpPr/>
              <p:nvPr/>
            </p:nvSpPr>
            <p:spPr>
              <a:xfrm>
                <a:off x="9584925" y="3917500"/>
                <a:ext cx="200750" cy="28850"/>
              </a:xfrm>
              <a:custGeom>
                <a:avLst/>
                <a:gdLst/>
                <a:ahLst/>
                <a:cxnLst/>
                <a:rect l="l" t="t" r="r" b="b"/>
                <a:pathLst>
                  <a:path w="8030" h="1154" extrusionOk="0">
                    <a:moveTo>
                      <a:pt x="7833" y="0"/>
                    </a:moveTo>
                    <a:lnTo>
                      <a:pt x="4004" y="240"/>
                    </a:lnTo>
                    <a:lnTo>
                      <a:pt x="131" y="109"/>
                    </a:lnTo>
                    <a:lnTo>
                      <a:pt x="0" y="980"/>
                    </a:lnTo>
                    <a:lnTo>
                      <a:pt x="3982" y="1154"/>
                    </a:lnTo>
                    <a:lnTo>
                      <a:pt x="8029" y="849"/>
                    </a:lnTo>
                    <a:lnTo>
                      <a:pt x="7833" y="0"/>
                    </a:lnTo>
                    <a:close/>
                  </a:path>
                </a:pathLst>
              </a:custGeom>
              <a:solidFill>
                <a:schemeClr val="l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08" name="Google Shape;508;p22"/>
              <p:cNvSpPr/>
              <p:nvPr/>
            </p:nvSpPr>
            <p:spPr>
              <a:xfrm>
                <a:off x="9663250" y="3921850"/>
                <a:ext cx="42450" cy="24500"/>
              </a:xfrm>
              <a:custGeom>
                <a:avLst/>
                <a:gdLst/>
                <a:ahLst/>
                <a:cxnLst/>
                <a:rect l="l" t="t" r="r" b="b"/>
                <a:pathLst>
                  <a:path w="1698" h="980" extrusionOk="0">
                    <a:moveTo>
                      <a:pt x="479" y="1"/>
                    </a:moveTo>
                    <a:cubicBezTo>
                      <a:pt x="218" y="1"/>
                      <a:pt x="0" y="218"/>
                      <a:pt x="0" y="479"/>
                    </a:cubicBezTo>
                    <a:cubicBezTo>
                      <a:pt x="0" y="762"/>
                      <a:pt x="218" y="980"/>
                      <a:pt x="479" y="980"/>
                    </a:cubicBezTo>
                    <a:lnTo>
                      <a:pt x="1197" y="980"/>
                    </a:lnTo>
                    <a:cubicBezTo>
                      <a:pt x="1480" y="980"/>
                      <a:pt x="1698" y="762"/>
                      <a:pt x="1698" y="479"/>
                    </a:cubicBezTo>
                    <a:cubicBezTo>
                      <a:pt x="1698" y="218"/>
                      <a:pt x="1480" y="1"/>
                      <a:pt x="1197" y="1"/>
                    </a:cubicBezTo>
                    <a:close/>
                  </a:path>
                </a:pathLst>
              </a:custGeom>
              <a:solidFill>
                <a:schemeClr val="accen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09" name="Google Shape;509;p22"/>
              <p:cNvSpPr/>
              <p:nvPr/>
            </p:nvSpPr>
            <p:spPr>
              <a:xfrm>
                <a:off x="9669775" y="3608000"/>
                <a:ext cx="31025" cy="27225"/>
              </a:xfrm>
              <a:custGeom>
                <a:avLst/>
                <a:gdLst/>
                <a:ahLst/>
                <a:cxnLst/>
                <a:rect l="l" t="t" r="r" b="b"/>
                <a:pathLst>
                  <a:path w="1241" h="1089" extrusionOk="0">
                    <a:moveTo>
                      <a:pt x="1" y="0"/>
                    </a:moveTo>
                    <a:lnTo>
                      <a:pt x="392" y="1088"/>
                    </a:lnTo>
                    <a:lnTo>
                      <a:pt x="893" y="1088"/>
                    </a:lnTo>
                    <a:lnTo>
                      <a:pt x="1241" y="0"/>
                    </a:ln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10" name="Google Shape;510;p22"/>
              <p:cNvSpPr/>
              <p:nvPr/>
            </p:nvSpPr>
            <p:spPr>
              <a:xfrm>
                <a:off x="9663250" y="3635200"/>
                <a:ext cx="42450" cy="295925"/>
              </a:xfrm>
              <a:custGeom>
                <a:avLst/>
                <a:gdLst/>
                <a:ahLst/>
                <a:cxnLst/>
                <a:rect l="l" t="t" r="r" b="b"/>
                <a:pathLst>
                  <a:path w="1698" h="11837" extrusionOk="0">
                    <a:moveTo>
                      <a:pt x="653" y="0"/>
                    </a:moveTo>
                    <a:lnTo>
                      <a:pt x="0" y="10879"/>
                    </a:lnTo>
                    <a:lnTo>
                      <a:pt x="893" y="11836"/>
                    </a:lnTo>
                    <a:lnTo>
                      <a:pt x="1698" y="10836"/>
                    </a:lnTo>
                    <a:lnTo>
                      <a:pt x="1154" y="0"/>
                    </a:ln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11" name="Google Shape;511;p22"/>
              <p:cNvSpPr/>
              <p:nvPr/>
            </p:nvSpPr>
            <p:spPr>
              <a:xfrm>
                <a:off x="9532150" y="3593300"/>
                <a:ext cx="128950" cy="447500"/>
              </a:xfrm>
              <a:custGeom>
                <a:avLst/>
                <a:gdLst/>
                <a:ahLst/>
                <a:cxnLst/>
                <a:rect l="l" t="t" r="r" b="b"/>
                <a:pathLst>
                  <a:path w="5158" h="17900" extrusionOk="0">
                    <a:moveTo>
                      <a:pt x="4178" y="1"/>
                    </a:moveTo>
                    <a:cubicBezTo>
                      <a:pt x="4178" y="1"/>
                      <a:pt x="806" y="588"/>
                      <a:pt x="414" y="762"/>
                    </a:cubicBezTo>
                    <a:cubicBezTo>
                      <a:pt x="1" y="936"/>
                      <a:pt x="1284" y="6528"/>
                      <a:pt x="1350" y="7986"/>
                    </a:cubicBezTo>
                    <a:cubicBezTo>
                      <a:pt x="1393" y="9422"/>
                      <a:pt x="1372" y="17799"/>
                      <a:pt x="1372" y="17799"/>
                    </a:cubicBezTo>
                    <a:lnTo>
                      <a:pt x="2220" y="17886"/>
                    </a:lnTo>
                    <a:cubicBezTo>
                      <a:pt x="2309" y="17895"/>
                      <a:pt x="2398" y="17899"/>
                      <a:pt x="2486" y="17899"/>
                    </a:cubicBezTo>
                    <a:cubicBezTo>
                      <a:pt x="2831" y="17899"/>
                      <a:pt x="3170" y="17833"/>
                      <a:pt x="3482" y="17712"/>
                    </a:cubicBezTo>
                    <a:lnTo>
                      <a:pt x="5070" y="17190"/>
                    </a:lnTo>
                    <a:lnTo>
                      <a:pt x="5157" y="7790"/>
                    </a:lnTo>
                    <a:lnTo>
                      <a:pt x="4178" y="1"/>
                    </a:ln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12" name="Google Shape;512;p22"/>
              <p:cNvSpPr/>
              <p:nvPr/>
            </p:nvSpPr>
            <p:spPr>
              <a:xfrm>
                <a:off x="9705675" y="3596025"/>
                <a:ext cx="130025" cy="443925"/>
              </a:xfrm>
              <a:custGeom>
                <a:avLst/>
                <a:gdLst/>
                <a:ahLst/>
                <a:cxnLst/>
                <a:rect l="l" t="t" r="r" b="b"/>
                <a:pathLst>
                  <a:path w="5201" h="17757" extrusionOk="0">
                    <a:moveTo>
                      <a:pt x="1197" y="0"/>
                    </a:moveTo>
                    <a:lnTo>
                      <a:pt x="1" y="7920"/>
                    </a:lnTo>
                    <a:lnTo>
                      <a:pt x="436" y="17102"/>
                    </a:lnTo>
                    <a:lnTo>
                      <a:pt x="2089" y="17624"/>
                    </a:lnTo>
                    <a:cubicBezTo>
                      <a:pt x="2342" y="17709"/>
                      <a:pt x="2613" y="17757"/>
                      <a:pt x="2891" y="17757"/>
                    </a:cubicBezTo>
                    <a:cubicBezTo>
                      <a:pt x="3043" y="17757"/>
                      <a:pt x="3197" y="17742"/>
                      <a:pt x="3351" y="17712"/>
                    </a:cubicBezTo>
                    <a:lnTo>
                      <a:pt x="5201" y="17429"/>
                    </a:lnTo>
                    <a:cubicBezTo>
                      <a:pt x="5201" y="17429"/>
                      <a:pt x="3917" y="9226"/>
                      <a:pt x="3895" y="7768"/>
                    </a:cubicBezTo>
                    <a:cubicBezTo>
                      <a:pt x="3874" y="6332"/>
                      <a:pt x="5114" y="610"/>
                      <a:pt x="4722" y="457"/>
                    </a:cubicBezTo>
                    <a:cubicBezTo>
                      <a:pt x="4309" y="305"/>
                      <a:pt x="1197" y="0"/>
                      <a:pt x="1197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13" name="Google Shape;513;p22"/>
              <p:cNvSpPr/>
              <p:nvPr/>
            </p:nvSpPr>
            <p:spPr>
              <a:xfrm>
                <a:off x="9619200" y="3572100"/>
                <a:ext cx="62025" cy="60400"/>
              </a:xfrm>
              <a:custGeom>
                <a:avLst/>
                <a:gdLst/>
                <a:ahLst/>
                <a:cxnLst/>
                <a:rect l="l" t="t" r="r" b="b"/>
                <a:pathLst>
                  <a:path w="2481" h="2416" extrusionOk="0">
                    <a:moveTo>
                      <a:pt x="740" y="0"/>
                    </a:moveTo>
                    <a:lnTo>
                      <a:pt x="0" y="870"/>
                    </a:lnTo>
                    <a:lnTo>
                      <a:pt x="1849" y="2415"/>
                    </a:lnTo>
                    <a:lnTo>
                      <a:pt x="2480" y="1240"/>
                    </a:lnTo>
                    <a:lnTo>
                      <a:pt x="740" y="0"/>
                    </a:lnTo>
                    <a:close/>
                  </a:path>
                </a:pathLst>
              </a:custGeom>
              <a:solidFill>
                <a:schemeClr val="dk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14" name="Google Shape;514;p22"/>
              <p:cNvSpPr/>
              <p:nvPr/>
            </p:nvSpPr>
            <p:spPr>
              <a:xfrm>
                <a:off x="9688825" y="3572100"/>
                <a:ext cx="62025" cy="60400"/>
              </a:xfrm>
              <a:custGeom>
                <a:avLst/>
                <a:gdLst/>
                <a:ahLst/>
                <a:cxnLst/>
                <a:rect l="l" t="t" r="r" b="b"/>
                <a:pathLst>
                  <a:path w="2481" h="2416" extrusionOk="0">
                    <a:moveTo>
                      <a:pt x="1741" y="0"/>
                    </a:moveTo>
                    <a:lnTo>
                      <a:pt x="0" y="1240"/>
                    </a:lnTo>
                    <a:lnTo>
                      <a:pt x="631" y="2415"/>
                    </a:lnTo>
                    <a:lnTo>
                      <a:pt x="2481" y="870"/>
                    </a:lnTo>
                    <a:lnTo>
                      <a:pt x="1741" y="0"/>
                    </a:lnTo>
                    <a:close/>
                  </a:path>
                </a:pathLst>
              </a:custGeom>
              <a:solidFill>
                <a:schemeClr val="dk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15" name="Google Shape;515;p22"/>
              <p:cNvSpPr/>
              <p:nvPr/>
            </p:nvSpPr>
            <p:spPr>
              <a:xfrm>
                <a:off x="9627900" y="3405525"/>
                <a:ext cx="121850" cy="158475"/>
              </a:xfrm>
              <a:custGeom>
                <a:avLst/>
                <a:gdLst/>
                <a:ahLst/>
                <a:cxnLst/>
                <a:rect l="l" t="t" r="r" b="b"/>
                <a:pathLst>
                  <a:path w="4874" h="6339" extrusionOk="0">
                    <a:moveTo>
                      <a:pt x="2510" y="1"/>
                    </a:moveTo>
                    <a:cubicBezTo>
                      <a:pt x="1278" y="1"/>
                      <a:pt x="214" y="1256"/>
                      <a:pt x="109" y="2877"/>
                    </a:cubicBezTo>
                    <a:cubicBezTo>
                      <a:pt x="0" y="4531"/>
                      <a:pt x="1219" y="6271"/>
                      <a:pt x="2241" y="6337"/>
                    </a:cubicBezTo>
                    <a:cubicBezTo>
                      <a:pt x="2263" y="6338"/>
                      <a:pt x="2284" y="6339"/>
                      <a:pt x="2305" y="6339"/>
                    </a:cubicBezTo>
                    <a:cubicBezTo>
                      <a:pt x="3361" y="6339"/>
                      <a:pt x="4659" y="4781"/>
                      <a:pt x="4765" y="3160"/>
                    </a:cubicBezTo>
                    <a:cubicBezTo>
                      <a:pt x="4874" y="1485"/>
                      <a:pt x="3917" y="70"/>
                      <a:pt x="2633" y="5"/>
                    </a:cubicBezTo>
                    <a:cubicBezTo>
                      <a:pt x="2592" y="2"/>
                      <a:pt x="2551" y="1"/>
                      <a:pt x="2510" y="1"/>
                    </a:cubicBezTo>
                    <a:close/>
                  </a:path>
                </a:pathLst>
              </a:custGeom>
              <a:solidFill>
                <a:srgbClr val="DAAA8E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16" name="Google Shape;516;p22"/>
              <p:cNvSpPr/>
              <p:nvPr/>
            </p:nvSpPr>
            <p:spPr>
              <a:xfrm>
                <a:off x="9620275" y="3401300"/>
                <a:ext cx="136025" cy="94650"/>
              </a:xfrm>
              <a:custGeom>
                <a:avLst/>
                <a:gdLst/>
                <a:ahLst/>
                <a:cxnLst/>
                <a:rect l="l" t="t" r="r" b="b"/>
                <a:pathLst>
                  <a:path w="5441" h="3786" extrusionOk="0">
                    <a:moveTo>
                      <a:pt x="2372" y="0"/>
                    </a:moveTo>
                    <a:cubicBezTo>
                      <a:pt x="2198" y="22"/>
                      <a:pt x="958" y="544"/>
                      <a:pt x="806" y="762"/>
                    </a:cubicBezTo>
                    <a:cubicBezTo>
                      <a:pt x="653" y="979"/>
                      <a:pt x="196" y="1697"/>
                      <a:pt x="109" y="2045"/>
                    </a:cubicBezTo>
                    <a:cubicBezTo>
                      <a:pt x="1" y="2393"/>
                      <a:pt x="305" y="3177"/>
                      <a:pt x="392" y="3373"/>
                    </a:cubicBezTo>
                    <a:cubicBezTo>
                      <a:pt x="392" y="3373"/>
                      <a:pt x="893" y="1806"/>
                      <a:pt x="1088" y="1697"/>
                    </a:cubicBezTo>
                    <a:cubicBezTo>
                      <a:pt x="1120" y="1684"/>
                      <a:pt x="1216" y="1679"/>
                      <a:pt x="1356" y="1679"/>
                    </a:cubicBezTo>
                    <a:cubicBezTo>
                      <a:pt x="2166" y="1679"/>
                      <a:pt x="4461" y="1872"/>
                      <a:pt x="4461" y="2002"/>
                    </a:cubicBezTo>
                    <a:cubicBezTo>
                      <a:pt x="4483" y="2154"/>
                      <a:pt x="5005" y="3786"/>
                      <a:pt x="5005" y="3786"/>
                    </a:cubicBezTo>
                    <a:cubicBezTo>
                      <a:pt x="5005" y="3786"/>
                      <a:pt x="5114" y="3612"/>
                      <a:pt x="5135" y="3568"/>
                    </a:cubicBezTo>
                    <a:cubicBezTo>
                      <a:pt x="5157" y="3503"/>
                      <a:pt x="5375" y="2763"/>
                      <a:pt x="5418" y="2676"/>
                    </a:cubicBezTo>
                    <a:cubicBezTo>
                      <a:pt x="5440" y="2589"/>
                      <a:pt x="5266" y="1937"/>
                      <a:pt x="5157" y="1697"/>
                    </a:cubicBezTo>
                    <a:cubicBezTo>
                      <a:pt x="5048" y="1458"/>
                      <a:pt x="4700" y="1088"/>
                      <a:pt x="4570" y="762"/>
                    </a:cubicBezTo>
                    <a:cubicBezTo>
                      <a:pt x="4439" y="457"/>
                      <a:pt x="3786" y="152"/>
                      <a:pt x="3417" y="65"/>
                    </a:cubicBezTo>
                    <a:cubicBezTo>
                      <a:pt x="3047" y="0"/>
                      <a:pt x="2568" y="0"/>
                      <a:pt x="2372" y="0"/>
                    </a:cubicBezTo>
                    <a:close/>
                  </a:path>
                </a:pathLst>
              </a:custGeom>
              <a:solidFill>
                <a:schemeClr val="accent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</p:grpSp>
        <p:sp>
          <p:nvSpPr>
            <p:cNvPr id="517" name="Google Shape;517;p22"/>
            <p:cNvSpPr/>
            <p:nvPr/>
          </p:nvSpPr>
          <p:spPr>
            <a:xfrm>
              <a:off x="-519608" y="4811475"/>
              <a:ext cx="1627556" cy="461704"/>
            </a:xfrm>
            <a:custGeom>
              <a:avLst/>
              <a:gdLst/>
              <a:ahLst/>
              <a:cxnLst/>
              <a:rect l="l" t="t" r="r" b="b"/>
              <a:pathLst>
                <a:path w="64014" h="9771" extrusionOk="0">
                  <a:moveTo>
                    <a:pt x="31876" y="1"/>
                  </a:moveTo>
                  <a:cubicBezTo>
                    <a:pt x="14187" y="1"/>
                    <a:pt x="1" y="2155"/>
                    <a:pt x="1" y="4875"/>
                  </a:cubicBezTo>
                  <a:cubicBezTo>
                    <a:pt x="1" y="7573"/>
                    <a:pt x="14339" y="9770"/>
                    <a:pt x="32007" y="9770"/>
                  </a:cubicBezTo>
                  <a:cubicBezTo>
                    <a:pt x="49674" y="9770"/>
                    <a:pt x="64013" y="7573"/>
                    <a:pt x="64013" y="4875"/>
                  </a:cubicBezTo>
                  <a:cubicBezTo>
                    <a:pt x="64013" y="2155"/>
                    <a:pt x="49544" y="1"/>
                    <a:pt x="31876" y="1"/>
                  </a:cubicBezTo>
                  <a:close/>
                </a:path>
              </a:pathLst>
            </a:custGeom>
            <a:solidFill>
              <a:srgbClr val="191919">
                <a:alpha val="17610"/>
              </a:srgb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grpSp>
          <p:nvGrpSpPr>
            <p:cNvPr id="518" name="Google Shape;518;p22"/>
            <p:cNvGrpSpPr/>
            <p:nvPr/>
          </p:nvGrpSpPr>
          <p:grpSpPr>
            <a:xfrm>
              <a:off x="-105150" y="2250975"/>
              <a:ext cx="798614" cy="2892524"/>
              <a:chOff x="-163725" y="2250975"/>
              <a:chExt cx="798614" cy="2892524"/>
            </a:xfrm>
          </p:grpSpPr>
          <p:sp>
            <p:nvSpPr>
              <p:cNvPr id="519" name="Google Shape;519;p22"/>
              <p:cNvSpPr/>
              <p:nvPr/>
            </p:nvSpPr>
            <p:spPr>
              <a:xfrm>
                <a:off x="212628" y="2758945"/>
                <a:ext cx="406911" cy="472834"/>
              </a:xfrm>
              <a:custGeom>
                <a:avLst/>
                <a:gdLst/>
                <a:ahLst/>
                <a:cxnLst/>
                <a:rect l="l" t="t" r="r" b="b"/>
                <a:pathLst>
                  <a:path w="5222" h="6068" extrusionOk="0">
                    <a:moveTo>
                      <a:pt x="1308" y="0"/>
                    </a:moveTo>
                    <a:cubicBezTo>
                      <a:pt x="1138" y="0"/>
                      <a:pt x="956" y="38"/>
                      <a:pt x="762" y="126"/>
                    </a:cubicBezTo>
                    <a:cubicBezTo>
                      <a:pt x="1" y="474"/>
                      <a:pt x="66" y="1214"/>
                      <a:pt x="458" y="1953"/>
                    </a:cubicBezTo>
                    <a:cubicBezTo>
                      <a:pt x="849" y="2671"/>
                      <a:pt x="3656" y="6022"/>
                      <a:pt x="3917" y="6066"/>
                    </a:cubicBezTo>
                    <a:cubicBezTo>
                      <a:pt x="3926" y="6067"/>
                      <a:pt x="3935" y="6068"/>
                      <a:pt x="3945" y="6068"/>
                    </a:cubicBezTo>
                    <a:cubicBezTo>
                      <a:pt x="4244" y="6068"/>
                      <a:pt x="5221" y="5445"/>
                      <a:pt x="5179" y="5087"/>
                    </a:cubicBezTo>
                    <a:cubicBezTo>
                      <a:pt x="5136" y="4695"/>
                      <a:pt x="3177" y="1496"/>
                      <a:pt x="2764" y="952"/>
                    </a:cubicBezTo>
                    <a:cubicBezTo>
                      <a:pt x="2421" y="524"/>
                      <a:pt x="1943" y="0"/>
                      <a:pt x="1308" y="0"/>
                    </a:cubicBez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20" name="Google Shape;520;p22"/>
              <p:cNvSpPr/>
              <p:nvPr/>
            </p:nvSpPr>
            <p:spPr>
              <a:xfrm>
                <a:off x="-151881" y="2480454"/>
                <a:ext cx="562990" cy="1236085"/>
              </a:xfrm>
              <a:custGeom>
                <a:avLst/>
                <a:gdLst/>
                <a:ahLst/>
                <a:cxnLst/>
                <a:rect l="l" t="t" r="r" b="b"/>
                <a:pathLst>
                  <a:path w="7225" h="15863" extrusionOk="0">
                    <a:moveTo>
                      <a:pt x="2960" y="1"/>
                    </a:moveTo>
                    <a:cubicBezTo>
                      <a:pt x="2960" y="1"/>
                      <a:pt x="2851" y="2438"/>
                      <a:pt x="2699" y="2568"/>
                    </a:cubicBezTo>
                    <a:cubicBezTo>
                      <a:pt x="2264" y="2938"/>
                      <a:pt x="653" y="3243"/>
                      <a:pt x="371" y="3896"/>
                    </a:cubicBezTo>
                    <a:cubicBezTo>
                      <a:pt x="1" y="4657"/>
                      <a:pt x="2002" y="8138"/>
                      <a:pt x="2264" y="9292"/>
                    </a:cubicBezTo>
                    <a:cubicBezTo>
                      <a:pt x="2525" y="10445"/>
                      <a:pt x="1981" y="12229"/>
                      <a:pt x="1807" y="13360"/>
                    </a:cubicBezTo>
                    <a:cubicBezTo>
                      <a:pt x="1633" y="14492"/>
                      <a:pt x="5179" y="15862"/>
                      <a:pt x="5310" y="15862"/>
                    </a:cubicBezTo>
                    <a:cubicBezTo>
                      <a:pt x="5440" y="15862"/>
                      <a:pt x="6593" y="14796"/>
                      <a:pt x="6811" y="14426"/>
                    </a:cubicBezTo>
                    <a:cubicBezTo>
                      <a:pt x="7029" y="14057"/>
                      <a:pt x="6811" y="11163"/>
                      <a:pt x="6811" y="10423"/>
                    </a:cubicBezTo>
                    <a:cubicBezTo>
                      <a:pt x="6811" y="9683"/>
                      <a:pt x="6985" y="7094"/>
                      <a:pt x="7007" y="6920"/>
                    </a:cubicBezTo>
                    <a:cubicBezTo>
                      <a:pt x="7224" y="5788"/>
                      <a:pt x="6942" y="4896"/>
                      <a:pt x="6898" y="4657"/>
                    </a:cubicBezTo>
                    <a:cubicBezTo>
                      <a:pt x="6855" y="4418"/>
                      <a:pt x="6855" y="4026"/>
                      <a:pt x="6746" y="3874"/>
                    </a:cubicBezTo>
                    <a:cubicBezTo>
                      <a:pt x="6506" y="3569"/>
                      <a:pt x="5179" y="3156"/>
                      <a:pt x="5157" y="3003"/>
                    </a:cubicBezTo>
                    <a:cubicBezTo>
                      <a:pt x="5136" y="2851"/>
                      <a:pt x="4962" y="741"/>
                      <a:pt x="4962" y="741"/>
                    </a:cubicBezTo>
                    <a:lnTo>
                      <a:pt x="2960" y="1"/>
                    </a:lnTo>
                    <a:close/>
                  </a:path>
                </a:pathLst>
              </a:custGeom>
              <a:solidFill>
                <a:srgbClr val="A2664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21" name="Google Shape;521;p22"/>
              <p:cNvSpPr/>
              <p:nvPr/>
            </p:nvSpPr>
            <p:spPr>
              <a:xfrm>
                <a:off x="-138323" y="2680556"/>
                <a:ext cx="544367" cy="787173"/>
              </a:xfrm>
              <a:custGeom>
                <a:avLst/>
                <a:gdLst/>
                <a:ahLst/>
                <a:cxnLst/>
                <a:rect l="l" t="t" r="r" b="b"/>
                <a:pathLst>
                  <a:path w="6986" h="10102" extrusionOk="0">
                    <a:moveTo>
                      <a:pt x="2525" y="0"/>
                    </a:moveTo>
                    <a:cubicBezTo>
                      <a:pt x="2525" y="0"/>
                      <a:pt x="1132" y="631"/>
                      <a:pt x="697" y="849"/>
                    </a:cubicBezTo>
                    <a:cubicBezTo>
                      <a:pt x="284" y="1045"/>
                      <a:pt x="1" y="1415"/>
                      <a:pt x="23" y="1980"/>
                    </a:cubicBezTo>
                    <a:cubicBezTo>
                      <a:pt x="44" y="2546"/>
                      <a:pt x="1807" y="6789"/>
                      <a:pt x="1872" y="7028"/>
                    </a:cubicBezTo>
                    <a:cubicBezTo>
                      <a:pt x="1916" y="7267"/>
                      <a:pt x="1393" y="9509"/>
                      <a:pt x="1676" y="9726"/>
                    </a:cubicBezTo>
                    <a:cubicBezTo>
                      <a:pt x="1741" y="9791"/>
                      <a:pt x="3330" y="9987"/>
                      <a:pt x="4744" y="10074"/>
                    </a:cubicBezTo>
                    <a:cubicBezTo>
                      <a:pt x="5364" y="10096"/>
                      <a:pt x="5876" y="10101"/>
                      <a:pt x="6232" y="10101"/>
                    </a:cubicBezTo>
                    <a:cubicBezTo>
                      <a:pt x="6588" y="10101"/>
                      <a:pt x="6789" y="10096"/>
                      <a:pt x="6789" y="10096"/>
                    </a:cubicBezTo>
                    <a:cubicBezTo>
                      <a:pt x="6789" y="10096"/>
                      <a:pt x="6702" y="8007"/>
                      <a:pt x="6768" y="7180"/>
                    </a:cubicBezTo>
                    <a:cubicBezTo>
                      <a:pt x="6855" y="6201"/>
                      <a:pt x="6855" y="5440"/>
                      <a:pt x="6898" y="4874"/>
                    </a:cubicBezTo>
                    <a:cubicBezTo>
                      <a:pt x="6985" y="3873"/>
                      <a:pt x="6963" y="2764"/>
                      <a:pt x="6898" y="2502"/>
                    </a:cubicBezTo>
                    <a:cubicBezTo>
                      <a:pt x="6833" y="2263"/>
                      <a:pt x="6746" y="1610"/>
                      <a:pt x="6572" y="1306"/>
                    </a:cubicBezTo>
                    <a:cubicBezTo>
                      <a:pt x="6398" y="1001"/>
                      <a:pt x="5070" y="544"/>
                      <a:pt x="5070" y="544"/>
                    </a:cubicBezTo>
                    <a:lnTo>
                      <a:pt x="4679" y="1284"/>
                    </a:lnTo>
                    <a:lnTo>
                      <a:pt x="2525" y="0"/>
                    </a:ln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22" name="Google Shape;522;p22"/>
              <p:cNvSpPr/>
              <p:nvPr/>
            </p:nvSpPr>
            <p:spPr>
              <a:xfrm>
                <a:off x="-101057" y="2738218"/>
                <a:ext cx="501977" cy="713458"/>
              </a:xfrm>
              <a:custGeom>
                <a:avLst/>
                <a:gdLst/>
                <a:ahLst/>
                <a:cxnLst/>
                <a:rect l="l" t="t" r="r" b="b"/>
                <a:pathLst>
                  <a:path w="6442" h="9156" extrusionOk="0">
                    <a:moveTo>
                      <a:pt x="654" y="0"/>
                    </a:moveTo>
                    <a:lnTo>
                      <a:pt x="654" y="0"/>
                    </a:lnTo>
                    <a:cubicBezTo>
                      <a:pt x="653" y="0"/>
                      <a:pt x="1" y="1197"/>
                      <a:pt x="23" y="1632"/>
                    </a:cubicBezTo>
                    <a:cubicBezTo>
                      <a:pt x="23" y="2089"/>
                      <a:pt x="1132" y="4983"/>
                      <a:pt x="1350" y="5592"/>
                    </a:cubicBezTo>
                    <a:cubicBezTo>
                      <a:pt x="1568" y="6179"/>
                      <a:pt x="893" y="8507"/>
                      <a:pt x="1176" y="8899"/>
                    </a:cubicBezTo>
                    <a:cubicBezTo>
                      <a:pt x="1314" y="9106"/>
                      <a:pt x="1837" y="9155"/>
                      <a:pt x="2298" y="9155"/>
                    </a:cubicBezTo>
                    <a:cubicBezTo>
                      <a:pt x="2707" y="9155"/>
                      <a:pt x="3069" y="9117"/>
                      <a:pt x="3069" y="9117"/>
                    </a:cubicBezTo>
                    <a:cubicBezTo>
                      <a:pt x="3069" y="9117"/>
                      <a:pt x="2590" y="8573"/>
                      <a:pt x="2808" y="8246"/>
                    </a:cubicBezTo>
                    <a:cubicBezTo>
                      <a:pt x="3047" y="7920"/>
                      <a:pt x="6441" y="6810"/>
                      <a:pt x="6441" y="6810"/>
                    </a:cubicBezTo>
                    <a:cubicBezTo>
                      <a:pt x="6441" y="6810"/>
                      <a:pt x="3961" y="5418"/>
                      <a:pt x="3395" y="5309"/>
                    </a:cubicBezTo>
                    <a:cubicBezTo>
                      <a:pt x="2851" y="5200"/>
                      <a:pt x="1002" y="2459"/>
                      <a:pt x="545" y="1849"/>
                    </a:cubicBezTo>
                    <a:cubicBezTo>
                      <a:pt x="110" y="1240"/>
                      <a:pt x="654" y="0"/>
                      <a:pt x="654" y="0"/>
                    </a:cubicBezTo>
                    <a:close/>
                  </a:path>
                </a:pathLst>
              </a:custGeom>
              <a:solidFill>
                <a:srgbClr val="191919">
                  <a:alpha val="1761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23" name="Google Shape;523;p22"/>
              <p:cNvSpPr/>
              <p:nvPr/>
            </p:nvSpPr>
            <p:spPr>
              <a:xfrm>
                <a:off x="66840" y="2548323"/>
                <a:ext cx="172988" cy="132312"/>
              </a:xfrm>
              <a:custGeom>
                <a:avLst/>
                <a:gdLst/>
                <a:ahLst/>
                <a:cxnLst/>
                <a:rect l="l" t="t" r="r" b="b"/>
                <a:pathLst>
                  <a:path w="2220" h="1698" extrusionOk="0">
                    <a:moveTo>
                      <a:pt x="66" y="0"/>
                    </a:moveTo>
                    <a:lnTo>
                      <a:pt x="1" y="1284"/>
                    </a:lnTo>
                    <a:lnTo>
                      <a:pt x="675" y="1697"/>
                    </a:lnTo>
                    <a:lnTo>
                      <a:pt x="2220" y="1088"/>
                    </a:lnTo>
                    <a:lnTo>
                      <a:pt x="66" y="0"/>
                    </a:lnTo>
                    <a:close/>
                  </a:path>
                </a:pathLst>
              </a:custGeom>
              <a:solidFill>
                <a:srgbClr val="191919">
                  <a:alpha val="1761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24" name="Google Shape;524;p22"/>
              <p:cNvSpPr/>
              <p:nvPr/>
            </p:nvSpPr>
            <p:spPr>
              <a:xfrm>
                <a:off x="-163725" y="2754192"/>
                <a:ext cx="203534" cy="533457"/>
              </a:xfrm>
              <a:custGeom>
                <a:avLst/>
                <a:gdLst/>
                <a:ahLst/>
                <a:cxnLst/>
                <a:rect l="l" t="t" r="r" b="b"/>
                <a:pathLst>
                  <a:path w="2612" h="6846" extrusionOk="0">
                    <a:moveTo>
                      <a:pt x="1127" y="1"/>
                    </a:moveTo>
                    <a:cubicBezTo>
                      <a:pt x="411" y="1"/>
                      <a:pt x="126" y="619"/>
                      <a:pt x="66" y="1405"/>
                    </a:cubicBezTo>
                    <a:cubicBezTo>
                      <a:pt x="0" y="2232"/>
                      <a:pt x="588" y="6540"/>
                      <a:pt x="784" y="6714"/>
                    </a:cubicBezTo>
                    <a:cubicBezTo>
                      <a:pt x="868" y="6798"/>
                      <a:pt x="1139" y="6846"/>
                      <a:pt x="1436" y="6846"/>
                    </a:cubicBezTo>
                    <a:cubicBezTo>
                      <a:pt x="1832" y="6846"/>
                      <a:pt x="2273" y="6761"/>
                      <a:pt x="2372" y="6562"/>
                    </a:cubicBezTo>
                    <a:cubicBezTo>
                      <a:pt x="2546" y="6214"/>
                      <a:pt x="2611" y="2471"/>
                      <a:pt x="2546" y="1775"/>
                    </a:cubicBezTo>
                    <a:cubicBezTo>
                      <a:pt x="2459" y="1101"/>
                      <a:pt x="2285" y="143"/>
                      <a:pt x="1306" y="13"/>
                    </a:cubicBezTo>
                    <a:cubicBezTo>
                      <a:pt x="1244" y="5"/>
                      <a:pt x="1184" y="1"/>
                      <a:pt x="1127" y="1"/>
                    </a:cubicBez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25" name="Google Shape;525;p22"/>
              <p:cNvSpPr/>
              <p:nvPr/>
            </p:nvSpPr>
            <p:spPr>
              <a:xfrm>
                <a:off x="4115" y="2258222"/>
                <a:ext cx="332417" cy="373794"/>
              </a:xfrm>
              <a:custGeom>
                <a:avLst/>
                <a:gdLst/>
                <a:ahLst/>
                <a:cxnLst/>
                <a:rect l="l" t="t" r="r" b="b"/>
                <a:pathLst>
                  <a:path w="4266" h="4797" extrusionOk="0">
                    <a:moveTo>
                      <a:pt x="2013" y="0"/>
                    </a:moveTo>
                    <a:cubicBezTo>
                      <a:pt x="1610" y="0"/>
                      <a:pt x="1209" y="133"/>
                      <a:pt x="893" y="481"/>
                    </a:cubicBezTo>
                    <a:cubicBezTo>
                      <a:pt x="0" y="1417"/>
                      <a:pt x="196" y="2505"/>
                      <a:pt x="523" y="3201"/>
                    </a:cubicBezTo>
                    <a:cubicBezTo>
                      <a:pt x="784" y="3745"/>
                      <a:pt x="1067" y="4050"/>
                      <a:pt x="1632" y="4419"/>
                    </a:cubicBezTo>
                    <a:cubicBezTo>
                      <a:pt x="1752" y="4479"/>
                      <a:pt x="2700" y="4797"/>
                      <a:pt x="3038" y="4797"/>
                    </a:cubicBezTo>
                    <a:cubicBezTo>
                      <a:pt x="3068" y="4797"/>
                      <a:pt x="3093" y="4795"/>
                      <a:pt x="3112" y="4789"/>
                    </a:cubicBezTo>
                    <a:cubicBezTo>
                      <a:pt x="3264" y="4768"/>
                      <a:pt x="3525" y="3614"/>
                      <a:pt x="3591" y="3614"/>
                    </a:cubicBezTo>
                    <a:cubicBezTo>
                      <a:pt x="3598" y="3618"/>
                      <a:pt x="3608" y="3620"/>
                      <a:pt x="3619" y="3620"/>
                    </a:cubicBezTo>
                    <a:cubicBezTo>
                      <a:pt x="3675" y="3620"/>
                      <a:pt x="3768" y="3574"/>
                      <a:pt x="3786" y="3484"/>
                    </a:cubicBezTo>
                    <a:cubicBezTo>
                      <a:pt x="3808" y="3353"/>
                      <a:pt x="3765" y="2505"/>
                      <a:pt x="3808" y="2418"/>
                    </a:cubicBezTo>
                    <a:cubicBezTo>
                      <a:pt x="3852" y="2331"/>
                      <a:pt x="4265" y="1395"/>
                      <a:pt x="3721" y="764"/>
                    </a:cubicBezTo>
                    <a:cubicBezTo>
                      <a:pt x="3431" y="404"/>
                      <a:pt x="2717" y="0"/>
                      <a:pt x="2013" y="0"/>
                    </a:cubicBezTo>
                    <a:close/>
                  </a:path>
                </a:pathLst>
              </a:custGeom>
              <a:solidFill>
                <a:srgbClr val="A2664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26" name="Google Shape;526;p22"/>
              <p:cNvSpPr/>
              <p:nvPr/>
            </p:nvSpPr>
            <p:spPr>
              <a:xfrm>
                <a:off x="-4379" y="2250975"/>
                <a:ext cx="318859" cy="302495"/>
              </a:xfrm>
              <a:custGeom>
                <a:avLst/>
                <a:gdLst/>
                <a:ahLst/>
                <a:cxnLst/>
                <a:rect l="l" t="t" r="r" b="b"/>
                <a:pathLst>
                  <a:path w="4092" h="3882" extrusionOk="0">
                    <a:moveTo>
                      <a:pt x="2362" y="0"/>
                    </a:moveTo>
                    <a:cubicBezTo>
                      <a:pt x="1844" y="0"/>
                      <a:pt x="1024" y="197"/>
                      <a:pt x="588" y="1053"/>
                    </a:cubicBezTo>
                    <a:cubicBezTo>
                      <a:pt x="1" y="2228"/>
                      <a:pt x="697" y="3860"/>
                      <a:pt x="980" y="3881"/>
                    </a:cubicBezTo>
                    <a:cubicBezTo>
                      <a:pt x="1089" y="3881"/>
                      <a:pt x="1502" y="3337"/>
                      <a:pt x="1306" y="2228"/>
                    </a:cubicBezTo>
                    <a:cubicBezTo>
                      <a:pt x="1306" y="2221"/>
                      <a:pt x="1309" y="2218"/>
                      <a:pt x="1313" y="2218"/>
                    </a:cubicBezTo>
                    <a:cubicBezTo>
                      <a:pt x="1382" y="2218"/>
                      <a:pt x="1945" y="2908"/>
                      <a:pt x="2054" y="2908"/>
                    </a:cubicBezTo>
                    <a:cubicBezTo>
                      <a:pt x="2060" y="2908"/>
                      <a:pt x="2065" y="2906"/>
                      <a:pt x="2068" y="2902"/>
                    </a:cubicBezTo>
                    <a:cubicBezTo>
                      <a:pt x="2133" y="2837"/>
                      <a:pt x="1807" y="1858"/>
                      <a:pt x="2068" y="1662"/>
                    </a:cubicBezTo>
                    <a:cubicBezTo>
                      <a:pt x="2575" y="1299"/>
                      <a:pt x="3011" y="1194"/>
                      <a:pt x="3347" y="1194"/>
                    </a:cubicBezTo>
                    <a:cubicBezTo>
                      <a:pt x="3817" y="1194"/>
                      <a:pt x="4091" y="1401"/>
                      <a:pt x="4091" y="1401"/>
                    </a:cubicBezTo>
                    <a:cubicBezTo>
                      <a:pt x="3982" y="357"/>
                      <a:pt x="3069" y="161"/>
                      <a:pt x="2764" y="52"/>
                    </a:cubicBezTo>
                    <a:cubicBezTo>
                      <a:pt x="2685" y="24"/>
                      <a:pt x="2542" y="0"/>
                      <a:pt x="2362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27" name="Google Shape;527;p22"/>
              <p:cNvSpPr/>
              <p:nvPr/>
            </p:nvSpPr>
            <p:spPr>
              <a:xfrm>
                <a:off x="85463" y="2414142"/>
                <a:ext cx="54390" cy="100442"/>
              </a:xfrm>
              <a:custGeom>
                <a:avLst/>
                <a:gdLst/>
                <a:ahLst/>
                <a:cxnLst/>
                <a:rect l="l" t="t" r="r" b="b"/>
                <a:pathLst>
                  <a:path w="698" h="1289" extrusionOk="0">
                    <a:moveTo>
                      <a:pt x="329" y="1"/>
                    </a:moveTo>
                    <a:cubicBezTo>
                      <a:pt x="315" y="1"/>
                      <a:pt x="300" y="1"/>
                      <a:pt x="284" y="3"/>
                    </a:cubicBezTo>
                    <a:cubicBezTo>
                      <a:pt x="110" y="25"/>
                      <a:pt x="1" y="351"/>
                      <a:pt x="66" y="700"/>
                    </a:cubicBezTo>
                    <a:cubicBezTo>
                      <a:pt x="108" y="1034"/>
                      <a:pt x="311" y="1288"/>
                      <a:pt x="481" y="1288"/>
                    </a:cubicBezTo>
                    <a:cubicBezTo>
                      <a:pt x="488" y="1288"/>
                      <a:pt x="495" y="1288"/>
                      <a:pt x="501" y="1287"/>
                    </a:cubicBezTo>
                    <a:cubicBezTo>
                      <a:pt x="697" y="1265"/>
                      <a:pt x="697" y="787"/>
                      <a:pt x="632" y="438"/>
                    </a:cubicBezTo>
                    <a:cubicBezTo>
                      <a:pt x="592" y="118"/>
                      <a:pt x="497" y="1"/>
                      <a:pt x="329" y="1"/>
                    </a:cubicBezTo>
                    <a:close/>
                  </a:path>
                </a:pathLst>
              </a:custGeom>
              <a:solidFill>
                <a:srgbClr val="A2664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28" name="Google Shape;528;p22"/>
              <p:cNvSpPr/>
              <p:nvPr/>
            </p:nvSpPr>
            <p:spPr>
              <a:xfrm>
                <a:off x="141409" y="5055834"/>
                <a:ext cx="108624" cy="20416"/>
              </a:xfrm>
              <a:custGeom>
                <a:avLst/>
                <a:gdLst/>
                <a:ahLst/>
                <a:cxnLst/>
                <a:rect l="l" t="t" r="r" b="b"/>
                <a:pathLst>
                  <a:path w="1394" h="262" extrusionOk="0">
                    <a:moveTo>
                      <a:pt x="1" y="0"/>
                    </a:moveTo>
                    <a:lnTo>
                      <a:pt x="1" y="261"/>
                    </a:lnTo>
                    <a:lnTo>
                      <a:pt x="1393" y="261"/>
                    </a:lnTo>
                    <a:lnTo>
                      <a:pt x="1393" y="0"/>
                    </a:lnTo>
                    <a:close/>
                  </a:path>
                </a:pathLst>
              </a:custGeom>
              <a:solidFill>
                <a:srgbClr val="191919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29" name="Google Shape;529;p22"/>
              <p:cNvSpPr/>
              <p:nvPr/>
            </p:nvSpPr>
            <p:spPr>
              <a:xfrm>
                <a:off x="119436" y="4912459"/>
                <a:ext cx="412054" cy="180780"/>
              </a:xfrm>
              <a:custGeom>
                <a:avLst/>
                <a:gdLst/>
                <a:ahLst/>
                <a:cxnLst/>
                <a:rect l="l" t="t" r="r" b="b"/>
                <a:pathLst>
                  <a:path w="5288" h="2320" extrusionOk="0">
                    <a:moveTo>
                      <a:pt x="501" y="0"/>
                    </a:moveTo>
                    <a:cubicBezTo>
                      <a:pt x="411" y="0"/>
                      <a:pt x="353" y="4"/>
                      <a:pt x="348" y="13"/>
                    </a:cubicBezTo>
                    <a:cubicBezTo>
                      <a:pt x="152" y="274"/>
                      <a:pt x="44" y="752"/>
                      <a:pt x="22" y="992"/>
                    </a:cubicBezTo>
                    <a:cubicBezTo>
                      <a:pt x="0" y="1253"/>
                      <a:pt x="152" y="1840"/>
                      <a:pt x="348" y="1840"/>
                    </a:cubicBezTo>
                    <a:cubicBezTo>
                      <a:pt x="870" y="1840"/>
                      <a:pt x="1480" y="1862"/>
                      <a:pt x="2024" y="1927"/>
                    </a:cubicBezTo>
                    <a:cubicBezTo>
                      <a:pt x="2568" y="1993"/>
                      <a:pt x="2763" y="2319"/>
                      <a:pt x="4156" y="2319"/>
                    </a:cubicBezTo>
                    <a:cubicBezTo>
                      <a:pt x="4548" y="2319"/>
                      <a:pt x="5287" y="2276"/>
                      <a:pt x="5266" y="2123"/>
                    </a:cubicBezTo>
                    <a:cubicBezTo>
                      <a:pt x="5244" y="1949"/>
                      <a:pt x="3938" y="1666"/>
                      <a:pt x="3525" y="1275"/>
                    </a:cubicBezTo>
                    <a:cubicBezTo>
                      <a:pt x="2459" y="296"/>
                      <a:pt x="1741" y="56"/>
                      <a:pt x="1741" y="56"/>
                    </a:cubicBezTo>
                    <a:cubicBezTo>
                      <a:pt x="1741" y="56"/>
                      <a:pt x="863" y="0"/>
                      <a:pt x="501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30" name="Google Shape;530;p22"/>
              <p:cNvSpPr/>
              <p:nvPr/>
            </p:nvSpPr>
            <p:spPr>
              <a:xfrm>
                <a:off x="39724" y="3463978"/>
                <a:ext cx="359534" cy="1502502"/>
              </a:xfrm>
              <a:custGeom>
                <a:avLst/>
                <a:gdLst/>
                <a:ahLst/>
                <a:cxnLst/>
                <a:rect l="l" t="t" r="r" b="b"/>
                <a:pathLst>
                  <a:path w="4614" h="19282" extrusionOk="0">
                    <a:moveTo>
                      <a:pt x="4380" y="0"/>
                    </a:moveTo>
                    <a:cubicBezTo>
                      <a:pt x="3680" y="0"/>
                      <a:pt x="262" y="999"/>
                      <a:pt x="262" y="999"/>
                    </a:cubicBezTo>
                    <a:cubicBezTo>
                      <a:pt x="262" y="999"/>
                      <a:pt x="174" y="1565"/>
                      <a:pt x="87" y="2370"/>
                    </a:cubicBezTo>
                    <a:cubicBezTo>
                      <a:pt x="0" y="3175"/>
                      <a:pt x="784" y="5743"/>
                      <a:pt x="1067" y="7766"/>
                    </a:cubicBezTo>
                    <a:cubicBezTo>
                      <a:pt x="1328" y="9790"/>
                      <a:pt x="1502" y="10203"/>
                      <a:pt x="1436" y="10682"/>
                    </a:cubicBezTo>
                    <a:cubicBezTo>
                      <a:pt x="1371" y="11160"/>
                      <a:pt x="762" y="13097"/>
                      <a:pt x="849" y="14381"/>
                    </a:cubicBezTo>
                    <a:cubicBezTo>
                      <a:pt x="914" y="15686"/>
                      <a:pt x="1175" y="19059"/>
                      <a:pt x="1175" y="19059"/>
                    </a:cubicBezTo>
                    <a:cubicBezTo>
                      <a:pt x="1175" y="19059"/>
                      <a:pt x="1567" y="19233"/>
                      <a:pt x="2220" y="19276"/>
                    </a:cubicBezTo>
                    <a:cubicBezTo>
                      <a:pt x="2257" y="19280"/>
                      <a:pt x="2293" y="19281"/>
                      <a:pt x="2328" y="19281"/>
                    </a:cubicBezTo>
                    <a:cubicBezTo>
                      <a:pt x="2943" y="19281"/>
                      <a:pt x="3351" y="18776"/>
                      <a:pt x="3351" y="18776"/>
                    </a:cubicBezTo>
                    <a:cubicBezTo>
                      <a:pt x="3351" y="18776"/>
                      <a:pt x="3873" y="11247"/>
                      <a:pt x="3960" y="10464"/>
                    </a:cubicBezTo>
                    <a:cubicBezTo>
                      <a:pt x="4026" y="9942"/>
                      <a:pt x="4439" y="6395"/>
                      <a:pt x="4570" y="3502"/>
                    </a:cubicBezTo>
                    <a:cubicBezTo>
                      <a:pt x="4613" y="2566"/>
                      <a:pt x="4504" y="412"/>
                      <a:pt x="4504" y="42"/>
                    </a:cubicBezTo>
                    <a:cubicBezTo>
                      <a:pt x="4504" y="13"/>
                      <a:pt x="4460" y="0"/>
                      <a:pt x="4380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31" name="Google Shape;531;p22"/>
              <p:cNvSpPr/>
              <p:nvPr/>
            </p:nvSpPr>
            <p:spPr>
              <a:xfrm>
                <a:off x="-41624" y="3440056"/>
                <a:ext cx="371379" cy="1526736"/>
              </a:xfrm>
              <a:custGeom>
                <a:avLst/>
                <a:gdLst/>
                <a:ahLst/>
                <a:cxnLst/>
                <a:rect l="l" t="t" r="r" b="b"/>
                <a:pathLst>
                  <a:path w="4766" h="19593" extrusionOk="0">
                    <a:moveTo>
                      <a:pt x="457" y="1"/>
                    </a:moveTo>
                    <a:cubicBezTo>
                      <a:pt x="457" y="1"/>
                      <a:pt x="0" y="1198"/>
                      <a:pt x="0" y="2198"/>
                    </a:cubicBezTo>
                    <a:cubicBezTo>
                      <a:pt x="22" y="3004"/>
                      <a:pt x="239" y="4505"/>
                      <a:pt x="522" y="6528"/>
                    </a:cubicBezTo>
                    <a:cubicBezTo>
                      <a:pt x="805" y="8552"/>
                      <a:pt x="827" y="10423"/>
                      <a:pt x="762" y="10902"/>
                    </a:cubicBezTo>
                    <a:cubicBezTo>
                      <a:pt x="696" y="11380"/>
                      <a:pt x="44" y="13404"/>
                      <a:pt x="131" y="14688"/>
                    </a:cubicBezTo>
                    <a:cubicBezTo>
                      <a:pt x="196" y="15993"/>
                      <a:pt x="544" y="19170"/>
                      <a:pt x="544" y="19170"/>
                    </a:cubicBezTo>
                    <a:cubicBezTo>
                      <a:pt x="544" y="19170"/>
                      <a:pt x="957" y="19518"/>
                      <a:pt x="1610" y="19583"/>
                    </a:cubicBezTo>
                    <a:cubicBezTo>
                      <a:pt x="1680" y="19590"/>
                      <a:pt x="1747" y="19593"/>
                      <a:pt x="1810" y="19593"/>
                    </a:cubicBezTo>
                    <a:cubicBezTo>
                      <a:pt x="2361" y="19593"/>
                      <a:pt x="2676" y="19366"/>
                      <a:pt x="2676" y="19366"/>
                    </a:cubicBezTo>
                    <a:cubicBezTo>
                      <a:pt x="2676" y="19366"/>
                      <a:pt x="3438" y="11816"/>
                      <a:pt x="3742" y="11076"/>
                    </a:cubicBezTo>
                    <a:cubicBezTo>
                      <a:pt x="4221" y="9901"/>
                      <a:pt x="4308" y="6158"/>
                      <a:pt x="4635" y="3613"/>
                    </a:cubicBezTo>
                    <a:cubicBezTo>
                      <a:pt x="4765" y="2590"/>
                      <a:pt x="4678" y="306"/>
                      <a:pt x="4678" y="306"/>
                    </a:cubicBezTo>
                    <a:lnTo>
                      <a:pt x="457" y="1"/>
                    </a:ln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32" name="Google Shape;532;p22"/>
              <p:cNvSpPr/>
              <p:nvPr/>
            </p:nvSpPr>
            <p:spPr>
              <a:xfrm>
                <a:off x="-41637" y="3440056"/>
                <a:ext cx="371379" cy="1526736"/>
              </a:xfrm>
              <a:custGeom>
                <a:avLst/>
                <a:gdLst/>
                <a:ahLst/>
                <a:cxnLst/>
                <a:rect l="l" t="t" r="r" b="b"/>
                <a:pathLst>
                  <a:path w="4766" h="19593" extrusionOk="0">
                    <a:moveTo>
                      <a:pt x="457" y="1"/>
                    </a:moveTo>
                    <a:cubicBezTo>
                      <a:pt x="457" y="1"/>
                      <a:pt x="0" y="1198"/>
                      <a:pt x="0" y="2198"/>
                    </a:cubicBezTo>
                    <a:cubicBezTo>
                      <a:pt x="22" y="3004"/>
                      <a:pt x="239" y="4505"/>
                      <a:pt x="522" y="6528"/>
                    </a:cubicBezTo>
                    <a:cubicBezTo>
                      <a:pt x="805" y="8552"/>
                      <a:pt x="827" y="10423"/>
                      <a:pt x="762" y="10902"/>
                    </a:cubicBezTo>
                    <a:cubicBezTo>
                      <a:pt x="696" y="11380"/>
                      <a:pt x="44" y="13404"/>
                      <a:pt x="131" y="14688"/>
                    </a:cubicBezTo>
                    <a:cubicBezTo>
                      <a:pt x="196" y="15993"/>
                      <a:pt x="544" y="19170"/>
                      <a:pt x="544" y="19170"/>
                    </a:cubicBezTo>
                    <a:cubicBezTo>
                      <a:pt x="544" y="19170"/>
                      <a:pt x="957" y="19518"/>
                      <a:pt x="1610" y="19583"/>
                    </a:cubicBezTo>
                    <a:cubicBezTo>
                      <a:pt x="1680" y="19590"/>
                      <a:pt x="1747" y="19593"/>
                      <a:pt x="1810" y="19593"/>
                    </a:cubicBezTo>
                    <a:cubicBezTo>
                      <a:pt x="2361" y="19593"/>
                      <a:pt x="2676" y="19366"/>
                      <a:pt x="2676" y="19366"/>
                    </a:cubicBezTo>
                    <a:cubicBezTo>
                      <a:pt x="2676" y="19366"/>
                      <a:pt x="3438" y="11816"/>
                      <a:pt x="3742" y="11076"/>
                    </a:cubicBezTo>
                    <a:cubicBezTo>
                      <a:pt x="4221" y="9901"/>
                      <a:pt x="4308" y="6158"/>
                      <a:pt x="4635" y="3613"/>
                    </a:cubicBezTo>
                    <a:cubicBezTo>
                      <a:pt x="4765" y="2590"/>
                      <a:pt x="4678" y="306"/>
                      <a:pt x="4678" y="306"/>
                    </a:cubicBezTo>
                    <a:lnTo>
                      <a:pt x="457" y="1"/>
                    </a:lnTo>
                    <a:close/>
                  </a:path>
                </a:pathLst>
              </a:custGeom>
              <a:solidFill>
                <a:srgbClr val="FFFFFF">
                  <a:alpha val="1824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33" name="Google Shape;533;p22"/>
              <p:cNvSpPr/>
              <p:nvPr/>
            </p:nvSpPr>
            <p:spPr>
              <a:xfrm>
                <a:off x="-2677" y="5084665"/>
                <a:ext cx="108546" cy="28909"/>
              </a:xfrm>
              <a:custGeom>
                <a:avLst/>
                <a:gdLst/>
                <a:ahLst/>
                <a:cxnLst/>
                <a:rect l="l" t="t" r="r" b="b"/>
                <a:pathLst>
                  <a:path w="1393" h="371" extrusionOk="0">
                    <a:moveTo>
                      <a:pt x="22" y="0"/>
                    </a:moveTo>
                    <a:lnTo>
                      <a:pt x="0" y="283"/>
                    </a:lnTo>
                    <a:lnTo>
                      <a:pt x="1371" y="370"/>
                    </a:lnTo>
                    <a:lnTo>
                      <a:pt x="1393" y="87"/>
                    </a:lnTo>
                    <a:lnTo>
                      <a:pt x="22" y="0"/>
                    </a:lnTo>
                    <a:close/>
                  </a:path>
                </a:pathLst>
              </a:custGeom>
              <a:solidFill>
                <a:srgbClr val="FFFFFF">
                  <a:alpha val="1824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34" name="Google Shape;534;p22"/>
              <p:cNvSpPr/>
              <p:nvPr/>
            </p:nvSpPr>
            <p:spPr>
              <a:xfrm>
                <a:off x="-21300" y="4938329"/>
                <a:ext cx="406366" cy="205170"/>
              </a:xfrm>
              <a:custGeom>
                <a:avLst/>
                <a:gdLst/>
                <a:ahLst/>
                <a:cxnLst/>
                <a:rect l="l" t="t" r="r" b="b"/>
                <a:pathLst>
                  <a:path w="5215" h="2633" extrusionOk="0">
                    <a:moveTo>
                      <a:pt x="495" y="0"/>
                    </a:moveTo>
                    <a:cubicBezTo>
                      <a:pt x="461" y="0"/>
                      <a:pt x="440" y="2"/>
                      <a:pt x="435" y="7"/>
                    </a:cubicBezTo>
                    <a:cubicBezTo>
                      <a:pt x="239" y="268"/>
                      <a:pt x="65" y="769"/>
                      <a:pt x="44" y="986"/>
                    </a:cubicBezTo>
                    <a:cubicBezTo>
                      <a:pt x="0" y="1269"/>
                      <a:pt x="131" y="1878"/>
                      <a:pt x="305" y="1900"/>
                    </a:cubicBezTo>
                    <a:cubicBezTo>
                      <a:pt x="827" y="1922"/>
                      <a:pt x="1458" y="1987"/>
                      <a:pt x="1980" y="2096"/>
                    </a:cubicBezTo>
                    <a:cubicBezTo>
                      <a:pt x="2524" y="2205"/>
                      <a:pt x="2698" y="2531"/>
                      <a:pt x="4091" y="2618"/>
                    </a:cubicBezTo>
                    <a:cubicBezTo>
                      <a:pt x="4221" y="2625"/>
                      <a:pt x="4390" y="2633"/>
                      <a:pt x="4557" y="2633"/>
                    </a:cubicBezTo>
                    <a:cubicBezTo>
                      <a:pt x="4891" y="2633"/>
                      <a:pt x="5215" y="2604"/>
                      <a:pt x="5200" y="2487"/>
                    </a:cubicBezTo>
                    <a:cubicBezTo>
                      <a:pt x="5200" y="2313"/>
                      <a:pt x="3917" y="1922"/>
                      <a:pt x="3525" y="1508"/>
                    </a:cubicBezTo>
                    <a:cubicBezTo>
                      <a:pt x="2524" y="420"/>
                      <a:pt x="1828" y="138"/>
                      <a:pt x="1828" y="138"/>
                    </a:cubicBezTo>
                    <a:cubicBezTo>
                      <a:pt x="1828" y="138"/>
                      <a:pt x="762" y="0"/>
                      <a:pt x="495" y="0"/>
                    </a:cubicBezTo>
                    <a:close/>
                  </a:path>
                </a:pathLst>
              </a:custGeom>
              <a:solidFill>
                <a:srgbClr val="FFFFFF">
                  <a:alpha val="1824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35" name="Google Shape;535;p22"/>
              <p:cNvSpPr/>
              <p:nvPr/>
            </p:nvSpPr>
            <p:spPr>
              <a:xfrm>
                <a:off x="-2665" y="5084665"/>
                <a:ext cx="108546" cy="28909"/>
              </a:xfrm>
              <a:custGeom>
                <a:avLst/>
                <a:gdLst/>
                <a:ahLst/>
                <a:cxnLst/>
                <a:rect l="l" t="t" r="r" b="b"/>
                <a:pathLst>
                  <a:path w="1393" h="371" extrusionOk="0">
                    <a:moveTo>
                      <a:pt x="22" y="0"/>
                    </a:moveTo>
                    <a:lnTo>
                      <a:pt x="0" y="283"/>
                    </a:lnTo>
                    <a:lnTo>
                      <a:pt x="1371" y="370"/>
                    </a:lnTo>
                    <a:lnTo>
                      <a:pt x="1393" y="87"/>
                    </a:lnTo>
                    <a:lnTo>
                      <a:pt x="22" y="0"/>
                    </a:ln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36" name="Google Shape;536;p22"/>
              <p:cNvSpPr/>
              <p:nvPr/>
            </p:nvSpPr>
            <p:spPr>
              <a:xfrm>
                <a:off x="-21287" y="4938329"/>
                <a:ext cx="406366" cy="205170"/>
              </a:xfrm>
              <a:custGeom>
                <a:avLst/>
                <a:gdLst/>
                <a:ahLst/>
                <a:cxnLst/>
                <a:rect l="l" t="t" r="r" b="b"/>
                <a:pathLst>
                  <a:path w="5215" h="2633" extrusionOk="0">
                    <a:moveTo>
                      <a:pt x="495" y="0"/>
                    </a:moveTo>
                    <a:cubicBezTo>
                      <a:pt x="461" y="0"/>
                      <a:pt x="440" y="2"/>
                      <a:pt x="435" y="7"/>
                    </a:cubicBezTo>
                    <a:cubicBezTo>
                      <a:pt x="239" y="268"/>
                      <a:pt x="65" y="769"/>
                      <a:pt x="44" y="986"/>
                    </a:cubicBezTo>
                    <a:cubicBezTo>
                      <a:pt x="0" y="1269"/>
                      <a:pt x="131" y="1878"/>
                      <a:pt x="305" y="1900"/>
                    </a:cubicBezTo>
                    <a:cubicBezTo>
                      <a:pt x="827" y="1922"/>
                      <a:pt x="1458" y="1987"/>
                      <a:pt x="1980" y="2096"/>
                    </a:cubicBezTo>
                    <a:cubicBezTo>
                      <a:pt x="2524" y="2205"/>
                      <a:pt x="2698" y="2531"/>
                      <a:pt x="4091" y="2618"/>
                    </a:cubicBezTo>
                    <a:cubicBezTo>
                      <a:pt x="4221" y="2625"/>
                      <a:pt x="4390" y="2633"/>
                      <a:pt x="4557" y="2633"/>
                    </a:cubicBezTo>
                    <a:cubicBezTo>
                      <a:pt x="4891" y="2633"/>
                      <a:pt x="5215" y="2604"/>
                      <a:pt x="5200" y="2487"/>
                    </a:cubicBezTo>
                    <a:cubicBezTo>
                      <a:pt x="5200" y="2313"/>
                      <a:pt x="3917" y="1922"/>
                      <a:pt x="3525" y="1508"/>
                    </a:cubicBezTo>
                    <a:cubicBezTo>
                      <a:pt x="2524" y="420"/>
                      <a:pt x="1828" y="138"/>
                      <a:pt x="1828" y="138"/>
                    </a:cubicBezTo>
                    <a:cubicBezTo>
                      <a:pt x="1828" y="138"/>
                      <a:pt x="762" y="0"/>
                      <a:pt x="495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37" name="Google Shape;537;p22"/>
              <p:cNvSpPr/>
              <p:nvPr/>
            </p:nvSpPr>
            <p:spPr>
              <a:xfrm>
                <a:off x="138059" y="2728010"/>
                <a:ext cx="88208" cy="52598"/>
              </a:xfrm>
              <a:custGeom>
                <a:avLst/>
                <a:gdLst/>
                <a:ahLst/>
                <a:cxnLst/>
                <a:rect l="l" t="t" r="r" b="b"/>
                <a:pathLst>
                  <a:path w="1132" h="675" extrusionOk="0">
                    <a:moveTo>
                      <a:pt x="0" y="0"/>
                    </a:moveTo>
                    <a:lnTo>
                      <a:pt x="1132" y="675"/>
                    </a:lnTo>
                    <a:lnTo>
                      <a:pt x="1023" y="15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B8D1FF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38" name="Google Shape;538;p22"/>
              <p:cNvSpPr/>
              <p:nvPr/>
            </p:nvSpPr>
            <p:spPr>
              <a:xfrm>
                <a:off x="226186" y="2734789"/>
                <a:ext cx="33974" cy="45818"/>
              </a:xfrm>
              <a:custGeom>
                <a:avLst/>
                <a:gdLst/>
                <a:ahLst/>
                <a:cxnLst/>
                <a:rect l="l" t="t" r="r" b="b"/>
                <a:pathLst>
                  <a:path w="436" h="588" extrusionOk="0">
                    <a:moveTo>
                      <a:pt x="262" y="1"/>
                    </a:moveTo>
                    <a:lnTo>
                      <a:pt x="1" y="588"/>
                    </a:lnTo>
                    <a:lnTo>
                      <a:pt x="1" y="588"/>
                    </a:lnTo>
                    <a:lnTo>
                      <a:pt x="436" y="153"/>
                    </a:lnTo>
                    <a:lnTo>
                      <a:pt x="262" y="1"/>
                    </a:lnTo>
                    <a:close/>
                  </a:path>
                </a:pathLst>
              </a:custGeom>
              <a:solidFill>
                <a:srgbClr val="B8D1FF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39" name="Google Shape;539;p22"/>
              <p:cNvSpPr/>
              <p:nvPr/>
            </p:nvSpPr>
            <p:spPr>
              <a:xfrm>
                <a:off x="-21287" y="3440056"/>
                <a:ext cx="413768" cy="62026"/>
              </a:xfrm>
              <a:custGeom>
                <a:avLst/>
                <a:gdLst/>
                <a:ahLst/>
                <a:cxnLst/>
                <a:rect l="l" t="t" r="r" b="b"/>
                <a:pathLst>
                  <a:path w="5310" h="796" extrusionOk="0">
                    <a:moveTo>
                      <a:pt x="152" y="1"/>
                    </a:moveTo>
                    <a:lnTo>
                      <a:pt x="0" y="523"/>
                    </a:lnTo>
                    <a:cubicBezTo>
                      <a:pt x="0" y="523"/>
                      <a:pt x="849" y="654"/>
                      <a:pt x="2328" y="741"/>
                    </a:cubicBezTo>
                    <a:cubicBezTo>
                      <a:pt x="3090" y="784"/>
                      <a:pt x="3835" y="795"/>
                      <a:pt x="4390" y="795"/>
                    </a:cubicBezTo>
                    <a:cubicBezTo>
                      <a:pt x="4945" y="795"/>
                      <a:pt x="5309" y="784"/>
                      <a:pt x="5309" y="784"/>
                    </a:cubicBezTo>
                    <a:lnTo>
                      <a:pt x="5309" y="240"/>
                    </a:lnTo>
                    <a:cubicBezTo>
                      <a:pt x="5309" y="240"/>
                      <a:pt x="4439" y="197"/>
                      <a:pt x="3003" y="153"/>
                    </a:cubicBezTo>
                    <a:cubicBezTo>
                      <a:pt x="1588" y="88"/>
                      <a:pt x="152" y="1"/>
                      <a:pt x="152" y="1"/>
                    </a:cubicBezTo>
                    <a:close/>
                  </a:path>
                </a:pathLst>
              </a:custGeom>
              <a:solidFill>
                <a:schemeClr val="dk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40" name="Google Shape;540;p22"/>
              <p:cNvSpPr/>
              <p:nvPr/>
            </p:nvSpPr>
            <p:spPr>
              <a:xfrm>
                <a:off x="339794" y="3457043"/>
                <a:ext cx="50961" cy="50961"/>
              </a:xfrm>
              <a:custGeom>
                <a:avLst/>
                <a:gdLst/>
                <a:ahLst/>
                <a:cxnLst/>
                <a:rect l="l" t="t" r="r" b="b"/>
                <a:pathLst>
                  <a:path w="654" h="654" extrusionOk="0">
                    <a:moveTo>
                      <a:pt x="175" y="0"/>
                    </a:moveTo>
                    <a:cubicBezTo>
                      <a:pt x="66" y="0"/>
                      <a:pt x="1" y="88"/>
                      <a:pt x="1" y="175"/>
                    </a:cubicBezTo>
                    <a:lnTo>
                      <a:pt x="1" y="479"/>
                    </a:lnTo>
                    <a:cubicBezTo>
                      <a:pt x="1" y="566"/>
                      <a:pt x="66" y="653"/>
                      <a:pt x="175" y="653"/>
                    </a:cubicBezTo>
                    <a:lnTo>
                      <a:pt x="479" y="653"/>
                    </a:lnTo>
                    <a:cubicBezTo>
                      <a:pt x="588" y="653"/>
                      <a:pt x="653" y="566"/>
                      <a:pt x="653" y="479"/>
                    </a:cubicBezTo>
                    <a:lnTo>
                      <a:pt x="653" y="175"/>
                    </a:lnTo>
                    <a:cubicBezTo>
                      <a:pt x="653" y="88"/>
                      <a:pt x="588" y="0"/>
                      <a:pt x="479" y="0"/>
                    </a:cubicBezTo>
                    <a:close/>
                  </a:path>
                </a:pathLst>
              </a:custGeom>
              <a:solidFill>
                <a:schemeClr val="accen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41" name="Google Shape;541;p22"/>
              <p:cNvSpPr/>
              <p:nvPr/>
            </p:nvSpPr>
            <p:spPr>
              <a:xfrm>
                <a:off x="194005" y="2746633"/>
                <a:ext cx="71299" cy="45896"/>
              </a:xfrm>
              <a:custGeom>
                <a:avLst/>
                <a:gdLst/>
                <a:ahLst/>
                <a:cxnLst/>
                <a:rect l="l" t="t" r="r" b="b"/>
                <a:pathLst>
                  <a:path w="915" h="589" extrusionOk="0">
                    <a:moveTo>
                      <a:pt x="914" y="1"/>
                    </a:moveTo>
                    <a:lnTo>
                      <a:pt x="0" y="110"/>
                    </a:lnTo>
                    <a:lnTo>
                      <a:pt x="457" y="588"/>
                    </a:lnTo>
                    <a:lnTo>
                      <a:pt x="849" y="523"/>
                    </a:lnTo>
                    <a:lnTo>
                      <a:pt x="914" y="1"/>
                    </a:ln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42" name="Google Shape;542;p22"/>
              <p:cNvSpPr/>
              <p:nvPr/>
            </p:nvSpPr>
            <p:spPr>
              <a:xfrm>
                <a:off x="229615" y="2787386"/>
                <a:ext cx="144157" cy="717199"/>
              </a:xfrm>
              <a:custGeom>
                <a:avLst/>
                <a:gdLst/>
                <a:ahLst/>
                <a:cxnLst/>
                <a:rect l="l" t="t" r="r" b="b"/>
                <a:pathLst>
                  <a:path w="1850" h="9204" extrusionOk="0">
                    <a:moveTo>
                      <a:pt x="392" y="0"/>
                    </a:moveTo>
                    <a:lnTo>
                      <a:pt x="0" y="65"/>
                    </a:lnTo>
                    <a:cubicBezTo>
                      <a:pt x="0" y="65"/>
                      <a:pt x="610" y="3394"/>
                      <a:pt x="784" y="5004"/>
                    </a:cubicBezTo>
                    <a:cubicBezTo>
                      <a:pt x="979" y="6614"/>
                      <a:pt x="979" y="8703"/>
                      <a:pt x="979" y="8703"/>
                    </a:cubicBezTo>
                    <a:lnTo>
                      <a:pt x="1567" y="9204"/>
                    </a:lnTo>
                    <a:lnTo>
                      <a:pt x="1850" y="8747"/>
                    </a:lnTo>
                    <a:cubicBezTo>
                      <a:pt x="1850" y="8747"/>
                      <a:pt x="1632" y="7376"/>
                      <a:pt x="1349" y="4917"/>
                    </a:cubicBezTo>
                    <a:cubicBezTo>
                      <a:pt x="1045" y="2459"/>
                      <a:pt x="392" y="0"/>
                      <a:pt x="392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43" name="Google Shape;543;p22"/>
              <p:cNvSpPr/>
              <p:nvPr/>
            </p:nvSpPr>
            <p:spPr>
              <a:xfrm>
                <a:off x="36295" y="2648296"/>
                <a:ext cx="181559" cy="145949"/>
              </a:xfrm>
              <a:custGeom>
                <a:avLst/>
                <a:gdLst/>
                <a:ahLst/>
                <a:cxnLst/>
                <a:rect l="l" t="t" r="r" b="b"/>
                <a:pathLst>
                  <a:path w="2330" h="1873" extrusionOk="0">
                    <a:moveTo>
                      <a:pt x="393" y="1"/>
                    </a:moveTo>
                    <a:lnTo>
                      <a:pt x="1" y="545"/>
                    </a:lnTo>
                    <a:lnTo>
                      <a:pt x="2024" y="1872"/>
                    </a:lnTo>
                    <a:lnTo>
                      <a:pt x="2329" y="1176"/>
                    </a:lnTo>
                    <a:lnTo>
                      <a:pt x="393" y="1"/>
                    </a:lnTo>
                    <a:close/>
                  </a:path>
                </a:pathLst>
              </a:custGeom>
              <a:solidFill>
                <a:schemeClr val="dk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44" name="Google Shape;544;p22"/>
              <p:cNvSpPr/>
              <p:nvPr/>
            </p:nvSpPr>
            <p:spPr>
              <a:xfrm>
                <a:off x="136345" y="2875515"/>
                <a:ext cx="351041" cy="507042"/>
              </a:xfrm>
              <a:custGeom>
                <a:avLst/>
                <a:gdLst/>
                <a:ahLst/>
                <a:cxnLst/>
                <a:rect l="l" t="t" r="r" b="b"/>
                <a:pathLst>
                  <a:path w="4505" h="6507" extrusionOk="0">
                    <a:moveTo>
                      <a:pt x="4265" y="0"/>
                    </a:moveTo>
                    <a:lnTo>
                      <a:pt x="1" y="566"/>
                    </a:lnTo>
                    <a:lnTo>
                      <a:pt x="262" y="6506"/>
                    </a:lnTo>
                    <a:lnTo>
                      <a:pt x="4505" y="5832"/>
                    </a:lnTo>
                    <a:lnTo>
                      <a:pt x="4265" y="0"/>
                    </a:lnTo>
                    <a:close/>
                  </a:path>
                </a:pathLst>
              </a:custGeom>
              <a:solidFill>
                <a:schemeClr val="accent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45" name="Google Shape;545;p22"/>
              <p:cNvSpPr/>
              <p:nvPr/>
            </p:nvSpPr>
            <p:spPr>
              <a:xfrm>
                <a:off x="246523" y="2704244"/>
                <a:ext cx="34052" cy="67948"/>
              </a:xfrm>
              <a:custGeom>
                <a:avLst/>
                <a:gdLst/>
                <a:ahLst/>
                <a:cxnLst/>
                <a:rect l="l" t="t" r="r" b="b"/>
                <a:pathLst>
                  <a:path w="437" h="872" extrusionOk="0">
                    <a:moveTo>
                      <a:pt x="23" y="1"/>
                    </a:moveTo>
                    <a:lnTo>
                      <a:pt x="1" y="393"/>
                    </a:lnTo>
                    <a:lnTo>
                      <a:pt x="371" y="871"/>
                    </a:lnTo>
                    <a:lnTo>
                      <a:pt x="436" y="305"/>
                    </a:lnTo>
                    <a:lnTo>
                      <a:pt x="23" y="1"/>
                    </a:lnTo>
                    <a:close/>
                  </a:path>
                </a:pathLst>
              </a:custGeom>
              <a:solidFill>
                <a:schemeClr val="dk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46" name="Google Shape;546;p22"/>
              <p:cNvSpPr/>
              <p:nvPr/>
            </p:nvSpPr>
            <p:spPr>
              <a:xfrm>
                <a:off x="-133180" y="3036579"/>
                <a:ext cx="498470" cy="250365"/>
              </a:xfrm>
              <a:custGeom>
                <a:avLst/>
                <a:gdLst/>
                <a:ahLst/>
                <a:cxnLst/>
                <a:rect l="l" t="t" r="r" b="b"/>
                <a:pathLst>
                  <a:path w="6397" h="3213" extrusionOk="0">
                    <a:moveTo>
                      <a:pt x="6049" y="0"/>
                    </a:moveTo>
                    <a:cubicBezTo>
                      <a:pt x="6049" y="0"/>
                      <a:pt x="3568" y="305"/>
                      <a:pt x="1153" y="1175"/>
                    </a:cubicBezTo>
                    <a:cubicBezTo>
                      <a:pt x="914" y="1262"/>
                      <a:pt x="0" y="1850"/>
                      <a:pt x="239" y="2764"/>
                    </a:cubicBezTo>
                    <a:cubicBezTo>
                      <a:pt x="328" y="3093"/>
                      <a:pt x="627" y="3212"/>
                      <a:pt x="1013" y="3212"/>
                    </a:cubicBezTo>
                    <a:cubicBezTo>
                      <a:pt x="1672" y="3212"/>
                      <a:pt x="2585" y="2866"/>
                      <a:pt x="3133" y="2633"/>
                    </a:cubicBezTo>
                    <a:cubicBezTo>
                      <a:pt x="3982" y="2263"/>
                      <a:pt x="6397" y="958"/>
                      <a:pt x="6397" y="958"/>
                    </a:cubicBezTo>
                    <a:lnTo>
                      <a:pt x="6049" y="0"/>
                    </a:ln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47" name="Google Shape;547;p22"/>
              <p:cNvSpPr/>
              <p:nvPr/>
            </p:nvSpPr>
            <p:spPr>
              <a:xfrm>
                <a:off x="407584" y="3075228"/>
                <a:ext cx="84858" cy="36000"/>
              </a:xfrm>
              <a:custGeom>
                <a:avLst/>
                <a:gdLst/>
                <a:ahLst/>
                <a:cxnLst/>
                <a:rect l="l" t="t" r="r" b="b"/>
                <a:pathLst>
                  <a:path w="1089" h="462" extrusionOk="0">
                    <a:moveTo>
                      <a:pt x="913" y="1"/>
                    </a:moveTo>
                    <a:cubicBezTo>
                      <a:pt x="900" y="1"/>
                      <a:pt x="886" y="2"/>
                      <a:pt x="871" y="5"/>
                    </a:cubicBezTo>
                    <a:lnTo>
                      <a:pt x="153" y="114"/>
                    </a:lnTo>
                    <a:cubicBezTo>
                      <a:pt x="66" y="135"/>
                      <a:pt x="1" y="222"/>
                      <a:pt x="23" y="310"/>
                    </a:cubicBezTo>
                    <a:cubicBezTo>
                      <a:pt x="44" y="397"/>
                      <a:pt x="131" y="462"/>
                      <a:pt x="219" y="462"/>
                    </a:cubicBezTo>
                    <a:lnTo>
                      <a:pt x="937" y="331"/>
                    </a:lnTo>
                    <a:cubicBezTo>
                      <a:pt x="1024" y="331"/>
                      <a:pt x="1089" y="244"/>
                      <a:pt x="1067" y="135"/>
                    </a:cubicBezTo>
                    <a:cubicBezTo>
                      <a:pt x="1067" y="60"/>
                      <a:pt x="1001" y="1"/>
                      <a:pt x="913" y="1"/>
                    </a:cubicBezTo>
                    <a:close/>
                  </a:path>
                </a:pathLst>
              </a:custGeom>
              <a:solidFill>
                <a:srgbClr val="A2664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48" name="Google Shape;548;p22"/>
              <p:cNvSpPr/>
              <p:nvPr/>
            </p:nvSpPr>
            <p:spPr>
              <a:xfrm>
                <a:off x="405948" y="3050137"/>
                <a:ext cx="84858" cy="36000"/>
              </a:xfrm>
              <a:custGeom>
                <a:avLst/>
                <a:gdLst/>
                <a:ahLst/>
                <a:cxnLst/>
                <a:rect l="l" t="t" r="r" b="b"/>
                <a:pathLst>
                  <a:path w="1089" h="462" extrusionOk="0">
                    <a:moveTo>
                      <a:pt x="871" y="1"/>
                    </a:moveTo>
                    <a:lnTo>
                      <a:pt x="152" y="131"/>
                    </a:lnTo>
                    <a:cubicBezTo>
                      <a:pt x="65" y="131"/>
                      <a:pt x="0" y="218"/>
                      <a:pt x="22" y="305"/>
                    </a:cubicBezTo>
                    <a:lnTo>
                      <a:pt x="22" y="327"/>
                    </a:lnTo>
                    <a:cubicBezTo>
                      <a:pt x="41" y="402"/>
                      <a:pt x="109" y="462"/>
                      <a:pt x="184" y="462"/>
                    </a:cubicBezTo>
                    <a:cubicBezTo>
                      <a:pt x="195" y="462"/>
                      <a:pt x="206" y="460"/>
                      <a:pt x="218" y="457"/>
                    </a:cubicBezTo>
                    <a:lnTo>
                      <a:pt x="936" y="349"/>
                    </a:lnTo>
                    <a:cubicBezTo>
                      <a:pt x="1023" y="327"/>
                      <a:pt x="1088" y="240"/>
                      <a:pt x="1066" y="153"/>
                    </a:cubicBezTo>
                    <a:cubicBezTo>
                      <a:pt x="1066" y="44"/>
                      <a:pt x="979" y="1"/>
                      <a:pt x="871" y="1"/>
                    </a:cubicBezTo>
                    <a:close/>
                  </a:path>
                </a:pathLst>
              </a:custGeom>
              <a:solidFill>
                <a:srgbClr val="A2664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49" name="Google Shape;549;p22"/>
              <p:cNvSpPr/>
              <p:nvPr/>
            </p:nvSpPr>
            <p:spPr>
              <a:xfrm>
                <a:off x="404233" y="3026059"/>
                <a:ext cx="83143" cy="36000"/>
              </a:xfrm>
              <a:custGeom>
                <a:avLst/>
                <a:gdLst/>
                <a:ahLst/>
                <a:cxnLst/>
                <a:rect l="l" t="t" r="r" b="b"/>
                <a:pathLst>
                  <a:path w="1067" h="462" extrusionOk="0">
                    <a:moveTo>
                      <a:pt x="905" y="1"/>
                    </a:moveTo>
                    <a:cubicBezTo>
                      <a:pt x="894" y="1"/>
                      <a:pt x="882" y="2"/>
                      <a:pt x="871" y="5"/>
                    </a:cubicBezTo>
                    <a:lnTo>
                      <a:pt x="153" y="114"/>
                    </a:lnTo>
                    <a:cubicBezTo>
                      <a:pt x="44" y="135"/>
                      <a:pt x="0" y="223"/>
                      <a:pt x="0" y="310"/>
                    </a:cubicBezTo>
                    <a:cubicBezTo>
                      <a:pt x="22" y="418"/>
                      <a:pt x="109" y="462"/>
                      <a:pt x="196" y="462"/>
                    </a:cubicBezTo>
                    <a:lnTo>
                      <a:pt x="914" y="331"/>
                    </a:lnTo>
                    <a:cubicBezTo>
                      <a:pt x="1001" y="331"/>
                      <a:pt x="1067" y="244"/>
                      <a:pt x="1067" y="135"/>
                    </a:cubicBezTo>
                    <a:cubicBezTo>
                      <a:pt x="1048" y="60"/>
                      <a:pt x="980" y="1"/>
                      <a:pt x="905" y="1"/>
                    </a:cubicBezTo>
                    <a:close/>
                  </a:path>
                </a:pathLst>
              </a:custGeom>
              <a:solidFill>
                <a:srgbClr val="A2664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50" name="Google Shape;550;p22"/>
              <p:cNvSpPr/>
              <p:nvPr/>
            </p:nvSpPr>
            <p:spPr>
              <a:xfrm>
                <a:off x="399169" y="3004008"/>
                <a:ext cx="83143" cy="34676"/>
              </a:xfrm>
              <a:custGeom>
                <a:avLst/>
                <a:gdLst/>
                <a:ahLst/>
                <a:cxnLst/>
                <a:rect l="l" t="t" r="r" b="b"/>
                <a:pathLst>
                  <a:path w="1067" h="445" extrusionOk="0">
                    <a:moveTo>
                      <a:pt x="905" y="1"/>
                    </a:moveTo>
                    <a:cubicBezTo>
                      <a:pt x="893" y="1"/>
                      <a:pt x="882" y="2"/>
                      <a:pt x="870" y="5"/>
                    </a:cubicBezTo>
                    <a:lnTo>
                      <a:pt x="152" y="114"/>
                    </a:lnTo>
                    <a:cubicBezTo>
                      <a:pt x="44" y="114"/>
                      <a:pt x="0" y="223"/>
                      <a:pt x="0" y="310"/>
                    </a:cubicBezTo>
                    <a:cubicBezTo>
                      <a:pt x="19" y="385"/>
                      <a:pt x="87" y="444"/>
                      <a:pt x="162" y="444"/>
                    </a:cubicBezTo>
                    <a:cubicBezTo>
                      <a:pt x="173" y="444"/>
                      <a:pt x="185" y="443"/>
                      <a:pt x="196" y="440"/>
                    </a:cubicBezTo>
                    <a:lnTo>
                      <a:pt x="914" y="331"/>
                    </a:lnTo>
                    <a:cubicBezTo>
                      <a:pt x="1001" y="310"/>
                      <a:pt x="1066" y="223"/>
                      <a:pt x="1066" y="136"/>
                    </a:cubicBezTo>
                    <a:cubicBezTo>
                      <a:pt x="1047" y="60"/>
                      <a:pt x="979" y="1"/>
                      <a:pt x="905" y="1"/>
                    </a:cubicBezTo>
                    <a:close/>
                  </a:path>
                </a:pathLst>
              </a:custGeom>
              <a:solidFill>
                <a:srgbClr val="A2664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51" name="Google Shape;551;p22"/>
              <p:cNvSpPr/>
              <p:nvPr/>
            </p:nvSpPr>
            <p:spPr>
              <a:xfrm>
                <a:off x="287276" y="3003228"/>
                <a:ext cx="193326" cy="127871"/>
              </a:xfrm>
              <a:custGeom>
                <a:avLst/>
                <a:gdLst/>
                <a:ahLst/>
                <a:cxnLst/>
                <a:rect l="l" t="t" r="r" b="b"/>
                <a:pathLst>
                  <a:path w="2481" h="1641" extrusionOk="0">
                    <a:moveTo>
                      <a:pt x="1777" y="1"/>
                    </a:moveTo>
                    <a:cubicBezTo>
                      <a:pt x="1555" y="1"/>
                      <a:pt x="1334" y="9"/>
                      <a:pt x="1240" y="37"/>
                    </a:cubicBezTo>
                    <a:cubicBezTo>
                      <a:pt x="1001" y="124"/>
                      <a:pt x="0" y="777"/>
                      <a:pt x="0" y="777"/>
                    </a:cubicBezTo>
                    <a:lnTo>
                      <a:pt x="653" y="1603"/>
                    </a:lnTo>
                    <a:cubicBezTo>
                      <a:pt x="653" y="1603"/>
                      <a:pt x="861" y="1640"/>
                      <a:pt x="1121" y="1640"/>
                    </a:cubicBezTo>
                    <a:cubicBezTo>
                      <a:pt x="1208" y="1640"/>
                      <a:pt x="1300" y="1636"/>
                      <a:pt x="1393" y="1625"/>
                    </a:cubicBezTo>
                    <a:cubicBezTo>
                      <a:pt x="1763" y="1582"/>
                      <a:pt x="2481" y="1255"/>
                      <a:pt x="2481" y="1255"/>
                    </a:cubicBezTo>
                    <a:cubicBezTo>
                      <a:pt x="2481" y="1255"/>
                      <a:pt x="2263" y="755"/>
                      <a:pt x="2219" y="559"/>
                    </a:cubicBezTo>
                    <a:cubicBezTo>
                      <a:pt x="2154" y="363"/>
                      <a:pt x="2372" y="15"/>
                      <a:pt x="2372" y="15"/>
                    </a:cubicBezTo>
                    <a:cubicBezTo>
                      <a:pt x="2372" y="15"/>
                      <a:pt x="2073" y="1"/>
                      <a:pt x="1777" y="1"/>
                    </a:cubicBezTo>
                    <a:close/>
                  </a:path>
                </a:pathLst>
              </a:custGeom>
              <a:solidFill>
                <a:srgbClr val="A2664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52" name="Google Shape;552;p22"/>
              <p:cNvSpPr/>
              <p:nvPr/>
            </p:nvSpPr>
            <p:spPr>
              <a:xfrm>
                <a:off x="261796" y="3024735"/>
                <a:ext cx="103481" cy="127247"/>
              </a:xfrm>
              <a:custGeom>
                <a:avLst/>
                <a:gdLst/>
                <a:ahLst/>
                <a:cxnLst/>
                <a:rect l="l" t="t" r="r" b="b"/>
                <a:pathLst>
                  <a:path w="1328" h="1633" extrusionOk="0">
                    <a:moveTo>
                      <a:pt x="871" y="0"/>
                    </a:moveTo>
                    <a:lnTo>
                      <a:pt x="1" y="283"/>
                    </a:lnTo>
                    <a:lnTo>
                      <a:pt x="436" y="1632"/>
                    </a:lnTo>
                    <a:lnTo>
                      <a:pt x="1328" y="1327"/>
                    </a:lnTo>
                    <a:lnTo>
                      <a:pt x="871" y="0"/>
                    </a:lnTo>
                    <a:close/>
                  </a:path>
                </a:pathLst>
              </a:custGeom>
              <a:solidFill>
                <a:schemeClr val="lt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53" name="Google Shape;553;p22"/>
              <p:cNvSpPr/>
              <p:nvPr/>
            </p:nvSpPr>
            <p:spPr>
              <a:xfrm>
                <a:off x="263510" y="3116526"/>
                <a:ext cx="371379" cy="233767"/>
              </a:xfrm>
              <a:custGeom>
                <a:avLst/>
                <a:gdLst/>
                <a:ahLst/>
                <a:cxnLst/>
                <a:rect l="l" t="t" r="r" b="b"/>
                <a:pathLst>
                  <a:path w="4766" h="3000" extrusionOk="0">
                    <a:moveTo>
                      <a:pt x="3897" y="0"/>
                    </a:moveTo>
                    <a:cubicBezTo>
                      <a:pt x="3372" y="0"/>
                      <a:pt x="2639" y="458"/>
                      <a:pt x="2155" y="737"/>
                    </a:cubicBezTo>
                    <a:cubicBezTo>
                      <a:pt x="1437" y="1150"/>
                      <a:pt x="0" y="2086"/>
                      <a:pt x="0" y="2086"/>
                    </a:cubicBezTo>
                    <a:lnTo>
                      <a:pt x="392" y="3000"/>
                    </a:lnTo>
                    <a:cubicBezTo>
                      <a:pt x="392" y="3000"/>
                      <a:pt x="2611" y="2565"/>
                      <a:pt x="3830" y="2021"/>
                    </a:cubicBezTo>
                    <a:cubicBezTo>
                      <a:pt x="4026" y="1912"/>
                      <a:pt x="4766" y="1281"/>
                      <a:pt x="4461" y="389"/>
                    </a:cubicBezTo>
                    <a:cubicBezTo>
                      <a:pt x="4355" y="106"/>
                      <a:pt x="4150" y="0"/>
                      <a:pt x="3897" y="0"/>
                    </a:cubicBez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54" name="Google Shape;554;p22"/>
              <p:cNvSpPr/>
              <p:nvPr/>
            </p:nvSpPr>
            <p:spPr>
              <a:xfrm>
                <a:off x="139773" y="3357381"/>
                <a:ext cx="81429" cy="48546"/>
              </a:xfrm>
              <a:custGeom>
                <a:avLst/>
                <a:gdLst/>
                <a:ahLst/>
                <a:cxnLst/>
                <a:rect l="l" t="t" r="r" b="b"/>
                <a:pathLst>
                  <a:path w="1045" h="623" extrusionOk="0">
                    <a:moveTo>
                      <a:pt x="856" y="0"/>
                    </a:moveTo>
                    <a:cubicBezTo>
                      <a:pt x="832" y="0"/>
                      <a:pt x="807" y="6"/>
                      <a:pt x="783" y="18"/>
                    </a:cubicBezTo>
                    <a:lnTo>
                      <a:pt x="109" y="300"/>
                    </a:lnTo>
                    <a:cubicBezTo>
                      <a:pt x="44" y="344"/>
                      <a:pt x="0" y="431"/>
                      <a:pt x="22" y="518"/>
                    </a:cubicBezTo>
                    <a:cubicBezTo>
                      <a:pt x="54" y="582"/>
                      <a:pt x="121" y="622"/>
                      <a:pt x="188" y="622"/>
                    </a:cubicBezTo>
                    <a:cubicBezTo>
                      <a:pt x="213" y="622"/>
                      <a:pt x="238" y="617"/>
                      <a:pt x="261" y="605"/>
                    </a:cubicBezTo>
                    <a:lnTo>
                      <a:pt x="914" y="322"/>
                    </a:lnTo>
                    <a:cubicBezTo>
                      <a:pt x="1001" y="279"/>
                      <a:pt x="1045" y="192"/>
                      <a:pt x="1001" y="105"/>
                    </a:cubicBezTo>
                    <a:cubicBezTo>
                      <a:pt x="985" y="41"/>
                      <a:pt x="923" y="0"/>
                      <a:pt x="856" y="0"/>
                    </a:cubicBezTo>
                    <a:close/>
                  </a:path>
                </a:pathLst>
              </a:custGeom>
              <a:solidFill>
                <a:srgbClr val="A2664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55" name="Google Shape;555;p22"/>
              <p:cNvSpPr/>
              <p:nvPr/>
            </p:nvSpPr>
            <p:spPr>
              <a:xfrm>
                <a:off x="127851" y="3335329"/>
                <a:ext cx="81507" cy="49481"/>
              </a:xfrm>
              <a:custGeom>
                <a:avLst/>
                <a:gdLst/>
                <a:ahLst/>
                <a:cxnLst/>
                <a:rect l="l" t="t" r="r" b="b"/>
                <a:pathLst>
                  <a:path w="1046" h="635" extrusionOk="0">
                    <a:moveTo>
                      <a:pt x="853" y="1"/>
                    </a:moveTo>
                    <a:cubicBezTo>
                      <a:pt x="831" y="1"/>
                      <a:pt x="807" y="6"/>
                      <a:pt x="784" y="18"/>
                    </a:cubicBezTo>
                    <a:lnTo>
                      <a:pt x="110" y="301"/>
                    </a:lnTo>
                    <a:cubicBezTo>
                      <a:pt x="23" y="344"/>
                      <a:pt x="1" y="453"/>
                      <a:pt x="23" y="540"/>
                    </a:cubicBezTo>
                    <a:cubicBezTo>
                      <a:pt x="56" y="606"/>
                      <a:pt x="127" y="635"/>
                      <a:pt x="198" y="635"/>
                    </a:cubicBezTo>
                    <a:cubicBezTo>
                      <a:pt x="220" y="635"/>
                      <a:pt x="241" y="632"/>
                      <a:pt x="262" y="627"/>
                    </a:cubicBezTo>
                    <a:lnTo>
                      <a:pt x="915" y="322"/>
                    </a:lnTo>
                    <a:cubicBezTo>
                      <a:pt x="1002" y="301"/>
                      <a:pt x="1045" y="192"/>
                      <a:pt x="1002" y="105"/>
                    </a:cubicBezTo>
                    <a:cubicBezTo>
                      <a:pt x="970" y="41"/>
                      <a:pt x="915" y="1"/>
                      <a:pt x="853" y="1"/>
                    </a:cubicBezTo>
                    <a:close/>
                  </a:path>
                </a:pathLst>
              </a:custGeom>
              <a:solidFill>
                <a:srgbClr val="A2664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56" name="Google Shape;556;p22"/>
              <p:cNvSpPr/>
              <p:nvPr/>
            </p:nvSpPr>
            <p:spPr>
              <a:xfrm>
                <a:off x="116008" y="3313278"/>
                <a:ext cx="83143" cy="50260"/>
              </a:xfrm>
              <a:custGeom>
                <a:avLst/>
                <a:gdLst/>
                <a:ahLst/>
                <a:cxnLst/>
                <a:rect l="l" t="t" r="r" b="b"/>
                <a:pathLst>
                  <a:path w="1067" h="645" extrusionOk="0">
                    <a:moveTo>
                      <a:pt x="875" y="1"/>
                    </a:moveTo>
                    <a:cubicBezTo>
                      <a:pt x="852" y="1"/>
                      <a:pt x="829" y="6"/>
                      <a:pt x="806" y="18"/>
                    </a:cubicBezTo>
                    <a:lnTo>
                      <a:pt x="131" y="301"/>
                    </a:lnTo>
                    <a:cubicBezTo>
                      <a:pt x="44" y="344"/>
                      <a:pt x="1" y="453"/>
                      <a:pt x="44" y="540"/>
                    </a:cubicBezTo>
                    <a:cubicBezTo>
                      <a:pt x="76" y="604"/>
                      <a:pt x="143" y="644"/>
                      <a:pt x="202" y="644"/>
                    </a:cubicBezTo>
                    <a:cubicBezTo>
                      <a:pt x="224" y="644"/>
                      <a:pt x="244" y="639"/>
                      <a:pt x="262" y="627"/>
                    </a:cubicBezTo>
                    <a:lnTo>
                      <a:pt x="936" y="322"/>
                    </a:lnTo>
                    <a:cubicBezTo>
                      <a:pt x="1023" y="301"/>
                      <a:pt x="1067" y="192"/>
                      <a:pt x="1023" y="105"/>
                    </a:cubicBezTo>
                    <a:cubicBezTo>
                      <a:pt x="991" y="41"/>
                      <a:pt x="936" y="1"/>
                      <a:pt x="875" y="1"/>
                    </a:cubicBezTo>
                    <a:close/>
                  </a:path>
                </a:pathLst>
              </a:custGeom>
              <a:solidFill>
                <a:srgbClr val="A2664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57" name="Google Shape;557;p22"/>
              <p:cNvSpPr/>
              <p:nvPr/>
            </p:nvSpPr>
            <p:spPr>
              <a:xfrm>
                <a:off x="109229" y="3291226"/>
                <a:ext cx="81429" cy="50260"/>
              </a:xfrm>
              <a:custGeom>
                <a:avLst/>
                <a:gdLst/>
                <a:ahLst/>
                <a:cxnLst/>
                <a:rect l="l" t="t" r="r" b="b"/>
                <a:pathLst>
                  <a:path w="1045" h="645" extrusionOk="0">
                    <a:moveTo>
                      <a:pt x="853" y="1"/>
                    </a:moveTo>
                    <a:cubicBezTo>
                      <a:pt x="830" y="1"/>
                      <a:pt x="807" y="6"/>
                      <a:pt x="784" y="18"/>
                    </a:cubicBezTo>
                    <a:lnTo>
                      <a:pt x="109" y="301"/>
                    </a:lnTo>
                    <a:cubicBezTo>
                      <a:pt x="22" y="344"/>
                      <a:pt x="1" y="453"/>
                      <a:pt x="22" y="540"/>
                    </a:cubicBezTo>
                    <a:cubicBezTo>
                      <a:pt x="54" y="604"/>
                      <a:pt x="121" y="644"/>
                      <a:pt x="189" y="644"/>
                    </a:cubicBezTo>
                    <a:cubicBezTo>
                      <a:pt x="213" y="644"/>
                      <a:pt x="238" y="639"/>
                      <a:pt x="262" y="627"/>
                    </a:cubicBezTo>
                    <a:lnTo>
                      <a:pt x="914" y="323"/>
                    </a:lnTo>
                    <a:cubicBezTo>
                      <a:pt x="1001" y="301"/>
                      <a:pt x="1045" y="192"/>
                      <a:pt x="1001" y="105"/>
                    </a:cubicBezTo>
                    <a:cubicBezTo>
                      <a:pt x="970" y="41"/>
                      <a:pt x="914" y="1"/>
                      <a:pt x="853" y="1"/>
                    </a:cubicBezTo>
                    <a:close/>
                  </a:path>
                </a:pathLst>
              </a:custGeom>
              <a:solidFill>
                <a:srgbClr val="A2664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58" name="Google Shape;558;p22"/>
              <p:cNvSpPr/>
              <p:nvPr/>
            </p:nvSpPr>
            <p:spPr>
              <a:xfrm>
                <a:off x="114293" y="3268629"/>
                <a:ext cx="186624" cy="135897"/>
              </a:xfrm>
              <a:custGeom>
                <a:avLst/>
                <a:gdLst/>
                <a:ahLst/>
                <a:cxnLst/>
                <a:rect l="l" t="t" r="r" b="b"/>
                <a:pathLst>
                  <a:path w="2395" h="1744" extrusionOk="0">
                    <a:moveTo>
                      <a:pt x="2076" y="1"/>
                    </a:moveTo>
                    <a:cubicBezTo>
                      <a:pt x="1705" y="1"/>
                      <a:pt x="1125" y="11"/>
                      <a:pt x="980" y="69"/>
                    </a:cubicBezTo>
                    <a:cubicBezTo>
                      <a:pt x="741" y="134"/>
                      <a:pt x="1" y="656"/>
                      <a:pt x="1" y="656"/>
                    </a:cubicBezTo>
                    <a:cubicBezTo>
                      <a:pt x="1" y="656"/>
                      <a:pt x="371" y="808"/>
                      <a:pt x="436" y="1026"/>
                    </a:cubicBezTo>
                    <a:cubicBezTo>
                      <a:pt x="479" y="1222"/>
                      <a:pt x="588" y="1744"/>
                      <a:pt x="588" y="1744"/>
                    </a:cubicBezTo>
                    <a:cubicBezTo>
                      <a:pt x="588" y="1744"/>
                      <a:pt x="1372" y="1635"/>
                      <a:pt x="1698" y="1461"/>
                    </a:cubicBezTo>
                    <a:cubicBezTo>
                      <a:pt x="2024" y="1287"/>
                      <a:pt x="2307" y="1048"/>
                      <a:pt x="2307" y="1048"/>
                    </a:cubicBezTo>
                    <a:lnTo>
                      <a:pt x="2394" y="3"/>
                    </a:lnTo>
                    <a:cubicBezTo>
                      <a:pt x="2394" y="3"/>
                      <a:pt x="2261" y="1"/>
                      <a:pt x="2076" y="1"/>
                    </a:cubicBezTo>
                    <a:close/>
                  </a:path>
                </a:pathLst>
              </a:custGeom>
              <a:solidFill>
                <a:srgbClr val="A2664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559" name="Google Shape;559;p22"/>
              <p:cNvSpPr/>
              <p:nvPr/>
            </p:nvSpPr>
            <p:spPr>
              <a:xfrm>
                <a:off x="239744" y="3240032"/>
                <a:ext cx="105195" cy="127247"/>
              </a:xfrm>
              <a:custGeom>
                <a:avLst/>
                <a:gdLst/>
                <a:ahLst/>
                <a:cxnLst/>
                <a:rect l="l" t="t" r="r" b="b"/>
                <a:pathLst>
                  <a:path w="1350" h="1633" extrusionOk="0">
                    <a:moveTo>
                      <a:pt x="893" y="0"/>
                    </a:moveTo>
                    <a:lnTo>
                      <a:pt x="1" y="305"/>
                    </a:lnTo>
                    <a:lnTo>
                      <a:pt x="458" y="1632"/>
                    </a:lnTo>
                    <a:lnTo>
                      <a:pt x="1350" y="1328"/>
                    </a:lnTo>
                    <a:lnTo>
                      <a:pt x="893" y="0"/>
                    </a:lnTo>
                    <a:close/>
                  </a:path>
                </a:pathLst>
              </a:custGeom>
              <a:solidFill>
                <a:schemeClr val="lt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0991809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bg>
      <p:bgPr>
        <a:noFill/>
        <a:effectLst/>
      </p:bgPr>
    </p:bg>
    <p:spTree>
      <p:nvGrpSpPr>
        <p:cNvPr id="1" name="Shape 137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6068886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 and two 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713225" y="593367"/>
            <a:ext cx="7717500" cy="763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1pPr>
            <a:lvl2pPr lvl="1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subTitle" idx="1"/>
          </p:nvPr>
        </p:nvSpPr>
        <p:spPr>
          <a:xfrm>
            <a:off x="3761899" y="2464665"/>
            <a:ext cx="2505600" cy="2340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"/>
              <a:buNone/>
              <a:defRPr b="0"/>
            </a:lvl1pPr>
            <a:lvl2pPr lvl="1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"/>
              <a:buNone/>
              <a:defRPr/>
            </a:lvl2pPr>
            <a:lvl3pPr lvl="2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"/>
              <a:buNone/>
              <a:defRPr/>
            </a:lvl3pPr>
            <a:lvl4pPr lvl="3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"/>
              <a:buNone/>
              <a:defRPr/>
            </a:lvl4pPr>
            <a:lvl5pPr lvl="4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"/>
              <a:buNone/>
              <a:defRPr/>
            </a:lvl5pPr>
            <a:lvl6pPr lvl="5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"/>
              <a:buNone/>
              <a:defRPr/>
            </a:lvl6pPr>
            <a:lvl7pPr lvl="6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"/>
              <a:buNone/>
              <a:defRPr/>
            </a:lvl7pPr>
            <a:lvl8pPr lvl="7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"/>
              <a:buNone/>
              <a:defRPr/>
            </a:lvl8pPr>
            <a:lvl9pPr lvl="8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subTitle" idx="2"/>
          </p:nvPr>
        </p:nvSpPr>
        <p:spPr>
          <a:xfrm>
            <a:off x="872400" y="2464665"/>
            <a:ext cx="2505600" cy="2340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"/>
              <a:buNone/>
              <a:defRPr b="0"/>
            </a:lvl1pPr>
            <a:lvl2pPr lvl="1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"/>
              <a:buNone/>
              <a:defRPr/>
            </a:lvl2pPr>
            <a:lvl3pPr lvl="2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"/>
              <a:buNone/>
              <a:defRPr/>
            </a:lvl3pPr>
            <a:lvl4pPr lvl="3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"/>
              <a:buNone/>
              <a:defRPr/>
            </a:lvl4pPr>
            <a:lvl5pPr lvl="4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"/>
              <a:buNone/>
              <a:defRPr/>
            </a:lvl5pPr>
            <a:lvl6pPr lvl="5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"/>
              <a:buNone/>
              <a:defRPr/>
            </a:lvl6pPr>
            <a:lvl7pPr lvl="6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"/>
              <a:buNone/>
              <a:defRPr/>
            </a:lvl7pPr>
            <a:lvl8pPr lvl="7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"/>
              <a:buNone/>
              <a:defRPr/>
            </a:lvl8pPr>
            <a:lvl9pPr lvl="8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ubTitle" idx="3"/>
          </p:nvPr>
        </p:nvSpPr>
        <p:spPr>
          <a:xfrm>
            <a:off x="872400" y="1821053"/>
            <a:ext cx="2505600" cy="7452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Font typeface="Epilogue"/>
              <a:buNone/>
              <a:defRPr sz="2400" b="1">
                <a:solidFill>
                  <a:schemeClr val="accent1"/>
                </a:solidFill>
                <a:latin typeface="Epilogue"/>
                <a:ea typeface="Epilogue"/>
                <a:cs typeface="Epilogue"/>
                <a:sym typeface="Epilogue"/>
              </a:defRPr>
            </a:lvl1pPr>
            <a:lvl2pPr lvl="1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Font typeface="Epilogue"/>
              <a:buNone/>
              <a:defRPr sz="2400">
                <a:latin typeface="Epilogue"/>
                <a:ea typeface="Epilogue"/>
                <a:cs typeface="Epilogue"/>
                <a:sym typeface="Epilogue"/>
              </a:defRPr>
            </a:lvl2pPr>
            <a:lvl3pPr lvl="2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Font typeface="Epilogue"/>
              <a:buNone/>
              <a:defRPr sz="2400">
                <a:latin typeface="Epilogue"/>
                <a:ea typeface="Epilogue"/>
                <a:cs typeface="Epilogue"/>
                <a:sym typeface="Epilogue"/>
              </a:defRPr>
            </a:lvl3pPr>
            <a:lvl4pPr lvl="3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Font typeface="Epilogue"/>
              <a:buNone/>
              <a:defRPr sz="2400">
                <a:latin typeface="Epilogue"/>
                <a:ea typeface="Epilogue"/>
                <a:cs typeface="Epilogue"/>
                <a:sym typeface="Epilogue"/>
              </a:defRPr>
            </a:lvl4pPr>
            <a:lvl5pPr lvl="4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Font typeface="Epilogue"/>
              <a:buNone/>
              <a:defRPr sz="2400">
                <a:latin typeface="Epilogue"/>
                <a:ea typeface="Epilogue"/>
                <a:cs typeface="Epilogue"/>
                <a:sym typeface="Epilogue"/>
              </a:defRPr>
            </a:lvl5pPr>
            <a:lvl6pPr lvl="5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Font typeface="Epilogue"/>
              <a:buNone/>
              <a:defRPr sz="2400">
                <a:latin typeface="Epilogue"/>
                <a:ea typeface="Epilogue"/>
                <a:cs typeface="Epilogue"/>
                <a:sym typeface="Epilogue"/>
              </a:defRPr>
            </a:lvl6pPr>
            <a:lvl7pPr lvl="6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Font typeface="Epilogue"/>
              <a:buNone/>
              <a:defRPr sz="2400">
                <a:latin typeface="Epilogue"/>
                <a:ea typeface="Epilogue"/>
                <a:cs typeface="Epilogue"/>
                <a:sym typeface="Epilogue"/>
              </a:defRPr>
            </a:lvl7pPr>
            <a:lvl8pPr lvl="7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Font typeface="Epilogue"/>
              <a:buNone/>
              <a:defRPr sz="2400">
                <a:latin typeface="Epilogue"/>
                <a:ea typeface="Epilogue"/>
                <a:cs typeface="Epilogue"/>
                <a:sym typeface="Epilogue"/>
              </a:defRPr>
            </a:lvl8pPr>
            <a:lvl9pPr lvl="8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Font typeface="Epilogue"/>
              <a:buNone/>
              <a:defRPr sz="2400">
                <a:latin typeface="Epilogue"/>
                <a:ea typeface="Epilogue"/>
                <a:cs typeface="Epilogue"/>
                <a:sym typeface="Epilogue"/>
              </a:defRPr>
            </a:lvl9pPr>
          </a:lstStyle>
          <a:p>
            <a:endParaRPr/>
          </a:p>
        </p:txBody>
      </p:sp>
      <p:sp>
        <p:nvSpPr>
          <p:cNvPr id="25" name="Google Shape;25;p5"/>
          <p:cNvSpPr txBox="1">
            <a:spLocks noGrp="1"/>
          </p:cNvSpPr>
          <p:nvPr>
            <p:ph type="subTitle" idx="4"/>
          </p:nvPr>
        </p:nvSpPr>
        <p:spPr>
          <a:xfrm>
            <a:off x="3761900" y="1821053"/>
            <a:ext cx="2505600" cy="7452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Font typeface="Epilogue"/>
              <a:buNone/>
              <a:defRPr sz="2400" b="1">
                <a:solidFill>
                  <a:schemeClr val="accent1"/>
                </a:solidFill>
                <a:latin typeface="Epilogue"/>
                <a:ea typeface="Epilogue"/>
                <a:cs typeface="Epilogue"/>
                <a:sym typeface="Epilogue"/>
              </a:defRPr>
            </a:lvl1pPr>
            <a:lvl2pPr lvl="1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Font typeface="Epilogue"/>
              <a:buNone/>
              <a:defRPr sz="2400">
                <a:latin typeface="Epilogue"/>
                <a:ea typeface="Epilogue"/>
                <a:cs typeface="Epilogue"/>
                <a:sym typeface="Epilogue"/>
              </a:defRPr>
            </a:lvl2pPr>
            <a:lvl3pPr lvl="2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Font typeface="Epilogue"/>
              <a:buNone/>
              <a:defRPr sz="2400">
                <a:latin typeface="Epilogue"/>
                <a:ea typeface="Epilogue"/>
                <a:cs typeface="Epilogue"/>
                <a:sym typeface="Epilogue"/>
              </a:defRPr>
            </a:lvl3pPr>
            <a:lvl4pPr lvl="3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Font typeface="Epilogue"/>
              <a:buNone/>
              <a:defRPr sz="2400">
                <a:latin typeface="Epilogue"/>
                <a:ea typeface="Epilogue"/>
                <a:cs typeface="Epilogue"/>
                <a:sym typeface="Epilogue"/>
              </a:defRPr>
            </a:lvl4pPr>
            <a:lvl5pPr lvl="4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Font typeface="Epilogue"/>
              <a:buNone/>
              <a:defRPr sz="2400">
                <a:latin typeface="Epilogue"/>
                <a:ea typeface="Epilogue"/>
                <a:cs typeface="Epilogue"/>
                <a:sym typeface="Epilogue"/>
              </a:defRPr>
            </a:lvl5pPr>
            <a:lvl6pPr lvl="5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Font typeface="Epilogue"/>
              <a:buNone/>
              <a:defRPr sz="2400">
                <a:latin typeface="Epilogue"/>
                <a:ea typeface="Epilogue"/>
                <a:cs typeface="Epilogue"/>
                <a:sym typeface="Epilogue"/>
              </a:defRPr>
            </a:lvl6pPr>
            <a:lvl7pPr lvl="6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Font typeface="Epilogue"/>
              <a:buNone/>
              <a:defRPr sz="2400">
                <a:latin typeface="Epilogue"/>
                <a:ea typeface="Epilogue"/>
                <a:cs typeface="Epilogue"/>
                <a:sym typeface="Epilogue"/>
              </a:defRPr>
            </a:lvl7pPr>
            <a:lvl8pPr lvl="7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Font typeface="Epilogue"/>
              <a:buNone/>
              <a:defRPr sz="2400">
                <a:latin typeface="Epilogue"/>
                <a:ea typeface="Epilogue"/>
                <a:cs typeface="Epilogue"/>
                <a:sym typeface="Epilogue"/>
              </a:defRPr>
            </a:lvl8pPr>
            <a:lvl9pPr lvl="8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Font typeface="Epilogue"/>
              <a:buNone/>
              <a:defRPr sz="2400">
                <a:latin typeface="Epilogue"/>
                <a:ea typeface="Epilogue"/>
                <a:cs typeface="Epilogue"/>
                <a:sym typeface="Epilogue"/>
              </a:defRPr>
            </a:lvl9pPr>
          </a:lstStyle>
          <a:p>
            <a:endParaRPr/>
          </a:p>
        </p:txBody>
      </p:sp>
      <p:sp>
        <p:nvSpPr>
          <p:cNvPr id="26" name="Google Shape;26;p5"/>
          <p:cNvSpPr/>
          <p:nvPr/>
        </p:nvSpPr>
        <p:spPr>
          <a:xfrm>
            <a:off x="-25" y="6127167"/>
            <a:ext cx="9144017" cy="787955"/>
          </a:xfrm>
          <a:custGeom>
            <a:avLst/>
            <a:gdLst/>
            <a:ahLst/>
            <a:cxnLst/>
            <a:rect l="l" t="t" r="r" b="b"/>
            <a:pathLst>
              <a:path w="81572" h="31202" extrusionOk="0">
                <a:moveTo>
                  <a:pt x="0" y="0"/>
                </a:moveTo>
                <a:lnTo>
                  <a:pt x="0" y="31201"/>
                </a:lnTo>
                <a:lnTo>
                  <a:pt x="81572" y="31201"/>
                </a:lnTo>
                <a:lnTo>
                  <a:pt x="81572" y="0"/>
                </a:lnTo>
                <a:close/>
              </a:path>
            </a:pathLst>
          </a:custGeom>
          <a:solidFill>
            <a:schemeClr val="dk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/>
          </a:p>
        </p:txBody>
      </p:sp>
    </p:spTree>
    <p:extLst>
      <p:ext uri="{BB962C8B-B14F-4D97-AF65-F5344CB8AC3E}">
        <p14:creationId xmlns:p14="http://schemas.microsoft.com/office/powerpoint/2010/main" val="5217681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 only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6"/>
          <p:cNvSpPr txBox="1">
            <a:spLocks noGrp="1"/>
          </p:cNvSpPr>
          <p:nvPr>
            <p:ph type="title"/>
          </p:nvPr>
        </p:nvSpPr>
        <p:spPr>
          <a:xfrm>
            <a:off x="720000" y="593367"/>
            <a:ext cx="7704000" cy="1712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1pPr>
            <a:lvl2pPr lvl="1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6"/>
          <p:cNvSpPr/>
          <p:nvPr/>
        </p:nvSpPr>
        <p:spPr>
          <a:xfrm>
            <a:off x="-25" y="6127167"/>
            <a:ext cx="9144017" cy="787955"/>
          </a:xfrm>
          <a:custGeom>
            <a:avLst/>
            <a:gdLst/>
            <a:ahLst/>
            <a:cxnLst/>
            <a:rect l="l" t="t" r="r" b="b"/>
            <a:pathLst>
              <a:path w="81572" h="31202" extrusionOk="0">
                <a:moveTo>
                  <a:pt x="0" y="0"/>
                </a:moveTo>
                <a:lnTo>
                  <a:pt x="0" y="31201"/>
                </a:lnTo>
                <a:lnTo>
                  <a:pt x="81572" y="31201"/>
                </a:lnTo>
                <a:lnTo>
                  <a:pt x="81572" y="0"/>
                </a:lnTo>
                <a:close/>
              </a:path>
            </a:pathLst>
          </a:custGeom>
          <a:solidFill>
            <a:schemeClr val="dk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/>
          </a:p>
        </p:txBody>
      </p:sp>
      <p:sp>
        <p:nvSpPr>
          <p:cNvPr id="30" name="Google Shape;30;p6"/>
          <p:cNvSpPr/>
          <p:nvPr/>
        </p:nvSpPr>
        <p:spPr>
          <a:xfrm>
            <a:off x="8051179" y="6415300"/>
            <a:ext cx="1627556" cy="615605"/>
          </a:xfrm>
          <a:custGeom>
            <a:avLst/>
            <a:gdLst/>
            <a:ahLst/>
            <a:cxnLst/>
            <a:rect l="l" t="t" r="r" b="b"/>
            <a:pathLst>
              <a:path w="64014" h="9771" extrusionOk="0">
                <a:moveTo>
                  <a:pt x="31876" y="1"/>
                </a:moveTo>
                <a:cubicBezTo>
                  <a:pt x="14187" y="1"/>
                  <a:pt x="1" y="2155"/>
                  <a:pt x="1" y="4875"/>
                </a:cubicBezTo>
                <a:cubicBezTo>
                  <a:pt x="1" y="7573"/>
                  <a:pt x="14339" y="9770"/>
                  <a:pt x="32007" y="9770"/>
                </a:cubicBezTo>
                <a:cubicBezTo>
                  <a:pt x="49674" y="9770"/>
                  <a:pt x="64013" y="7573"/>
                  <a:pt x="64013" y="4875"/>
                </a:cubicBezTo>
                <a:cubicBezTo>
                  <a:pt x="64013" y="2155"/>
                  <a:pt x="49544" y="1"/>
                  <a:pt x="31876" y="1"/>
                </a:cubicBezTo>
                <a:close/>
              </a:path>
            </a:pathLst>
          </a:custGeom>
          <a:solidFill>
            <a:srgbClr val="191919">
              <a:alpha val="17610"/>
            </a:srgbClr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/>
          </a:p>
        </p:txBody>
      </p:sp>
      <p:sp>
        <p:nvSpPr>
          <p:cNvPr id="31" name="Google Shape;31;p6"/>
          <p:cNvSpPr/>
          <p:nvPr/>
        </p:nvSpPr>
        <p:spPr>
          <a:xfrm>
            <a:off x="-578183" y="6415300"/>
            <a:ext cx="1627556" cy="615605"/>
          </a:xfrm>
          <a:custGeom>
            <a:avLst/>
            <a:gdLst/>
            <a:ahLst/>
            <a:cxnLst/>
            <a:rect l="l" t="t" r="r" b="b"/>
            <a:pathLst>
              <a:path w="64014" h="9771" extrusionOk="0">
                <a:moveTo>
                  <a:pt x="31876" y="1"/>
                </a:moveTo>
                <a:cubicBezTo>
                  <a:pt x="14187" y="1"/>
                  <a:pt x="1" y="2155"/>
                  <a:pt x="1" y="4875"/>
                </a:cubicBezTo>
                <a:cubicBezTo>
                  <a:pt x="1" y="7573"/>
                  <a:pt x="14339" y="9770"/>
                  <a:pt x="32007" y="9770"/>
                </a:cubicBezTo>
                <a:cubicBezTo>
                  <a:pt x="49674" y="9770"/>
                  <a:pt x="64013" y="7573"/>
                  <a:pt x="64013" y="4875"/>
                </a:cubicBezTo>
                <a:cubicBezTo>
                  <a:pt x="64013" y="2155"/>
                  <a:pt x="49544" y="1"/>
                  <a:pt x="31876" y="1"/>
                </a:cubicBezTo>
                <a:close/>
              </a:path>
            </a:pathLst>
          </a:custGeom>
          <a:solidFill>
            <a:srgbClr val="191919">
              <a:alpha val="17610"/>
            </a:srgbClr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/>
          </a:p>
        </p:txBody>
      </p:sp>
      <p:grpSp>
        <p:nvGrpSpPr>
          <p:cNvPr id="32" name="Google Shape;32;p6"/>
          <p:cNvGrpSpPr/>
          <p:nvPr/>
        </p:nvGrpSpPr>
        <p:grpSpPr>
          <a:xfrm>
            <a:off x="8430826" y="3001303"/>
            <a:ext cx="868271" cy="3856696"/>
            <a:chOff x="-1434450" y="2250977"/>
            <a:chExt cx="868271" cy="2892522"/>
          </a:xfrm>
        </p:grpSpPr>
        <p:sp>
          <p:nvSpPr>
            <p:cNvPr id="33" name="Google Shape;33;p6"/>
            <p:cNvSpPr/>
            <p:nvPr/>
          </p:nvSpPr>
          <p:spPr>
            <a:xfrm>
              <a:off x="-1301572" y="2770032"/>
              <a:ext cx="359138" cy="275989"/>
            </a:xfrm>
            <a:custGeom>
              <a:avLst/>
              <a:gdLst/>
              <a:ahLst/>
              <a:cxnLst/>
              <a:rect l="l" t="t" r="r" b="b"/>
              <a:pathLst>
                <a:path w="4527" h="3479" extrusionOk="0">
                  <a:moveTo>
                    <a:pt x="4178" y="0"/>
                  </a:moveTo>
                  <a:cubicBezTo>
                    <a:pt x="4178" y="0"/>
                    <a:pt x="2046" y="1001"/>
                    <a:pt x="1023" y="1654"/>
                  </a:cubicBezTo>
                  <a:cubicBezTo>
                    <a:pt x="23" y="2329"/>
                    <a:pt x="1" y="2742"/>
                    <a:pt x="218" y="3112"/>
                  </a:cubicBezTo>
                  <a:cubicBezTo>
                    <a:pt x="375" y="3377"/>
                    <a:pt x="593" y="3479"/>
                    <a:pt x="839" y="3479"/>
                  </a:cubicBezTo>
                  <a:cubicBezTo>
                    <a:pt x="1480" y="3479"/>
                    <a:pt x="2305" y="2786"/>
                    <a:pt x="2699" y="2503"/>
                  </a:cubicBezTo>
                  <a:cubicBezTo>
                    <a:pt x="3243" y="2133"/>
                    <a:pt x="4527" y="610"/>
                    <a:pt x="4527" y="610"/>
                  </a:cubicBezTo>
                  <a:lnTo>
                    <a:pt x="4178" y="0"/>
                  </a:lnTo>
                  <a:close/>
                </a:path>
              </a:pathLst>
            </a:custGeom>
            <a:solidFill>
              <a:srgbClr val="3183B5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34" name="Google Shape;34;p6"/>
            <p:cNvSpPr/>
            <p:nvPr/>
          </p:nvSpPr>
          <p:spPr>
            <a:xfrm>
              <a:off x="-1325689" y="2782090"/>
              <a:ext cx="367706" cy="285350"/>
            </a:xfrm>
            <a:custGeom>
              <a:avLst/>
              <a:gdLst/>
              <a:ahLst/>
              <a:cxnLst/>
              <a:rect l="l" t="t" r="r" b="b"/>
              <a:pathLst>
                <a:path w="4635" h="3597" extrusionOk="0">
                  <a:moveTo>
                    <a:pt x="3873" y="1"/>
                  </a:moveTo>
                  <a:cubicBezTo>
                    <a:pt x="3873" y="1"/>
                    <a:pt x="2002" y="893"/>
                    <a:pt x="1001" y="1546"/>
                  </a:cubicBezTo>
                  <a:cubicBezTo>
                    <a:pt x="0" y="2177"/>
                    <a:pt x="44" y="2851"/>
                    <a:pt x="261" y="3221"/>
                  </a:cubicBezTo>
                  <a:cubicBezTo>
                    <a:pt x="416" y="3493"/>
                    <a:pt x="636" y="3596"/>
                    <a:pt x="883" y="3596"/>
                  </a:cubicBezTo>
                  <a:cubicBezTo>
                    <a:pt x="1506" y="3596"/>
                    <a:pt x="2303" y="2942"/>
                    <a:pt x="2676" y="2677"/>
                  </a:cubicBezTo>
                  <a:cubicBezTo>
                    <a:pt x="3220" y="2307"/>
                    <a:pt x="4635" y="1284"/>
                    <a:pt x="4635" y="1284"/>
                  </a:cubicBezTo>
                  <a:lnTo>
                    <a:pt x="3873" y="1"/>
                  </a:lnTo>
                  <a:close/>
                </a:path>
              </a:pathLst>
            </a:custGeom>
            <a:solidFill>
              <a:srgbClr val="3183B5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35" name="Google Shape;35;p6"/>
            <p:cNvSpPr/>
            <p:nvPr/>
          </p:nvSpPr>
          <p:spPr>
            <a:xfrm>
              <a:off x="-987426" y="2766303"/>
              <a:ext cx="129550" cy="74967"/>
            </a:xfrm>
            <a:custGeom>
              <a:avLst/>
              <a:gdLst/>
              <a:ahLst/>
              <a:cxnLst/>
              <a:rect l="l" t="t" r="r" b="b"/>
              <a:pathLst>
                <a:path w="1633" h="945" extrusionOk="0">
                  <a:moveTo>
                    <a:pt x="562" y="0"/>
                  </a:moveTo>
                  <a:cubicBezTo>
                    <a:pt x="289" y="0"/>
                    <a:pt x="1" y="156"/>
                    <a:pt x="1" y="156"/>
                  </a:cubicBezTo>
                  <a:lnTo>
                    <a:pt x="284" y="809"/>
                  </a:lnTo>
                  <a:cubicBezTo>
                    <a:pt x="284" y="809"/>
                    <a:pt x="1067" y="918"/>
                    <a:pt x="1176" y="939"/>
                  </a:cubicBezTo>
                  <a:cubicBezTo>
                    <a:pt x="1184" y="943"/>
                    <a:pt x="1194" y="944"/>
                    <a:pt x="1205" y="944"/>
                  </a:cubicBezTo>
                  <a:cubicBezTo>
                    <a:pt x="1336" y="944"/>
                    <a:pt x="1633" y="722"/>
                    <a:pt x="1633" y="722"/>
                  </a:cubicBezTo>
                  <a:cubicBezTo>
                    <a:pt x="1633" y="722"/>
                    <a:pt x="1132" y="265"/>
                    <a:pt x="828" y="69"/>
                  </a:cubicBezTo>
                  <a:cubicBezTo>
                    <a:pt x="749" y="19"/>
                    <a:pt x="657" y="0"/>
                    <a:pt x="562" y="0"/>
                  </a:cubicBezTo>
                  <a:close/>
                </a:path>
              </a:pathLst>
            </a:custGeom>
            <a:solidFill>
              <a:srgbClr val="3183B5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36" name="Google Shape;36;p6"/>
            <p:cNvSpPr/>
            <p:nvPr/>
          </p:nvSpPr>
          <p:spPr>
            <a:xfrm>
              <a:off x="-964975" y="2742425"/>
              <a:ext cx="100197" cy="55610"/>
            </a:xfrm>
            <a:custGeom>
              <a:avLst/>
              <a:gdLst/>
              <a:ahLst/>
              <a:cxnLst/>
              <a:rect l="l" t="t" r="r" b="b"/>
              <a:pathLst>
                <a:path w="1263" h="701" extrusionOk="0">
                  <a:moveTo>
                    <a:pt x="1219" y="0"/>
                  </a:moveTo>
                  <a:cubicBezTo>
                    <a:pt x="1176" y="0"/>
                    <a:pt x="849" y="196"/>
                    <a:pt x="740" y="196"/>
                  </a:cubicBezTo>
                  <a:cubicBezTo>
                    <a:pt x="109" y="240"/>
                    <a:pt x="1" y="392"/>
                    <a:pt x="1" y="392"/>
                  </a:cubicBezTo>
                  <a:cubicBezTo>
                    <a:pt x="1" y="392"/>
                    <a:pt x="348" y="700"/>
                    <a:pt x="588" y="700"/>
                  </a:cubicBezTo>
                  <a:cubicBezTo>
                    <a:pt x="603" y="700"/>
                    <a:pt x="618" y="699"/>
                    <a:pt x="632" y="697"/>
                  </a:cubicBezTo>
                  <a:cubicBezTo>
                    <a:pt x="849" y="653"/>
                    <a:pt x="871" y="566"/>
                    <a:pt x="914" y="479"/>
                  </a:cubicBezTo>
                  <a:cubicBezTo>
                    <a:pt x="958" y="392"/>
                    <a:pt x="1045" y="370"/>
                    <a:pt x="1154" y="261"/>
                  </a:cubicBezTo>
                  <a:cubicBezTo>
                    <a:pt x="1241" y="174"/>
                    <a:pt x="1263" y="0"/>
                    <a:pt x="1219" y="0"/>
                  </a:cubicBezTo>
                  <a:close/>
                </a:path>
              </a:pathLst>
            </a:custGeom>
            <a:solidFill>
              <a:srgbClr val="3183B5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37" name="Google Shape;37;p6"/>
            <p:cNvSpPr/>
            <p:nvPr/>
          </p:nvSpPr>
          <p:spPr>
            <a:xfrm>
              <a:off x="-933878" y="2795655"/>
              <a:ext cx="157158" cy="55055"/>
            </a:xfrm>
            <a:custGeom>
              <a:avLst/>
              <a:gdLst/>
              <a:ahLst/>
              <a:cxnLst/>
              <a:rect l="l" t="t" r="r" b="b"/>
              <a:pathLst>
                <a:path w="1981" h="694" extrusionOk="0">
                  <a:moveTo>
                    <a:pt x="1867" y="1"/>
                  </a:moveTo>
                  <a:cubicBezTo>
                    <a:pt x="1811" y="1"/>
                    <a:pt x="1736" y="21"/>
                    <a:pt x="1654" y="91"/>
                  </a:cubicBezTo>
                  <a:cubicBezTo>
                    <a:pt x="1522" y="185"/>
                    <a:pt x="1358" y="295"/>
                    <a:pt x="1344" y="295"/>
                  </a:cubicBezTo>
                  <a:cubicBezTo>
                    <a:pt x="1342" y="295"/>
                    <a:pt x="1343" y="293"/>
                    <a:pt x="1349" y="287"/>
                  </a:cubicBezTo>
                  <a:lnTo>
                    <a:pt x="1349" y="287"/>
                  </a:lnTo>
                  <a:cubicBezTo>
                    <a:pt x="1284" y="308"/>
                    <a:pt x="1219" y="352"/>
                    <a:pt x="1153" y="352"/>
                  </a:cubicBezTo>
                  <a:cubicBezTo>
                    <a:pt x="1001" y="330"/>
                    <a:pt x="675" y="113"/>
                    <a:pt x="675" y="113"/>
                  </a:cubicBezTo>
                  <a:cubicBezTo>
                    <a:pt x="675" y="113"/>
                    <a:pt x="675" y="91"/>
                    <a:pt x="653" y="91"/>
                  </a:cubicBezTo>
                  <a:cubicBezTo>
                    <a:pt x="615" y="166"/>
                    <a:pt x="561" y="226"/>
                    <a:pt x="505" y="226"/>
                  </a:cubicBezTo>
                  <a:cubicBezTo>
                    <a:pt x="496" y="226"/>
                    <a:pt x="488" y="224"/>
                    <a:pt x="479" y="221"/>
                  </a:cubicBezTo>
                  <a:cubicBezTo>
                    <a:pt x="461" y="210"/>
                    <a:pt x="424" y="203"/>
                    <a:pt x="378" y="203"/>
                  </a:cubicBezTo>
                  <a:cubicBezTo>
                    <a:pt x="254" y="203"/>
                    <a:pt x="64" y="253"/>
                    <a:pt x="0" y="395"/>
                  </a:cubicBezTo>
                  <a:cubicBezTo>
                    <a:pt x="0" y="395"/>
                    <a:pt x="218" y="526"/>
                    <a:pt x="522" y="591"/>
                  </a:cubicBezTo>
                  <a:cubicBezTo>
                    <a:pt x="566" y="591"/>
                    <a:pt x="610" y="613"/>
                    <a:pt x="653" y="635"/>
                  </a:cubicBezTo>
                  <a:lnTo>
                    <a:pt x="762" y="635"/>
                  </a:lnTo>
                  <a:cubicBezTo>
                    <a:pt x="784" y="635"/>
                    <a:pt x="805" y="657"/>
                    <a:pt x="827" y="657"/>
                  </a:cubicBezTo>
                  <a:cubicBezTo>
                    <a:pt x="842" y="657"/>
                    <a:pt x="866" y="647"/>
                    <a:pt x="893" y="647"/>
                  </a:cubicBezTo>
                  <a:cubicBezTo>
                    <a:pt x="907" y="647"/>
                    <a:pt x="921" y="649"/>
                    <a:pt x="936" y="657"/>
                  </a:cubicBezTo>
                  <a:cubicBezTo>
                    <a:pt x="958" y="657"/>
                    <a:pt x="1001" y="678"/>
                    <a:pt x="1023" y="678"/>
                  </a:cubicBezTo>
                  <a:cubicBezTo>
                    <a:pt x="1045" y="689"/>
                    <a:pt x="1062" y="693"/>
                    <a:pt x="1077" y="693"/>
                  </a:cubicBezTo>
                  <a:cubicBezTo>
                    <a:pt x="1121" y="693"/>
                    <a:pt x="1137" y="657"/>
                    <a:pt x="1153" y="657"/>
                  </a:cubicBezTo>
                  <a:cubicBezTo>
                    <a:pt x="1241" y="678"/>
                    <a:pt x="1284" y="678"/>
                    <a:pt x="1306" y="678"/>
                  </a:cubicBezTo>
                  <a:cubicBezTo>
                    <a:pt x="1371" y="657"/>
                    <a:pt x="1676" y="417"/>
                    <a:pt x="1697" y="374"/>
                  </a:cubicBezTo>
                  <a:cubicBezTo>
                    <a:pt x="1741" y="308"/>
                    <a:pt x="1980" y="69"/>
                    <a:pt x="1959" y="26"/>
                  </a:cubicBezTo>
                  <a:cubicBezTo>
                    <a:pt x="1948" y="15"/>
                    <a:pt x="1915" y="1"/>
                    <a:pt x="1867" y="1"/>
                  </a:cubicBezTo>
                  <a:close/>
                </a:path>
              </a:pathLst>
            </a:custGeom>
            <a:solidFill>
              <a:srgbClr val="3183B5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38" name="Google Shape;38;p6"/>
            <p:cNvSpPr/>
            <p:nvPr/>
          </p:nvSpPr>
          <p:spPr>
            <a:xfrm>
              <a:off x="-882075" y="2783835"/>
              <a:ext cx="65608" cy="39744"/>
            </a:xfrm>
            <a:custGeom>
              <a:avLst/>
              <a:gdLst/>
              <a:ahLst/>
              <a:cxnLst/>
              <a:rect l="l" t="t" r="r" b="b"/>
              <a:pathLst>
                <a:path w="827" h="501" extrusionOk="0">
                  <a:moveTo>
                    <a:pt x="718" y="0"/>
                  </a:moveTo>
                  <a:cubicBezTo>
                    <a:pt x="675" y="0"/>
                    <a:pt x="544" y="131"/>
                    <a:pt x="544" y="131"/>
                  </a:cubicBezTo>
                  <a:cubicBezTo>
                    <a:pt x="544" y="131"/>
                    <a:pt x="500" y="22"/>
                    <a:pt x="479" y="22"/>
                  </a:cubicBezTo>
                  <a:cubicBezTo>
                    <a:pt x="472" y="21"/>
                    <a:pt x="466" y="20"/>
                    <a:pt x="459" y="20"/>
                  </a:cubicBezTo>
                  <a:cubicBezTo>
                    <a:pt x="382" y="20"/>
                    <a:pt x="323" y="133"/>
                    <a:pt x="283" y="153"/>
                  </a:cubicBezTo>
                  <a:cubicBezTo>
                    <a:pt x="280" y="158"/>
                    <a:pt x="278" y="161"/>
                    <a:pt x="276" y="161"/>
                  </a:cubicBezTo>
                  <a:cubicBezTo>
                    <a:pt x="260" y="161"/>
                    <a:pt x="256" y="44"/>
                    <a:pt x="218" y="44"/>
                  </a:cubicBezTo>
                  <a:cubicBezTo>
                    <a:pt x="131" y="44"/>
                    <a:pt x="65" y="153"/>
                    <a:pt x="0" y="240"/>
                  </a:cubicBezTo>
                  <a:cubicBezTo>
                    <a:pt x="22" y="240"/>
                    <a:pt x="22" y="262"/>
                    <a:pt x="22" y="262"/>
                  </a:cubicBezTo>
                  <a:cubicBezTo>
                    <a:pt x="22" y="262"/>
                    <a:pt x="348" y="479"/>
                    <a:pt x="500" y="501"/>
                  </a:cubicBezTo>
                  <a:cubicBezTo>
                    <a:pt x="566" y="501"/>
                    <a:pt x="631" y="457"/>
                    <a:pt x="696" y="436"/>
                  </a:cubicBezTo>
                  <a:cubicBezTo>
                    <a:pt x="718" y="414"/>
                    <a:pt x="805" y="196"/>
                    <a:pt x="805" y="87"/>
                  </a:cubicBezTo>
                  <a:cubicBezTo>
                    <a:pt x="827" y="22"/>
                    <a:pt x="762" y="0"/>
                    <a:pt x="718" y="0"/>
                  </a:cubicBezTo>
                  <a:close/>
                </a:path>
              </a:pathLst>
            </a:custGeom>
            <a:solidFill>
              <a:srgbClr val="3183B5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39" name="Google Shape;39;p6"/>
            <p:cNvSpPr/>
            <p:nvPr/>
          </p:nvSpPr>
          <p:spPr>
            <a:xfrm>
              <a:off x="-973622" y="2275252"/>
              <a:ext cx="184765" cy="339612"/>
            </a:xfrm>
            <a:custGeom>
              <a:avLst/>
              <a:gdLst/>
              <a:ahLst/>
              <a:cxnLst/>
              <a:rect l="l" t="t" r="r" b="b"/>
              <a:pathLst>
                <a:path w="2329" h="4281" extrusionOk="0">
                  <a:moveTo>
                    <a:pt x="1216" y="0"/>
                  </a:moveTo>
                  <a:cubicBezTo>
                    <a:pt x="753" y="0"/>
                    <a:pt x="393" y="515"/>
                    <a:pt x="393" y="515"/>
                  </a:cubicBezTo>
                  <a:lnTo>
                    <a:pt x="305" y="1821"/>
                  </a:lnTo>
                  <a:cubicBezTo>
                    <a:pt x="305" y="1821"/>
                    <a:pt x="480" y="2408"/>
                    <a:pt x="240" y="3170"/>
                  </a:cubicBezTo>
                  <a:cubicBezTo>
                    <a:pt x="1" y="3931"/>
                    <a:pt x="675" y="4236"/>
                    <a:pt x="915" y="4279"/>
                  </a:cubicBezTo>
                  <a:cubicBezTo>
                    <a:pt x="925" y="4280"/>
                    <a:pt x="935" y="4281"/>
                    <a:pt x="945" y="4281"/>
                  </a:cubicBezTo>
                  <a:cubicBezTo>
                    <a:pt x="1165" y="4281"/>
                    <a:pt x="1281" y="4060"/>
                    <a:pt x="1198" y="4018"/>
                  </a:cubicBezTo>
                  <a:cubicBezTo>
                    <a:pt x="1089" y="3996"/>
                    <a:pt x="1633" y="2473"/>
                    <a:pt x="1959" y="2125"/>
                  </a:cubicBezTo>
                  <a:cubicBezTo>
                    <a:pt x="2285" y="1777"/>
                    <a:pt x="2329" y="667"/>
                    <a:pt x="1654" y="167"/>
                  </a:cubicBezTo>
                  <a:cubicBezTo>
                    <a:pt x="1504" y="46"/>
                    <a:pt x="1356" y="0"/>
                    <a:pt x="1216" y="0"/>
                  </a:cubicBezTo>
                  <a:close/>
                </a:path>
              </a:pathLst>
            </a:custGeom>
            <a:solidFill>
              <a:schemeClr val="accent5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40" name="Google Shape;40;p6"/>
            <p:cNvSpPr/>
            <p:nvPr/>
          </p:nvSpPr>
          <p:spPr>
            <a:xfrm>
              <a:off x="-1220418" y="4837604"/>
              <a:ext cx="260687" cy="252587"/>
            </a:xfrm>
            <a:custGeom>
              <a:avLst/>
              <a:gdLst/>
              <a:ahLst/>
              <a:cxnLst/>
              <a:rect l="l" t="t" r="r" b="b"/>
              <a:pathLst>
                <a:path w="3286" h="3184" extrusionOk="0">
                  <a:moveTo>
                    <a:pt x="2838" y="0"/>
                  </a:moveTo>
                  <a:cubicBezTo>
                    <a:pt x="2714" y="0"/>
                    <a:pt x="1763" y="330"/>
                    <a:pt x="1763" y="330"/>
                  </a:cubicBezTo>
                  <a:cubicBezTo>
                    <a:pt x="1763" y="330"/>
                    <a:pt x="1676" y="983"/>
                    <a:pt x="697" y="2375"/>
                  </a:cubicBezTo>
                  <a:cubicBezTo>
                    <a:pt x="697" y="2375"/>
                    <a:pt x="0" y="2941"/>
                    <a:pt x="66" y="3071"/>
                  </a:cubicBezTo>
                  <a:cubicBezTo>
                    <a:pt x="88" y="3151"/>
                    <a:pt x="290" y="3183"/>
                    <a:pt x="517" y="3183"/>
                  </a:cubicBezTo>
                  <a:cubicBezTo>
                    <a:pt x="724" y="3183"/>
                    <a:pt x="953" y="3157"/>
                    <a:pt x="1088" y="3115"/>
                  </a:cubicBezTo>
                  <a:cubicBezTo>
                    <a:pt x="1393" y="3028"/>
                    <a:pt x="1872" y="2179"/>
                    <a:pt x="2220" y="1940"/>
                  </a:cubicBezTo>
                  <a:cubicBezTo>
                    <a:pt x="2568" y="1701"/>
                    <a:pt x="2916" y="1788"/>
                    <a:pt x="3177" y="1483"/>
                  </a:cubicBezTo>
                  <a:cubicBezTo>
                    <a:pt x="3286" y="1374"/>
                    <a:pt x="3286" y="1004"/>
                    <a:pt x="3155" y="787"/>
                  </a:cubicBezTo>
                  <a:cubicBezTo>
                    <a:pt x="3047" y="613"/>
                    <a:pt x="2894" y="373"/>
                    <a:pt x="2851" y="4"/>
                  </a:cubicBezTo>
                  <a:cubicBezTo>
                    <a:pt x="2850" y="1"/>
                    <a:pt x="2845" y="0"/>
                    <a:pt x="2838" y="0"/>
                  </a:cubicBezTo>
                  <a:close/>
                </a:path>
              </a:pathLst>
            </a:custGeom>
            <a:solidFill>
              <a:srgbClr val="E9CAB7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41" name="Google Shape;41;p6"/>
            <p:cNvSpPr/>
            <p:nvPr/>
          </p:nvSpPr>
          <p:spPr>
            <a:xfrm>
              <a:off x="-1232476" y="4875841"/>
              <a:ext cx="276236" cy="225377"/>
            </a:xfrm>
            <a:custGeom>
              <a:avLst/>
              <a:gdLst/>
              <a:ahLst/>
              <a:cxnLst/>
              <a:rect l="l" t="t" r="r" b="b"/>
              <a:pathLst>
                <a:path w="3482" h="2841" extrusionOk="0">
                  <a:moveTo>
                    <a:pt x="3133" y="0"/>
                  </a:moveTo>
                  <a:cubicBezTo>
                    <a:pt x="3133" y="0"/>
                    <a:pt x="3133" y="283"/>
                    <a:pt x="2937" y="566"/>
                  </a:cubicBezTo>
                  <a:cubicBezTo>
                    <a:pt x="2763" y="827"/>
                    <a:pt x="1828" y="1676"/>
                    <a:pt x="1132" y="2111"/>
                  </a:cubicBezTo>
                  <a:cubicBezTo>
                    <a:pt x="1077" y="2138"/>
                    <a:pt x="934" y="2166"/>
                    <a:pt x="826" y="2166"/>
                  </a:cubicBezTo>
                  <a:cubicBezTo>
                    <a:pt x="764" y="2166"/>
                    <a:pt x="712" y="2157"/>
                    <a:pt x="696" y="2133"/>
                  </a:cubicBezTo>
                  <a:cubicBezTo>
                    <a:pt x="653" y="2067"/>
                    <a:pt x="849" y="1893"/>
                    <a:pt x="849" y="1893"/>
                  </a:cubicBezTo>
                  <a:lnTo>
                    <a:pt x="849" y="1893"/>
                  </a:lnTo>
                  <a:cubicBezTo>
                    <a:pt x="522" y="2133"/>
                    <a:pt x="0" y="2633"/>
                    <a:pt x="44" y="2742"/>
                  </a:cubicBezTo>
                  <a:cubicBezTo>
                    <a:pt x="64" y="2812"/>
                    <a:pt x="290" y="2840"/>
                    <a:pt x="556" y="2840"/>
                  </a:cubicBezTo>
                  <a:cubicBezTo>
                    <a:pt x="870" y="2840"/>
                    <a:pt x="1240" y="2801"/>
                    <a:pt x="1393" y="2742"/>
                  </a:cubicBezTo>
                  <a:cubicBezTo>
                    <a:pt x="1697" y="2655"/>
                    <a:pt x="2132" y="1828"/>
                    <a:pt x="2481" y="1589"/>
                  </a:cubicBezTo>
                  <a:cubicBezTo>
                    <a:pt x="2633" y="1480"/>
                    <a:pt x="3177" y="1175"/>
                    <a:pt x="3329" y="1001"/>
                  </a:cubicBezTo>
                  <a:cubicBezTo>
                    <a:pt x="3373" y="958"/>
                    <a:pt x="3438" y="784"/>
                    <a:pt x="3438" y="718"/>
                  </a:cubicBezTo>
                  <a:cubicBezTo>
                    <a:pt x="3481" y="414"/>
                    <a:pt x="3199" y="0"/>
                    <a:pt x="3133" y="0"/>
                  </a:cubicBezTo>
                  <a:close/>
                </a:path>
              </a:pathLst>
            </a:custGeom>
            <a:solidFill>
              <a:schemeClr val="dk1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42" name="Google Shape;42;p6"/>
            <p:cNvSpPr/>
            <p:nvPr/>
          </p:nvSpPr>
          <p:spPr>
            <a:xfrm>
              <a:off x="-1040894" y="4927643"/>
              <a:ext cx="81157" cy="136368"/>
            </a:xfrm>
            <a:custGeom>
              <a:avLst/>
              <a:gdLst/>
              <a:ahLst/>
              <a:cxnLst/>
              <a:rect l="l" t="t" r="r" b="b"/>
              <a:pathLst>
                <a:path w="1023" h="1719" extrusionOk="0">
                  <a:moveTo>
                    <a:pt x="1023" y="0"/>
                  </a:moveTo>
                  <a:cubicBezTo>
                    <a:pt x="1023" y="0"/>
                    <a:pt x="1" y="944"/>
                    <a:pt x="49" y="944"/>
                  </a:cubicBezTo>
                  <a:cubicBezTo>
                    <a:pt x="52" y="944"/>
                    <a:pt x="57" y="941"/>
                    <a:pt x="66" y="936"/>
                  </a:cubicBezTo>
                  <a:cubicBezTo>
                    <a:pt x="155" y="875"/>
                    <a:pt x="229" y="849"/>
                    <a:pt x="291" y="849"/>
                  </a:cubicBezTo>
                  <a:cubicBezTo>
                    <a:pt x="645" y="849"/>
                    <a:pt x="566" y="1719"/>
                    <a:pt x="566" y="1719"/>
                  </a:cubicBezTo>
                  <a:lnTo>
                    <a:pt x="697" y="1719"/>
                  </a:lnTo>
                  <a:cubicBezTo>
                    <a:pt x="697" y="1719"/>
                    <a:pt x="718" y="1088"/>
                    <a:pt x="805" y="805"/>
                  </a:cubicBezTo>
                  <a:cubicBezTo>
                    <a:pt x="849" y="588"/>
                    <a:pt x="1023" y="0"/>
                    <a:pt x="1023" y="0"/>
                  </a:cubicBezTo>
                  <a:close/>
                </a:path>
              </a:pathLst>
            </a:custGeom>
            <a:solidFill>
              <a:schemeClr val="dk1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43" name="Google Shape;43;p6"/>
            <p:cNvSpPr/>
            <p:nvPr/>
          </p:nvSpPr>
          <p:spPr>
            <a:xfrm>
              <a:off x="-1138311" y="4121018"/>
              <a:ext cx="220068" cy="762282"/>
            </a:xfrm>
            <a:custGeom>
              <a:avLst/>
              <a:gdLst/>
              <a:ahLst/>
              <a:cxnLst/>
              <a:rect l="l" t="t" r="r" b="b"/>
              <a:pathLst>
                <a:path w="2774" h="9609" extrusionOk="0">
                  <a:moveTo>
                    <a:pt x="554" y="1"/>
                  </a:moveTo>
                  <a:cubicBezTo>
                    <a:pt x="240" y="1"/>
                    <a:pt x="0" y="152"/>
                    <a:pt x="10" y="573"/>
                  </a:cubicBezTo>
                  <a:cubicBezTo>
                    <a:pt x="10" y="747"/>
                    <a:pt x="227" y="2683"/>
                    <a:pt x="293" y="3097"/>
                  </a:cubicBezTo>
                  <a:cubicBezTo>
                    <a:pt x="358" y="3510"/>
                    <a:pt x="815" y="7775"/>
                    <a:pt x="728" y="9363"/>
                  </a:cubicBezTo>
                  <a:cubicBezTo>
                    <a:pt x="728" y="9476"/>
                    <a:pt x="1199" y="9608"/>
                    <a:pt x="1509" y="9608"/>
                  </a:cubicBezTo>
                  <a:cubicBezTo>
                    <a:pt x="1675" y="9608"/>
                    <a:pt x="1795" y="9570"/>
                    <a:pt x="1772" y="9472"/>
                  </a:cubicBezTo>
                  <a:cubicBezTo>
                    <a:pt x="1729" y="9189"/>
                    <a:pt x="2686" y="4990"/>
                    <a:pt x="2730" y="4185"/>
                  </a:cubicBezTo>
                  <a:cubicBezTo>
                    <a:pt x="2773" y="3401"/>
                    <a:pt x="2599" y="1334"/>
                    <a:pt x="1794" y="529"/>
                  </a:cubicBezTo>
                  <a:cubicBezTo>
                    <a:pt x="1521" y="268"/>
                    <a:pt x="971" y="1"/>
                    <a:pt x="554" y="1"/>
                  </a:cubicBezTo>
                  <a:close/>
                </a:path>
              </a:pathLst>
            </a:custGeom>
            <a:solidFill>
              <a:srgbClr val="E9CAB7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44" name="Google Shape;44;p6"/>
            <p:cNvSpPr/>
            <p:nvPr/>
          </p:nvSpPr>
          <p:spPr>
            <a:xfrm>
              <a:off x="-685337" y="4967308"/>
              <a:ext cx="119157" cy="176192"/>
            </a:xfrm>
            <a:custGeom>
              <a:avLst/>
              <a:gdLst/>
              <a:ahLst/>
              <a:cxnLst/>
              <a:rect l="l" t="t" r="r" b="b"/>
              <a:pathLst>
                <a:path w="1502" h="2221" extrusionOk="0">
                  <a:moveTo>
                    <a:pt x="1088" y="0"/>
                  </a:moveTo>
                  <a:lnTo>
                    <a:pt x="0" y="327"/>
                  </a:lnTo>
                  <a:cubicBezTo>
                    <a:pt x="0" y="327"/>
                    <a:pt x="22" y="1241"/>
                    <a:pt x="370" y="1676"/>
                  </a:cubicBezTo>
                  <a:cubicBezTo>
                    <a:pt x="434" y="1761"/>
                    <a:pt x="935" y="2220"/>
                    <a:pt x="1140" y="2220"/>
                  </a:cubicBezTo>
                  <a:cubicBezTo>
                    <a:pt x="1145" y="2220"/>
                    <a:pt x="1149" y="2220"/>
                    <a:pt x="1154" y="2220"/>
                  </a:cubicBezTo>
                  <a:cubicBezTo>
                    <a:pt x="1371" y="2176"/>
                    <a:pt x="1502" y="1545"/>
                    <a:pt x="1502" y="1262"/>
                  </a:cubicBezTo>
                  <a:cubicBezTo>
                    <a:pt x="1502" y="1001"/>
                    <a:pt x="1088" y="0"/>
                    <a:pt x="1088" y="0"/>
                  </a:cubicBezTo>
                  <a:close/>
                </a:path>
              </a:pathLst>
            </a:custGeom>
            <a:solidFill>
              <a:schemeClr val="dk1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45" name="Google Shape;45;p6"/>
            <p:cNvSpPr/>
            <p:nvPr/>
          </p:nvSpPr>
          <p:spPr>
            <a:xfrm>
              <a:off x="-687082" y="4922407"/>
              <a:ext cx="103688" cy="164134"/>
            </a:xfrm>
            <a:custGeom>
              <a:avLst/>
              <a:gdLst/>
              <a:ahLst/>
              <a:cxnLst/>
              <a:rect l="l" t="t" r="r" b="b"/>
              <a:pathLst>
                <a:path w="1307" h="2069" extrusionOk="0">
                  <a:moveTo>
                    <a:pt x="893" y="1"/>
                  </a:moveTo>
                  <a:lnTo>
                    <a:pt x="44" y="88"/>
                  </a:lnTo>
                  <a:cubicBezTo>
                    <a:pt x="44" y="88"/>
                    <a:pt x="44" y="458"/>
                    <a:pt x="22" y="784"/>
                  </a:cubicBezTo>
                  <a:cubicBezTo>
                    <a:pt x="1" y="1128"/>
                    <a:pt x="447" y="2068"/>
                    <a:pt x="983" y="2068"/>
                  </a:cubicBezTo>
                  <a:cubicBezTo>
                    <a:pt x="989" y="2068"/>
                    <a:pt x="995" y="2068"/>
                    <a:pt x="1002" y="2068"/>
                  </a:cubicBezTo>
                  <a:cubicBezTo>
                    <a:pt x="1219" y="2068"/>
                    <a:pt x="1306" y="1502"/>
                    <a:pt x="1284" y="1350"/>
                  </a:cubicBezTo>
                  <a:cubicBezTo>
                    <a:pt x="1219" y="741"/>
                    <a:pt x="893" y="1"/>
                    <a:pt x="893" y="1"/>
                  </a:cubicBezTo>
                  <a:close/>
                </a:path>
              </a:pathLst>
            </a:custGeom>
            <a:solidFill>
              <a:srgbClr val="FAD9C5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46" name="Google Shape;46;p6"/>
            <p:cNvSpPr/>
            <p:nvPr/>
          </p:nvSpPr>
          <p:spPr>
            <a:xfrm>
              <a:off x="-852803" y="4153067"/>
              <a:ext cx="252119" cy="847086"/>
            </a:xfrm>
            <a:custGeom>
              <a:avLst/>
              <a:gdLst/>
              <a:ahLst/>
              <a:cxnLst/>
              <a:rect l="l" t="t" r="r" b="b"/>
              <a:pathLst>
                <a:path w="3178" h="10678" extrusionOk="0">
                  <a:moveTo>
                    <a:pt x="1071" y="0"/>
                  </a:moveTo>
                  <a:cubicBezTo>
                    <a:pt x="1020" y="0"/>
                    <a:pt x="968" y="5"/>
                    <a:pt x="915" y="16"/>
                  </a:cubicBezTo>
                  <a:cubicBezTo>
                    <a:pt x="175" y="147"/>
                    <a:pt x="1" y="669"/>
                    <a:pt x="349" y="2801"/>
                  </a:cubicBezTo>
                  <a:cubicBezTo>
                    <a:pt x="632" y="4433"/>
                    <a:pt x="1633" y="8089"/>
                    <a:pt x="2111" y="9786"/>
                  </a:cubicBezTo>
                  <a:cubicBezTo>
                    <a:pt x="2286" y="10330"/>
                    <a:pt x="2220" y="10678"/>
                    <a:pt x="2264" y="10678"/>
                  </a:cubicBezTo>
                  <a:cubicBezTo>
                    <a:pt x="2481" y="10678"/>
                    <a:pt x="3091" y="10678"/>
                    <a:pt x="3156" y="10199"/>
                  </a:cubicBezTo>
                  <a:cubicBezTo>
                    <a:pt x="3178" y="10090"/>
                    <a:pt x="2938" y="9720"/>
                    <a:pt x="2938" y="9438"/>
                  </a:cubicBezTo>
                  <a:cubicBezTo>
                    <a:pt x="2938" y="7762"/>
                    <a:pt x="2917" y="3541"/>
                    <a:pt x="2829" y="2932"/>
                  </a:cubicBezTo>
                  <a:cubicBezTo>
                    <a:pt x="2705" y="2268"/>
                    <a:pt x="2125" y="0"/>
                    <a:pt x="1071" y="0"/>
                  </a:cubicBezTo>
                  <a:close/>
                </a:path>
              </a:pathLst>
            </a:custGeom>
            <a:solidFill>
              <a:srgbClr val="FAD9C5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47" name="Google Shape;47;p6"/>
            <p:cNvSpPr/>
            <p:nvPr/>
          </p:nvSpPr>
          <p:spPr>
            <a:xfrm>
              <a:off x="-1434450" y="2706965"/>
              <a:ext cx="347000" cy="513503"/>
            </a:xfrm>
            <a:custGeom>
              <a:avLst/>
              <a:gdLst/>
              <a:ahLst/>
              <a:cxnLst/>
              <a:rect l="l" t="t" r="r" b="b"/>
              <a:pathLst>
                <a:path w="4374" h="6473" extrusionOk="0">
                  <a:moveTo>
                    <a:pt x="3338" y="0"/>
                  </a:moveTo>
                  <a:cubicBezTo>
                    <a:pt x="2854" y="0"/>
                    <a:pt x="2108" y="1267"/>
                    <a:pt x="1654" y="2710"/>
                  </a:cubicBezTo>
                  <a:cubicBezTo>
                    <a:pt x="805" y="5386"/>
                    <a:pt x="0" y="5822"/>
                    <a:pt x="893" y="6322"/>
                  </a:cubicBezTo>
                  <a:cubicBezTo>
                    <a:pt x="1088" y="6424"/>
                    <a:pt x="1251" y="6473"/>
                    <a:pt x="1391" y="6473"/>
                  </a:cubicBezTo>
                  <a:cubicBezTo>
                    <a:pt x="2061" y="6473"/>
                    <a:pt x="2223" y="5358"/>
                    <a:pt x="3068" y="3559"/>
                  </a:cubicBezTo>
                  <a:cubicBezTo>
                    <a:pt x="3852" y="1840"/>
                    <a:pt x="4374" y="338"/>
                    <a:pt x="3416" y="12"/>
                  </a:cubicBezTo>
                  <a:cubicBezTo>
                    <a:pt x="3391" y="4"/>
                    <a:pt x="3365" y="0"/>
                    <a:pt x="3338" y="0"/>
                  </a:cubicBezTo>
                  <a:close/>
                </a:path>
              </a:pathLst>
            </a:custGeom>
            <a:solidFill>
              <a:schemeClr val="dk2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48" name="Google Shape;48;p6"/>
            <p:cNvSpPr/>
            <p:nvPr/>
          </p:nvSpPr>
          <p:spPr>
            <a:xfrm>
              <a:off x="-1229065" y="3487490"/>
              <a:ext cx="274570" cy="812657"/>
            </a:xfrm>
            <a:custGeom>
              <a:avLst/>
              <a:gdLst/>
              <a:ahLst/>
              <a:cxnLst/>
              <a:rect l="l" t="t" r="r" b="b"/>
              <a:pathLst>
                <a:path w="3461" h="10244" extrusionOk="0">
                  <a:moveTo>
                    <a:pt x="1571" y="0"/>
                  </a:moveTo>
                  <a:cubicBezTo>
                    <a:pt x="1113" y="0"/>
                    <a:pt x="614" y="197"/>
                    <a:pt x="349" y="682"/>
                  </a:cubicBezTo>
                  <a:cubicBezTo>
                    <a:pt x="1" y="1313"/>
                    <a:pt x="22" y="2423"/>
                    <a:pt x="196" y="3881"/>
                  </a:cubicBezTo>
                  <a:cubicBezTo>
                    <a:pt x="414" y="5861"/>
                    <a:pt x="1067" y="8994"/>
                    <a:pt x="1154" y="9277"/>
                  </a:cubicBezTo>
                  <a:cubicBezTo>
                    <a:pt x="1334" y="9940"/>
                    <a:pt x="1758" y="10243"/>
                    <a:pt x="2152" y="10243"/>
                  </a:cubicBezTo>
                  <a:cubicBezTo>
                    <a:pt x="2521" y="10243"/>
                    <a:pt x="2865" y="9978"/>
                    <a:pt x="2960" y="9494"/>
                  </a:cubicBezTo>
                  <a:cubicBezTo>
                    <a:pt x="3025" y="9211"/>
                    <a:pt x="3460" y="3533"/>
                    <a:pt x="3373" y="2902"/>
                  </a:cubicBezTo>
                  <a:cubicBezTo>
                    <a:pt x="3308" y="2271"/>
                    <a:pt x="2960" y="1117"/>
                    <a:pt x="2503" y="399"/>
                  </a:cubicBezTo>
                  <a:cubicBezTo>
                    <a:pt x="2350" y="154"/>
                    <a:pt x="1976" y="0"/>
                    <a:pt x="1571" y="0"/>
                  </a:cubicBezTo>
                  <a:close/>
                </a:path>
              </a:pathLst>
            </a:custGeom>
            <a:solidFill>
              <a:srgbClr val="E9CAB7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49" name="Google Shape;49;p6"/>
            <p:cNvSpPr/>
            <p:nvPr/>
          </p:nvSpPr>
          <p:spPr>
            <a:xfrm>
              <a:off x="-970132" y="3505102"/>
              <a:ext cx="300432" cy="796156"/>
            </a:xfrm>
            <a:custGeom>
              <a:avLst/>
              <a:gdLst/>
              <a:ahLst/>
              <a:cxnLst/>
              <a:rect l="l" t="t" r="r" b="b"/>
              <a:pathLst>
                <a:path w="3787" h="10036" extrusionOk="0">
                  <a:moveTo>
                    <a:pt x="1536" y="0"/>
                  </a:moveTo>
                  <a:cubicBezTo>
                    <a:pt x="966" y="0"/>
                    <a:pt x="434" y="209"/>
                    <a:pt x="305" y="526"/>
                  </a:cubicBezTo>
                  <a:cubicBezTo>
                    <a:pt x="0" y="1309"/>
                    <a:pt x="153" y="2462"/>
                    <a:pt x="218" y="3093"/>
                  </a:cubicBezTo>
                  <a:cubicBezTo>
                    <a:pt x="261" y="3724"/>
                    <a:pt x="1589" y="9185"/>
                    <a:pt x="1698" y="9446"/>
                  </a:cubicBezTo>
                  <a:cubicBezTo>
                    <a:pt x="1859" y="9841"/>
                    <a:pt x="2209" y="10036"/>
                    <a:pt x="2572" y="10036"/>
                  </a:cubicBezTo>
                  <a:cubicBezTo>
                    <a:pt x="3090" y="10036"/>
                    <a:pt x="3635" y="9639"/>
                    <a:pt x="3699" y="8859"/>
                  </a:cubicBezTo>
                  <a:cubicBezTo>
                    <a:pt x="3721" y="8576"/>
                    <a:pt x="3786" y="5595"/>
                    <a:pt x="3634" y="3615"/>
                  </a:cubicBezTo>
                  <a:cubicBezTo>
                    <a:pt x="3503" y="2157"/>
                    <a:pt x="3308" y="1048"/>
                    <a:pt x="2851" y="526"/>
                  </a:cubicBezTo>
                  <a:cubicBezTo>
                    <a:pt x="2539" y="154"/>
                    <a:pt x="2024" y="0"/>
                    <a:pt x="1536" y="0"/>
                  </a:cubicBezTo>
                  <a:close/>
                </a:path>
              </a:pathLst>
            </a:custGeom>
            <a:solidFill>
              <a:srgbClr val="FAD9C5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50" name="Google Shape;50;p6"/>
            <p:cNvSpPr/>
            <p:nvPr/>
          </p:nvSpPr>
          <p:spPr>
            <a:xfrm>
              <a:off x="-1218672" y="3469086"/>
              <a:ext cx="250373" cy="248620"/>
            </a:xfrm>
            <a:custGeom>
              <a:avLst/>
              <a:gdLst/>
              <a:ahLst/>
              <a:cxnLst/>
              <a:rect l="l" t="t" r="r" b="b"/>
              <a:pathLst>
                <a:path w="3156" h="3134" extrusionOk="0">
                  <a:moveTo>
                    <a:pt x="414" y="0"/>
                  </a:moveTo>
                  <a:cubicBezTo>
                    <a:pt x="174" y="610"/>
                    <a:pt x="0" y="1154"/>
                    <a:pt x="87" y="1458"/>
                  </a:cubicBezTo>
                  <a:cubicBezTo>
                    <a:pt x="327" y="2372"/>
                    <a:pt x="2981" y="3134"/>
                    <a:pt x="2981" y="3134"/>
                  </a:cubicBezTo>
                  <a:lnTo>
                    <a:pt x="3155" y="3134"/>
                  </a:lnTo>
                  <a:lnTo>
                    <a:pt x="3155" y="218"/>
                  </a:lnTo>
                  <a:cubicBezTo>
                    <a:pt x="2133" y="218"/>
                    <a:pt x="1436" y="0"/>
                    <a:pt x="414" y="0"/>
                  </a:cubicBezTo>
                  <a:close/>
                </a:path>
              </a:pathLst>
            </a:custGeom>
            <a:solidFill>
              <a:srgbClr val="27547C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51" name="Google Shape;51;p6"/>
            <p:cNvSpPr/>
            <p:nvPr/>
          </p:nvSpPr>
          <p:spPr>
            <a:xfrm>
              <a:off x="-1268730" y="2694113"/>
              <a:ext cx="581745" cy="792269"/>
            </a:xfrm>
            <a:custGeom>
              <a:avLst/>
              <a:gdLst/>
              <a:ahLst/>
              <a:cxnLst/>
              <a:rect l="l" t="t" r="r" b="b"/>
              <a:pathLst>
                <a:path w="7333" h="9987" extrusionOk="0">
                  <a:moveTo>
                    <a:pt x="3786" y="0"/>
                  </a:moveTo>
                  <a:cubicBezTo>
                    <a:pt x="3786" y="0"/>
                    <a:pt x="1931" y="176"/>
                    <a:pt x="1366" y="176"/>
                  </a:cubicBezTo>
                  <a:cubicBezTo>
                    <a:pt x="1334" y="176"/>
                    <a:pt x="1307" y="175"/>
                    <a:pt x="1284" y="174"/>
                  </a:cubicBezTo>
                  <a:cubicBezTo>
                    <a:pt x="1088" y="174"/>
                    <a:pt x="958" y="849"/>
                    <a:pt x="892" y="1044"/>
                  </a:cubicBezTo>
                  <a:cubicBezTo>
                    <a:pt x="479" y="2132"/>
                    <a:pt x="0" y="3394"/>
                    <a:pt x="1023" y="4265"/>
                  </a:cubicBezTo>
                  <a:cubicBezTo>
                    <a:pt x="1240" y="4460"/>
                    <a:pt x="1458" y="6745"/>
                    <a:pt x="1458" y="7811"/>
                  </a:cubicBezTo>
                  <a:cubicBezTo>
                    <a:pt x="1458" y="8246"/>
                    <a:pt x="1349" y="8943"/>
                    <a:pt x="1045" y="9769"/>
                  </a:cubicBezTo>
                  <a:cubicBezTo>
                    <a:pt x="2067" y="9769"/>
                    <a:pt x="2764" y="9987"/>
                    <a:pt x="3786" y="9987"/>
                  </a:cubicBezTo>
                  <a:lnTo>
                    <a:pt x="6854" y="9987"/>
                  </a:lnTo>
                  <a:cubicBezTo>
                    <a:pt x="6528" y="9160"/>
                    <a:pt x="6201" y="8246"/>
                    <a:pt x="6114" y="7811"/>
                  </a:cubicBezTo>
                  <a:cubicBezTo>
                    <a:pt x="5527" y="4547"/>
                    <a:pt x="7333" y="1501"/>
                    <a:pt x="7072" y="892"/>
                  </a:cubicBezTo>
                  <a:cubicBezTo>
                    <a:pt x="6876" y="479"/>
                    <a:pt x="5940" y="305"/>
                    <a:pt x="5527" y="174"/>
                  </a:cubicBezTo>
                  <a:cubicBezTo>
                    <a:pt x="5070" y="44"/>
                    <a:pt x="3786" y="0"/>
                    <a:pt x="3786" y="0"/>
                  </a:cubicBezTo>
                  <a:close/>
                </a:path>
              </a:pathLst>
            </a:custGeom>
            <a:solidFill>
              <a:schemeClr val="dk2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52" name="Google Shape;52;p6"/>
            <p:cNvSpPr/>
            <p:nvPr/>
          </p:nvSpPr>
          <p:spPr>
            <a:xfrm>
              <a:off x="-968386" y="3486380"/>
              <a:ext cx="274490" cy="231326"/>
            </a:xfrm>
            <a:custGeom>
              <a:avLst/>
              <a:gdLst/>
              <a:ahLst/>
              <a:cxnLst/>
              <a:rect l="l" t="t" r="r" b="b"/>
              <a:pathLst>
                <a:path w="3460" h="2916" extrusionOk="0">
                  <a:moveTo>
                    <a:pt x="0" y="0"/>
                  </a:moveTo>
                  <a:lnTo>
                    <a:pt x="0" y="2916"/>
                  </a:lnTo>
                  <a:lnTo>
                    <a:pt x="174" y="2916"/>
                  </a:lnTo>
                  <a:cubicBezTo>
                    <a:pt x="174" y="2916"/>
                    <a:pt x="3155" y="2350"/>
                    <a:pt x="3394" y="1458"/>
                  </a:cubicBezTo>
                  <a:cubicBezTo>
                    <a:pt x="3460" y="1153"/>
                    <a:pt x="3286" y="587"/>
                    <a:pt x="3068" y="0"/>
                  </a:cubicBezTo>
                  <a:close/>
                </a:path>
              </a:pathLst>
            </a:custGeom>
            <a:solidFill>
              <a:srgbClr val="27547C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53" name="Google Shape;53;p6"/>
            <p:cNvSpPr/>
            <p:nvPr/>
          </p:nvSpPr>
          <p:spPr>
            <a:xfrm>
              <a:off x="-1094442" y="2511100"/>
              <a:ext cx="233158" cy="234817"/>
            </a:xfrm>
            <a:custGeom>
              <a:avLst/>
              <a:gdLst/>
              <a:ahLst/>
              <a:cxnLst/>
              <a:rect l="l" t="t" r="r" b="b"/>
              <a:pathLst>
                <a:path w="2939" h="2960" extrusionOk="0">
                  <a:moveTo>
                    <a:pt x="762" y="1"/>
                  </a:moveTo>
                  <a:cubicBezTo>
                    <a:pt x="762" y="1"/>
                    <a:pt x="784" y="1284"/>
                    <a:pt x="654" y="1633"/>
                  </a:cubicBezTo>
                  <a:cubicBezTo>
                    <a:pt x="523" y="1981"/>
                    <a:pt x="1" y="2394"/>
                    <a:pt x="1" y="2394"/>
                  </a:cubicBezTo>
                  <a:lnTo>
                    <a:pt x="1197" y="2960"/>
                  </a:lnTo>
                  <a:lnTo>
                    <a:pt x="2938" y="2307"/>
                  </a:lnTo>
                  <a:cubicBezTo>
                    <a:pt x="2938" y="2307"/>
                    <a:pt x="2655" y="1981"/>
                    <a:pt x="2525" y="1633"/>
                  </a:cubicBezTo>
                  <a:cubicBezTo>
                    <a:pt x="2394" y="1284"/>
                    <a:pt x="2394" y="1"/>
                    <a:pt x="2394" y="1"/>
                  </a:cubicBezTo>
                  <a:close/>
                </a:path>
              </a:pathLst>
            </a:custGeom>
            <a:solidFill>
              <a:srgbClr val="FAD9C5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54" name="Google Shape;54;p6"/>
            <p:cNvSpPr/>
            <p:nvPr/>
          </p:nvSpPr>
          <p:spPr>
            <a:xfrm>
              <a:off x="-1106500" y="2511100"/>
              <a:ext cx="203726" cy="196897"/>
            </a:xfrm>
            <a:custGeom>
              <a:avLst/>
              <a:gdLst/>
              <a:ahLst/>
              <a:cxnLst/>
              <a:rect l="l" t="t" r="r" b="b"/>
              <a:pathLst>
                <a:path w="2568" h="2482" extrusionOk="0">
                  <a:moveTo>
                    <a:pt x="914" y="1"/>
                  </a:moveTo>
                  <a:cubicBezTo>
                    <a:pt x="914" y="1"/>
                    <a:pt x="936" y="1284"/>
                    <a:pt x="806" y="1633"/>
                  </a:cubicBezTo>
                  <a:cubicBezTo>
                    <a:pt x="675" y="1981"/>
                    <a:pt x="0" y="2481"/>
                    <a:pt x="0" y="2481"/>
                  </a:cubicBezTo>
                  <a:lnTo>
                    <a:pt x="2568" y="653"/>
                  </a:lnTo>
                  <a:cubicBezTo>
                    <a:pt x="2546" y="305"/>
                    <a:pt x="2546" y="1"/>
                    <a:pt x="2546" y="1"/>
                  </a:cubicBezTo>
                  <a:close/>
                </a:path>
              </a:pathLst>
            </a:custGeom>
            <a:solidFill>
              <a:srgbClr val="191919">
                <a:alpha val="17610"/>
              </a:srgb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55" name="Google Shape;55;p6"/>
            <p:cNvSpPr/>
            <p:nvPr/>
          </p:nvSpPr>
          <p:spPr>
            <a:xfrm>
              <a:off x="-1132361" y="2262083"/>
              <a:ext cx="307334" cy="346672"/>
            </a:xfrm>
            <a:custGeom>
              <a:avLst/>
              <a:gdLst/>
              <a:ahLst/>
              <a:cxnLst/>
              <a:rect l="l" t="t" r="r" b="b"/>
              <a:pathLst>
                <a:path w="3874" h="4370" extrusionOk="0">
                  <a:moveTo>
                    <a:pt x="1962" y="0"/>
                  </a:moveTo>
                  <a:cubicBezTo>
                    <a:pt x="1191" y="0"/>
                    <a:pt x="478" y="568"/>
                    <a:pt x="261" y="1617"/>
                  </a:cubicBezTo>
                  <a:cubicBezTo>
                    <a:pt x="0" y="2900"/>
                    <a:pt x="522" y="4162"/>
                    <a:pt x="1132" y="4336"/>
                  </a:cubicBezTo>
                  <a:cubicBezTo>
                    <a:pt x="1204" y="4359"/>
                    <a:pt x="1286" y="4370"/>
                    <a:pt x="1375" y="4370"/>
                  </a:cubicBezTo>
                  <a:cubicBezTo>
                    <a:pt x="2064" y="4370"/>
                    <a:pt x="3176" y="3715"/>
                    <a:pt x="3503" y="2617"/>
                  </a:cubicBezTo>
                  <a:cubicBezTo>
                    <a:pt x="3873" y="1399"/>
                    <a:pt x="3373" y="355"/>
                    <a:pt x="2437" y="72"/>
                  </a:cubicBezTo>
                  <a:cubicBezTo>
                    <a:pt x="2279" y="24"/>
                    <a:pt x="2119" y="0"/>
                    <a:pt x="1962" y="0"/>
                  </a:cubicBezTo>
                  <a:close/>
                </a:path>
              </a:pathLst>
            </a:custGeom>
            <a:solidFill>
              <a:srgbClr val="FAD9C5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56" name="Google Shape;56;p6"/>
            <p:cNvSpPr/>
            <p:nvPr/>
          </p:nvSpPr>
          <p:spPr>
            <a:xfrm>
              <a:off x="-1035737" y="2250977"/>
              <a:ext cx="252119" cy="287809"/>
            </a:xfrm>
            <a:custGeom>
              <a:avLst/>
              <a:gdLst/>
              <a:ahLst/>
              <a:cxnLst/>
              <a:rect l="l" t="t" r="r" b="b"/>
              <a:pathLst>
                <a:path w="3178" h="3628" extrusionOk="0">
                  <a:moveTo>
                    <a:pt x="773" y="0"/>
                  </a:moveTo>
                  <a:cubicBezTo>
                    <a:pt x="351" y="0"/>
                    <a:pt x="33" y="172"/>
                    <a:pt x="22" y="234"/>
                  </a:cubicBezTo>
                  <a:cubicBezTo>
                    <a:pt x="1" y="342"/>
                    <a:pt x="109" y="778"/>
                    <a:pt x="153" y="952"/>
                  </a:cubicBezTo>
                  <a:cubicBezTo>
                    <a:pt x="240" y="1321"/>
                    <a:pt x="566" y="1583"/>
                    <a:pt x="1328" y="1757"/>
                  </a:cubicBezTo>
                  <a:cubicBezTo>
                    <a:pt x="1850" y="1865"/>
                    <a:pt x="2111" y="2692"/>
                    <a:pt x="2068" y="2975"/>
                  </a:cubicBezTo>
                  <a:cubicBezTo>
                    <a:pt x="2046" y="3106"/>
                    <a:pt x="1828" y="3628"/>
                    <a:pt x="1828" y="3628"/>
                  </a:cubicBezTo>
                  <a:cubicBezTo>
                    <a:pt x="1828" y="3628"/>
                    <a:pt x="3177" y="2670"/>
                    <a:pt x="2307" y="1060"/>
                  </a:cubicBezTo>
                  <a:cubicBezTo>
                    <a:pt x="1857" y="219"/>
                    <a:pt x="1249" y="0"/>
                    <a:pt x="773" y="0"/>
                  </a:cubicBezTo>
                  <a:close/>
                </a:path>
              </a:pathLst>
            </a:custGeom>
            <a:solidFill>
              <a:schemeClr val="accent5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57" name="Google Shape;57;p6"/>
            <p:cNvSpPr/>
            <p:nvPr/>
          </p:nvSpPr>
          <p:spPr>
            <a:xfrm>
              <a:off x="-1113402" y="2267557"/>
              <a:ext cx="144702" cy="112490"/>
            </a:xfrm>
            <a:custGeom>
              <a:avLst/>
              <a:gdLst/>
              <a:ahLst/>
              <a:cxnLst/>
              <a:rect l="l" t="t" r="r" b="b"/>
              <a:pathLst>
                <a:path w="1824" h="1418" extrusionOk="0">
                  <a:moveTo>
                    <a:pt x="1258" y="0"/>
                  </a:moveTo>
                  <a:cubicBezTo>
                    <a:pt x="1188" y="0"/>
                    <a:pt x="1103" y="8"/>
                    <a:pt x="1001" y="25"/>
                  </a:cubicBezTo>
                  <a:cubicBezTo>
                    <a:pt x="87" y="155"/>
                    <a:pt x="0" y="1417"/>
                    <a:pt x="0" y="1417"/>
                  </a:cubicBezTo>
                  <a:cubicBezTo>
                    <a:pt x="0" y="1417"/>
                    <a:pt x="479" y="1112"/>
                    <a:pt x="936" y="1069"/>
                  </a:cubicBezTo>
                  <a:cubicBezTo>
                    <a:pt x="1415" y="1025"/>
                    <a:pt x="1480" y="481"/>
                    <a:pt x="1480" y="481"/>
                  </a:cubicBezTo>
                  <a:cubicBezTo>
                    <a:pt x="1480" y="481"/>
                    <a:pt x="1824" y="0"/>
                    <a:pt x="1258" y="0"/>
                  </a:cubicBezTo>
                  <a:close/>
                </a:path>
              </a:pathLst>
            </a:custGeom>
            <a:solidFill>
              <a:schemeClr val="accent5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58" name="Google Shape;58;p6"/>
            <p:cNvSpPr/>
            <p:nvPr/>
          </p:nvSpPr>
          <p:spPr>
            <a:xfrm>
              <a:off x="-1246279" y="2849441"/>
              <a:ext cx="474726" cy="631784"/>
            </a:xfrm>
            <a:custGeom>
              <a:avLst/>
              <a:gdLst/>
              <a:ahLst/>
              <a:cxnLst/>
              <a:rect l="l" t="t" r="r" b="b"/>
              <a:pathLst>
                <a:path w="5984" h="7964" extrusionOk="0">
                  <a:moveTo>
                    <a:pt x="283" y="0"/>
                  </a:moveTo>
                  <a:cubicBezTo>
                    <a:pt x="44" y="827"/>
                    <a:pt x="0" y="1676"/>
                    <a:pt x="740" y="2307"/>
                  </a:cubicBezTo>
                  <a:cubicBezTo>
                    <a:pt x="957" y="2502"/>
                    <a:pt x="1175" y="4787"/>
                    <a:pt x="1175" y="5853"/>
                  </a:cubicBezTo>
                  <a:cubicBezTo>
                    <a:pt x="1175" y="6288"/>
                    <a:pt x="1066" y="6985"/>
                    <a:pt x="762" y="7811"/>
                  </a:cubicBezTo>
                  <a:cubicBezTo>
                    <a:pt x="1414" y="7811"/>
                    <a:pt x="1915" y="7898"/>
                    <a:pt x="2481" y="7964"/>
                  </a:cubicBezTo>
                  <a:cubicBezTo>
                    <a:pt x="2481" y="7964"/>
                    <a:pt x="2285" y="7202"/>
                    <a:pt x="2285" y="6789"/>
                  </a:cubicBezTo>
                  <a:cubicBezTo>
                    <a:pt x="2296" y="6007"/>
                    <a:pt x="3098" y="5907"/>
                    <a:pt x="3921" y="5907"/>
                  </a:cubicBezTo>
                  <a:cubicBezTo>
                    <a:pt x="4202" y="5907"/>
                    <a:pt x="4485" y="5919"/>
                    <a:pt x="4740" y="5919"/>
                  </a:cubicBezTo>
                  <a:cubicBezTo>
                    <a:pt x="5192" y="5919"/>
                    <a:pt x="5556" y="5882"/>
                    <a:pt x="5657" y="5679"/>
                  </a:cubicBezTo>
                  <a:cubicBezTo>
                    <a:pt x="5984" y="5026"/>
                    <a:pt x="4482" y="3438"/>
                    <a:pt x="4635" y="3220"/>
                  </a:cubicBezTo>
                  <a:cubicBezTo>
                    <a:pt x="4809" y="3003"/>
                    <a:pt x="4635" y="2720"/>
                    <a:pt x="4373" y="2589"/>
                  </a:cubicBezTo>
                  <a:cubicBezTo>
                    <a:pt x="4091" y="2481"/>
                    <a:pt x="3503" y="2524"/>
                    <a:pt x="2089" y="2459"/>
                  </a:cubicBezTo>
                  <a:cubicBezTo>
                    <a:pt x="696" y="2372"/>
                    <a:pt x="501" y="1676"/>
                    <a:pt x="283" y="1371"/>
                  </a:cubicBezTo>
                  <a:cubicBezTo>
                    <a:pt x="87" y="1066"/>
                    <a:pt x="283" y="66"/>
                    <a:pt x="283" y="0"/>
                  </a:cubicBezTo>
                  <a:close/>
                </a:path>
              </a:pathLst>
            </a:custGeom>
            <a:solidFill>
              <a:srgbClr val="191919">
                <a:alpha val="17610"/>
              </a:srgb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59" name="Google Shape;59;p6"/>
            <p:cNvSpPr/>
            <p:nvPr/>
          </p:nvSpPr>
          <p:spPr>
            <a:xfrm>
              <a:off x="-1059933" y="2711328"/>
              <a:ext cx="60531" cy="34588"/>
            </a:xfrm>
            <a:custGeom>
              <a:avLst/>
              <a:gdLst/>
              <a:ahLst/>
              <a:cxnLst/>
              <a:rect l="l" t="t" r="r" b="b"/>
              <a:pathLst>
                <a:path w="763" h="436" extrusionOk="0">
                  <a:moveTo>
                    <a:pt x="610" y="1"/>
                  </a:moveTo>
                  <a:lnTo>
                    <a:pt x="1" y="109"/>
                  </a:lnTo>
                  <a:lnTo>
                    <a:pt x="762" y="436"/>
                  </a:lnTo>
                  <a:lnTo>
                    <a:pt x="610" y="1"/>
                  </a:lnTo>
                  <a:close/>
                </a:path>
              </a:pathLst>
            </a:custGeom>
            <a:solidFill>
              <a:schemeClr val="lt2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60" name="Google Shape;60;p6"/>
            <p:cNvSpPr/>
            <p:nvPr/>
          </p:nvSpPr>
          <p:spPr>
            <a:xfrm>
              <a:off x="-999484" y="2711328"/>
              <a:ext cx="48393" cy="34588"/>
            </a:xfrm>
            <a:custGeom>
              <a:avLst/>
              <a:gdLst/>
              <a:ahLst/>
              <a:cxnLst/>
              <a:rect l="l" t="t" r="r" b="b"/>
              <a:pathLst>
                <a:path w="610" h="436" extrusionOk="0">
                  <a:moveTo>
                    <a:pt x="153" y="1"/>
                  </a:moveTo>
                  <a:lnTo>
                    <a:pt x="0" y="436"/>
                  </a:lnTo>
                  <a:lnTo>
                    <a:pt x="610" y="218"/>
                  </a:lnTo>
                  <a:lnTo>
                    <a:pt x="153" y="1"/>
                  </a:lnTo>
                  <a:close/>
                </a:path>
              </a:pathLst>
            </a:custGeom>
            <a:solidFill>
              <a:schemeClr val="lt2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61" name="Google Shape;61;p6"/>
            <p:cNvSpPr/>
            <p:nvPr/>
          </p:nvSpPr>
          <p:spPr>
            <a:xfrm>
              <a:off x="-1235966" y="3469086"/>
              <a:ext cx="576589" cy="785446"/>
            </a:xfrm>
            <a:custGeom>
              <a:avLst/>
              <a:gdLst/>
              <a:ahLst/>
              <a:cxnLst/>
              <a:rect l="l" t="t" r="r" b="b"/>
              <a:pathLst>
                <a:path w="7268" h="9901" extrusionOk="0">
                  <a:moveTo>
                    <a:pt x="632" y="0"/>
                  </a:moveTo>
                  <a:cubicBezTo>
                    <a:pt x="632" y="0"/>
                    <a:pt x="175" y="762"/>
                    <a:pt x="88" y="2111"/>
                  </a:cubicBezTo>
                  <a:cubicBezTo>
                    <a:pt x="1" y="3482"/>
                    <a:pt x="980" y="9748"/>
                    <a:pt x="980" y="9748"/>
                  </a:cubicBezTo>
                  <a:lnTo>
                    <a:pt x="3678" y="9900"/>
                  </a:lnTo>
                  <a:lnTo>
                    <a:pt x="7268" y="9618"/>
                  </a:lnTo>
                  <a:cubicBezTo>
                    <a:pt x="7268" y="9618"/>
                    <a:pt x="7181" y="3895"/>
                    <a:pt x="7029" y="2176"/>
                  </a:cubicBezTo>
                  <a:cubicBezTo>
                    <a:pt x="6854" y="479"/>
                    <a:pt x="6376" y="44"/>
                    <a:pt x="6376" y="44"/>
                  </a:cubicBezTo>
                  <a:lnTo>
                    <a:pt x="3112" y="174"/>
                  </a:lnTo>
                  <a:lnTo>
                    <a:pt x="632" y="0"/>
                  </a:lnTo>
                  <a:close/>
                </a:path>
              </a:pathLst>
            </a:custGeom>
            <a:solidFill>
              <a:schemeClr val="accent3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62" name="Google Shape;62;p6"/>
            <p:cNvSpPr/>
            <p:nvPr/>
          </p:nvSpPr>
          <p:spPr>
            <a:xfrm>
              <a:off x="-987426" y="2652624"/>
              <a:ext cx="157158" cy="117488"/>
            </a:xfrm>
            <a:custGeom>
              <a:avLst/>
              <a:gdLst/>
              <a:ahLst/>
              <a:cxnLst/>
              <a:rect l="l" t="t" r="r" b="b"/>
              <a:pathLst>
                <a:path w="1981" h="1481" extrusionOk="0">
                  <a:moveTo>
                    <a:pt x="1437" y="1"/>
                  </a:moveTo>
                  <a:lnTo>
                    <a:pt x="1" y="741"/>
                  </a:lnTo>
                  <a:lnTo>
                    <a:pt x="501" y="1480"/>
                  </a:lnTo>
                  <a:lnTo>
                    <a:pt x="1981" y="697"/>
                  </a:lnTo>
                  <a:lnTo>
                    <a:pt x="1437" y="1"/>
                  </a:lnTo>
                  <a:close/>
                </a:path>
              </a:pathLst>
            </a:custGeom>
            <a:solidFill>
              <a:schemeClr val="accent6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63" name="Google Shape;63;p6"/>
            <p:cNvSpPr/>
            <p:nvPr/>
          </p:nvSpPr>
          <p:spPr>
            <a:xfrm>
              <a:off x="-1123794" y="2661271"/>
              <a:ext cx="112335" cy="103684"/>
            </a:xfrm>
            <a:custGeom>
              <a:avLst/>
              <a:gdLst/>
              <a:ahLst/>
              <a:cxnLst/>
              <a:rect l="l" t="t" r="r" b="b"/>
              <a:pathLst>
                <a:path w="1416" h="1307" extrusionOk="0">
                  <a:moveTo>
                    <a:pt x="654" y="1"/>
                  </a:moveTo>
                  <a:lnTo>
                    <a:pt x="1" y="588"/>
                  </a:lnTo>
                  <a:lnTo>
                    <a:pt x="871" y="1306"/>
                  </a:lnTo>
                  <a:lnTo>
                    <a:pt x="1415" y="632"/>
                  </a:lnTo>
                  <a:lnTo>
                    <a:pt x="654" y="1"/>
                  </a:lnTo>
                  <a:close/>
                </a:path>
              </a:pathLst>
            </a:custGeom>
            <a:solidFill>
              <a:schemeClr val="accent6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64" name="Google Shape;64;p6"/>
            <p:cNvSpPr/>
            <p:nvPr/>
          </p:nvSpPr>
          <p:spPr>
            <a:xfrm>
              <a:off x="-1235966" y="3469086"/>
              <a:ext cx="338432" cy="785446"/>
            </a:xfrm>
            <a:custGeom>
              <a:avLst/>
              <a:gdLst/>
              <a:ahLst/>
              <a:cxnLst/>
              <a:rect l="l" t="t" r="r" b="b"/>
              <a:pathLst>
                <a:path w="4266" h="9901" extrusionOk="0">
                  <a:moveTo>
                    <a:pt x="632" y="0"/>
                  </a:moveTo>
                  <a:cubicBezTo>
                    <a:pt x="632" y="0"/>
                    <a:pt x="175" y="762"/>
                    <a:pt x="88" y="2111"/>
                  </a:cubicBezTo>
                  <a:cubicBezTo>
                    <a:pt x="1" y="3482"/>
                    <a:pt x="980" y="9748"/>
                    <a:pt x="980" y="9748"/>
                  </a:cubicBezTo>
                  <a:lnTo>
                    <a:pt x="3678" y="9900"/>
                  </a:lnTo>
                  <a:lnTo>
                    <a:pt x="4265" y="9879"/>
                  </a:lnTo>
                  <a:cubicBezTo>
                    <a:pt x="4265" y="9879"/>
                    <a:pt x="3612" y="9748"/>
                    <a:pt x="3525" y="9161"/>
                  </a:cubicBezTo>
                  <a:cubicBezTo>
                    <a:pt x="3337" y="8007"/>
                    <a:pt x="3148" y="5801"/>
                    <a:pt x="2978" y="5801"/>
                  </a:cubicBezTo>
                  <a:cubicBezTo>
                    <a:pt x="2972" y="5801"/>
                    <a:pt x="2966" y="5804"/>
                    <a:pt x="2960" y="5810"/>
                  </a:cubicBezTo>
                  <a:cubicBezTo>
                    <a:pt x="2786" y="6027"/>
                    <a:pt x="2873" y="7746"/>
                    <a:pt x="2568" y="8073"/>
                  </a:cubicBezTo>
                  <a:cubicBezTo>
                    <a:pt x="2444" y="8224"/>
                    <a:pt x="2294" y="8302"/>
                    <a:pt x="2141" y="8302"/>
                  </a:cubicBezTo>
                  <a:cubicBezTo>
                    <a:pt x="1919" y="8302"/>
                    <a:pt x="1691" y="8137"/>
                    <a:pt x="1524" y="7790"/>
                  </a:cubicBezTo>
                  <a:cubicBezTo>
                    <a:pt x="1263" y="7181"/>
                    <a:pt x="566" y="2938"/>
                    <a:pt x="1132" y="1436"/>
                  </a:cubicBezTo>
                  <a:cubicBezTo>
                    <a:pt x="1524" y="392"/>
                    <a:pt x="2351" y="153"/>
                    <a:pt x="2351" y="153"/>
                  </a:cubicBezTo>
                  <a:lnTo>
                    <a:pt x="2242" y="131"/>
                  </a:lnTo>
                  <a:lnTo>
                    <a:pt x="632" y="0"/>
                  </a:lnTo>
                  <a:close/>
                </a:path>
              </a:pathLst>
            </a:custGeom>
            <a:solidFill>
              <a:srgbClr val="191919">
                <a:alpha val="17610"/>
              </a:srgb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65" name="Google Shape;65;p6"/>
            <p:cNvSpPr/>
            <p:nvPr/>
          </p:nvSpPr>
          <p:spPr>
            <a:xfrm>
              <a:off x="-1027090" y="2734413"/>
              <a:ext cx="50138" cy="45853"/>
            </a:xfrm>
            <a:custGeom>
              <a:avLst/>
              <a:gdLst/>
              <a:ahLst/>
              <a:cxnLst/>
              <a:rect l="l" t="t" r="r" b="b"/>
              <a:pathLst>
                <a:path w="632" h="578" extrusionOk="0">
                  <a:moveTo>
                    <a:pt x="329" y="0"/>
                  </a:moveTo>
                  <a:cubicBezTo>
                    <a:pt x="207" y="0"/>
                    <a:pt x="79" y="23"/>
                    <a:pt x="44" y="58"/>
                  </a:cubicBezTo>
                  <a:cubicBezTo>
                    <a:pt x="0" y="145"/>
                    <a:pt x="44" y="471"/>
                    <a:pt x="66" y="536"/>
                  </a:cubicBezTo>
                  <a:cubicBezTo>
                    <a:pt x="90" y="560"/>
                    <a:pt x="179" y="578"/>
                    <a:pt x="265" y="578"/>
                  </a:cubicBezTo>
                  <a:cubicBezTo>
                    <a:pt x="337" y="578"/>
                    <a:pt x="406" y="566"/>
                    <a:pt x="436" y="536"/>
                  </a:cubicBezTo>
                  <a:cubicBezTo>
                    <a:pt x="501" y="471"/>
                    <a:pt x="631" y="167"/>
                    <a:pt x="566" y="58"/>
                  </a:cubicBezTo>
                  <a:cubicBezTo>
                    <a:pt x="536" y="17"/>
                    <a:pt x="435" y="0"/>
                    <a:pt x="329" y="0"/>
                  </a:cubicBezTo>
                  <a:close/>
                </a:path>
              </a:pathLst>
            </a:custGeom>
            <a:solidFill>
              <a:schemeClr val="dk1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66" name="Google Shape;66;p6"/>
            <p:cNvSpPr/>
            <p:nvPr/>
          </p:nvSpPr>
          <p:spPr>
            <a:xfrm>
              <a:off x="-1087540" y="2776934"/>
              <a:ext cx="98531" cy="274482"/>
            </a:xfrm>
            <a:custGeom>
              <a:avLst/>
              <a:gdLst/>
              <a:ahLst/>
              <a:cxnLst/>
              <a:rect l="l" t="t" r="r" b="b"/>
              <a:pathLst>
                <a:path w="1242" h="3460" extrusionOk="0">
                  <a:moveTo>
                    <a:pt x="828" y="0"/>
                  </a:moveTo>
                  <a:lnTo>
                    <a:pt x="1" y="2350"/>
                  </a:lnTo>
                  <a:lnTo>
                    <a:pt x="501" y="3460"/>
                  </a:lnTo>
                  <a:lnTo>
                    <a:pt x="1241" y="2481"/>
                  </a:lnTo>
                  <a:lnTo>
                    <a:pt x="1198" y="0"/>
                  </a:lnTo>
                  <a:close/>
                </a:path>
              </a:pathLst>
            </a:custGeom>
            <a:solidFill>
              <a:schemeClr val="dk1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67" name="Google Shape;67;p6"/>
            <p:cNvSpPr/>
            <p:nvPr/>
          </p:nvSpPr>
          <p:spPr>
            <a:xfrm>
              <a:off x="-845901" y="2739887"/>
              <a:ext cx="171041" cy="541269"/>
            </a:xfrm>
            <a:custGeom>
              <a:avLst/>
              <a:gdLst/>
              <a:ahLst/>
              <a:cxnLst/>
              <a:rect l="l" t="t" r="r" b="b"/>
              <a:pathLst>
                <a:path w="2156" h="6823" extrusionOk="0">
                  <a:moveTo>
                    <a:pt x="1243" y="0"/>
                  </a:moveTo>
                  <a:cubicBezTo>
                    <a:pt x="225" y="0"/>
                    <a:pt x="67" y="1509"/>
                    <a:pt x="88" y="3296"/>
                  </a:cubicBezTo>
                  <a:cubicBezTo>
                    <a:pt x="110" y="5668"/>
                    <a:pt x="1" y="6799"/>
                    <a:pt x="893" y="6821"/>
                  </a:cubicBezTo>
                  <a:cubicBezTo>
                    <a:pt x="914" y="6822"/>
                    <a:pt x="935" y="6822"/>
                    <a:pt x="955" y="6822"/>
                  </a:cubicBezTo>
                  <a:cubicBezTo>
                    <a:pt x="1858" y="6822"/>
                    <a:pt x="1554" y="5848"/>
                    <a:pt x="1937" y="3165"/>
                  </a:cubicBezTo>
                  <a:cubicBezTo>
                    <a:pt x="2155" y="1599"/>
                    <a:pt x="1937" y="76"/>
                    <a:pt x="1393" y="11"/>
                  </a:cubicBezTo>
                  <a:cubicBezTo>
                    <a:pt x="1341" y="4"/>
                    <a:pt x="1291" y="0"/>
                    <a:pt x="1243" y="0"/>
                  </a:cubicBezTo>
                  <a:close/>
                </a:path>
              </a:pathLst>
            </a:custGeom>
            <a:solidFill>
              <a:schemeClr val="dk2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68" name="Google Shape;68;p6"/>
            <p:cNvSpPr/>
            <p:nvPr/>
          </p:nvSpPr>
          <p:spPr>
            <a:xfrm>
              <a:off x="-1217006" y="2835638"/>
              <a:ext cx="333276" cy="440202"/>
            </a:xfrm>
            <a:custGeom>
              <a:avLst/>
              <a:gdLst/>
              <a:ahLst/>
              <a:cxnLst/>
              <a:rect l="l" t="t" r="r" b="b"/>
              <a:pathLst>
                <a:path w="4201" h="5549" extrusionOk="0">
                  <a:moveTo>
                    <a:pt x="4113" y="0"/>
                  </a:moveTo>
                  <a:lnTo>
                    <a:pt x="1" y="65"/>
                  </a:lnTo>
                  <a:lnTo>
                    <a:pt x="88" y="5549"/>
                  </a:lnTo>
                  <a:lnTo>
                    <a:pt x="4200" y="5483"/>
                  </a:lnTo>
                  <a:lnTo>
                    <a:pt x="4113" y="0"/>
                  </a:lnTo>
                  <a:close/>
                </a:path>
              </a:pathLst>
            </a:custGeom>
            <a:solidFill>
              <a:schemeClr val="accent1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69" name="Google Shape;69;p6"/>
            <p:cNvSpPr/>
            <p:nvPr/>
          </p:nvSpPr>
          <p:spPr>
            <a:xfrm>
              <a:off x="-1217006" y="2840794"/>
              <a:ext cx="333276" cy="435046"/>
            </a:xfrm>
            <a:custGeom>
              <a:avLst/>
              <a:gdLst/>
              <a:ahLst/>
              <a:cxnLst/>
              <a:rect l="l" t="t" r="r" b="b"/>
              <a:pathLst>
                <a:path w="4201" h="5484" extrusionOk="0">
                  <a:moveTo>
                    <a:pt x="1" y="0"/>
                  </a:moveTo>
                  <a:lnTo>
                    <a:pt x="88" y="5484"/>
                  </a:lnTo>
                  <a:lnTo>
                    <a:pt x="4200" y="5418"/>
                  </a:lnTo>
                  <a:lnTo>
                    <a:pt x="4179" y="3917"/>
                  </a:lnTo>
                  <a:cubicBezTo>
                    <a:pt x="4179" y="3917"/>
                    <a:pt x="2351" y="3656"/>
                    <a:pt x="1633" y="2786"/>
                  </a:cubicBezTo>
                  <a:cubicBezTo>
                    <a:pt x="915" y="1915"/>
                    <a:pt x="675" y="22"/>
                    <a:pt x="675" y="22"/>
                  </a:cubicBezTo>
                  <a:lnTo>
                    <a:pt x="1" y="0"/>
                  </a:lnTo>
                  <a:close/>
                </a:path>
              </a:pathLst>
            </a:custGeom>
            <a:solidFill>
              <a:srgbClr val="191919">
                <a:alpha val="17610"/>
              </a:srgb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70" name="Google Shape;70;p6"/>
            <p:cNvSpPr/>
            <p:nvPr/>
          </p:nvSpPr>
          <p:spPr>
            <a:xfrm>
              <a:off x="-1410254" y="3090286"/>
              <a:ext cx="485118" cy="145253"/>
            </a:xfrm>
            <a:custGeom>
              <a:avLst/>
              <a:gdLst/>
              <a:ahLst/>
              <a:cxnLst/>
              <a:rect l="l" t="t" r="r" b="b"/>
              <a:pathLst>
                <a:path w="6115" h="1831" extrusionOk="0">
                  <a:moveTo>
                    <a:pt x="4965" y="0"/>
                  </a:moveTo>
                  <a:cubicBezTo>
                    <a:pt x="4233" y="0"/>
                    <a:pt x="3221" y="116"/>
                    <a:pt x="2306" y="141"/>
                  </a:cubicBezTo>
                  <a:cubicBezTo>
                    <a:pt x="696" y="184"/>
                    <a:pt x="0" y="446"/>
                    <a:pt x="218" y="1359"/>
                  </a:cubicBezTo>
                  <a:cubicBezTo>
                    <a:pt x="288" y="1640"/>
                    <a:pt x="630" y="1831"/>
                    <a:pt x="1215" y="1831"/>
                  </a:cubicBezTo>
                  <a:cubicBezTo>
                    <a:pt x="1537" y="1831"/>
                    <a:pt x="1931" y="1773"/>
                    <a:pt x="2393" y="1642"/>
                  </a:cubicBezTo>
                  <a:cubicBezTo>
                    <a:pt x="3917" y="1229"/>
                    <a:pt x="6114" y="663"/>
                    <a:pt x="5984" y="293"/>
                  </a:cubicBezTo>
                  <a:cubicBezTo>
                    <a:pt x="5918" y="68"/>
                    <a:pt x="5523" y="0"/>
                    <a:pt x="4965" y="0"/>
                  </a:cubicBezTo>
                  <a:close/>
                </a:path>
              </a:pathLst>
            </a:custGeom>
            <a:solidFill>
              <a:srgbClr val="E9CAB7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71" name="Google Shape;71;p6"/>
            <p:cNvSpPr/>
            <p:nvPr/>
          </p:nvSpPr>
          <p:spPr>
            <a:xfrm>
              <a:off x="-937368" y="3125588"/>
              <a:ext cx="63942" cy="22530"/>
            </a:xfrm>
            <a:custGeom>
              <a:avLst/>
              <a:gdLst/>
              <a:ahLst/>
              <a:cxnLst/>
              <a:rect l="l" t="t" r="r" b="b"/>
              <a:pathLst>
                <a:path w="806" h="284" extrusionOk="0">
                  <a:moveTo>
                    <a:pt x="131" y="1"/>
                  </a:moveTo>
                  <a:cubicBezTo>
                    <a:pt x="44" y="1"/>
                    <a:pt x="1" y="66"/>
                    <a:pt x="1" y="131"/>
                  </a:cubicBezTo>
                  <a:cubicBezTo>
                    <a:pt x="1" y="218"/>
                    <a:pt x="44" y="262"/>
                    <a:pt x="110" y="262"/>
                  </a:cubicBezTo>
                  <a:lnTo>
                    <a:pt x="675" y="283"/>
                  </a:lnTo>
                  <a:cubicBezTo>
                    <a:pt x="741" y="283"/>
                    <a:pt x="806" y="218"/>
                    <a:pt x="806" y="153"/>
                  </a:cubicBezTo>
                  <a:cubicBezTo>
                    <a:pt x="806" y="88"/>
                    <a:pt x="741" y="22"/>
                    <a:pt x="675" y="22"/>
                  </a:cubicBezTo>
                  <a:lnTo>
                    <a:pt x="131" y="1"/>
                  </a:lnTo>
                  <a:close/>
                </a:path>
              </a:pathLst>
            </a:custGeom>
            <a:solidFill>
              <a:srgbClr val="FFA47C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72" name="Google Shape;72;p6"/>
            <p:cNvSpPr/>
            <p:nvPr/>
          </p:nvSpPr>
          <p:spPr>
            <a:xfrm>
              <a:off x="-935623" y="3106628"/>
              <a:ext cx="63942" cy="22530"/>
            </a:xfrm>
            <a:custGeom>
              <a:avLst/>
              <a:gdLst/>
              <a:ahLst/>
              <a:cxnLst/>
              <a:rect l="l" t="t" r="r" b="b"/>
              <a:pathLst>
                <a:path w="806" h="284" extrusionOk="0">
                  <a:moveTo>
                    <a:pt x="131" y="0"/>
                  </a:moveTo>
                  <a:cubicBezTo>
                    <a:pt x="66" y="0"/>
                    <a:pt x="1" y="66"/>
                    <a:pt x="1" y="131"/>
                  </a:cubicBezTo>
                  <a:cubicBezTo>
                    <a:pt x="1" y="218"/>
                    <a:pt x="44" y="261"/>
                    <a:pt x="131" y="261"/>
                  </a:cubicBezTo>
                  <a:lnTo>
                    <a:pt x="675" y="283"/>
                  </a:lnTo>
                  <a:cubicBezTo>
                    <a:pt x="740" y="283"/>
                    <a:pt x="806" y="218"/>
                    <a:pt x="806" y="153"/>
                  </a:cubicBezTo>
                  <a:cubicBezTo>
                    <a:pt x="806" y="87"/>
                    <a:pt x="740" y="22"/>
                    <a:pt x="675" y="22"/>
                  </a:cubicBezTo>
                  <a:lnTo>
                    <a:pt x="131" y="0"/>
                  </a:lnTo>
                  <a:close/>
                </a:path>
              </a:pathLst>
            </a:custGeom>
            <a:solidFill>
              <a:srgbClr val="E9CAB7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73" name="Google Shape;73;p6"/>
            <p:cNvSpPr/>
            <p:nvPr/>
          </p:nvSpPr>
          <p:spPr>
            <a:xfrm>
              <a:off x="-935623" y="3089334"/>
              <a:ext cx="63942" cy="20784"/>
            </a:xfrm>
            <a:custGeom>
              <a:avLst/>
              <a:gdLst/>
              <a:ahLst/>
              <a:cxnLst/>
              <a:rect l="l" t="t" r="r" b="b"/>
              <a:pathLst>
                <a:path w="806" h="262" extrusionOk="0">
                  <a:moveTo>
                    <a:pt x="131" y="1"/>
                  </a:moveTo>
                  <a:cubicBezTo>
                    <a:pt x="66" y="1"/>
                    <a:pt x="1" y="44"/>
                    <a:pt x="1" y="131"/>
                  </a:cubicBezTo>
                  <a:cubicBezTo>
                    <a:pt x="1" y="196"/>
                    <a:pt x="66" y="240"/>
                    <a:pt x="131" y="240"/>
                  </a:cubicBezTo>
                  <a:lnTo>
                    <a:pt x="675" y="262"/>
                  </a:lnTo>
                  <a:cubicBezTo>
                    <a:pt x="762" y="262"/>
                    <a:pt x="806" y="196"/>
                    <a:pt x="806" y="131"/>
                  </a:cubicBezTo>
                  <a:cubicBezTo>
                    <a:pt x="806" y="66"/>
                    <a:pt x="762" y="1"/>
                    <a:pt x="697" y="1"/>
                  </a:cubicBezTo>
                  <a:close/>
                </a:path>
              </a:pathLst>
            </a:custGeom>
            <a:solidFill>
              <a:srgbClr val="E9CAB7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74" name="Google Shape;74;p6"/>
            <p:cNvSpPr/>
            <p:nvPr/>
          </p:nvSpPr>
          <p:spPr>
            <a:xfrm>
              <a:off x="-935623" y="3070374"/>
              <a:ext cx="63942" cy="20784"/>
            </a:xfrm>
            <a:custGeom>
              <a:avLst/>
              <a:gdLst/>
              <a:ahLst/>
              <a:cxnLst/>
              <a:rect l="l" t="t" r="r" b="b"/>
              <a:pathLst>
                <a:path w="806" h="262" extrusionOk="0">
                  <a:moveTo>
                    <a:pt x="131" y="0"/>
                  </a:moveTo>
                  <a:cubicBezTo>
                    <a:pt x="66" y="0"/>
                    <a:pt x="1" y="66"/>
                    <a:pt x="1" y="131"/>
                  </a:cubicBezTo>
                  <a:cubicBezTo>
                    <a:pt x="1" y="196"/>
                    <a:pt x="66" y="261"/>
                    <a:pt x="131" y="261"/>
                  </a:cubicBezTo>
                  <a:lnTo>
                    <a:pt x="675" y="261"/>
                  </a:lnTo>
                  <a:cubicBezTo>
                    <a:pt x="740" y="261"/>
                    <a:pt x="806" y="218"/>
                    <a:pt x="806" y="153"/>
                  </a:cubicBezTo>
                  <a:cubicBezTo>
                    <a:pt x="806" y="66"/>
                    <a:pt x="740" y="22"/>
                    <a:pt x="675" y="22"/>
                  </a:cubicBezTo>
                  <a:lnTo>
                    <a:pt x="131" y="0"/>
                  </a:lnTo>
                  <a:close/>
                </a:path>
              </a:pathLst>
            </a:custGeom>
            <a:solidFill>
              <a:srgbClr val="E9CAB7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75" name="Google Shape;75;p6"/>
            <p:cNvSpPr/>
            <p:nvPr/>
          </p:nvSpPr>
          <p:spPr>
            <a:xfrm>
              <a:off x="-1025345" y="3063235"/>
              <a:ext cx="148510" cy="93689"/>
            </a:xfrm>
            <a:custGeom>
              <a:avLst/>
              <a:gdLst/>
              <a:ahLst/>
              <a:cxnLst/>
              <a:rect l="l" t="t" r="r" b="b"/>
              <a:pathLst>
                <a:path w="1872" h="1181" extrusionOk="0">
                  <a:moveTo>
                    <a:pt x="1050" y="1"/>
                  </a:moveTo>
                  <a:cubicBezTo>
                    <a:pt x="1031" y="1"/>
                    <a:pt x="1014" y="2"/>
                    <a:pt x="1001" y="3"/>
                  </a:cubicBezTo>
                  <a:cubicBezTo>
                    <a:pt x="827" y="25"/>
                    <a:pt x="0" y="373"/>
                    <a:pt x="0" y="373"/>
                  </a:cubicBezTo>
                  <a:lnTo>
                    <a:pt x="370" y="1091"/>
                  </a:lnTo>
                  <a:cubicBezTo>
                    <a:pt x="370" y="1091"/>
                    <a:pt x="631" y="1156"/>
                    <a:pt x="914" y="1178"/>
                  </a:cubicBezTo>
                  <a:cubicBezTo>
                    <a:pt x="936" y="1180"/>
                    <a:pt x="959" y="1181"/>
                    <a:pt x="984" y="1181"/>
                  </a:cubicBezTo>
                  <a:cubicBezTo>
                    <a:pt x="1284" y="1181"/>
                    <a:pt x="1784" y="1069"/>
                    <a:pt x="1784" y="1069"/>
                  </a:cubicBezTo>
                  <a:cubicBezTo>
                    <a:pt x="1784" y="1069"/>
                    <a:pt x="1697" y="656"/>
                    <a:pt x="1675" y="504"/>
                  </a:cubicBezTo>
                  <a:cubicBezTo>
                    <a:pt x="1654" y="351"/>
                    <a:pt x="1871" y="112"/>
                    <a:pt x="1871" y="112"/>
                  </a:cubicBezTo>
                  <a:cubicBezTo>
                    <a:pt x="1871" y="112"/>
                    <a:pt x="1278" y="1"/>
                    <a:pt x="1050" y="1"/>
                  </a:cubicBezTo>
                  <a:close/>
                </a:path>
              </a:pathLst>
            </a:custGeom>
            <a:solidFill>
              <a:srgbClr val="E9CAB7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76" name="Google Shape;76;p6"/>
            <p:cNvSpPr/>
            <p:nvPr/>
          </p:nvSpPr>
          <p:spPr>
            <a:xfrm>
              <a:off x="-1172106" y="3066249"/>
              <a:ext cx="461001" cy="219347"/>
            </a:xfrm>
            <a:custGeom>
              <a:avLst/>
              <a:gdLst/>
              <a:ahLst/>
              <a:cxnLst/>
              <a:rect l="l" t="t" r="r" b="b"/>
              <a:pathLst>
                <a:path w="5811" h="2765" extrusionOk="0">
                  <a:moveTo>
                    <a:pt x="433" y="0"/>
                  </a:moveTo>
                  <a:cubicBezTo>
                    <a:pt x="246" y="0"/>
                    <a:pt x="129" y="35"/>
                    <a:pt x="109" y="118"/>
                  </a:cubicBezTo>
                  <a:cubicBezTo>
                    <a:pt x="1" y="640"/>
                    <a:pt x="1741" y="1293"/>
                    <a:pt x="3090" y="2054"/>
                  </a:cubicBezTo>
                  <a:cubicBezTo>
                    <a:pt x="3857" y="2487"/>
                    <a:pt x="4518" y="2765"/>
                    <a:pt x="4990" y="2765"/>
                  </a:cubicBezTo>
                  <a:cubicBezTo>
                    <a:pt x="5348" y="2765"/>
                    <a:pt x="5598" y="2604"/>
                    <a:pt x="5701" y="2228"/>
                  </a:cubicBezTo>
                  <a:cubicBezTo>
                    <a:pt x="5810" y="1815"/>
                    <a:pt x="4983" y="1075"/>
                    <a:pt x="3721" y="749"/>
                  </a:cubicBezTo>
                  <a:cubicBezTo>
                    <a:pt x="2588" y="427"/>
                    <a:pt x="1086" y="0"/>
                    <a:pt x="433" y="0"/>
                  </a:cubicBezTo>
                  <a:close/>
                </a:path>
              </a:pathLst>
            </a:custGeom>
            <a:solidFill>
              <a:srgbClr val="FAD9C5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77" name="Google Shape;77;p6"/>
            <p:cNvSpPr/>
            <p:nvPr/>
          </p:nvSpPr>
          <p:spPr>
            <a:xfrm>
              <a:off x="-1234221" y="3018572"/>
              <a:ext cx="146765" cy="107095"/>
            </a:xfrm>
            <a:custGeom>
              <a:avLst/>
              <a:gdLst/>
              <a:ahLst/>
              <a:cxnLst/>
              <a:rect l="l" t="t" r="r" b="b"/>
              <a:pathLst>
                <a:path w="1850" h="1350" extrusionOk="0">
                  <a:moveTo>
                    <a:pt x="174" y="1"/>
                  </a:moveTo>
                  <a:cubicBezTo>
                    <a:pt x="174" y="1"/>
                    <a:pt x="327" y="283"/>
                    <a:pt x="261" y="436"/>
                  </a:cubicBezTo>
                  <a:cubicBezTo>
                    <a:pt x="196" y="566"/>
                    <a:pt x="0" y="936"/>
                    <a:pt x="0" y="936"/>
                  </a:cubicBezTo>
                  <a:cubicBezTo>
                    <a:pt x="0" y="936"/>
                    <a:pt x="501" y="1154"/>
                    <a:pt x="762" y="1241"/>
                  </a:cubicBezTo>
                  <a:cubicBezTo>
                    <a:pt x="1197" y="1350"/>
                    <a:pt x="1436" y="1350"/>
                    <a:pt x="1436" y="1350"/>
                  </a:cubicBezTo>
                  <a:lnTo>
                    <a:pt x="1850" y="675"/>
                  </a:lnTo>
                  <a:cubicBezTo>
                    <a:pt x="1850" y="675"/>
                    <a:pt x="1197" y="196"/>
                    <a:pt x="1045" y="131"/>
                  </a:cubicBezTo>
                  <a:cubicBezTo>
                    <a:pt x="871" y="66"/>
                    <a:pt x="175" y="1"/>
                    <a:pt x="174" y="1"/>
                  </a:cubicBezTo>
                  <a:close/>
                </a:path>
              </a:pathLst>
            </a:custGeom>
            <a:solidFill>
              <a:srgbClr val="FAD9C5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</p:grpSp>
      <p:grpSp>
        <p:nvGrpSpPr>
          <p:cNvPr id="78" name="Google Shape;78;p6"/>
          <p:cNvGrpSpPr/>
          <p:nvPr/>
        </p:nvGrpSpPr>
        <p:grpSpPr>
          <a:xfrm>
            <a:off x="-163725" y="3001300"/>
            <a:ext cx="798614" cy="3856699"/>
            <a:chOff x="-163725" y="2250975"/>
            <a:chExt cx="798614" cy="2892524"/>
          </a:xfrm>
        </p:grpSpPr>
        <p:sp>
          <p:nvSpPr>
            <p:cNvPr id="79" name="Google Shape;79;p6"/>
            <p:cNvSpPr/>
            <p:nvPr/>
          </p:nvSpPr>
          <p:spPr>
            <a:xfrm>
              <a:off x="212628" y="2758945"/>
              <a:ext cx="406911" cy="472834"/>
            </a:xfrm>
            <a:custGeom>
              <a:avLst/>
              <a:gdLst/>
              <a:ahLst/>
              <a:cxnLst/>
              <a:rect l="l" t="t" r="r" b="b"/>
              <a:pathLst>
                <a:path w="5222" h="6068" extrusionOk="0">
                  <a:moveTo>
                    <a:pt x="1308" y="0"/>
                  </a:moveTo>
                  <a:cubicBezTo>
                    <a:pt x="1138" y="0"/>
                    <a:pt x="956" y="38"/>
                    <a:pt x="762" y="126"/>
                  </a:cubicBezTo>
                  <a:cubicBezTo>
                    <a:pt x="1" y="474"/>
                    <a:pt x="66" y="1214"/>
                    <a:pt x="458" y="1953"/>
                  </a:cubicBezTo>
                  <a:cubicBezTo>
                    <a:pt x="849" y="2671"/>
                    <a:pt x="3656" y="6022"/>
                    <a:pt x="3917" y="6066"/>
                  </a:cubicBezTo>
                  <a:cubicBezTo>
                    <a:pt x="3926" y="6067"/>
                    <a:pt x="3935" y="6068"/>
                    <a:pt x="3945" y="6068"/>
                  </a:cubicBezTo>
                  <a:cubicBezTo>
                    <a:pt x="4244" y="6068"/>
                    <a:pt x="5221" y="5445"/>
                    <a:pt x="5179" y="5087"/>
                  </a:cubicBezTo>
                  <a:cubicBezTo>
                    <a:pt x="5136" y="4695"/>
                    <a:pt x="3177" y="1496"/>
                    <a:pt x="2764" y="952"/>
                  </a:cubicBezTo>
                  <a:cubicBezTo>
                    <a:pt x="2421" y="524"/>
                    <a:pt x="1943" y="0"/>
                    <a:pt x="1308" y="0"/>
                  </a:cubicBezTo>
                  <a:close/>
                </a:path>
              </a:pathLst>
            </a:custGeom>
            <a:solidFill>
              <a:schemeClr val="lt2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80" name="Google Shape;80;p6"/>
            <p:cNvSpPr/>
            <p:nvPr/>
          </p:nvSpPr>
          <p:spPr>
            <a:xfrm>
              <a:off x="-151881" y="2480454"/>
              <a:ext cx="562990" cy="1236085"/>
            </a:xfrm>
            <a:custGeom>
              <a:avLst/>
              <a:gdLst/>
              <a:ahLst/>
              <a:cxnLst/>
              <a:rect l="l" t="t" r="r" b="b"/>
              <a:pathLst>
                <a:path w="7225" h="15863" extrusionOk="0">
                  <a:moveTo>
                    <a:pt x="2960" y="1"/>
                  </a:moveTo>
                  <a:cubicBezTo>
                    <a:pt x="2960" y="1"/>
                    <a:pt x="2851" y="2438"/>
                    <a:pt x="2699" y="2568"/>
                  </a:cubicBezTo>
                  <a:cubicBezTo>
                    <a:pt x="2264" y="2938"/>
                    <a:pt x="653" y="3243"/>
                    <a:pt x="371" y="3896"/>
                  </a:cubicBezTo>
                  <a:cubicBezTo>
                    <a:pt x="1" y="4657"/>
                    <a:pt x="2002" y="8138"/>
                    <a:pt x="2264" y="9292"/>
                  </a:cubicBezTo>
                  <a:cubicBezTo>
                    <a:pt x="2525" y="10445"/>
                    <a:pt x="1981" y="12229"/>
                    <a:pt x="1807" y="13360"/>
                  </a:cubicBezTo>
                  <a:cubicBezTo>
                    <a:pt x="1633" y="14492"/>
                    <a:pt x="5179" y="15862"/>
                    <a:pt x="5310" y="15862"/>
                  </a:cubicBezTo>
                  <a:cubicBezTo>
                    <a:pt x="5440" y="15862"/>
                    <a:pt x="6593" y="14796"/>
                    <a:pt x="6811" y="14426"/>
                  </a:cubicBezTo>
                  <a:cubicBezTo>
                    <a:pt x="7029" y="14057"/>
                    <a:pt x="6811" y="11163"/>
                    <a:pt x="6811" y="10423"/>
                  </a:cubicBezTo>
                  <a:cubicBezTo>
                    <a:pt x="6811" y="9683"/>
                    <a:pt x="6985" y="7094"/>
                    <a:pt x="7007" y="6920"/>
                  </a:cubicBezTo>
                  <a:cubicBezTo>
                    <a:pt x="7224" y="5788"/>
                    <a:pt x="6942" y="4896"/>
                    <a:pt x="6898" y="4657"/>
                  </a:cubicBezTo>
                  <a:cubicBezTo>
                    <a:pt x="6855" y="4418"/>
                    <a:pt x="6855" y="4026"/>
                    <a:pt x="6746" y="3874"/>
                  </a:cubicBezTo>
                  <a:cubicBezTo>
                    <a:pt x="6506" y="3569"/>
                    <a:pt x="5179" y="3156"/>
                    <a:pt x="5157" y="3003"/>
                  </a:cubicBezTo>
                  <a:cubicBezTo>
                    <a:pt x="5136" y="2851"/>
                    <a:pt x="4962" y="741"/>
                    <a:pt x="4962" y="741"/>
                  </a:cubicBezTo>
                  <a:lnTo>
                    <a:pt x="2960" y="1"/>
                  </a:lnTo>
                  <a:close/>
                </a:path>
              </a:pathLst>
            </a:custGeom>
            <a:solidFill>
              <a:srgbClr val="FFBD95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81" name="Google Shape;81;p6"/>
            <p:cNvSpPr/>
            <p:nvPr/>
          </p:nvSpPr>
          <p:spPr>
            <a:xfrm>
              <a:off x="-138323" y="2680556"/>
              <a:ext cx="544367" cy="787173"/>
            </a:xfrm>
            <a:custGeom>
              <a:avLst/>
              <a:gdLst/>
              <a:ahLst/>
              <a:cxnLst/>
              <a:rect l="l" t="t" r="r" b="b"/>
              <a:pathLst>
                <a:path w="6986" h="10102" extrusionOk="0">
                  <a:moveTo>
                    <a:pt x="2525" y="0"/>
                  </a:moveTo>
                  <a:cubicBezTo>
                    <a:pt x="2525" y="0"/>
                    <a:pt x="1132" y="631"/>
                    <a:pt x="697" y="849"/>
                  </a:cubicBezTo>
                  <a:cubicBezTo>
                    <a:pt x="284" y="1045"/>
                    <a:pt x="1" y="1415"/>
                    <a:pt x="23" y="1980"/>
                  </a:cubicBezTo>
                  <a:cubicBezTo>
                    <a:pt x="44" y="2546"/>
                    <a:pt x="1807" y="6789"/>
                    <a:pt x="1872" y="7028"/>
                  </a:cubicBezTo>
                  <a:cubicBezTo>
                    <a:pt x="1916" y="7267"/>
                    <a:pt x="1393" y="9509"/>
                    <a:pt x="1676" y="9726"/>
                  </a:cubicBezTo>
                  <a:cubicBezTo>
                    <a:pt x="1741" y="9791"/>
                    <a:pt x="3330" y="9987"/>
                    <a:pt x="4744" y="10074"/>
                  </a:cubicBezTo>
                  <a:cubicBezTo>
                    <a:pt x="5364" y="10096"/>
                    <a:pt x="5876" y="10101"/>
                    <a:pt x="6232" y="10101"/>
                  </a:cubicBezTo>
                  <a:cubicBezTo>
                    <a:pt x="6588" y="10101"/>
                    <a:pt x="6789" y="10096"/>
                    <a:pt x="6789" y="10096"/>
                  </a:cubicBezTo>
                  <a:cubicBezTo>
                    <a:pt x="6789" y="10096"/>
                    <a:pt x="6702" y="8007"/>
                    <a:pt x="6768" y="7180"/>
                  </a:cubicBezTo>
                  <a:cubicBezTo>
                    <a:pt x="6855" y="6201"/>
                    <a:pt x="6855" y="5440"/>
                    <a:pt x="6898" y="4874"/>
                  </a:cubicBezTo>
                  <a:cubicBezTo>
                    <a:pt x="6985" y="3873"/>
                    <a:pt x="6963" y="2764"/>
                    <a:pt x="6898" y="2502"/>
                  </a:cubicBezTo>
                  <a:cubicBezTo>
                    <a:pt x="6833" y="2263"/>
                    <a:pt x="6746" y="1610"/>
                    <a:pt x="6572" y="1306"/>
                  </a:cubicBezTo>
                  <a:cubicBezTo>
                    <a:pt x="6398" y="1001"/>
                    <a:pt x="5070" y="544"/>
                    <a:pt x="5070" y="544"/>
                  </a:cubicBezTo>
                  <a:lnTo>
                    <a:pt x="4679" y="1284"/>
                  </a:lnTo>
                  <a:lnTo>
                    <a:pt x="2525" y="0"/>
                  </a:lnTo>
                  <a:close/>
                </a:path>
              </a:pathLst>
            </a:custGeom>
            <a:solidFill>
              <a:schemeClr val="dk2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82" name="Google Shape;82;p6"/>
            <p:cNvSpPr/>
            <p:nvPr/>
          </p:nvSpPr>
          <p:spPr>
            <a:xfrm>
              <a:off x="-101057" y="2738218"/>
              <a:ext cx="501977" cy="713458"/>
            </a:xfrm>
            <a:custGeom>
              <a:avLst/>
              <a:gdLst/>
              <a:ahLst/>
              <a:cxnLst/>
              <a:rect l="l" t="t" r="r" b="b"/>
              <a:pathLst>
                <a:path w="6442" h="9156" extrusionOk="0">
                  <a:moveTo>
                    <a:pt x="654" y="0"/>
                  </a:moveTo>
                  <a:lnTo>
                    <a:pt x="654" y="0"/>
                  </a:lnTo>
                  <a:cubicBezTo>
                    <a:pt x="653" y="0"/>
                    <a:pt x="1" y="1197"/>
                    <a:pt x="23" y="1632"/>
                  </a:cubicBezTo>
                  <a:cubicBezTo>
                    <a:pt x="23" y="2089"/>
                    <a:pt x="1132" y="4983"/>
                    <a:pt x="1350" y="5592"/>
                  </a:cubicBezTo>
                  <a:cubicBezTo>
                    <a:pt x="1568" y="6179"/>
                    <a:pt x="893" y="8507"/>
                    <a:pt x="1176" y="8899"/>
                  </a:cubicBezTo>
                  <a:cubicBezTo>
                    <a:pt x="1314" y="9106"/>
                    <a:pt x="1837" y="9155"/>
                    <a:pt x="2298" y="9155"/>
                  </a:cubicBezTo>
                  <a:cubicBezTo>
                    <a:pt x="2707" y="9155"/>
                    <a:pt x="3069" y="9117"/>
                    <a:pt x="3069" y="9117"/>
                  </a:cubicBezTo>
                  <a:cubicBezTo>
                    <a:pt x="3069" y="9117"/>
                    <a:pt x="2590" y="8573"/>
                    <a:pt x="2808" y="8246"/>
                  </a:cubicBezTo>
                  <a:cubicBezTo>
                    <a:pt x="3047" y="7920"/>
                    <a:pt x="6441" y="6810"/>
                    <a:pt x="6441" y="6810"/>
                  </a:cubicBezTo>
                  <a:cubicBezTo>
                    <a:pt x="6441" y="6810"/>
                    <a:pt x="3961" y="5418"/>
                    <a:pt x="3395" y="5309"/>
                  </a:cubicBezTo>
                  <a:cubicBezTo>
                    <a:pt x="2851" y="5200"/>
                    <a:pt x="1002" y="2459"/>
                    <a:pt x="545" y="1849"/>
                  </a:cubicBezTo>
                  <a:cubicBezTo>
                    <a:pt x="110" y="1240"/>
                    <a:pt x="654" y="0"/>
                    <a:pt x="654" y="0"/>
                  </a:cubicBezTo>
                  <a:close/>
                </a:path>
              </a:pathLst>
            </a:custGeom>
            <a:solidFill>
              <a:srgbClr val="191919">
                <a:alpha val="17610"/>
              </a:srgb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83" name="Google Shape;83;p6"/>
            <p:cNvSpPr/>
            <p:nvPr/>
          </p:nvSpPr>
          <p:spPr>
            <a:xfrm>
              <a:off x="66840" y="2548323"/>
              <a:ext cx="172988" cy="132312"/>
            </a:xfrm>
            <a:custGeom>
              <a:avLst/>
              <a:gdLst/>
              <a:ahLst/>
              <a:cxnLst/>
              <a:rect l="l" t="t" r="r" b="b"/>
              <a:pathLst>
                <a:path w="2220" h="1698" extrusionOk="0">
                  <a:moveTo>
                    <a:pt x="66" y="0"/>
                  </a:moveTo>
                  <a:lnTo>
                    <a:pt x="1" y="1284"/>
                  </a:lnTo>
                  <a:lnTo>
                    <a:pt x="675" y="1697"/>
                  </a:lnTo>
                  <a:lnTo>
                    <a:pt x="2220" y="1088"/>
                  </a:lnTo>
                  <a:lnTo>
                    <a:pt x="66" y="0"/>
                  </a:lnTo>
                  <a:close/>
                </a:path>
              </a:pathLst>
            </a:custGeom>
            <a:solidFill>
              <a:srgbClr val="191919">
                <a:alpha val="17610"/>
              </a:srgb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84" name="Google Shape;84;p6"/>
            <p:cNvSpPr/>
            <p:nvPr/>
          </p:nvSpPr>
          <p:spPr>
            <a:xfrm>
              <a:off x="-163725" y="2754192"/>
              <a:ext cx="203534" cy="533457"/>
            </a:xfrm>
            <a:custGeom>
              <a:avLst/>
              <a:gdLst/>
              <a:ahLst/>
              <a:cxnLst/>
              <a:rect l="l" t="t" r="r" b="b"/>
              <a:pathLst>
                <a:path w="2612" h="6846" extrusionOk="0">
                  <a:moveTo>
                    <a:pt x="1127" y="1"/>
                  </a:moveTo>
                  <a:cubicBezTo>
                    <a:pt x="411" y="1"/>
                    <a:pt x="126" y="619"/>
                    <a:pt x="66" y="1405"/>
                  </a:cubicBezTo>
                  <a:cubicBezTo>
                    <a:pt x="0" y="2232"/>
                    <a:pt x="588" y="6540"/>
                    <a:pt x="784" y="6714"/>
                  </a:cubicBezTo>
                  <a:cubicBezTo>
                    <a:pt x="868" y="6798"/>
                    <a:pt x="1139" y="6846"/>
                    <a:pt x="1436" y="6846"/>
                  </a:cubicBezTo>
                  <a:cubicBezTo>
                    <a:pt x="1832" y="6846"/>
                    <a:pt x="2273" y="6761"/>
                    <a:pt x="2372" y="6562"/>
                  </a:cubicBezTo>
                  <a:cubicBezTo>
                    <a:pt x="2546" y="6214"/>
                    <a:pt x="2611" y="2471"/>
                    <a:pt x="2546" y="1775"/>
                  </a:cubicBezTo>
                  <a:cubicBezTo>
                    <a:pt x="2459" y="1101"/>
                    <a:pt x="2285" y="143"/>
                    <a:pt x="1306" y="13"/>
                  </a:cubicBezTo>
                  <a:cubicBezTo>
                    <a:pt x="1244" y="5"/>
                    <a:pt x="1184" y="1"/>
                    <a:pt x="1127" y="1"/>
                  </a:cubicBezTo>
                  <a:close/>
                </a:path>
              </a:pathLst>
            </a:custGeom>
            <a:solidFill>
              <a:schemeClr val="dk2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85" name="Google Shape;85;p6"/>
            <p:cNvSpPr/>
            <p:nvPr/>
          </p:nvSpPr>
          <p:spPr>
            <a:xfrm>
              <a:off x="4115" y="2258222"/>
              <a:ext cx="332417" cy="373794"/>
            </a:xfrm>
            <a:custGeom>
              <a:avLst/>
              <a:gdLst/>
              <a:ahLst/>
              <a:cxnLst/>
              <a:rect l="l" t="t" r="r" b="b"/>
              <a:pathLst>
                <a:path w="4266" h="4797" extrusionOk="0">
                  <a:moveTo>
                    <a:pt x="2013" y="0"/>
                  </a:moveTo>
                  <a:cubicBezTo>
                    <a:pt x="1610" y="0"/>
                    <a:pt x="1209" y="133"/>
                    <a:pt x="893" y="481"/>
                  </a:cubicBezTo>
                  <a:cubicBezTo>
                    <a:pt x="0" y="1417"/>
                    <a:pt x="196" y="2505"/>
                    <a:pt x="523" y="3201"/>
                  </a:cubicBezTo>
                  <a:cubicBezTo>
                    <a:pt x="784" y="3745"/>
                    <a:pt x="1067" y="4050"/>
                    <a:pt x="1632" y="4419"/>
                  </a:cubicBezTo>
                  <a:cubicBezTo>
                    <a:pt x="1752" y="4479"/>
                    <a:pt x="2700" y="4797"/>
                    <a:pt x="3038" y="4797"/>
                  </a:cubicBezTo>
                  <a:cubicBezTo>
                    <a:pt x="3068" y="4797"/>
                    <a:pt x="3093" y="4795"/>
                    <a:pt x="3112" y="4789"/>
                  </a:cubicBezTo>
                  <a:cubicBezTo>
                    <a:pt x="3264" y="4768"/>
                    <a:pt x="3525" y="3614"/>
                    <a:pt x="3591" y="3614"/>
                  </a:cubicBezTo>
                  <a:cubicBezTo>
                    <a:pt x="3598" y="3618"/>
                    <a:pt x="3608" y="3620"/>
                    <a:pt x="3619" y="3620"/>
                  </a:cubicBezTo>
                  <a:cubicBezTo>
                    <a:pt x="3675" y="3620"/>
                    <a:pt x="3768" y="3574"/>
                    <a:pt x="3786" y="3484"/>
                  </a:cubicBezTo>
                  <a:cubicBezTo>
                    <a:pt x="3808" y="3353"/>
                    <a:pt x="3765" y="2505"/>
                    <a:pt x="3808" y="2418"/>
                  </a:cubicBezTo>
                  <a:cubicBezTo>
                    <a:pt x="3852" y="2331"/>
                    <a:pt x="4265" y="1395"/>
                    <a:pt x="3721" y="764"/>
                  </a:cubicBezTo>
                  <a:cubicBezTo>
                    <a:pt x="3431" y="404"/>
                    <a:pt x="2717" y="0"/>
                    <a:pt x="2013" y="0"/>
                  </a:cubicBezTo>
                  <a:close/>
                </a:path>
              </a:pathLst>
            </a:custGeom>
            <a:solidFill>
              <a:srgbClr val="FFBD95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86" name="Google Shape;86;p6"/>
            <p:cNvSpPr/>
            <p:nvPr/>
          </p:nvSpPr>
          <p:spPr>
            <a:xfrm>
              <a:off x="-4379" y="2250975"/>
              <a:ext cx="318859" cy="302495"/>
            </a:xfrm>
            <a:custGeom>
              <a:avLst/>
              <a:gdLst/>
              <a:ahLst/>
              <a:cxnLst/>
              <a:rect l="l" t="t" r="r" b="b"/>
              <a:pathLst>
                <a:path w="4092" h="3882" extrusionOk="0">
                  <a:moveTo>
                    <a:pt x="2362" y="0"/>
                  </a:moveTo>
                  <a:cubicBezTo>
                    <a:pt x="1844" y="0"/>
                    <a:pt x="1024" y="197"/>
                    <a:pt x="588" y="1053"/>
                  </a:cubicBezTo>
                  <a:cubicBezTo>
                    <a:pt x="1" y="2228"/>
                    <a:pt x="697" y="3860"/>
                    <a:pt x="980" y="3881"/>
                  </a:cubicBezTo>
                  <a:cubicBezTo>
                    <a:pt x="1089" y="3881"/>
                    <a:pt x="1502" y="3337"/>
                    <a:pt x="1306" y="2228"/>
                  </a:cubicBezTo>
                  <a:cubicBezTo>
                    <a:pt x="1306" y="2221"/>
                    <a:pt x="1309" y="2218"/>
                    <a:pt x="1313" y="2218"/>
                  </a:cubicBezTo>
                  <a:cubicBezTo>
                    <a:pt x="1382" y="2218"/>
                    <a:pt x="1945" y="2908"/>
                    <a:pt x="2054" y="2908"/>
                  </a:cubicBezTo>
                  <a:cubicBezTo>
                    <a:pt x="2060" y="2908"/>
                    <a:pt x="2065" y="2906"/>
                    <a:pt x="2068" y="2902"/>
                  </a:cubicBezTo>
                  <a:cubicBezTo>
                    <a:pt x="2133" y="2837"/>
                    <a:pt x="1807" y="1858"/>
                    <a:pt x="2068" y="1662"/>
                  </a:cubicBezTo>
                  <a:cubicBezTo>
                    <a:pt x="2575" y="1299"/>
                    <a:pt x="3011" y="1194"/>
                    <a:pt x="3347" y="1194"/>
                  </a:cubicBezTo>
                  <a:cubicBezTo>
                    <a:pt x="3817" y="1194"/>
                    <a:pt x="4091" y="1401"/>
                    <a:pt x="4091" y="1401"/>
                  </a:cubicBezTo>
                  <a:cubicBezTo>
                    <a:pt x="3982" y="357"/>
                    <a:pt x="3069" y="161"/>
                    <a:pt x="2764" y="52"/>
                  </a:cubicBezTo>
                  <a:cubicBezTo>
                    <a:pt x="2685" y="24"/>
                    <a:pt x="2542" y="0"/>
                    <a:pt x="2362" y="0"/>
                  </a:cubicBezTo>
                  <a:close/>
                </a:path>
              </a:pathLst>
            </a:custGeom>
            <a:solidFill>
              <a:schemeClr val="dk1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87" name="Google Shape;87;p6"/>
            <p:cNvSpPr/>
            <p:nvPr/>
          </p:nvSpPr>
          <p:spPr>
            <a:xfrm>
              <a:off x="85463" y="2414142"/>
              <a:ext cx="54390" cy="100442"/>
            </a:xfrm>
            <a:custGeom>
              <a:avLst/>
              <a:gdLst/>
              <a:ahLst/>
              <a:cxnLst/>
              <a:rect l="l" t="t" r="r" b="b"/>
              <a:pathLst>
                <a:path w="698" h="1289" extrusionOk="0">
                  <a:moveTo>
                    <a:pt x="329" y="1"/>
                  </a:moveTo>
                  <a:cubicBezTo>
                    <a:pt x="315" y="1"/>
                    <a:pt x="300" y="1"/>
                    <a:pt x="284" y="3"/>
                  </a:cubicBezTo>
                  <a:cubicBezTo>
                    <a:pt x="110" y="25"/>
                    <a:pt x="1" y="351"/>
                    <a:pt x="66" y="700"/>
                  </a:cubicBezTo>
                  <a:cubicBezTo>
                    <a:pt x="108" y="1034"/>
                    <a:pt x="311" y="1288"/>
                    <a:pt x="481" y="1288"/>
                  </a:cubicBezTo>
                  <a:cubicBezTo>
                    <a:pt x="488" y="1288"/>
                    <a:pt x="495" y="1288"/>
                    <a:pt x="501" y="1287"/>
                  </a:cubicBezTo>
                  <a:cubicBezTo>
                    <a:pt x="697" y="1265"/>
                    <a:pt x="697" y="787"/>
                    <a:pt x="632" y="438"/>
                  </a:cubicBezTo>
                  <a:cubicBezTo>
                    <a:pt x="592" y="118"/>
                    <a:pt x="497" y="1"/>
                    <a:pt x="329" y="1"/>
                  </a:cubicBezTo>
                  <a:close/>
                </a:path>
              </a:pathLst>
            </a:custGeom>
            <a:solidFill>
              <a:srgbClr val="FFBD95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88" name="Google Shape;88;p6"/>
            <p:cNvSpPr/>
            <p:nvPr/>
          </p:nvSpPr>
          <p:spPr>
            <a:xfrm>
              <a:off x="141409" y="5055834"/>
              <a:ext cx="108624" cy="20416"/>
            </a:xfrm>
            <a:custGeom>
              <a:avLst/>
              <a:gdLst/>
              <a:ahLst/>
              <a:cxnLst/>
              <a:rect l="l" t="t" r="r" b="b"/>
              <a:pathLst>
                <a:path w="1394" h="262" extrusionOk="0">
                  <a:moveTo>
                    <a:pt x="1" y="0"/>
                  </a:moveTo>
                  <a:lnTo>
                    <a:pt x="1" y="261"/>
                  </a:lnTo>
                  <a:lnTo>
                    <a:pt x="1393" y="261"/>
                  </a:lnTo>
                  <a:lnTo>
                    <a:pt x="1393" y="0"/>
                  </a:lnTo>
                  <a:close/>
                </a:path>
              </a:pathLst>
            </a:custGeom>
            <a:solidFill>
              <a:srgbClr val="191919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89" name="Google Shape;89;p6"/>
            <p:cNvSpPr/>
            <p:nvPr/>
          </p:nvSpPr>
          <p:spPr>
            <a:xfrm>
              <a:off x="119436" y="4912459"/>
              <a:ext cx="412054" cy="180780"/>
            </a:xfrm>
            <a:custGeom>
              <a:avLst/>
              <a:gdLst/>
              <a:ahLst/>
              <a:cxnLst/>
              <a:rect l="l" t="t" r="r" b="b"/>
              <a:pathLst>
                <a:path w="5288" h="2320" extrusionOk="0">
                  <a:moveTo>
                    <a:pt x="501" y="0"/>
                  </a:moveTo>
                  <a:cubicBezTo>
                    <a:pt x="411" y="0"/>
                    <a:pt x="353" y="4"/>
                    <a:pt x="348" y="13"/>
                  </a:cubicBezTo>
                  <a:cubicBezTo>
                    <a:pt x="152" y="274"/>
                    <a:pt x="44" y="752"/>
                    <a:pt x="22" y="992"/>
                  </a:cubicBezTo>
                  <a:cubicBezTo>
                    <a:pt x="0" y="1253"/>
                    <a:pt x="152" y="1840"/>
                    <a:pt x="348" y="1840"/>
                  </a:cubicBezTo>
                  <a:cubicBezTo>
                    <a:pt x="870" y="1840"/>
                    <a:pt x="1480" y="1862"/>
                    <a:pt x="2024" y="1927"/>
                  </a:cubicBezTo>
                  <a:cubicBezTo>
                    <a:pt x="2568" y="1993"/>
                    <a:pt x="2763" y="2319"/>
                    <a:pt x="4156" y="2319"/>
                  </a:cubicBezTo>
                  <a:cubicBezTo>
                    <a:pt x="4548" y="2319"/>
                    <a:pt x="5287" y="2276"/>
                    <a:pt x="5266" y="2123"/>
                  </a:cubicBezTo>
                  <a:cubicBezTo>
                    <a:pt x="5244" y="1949"/>
                    <a:pt x="3938" y="1666"/>
                    <a:pt x="3525" y="1275"/>
                  </a:cubicBezTo>
                  <a:cubicBezTo>
                    <a:pt x="2459" y="296"/>
                    <a:pt x="1741" y="56"/>
                    <a:pt x="1741" y="56"/>
                  </a:cubicBezTo>
                  <a:cubicBezTo>
                    <a:pt x="1741" y="56"/>
                    <a:pt x="863" y="0"/>
                    <a:pt x="501" y="0"/>
                  </a:cubicBezTo>
                  <a:close/>
                </a:path>
              </a:pathLst>
            </a:custGeom>
            <a:solidFill>
              <a:schemeClr val="dk1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90" name="Google Shape;90;p6"/>
            <p:cNvSpPr/>
            <p:nvPr/>
          </p:nvSpPr>
          <p:spPr>
            <a:xfrm>
              <a:off x="39724" y="3463978"/>
              <a:ext cx="359534" cy="1502502"/>
            </a:xfrm>
            <a:custGeom>
              <a:avLst/>
              <a:gdLst/>
              <a:ahLst/>
              <a:cxnLst/>
              <a:rect l="l" t="t" r="r" b="b"/>
              <a:pathLst>
                <a:path w="4614" h="19282" extrusionOk="0">
                  <a:moveTo>
                    <a:pt x="4380" y="0"/>
                  </a:moveTo>
                  <a:cubicBezTo>
                    <a:pt x="3680" y="0"/>
                    <a:pt x="262" y="999"/>
                    <a:pt x="262" y="999"/>
                  </a:cubicBezTo>
                  <a:cubicBezTo>
                    <a:pt x="262" y="999"/>
                    <a:pt x="174" y="1565"/>
                    <a:pt x="87" y="2370"/>
                  </a:cubicBezTo>
                  <a:cubicBezTo>
                    <a:pt x="0" y="3175"/>
                    <a:pt x="784" y="5743"/>
                    <a:pt x="1067" y="7766"/>
                  </a:cubicBezTo>
                  <a:cubicBezTo>
                    <a:pt x="1328" y="9790"/>
                    <a:pt x="1502" y="10203"/>
                    <a:pt x="1436" y="10682"/>
                  </a:cubicBezTo>
                  <a:cubicBezTo>
                    <a:pt x="1371" y="11160"/>
                    <a:pt x="762" y="13097"/>
                    <a:pt x="849" y="14381"/>
                  </a:cubicBezTo>
                  <a:cubicBezTo>
                    <a:pt x="914" y="15686"/>
                    <a:pt x="1175" y="19059"/>
                    <a:pt x="1175" y="19059"/>
                  </a:cubicBezTo>
                  <a:cubicBezTo>
                    <a:pt x="1175" y="19059"/>
                    <a:pt x="1567" y="19233"/>
                    <a:pt x="2220" y="19276"/>
                  </a:cubicBezTo>
                  <a:cubicBezTo>
                    <a:pt x="2257" y="19280"/>
                    <a:pt x="2293" y="19281"/>
                    <a:pt x="2328" y="19281"/>
                  </a:cubicBezTo>
                  <a:cubicBezTo>
                    <a:pt x="2943" y="19281"/>
                    <a:pt x="3351" y="18776"/>
                    <a:pt x="3351" y="18776"/>
                  </a:cubicBezTo>
                  <a:cubicBezTo>
                    <a:pt x="3351" y="18776"/>
                    <a:pt x="3873" y="11247"/>
                    <a:pt x="3960" y="10464"/>
                  </a:cubicBezTo>
                  <a:cubicBezTo>
                    <a:pt x="4026" y="9942"/>
                    <a:pt x="4439" y="6395"/>
                    <a:pt x="4570" y="3502"/>
                  </a:cubicBezTo>
                  <a:cubicBezTo>
                    <a:pt x="4613" y="2566"/>
                    <a:pt x="4504" y="412"/>
                    <a:pt x="4504" y="42"/>
                  </a:cubicBezTo>
                  <a:cubicBezTo>
                    <a:pt x="4504" y="13"/>
                    <a:pt x="4460" y="0"/>
                    <a:pt x="4380" y="0"/>
                  </a:cubicBezTo>
                  <a:close/>
                </a:path>
              </a:pathLst>
            </a:custGeom>
            <a:solidFill>
              <a:schemeClr val="dk1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91" name="Google Shape;91;p6"/>
            <p:cNvSpPr/>
            <p:nvPr/>
          </p:nvSpPr>
          <p:spPr>
            <a:xfrm>
              <a:off x="-41624" y="3440056"/>
              <a:ext cx="371379" cy="1526736"/>
            </a:xfrm>
            <a:custGeom>
              <a:avLst/>
              <a:gdLst/>
              <a:ahLst/>
              <a:cxnLst/>
              <a:rect l="l" t="t" r="r" b="b"/>
              <a:pathLst>
                <a:path w="4766" h="19593" extrusionOk="0">
                  <a:moveTo>
                    <a:pt x="457" y="1"/>
                  </a:moveTo>
                  <a:cubicBezTo>
                    <a:pt x="457" y="1"/>
                    <a:pt x="0" y="1198"/>
                    <a:pt x="0" y="2198"/>
                  </a:cubicBezTo>
                  <a:cubicBezTo>
                    <a:pt x="22" y="3004"/>
                    <a:pt x="239" y="4505"/>
                    <a:pt x="522" y="6528"/>
                  </a:cubicBezTo>
                  <a:cubicBezTo>
                    <a:pt x="805" y="8552"/>
                    <a:pt x="827" y="10423"/>
                    <a:pt x="762" y="10902"/>
                  </a:cubicBezTo>
                  <a:cubicBezTo>
                    <a:pt x="696" y="11380"/>
                    <a:pt x="44" y="13404"/>
                    <a:pt x="131" y="14688"/>
                  </a:cubicBezTo>
                  <a:cubicBezTo>
                    <a:pt x="196" y="15993"/>
                    <a:pt x="544" y="19170"/>
                    <a:pt x="544" y="19170"/>
                  </a:cubicBezTo>
                  <a:cubicBezTo>
                    <a:pt x="544" y="19170"/>
                    <a:pt x="957" y="19518"/>
                    <a:pt x="1610" y="19583"/>
                  </a:cubicBezTo>
                  <a:cubicBezTo>
                    <a:pt x="1680" y="19590"/>
                    <a:pt x="1747" y="19593"/>
                    <a:pt x="1810" y="19593"/>
                  </a:cubicBezTo>
                  <a:cubicBezTo>
                    <a:pt x="2361" y="19593"/>
                    <a:pt x="2676" y="19366"/>
                    <a:pt x="2676" y="19366"/>
                  </a:cubicBezTo>
                  <a:cubicBezTo>
                    <a:pt x="2676" y="19366"/>
                    <a:pt x="3438" y="11816"/>
                    <a:pt x="3742" y="11076"/>
                  </a:cubicBezTo>
                  <a:cubicBezTo>
                    <a:pt x="4221" y="9901"/>
                    <a:pt x="4308" y="6158"/>
                    <a:pt x="4635" y="3613"/>
                  </a:cubicBezTo>
                  <a:cubicBezTo>
                    <a:pt x="4765" y="2590"/>
                    <a:pt x="4678" y="306"/>
                    <a:pt x="4678" y="306"/>
                  </a:cubicBezTo>
                  <a:lnTo>
                    <a:pt x="457" y="1"/>
                  </a:lnTo>
                  <a:close/>
                </a:path>
              </a:pathLst>
            </a:custGeom>
            <a:solidFill>
              <a:schemeClr val="dk1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92" name="Google Shape;92;p6"/>
            <p:cNvSpPr/>
            <p:nvPr/>
          </p:nvSpPr>
          <p:spPr>
            <a:xfrm>
              <a:off x="-41637" y="3440056"/>
              <a:ext cx="371379" cy="1526736"/>
            </a:xfrm>
            <a:custGeom>
              <a:avLst/>
              <a:gdLst/>
              <a:ahLst/>
              <a:cxnLst/>
              <a:rect l="l" t="t" r="r" b="b"/>
              <a:pathLst>
                <a:path w="4766" h="19593" extrusionOk="0">
                  <a:moveTo>
                    <a:pt x="457" y="1"/>
                  </a:moveTo>
                  <a:cubicBezTo>
                    <a:pt x="457" y="1"/>
                    <a:pt x="0" y="1198"/>
                    <a:pt x="0" y="2198"/>
                  </a:cubicBezTo>
                  <a:cubicBezTo>
                    <a:pt x="22" y="3004"/>
                    <a:pt x="239" y="4505"/>
                    <a:pt x="522" y="6528"/>
                  </a:cubicBezTo>
                  <a:cubicBezTo>
                    <a:pt x="805" y="8552"/>
                    <a:pt x="827" y="10423"/>
                    <a:pt x="762" y="10902"/>
                  </a:cubicBezTo>
                  <a:cubicBezTo>
                    <a:pt x="696" y="11380"/>
                    <a:pt x="44" y="13404"/>
                    <a:pt x="131" y="14688"/>
                  </a:cubicBezTo>
                  <a:cubicBezTo>
                    <a:pt x="196" y="15993"/>
                    <a:pt x="544" y="19170"/>
                    <a:pt x="544" y="19170"/>
                  </a:cubicBezTo>
                  <a:cubicBezTo>
                    <a:pt x="544" y="19170"/>
                    <a:pt x="957" y="19518"/>
                    <a:pt x="1610" y="19583"/>
                  </a:cubicBezTo>
                  <a:cubicBezTo>
                    <a:pt x="1680" y="19590"/>
                    <a:pt x="1747" y="19593"/>
                    <a:pt x="1810" y="19593"/>
                  </a:cubicBezTo>
                  <a:cubicBezTo>
                    <a:pt x="2361" y="19593"/>
                    <a:pt x="2676" y="19366"/>
                    <a:pt x="2676" y="19366"/>
                  </a:cubicBezTo>
                  <a:cubicBezTo>
                    <a:pt x="2676" y="19366"/>
                    <a:pt x="3438" y="11816"/>
                    <a:pt x="3742" y="11076"/>
                  </a:cubicBezTo>
                  <a:cubicBezTo>
                    <a:pt x="4221" y="9901"/>
                    <a:pt x="4308" y="6158"/>
                    <a:pt x="4635" y="3613"/>
                  </a:cubicBezTo>
                  <a:cubicBezTo>
                    <a:pt x="4765" y="2590"/>
                    <a:pt x="4678" y="306"/>
                    <a:pt x="4678" y="306"/>
                  </a:cubicBezTo>
                  <a:lnTo>
                    <a:pt x="457" y="1"/>
                  </a:lnTo>
                  <a:close/>
                </a:path>
              </a:pathLst>
            </a:custGeom>
            <a:solidFill>
              <a:srgbClr val="FFFFFF">
                <a:alpha val="18240"/>
              </a:srgb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93" name="Google Shape;93;p6"/>
            <p:cNvSpPr/>
            <p:nvPr/>
          </p:nvSpPr>
          <p:spPr>
            <a:xfrm>
              <a:off x="-2677" y="5084665"/>
              <a:ext cx="108546" cy="28909"/>
            </a:xfrm>
            <a:custGeom>
              <a:avLst/>
              <a:gdLst/>
              <a:ahLst/>
              <a:cxnLst/>
              <a:rect l="l" t="t" r="r" b="b"/>
              <a:pathLst>
                <a:path w="1393" h="371" extrusionOk="0">
                  <a:moveTo>
                    <a:pt x="22" y="0"/>
                  </a:moveTo>
                  <a:lnTo>
                    <a:pt x="0" y="283"/>
                  </a:lnTo>
                  <a:lnTo>
                    <a:pt x="1371" y="370"/>
                  </a:lnTo>
                  <a:lnTo>
                    <a:pt x="1393" y="87"/>
                  </a:lnTo>
                  <a:lnTo>
                    <a:pt x="22" y="0"/>
                  </a:lnTo>
                  <a:close/>
                </a:path>
              </a:pathLst>
            </a:custGeom>
            <a:solidFill>
              <a:srgbClr val="FFFFFF">
                <a:alpha val="18240"/>
              </a:srgb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94" name="Google Shape;94;p6"/>
            <p:cNvSpPr/>
            <p:nvPr/>
          </p:nvSpPr>
          <p:spPr>
            <a:xfrm>
              <a:off x="-21300" y="4938329"/>
              <a:ext cx="406366" cy="205170"/>
            </a:xfrm>
            <a:custGeom>
              <a:avLst/>
              <a:gdLst/>
              <a:ahLst/>
              <a:cxnLst/>
              <a:rect l="l" t="t" r="r" b="b"/>
              <a:pathLst>
                <a:path w="5215" h="2633" extrusionOk="0">
                  <a:moveTo>
                    <a:pt x="495" y="0"/>
                  </a:moveTo>
                  <a:cubicBezTo>
                    <a:pt x="461" y="0"/>
                    <a:pt x="440" y="2"/>
                    <a:pt x="435" y="7"/>
                  </a:cubicBezTo>
                  <a:cubicBezTo>
                    <a:pt x="239" y="268"/>
                    <a:pt x="65" y="769"/>
                    <a:pt x="44" y="986"/>
                  </a:cubicBezTo>
                  <a:cubicBezTo>
                    <a:pt x="0" y="1269"/>
                    <a:pt x="131" y="1878"/>
                    <a:pt x="305" y="1900"/>
                  </a:cubicBezTo>
                  <a:cubicBezTo>
                    <a:pt x="827" y="1922"/>
                    <a:pt x="1458" y="1987"/>
                    <a:pt x="1980" y="2096"/>
                  </a:cubicBezTo>
                  <a:cubicBezTo>
                    <a:pt x="2524" y="2205"/>
                    <a:pt x="2698" y="2531"/>
                    <a:pt x="4091" y="2618"/>
                  </a:cubicBezTo>
                  <a:cubicBezTo>
                    <a:pt x="4221" y="2625"/>
                    <a:pt x="4390" y="2633"/>
                    <a:pt x="4557" y="2633"/>
                  </a:cubicBezTo>
                  <a:cubicBezTo>
                    <a:pt x="4891" y="2633"/>
                    <a:pt x="5215" y="2604"/>
                    <a:pt x="5200" y="2487"/>
                  </a:cubicBezTo>
                  <a:cubicBezTo>
                    <a:pt x="5200" y="2313"/>
                    <a:pt x="3917" y="1922"/>
                    <a:pt x="3525" y="1508"/>
                  </a:cubicBezTo>
                  <a:cubicBezTo>
                    <a:pt x="2524" y="420"/>
                    <a:pt x="1828" y="138"/>
                    <a:pt x="1828" y="138"/>
                  </a:cubicBezTo>
                  <a:cubicBezTo>
                    <a:pt x="1828" y="138"/>
                    <a:pt x="762" y="0"/>
                    <a:pt x="495" y="0"/>
                  </a:cubicBezTo>
                  <a:close/>
                </a:path>
              </a:pathLst>
            </a:custGeom>
            <a:solidFill>
              <a:srgbClr val="FFFFFF">
                <a:alpha val="18240"/>
              </a:srgb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95" name="Google Shape;95;p6"/>
            <p:cNvSpPr/>
            <p:nvPr/>
          </p:nvSpPr>
          <p:spPr>
            <a:xfrm>
              <a:off x="-2665" y="5084665"/>
              <a:ext cx="108546" cy="28909"/>
            </a:xfrm>
            <a:custGeom>
              <a:avLst/>
              <a:gdLst/>
              <a:ahLst/>
              <a:cxnLst/>
              <a:rect l="l" t="t" r="r" b="b"/>
              <a:pathLst>
                <a:path w="1393" h="371" extrusionOk="0">
                  <a:moveTo>
                    <a:pt x="22" y="0"/>
                  </a:moveTo>
                  <a:lnTo>
                    <a:pt x="0" y="283"/>
                  </a:lnTo>
                  <a:lnTo>
                    <a:pt x="1371" y="370"/>
                  </a:lnTo>
                  <a:lnTo>
                    <a:pt x="1393" y="87"/>
                  </a:lnTo>
                  <a:lnTo>
                    <a:pt x="22" y="0"/>
                  </a:lnTo>
                  <a:close/>
                </a:path>
              </a:pathLst>
            </a:custGeom>
            <a:solidFill>
              <a:schemeClr val="dk1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96" name="Google Shape;96;p6"/>
            <p:cNvSpPr/>
            <p:nvPr/>
          </p:nvSpPr>
          <p:spPr>
            <a:xfrm>
              <a:off x="-21287" y="4938329"/>
              <a:ext cx="406366" cy="205170"/>
            </a:xfrm>
            <a:custGeom>
              <a:avLst/>
              <a:gdLst/>
              <a:ahLst/>
              <a:cxnLst/>
              <a:rect l="l" t="t" r="r" b="b"/>
              <a:pathLst>
                <a:path w="5215" h="2633" extrusionOk="0">
                  <a:moveTo>
                    <a:pt x="495" y="0"/>
                  </a:moveTo>
                  <a:cubicBezTo>
                    <a:pt x="461" y="0"/>
                    <a:pt x="440" y="2"/>
                    <a:pt x="435" y="7"/>
                  </a:cubicBezTo>
                  <a:cubicBezTo>
                    <a:pt x="239" y="268"/>
                    <a:pt x="65" y="769"/>
                    <a:pt x="44" y="986"/>
                  </a:cubicBezTo>
                  <a:cubicBezTo>
                    <a:pt x="0" y="1269"/>
                    <a:pt x="131" y="1878"/>
                    <a:pt x="305" y="1900"/>
                  </a:cubicBezTo>
                  <a:cubicBezTo>
                    <a:pt x="827" y="1922"/>
                    <a:pt x="1458" y="1987"/>
                    <a:pt x="1980" y="2096"/>
                  </a:cubicBezTo>
                  <a:cubicBezTo>
                    <a:pt x="2524" y="2205"/>
                    <a:pt x="2698" y="2531"/>
                    <a:pt x="4091" y="2618"/>
                  </a:cubicBezTo>
                  <a:cubicBezTo>
                    <a:pt x="4221" y="2625"/>
                    <a:pt x="4390" y="2633"/>
                    <a:pt x="4557" y="2633"/>
                  </a:cubicBezTo>
                  <a:cubicBezTo>
                    <a:pt x="4891" y="2633"/>
                    <a:pt x="5215" y="2604"/>
                    <a:pt x="5200" y="2487"/>
                  </a:cubicBezTo>
                  <a:cubicBezTo>
                    <a:pt x="5200" y="2313"/>
                    <a:pt x="3917" y="1922"/>
                    <a:pt x="3525" y="1508"/>
                  </a:cubicBezTo>
                  <a:cubicBezTo>
                    <a:pt x="2524" y="420"/>
                    <a:pt x="1828" y="138"/>
                    <a:pt x="1828" y="138"/>
                  </a:cubicBezTo>
                  <a:cubicBezTo>
                    <a:pt x="1828" y="138"/>
                    <a:pt x="762" y="0"/>
                    <a:pt x="495" y="0"/>
                  </a:cubicBezTo>
                  <a:close/>
                </a:path>
              </a:pathLst>
            </a:custGeom>
            <a:solidFill>
              <a:schemeClr val="dk1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97" name="Google Shape;97;p6"/>
            <p:cNvSpPr/>
            <p:nvPr/>
          </p:nvSpPr>
          <p:spPr>
            <a:xfrm>
              <a:off x="138059" y="2728010"/>
              <a:ext cx="88208" cy="52598"/>
            </a:xfrm>
            <a:custGeom>
              <a:avLst/>
              <a:gdLst/>
              <a:ahLst/>
              <a:cxnLst/>
              <a:rect l="l" t="t" r="r" b="b"/>
              <a:pathLst>
                <a:path w="1132" h="675" extrusionOk="0">
                  <a:moveTo>
                    <a:pt x="0" y="0"/>
                  </a:moveTo>
                  <a:lnTo>
                    <a:pt x="1132" y="675"/>
                  </a:lnTo>
                  <a:lnTo>
                    <a:pt x="1023" y="15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8D1FF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98" name="Google Shape;98;p6"/>
            <p:cNvSpPr/>
            <p:nvPr/>
          </p:nvSpPr>
          <p:spPr>
            <a:xfrm>
              <a:off x="226186" y="2734789"/>
              <a:ext cx="33974" cy="45818"/>
            </a:xfrm>
            <a:custGeom>
              <a:avLst/>
              <a:gdLst/>
              <a:ahLst/>
              <a:cxnLst/>
              <a:rect l="l" t="t" r="r" b="b"/>
              <a:pathLst>
                <a:path w="436" h="588" extrusionOk="0">
                  <a:moveTo>
                    <a:pt x="262" y="1"/>
                  </a:moveTo>
                  <a:lnTo>
                    <a:pt x="1" y="588"/>
                  </a:lnTo>
                  <a:lnTo>
                    <a:pt x="1" y="588"/>
                  </a:lnTo>
                  <a:lnTo>
                    <a:pt x="436" y="153"/>
                  </a:lnTo>
                  <a:lnTo>
                    <a:pt x="262" y="1"/>
                  </a:lnTo>
                  <a:close/>
                </a:path>
              </a:pathLst>
            </a:custGeom>
            <a:solidFill>
              <a:srgbClr val="B8D1FF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99" name="Google Shape;99;p6"/>
            <p:cNvSpPr/>
            <p:nvPr/>
          </p:nvSpPr>
          <p:spPr>
            <a:xfrm>
              <a:off x="-21287" y="3440056"/>
              <a:ext cx="413768" cy="62026"/>
            </a:xfrm>
            <a:custGeom>
              <a:avLst/>
              <a:gdLst/>
              <a:ahLst/>
              <a:cxnLst/>
              <a:rect l="l" t="t" r="r" b="b"/>
              <a:pathLst>
                <a:path w="5310" h="796" extrusionOk="0">
                  <a:moveTo>
                    <a:pt x="152" y="1"/>
                  </a:moveTo>
                  <a:lnTo>
                    <a:pt x="0" y="523"/>
                  </a:lnTo>
                  <a:cubicBezTo>
                    <a:pt x="0" y="523"/>
                    <a:pt x="849" y="654"/>
                    <a:pt x="2328" y="741"/>
                  </a:cubicBezTo>
                  <a:cubicBezTo>
                    <a:pt x="3090" y="784"/>
                    <a:pt x="3835" y="795"/>
                    <a:pt x="4390" y="795"/>
                  </a:cubicBezTo>
                  <a:cubicBezTo>
                    <a:pt x="4945" y="795"/>
                    <a:pt x="5309" y="784"/>
                    <a:pt x="5309" y="784"/>
                  </a:cubicBezTo>
                  <a:lnTo>
                    <a:pt x="5309" y="240"/>
                  </a:lnTo>
                  <a:cubicBezTo>
                    <a:pt x="5309" y="240"/>
                    <a:pt x="4439" y="197"/>
                    <a:pt x="3003" y="153"/>
                  </a:cubicBezTo>
                  <a:cubicBezTo>
                    <a:pt x="1588" y="88"/>
                    <a:pt x="152" y="1"/>
                    <a:pt x="152" y="1"/>
                  </a:cubicBezTo>
                  <a:close/>
                </a:path>
              </a:pathLst>
            </a:custGeom>
            <a:solidFill>
              <a:schemeClr val="accent1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100" name="Google Shape;100;p6"/>
            <p:cNvSpPr/>
            <p:nvPr/>
          </p:nvSpPr>
          <p:spPr>
            <a:xfrm>
              <a:off x="339794" y="3457043"/>
              <a:ext cx="50961" cy="50961"/>
            </a:xfrm>
            <a:custGeom>
              <a:avLst/>
              <a:gdLst/>
              <a:ahLst/>
              <a:cxnLst/>
              <a:rect l="l" t="t" r="r" b="b"/>
              <a:pathLst>
                <a:path w="654" h="654" extrusionOk="0">
                  <a:moveTo>
                    <a:pt x="175" y="0"/>
                  </a:moveTo>
                  <a:cubicBezTo>
                    <a:pt x="66" y="0"/>
                    <a:pt x="1" y="88"/>
                    <a:pt x="1" y="175"/>
                  </a:cubicBezTo>
                  <a:lnTo>
                    <a:pt x="1" y="479"/>
                  </a:lnTo>
                  <a:cubicBezTo>
                    <a:pt x="1" y="566"/>
                    <a:pt x="66" y="653"/>
                    <a:pt x="175" y="653"/>
                  </a:cubicBezTo>
                  <a:lnTo>
                    <a:pt x="479" y="653"/>
                  </a:lnTo>
                  <a:cubicBezTo>
                    <a:pt x="588" y="653"/>
                    <a:pt x="653" y="566"/>
                    <a:pt x="653" y="479"/>
                  </a:cubicBezTo>
                  <a:lnTo>
                    <a:pt x="653" y="175"/>
                  </a:lnTo>
                  <a:cubicBezTo>
                    <a:pt x="653" y="88"/>
                    <a:pt x="588" y="0"/>
                    <a:pt x="479" y="0"/>
                  </a:cubicBezTo>
                  <a:close/>
                </a:path>
              </a:pathLst>
            </a:custGeom>
            <a:solidFill>
              <a:schemeClr val="accent2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101" name="Google Shape;101;p6"/>
            <p:cNvSpPr/>
            <p:nvPr/>
          </p:nvSpPr>
          <p:spPr>
            <a:xfrm>
              <a:off x="194005" y="2746633"/>
              <a:ext cx="71299" cy="45896"/>
            </a:xfrm>
            <a:custGeom>
              <a:avLst/>
              <a:gdLst/>
              <a:ahLst/>
              <a:cxnLst/>
              <a:rect l="l" t="t" r="r" b="b"/>
              <a:pathLst>
                <a:path w="915" h="589" extrusionOk="0">
                  <a:moveTo>
                    <a:pt x="914" y="1"/>
                  </a:moveTo>
                  <a:lnTo>
                    <a:pt x="0" y="110"/>
                  </a:lnTo>
                  <a:lnTo>
                    <a:pt x="457" y="588"/>
                  </a:lnTo>
                  <a:lnTo>
                    <a:pt x="849" y="523"/>
                  </a:lnTo>
                  <a:lnTo>
                    <a:pt x="914" y="1"/>
                  </a:lnTo>
                  <a:close/>
                </a:path>
              </a:pathLst>
            </a:custGeom>
            <a:solidFill>
              <a:schemeClr val="dk1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102" name="Google Shape;102;p6"/>
            <p:cNvSpPr/>
            <p:nvPr/>
          </p:nvSpPr>
          <p:spPr>
            <a:xfrm>
              <a:off x="229615" y="2787386"/>
              <a:ext cx="144157" cy="717199"/>
            </a:xfrm>
            <a:custGeom>
              <a:avLst/>
              <a:gdLst/>
              <a:ahLst/>
              <a:cxnLst/>
              <a:rect l="l" t="t" r="r" b="b"/>
              <a:pathLst>
                <a:path w="1850" h="9204" extrusionOk="0">
                  <a:moveTo>
                    <a:pt x="392" y="0"/>
                  </a:moveTo>
                  <a:lnTo>
                    <a:pt x="0" y="65"/>
                  </a:lnTo>
                  <a:cubicBezTo>
                    <a:pt x="0" y="65"/>
                    <a:pt x="610" y="3394"/>
                    <a:pt x="784" y="5004"/>
                  </a:cubicBezTo>
                  <a:cubicBezTo>
                    <a:pt x="979" y="6614"/>
                    <a:pt x="979" y="8703"/>
                    <a:pt x="979" y="8703"/>
                  </a:cubicBezTo>
                  <a:lnTo>
                    <a:pt x="1567" y="9204"/>
                  </a:lnTo>
                  <a:lnTo>
                    <a:pt x="1850" y="8747"/>
                  </a:lnTo>
                  <a:cubicBezTo>
                    <a:pt x="1850" y="8747"/>
                    <a:pt x="1632" y="7376"/>
                    <a:pt x="1349" y="4917"/>
                  </a:cubicBezTo>
                  <a:cubicBezTo>
                    <a:pt x="1045" y="2459"/>
                    <a:pt x="392" y="0"/>
                    <a:pt x="392" y="0"/>
                  </a:cubicBezTo>
                  <a:close/>
                </a:path>
              </a:pathLst>
            </a:custGeom>
            <a:solidFill>
              <a:schemeClr val="dk1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103" name="Google Shape;103;p6"/>
            <p:cNvSpPr/>
            <p:nvPr/>
          </p:nvSpPr>
          <p:spPr>
            <a:xfrm>
              <a:off x="36295" y="2648296"/>
              <a:ext cx="181559" cy="145949"/>
            </a:xfrm>
            <a:custGeom>
              <a:avLst/>
              <a:gdLst/>
              <a:ahLst/>
              <a:cxnLst/>
              <a:rect l="l" t="t" r="r" b="b"/>
              <a:pathLst>
                <a:path w="2330" h="1873" extrusionOk="0">
                  <a:moveTo>
                    <a:pt x="393" y="1"/>
                  </a:moveTo>
                  <a:lnTo>
                    <a:pt x="1" y="545"/>
                  </a:lnTo>
                  <a:lnTo>
                    <a:pt x="2024" y="1872"/>
                  </a:lnTo>
                  <a:lnTo>
                    <a:pt x="2329" y="1176"/>
                  </a:lnTo>
                  <a:lnTo>
                    <a:pt x="393" y="1"/>
                  </a:lnTo>
                  <a:close/>
                </a:path>
              </a:pathLst>
            </a:custGeom>
            <a:solidFill>
              <a:schemeClr val="dk2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104" name="Google Shape;104;p6"/>
            <p:cNvSpPr/>
            <p:nvPr/>
          </p:nvSpPr>
          <p:spPr>
            <a:xfrm>
              <a:off x="136345" y="2875515"/>
              <a:ext cx="351041" cy="507042"/>
            </a:xfrm>
            <a:custGeom>
              <a:avLst/>
              <a:gdLst/>
              <a:ahLst/>
              <a:cxnLst/>
              <a:rect l="l" t="t" r="r" b="b"/>
              <a:pathLst>
                <a:path w="4505" h="6507" extrusionOk="0">
                  <a:moveTo>
                    <a:pt x="4265" y="0"/>
                  </a:moveTo>
                  <a:lnTo>
                    <a:pt x="1" y="566"/>
                  </a:lnTo>
                  <a:lnTo>
                    <a:pt x="262" y="6506"/>
                  </a:lnTo>
                  <a:lnTo>
                    <a:pt x="4505" y="5832"/>
                  </a:lnTo>
                  <a:lnTo>
                    <a:pt x="4265" y="0"/>
                  </a:lnTo>
                  <a:close/>
                </a:path>
              </a:pathLst>
            </a:custGeom>
            <a:solidFill>
              <a:schemeClr val="accent1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105" name="Google Shape;105;p6"/>
            <p:cNvSpPr/>
            <p:nvPr/>
          </p:nvSpPr>
          <p:spPr>
            <a:xfrm>
              <a:off x="246523" y="2704244"/>
              <a:ext cx="34052" cy="67948"/>
            </a:xfrm>
            <a:custGeom>
              <a:avLst/>
              <a:gdLst/>
              <a:ahLst/>
              <a:cxnLst/>
              <a:rect l="l" t="t" r="r" b="b"/>
              <a:pathLst>
                <a:path w="437" h="872" extrusionOk="0">
                  <a:moveTo>
                    <a:pt x="23" y="1"/>
                  </a:moveTo>
                  <a:lnTo>
                    <a:pt x="1" y="393"/>
                  </a:lnTo>
                  <a:lnTo>
                    <a:pt x="371" y="871"/>
                  </a:lnTo>
                  <a:lnTo>
                    <a:pt x="436" y="305"/>
                  </a:lnTo>
                  <a:lnTo>
                    <a:pt x="23" y="1"/>
                  </a:lnTo>
                  <a:close/>
                </a:path>
              </a:pathLst>
            </a:custGeom>
            <a:solidFill>
              <a:schemeClr val="dk2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106" name="Google Shape;106;p6"/>
            <p:cNvSpPr/>
            <p:nvPr/>
          </p:nvSpPr>
          <p:spPr>
            <a:xfrm>
              <a:off x="-133180" y="3036579"/>
              <a:ext cx="498470" cy="250365"/>
            </a:xfrm>
            <a:custGeom>
              <a:avLst/>
              <a:gdLst/>
              <a:ahLst/>
              <a:cxnLst/>
              <a:rect l="l" t="t" r="r" b="b"/>
              <a:pathLst>
                <a:path w="6397" h="3213" extrusionOk="0">
                  <a:moveTo>
                    <a:pt x="6049" y="0"/>
                  </a:moveTo>
                  <a:cubicBezTo>
                    <a:pt x="6049" y="0"/>
                    <a:pt x="3568" y="305"/>
                    <a:pt x="1153" y="1175"/>
                  </a:cubicBezTo>
                  <a:cubicBezTo>
                    <a:pt x="914" y="1262"/>
                    <a:pt x="0" y="1850"/>
                    <a:pt x="239" y="2764"/>
                  </a:cubicBezTo>
                  <a:cubicBezTo>
                    <a:pt x="328" y="3093"/>
                    <a:pt x="627" y="3212"/>
                    <a:pt x="1013" y="3212"/>
                  </a:cubicBezTo>
                  <a:cubicBezTo>
                    <a:pt x="1672" y="3212"/>
                    <a:pt x="2585" y="2866"/>
                    <a:pt x="3133" y="2633"/>
                  </a:cubicBezTo>
                  <a:cubicBezTo>
                    <a:pt x="3982" y="2263"/>
                    <a:pt x="6397" y="958"/>
                    <a:pt x="6397" y="958"/>
                  </a:cubicBezTo>
                  <a:lnTo>
                    <a:pt x="6049" y="0"/>
                  </a:lnTo>
                  <a:close/>
                </a:path>
              </a:pathLst>
            </a:custGeom>
            <a:solidFill>
              <a:schemeClr val="dk2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107" name="Google Shape;107;p6"/>
            <p:cNvSpPr/>
            <p:nvPr/>
          </p:nvSpPr>
          <p:spPr>
            <a:xfrm>
              <a:off x="407584" y="3075228"/>
              <a:ext cx="84858" cy="36000"/>
            </a:xfrm>
            <a:custGeom>
              <a:avLst/>
              <a:gdLst/>
              <a:ahLst/>
              <a:cxnLst/>
              <a:rect l="l" t="t" r="r" b="b"/>
              <a:pathLst>
                <a:path w="1089" h="462" extrusionOk="0">
                  <a:moveTo>
                    <a:pt x="913" y="1"/>
                  </a:moveTo>
                  <a:cubicBezTo>
                    <a:pt x="900" y="1"/>
                    <a:pt x="886" y="2"/>
                    <a:pt x="871" y="5"/>
                  </a:cubicBezTo>
                  <a:lnTo>
                    <a:pt x="153" y="114"/>
                  </a:lnTo>
                  <a:cubicBezTo>
                    <a:pt x="66" y="135"/>
                    <a:pt x="1" y="222"/>
                    <a:pt x="23" y="310"/>
                  </a:cubicBezTo>
                  <a:cubicBezTo>
                    <a:pt x="44" y="397"/>
                    <a:pt x="131" y="462"/>
                    <a:pt x="219" y="462"/>
                  </a:cubicBezTo>
                  <a:lnTo>
                    <a:pt x="937" y="331"/>
                  </a:lnTo>
                  <a:cubicBezTo>
                    <a:pt x="1024" y="331"/>
                    <a:pt x="1089" y="244"/>
                    <a:pt x="1067" y="135"/>
                  </a:cubicBezTo>
                  <a:cubicBezTo>
                    <a:pt x="1067" y="60"/>
                    <a:pt x="1001" y="1"/>
                    <a:pt x="913" y="1"/>
                  </a:cubicBezTo>
                  <a:close/>
                </a:path>
              </a:pathLst>
            </a:custGeom>
            <a:solidFill>
              <a:srgbClr val="FFBD95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108" name="Google Shape;108;p6"/>
            <p:cNvSpPr/>
            <p:nvPr/>
          </p:nvSpPr>
          <p:spPr>
            <a:xfrm>
              <a:off x="405948" y="3050137"/>
              <a:ext cx="84858" cy="36000"/>
            </a:xfrm>
            <a:custGeom>
              <a:avLst/>
              <a:gdLst/>
              <a:ahLst/>
              <a:cxnLst/>
              <a:rect l="l" t="t" r="r" b="b"/>
              <a:pathLst>
                <a:path w="1089" h="462" extrusionOk="0">
                  <a:moveTo>
                    <a:pt x="871" y="1"/>
                  </a:moveTo>
                  <a:lnTo>
                    <a:pt x="152" y="131"/>
                  </a:lnTo>
                  <a:cubicBezTo>
                    <a:pt x="65" y="131"/>
                    <a:pt x="0" y="218"/>
                    <a:pt x="22" y="305"/>
                  </a:cubicBezTo>
                  <a:lnTo>
                    <a:pt x="22" y="327"/>
                  </a:lnTo>
                  <a:cubicBezTo>
                    <a:pt x="41" y="402"/>
                    <a:pt x="109" y="462"/>
                    <a:pt x="184" y="462"/>
                  </a:cubicBezTo>
                  <a:cubicBezTo>
                    <a:pt x="195" y="462"/>
                    <a:pt x="206" y="460"/>
                    <a:pt x="218" y="457"/>
                  </a:cubicBezTo>
                  <a:lnTo>
                    <a:pt x="936" y="349"/>
                  </a:lnTo>
                  <a:cubicBezTo>
                    <a:pt x="1023" y="327"/>
                    <a:pt x="1088" y="240"/>
                    <a:pt x="1066" y="153"/>
                  </a:cubicBezTo>
                  <a:cubicBezTo>
                    <a:pt x="1066" y="44"/>
                    <a:pt x="979" y="1"/>
                    <a:pt x="871" y="1"/>
                  </a:cubicBezTo>
                  <a:close/>
                </a:path>
              </a:pathLst>
            </a:custGeom>
            <a:solidFill>
              <a:srgbClr val="FFBD95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109" name="Google Shape;109;p6"/>
            <p:cNvSpPr/>
            <p:nvPr/>
          </p:nvSpPr>
          <p:spPr>
            <a:xfrm>
              <a:off x="404233" y="3026059"/>
              <a:ext cx="83143" cy="36000"/>
            </a:xfrm>
            <a:custGeom>
              <a:avLst/>
              <a:gdLst/>
              <a:ahLst/>
              <a:cxnLst/>
              <a:rect l="l" t="t" r="r" b="b"/>
              <a:pathLst>
                <a:path w="1067" h="462" extrusionOk="0">
                  <a:moveTo>
                    <a:pt x="905" y="1"/>
                  </a:moveTo>
                  <a:cubicBezTo>
                    <a:pt x="894" y="1"/>
                    <a:pt x="882" y="2"/>
                    <a:pt x="871" y="5"/>
                  </a:cubicBezTo>
                  <a:lnTo>
                    <a:pt x="153" y="114"/>
                  </a:lnTo>
                  <a:cubicBezTo>
                    <a:pt x="44" y="135"/>
                    <a:pt x="0" y="223"/>
                    <a:pt x="0" y="310"/>
                  </a:cubicBezTo>
                  <a:cubicBezTo>
                    <a:pt x="22" y="418"/>
                    <a:pt x="109" y="462"/>
                    <a:pt x="196" y="462"/>
                  </a:cubicBezTo>
                  <a:lnTo>
                    <a:pt x="914" y="331"/>
                  </a:lnTo>
                  <a:cubicBezTo>
                    <a:pt x="1001" y="331"/>
                    <a:pt x="1067" y="244"/>
                    <a:pt x="1067" y="135"/>
                  </a:cubicBezTo>
                  <a:cubicBezTo>
                    <a:pt x="1048" y="60"/>
                    <a:pt x="980" y="1"/>
                    <a:pt x="905" y="1"/>
                  </a:cubicBezTo>
                  <a:close/>
                </a:path>
              </a:pathLst>
            </a:custGeom>
            <a:solidFill>
              <a:srgbClr val="FFBD95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110" name="Google Shape;110;p6"/>
            <p:cNvSpPr/>
            <p:nvPr/>
          </p:nvSpPr>
          <p:spPr>
            <a:xfrm>
              <a:off x="399169" y="3004008"/>
              <a:ext cx="83143" cy="34676"/>
            </a:xfrm>
            <a:custGeom>
              <a:avLst/>
              <a:gdLst/>
              <a:ahLst/>
              <a:cxnLst/>
              <a:rect l="l" t="t" r="r" b="b"/>
              <a:pathLst>
                <a:path w="1067" h="445" extrusionOk="0">
                  <a:moveTo>
                    <a:pt x="905" y="1"/>
                  </a:moveTo>
                  <a:cubicBezTo>
                    <a:pt x="893" y="1"/>
                    <a:pt x="882" y="2"/>
                    <a:pt x="870" y="5"/>
                  </a:cubicBezTo>
                  <a:lnTo>
                    <a:pt x="152" y="114"/>
                  </a:lnTo>
                  <a:cubicBezTo>
                    <a:pt x="44" y="114"/>
                    <a:pt x="0" y="223"/>
                    <a:pt x="0" y="310"/>
                  </a:cubicBezTo>
                  <a:cubicBezTo>
                    <a:pt x="19" y="385"/>
                    <a:pt x="87" y="444"/>
                    <a:pt x="162" y="444"/>
                  </a:cubicBezTo>
                  <a:cubicBezTo>
                    <a:pt x="173" y="444"/>
                    <a:pt x="185" y="443"/>
                    <a:pt x="196" y="440"/>
                  </a:cubicBezTo>
                  <a:lnTo>
                    <a:pt x="914" y="331"/>
                  </a:lnTo>
                  <a:cubicBezTo>
                    <a:pt x="1001" y="310"/>
                    <a:pt x="1066" y="223"/>
                    <a:pt x="1066" y="136"/>
                  </a:cubicBezTo>
                  <a:cubicBezTo>
                    <a:pt x="1047" y="60"/>
                    <a:pt x="979" y="1"/>
                    <a:pt x="905" y="1"/>
                  </a:cubicBezTo>
                  <a:close/>
                </a:path>
              </a:pathLst>
            </a:custGeom>
            <a:solidFill>
              <a:srgbClr val="FFBD95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111" name="Google Shape;111;p6"/>
            <p:cNvSpPr/>
            <p:nvPr/>
          </p:nvSpPr>
          <p:spPr>
            <a:xfrm>
              <a:off x="287276" y="3003228"/>
              <a:ext cx="193326" cy="127871"/>
            </a:xfrm>
            <a:custGeom>
              <a:avLst/>
              <a:gdLst/>
              <a:ahLst/>
              <a:cxnLst/>
              <a:rect l="l" t="t" r="r" b="b"/>
              <a:pathLst>
                <a:path w="2481" h="1641" extrusionOk="0">
                  <a:moveTo>
                    <a:pt x="1777" y="1"/>
                  </a:moveTo>
                  <a:cubicBezTo>
                    <a:pt x="1555" y="1"/>
                    <a:pt x="1334" y="9"/>
                    <a:pt x="1240" y="37"/>
                  </a:cubicBezTo>
                  <a:cubicBezTo>
                    <a:pt x="1001" y="124"/>
                    <a:pt x="0" y="777"/>
                    <a:pt x="0" y="777"/>
                  </a:cubicBezTo>
                  <a:lnTo>
                    <a:pt x="653" y="1603"/>
                  </a:lnTo>
                  <a:cubicBezTo>
                    <a:pt x="653" y="1603"/>
                    <a:pt x="861" y="1640"/>
                    <a:pt x="1121" y="1640"/>
                  </a:cubicBezTo>
                  <a:cubicBezTo>
                    <a:pt x="1208" y="1640"/>
                    <a:pt x="1300" y="1636"/>
                    <a:pt x="1393" y="1625"/>
                  </a:cubicBezTo>
                  <a:cubicBezTo>
                    <a:pt x="1763" y="1582"/>
                    <a:pt x="2481" y="1255"/>
                    <a:pt x="2481" y="1255"/>
                  </a:cubicBezTo>
                  <a:cubicBezTo>
                    <a:pt x="2481" y="1255"/>
                    <a:pt x="2263" y="755"/>
                    <a:pt x="2219" y="559"/>
                  </a:cubicBezTo>
                  <a:cubicBezTo>
                    <a:pt x="2154" y="363"/>
                    <a:pt x="2372" y="15"/>
                    <a:pt x="2372" y="15"/>
                  </a:cubicBezTo>
                  <a:cubicBezTo>
                    <a:pt x="2372" y="15"/>
                    <a:pt x="2073" y="1"/>
                    <a:pt x="1777" y="1"/>
                  </a:cubicBezTo>
                  <a:close/>
                </a:path>
              </a:pathLst>
            </a:custGeom>
            <a:solidFill>
              <a:srgbClr val="FFBD95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112" name="Google Shape;112;p6"/>
            <p:cNvSpPr/>
            <p:nvPr/>
          </p:nvSpPr>
          <p:spPr>
            <a:xfrm>
              <a:off x="261796" y="3024735"/>
              <a:ext cx="103481" cy="127247"/>
            </a:xfrm>
            <a:custGeom>
              <a:avLst/>
              <a:gdLst/>
              <a:ahLst/>
              <a:cxnLst/>
              <a:rect l="l" t="t" r="r" b="b"/>
              <a:pathLst>
                <a:path w="1328" h="1633" extrusionOk="0">
                  <a:moveTo>
                    <a:pt x="871" y="0"/>
                  </a:moveTo>
                  <a:lnTo>
                    <a:pt x="1" y="283"/>
                  </a:lnTo>
                  <a:lnTo>
                    <a:pt x="436" y="1632"/>
                  </a:lnTo>
                  <a:lnTo>
                    <a:pt x="1328" y="1327"/>
                  </a:lnTo>
                  <a:lnTo>
                    <a:pt x="871" y="0"/>
                  </a:lnTo>
                  <a:close/>
                </a:path>
              </a:pathLst>
            </a:custGeom>
            <a:solidFill>
              <a:schemeClr val="dk2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113" name="Google Shape;113;p6"/>
            <p:cNvSpPr/>
            <p:nvPr/>
          </p:nvSpPr>
          <p:spPr>
            <a:xfrm>
              <a:off x="263510" y="3116526"/>
              <a:ext cx="371379" cy="233767"/>
            </a:xfrm>
            <a:custGeom>
              <a:avLst/>
              <a:gdLst/>
              <a:ahLst/>
              <a:cxnLst/>
              <a:rect l="l" t="t" r="r" b="b"/>
              <a:pathLst>
                <a:path w="4766" h="3000" extrusionOk="0">
                  <a:moveTo>
                    <a:pt x="3897" y="0"/>
                  </a:moveTo>
                  <a:cubicBezTo>
                    <a:pt x="3372" y="0"/>
                    <a:pt x="2639" y="458"/>
                    <a:pt x="2155" y="737"/>
                  </a:cubicBezTo>
                  <a:cubicBezTo>
                    <a:pt x="1437" y="1150"/>
                    <a:pt x="0" y="2086"/>
                    <a:pt x="0" y="2086"/>
                  </a:cubicBezTo>
                  <a:lnTo>
                    <a:pt x="392" y="3000"/>
                  </a:lnTo>
                  <a:cubicBezTo>
                    <a:pt x="392" y="3000"/>
                    <a:pt x="2611" y="2565"/>
                    <a:pt x="3830" y="2021"/>
                  </a:cubicBezTo>
                  <a:cubicBezTo>
                    <a:pt x="4026" y="1912"/>
                    <a:pt x="4766" y="1281"/>
                    <a:pt x="4461" y="389"/>
                  </a:cubicBezTo>
                  <a:cubicBezTo>
                    <a:pt x="4355" y="106"/>
                    <a:pt x="4150" y="0"/>
                    <a:pt x="3897" y="0"/>
                  </a:cubicBezTo>
                  <a:close/>
                </a:path>
              </a:pathLst>
            </a:custGeom>
            <a:solidFill>
              <a:schemeClr val="dk2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114" name="Google Shape;114;p6"/>
            <p:cNvSpPr/>
            <p:nvPr/>
          </p:nvSpPr>
          <p:spPr>
            <a:xfrm>
              <a:off x="139773" y="3357381"/>
              <a:ext cx="81429" cy="48546"/>
            </a:xfrm>
            <a:custGeom>
              <a:avLst/>
              <a:gdLst/>
              <a:ahLst/>
              <a:cxnLst/>
              <a:rect l="l" t="t" r="r" b="b"/>
              <a:pathLst>
                <a:path w="1045" h="623" extrusionOk="0">
                  <a:moveTo>
                    <a:pt x="856" y="0"/>
                  </a:moveTo>
                  <a:cubicBezTo>
                    <a:pt x="832" y="0"/>
                    <a:pt x="807" y="6"/>
                    <a:pt x="783" y="18"/>
                  </a:cubicBezTo>
                  <a:lnTo>
                    <a:pt x="109" y="300"/>
                  </a:lnTo>
                  <a:cubicBezTo>
                    <a:pt x="44" y="344"/>
                    <a:pt x="0" y="431"/>
                    <a:pt x="22" y="518"/>
                  </a:cubicBezTo>
                  <a:cubicBezTo>
                    <a:pt x="54" y="582"/>
                    <a:pt x="121" y="622"/>
                    <a:pt x="188" y="622"/>
                  </a:cubicBezTo>
                  <a:cubicBezTo>
                    <a:pt x="213" y="622"/>
                    <a:pt x="238" y="617"/>
                    <a:pt x="261" y="605"/>
                  </a:cubicBezTo>
                  <a:lnTo>
                    <a:pt x="914" y="322"/>
                  </a:lnTo>
                  <a:cubicBezTo>
                    <a:pt x="1001" y="279"/>
                    <a:pt x="1045" y="192"/>
                    <a:pt x="1001" y="105"/>
                  </a:cubicBezTo>
                  <a:cubicBezTo>
                    <a:pt x="985" y="41"/>
                    <a:pt x="923" y="0"/>
                    <a:pt x="856" y="0"/>
                  </a:cubicBezTo>
                  <a:close/>
                </a:path>
              </a:pathLst>
            </a:custGeom>
            <a:solidFill>
              <a:srgbClr val="FFA47C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115" name="Google Shape;115;p6"/>
            <p:cNvSpPr/>
            <p:nvPr/>
          </p:nvSpPr>
          <p:spPr>
            <a:xfrm>
              <a:off x="127851" y="3335329"/>
              <a:ext cx="81507" cy="49481"/>
            </a:xfrm>
            <a:custGeom>
              <a:avLst/>
              <a:gdLst/>
              <a:ahLst/>
              <a:cxnLst/>
              <a:rect l="l" t="t" r="r" b="b"/>
              <a:pathLst>
                <a:path w="1046" h="635" extrusionOk="0">
                  <a:moveTo>
                    <a:pt x="853" y="1"/>
                  </a:moveTo>
                  <a:cubicBezTo>
                    <a:pt x="831" y="1"/>
                    <a:pt x="807" y="6"/>
                    <a:pt x="784" y="18"/>
                  </a:cubicBezTo>
                  <a:lnTo>
                    <a:pt x="110" y="301"/>
                  </a:lnTo>
                  <a:cubicBezTo>
                    <a:pt x="23" y="344"/>
                    <a:pt x="1" y="453"/>
                    <a:pt x="23" y="540"/>
                  </a:cubicBezTo>
                  <a:cubicBezTo>
                    <a:pt x="56" y="606"/>
                    <a:pt x="127" y="635"/>
                    <a:pt x="198" y="635"/>
                  </a:cubicBezTo>
                  <a:cubicBezTo>
                    <a:pt x="220" y="635"/>
                    <a:pt x="241" y="632"/>
                    <a:pt x="262" y="627"/>
                  </a:cubicBezTo>
                  <a:lnTo>
                    <a:pt x="915" y="322"/>
                  </a:lnTo>
                  <a:cubicBezTo>
                    <a:pt x="1002" y="301"/>
                    <a:pt x="1045" y="192"/>
                    <a:pt x="1002" y="105"/>
                  </a:cubicBezTo>
                  <a:cubicBezTo>
                    <a:pt x="970" y="41"/>
                    <a:pt x="915" y="1"/>
                    <a:pt x="853" y="1"/>
                  </a:cubicBezTo>
                  <a:close/>
                </a:path>
              </a:pathLst>
            </a:custGeom>
            <a:solidFill>
              <a:srgbClr val="FFA47C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116" name="Google Shape;116;p6"/>
            <p:cNvSpPr/>
            <p:nvPr/>
          </p:nvSpPr>
          <p:spPr>
            <a:xfrm>
              <a:off x="116008" y="3313278"/>
              <a:ext cx="83143" cy="50260"/>
            </a:xfrm>
            <a:custGeom>
              <a:avLst/>
              <a:gdLst/>
              <a:ahLst/>
              <a:cxnLst/>
              <a:rect l="l" t="t" r="r" b="b"/>
              <a:pathLst>
                <a:path w="1067" h="645" extrusionOk="0">
                  <a:moveTo>
                    <a:pt x="875" y="1"/>
                  </a:moveTo>
                  <a:cubicBezTo>
                    <a:pt x="852" y="1"/>
                    <a:pt x="829" y="6"/>
                    <a:pt x="806" y="18"/>
                  </a:cubicBezTo>
                  <a:lnTo>
                    <a:pt x="131" y="301"/>
                  </a:lnTo>
                  <a:cubicBezTo>
                    <a:pt x="44" y="344"/>
                    <a:pt x="1" y="453"/>
                    <a:pt x="44" y="540"/>
                  </a:cubicBezTo>
                  <a:cubicBezTo>
                    <a:pt x="76" y="604"/>
                    <a:pt x="143" y="644"/>
                    <a:pt x="202" y="644"/>
                  </a:cubicBezTo>
                  <a:cubicBezTo>
                    <a:pt x="224" y="644"/>
                    <a:pt x="244" y="639"/>
                    <a:pt x="262" y="627"/>
                  </a:cubicBezTo>
                  <a:lnTo>
                    <a:pt x="936" y="322"/>
                  </a:lnTo>
                  <a:cubicBezTo>
                    <a:pt x="1023" y="301"/>
                    <a:pt x="1067" y="192"/>
                    <a:pt x="1023" y="105"/>
                  </a:cubicBezTo>
                  <a:cubicBezTo>
                    <a:pt x="991" y="41"/>
                    <a:pt x="936" y="1"/>
                    <a:pt x="875" y="1"/>
                  </a:cubicBezTo>
                  <a:close/>
                </a:path>
              </a:pathLst>
            </a:custGeom>
            <a:solidFill>
              <a:srgbClr val="FFA47C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117" name="Google Shape;117;p6"/>
            <p:cNvSpPr/>
            <p:nvPr/>
          </p:nvSpPr>
          <p:spPr>
            <a:xfrm>
              <a:off x="109229" y="3291226"/>
              <a:ext cx="81429" cy="50260"/>
            </a:xfrm>
            <a:custGeom>
              <a:avLst/>
              <a:gdLst/>
              <a:ahLst/>
              <a:cxnLst/>
              <a:rect l="l" t="t" r="r" b="b"/>
              <a:pathLst>
                <a:path w="1045" h="645" extrusionOk="0">
                  <a:moveTo>
                    <a:pt x="853" y="1"/>
                  </a:moveTo>
                  <a:cubicBezTo>
                    <a:pt x="830" y="1"/>
                    <a:pt x="807" y="6"/>
                    <a:pt x="784" y="18"/>
                  </a:cubicBezTo>
                  <a:lnTo>
                    <a:pt x="109" y="301"/>
                  </a:lnTo>
                  <a:cubicBezTo>
                    <a:pt x="22" y="344"/>
                    <a:pt x="1" y="453"/>
                    <a:pt x="22" y="540"/>
                  </a:cubicBezTo>
                  <a:cubicBezTo>
                    <a:pt x="54" y="604"/>
                    <a:pt x="121" y="644"/>
                    <a:pt x="189" y="644"/>
                  </a:cubicBezTo>
                  <a:cubicBezTo>
                    <a:pt x="213" y="644"/>
                    <a:pt x="238" y="639"/>
                    <a:pt x="262" y="627"/>
                  </a:cubicBezTo>
                  <a:lnTo>
                    <a:pt x="914" y="323"/>
                  </a:lnTo>
                  <a:cubicBezTo>
                    <a:pt x="1001" y="301"/>
                    <a:pt x="1045" y="192"/>
                    <a:pt x="1001" y="105"/>
                  </a:cubicBezTo>
                  <a:cubicBezTo>
                    <a:pt x="970" y="41"/>
                    <a:pt x="914" y="1"/>
                    <a:pt x="853" y="1"/>
                  </a:cubicBezTo>
                  <a:close/>
                </a:path>
              </a:pathLst>
            </a:custGeom>
            <a:solidFill>
              <a:srgbClr val="FFA47C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118" name="Google Shape;118;p6"/>
            <p:cNvSpPr/>
            <p:nvPr/>
          </p:nvSpPr>
          <p:spPr>
            <a:xfrm>
              <a:off x="114293" y="3268629"/>
              <a:ext cx="186624" cy="135897"/>
            </a:xfrm>
            <a:custGeom>
              <a:avLst/>
              <a:gdLst/>
              <a:ahLst/>
              <a:cxnLst/>
              <a:rect l="l" t="t" r="r" b="b"/>
              <a:pathLst>
                <a:path w="2395" h="1744" extrusionOk="0">
                  <a:moveTo>
                    <a:pt x="2076" y="1"/>
                  </a:moveTo>
                  <a:cubicBezTo>
                    <a:pt x="1705" y="1"/>
                    <a:pt x="1125" y="11"/>
                    <a:pt x="980" y="69"/>
                  </a:cubicBezTo>
                  <a:cubicBezTo>
                    <a:pt x="741" y="134"/>
                    <a:pt x="1" y="656"/>
                    <a:pt x="1" y="656"/>
                  </a:cubicBezTo>
                  <a:cubicBezTo>
                    <a:pt x="1" y="656"/>
                    <a:pt x="371" y="808"/>
                    <a:pt x="436" y="1026"/>
                  </a:cubicBezTo>
                  <a:cubicBezTo>
                    <a:pt x="479" y="1222"/>
                    <a:pt x="588" y="1744"/>
                    <a:pt x="588" y="1744"/>
                  </a:cubicBezTo>
                  <a:cubicBezTo>
                    <a:pt x="588" y="1744"/>
                    <a:pt x="1372" y="1635"/>
                    <a:pt x="1698" y="1461"/>
                  </a:cubicBezTo>
                  <a:cubicBezTo>
                    <a:pt x="2024" y="1287"/>
                    <a:pt x="2307" y="1048"/>
                    <a:pt x="2307" y="1048"/>
                  </a:cubicBezTo>
                  <a:lnTo>
                    <a:pt x="2394" y="3"/>
                  </a:lnTo>
                  <a:cubicBezTo>
                    <a:pt x="2394" y="3"/>
                    <a:pt x="2261" y="1"/>
                    <a:pt x="2076" y="1"/>
                  </a:cubicBezTo>
                  <a:close/>
                </a:path>
              </a:pathLst>
            </a:custGeom>
            <a:solidFill>
              <a:srgbClr val="FFA47C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119" name="Google Shape;119;p6"/>
            <p:cNvSpPr/>
            <p:nvPr/>
          </p:nvSpPr>
          <p:spPr>
            <a:xfrm>
              <a:off x="239744" y="3240032"/>
              <a:ext cx="105195" cy="127247"/>
            </a:xfrm>
            <a:custGeom>
              <a:avLst/>
              <a:gdLst/>
              <a:ahLst/>
              <a:cxnLst/>
              <a:rect l="l" t="t" r="r" b="b"/>
              <a:pathLst>
                <a:path w="1350" h="1633" extrusionOk="0">
                  <a:moveTo>
                    <a:pt x="893" y="0"/>
                  </a:moveTo>
                  <a:lnTo>
                    <a:pt x="1" y="305"/>
                  </a:lnTo>
                  <a:lnTo>
                    <a:pt x="458" y="1632"/>
                  </a:lnTo>
                  <a:lnTo>
                    <a:pt x="1350" y="1328"/>
                  </a:lnTo>
                  <a:lnTo>
                    <a:pt x="893" y="0"/>
                  </a:lnTo>
                  <a:close/>
                </a:path>
              </a:pathLst>
            </a:custGeom>
            <a:solidFill>
              <a:schemeClr val="dk2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</p:grpSp>
    </p:spTree>
    <p:extLst>
      <p:ext uri="{BB962C8B-B14F-4D97-AF65-F5344CB8AC3E}">
        <p14:creationId xmlns:p14="http://schemas.microsoft.com/office/powerpoint/2010/main" val="14632359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 column text">
    <p:spTree>
      <p:nvGrpSpPr>
        <p:cNvPr id="1" name="Shape 1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Google Shape;121;p7"/>
          <p:cNvSpPr txBox="1">
            <a:spLocks noGrp="1"/>
          </p:cNvSpPr>
          <p:nvPr>
            <p:ph type="title"/>
          </p:nvPr>
        </p:nvSpPr>
        <p:spPr>
          <a:xfrm>
            <a:off x="713225" y="1470300"/>
            <a:ext cx="3636000" cy="7636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1pPr>
            <a:lvl2pPr lvl="1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9pPr>
          </a:lstStyle>
          <a:p>
            <a:endParaRPr/>
          </a:p>
        </p:txBody>
      </p:sp>
      <p:sp>
        <p:nvSpPr>
          <p:cNvPr id="122" name="Google Shape;122;p7"/>
          <p:cNvSpPr txBox="1">
            <a:spLocks noGrp="1"/>
          </p:cNvSpPr>
          <p:nvPr>
            <p:ph type="subTitle" idx="1"/>
          </p:nvPr>
        </p:nvSpPr>
        <p:spPr>
          <a:xfrm>
            <a:off x="713225" y="2233900"/>
            <a:ext cx="3636000" cy="23840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200"/>
              <a:buFont typeface="Nunito Light"/>
              <a:buChar char="●"/>
              <a:defRPr/>
            </a:lvl1pPr>
            <a:lvl2pPr lvl="1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E76A28"/>
              </a:buClr>
              <a:buSzPts val="1200"/>
              <a:buFont typeface="Nunito Light"/>
              <a:buChar char="○"/>
              <a:defRPr/>
            </a:lvl2pPr>
            <a:lvl3pPr lvl="2" algn="ctr" rtl="0">
              <a:lnSpc>
                <a:spcPct val="100000"/>
              </a:lnSpc>
              <a:spcBef>
                <a:spcPts val="1600"/>
              </a:spcBef>
              <a:spcAft>
                <a:spcPts val="0"/>
              </a:spcAft>
              <a:buClr>
                <a:srgbClr val="E76A28"/>
              </a:buClr>
              <a:buSzPts val="1200"/>
              <a:buFont typeface="Nunito Light"/>
              <a:buChar char="■"/>
              <a:defRPr/>
            </a:lvl3pPr>
            <a:lvl4pPr lvl="3" algn="ctr" rtl="0">
              <a:lnSpc>
                <a:spcPct val="100000"/>
              </a:lnSpc>
              <a:spcBef>
                <a:spcPts val="1600"/>
              </a:spcBef>
              <a:spcAft>
                <a:spcPts val="0"/>
              </a:spcAft>
              <a:buClr>
                <a:srgbClr val="E76A28"/>
              </a:buClr>
              <a:buSzPts val="1200"/>
              <a:buFont typeface="Nunito Light"/>
              <a:buChar char="●"/>
              <a:defRPr/>
            </a:lvl4pPr>
            <a:lvl5pPr lvl="4" algn="ctr" rtl="0">
              <a:lnSpc>
                <a:spcPct val="100000"/>
              </a:lnSpc>
              <a:spcBef>
                <a:spcPts val="1600"/>
              </a:spcBef>
              <a:spcAft>
                <a:spcPts val="0"/>
              </a:spcAft>
              <a:buClr>
                <a:srgbClr val="E76A28"/>
              </a:buClr>
              <a:buSzPts val="1200"/>
              <a:buFont typeface="Nunito Light"/>
              <a:buChar char="○"/>
              <a:defRPr/>
            </a:lvl5pPr>
            <a:lvl6pPr lvl="5" algn="ctr" rtl="0">
              <a:lnSpc>
                <a:spcPct val="100000"/>
              </a:lnSpc>
              <a:spcBef>
                <a:spcPts val="1600"/>
              </a:spcBef>
              <a:spcAft>
                <a:spcPts val="0"/>
              </a:spcAft>
              <a:buClr>
                <a:srgbClr val="999999"/>
              </a:buClr>
              <a:buSzPts val="1200"/>
              <a:buFont typeface="Nunito Light"/>
              <a:buChar char="■"/>
              <a:defRPr/>
            </a:lvl6pPr>
            <a:lvl7pPr lvl="6" algn="ctr" rtl="0">
              <a:lnSpc>
                <a:spcPct val="100000"/>
              </a:lnSpc>
              <a:spcBef>
                <a:spcPts val="1600"/>
              </a:spcBef>
              <a:spcAft>
                <a:spcPts val="0"/>
              </a:spcAft>
              <a:buClr>
                <a:srgbClr val="999999"/>
              </a:buClr>
              <a:buSzPts val="1200"/>
              <a:buFont typeface="Nunito Light"/>
              <a:buChar char="●"/>
              <a:defRPr/>
            </a:lvl7pPr>
            <a:lvl8pPr lvl="7" algn="ctr" rtl="0">
              <a:lnSpc>
                <a:spcPct val="100000"/>
              </a:lnSpc>
              <a:spcBef>
                <a:spcPts val="1600"/>
              </a:spcBef>
              <a:spcAft>
                <a:spcPts val="0"/>
              </a:spcAft>
              <a:buClr>
                <a:srgbClr val="999999"/>
              </a:buClr>
              <a:buSzPts val="1200"/>
              <a:buFont typeface="Nunito Light"/>
              <a:buChar char="○"/>
              <a:defRPr/>
            </a:lvl8pPr>
            <a:lvl9pPr lvl="8" algn="ctr" rtl="0">
              <a:lnSpc>
                <a:spcPct val="100000"/>
              </a:lnSpc>
              <a:spcBef>
                <a:spcPts val="1600"/>
              </a:spcBef>
              <a:spcAft>
                <a:spcPts val="1600"/>
              </a:spcAft>
              <a:buClr>
                <a:srgbClr val="999999"/>
              </a:buClr>
              <a:buSzPts val="1200"/>
              <a:buFont typeface="Nunito Light"/>
              <a:buChar char="■"/>
              <a:defRPr/>
            </a:lvl9pPr>
          </a:lstStyle>
          <a:p>
            <a:endParaRPr/>
          </a:p>
        </p:txBody>
      </p:sp>
      <p:sp>
        <p:nvSpPr>
          <p:cNvPr id="123" name="Google Shape;123;p7"/>
          <p:cNvSpPr>
            <a:spLocks noGrp="1"/>
          </p:cNvSpPr>
          <p:nvPr>
            <p:ph type="pic" idx="2"/>
          </p:nvPr>
        </p:nvSpPr>
        <p:spPr>
          <a:xfrm>
            <a:off x="4571975" y="497900"/>
            <a:ext cx="3858900" cy="5862400"/>
          </a:xfrm>
          <a:prstGeom prst="rect">
            <a:avLst/>
          </a:prstGeom>
          <a:noFill/>
          <a:ln>
            <a:noFill/>
          </a:ln>
        </p:spPr>
      </p:sp>
      <p:sp>
        <p:nvSpPr>
          <p:cNvPr id="124" name="Google Shape;124;p7"/>
          <p:cNvSpPr/>
          <p:nvPr/>
        </p:nvSpPr>
        <p:spPr>
          <a:xfrm>
            <a:off x="-25" y="6127167"/>
            <a:ext cx="9144017" cy="787955"/>
          </a:xfrm>
          <a:custGeom>
            <a:avLst/>
            <a:gdLst/>
            <a:ahLst/>
            <a:cxnLst/>
            <a:rect l="l" t="t" r="r" b="b"/>
            <a:pathLst>
              <a:path w="81572" h="31202" extrusionOk="0">
                <a:moveTo>
                  <a:pt x="0" y="0"/>
                </a:moveTo>
                <a:lnTo>
                  <a:pt x="0" y="31201"/>
                </a:lnTo>
                <a:lnTo>
                  <a:pt x="81572" y="31201"/>
                </a:lnTo>
                <a:lnTo>
                  <a:pt x="81572" y="0"/>
                </a:lnTo>
                <a:close/>
              </a:path>
            </a:pathLst>
          </a:custGeom>
          <a:solidFill>
            <a:schemeClr val="dk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/>
          </a:p>
        </p:txBody>
      </p:sp>
    </p:spTree>
    <p:extLst>
      <p:ext uri="{BB962C8B-B14F-4D97-AF65-F5344CB8AC3E}">
        <p14:creationId xmlns:p14="http://schemas.microsoft.com/office/powerpoint/2010/main" val="29363733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 point">
    <p:spTree>
      <p:nvGrpSpPr>
        <p:cNvPr id="1" name="Shape 1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Google Shape;126;p8"/>
          <p:cNvSpPr txBox="1">
            <a:spLocks noGrp="1"/>
          </p:cNvSpPr>
          <p:nvPr>
            <p:ph type="title"/>
          </p:nvPr>
        </p:nvSpPr>
        <p:spPr>
          <a:xfrm>
            <a:off x="2317950" y="1742800"/>
            <a:ext cx="4508100" cy="33724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 algn="ctr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100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32264895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 title and description">
    <p:spTree>
      <p:nvGrpSpPr>
        <p:cNvPr id="1" name="Shape 1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Google Shape;128;p9"/>
          <p:cNvSpPr txBox="1">
            <a:spLocks noGrp="1"/>
          </p:cNvSpPr>
          <p:nvPr>
            <p:ph type="title"/>
          </p:nvPr>
        </p:nvSpPr>
        <p:spPr>
          <a:xfrm>
            <a:off x="2135550" y="1585467"/>
            <a:ext cx="4872900" cy="26192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 algn="ctr" rtl="0">
              <a:spcBef>
                <a:spcPts val="0"/>
              </a:spcBef>
              <a:spcAft>
                <a:spcPts val="0"/>
              </a:spcAft>
              <a:buSzPts val="3500"/>
              <a:buNone/>
              <a:defRPr sz="15000"/>
            </a:lvl1pPr>
            <a:lvl2pPr lvl="1" algn="ctr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2pPr>
            <a:lvl3pPr lvl="2" algn="ctr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3pPr>
            <a:lvl4pPr lvl="3" algn="ctr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4pPr>
            <a:lvl5pPr lvl="4" algn="ctr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5pPr>
            <a:lvl6pPr lvl="5" algn="ctr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6pPr>
            <a:lvl7pPr lvl="6" algn="ctr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7pPr>
            <a:lvl8pPr lvl="7" algn="ctr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8pPr>
            <a:lvl9pPr lvl="8" algn="ctr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9pPr>
          </a:lstStyle>
          <a:p>
            <a:endParaRPr/>
          </a:p>
        </p:txBody>
      </p:sp>
      <p:sp>
        <p:nvSpPr>
          <p:cNvPr id="129" name="Google Shape;129;p9"/>
          <p:cNvSpPr txBox="1">
            <a:spLocks noGrp="1"/>
          </p:cNvSpPr>
          <p:nvPr>
            <p:ph type="subTitle" idx="1"/>
          </p:nvPr>
        </p:nvSpPr>
        <p:spPr>
          <a:xfrm>
            <a:off x="2135550" y="4204667"/>
            <a:ext cx="4872900" cy="89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"/>
              <a:buNone/>
              <a:defRPr sz="1600"/>
            </a:lvl1pPr>
            <a:lvl2pPr lvl="1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"/>
              <a:buNone/>
              <a:defRPr/>
            </a:lvl2pPr>
            <a:lvl3pPr lvl="2" algn="ctr" rtl="0">
              <a:lnSpc>
                <a:spcPct val="100000"/>
              </a:lnSpc>
              <a:spcBef>
                <a:spcPts val="1600"/>
              </a:spcBef>
              <a:spcAft>
                <a:spcPts val="0"/>
              </a:spcAft>
              <a:buSzPts val="1200"/>
              <a:buNone/>
              <a:defRPr/>
            </a:lvl3pPr>
            <a:lvl4pPr lvl="3" algn="ctr" rtl="0">
              <a:lnSpc>
                <a:spcPct val="100000"/>
              </a:lnSpc>
              <a:spcBef>
                <a:spcPts val="1600"/>
              </a:spcBef>
              <a:spcAft>
                <a:spcPts val="0"/>
              </a:spcAft>
              <a:buSzPts val="1200"/>
              <a:buNone/>
              <a:defRPr/>
            </a:lvl4pPr>
            <a:lvl5pPr lvl="4" algn="ctr" rtl="0">
              <a:lnSpc>
                <a:spcPct val="100000"/>
              </a:lnSpc>
              <a:spcBef>
                <a:spcPts val="1600"/>
              </a:spcBef>
              <a:spcAft>
                <a:spcPts val="0"/>
              </a:spcAft>
              <a:buSzPts val="1200"/>
              <a:buNone/>
              <a:defRPr/>
            </a:lvl5pPr>
            <a:lvl6pPr lvl="5" algn="ctr" rtl="0">
              <a:lnSpc>
                <a:spcPct val="100000"/>
              </a:lnSpc>
              <a:spcBef>
                <a:spcPts val="1600"/>
              </a:spcBef>
              <a:spcAft>
                <a:spcPts val="0"/>
              </a:spcAft>
              <a:buSzPts val="1200"/>
              <a:buNone/>
              <a:defRPr/>
            </a:lvl6pPr>
            <a:lvl7pPr lvl="6" algn="ctr" rtl="0">
              <a:lnSpc>
                <a:spcPct val="100000"/>
              </a:lnSpc>
              <a:spcBef>
                <a:spcPts val="1600"/>
              </a:spcBef>
              <a:spcAft>
                <a:spcPts val="0"/>
              </a:spcAft>
              <a:buSzPts val="1200"/>
              <a:buNone/>
              <a:defRPr/>
            </a:lvl7pPr>
            <a:lvl8pPr lvl="7" algn="ctr" rtl="0">
              <a:lnSpc>
                <a:spcPct val="100000"/>
              </a:lnSpc>
              <a:spcBef>
                <a:spcPts val="1600"/>
              </a:spcBef>
              <a:spcAft>
                <a:spcPts val="0"/>
              </a:spcAft>
              <a:buSzPts val="1200"/>
              <a:buNone/>
              <a:defRPr/>
            </a:lvl8pPr>
            <a:lvl9pPr lvl="8" algn="ctr" rtl="0">
              <a:lnSpc>
                <a:spcPct val="100000"/>
              </a:lnSpc>
              <a:spcBef>
                <a:spcPts val="1600"/>
              </a:spcBef>
              <a:spcAft>
                <a:spcPts val="1600"/>
              </a:spcAft>
              <a:buSzPts val="1200"/>
              <a:buNone/>
              <a:defRPr/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41606486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">
    <p:spTree>
      <p:nvGrpSpPr>
        <p:cNvPr id="1" name="Shape 1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Google Shape;131;p10"/>
          <p:cNvSpPr>
            <a:spLocks noGrp="1"/>
          </p:cNvSpPr>
          <p:nvPr>
            <p:ph type="pic" idx="2"/>
          </p:nvPr>
        </p:nvSpPr>
        <p:spPr>
          <a:xfrm>
            <a:off x="0" y="-9567"/>
            <a:ext cx="9144000" cy="6858000"/>
          </a:xfrm>
          <a:prstGeom prst="rect">
            <a:avLst/>
          </a:prstGeom>
          <a:noFill/>
          <a:ln>
            <a:noFill/>
          </a:ln>
        </p:spPr>
      </p:sp>
      <p:sp>
        <p:nvSpPr>
          <p:cNvPr id="132" name="Google Shape;132;p10"/>
          <p:cNvSpPr txBox="1">
            <a:spLocks noGrp="1"/>
          </p:cNvSpPr>
          <p:nvPr>
            <p:ph type="title"/>
          </p:nvPr>
        </p:nvSpPr>
        <p:spPr>
          <a:xfrm>
            <a:off x="720000" y="5352600"/>
            <a:ext cx="7704000" cy="763600"/>
          </a:xfrm>
          <a:prstGeom prst="rect">
            <a:avLst/>
          </a:prstGeom>
          <a:solidFill>
            <a:schemeClr val="lt1"/>
          </a:solidFill>
        </p:spPr>
        <p:txBody>
          <a:bodyPr spcFirstLastPara="1" wrap="square" lIns="91425" tIns="91425" rIns="91425" bIns="91425" anchor="ctr" anchorCtr="0">
            <a:noAutofit/>
          </a:bodyPr>
          <a:lstStyle>
            <a:lvl1pPr lvl="0" algn="ctr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1pPr>
            <a:lvl2pPr lvl="1" algn="ctr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2pPr>
            <a:lvl3pPr lvl="2" algn="ctr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3pPr>
            <a:lvl4pPr lvl="3" algn="ctr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4pPr>
            <a:lvl5pPr lvl="4" algn="ctr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5pPr>
            <a:lvl6pPr lvl="5" algn="ctr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6pPr>
            <a:lvl7pPr lvl="6" algn="ctr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7pPr>
            <a:lvl8pPr lvl="7" algn="ctr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8pPr>
            <a:lvl9pPr lvl="8" algn="ctr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30940838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 number">
    <p:spTree>
      <p:nvGrpSpPr>
        <p:cNvPr id="1" name="Shape 1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Google Shape;134;p11"/>
          <p:cNvSpPr txBox="1">
            <a:spLocks noGrp="1"/>
          </p:cNvSpPr>
          <p:nvPr>
            <p:ph type="title" hasCustomPrompt="1"/>
          </p:nvPr>
        </p:nvSpPr>
        <p:spPr>
          <a:xfrm>
            <a:off x="1283938" y="1077951"/>
            <a:ext cx="6576000" cy="14500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9600"/>
              <a:buNone/>
              <a:defRPr sz="6000"/>
            </a:lvl1pPr>
            <a:lvl2pPr lvl="1" algn="ctr">
              <a:spcBef>
                <a:spcPts val="0"/>
              </a:spcBef>
              <a:spcAft>
                <a:spcPts val="0"/>
              </a:spcAft>
              <a:buSzPts val="9600"/>
              <a:buNone/>
              <a:defRPr sz="9600"/>
            </a:lvl2pPr>
            <a:lvl3pPr lvl="2" algn="ctr">
              <a:spcBef>
                <a:spcPts val="0"/>
              </a:spcBef>
              <a:spcAft>
                <a:spcPts val="0"/>
              </a:spcAft>
              <a:buSzPts val="9600"/>
              <a:buNone/>
              <a:defRPr sz="9600"/>
            </a:lvl3pPr>
            <a:lvl4pPr lvl="3" algn="ctr">
              <a:spcBef>
                <a:spcPts val="0"/>
              </a:spcBef>
              <a:spcAft>
                <a:spcPts val="0"/>
              </a:spcAft>
              <a:buSzPts val="9600"/>
              <a:buNone/>
              <a:defRPr sz="9600"/>
            </a:lvl4pPr>
            <a:lvl5pPr lvl="4" algn="ctr">
              <a:spcBef>
                <a:spcPts val="0"/>
              </a:spcBef>
              <a:spcAft>
                <a:spcPts val="0"/>
              </a:spcAft>
              <a:buSzPts val="9600"/>
              <a:buNone/>
              <a:defRPr sz="9600"/>
            </a:lvl5pPr>
            <a:lvl6pPr lvl="5" algn="ctr">
              <a:spcBef>
                <a:spcPts val="0"/>
              </a:spcBef>
              <a:spcAft>
                <a:spcPts val="0"/>
              </a:spcAft>
              <a:buSzPts val="9600"/>
              <a:buNone/>
              <a:defRPr sz="9600"/>
            </a:lvl6pPr>
            <a:lvl7pPr lvl="6" algn="ctr">
              <a:spcBef>
                <a:spcPts val="0"/>
              </a:spcBef>
              <a:spcAft>
                <a:spcPts val="0"/>
              </a:spcAft>
              <a:buSzPts val="9600"/>
              <a:buNone/>
              <a:defRPr sz="9600"/>
            </a:lvl7pPr>
            <a:lvl8pPr lvl="7" algn="ctr">
              <a:spcBef>
                <a:spcPts val="0"/>
              </a:spcBef>
              <a:spcAft>
                <a:spcPts val="0"/>
              </a:spcAft>
              <a:buSzPts val="9600"/>
              <a:buNone/>
              <a:defRPr sz="9600"/>
            </a:lvl8pPr>
            <a:lvl9pPr lvl="8" algn="ctr">
              <a:spcBef>
                <a:spcPts val="0"/>
              </a:spcBef>
              <a:spcAft>
                <a:spcPts val="0"/>
              </a:spcAft>
              <a:buSzPts val="9600"/>
              <a:buNone/>
              <a:defRPr sz="9600"/>
            </a:lvl9pPr>
          </a:lstStyle>
          <a:p>
            <a:r>
              <a:t>xx%</a:t>
            </a:r>
          </a:p>
        </p:txBody>
      </p:sp>
      <p:sp>
        <p:nvSpPr>
          <p:cNvPr id="135" name="Google Shape;135;p11"/>
          <p:cNvSpPr txBox="1">
            <a:spLocks noGrp="1"/>
          </p:cNvSpPr>
          <p:nvPr>
            <p:ph type="subTitle" idx="1"/>
          </p:nvPr>
        </p:nvSpPr>
        <p:spPr>
          <a:xfrm>
            <a:off x="1283938" y="2527984"/>
            <a:ext cx="6576000" cy="662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None/>
              <a:defRPr sz="1900"/>
            </a:lvl1pPr>
            <a:lvl2pPr lvl="1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None/>
              <a:defRPr sz="1600"/>
            </a:lvl2pPr>
            <a:lvl3pPr lvl="2" algn="ctr" rtl="0">
              <a:lnSpc>
                <a:spcPct val="100000"/>
              </a:lnSpc>
              <a:spcBef>
                <a:spcPts val="1600"/>
              </a:spcBef>
              <a:spcAft>
                <a:spcPts val="0"/>
              </a:spcAft>
              <a:buSzPts val="1600"/>
              <a:buNone/>
              <a:defRPr sz="1600"/>
            </a:lvl3pPr>
            <a:lvl4pPr lvl="3" algn="ctr" rtl="0">
              <a:lnSpc>
                <a:spcPct val="100000"/>
              </a:lnSpc>
              <a:spcBef>
                <a:spcPts val="1600"/>
              </a:spcBef>
              <a:spcAft>
                <a:spcPts val="0"/>
              </a:spcAft>
              <a:buSzPts val="1600"/>
              <a:buNone/>
              <a:defRPr sz="1600"/>
            </a:lvl4pPr>
            <a:lvl5pPr lvl="4" algn="ctr" rtl="0">
              <a:lnSpc>
                <a:spcPct val="100000"/>
              </a:lnSpc>
              <a:spcBef>
                <a:spcPts val="1600"/>
              </a:spcBef>
              <a:spcAft>
                <a:spcPts val="0"/>
              </a:spcAft>
              <a:buSzPts val="1600"/>
              <a:buNone/>
              <a:defRPr sz="1600"/>
            </a:lvl5pPr>
            <a:lvl6pPr lvl="5" algn="ctr" rtl="0">
              <a:lnSpc>
                <a:spcPct val="100000"/>
              </a:lnSpc>
              <a:spcBef>
                <a:spcPts val="1600"/>
              </a:spcBef>
              <a:spcAft>
                <a:spcPts val="0"/>
              </a:spcAft>
              <a:buSzPts val="1600"/>
              <a:buNone/>
              <a:defRPr sz="1600"/>
            </a:lvl6pPr>
            <a:lvl7pPr lvl="6" algn="ctr" rtl="0">
              <a:lnSpc>
                <a:spcPct val="100000"/>
              </a:lnSpc>
              <a:spcBef>
                <a:spcPts val="1600"/>
              </a:spcBef>
              <a:spcAft>
                <a:spcPts val="0"/>
              </a:spcAft>
              <a:buSzPts val="1600"/>
              <a:buNone/>
              <a:defRPr sz="1600"/>
            </a:lvl7pPr>
            <a:lvl8pPr lvl="7" algn="ctr" rtl="0">
              <a:lnSpc>
                <a:spcPct val="100000"/>
              </a:lnSpc>
              <a:spcBef>
                <a:spcPts val="1600"/>
              </a:spcBef>
              <a:spcAft>
                <a:spcPts val="0"/>
              </a:spcAft>
              <a:buSzPts val="1600"/>
              <a:buNone/>
              <a:defRPr sz="1600"/>
            </a:lvl8pPr>
            <a:lvl9pPr lvl="8" algn="ctr" rtl="0">
              <a:lnSpc>
                <a:spcPct val="100000"/>
              </a:lnSpc>
              <a:spcBef>
                <a:spcPts val="1600"/>
              </a:spcBef>
              <a:spcAft>
                <a:spcPts val="1600"/>
              </a:spcAft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136" name="Google Shape;136;p11"/>
          <p:cNvSpPr/>
          <p:nvPr/>
        </p:nvSpPr>
        <p:spPr>
          <a:xfrm>
            <a:off x="-25" y="6127167"/>
            <a:ext cx="9144017" cy="787955"/>
          </a:xfrm>
          <a:custGeom>
            <a:avLst/>
            <a:gdLst/>
            <a:ahLst/>
            <a:cxnLst/>
            <a:rect l="l" t="t" r="r" b="b"/>
            <a:pathLst>
              <a:path w="81572" h="31202" extrusionOk="0">
                <a:moveTo>
                  <a:pt x="0" y="0"/>
                </a:moveTo>
                <a:lnTo>
                  <a:pt x="0" y="31201"/>
                </a:lnTo>
                <a:lnTo>
                  <a:pt x="81572" y="31201"/>
                </a:lnTo>
                <a:lnTo>
                  <a:pt x="81572" y="0"/>
                </a:lnTo>
                <a:close/>
              </a:path>
            </a:pathLst>
          </a:custGeom>
          <a:solidFill>
            <a:schemeClr val="dk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/>
          </a:p>
        </p:txBody>
      </p:sp>
    </p:spTree>
    <p:extLst>
      <p:ext uri="{BB962C8B-B14F-4D97-AF65-F5344CB8AC3E}">
        <p14:creationId xmlns:p14="http://schemas.microsoft.com/office/powerpoint/2010/main" val="18135721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 1">
  <p:cSld name="Title only 1">
    <p:spTree>
      <p:nvGrpSpPr>
        <p:cNvPr id="1" name="Shape 1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Google Shape;139;p13"/>
          <p:cNvSpPr/>
          <p:nvPr/>
        </p:nvSpPr>
        <p:spPr>
          <a:xfrm>
            <a:off x="-25" y="6127167"/>
            <a:ext cx="9144017" cy="787955"/>
          </a:xfrm>
          <a:custGeom>
            <a:avLst/>
            <a:gdLst/>
            <a:ahLst/>
            <a:cxnLst/>
            <a:rect l="l" t="t" r="r" b="b"/>
            <a:pathLst>
              <a:path w="81572" h="31202" extrusionOk="0">
                <a:moveTo>
                  <a:pt x="0" y="0"/>
                </a:moveTo>
                <a:lnTo>
                  <a:pt x="0" y="31201"/>
                </a:lnTo>
                <a:lnTo>
                  <a:pt x="81572" y="31201"/>
                </a:lnTo>
                <a:lnTo>
                  <a:pt x="81572" y="0"/>
                </a:lnTo>
                <a:close/>
              </a:path>
            </a:pathLst>
          </a:custGeom>
          <a:solidFill>
            <a:schemeClr val="dk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/>
          </a:p>
        </p:txBody>
      </p:sp>
      <p:sp>
        <p:nvSpPr>
          <p:cNvPr id="140" name="Google Shape;140;p13"/>
          <p:cNvSpPr txBox="1">
            <a:spLocks noGrp="1"/>
          </p:cNvSpPr>
          <p:nvPr>
            <p:ph type="title"/>
          </p:nvPr>
        </p:nvSpPr>
        <p:spPr>
          <a:xfrm>
            <a:off x="720000" y="593367"/>
            <a:ext cx="7704000" cy="763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1pPr>
            <a:lvl2pPr lvl="1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3500"/>
              <a:buNone/>
              <a:defRPr/>
            </a:lvl9pPr>
          </a:lstStyle>
          <a:p>
            <a:endParaRPr/>
          </a:p>
        </p:txBody>
      </p:sp>
      <p:grpSp>
        <p:nvGrpSpPr>
          <p:cNvPr id="141" name="Google Shape;141;p13"/>
          <p:cNvGrpSpPr/>
          <p:nvPr/>
        </p:nvGrpSpPr>
        <p:grpSpPr>
          <a:xfrm>
            <a:off x="-599772" y="2992300"/>
            <a:ext cx="10356593" cy="4038605"/>
            <a:chOff x="-578183" y="2244225"/>
            <a:chExt cx="10356593" cy="3028954"/>
          </a:xfrm>
        </p:grpSpPr>
        <p:sp>
          <p:nvSpPr>
            <p:cNvPr id="142" name="Google Shape;142;p13"/>
            <p:cNvSpPr/>
            <p:nvPr/>
          </p:nvSpPr>
          <p:spPr>
            <a:xfrm>
              <a:off x="8150854" y="4811475"/>
              <a:ext cx="1627556" cy="461704"/>
            </a:xfrm>
            <a:custGeom>
              <a:avLst/>
              <a:gdLst/>
              <a:ahLst/>
              <a:cxnLst/>
              <a:rect l="l" t="t" r="r" b="b"/>
              <a:pathLst>
                <a:path w="64014" h="9771" extrusionOk="0">
                  <a:moveTo>
                    <a:pt x="31876" y="1"/>
                  </a:moveTo>
                  <a:cubicBezTo>
                    <a:pt x="14187" y="1"/>
                    <a:pt x="1" y="2155"/>
                    <a:pt x="1" y="4875"/>
                  </a:cubicBezTo>
                  <a:cubicBezTo>
                    <a:pt x="1" y="7573"/>
                    <a:pt x="14339" y="9770"/>
                    <a:pt x="32007" y="9770"/>
                  </a:cubicBezTo>
                  <a:cubicBezTo>
                    <a:pt x="49674" y="9770"/>
                    <a:pt x="64013" y="7573"/>
                    <a:pt x="64013" y="4875"/>
                  </a:cubicBezTo>
                  <a:cubicBezTo>
                    <a:pt x="64013" y="2155"/>
                    <a:pt x="49544" y="1"/>
                    <a:pt x="31876" y="1"/>
                  </a:cubicBezTo>
                  <a:close/>
                </a:path>
              </a:pathLst>
            </a:custGeom>
            <a:solidFill>
              <a:srgbClr val="191919">
                <a:alpha val="17610"/>
              </a:srgb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sp>
          <p:nvSpPr>
            <p:cNvPr id="143" name="Google Shape;143;p13"/>
            <p:cNvSpPr/>
            <p:nvPr/>
          </p:nvSpPr>
          <p:spPr>
            <a:xfrm>
              <a:off x="-578183" y="4811475"/>
              <a:ext cx="1627556" cy="461704"/>
            </a:xfrm>
            <a:custGeom>
              <a:avLst/>
              <a:gdLst/>
              <a:ahLst/>
              <a:cxnLst/>
              <a:rect l="l" t="t" r="r" b="b"/>
              <a:pathLst>
                <a:path w="64014" h="9771" extrusionOk="0">
                  <a:moveTo>
                    <a:pt x="31876" y="1"/>
                  </a:moveTo>
                  <a:cubicBezTo>
                    <a:pt x="14187" y="1"/>
                    <a:pt x="1" y="2155"/>
                    <a:pt x="1" y="4875"/>
                  </a:cubicBezTo>
                  <a:cubicBezTo>
                    <a:pt x="1" y="7573"/>
                    <a:pt x="14339" y="9770"/>
                    <a:pt x="32007" y="9770"/>
                  </a:cubicBezTo>
                  <a:cubicBezTo>
                    <a:pt x="49674" y="9770"/>
                    <a:pt x="64013" y="7573"/>
                    <a:pt x="64013" y="4875"/>
                  </a:cubicBezTo>
                  <a:cubicBezTo>
                    <a:pt x="64013" y="2155"/>
                    <a:pt x="49544" y="1"/>
                    <a:pt x="31876" y="1"/>
                  </a:cubicBezTo>
                  <a:close/>
                </a:path>
              </a:pathLst>
            </a:custGeom>
            <a:solidFill>
              <a:srgbClr val="191919">
                <a:alpha val="17610"/>
              </a:srgb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/>
            </a:p>
          </p:txBody>
        </p:sp>
        <p:grpSp>
          <p:nvGrpSpPr>
            <p:cNvPr id="144" name="Google Shape;144;p13"/>
            <p:cNvGrpSpPr/>
            <p:nvPr/>
          </p:nvGrpSpPr>
          <p:grpSpPr>
            <a:xfrm flipH="1">
              <a:off x="-369038" y="2244999"/>
              <a:ext cx="1023446" cy="2863775"/>
              <a:chOff x="6573550" y="2555450"/>
              <a:chExt cx="251325" cy="703250"/>
            </a:xfrm>
          </p:grpSpPr>
          <p:sp>
            <p:nvSpPr>
              <p:cNvPr id="145" name="Google Shape;145;p13"/>
              <p:cNvSpPr/>
              <p:nvPr/>
            </p:nvSpPr>
            <p:spPr>
              <a:xfrm>
                <a:off x="6675275" y="2555450"/>
                <a:ext cx="42450" cy="81025"/>
              </a:xfrm>
              <a:custGeom>
                <a:avLst/>
                <a:gdLst/>
                <a:ahLst/>
                <a:cxnLst/>
                <a:rect l="l" t="t" r="r" b="b"/>
                <a:pathLst>
                  <a:path w="1698" h="3241" extrusionOk="0">
                    <a:moveTo>
                      <a:pt x="621" y="0"/>
                    </a:moveTo>
                    <a:cubicBezTo>
                      <a:pt x="168" y="0"/>
                      <a:pt x="0" y="604"/>
                      <a:pt x="0" y="604"/>
                    </a:cubicBezTo>
                    <a:lnTo>
                      <a:pt x="239" y="1605"/>
                    </a:lnTo>
                    <a:cubicBezTo>
                      <a:pt x="239" y="1605"/>
                      <a:pt x="522" y="1997"/>
                      <a:pt x="544" y="2606"/>
                    </a:cubicBezTo>
                    <a:cubicBezTo>
                      <a:pt x="544" y="3145"/>
                      <a:pt x="987" y="3241"/>
                      <a:pt x="1224" y="3241"/>
                    </a:cubicBezTo>
                    <a:cubicBezTo>
                      <a:pt x="1255" y="3241"/>
                      <a:pt x="1283" y="3239"/>
                      <a:pt x="1306" y="3237"/>
                    </a:cubicBezTo>
                    <a:cubicBezTo>
                      <a:pt x="1472" y="3216"/>
                      <a:pt x="1519" y="2996"/>
                      <a:pt x="1447" y="2996"/>
                    </a:cubicBezTo>
                    <a:cubicBezTo>
                      <a:pt x="1444" y="2996"/>
                      <a:pt x="1440" y="2997"/>
                      <a:pt x="1436" y="2998"/>
                    </a:cubicBezTo>
                    <a:cubicBezTo>
                      <a:pt x="1349" y="2998"/>
                      <a:pt x="1393" y="1757"/>
                      <a:pt x="1545" y="1409"/>
                    </a:cubicBezTo>
                    <a:cubicBezTo>
                      <a:pt x="1697" y="1083"/>
                      <a:pt x="1436" y="256"/>
                      <a:pt x="827" y="38"/>
                    </a:cubicBezTo>
                    <a:cubicBezTo>
                      <a:pt x="753" y="12"/>
                      <a:pt x="684" y="0"/>
                      <a:pt x="621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46" name="Google Shape;146;p13"/>
              <p:cNvSpPr/>
              <p:nvPr/>
            </p:nvSpPr>
            <p:spPr>
              <a:xfrm>
                <a:off x="6626300" y="3184550"/>
                <a:ext cx="63125" cy="61550"/>
              </a:xfrm>
              <a:custGeom>
                <a:avLst/>
                <a:gdLst/>
                <a:ahLst/>
                <a:cxnLst/>
                <a:rect l="l" t="t" r="r" b="b"/>
                <a:pathLst>
                  <a:path w="2525" h="2462" extrusionOk="0">
                    <a:moveTo>
                      <a:pt x="2166" y="1"/>
                    </a:moveTo>
                    <a:cubicBezTo>
                      <a:pt x="2070" y="1"/>
                      <a:pt x="1350" y="266"/>
                      <a:pt x="1350" y="266"/>
                    </a:cubicBezTo>
                    <a:cubicBezTo>
                      <a:pt x="1350" y="266"/>
                      <a:pt x="1285" y="745"/>
                      <a:pt x="523" y="1833"/>
                    </a:cubicBezTo>
                    <a:cubicBezTo>
                      <a:pt x="523" y="1833"/>
                      <a:pt x="1" y="2268"/>
                      <a:pt x="23" y="2377"/>
                    </a:cubicBezTo>
                    <a:cubicBezTo>
                      <a:pt x="46" y="2434"/>
                      <a:pt x="208" y="2461"/>
                      <a:pt x="388" y="2461"/>
                    </a:cubicBezTo>
                    <a:cubicBezTo>
                      <a:pt x="550" y="2461"/>
                      <a:pt x="725" y="2439"/>
                      <a:pt x="828" y="2398"/>
                    </a:cubicBezTo>
                    <a:cubicBezTo>
                      <a:pt x="1067" y="2333"/>
                      <a:pt x="1437" y="1702"/>
                      <a:pt x="1698" y="1506"/>
                    </a:cubicBezTo>
                    <a:cubicBezTo>
                      <a:pt x="1959" y="1310"/>
                      <a:pt x="2220" y="1376"/>
                      <a:pt x="2438" y="1158"/>
                    </a:cubicBezTo>
                    <a:cubicBezTo>
                      <a:pt x="2525" y="1071"/>
                      <a:pt x="2525" y="767"/>
                      <a:pt x="2416" y="614"/>
                    </a:cubicBezTo>
                    <a:cubicBezTo>
                      <a:pt x="2351" y="462"/>
                      <a:pt x="2220" y="310"/>
                      <a:pt x="2177" y="5"/>
                    </a:cubicBezTo>
                    <a:cubicBezTo>
                      <a:pt x="2177" y="2"/>
                      <a:pt x="2173" y="1"/>
                      <a:pt x="2166" y="1"/>
                    </a:cubicBezTo>
                    <a:close/>
                  </a:path>
                </a:pathLst>
              </a:custGeom>
              <a:solidFill>
                <a:srgbClr val="86502E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47" name="Google Shape;147;p13"/>
              <p:cNvSpPr/>
              <p:nvPr/>
            </p:nvSpPr>
            <p:spPr>
              <a:xfrm>
                <a:off x="6623050" y="3193900"/>
                <a:ext cx="67475" cy="55000"/>
              </a:xfrm>
              <a:custGeom>
                <a:avLst/>
                <a:gdLst/>
                <a:ahLst/>
                <a:cxnLst/>
                <a:rect l="l" t="t" r="r" b="b"/>
                <a:pathLst>
                  <a:path w="2699" h="2200" extrusionOk="0">
                    <a:moveTo>
                      <a:pt x="2416" y="1"/>
                    </a:moveTo>
                    <a:cubicBezTo>
                      <a:pt x="2416" y="1"/>
                      <a:pt x="2416" y="218"/>
                      <a:pt x="2263" y="436"/>
                    </a:cubicBezTo>
                    <a:cubicBezTo>
                      <a:pt x="2133" y="632"/>
                      <a:pt x="1415" y="1306"/>
                      <a:pt x="871" y="1633"/>
                    </a:cubicBezTo>
                    <a:cubicBezTo>
                      <a:pt x="831" y="1646"/>
                      <a:pt x="727" y="1667"/>
                      <a:pt x="642" y="1667"/>
                    </a:cubicBezTo>
                    <a:cubicBezTo>
                      <a:pt x="587" y="1667"/>
                      <a:pt x="540" y="1658"/>
                      <a:pt x="523" y="1633"/>
                    </a:cubicBezTo>
                    <a:cubicBezTo>
                      <a:pt x="501" y="1611"/>
                      <a:pt x="653" y="1459"/>
                      <a:pt x="653" y="1459"/>
                    </a:cubicBezTo>
                    <a:lnTo>
                      <a:pt x="653" y="1459"/>
                    </a:lnTo>
                    <a:cubicBezTo>
                      <a:pt x="392" y="1654"/>
                      <a:pt x="0" y="2046"/>
                      <a:pt x="22" y="2133"/>
                    </a:cubicBezTo>
                    <a:cubicBezTo>
                      <a:pt x="41" y="2181"/>
                      <a:pt x="204" y="2199"/>
                      <a:pt x="400" y="2199"/>
                    </a:cubicBezTo>
                    <a:cubicBezTo>
                      <a:pt x="650" y="2199"/>
                      <a:pt x="954" y="2170"/>
                      <a:pt x="1088" y="2133"/>
                    </a:cubicBezTo>
                    <a:cubicBezTo>
                      <a:pt x="1306" y="2046"/>
                      <a:pt x="1654" y="1415"/>
                      <a:pt x="1915" y="1219"/>
                    </a:cubicBezTo>
                    <a:cubicBezTo>
                      <a:pt x="2024" y="1132"/>
                      <a:pt x="2459" y="893"/>
                      <a:pt x="2568" y="784"/>
                    </a:cubicBezTo>
                    <a:cubicBezTo>
                      <a:pt x="2590" y="741"/>
                      <a:pt x="2655" y="610"/>
                      <a:pt x="2655" y="567"/>
                    </a:cubicBezTo>
                    <a:cubicBezTo>
                      <a:pt x="2698" y="305"/>
                      <a:pt x="2481" y="1"/>
                      <a:pt x="2416" y="1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48" name="Google Shape;148;p13"/>
              <p:cNvSpPr/>
              <p:nvPr/>
            </p:nvSpPr>
            <p:spPr>
              <a:xfrm>
                <a:off x="6669400" y="3206975"/>
                <a:ext cx="20025" cy="32650"/>
              </a:xfrm>
              <a:custGeom>
                <a:avLst/>
                <a:gdLst/>
                <a:ahLst/>
                <a:cxnLst/>
                <a:rect l="l" t="t" r="r" b="b"/>
                <a:pathLst>
                  <a:path w="801" h="1306" extrusionOk="0">
                    <a:moveTo>
                      <a:pt x="801" y="0"/>
                    </a:moveTo>
                    <a:lnTo>
                      <a:pt x="801" y="0"/>
                    </a:lnTo>
                    <a:cubicBezTo>
                      <a:pt x="801" y="0"/>
                      <a:pt x="0" y="703"/>
                      <a:pt x="45" y="703"/>
                    </a:cubicBezTo>
                    <a:cubicBezTo>
                      <a:pt x="48" y="703"/>
                      <a:pt x="53" y="701"/>
                      <a:pt x="61" y="696"/>
                    </a:cubicBezTo>
                    <a:cubicBezTo>
                      <a:pt x="126" y="653"/>
                      <a:pt x="181" y="634"/>
                      <a:pt x="227" y="634"/>
                    </a:cubicBezTo>
                    <a:cubicBezTo>
                      <a:pt x="501" y="634"/>
                      <a:pt x="453" y="1306"/>
                      <a:pt x="453" y="1306"/>
                    </a:cubicBezTo>
                    <a:lnTo>
                      <a:pt x="562" y="1306"/>
                    </a:lnTo>
                    <a:cubicBezTo>
                      <a:pt x="562" y="1306"/>
                      <a:pt x="562" y="827"/>
                      <a:pt x="627" y="588"/>
                    </a:cubicBezTo>
                    <a:cubicBezTo>
                      <a:pt x="670" y="435"/>
                      <a:pt x="801" y="0"/>
                      <a:pt x="801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49" name="Google Shape;149;p13"/>
              <p:cNvSpPr/>
              <p:nvPr/>
            </p:nvSpPr>
            <p:spPr>
              <a:xfrm>
                <a:off x="6645900" y="3010325"/>
                <a:ext cx="53325" cy="185500"/>
              </a:xfrm>
              <a:custGeom>
                <a:avLst/>
                <a:gdLst/>
                <a:ahLst/>
                <a:cxnLst/>
                <a:rect l="l" t="t" r="r" b="b"/>
                <a:pathLst>
                  <a:path w="2133" h="7420" extrusionOk="0">
                    <a:moveTo>
                      <a:pt x="435" y="0"/>
                    </a:moveTo>
                    <a:cubicBezTo>
                      <a:pt x="191" y="0"/>
                      <a:pt x="0" y="118"/>
                      <a:pt x="0" y="447"/>
                    </a:cubicBezTo>
                    <a:cubicBezTo>
                      <a:pt x="0" y="577"/>
                      <a:pt x="174" y="2057"/>
                      <a:pt x="240" y="2383"/>
                    </a:cubicBezTo>
                    <a:cubicBezTo>
                      <a:pt x="283" y="2709"/>
                      <a:pt x="631" y="5995"/>
                      <a:pt x="566" y="7235"/>
                    </a:cubicBezTo>
                    <a:cubicBezTo>
                      <a:pt x="566" y="7318"/>
                      <a:pt x="912" y="7419"/>
                      <a:pt x="1150" y="7419"/>
                    </a:cubicBezTo>
                    <a:cubicBezTo>
                      <a:pt x="1286" y="7419"/>
                      <a:pt x="1387" y="7387"/>
                      <a:pt x="1371" y="7300"/>
                    </a:cubicBezTo>
                    <a:cubicBezTo>
                      <a:pt x="1349" y="7083"/>
                      <a:pt x="2067" y="3863"/>
                      <a:pt x="2111" y="3232"/>
                    </a:cubicBezTo>
                    <a:cubicBezTo>
                      <a:pt x="2133" y="2622"/>
                      <a:pt x="2002" y="1034"/>
                      <a:pt x="1371" y="403"/>
                    </a:cubicBezTo>
                    <a:cubicBezTo>
                      <a:pt x="1173" y="205"/>
                      <a:pt x="757" y="0"/>
                      <a:pt x="435" y="0"/>
                    </a:cubicBezTo>
                    <a:close/>
                  </a:path>
                </a:pathLst>
              </a:custGeom>
              <a:solidFill>
                <a:srgbClr val="86502E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50" name="Google Shape;150;p13"/>
              <p:cNvSpPr/>
              <p:nvPr/>
            </p:nvSpPr>
            <p:spPr>
              <a:xfrm>
                <a:off x="6756325" y="3216200"/>
                <a:ext cx="28850" cy="42500"/>
              </a:xfrm>
              <a:custGeom>
                <a:avLst/>
                <a:gdLst/>
                <a:ahLst/>
                <a:cxnLst/>
                <a:rect l="l" t="t" r="r" b="b"/>
                <a:pathLst>
                  <a:path w="1154" h="1700" extrusionOk="0">
                    <a:moveTo>
                      <a:pt x="827" y="1"/>
                    </a:moveTo>
                    <a:lnTo>
                      <a:pt x="0" y="262"/>
                    </a:lnTo>
                    <a:cubicBezTo>
                      <a:pt x="0" y="262"/>
                      <a:pt x="0" y="958"/>
                      <a:pt x="283" y="1306"/>
                    </a:cubicBezTo>
                    <a:cubicBezTo>
                      <a:pt x="325" y="1349"/>
                      <a:pt x="696" y="1699"/>
                      <a:pt x="877" y="1699"/>
                    </a:cubicBezTo>
                    <a:cubicBezTo>
                      <a:pt x="882" y="1699"/>
                      <a:pt x="887" y="1699"/>
                      <a:pt x="892" y="1698"/>
                    </a:cubicBezTo>
                    <a:cubicBezTo>
                      <a:pt x="1045" y="1676"/>
                      <a:pt x="1153" y="1198"/>
                      <a:pt x="1153" y="980"/>
                    </a:cubicBezTo>
                    <a:cubicBezTo>
                      <a:pt x="1153" y="762"/>
                      <a:pt x="827" y="1"/>
                      <a:pt x="827" y="1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51" name="Google Shape;151;p13"/>
              <p:cNvSpPr/>
              <p:nvPr/>
            </p:nvSpPr>
            <p:spPr>
              <a:xfrm>
                <a:off x="6755775" y="3205325"/>
                <a:ext cx="25050" cy="39750"/>
              </a:xfrm>
              <a:custGeom>
                <a:avLst/>
                <a:gdLst/>
                <a:ahLst/>
                <a:cxnLst/>
                <a:rect l="l" t="t" r="r" b="b"/>
                <a:pathLst>
                  <a:path w="1002" h="1590" extrusionOk="0">
                    <a:moveTo>
                      <a:pt x="675" y="1"/>
                    </a:moveTo>
                    <a:lnTo>
                      <a:pt x="44" y="66"/>
                    </a:lnTo>
                    <a:cubicBezTo>
                      <a:pt x="44" y="66"/>
                      <a:pt x="22" y="349"/>
                      <a:pt x="0" y="610"/>
                    </a:cubicBezTo>
                    <a:cubicBezTo>
                      <a:pt x="0" y="867"/>
                      <a:pt x="339" y="1590"/>
                      <a:pt x="765" y="1590"/>
                    </a:cubicBezTo>
                    <a:cubicBezTo>
                      <a:pt x="771" y="1590"/>
                      <a:pt x="777" y="1589"/>
                      <a:pt x="784" y="1589"/>
                    </a:cubicBezTo>
                    <a:cubicBezTo>
                      <a:pt x="936" y="1589"/>
                      <a:pt x="1001" y="1154"/>
                      <a:pt x="1001" y="1045"/>
                    </a:cubicBezTo>
                    <a:cubicBezTo>
                      <a:pt x="936" y="567"/>
                      <a:pt x="675" y="1"/>
                      <a:pt x="675" y="1"/>
                    </a:cubicBezTo>
                    <a:close/>
                  </a:path>
                </a:pathLst>
              </a:custGeom>
              <a:solidFill>
                <a:srgbClr val="A2664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52" name="Google Shape;152;p13"/>
              <p:cNvSpPr/>
              <p:nvPr/>
            </p:nvSpPr>
            <p:spPr>
              <a:xfrm>
                <a:off x="6714975" y="3017925"/>
                <a:ext cx="61500" cy="206475"/>
              </a:xfrm>
              <a:custGeom>
                <a:avLst/>
                <a:gdLst/>
                <a:ahLst/>
                <a:cxnLst/>
                <a:rect l="l" t="t" r="r" b="b"/>
                <a:pathLst>
                  <a:path w="2460" h="8259" extrusionOk="0">
                    <a:moveTo>
                      <a:pt x="833" y="1"/>
                    </a:moveTo>
                    <a:cubicBezTo>
                      <a:pt x="796" y="1"/>
                      <a:pt x="757" y="4"/>
                      <a:pt x="719" y="12"/>
                    </a:cubicBezTo>
                    <a:cubicBezTo>
                      <a:pt x="153" y="121"/>
                      <a:pt x="1" y="512"/>
                      <a:pt x="283" y="2166"/>
                    </a:cubicBezTo>
                    <a:cubicBezTo>
                      <a:pt x="501" y="3428"/>
                      <a:pt x="1284" y="6257"/>
                      <a:pt x="1654" y="7562"/>
                    </a:cubicBezTo>
                    <a:cubicBezTo>
                      <a:pt x="1763" y="7975"/>
                      <a:pt x="1719" y="8258"/>
                      <a:pt x="1763" y="8258"/>
                    </a:cubicBezTo>
                    <a:cubicBezTo>
                      <a:pt x="1937" y="8258"/>
                      <a:pt x="2416" y="8237"/>
                      <a:pt x="2459" y="7867"/>
                    </a:cubicBezTo>
                    <a:cubicBezTo>
                      <a:pt x="2459" y="7801"/>
                      <a:pt x="2285" y="7519"/>
                      <a:pt x="2285" y="7301"/>
                    </a:cubicBezTo>
                    <a:cubicBezTo>
                      <a:pt x="2285" y="5995"/>
                      <a:pt x="2263" y="2732"/>
                      <a:pt x="2198" y="2275"/>
                    </a:cubicBezTo>
                    <a:cubicBezTo>
                      <a:pt x="2115" y="1755"/>
                      <a:pt x="1654" y="1"/>
                      <a:pt x="833" y="1"/>
                    </a:cubicBezTo>
                    <a:close/>
                  </a:path>
                </a:pathLst>
              </a:custGeom>
              <a:solidFill>
                <a:srgbClr val="A2664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53" name="Google Shape;153;p13"/>
              <p:cNvSpPr/>
              <p:nvPr/>
            </p:nvSpPr>
            <p:spPr>
              <a:xfrm>
                <a:off x="6573550" y="2666625"/>
                <a:ext cx="84325" cy="124650"/>
              </a:xfrm>
              <a:custGeom>
                <a:avLst/>
                <a:gdLst/>
                <a:ahLst/>
                <a:cxnLst/>
                <a:rect l="l" t="t" r="r" b="b"/>
                <a:pathLst>
                  <a:path w="3373" h="4986" extrusionOk="0">
                    <a:moveTo>
                      <a:pt x="2597" y="0"/>
                    </a:moveTo>
                    <a:cubicBezTo>
                      <a:pt x="2222" y="0"/>
                      <a:pt x="1635" y="960"/>
                      <a:pt x="1284" y="2097"/>
                    </a:cubicBezTo>
                    <a:cubicBezTo>
                      <a:pt x="631" y="4142"/>
                      <a:pt x="0" y="4490"/>
                      <a:pt x="697" y="4860"/>
                    </a:cubicBezTo>
                    <a:cubicBezTo>
                      <a:pt x="850" y="4945"/>
                      <a:pt x="978" y="4985"/>
                      <a:pt x="1087" y="4985"/>
                    </a:cubicBezTo>
                    <a:cubicBezTo>
                      <a:pt x="1598" y="4985"/>
                      <a:pt x="1727" y="4107"/>
                      <a:pt x="2372" y="2728"/>
                    </a:cubicBezTo>
                    <a:cubicBezTo>
                      <a:pt x="3003" y="1423"/>
                      <a:pt x="3373" y="248"/>
                      <a:pt x="2655" y="8"/>
                    </a:cubicBezTo>
                    <a:cubicBezTo>
                      <a:pt x="2636" y="3"/>
                      <a:pt x="2617" y="0"/>
                      <a:pt x="2597" y="0"/>
                    </a:cubicBezTo>
                    <a:close/>
                  </a:path>
                </a:pathLst>
              </a:custGeom>
              <a:solidFill>
                <a:schemeClr val="dk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54" name="Google Shape;154;p13"/>
              <p:cNvSpPr/>
              <p:nvPr/>
            </p:nvSpPr>
            <p:spPr>
              <a:xfrm>
                <a:off x="6614350" y="2663000"/>
                <a:ext cx="141450" cy="193150"/>
              </a:xfrm>
              <a:custGeom>
                <a:avLst/>
                <a:gdLst/>
                <a:ahLst/>
                <a:cxnLst/>
                <a:rect l="l" t="t" r="r" b="b"/>
                <a:pathLst>
                  <a:path w="5658" h="7726" extrusionOk="0">
                    <a:moveTo>
                      <a:pt x="2916" y="1"/>
                    </a:moveTo>
                    <a:cubicBezTo>
                      <a:pt x="2916" y="1"/>
                      <a:pt x="1509" y="155"/>
                      <a:pt x="1053" y="155"/>
                    </a:cubicBezTo>
                    <a:cubicBezTo>
                      <a:pt x="1025" y="155"/>
                      <a:pt x="1000" y="155"/>
                      <a:pt x="979" y="153"/>
                    </a:cubicBezTo>
                    <a:cubicBezTo>
                      <a:pt x="849" y="153"/>
                      <a:pt x="740" y="675"/>
                      <a:pt x="675" y="828"/>
                    </a:cubicBezTo>
                    <a:cubicBezTo>
                      <a:pt x="370" y="1655"/>
                      <a:pt x="0" y="2634"/>
                      <a:pt x="784" y="3308"/>
                    </a:cubicBezTo>
                    <a:cubicBezTo>
                      <a:pt x="958" y="3461"/>
                      <a:pt x="1110" y="5223"/>
                      <a:pt x="1110" y="6050"/>
                    </a:cubicBezTo>
                    <a:cubicBezTo>
                      <a:pt x="1110" y="6376"/>
                      <a:pt x="1045" y="6920"/>
                      <a:pt x="805" y="7551"/>
                    </a:cubicBezTo>
                    <a:cubicBezTo>
                      <a:pt x="1589" y="7551"/>
                      <a:pt x="2133" y="7725"/>
                      <a:pt x="2916" y="7725"/>
                    </a:cubicBezTo>
                    <a:lnTo>
                      <a:pt x="5287" y="7725"/>
                    </a:lnTo>
                    <a:cubicBezTo>
                      <a:pt x="5026" y="7072"/>
                      <a:pt x="4765" y="6376"/>
                      <a:pt x="4722" y="6050"/>
                    </a:cubicBezTo>
                    <a:cubicBezTo>
                      <a:pt x="4243" y="3526"/>
                      <a:pt x="5657" y="1176"/>
                      <a:pt x="5440" y="697"/>
                    </a:cubicBezTo>
                    <a:cubicBezTo>
                      <a:pt x="5309" y="393"/>
                      <a:pt x="4591" y="240"/>
                      <a:pt x="4243" y="153"/>
                    </a:cubicBezTo>
                    <a:cubicBezTo>
                      <a:pt x="3917" y="45"/>
                      <a:pt x="2916" y="1"/>
                      <a:pt x="2916" y="1"/>
                    </a:cubicBezTo>
                    <a:close/>
                  </a:path>
                </a:pathLst>
              </a:custGeom>
              <a:solidFill>
                <a:schemeClr val="dk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55" name="Google Shape;155;p13"/>
              <p:cNvSpPr/>
              <p:nvPr/>
            </p:nvSpPr>
            <p:spPr>
              <a:xfrm>
                <a:off x="6656225" y="2618950"/>
                <a:ext cx="57150" cy="56600"/>
              </a:xfrm>
              <a:custGeom>
                <a:avLst/>
                <a:gdLst/>
                <a:ahLst/>
                <a:cxnLst/>
                <a:rect l="l" t="t" r="r" b="b"/>
                <a:pathLst>
                  <a:path w="2286" h="2264" extrusionOk="0">
                    <a:moveTo>
                      <a:pt x="610" y="1"/>
                    </a:moveTo>
                    <a:cubicBezTo>
                      <a:pt x="610" y="1"/>
                      <a:pt x="610" y="1001"/>
                      <a:pt x="523" y="1263"/>
                    </a:cubicBezTo>
                    <a:cubicBezTo>
                      <a:pt x="414" y="1524"/>
                      <a:pt x="1" y="1850"/>
                      <a:pt x="1" y="1850"/>
                    </a:cubicBezTo>
                    <a:lnTo>
                      <a:pt x="936" y="2263"/>
                    </a:lnTo>
                    <a:lnTo>
                      <a:pt x="2285" y="1763"/>
                    </a:lnTo>
                    <a:cubicBezTo>
                      <a:pt x="2285" y="1763"/>
                      <a:pt x="2068" y="1524"/>
                      <a:pt x="1959" y="1263"/>
                    </a:cubicBezTo>
                    <a:cubicBezTo>
                      <a:pt x="1850" y="1001"/>
                      <a:pt x="1872" y="1"/>
                      <a:pt x="1872" y="1"/>
                    </a:cubicBezTo>
                    <a:close/>
                  </a:path>
                </a:pathLst>
              </a:custGeom>
              <a:solidFill>
                <a:srgbClr val="A2664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56" name="Google Shape;156;p13"/>
              <p:cNvSpPr/>
              <p:nvPr/>
            </p:nvSpPr>
            <p:spPr>
              <a:xfrm>
                <a:off x="6653500" y="2618950"/>
                <a:ext cx="49525" cy="47900"/>
              </a:xfrm>
              <a:custGeom>
                <a:avLst/>
                <a:gdLst/>
                <a:ahLst/>
                <a:cxnLst/>
                <a:rect l="l" t="t" r="r" b="b"/>
                <a:pathLst>
                  <a:path w="1981" h="1916" extrusionOk="0">
                    <a:moveTo>
                      <a:pt x="719" y="1"/>
                    </a:moveTo>
                    <a:cubicBezTo>
                      <a:pt x="719" y="1"/>
                      <a:pt x="719" y="1001"/>
                      <a:pt x="632" y="1263"/>
                    </a:cubicBezTo>
                    <a:cubicBezTo>
                      <a:pt x="523" y="1524"/>
                      <a:pt x="1" y="1915"/>
                      <a:pt x="1" y="1915"/>
                    </a:cubicBezTo>
                    <a:lnTo>
                      <a:pt x="1981" y="501"/>
                    </a:lnTo>
                    <a:cubicBezTo>
                      <a:pt x="1981" y="218"/>
                      <a:pt x="1981" y="1"/>
                      <a:pt x="1981" y="1"/>
                    </a:cubicBezTo>
                    <a:close/>
                  </a:path>
                </a:pathLst>
              </a:custGeom>
              <a:solidFill>
                <a:srgbClr val="191919">
                  <a:alpha val="1761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57" name="Google Shape;157;p13"/>
              <p:cNvSpPr/>
              <p:nvPr/>
            </p:nvSpPr>
            <p:spPr>
              <a:xfrm>
                <a:off x="6638825" y="2559100"/>
                <a:ext cx="69100" cy="86550"/>
              </a:xfrm>
              <a:custGeom>
                <a:avLst/>
                <a:gdLst/>
                <a:ahLst/>
                <a:cxnLst/>
                <a:rect l="l" t="t" r="r" b="b"/>
                <a:pathLst>
                  <a:path w="2764" h="3462" extrusionOk="0">
                    <a:moveTo>
                      <a:pt x="1364" y="1"/>
                    </a:moveTo>
                    <a:cubicBezTo>
                      <a:pt x="1352" y="1"/>
                      <a:pt x="1340" y="1"/>
                      <a:pt x="1328" y="1"/>
                    </a:cubicBezTo>
                    <a:cubicBezTo>
                      <a:pt x="588" y="23"/>
                      <a:pt x="0" y="697"/>
                      <a:pt x="131" y="1677"/>
                    </a:cubicBezTo>
                    <a:cubicBezTo>
                      <a:pt x="238" y="2664"/>
                      <a:pt x="918" y="3461"/>
                      <a:pt x="1416" y="3461"/>
                    </a:cubicBezTo>
                    <a:cubicBezTo>
                      <a:pt x="1423" y="3461"/>
                      <a:pt x="1430" y="3461"/>
                      <a:pt x="1436" y="3461"/>
                    </a:cubicBezTo>
                    <a:cubicBezTo>
                      <a:pt x="1937" y="3439"/>
                      <a:pt x="2764" y="2612"/>
                      <a:pt x="2742" y="1633"/>
                    </a:cubicBezTo>
                    <a:cubicBezTo>
                      <a:pt x="2720" y="648"/>
                      <a:pt x="2109" y="1"/>
                      <a:pt x="1364" y="1"/>
                    </a:cubicBezTo>
                    <a:close/>
                  </a:path>
                </a:pathLst>
              </a:custGeom>
              <a:solidFill>
                <a:srgbClr val="A2664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58" name="Google Shape;158;p13"/>
              <p:cNvSpPr/>
              <p:nvPr/>
            </p:nvSpPr>
            <p:spPr>
              <a:xfrm>
                <a:off x="6650250" y="2556750"/>
                <a:ext cx="72900" cy="61675"/>
              </a:xfrm>
              <a:custGeom>
                <a:avLst/>
                <a:gdLst/>
                <a:ahLst/>
                <a:cxnLst/>
                <a:rect l="l" t="t" r="r" b="b"/>
                <a:pathLst>
                  <a:path w="2916" h="2467" extrusionOk="0">
                    <a:moveTo>
                      <a:pt x="867" y="1"/>
                    </a:moveTo>
                    <a:cubicBezTo>
                      <a:pt x="350" y="1"/>
                      <a:pt x="0" y="345"/>
                      <a:pt x="0" y="400"/>
                    </a:cubicBezTo>
                    <a:cubicBezTo>
                      <a:pt x="22" y="487"/>
                      <a:pt x="196" y="791"/>
                      <a:pt x="283" y="900"/>
                    </a:cubicBezTo>
                    <a:cubicBezTo>
                      <a:pt x="407" y="1112"/>
                      <a:pt x="630" y="1223"/>
                      <a:pt x="1023" y="1223"/>
                    </a:cubicBezTo>
                    <a:cubicBezTo>
                      <a:pt x="1115" y="1223"/>
                      <a:pt x="1216" y="1217"/>
                      <a:pt x="1328" y="1205"/>
                    </a:cubicBezTo>
                    <a:cubicBezTo>
                      <a:pt x="1344" y="1203"/>
                      <a:pt x="1361" y="1202"/>
                      <a:pt x="1377" y="1202"/>
                    </a:cubicBezTo>
                    <a:cubicBezTo>
                      <a:pt x="1790" y="1202"/>
                      <a:pt x="2134" y="1714"/>
                      <a:pt x="2176" y="1923"/>
                    </a:cubicBezTo>
                    <a:cubicBezTo>
                      <a:pt x="2198" y="2010"/>
                      <a:pt x="2176" y="2467"/>
                      <a:pt x="2176" y="2467"/>
                    </a:cubicBezTo>
                    <a:cubicBezTo>
                      <a:pt x="2176" y="2467"/>
                      <a:pt x="2916" y="1422"/>
                      <a:pt x="1893" y="465"/>
                    </a:cubicBezTo>
                    <a:cubicBezTo>
                      <a:pt x="1519" y="115"/>
                      <a:pt x="1166" y="1"/>
                      <a:pt x="867" y="1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59" name="Google Shape;159;p13"/>
              <p:cNvSpPr/>
              <p:nvPr/>
            </p:nvSpPr>
            <p:spPr>
              <a:xfrm>
                <a:off x="6634475" y="2564200"/>
                <a:ext cx="30375" cy="34650"/>
              </a:xfrm>
              <a:custGeom>
                <a:avLst/>
                <a:gdLst/>
                <a:ahLst/>
                <a:cxnLst/>
                <a:rect l="l" t="t" r="r" b="b"/>
                <a:pathLst>
                  <a:path w="1215" h="1386" extrusionOk="0">
                    <a:moveTo>
                      <a:pt x="957" y="0"/>
                    </a:moveTo>
                    <a:cubicBezTo>
                      <a:pt x="882" y="0"/>
                      <a:pt x="777" y="29"/>
                      <a:pt x="631" y="102"/>
                    </a:cubicBezTo>
                    <a:cubicBezTo>
                      <a:pt x="0" y="450"/>
                      <a:pt x="240" y="1386"/>
                      <a:pt x="240" y="1386"/>
                    </a:cubicBezTo>
                    <a:cubicBezTo>
                      <a:pt x="240" y="1386"/>
                      <a:pt x="522" y="1037"/>
                      <a:pt x="849" y="885"/>
                    </a:cubicBezTo>
                    <a:cubicBezTo>
                      <a:pt x="1175" y="755"/>
                      <a:pt x="1110" y="341"/>
                      <a:pt x="1110" y="341"/>
                    </a:cubicBezTo>
                    <a:cubicBezTo>
                      <a:pt x="1110" y="341"/>
                      <a:pt x="1215" y="0"/>
                      <a:pt x="957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60" name="Google Shape;160;p13"/>
              <p:cNvSpPr/>
              <p:nvPr/>
            </p:nvSpPr>
            <p:spPr>
              <a:xfrm>
                <a:off x="6619250" y="2701100"/>
                <a:ext cx="115875" cy="153400"/>
              </a:xfrm>
              <a:custGeom>
                <a:avLst/>
                <a:gdLst/>
                <a:ahLst/>
                <a:cxnLst/>
                <a:rect l="l" t="t" r="r" b="b"/>
                <a:pathLst>
                  <a:path w="4635" h="6136" extrusionOk="0">
                    <a:moveTo>
                      <a:pt x="239" y="0"/>
                    </a:moveTo>
                    <a:lnTo>
                      <a:pt x="239" y="0"/>
                    </a:lnTo>
                    <a:cubicBezTo>
                      <a:pt x="44" y="631"/>
                      <a:pt x="0" y="1284"/>
                      <a:pt x="588" y="1784"/>
                    </a:cubicBezTo>
                    <a:cubicBezTo>
                      <a:pt x="762" y="1937"/>
                      <a:pt x="914" y="3699"/>
                      <a:pt x="914" y="4526"/>
                    </a:cubicBezTo>
                    <a:cubicBezTo>
                      <a:pt x="914" y="4852"/>
                      <a:pt x="849" y="5396"/>
                      <a:pt x="609" y="6027"/>
                    </a:cubicBezTo>
                    <a:cubicBezTo>
                      <a:pt x="1110" y="6027"/>
                      <a:pt x="1501" y="6092"/>
                      <a:pt x="1937" y="6136"/>
                    </a:cubicBezTo>
                    <a:cubicBezTo>
                      <a:pt x="1937" y="6136"/>
                      <a:pt x="1784" y="5548"/>
                      <a:pt x="1784" y="5244"/>
                    </a:cubicBezTo>
                    <a:cubicBezTo>
                      <a:pt x="1784" y="4635"/>
                      <a:pt x="2416" y="4564"/>
                      <a:pt x="3057" y="4564"/>
                    </a:cubicBezTo>
                    <a:cubicBezTo>
                      <a:pt x="3253" y="4564"/>
                      <a:pt x="3449" y="4570"/>
                      <a:pt x="3629" y="4570"/>
                    </a:cubicBezTo>
                    <a:cubicBezTo>
                      <a:pt x="3998" y="4570"/>
                      <a:pt x="4296" y="4542"/>
                      <a:pt x="4373" y="4373"/>
                    </a:cubicBezTo>
                    <a:cubicBezTo>
                      <a:pt x="4635" y="3873"/>
                      <a:pt x="3460" y="2655"/>
                      <a:pt x="3590" y="2480"/>
                    </a:cubicBezTo>
                    <a:cubicBezTo>
                      <a:pt x="3721" y="2306"/>
                      <a:pt x="3590" y="2111"/>
                      <a:pt x="3394" y="2002"/>
                    </a:cubicBezTo>
                    <a:cubicBezTo>
                      <a:pt x="3177" y="1915"/>
                      <a:pt x="2720" y="1958"/>
                      <a:pt x="1632" y="1893"/>
                    </a:cubicBezTo>
                    <a:cubicBezTo>
                      <a:pt x="544" y="1828"/>
                      <a:pt x="392" y="1284"/>
                      <a:pt x="239" y="1044"/>
                    </a:cubicBezTo>
                    <a:cubicBezTo>
                      <a:pt x="87" y="827"/>
                      <a:pt x="239" y="44"/>
                      <a:pt x="239" y="0"/>
                    </a:cubicBezTo>
                    <a:close/>
                  </a:path>
                </a:pathLst>
              </a:custGeom>
              <a:solidFill>
                <a:srgbClr val="191919">
                  <a:alpha val="1761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61" name="Google Shape;161;p13"/>
              <p:cNvSpPr/>
              <p:nvPr/>
            </p:nvSpPr>
            <p:spPr>
              <a:xfrm>
                <a:off x="6664925" y="2667375"/>
                <a:ext cx="14725" cy="8175"/>
              </a:xfrm>
              <a:custGeom>
                <a:avLst/>
                <a:gdLst/>
                <a:ahLst/>
                <a:cxnLst/>
                <a:rect l="l" t="t" r="r" b="b"/>
                <a:pathLst>
                  <a:path w="589" h="327" extrusionOk="0">
                    <a:moveTo>
                      <a:pt x="479" y="0"/>
                    </a:moveTo>
                    <a:lnTo>
                      <a:pt x="1" y="87"/>
                    </a:lnTo>
                    <a:lnTo>
                      <a:pt x="588" y="326"/>
                    </a:lnTo>
                    <a:lnTo>
                      <a:pt x="479" y="0"/>
                    </a:lnTo>
                    <a:close/>
                  </a:path>
                </a:pathLst>
              </a:custGeom>
              <a:solidFill>
                <a:schemeClr val="l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62" name="Google Shape;162;p13"/>
              <p:cNvSpPr/>
              <p:nvPr/>
            </p:nvSpPr>
            <p:spPr>
              <a:xfrm>
                <a:off x="6679625" y="2667375"/>
                <a:ext cx="11975" cy="8175"/>
              </a:xfrm>
              <a:custGeom>
                <a:avLst/>
                <a:gdLst/>
                <a:ahLst/>
                <a:cxnLst/>
                <a:rect l="l" t="t" r="r" b="b"/>
                <a:pathLst>
                  <a:path w="479" h="327" extrusionOk="0">
                    <a:moveTo>
                      <a:pt x="131" y="0"/>
                    </a:moveTo>
                    <a:lnTo>
                      <a:pt x="0" y="326"/>
                    </a:lnTo>
                    <a:lnTo>
                      <a:pt x="479" y="174"/>
                    </a:lnTo>
                    <a:lnTo>
                      <a:pt x="131" y="0"/>
                    </a:lnTo>
                    <a:close/>
                  </a:path>
                </a:pathLst>
              </a:custGeom>
              <a:solidFill>
                <a:schemeClr val="l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63" name="Google Shape;163;p13"/>
              <p:cNvSpPr/>
              <p:nvPr/>
            </p:nvSpPr>
            <p:spPr>
              <a:xfrm>
                <a:off x="6621950" y="2851775"/>
                <a:ext cx="140375" cy="190950"/>
              </a:xfrm>
              <a:custGeom>
                <a:avLst/>
                <a:gdLst/>
                <a:ahLst/>
                <a:cxnLst/>
                <a:rect l="l" t="t" r="r" b="b"/>
                <a:pathLst>
                  <a:path w="5615" h="7638" extrusionOk="0">
                    <a:moveTo>
                      <a:pt x="501" y="0"/>
                    </a:moveTo>
                    <a:cubicBezTo>
                      <a:pt x="501" y="0"/>
                      <a:pt x="153" y="588"/>
                      <a:pt x="88" y="1632"/>
                    </a:cubicBezTo>
                    <a:cubicBezTo>
                      <a:pt x="1" y="2698"/>
                      <a:pt x="762" y="7528"/>
                      <a:pt x="762" y="7528"/>
                    </a:cubicBezTo>
                    <a:lnTo>
                      <a:pt x="2851" y="7637"/>
                    </a:lnTo>
                    <a:lnTo>
                      <a:pt x="5614" y="7441"/>
                    </a:lnTo>
                    <a:cubicBezTo>
                      <a:pt x="5614" y="7441"/>
                      <a:pt x="5549" y="3003"/>
                      <a:pt x="5440" y="1697"/>
                    </a:cubicBezTo>
                    <a:cubicBezTo>
                      <a:pt x="5310" y="370"/>
                      <a:pt x="4918" y="44"/>
                      <a:pt x="4918" y="44"/>
                    </a:cubicBezTo>
                    <a:lnTo>
                      <a:pt x="2416" y="131"/>
                    </a:lnTo>
                    <a:lnTo>
                      <a:pt x="501" y="0"/>
                    </a:lnTo>
                    <a:close/>
                  </a:path>
                </a:pathLst>
              </a:custGeom>
              <a:solidFill>
                <a:schemeClr val="accent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64" name="Google Shape;164;p13"/>
              <p:cNvSpPr/>
              <p:nvPr/>
            </p:nvSpPr>
            <p:spPr>
              <a:xfrm>
                <a:off x="6682875" y="2653225"/>
                <a:ext cx="37575" cy="28300"/>
              </a:xfrm>
              <a:custGeom>
                <a:avLst/>
                <a:gdLst/>
                <a:ahLst/>
                <a:cxnLst/>
                <a:rect l="l" t="t" r="r" b="b"/>
                <a:pathLst>
                  <a:path w="1503" h="1132" extrusionOk="0">
                    <a:moveTo>
                      <a:pt x="1110" y="0"/>
                    </a:moveTo>
                    <a:lnTo>
                      <a:pt x="1" y="566"/>
                    </a:lnTo>
                    <a:lnTo>
                      <a:pt x="371" y="1132"/>
                    </a:lnTo>
                    <a:lnTo>
                      <a:pt x="1502" y="544"/>
                    </a:lnTo>
                    <a:lnTo>
                      <a:pt x="1110" y="0"/>
                    </a:lnTo>
                    <a:close/>
                  </a:path>
                </a:pathLst>
              </a:custGeom>
              <a:solidFill>
                <a:schemeClr val="accent6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65" name="Google Shape;165;p13"/>
              <p:cNvSpPr/>
              <p:nvPr/>
            </p:nvSpPr>
            <p:spPr>
              <a:xfrm>
                <a:off x="6649700" y="2655400"/>
                <a:ext cx="27225" cy="25050"/>
              </a:xfrm>
              <a:custGeom>
                <a:avLst/>
                <a:gdLst/>
                <a:ahLst/>
                <a:cxnLst/>
                <a:rect l="l" t="t" r="r" b="b"/>
                <a:pathLst>
                  <a:path w="1089" h="1002" extrusionOk="0">
                    <a:moveTo>
                      <a:pt x="501" y="0"/>
                    </a:moveTo>
                    <a:lnTo>
                      <a:pt x="1" y="457"/>
                    </a:lnTo>
                    <a:lnTo>
                      <a:pt x="653" y="1001"/>
                    </a:lnTo>
                    <a:lnTo>
                      <a:pt x="1088" y="479"/>
                    </a:lnTo>
                    <a:lnTo>
                      <a:pt x="501" y="0"/>
                    </a:lnTo>
                    <a:close/>
                  </a:path>
                </a:pathLst>
              </a:custGeom>
              <a:solidFill>
                <a:schemeClr val="accent6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66" name="Google Shape;166;p13"/>
              <p:cNvSpPr/>
              <p:nvPr/>
            </p:nvSpPr>
            <p:spPr>
              <a:xfrm>
                <a:off x="6621950" y="2851775"/>
                <a:ext cx="82175" cy="190950"/>
              </a:xfrm>
              <a:custGeom>
                <a:avLst/>
                <a:gdLst/>
                <a:ahLst/>
                <a:cxnLst/>
                <a:rect l="l" t="t" r="r" b="b"/>
                <a:pathLst>
                  <a:path w="3287" h="7638" extrusionOk="0">
                    <a:moveTo>
                      <a:pt x="501" y="0"/>
                    </a:moveTo>
                    <a:cubicBezTo>
                      <a:pt x="501" y="0"/>
                      <a:pt x="153" y="588"/>
                      <a:pt x="88" y="1632"/>
                    </a:cubicBezTo>
                    <a:cubicBezTo>
                      <a:pt x="1" y="2698"/>
                      <a:pt x="762" y="7528"/>
                      <a:pt x="762" y="7528"/>
                    </a:cubicBezTo>
                    <a:lnTo>
                      <a:pt x="2851" y="7637"/>
                    </a:lnTo>
                    <a:lnTo>
                      <a:pt x="3286" y="7615"/>
                    </a:lnTo>
                    <a:cubicBezTo>
                      <a:pt x="3286" y="7615"/>
                      <a:pt x="2808" y="7528"/>
                      <a:pt x="2721" y="7071"/>
                    </a:cubicBezTo>
                    <a:cubicBezTo>
                      <a:pt x="2574" y="6189"/>
                      <a:pt x="2427" y="4475"/>
                      <a:pt x="2319" y="4475"/>
                    </a:cubicBezTo>
                    <a:cubicBezTo>
                      <a:pt x="2315" y="4475"/>
                      <a:pt x="2311" y="4478"/>
                      <a:pt x="2307" y="4482"/>
                    </a:cubicBezTo>
                    <a:cubicBezTo>
                      <a:pt x="2155" y="4656"/>
                      <a:pt x="2220" y="5984"/>
                      <a:pt x="1981" y="6245"/>
                    </a:cubicBezTo>
                    <a:cubicBezTo>
                      <a:pt x="1885" y="6349"/>
                      <a:pt x="1772" y="6405"/>
                      <a:pt x="1658" y="6405"/>
                    </a:cubicBezTo>
                    <a:cubicBezTo>
                      <a:pt x="1487" y="6405"/>
                      <a:pt x="1315" y="6279"/>
                      <a:pt x="1198" y="6005"/>
                    </a:cubicBezTo>
                    <a:cubicBezTo>
                      <a:pt x="980" y="5548"/>
                      <a:pt x="436" y="2263"/>
                      <a:pt x="871" y="1110"/>
                    </a:cubicBezTo>
                    <a:cubicBezTo>
                      <a:pt x="1198" y="305"/>
                      <a:pt x="1829" y="109"/>
                      <a:pt x="1829" y="109"/>
                    </a:cubicBezTo>
                    <a:lnTo>
                      <a:pt x="1742" y="87"/>
                    </a:lnTo>
                    <a:lnTo>
                      <a:pt x="501" y="0"/>
                    </a:lnTo>
                    <a:close/>
                  </a:path>
                </a:pathLst>
              </a:custGeom>
              <a:solidFill>
                <a:srgbClr val="191919">
                  <a:alpha val="1761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67" name="Google Shape;167;p13"/>
              <p:cNvSpPr/>
              <p:nvPr/>
            </p:nvSpPr>
            <p:spPr>
              <a:xfrm>
                <a:off x="6673100" y="2673200"/>
                <a:ext cx="11975" cy="11100"/>
              </a:xfrm>
              <a:custGeom>
                <a:avLst/>
                <a:gdLst/>
                <a:ahLst/>
                <a:cxnLst/>
                <a:rect l="l" t="t" r="r" b="b"/>
                <a:pathLst>
                  <a:path w="479" h="444" extrusionOk="0">
                    <a:moveTo>
                      <a:pt x="231" y="1"/>
                    </a:moveTo>
                    <a:cubicBezTo>
                      <a:pt x="142" y="1"/>
                      <a:pt x="55" y="17"/>
                      <a:pt x="44" y="50"/>
                    </a:cubicBezTo>
                    <a:cubicBezTo>
                      <a:pt x="0" y="93"/>
                      <a:pt x="22" y="355"/>
                      <a:pt x="44" y="398"/>
                    </a:cubicBezTo>
                    <a:cubicBezTo>
                      <a:pt x="71" y="425"/>
                      <a:pt x="156" y="444"/>
                      <a:pt x="227" y="444"/>
                    </a:cubicBezTo>
                    <a:cubicBezTo>
                      <a:pt x="271" y="444"/>
                      <a:pt x="310" y="436"/>
                      <a:pt x="326" y="420"/>
                    </a:cubicBezTo>
                    <a:cubicBezTo>
                      <a:pt x="370" y="355"/>
                      <a:pt x="479" y="115"/>
                      <a:pt x="435" y="50"/>
                    </a:cubicBezTo>
                    <a:cubicBezTo>
                      <a:pt x="414" y="17"/>
                      <a:pt x="321" y="1"/>
                      <a:pt x="231" y="1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68" name="Google Shape;168;p13"/>
              <p:cNvSpPr/>
              <p:nvPr/>
            </p:nvSpPr>
            <p:spPr>
              <a:xfrm>
                <a:off x="6658400" y="2683150"/>
                <a:ext cx="23950" cy="66925"/>
              </a:xfrm>
              <a:custGeom>
                <a:avLst/>
                <a:gdLst/>
                <a:ahLst/>
                <a:cxnLst/>
                <a:rect l="l" t="t" r="r" b="b"/>
                <a:pathLst>
                  <a:path w="958" h="2677" extrusionOk="0">
                    <a:moveTo>
                      <a:pt x="632" y="0"/>
                    </a:moveTo>
                    <a:lnTo>
                      <a:pt x="1" y="1828"/>
                    </a:lnTo>
                    <a:lnTo>
                      <a:pt x="371" y="2676"/>
                    </a:lnTo>
                    <a:lnTo>
                      <a:pt x="958" y="1915"/>
                    </a:lnTo>
                    <a:lnTo>
                      <a:pt x="914" y="22"/>
                    </a:lnTo>
                    <a:lnTo>
                      <a:pt x="632" y="0"/>
                    </a:ln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69" name="Google Shape;169;p13"/>
              <p:cNvSpPr/>
              <p:nvPr/>
            </p:nvSpPr>
            <p:spPr>
              <a:xfrm>
                <a:off x="6716600" y="2673025"/>
                <a:ext cx="108275" cy="113075"/>
              </a:xfrm>
              <a:custGeom>
                <a:avLst/>
                <a:gdLst/>
                <a:ahLst/>
                <a:cxnLst/>
                <a:rect l="l" t="t" r="r" b="b"/>
                <a:pathLst>
                  <a:path w="4331" h="4523" extrusionOk="0">
                    <a:moveTo>
                      <a:pt x="878" y="0"/>
                    </a:moveTo>
                    <a:cubicBezTo>
                      <a:pt x="827" y="0"/>
                      <a:pt x="781" y="11"/>
                      <a:pt x="741" y="35"/>
                    </a:cubicBezTo>
                    <a:cubicBezTo>
                      <a:pt x="1" y="514"/>
                      <a:pt x="632" y="1536"/>
                      <a:pt x="1524" y="2668"/>
                    </a:cubicBezTo>
                    <a:cubicBezTo>
                      <a:pt x="2462" y="3818"/>
                      <a:pt x="2954" y="4523"/>
                      <a:pt x="3409" y="4523"/>
                    </a:cubicBezTo>
                    <a:cubicBezTo>
                      <a:pt x="3513" y="4523"/>
                      <a:pt x="3616" y="4486"/>
                      <a:pt x="3721" y="4409"/>
                    </a:cubicBezTo>
                    <a:cubicBezTo>
                      <a:pt x="4331" y="3973"/>
                      <a:pt x="3656" y="3538"/>
                      <a:pt x="2590" y="1711"/>
                    </a:cubicBezTo>
                    <a:cubicBezTo>
                      <a:pt x="2047" y="760"/>
                      <a:pt x="1297" y="0"/>
                      <a:pt x="878" y="0"/>
                    </a:cubicBezTo>
                    <a:close/>
                  </a:path>
                </a:pathLst>
              </a:custGeom>
              <a:solidFill>
                <a:schemeClr val="dk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70" name="Google Shape;170;p13"/>
              <p:cNvSpPr/>
              <p:nvPr/>
            </p:nvSpPr>
            <p:spPr>
              <a:xfrm>
                <a:off x="6626850" y="2697825"/>
                <a:ext cx="81075" cy="107175"/>
              </a:xfrm>
              <a:custGeom>
                <a:avLst/>
                <a:gdLst/>
                <a:ahLst/>
                <a:cxnLst/>
                <a:rect l="l" t="t" r="r" b="b"/>
                <a:pathLst>
                  <a:path w="3243" h="4287" extrusionOk="0">
                    <a:moveTo>
                      <a:pt x="3177" y="1"/>
                    </a:moveTo>
                    <a:lnTo>
                      <a:pt x="1" y="44"/>
                    </a:lnTo>
                    <a:lnTo>
                      <a:pt x="66" y="4287"/>
                    </a:lnTo>
                    <a:lnTo>
                      <a:pt x="3243" y="4243"/>
                    </a:lnTo>
                    <a:lnTo>
                      <a:pt x="3177" y="1"/>
                    </a:ln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71" name="Google Shape;171;p13"/>
              <p:cNvSpPr/>
              <p:nvPr/>
            </p:nvSpPr>
            <p:spPr>
              <a:xfrm>
                <a:off x="6626850" y="2698925"/>
                <a:ext cx="81075" cy="106075"/>
              </a:xfrm>
              <a:custGeom>
                <a:avLst/>
                <a:gdLst/>
                <a:ahLst/>
                <a:cxnLst/>
                <a:rect l="l" t="t" r="r" b="b"/>
                <a:pathLst>
                  <a:path w="3243" h="4243" extrusionOk="0">
                    <a:moveTo>
                      <a:pt x="1" y="0"/>
                    </a:moveTo>
                    <a:lnTo>
                      <a:pt x="66" y="4243"/>
                    </a:lnTo>
                    <a:lnTo>
                      <a:pt x="3243" y="4199"/>
                    </a:lnTo>
                    <a:lnTo>
                      <a:pt x="3221" y="3024"/>
                    </a:lnTo>
                    <a:cubicBezTo>
                      <a:pt x="3221" y="3024"/>
                      <a:pt x="1807" y="2829"/>
                      <a:pt x="1263" y="2154"/>
                    </a:cubicBezTo>
                    <a:cubicBezTo>
                      <a:pt x="719" y="1480"/>
                      <a:pt x="523" y="22"/>
                      <a:pt x="523" y="22"/>
                    </a:cubicBezTo>
                    <a:lnTo>
                      <a:pt x="1" y="0"/>
                    </a:lnTo>
                    <a:close/>
                  </a:path>
                </a:pathLst>
              </a:custGeom>
              <a:solidFill>
                <a:srgbClr val="191919">
                  <a:alpha val="1761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72" name="Google Shape;172;p13"/>
              <p:cNvSpPr/>
              <p:nvPr/>
            </p:nvSpPr>
            <p:spPr>
              <a:xfrm>
                <a:off x="6579525" y="2759525"/>
                <a:ext cx="118075" cy="35575"/>
              </a:xfrm>
              <a:custGeom>
                <a:avLst/>
                <a:gdLst/>
                <a:ahLst/>
                <a:cxnLst/>
                <a:rect l="l" t="t" r="r" b="b"/>
                <a:pathLst>
                  <a:path w="4723" h="1423" extrusionOk="0">
                    <a:moveTo>
                      <a:pt x="3855" y="0"/>
                    </a:moveTo>
                    <a:cubicBezTo>
                      <a:pt x="3289" y="0"/>
                      <a:pt x="2505" y="97"/>
                      <a:pt x="1807" y="122"/>
                    </a:cubicBezTo>
                    <a:cubicBezTo>
                      <a:pt x="545" y="143"/>
                      <a:pt x="1" y="361"/>
                      <a:pt x="175" y="1057"/>
                    </a:cubicBezTo>
                    <a:cubicBezTo>
                      <a:pt x="230" y="1280"/>
                      <a:pt x="491" y="1422"/>
                      <a:pt x="938" y="1422"/>
                    </a:cubicBezTo>
                    <a:cubicBezTo>
                      <a:pt x="1191" y="1422"/>
                      <a:pt x="1503" y="1377"/>
                      <a:pt x="1872" y="1275"/>
                    </a:cubicBezTo>
                    <a:cubicBezTo>
                      <a:pt x="3025" y="949"/>
                      <a:pt x="4722" y="535"/>
                      <a:pt x="4635" y="231"/>
                    </a:cubicBezTo>
                    <a:cubicBezTo>
                      <a:pt x="4579" y="54"/>
                      <a:pt x="4278" y="0"/>
                      <a:pt x="3855" y="0"/>
                    </a:cubicBezTo>
                    <a:close/>
                  </a:path>
                </a:pathLst>
              </a:custGeom>
              <a:solidFill>
                <a:srgbClr val="A2664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73" name="Google Shape;173;p13"/>
              <p:cNvSpPr/>
              <p:nvPr/>
            </p:nvSpPr>
            <p:spPr>
              <a:xfrm>
                <a:off x="6694850" y="2768550"/>
                <a:ext cx="15250" cy="4900"/>
              </a:xfrm>
              <a:custGeom>
                <a:avLst/>
                <a:gdLst/>
                <a:ahLst/>
                <a:cxnLst/>
                <a:rect l="l" t="t" r="r" b="b"/>
                <a:pathLst>
                  <a:path w="610" h="196" extrusionOk="0">
                    <a:moveTo>
                      <a:pt x="87" y="0"/>
                    </a:moveTo>
                    <a:cubicBezTo>
                      <a:pt x="44" y="0"/>
                      <a:pt x="0" y="44"/>
                      <a:pt x="0" y="87"/>
                    </a:cubicBezTo>
                    <a:cubicBezTo>
                      <a:pt x="0" y="152"/>
                      <a:pt x="44" y="196"/>
                      <a:pt x="87" y="196"/>
                    </a:cubicBezTo>
                    <a:lnTo>
                      <a:pt x="523" y="196"/>
                    </a:lnTo>
                    <a:cubicBezTo>
                      <a:pt x="566" y="196"/>
                      <a:pt x="610" y="152"/>
                      <a:pt x="610" y="109"/>
                    </a:cubicBezTo>
                    <a:cubicBezTo>
                      <a:pt x="610" y="44"/>
                      <a:pt x="566" y="0"/>
                      <a:pt x="523" y="0"/>
                    </a:cubicBezTo>
                    <a:close/>
                  </a:path>
                </a:pathLst>
              </a:custGeom>
              <a:solidFill>
                <a:srgbClr val="A2664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74" name="Google Shape;174;p13"/>
              <p:cNvSpPr/>
              <p:nvPr/>
            </p:nvSpPr>
            <p:spPr>
              <a:xfrm>
                <a:off x="6695400" y="2763650"/>
                <a:ext cx="15250" cy="5450"/>
              </a:xfrm>
              <a:custGeom>
                <a:avLst/>
                <a:gdLst/>
                <a:ahLst/>
                <a:cxnLst/>
                <a:rect l="l" t="t" r="r" b="b"/>
                <a:pathLst>
                  <a:path w="610" h="218" extrusionOk="0">
                    <a:moveTo>
                      <a:pt x="87" y="0"/>
                    </a:moveTo>
                    <a:cubicBezTo>
                      <a:pt x="44" y="0"/>
                      <a:pt x="0" y="44"/>
                      <a:pt x="0" y="109"/>
                    </a:cubicBezTo>
                    <a:cubicBezTo>
                      <a:pt x="0" y="153"/>
                      <a:pt x="44" y="196"/>
                      <a:pt x="87" y="196"/>
                    </a:cubicBezTo>
                    <a:lnTo>
                      <a:pt x="522" y="218"/>
                    </a:lnTo>
                    <a:cubicBezTo>
                      <a:pt x="566" y="218"/>
                      <a:pt x="609" y="174"/>
                      <a:pt x="609" y="109"/>
                    </a:cubicBezTo>
                    <a:cubicBezTo>
                      <a:pt x="609" y="66"/>
                      <a:pt x="566" y="22"/>
                      <a:pt x="522" y="22"/>
                    </a:cubicBezTo>
                    <a:lnTo>
                      <a:pt x="87" y="0"/>
                    </a:lnTo>
                    <a:close/>
                  </a:path>
                </a:pathLst>
              </a:custGeom>
              <a:solidFill>
                <a:srgbClr val="A2664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75" name="Google Shape;175;p13"/>
              <p:cNvSpPr/>
              <p:nvPr/>
            </p:nvSpPr>
            <p:spPr>
              <a:xfrm>
                <a:off x="6695400" y="2759300"/>
                <a:ext cx="15800" cy="4900"/>
              </a:xfrm>
              <a:custGeom>
                <a:avLst/>
                <a:gdLst/>
                <a:ahLst/>
                <a:cxnLst/>
                <a:rect l="l" t="t" r="r" b="b"/>
                <a:pathLst>
                  <a:path w="632" h="196" extrusionOk="0">
                    <a:moveTo>
                      <a:pt x="109" y="0"/>
                    </a:moveTo>
                    <a:cubicBezTo>
                      <a:pt x="44" y="0"/>
                      <a:pt x="0" y="44"/>
                      <a:pt x="0" y="109"/>
                    </a:cubicBezTo>
                    <a:cubicBezTo>
                      <a:pt x="0" y="152"/>
                      <a:pt x="44" y="196"/>
                      <a:pt x="87" y="196"/>
                    </a:cubicBezTo>
                    <a:lnTo>
                      <a:pt x="522" y="196"/>
                    </a:lnTo>
                    <a:cubicBezTo>
                      <a:pt x="566" y="196"/>
                      <a:pt x="609" y="152"/>
                      <a:pt x="631" y="109"/>
                    </a:cubicBezTo>
                    <a:cubicBezTo>
                      <a:pt x="631" y="44"/>
                      <a:pt x="588" y="0"/>
                      <a:pt x="522" y="0"/>
                    </a:cubicBezTo>
                    <a:close/>
                  </a:path>
                </a:pathLst>
              </a:custGeom>
              <a:solidFill>
                <a:srgbClr val="A2664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76" name="Google Shape;176;p13"/>
              <p:cNvSpPr/>
              <p:nvPr/>
            </p:nvSpPr>
            <p:spPr>
              <a:xfrm>
                <a:off x="6673625" y="2752775"/>
                <a:ext cx="35925" cy="23400"/>
              </a:xfrm>
              <a:custGeom>
                <a:avLst/>
                <a:gdLst/>
                <a:ahLst/>
                <a:cxnLst/>
                <a:rect l="l" t="t" r="r" b="b"/>
                <a:pathLst>
                  <a:path w="1437" h="936" extrusionOk="0">
                    <a:moveTo>
                      <a:pt x="762" y="0"/>
                    </a:moveTo>
                    <a:cubicBezTo>
                      <a:pt x="632" y="22"/>
                      <a:pt x="1" y="305"/>
                      <a:pt x="1" y="305"/>
                    </a:cubicBezTo>
                    <a:lnTo>
                      <a:pt x="284" y="849"/>
                    </a:lnTo>
                    <a:cubicBezTo>
                      <a:pt x="284" y="849"/>
                      <a:pt x="480" y="914"/>
                      <a:pt x="697" y="936"/>
                    </a:cubicBezTo>
                    <a:cubicBezTo>
                      <a:pt x="915" y="936"/>
                      <a:pt x="1372" y="827"/>
                      <a:pt x="1372" y="827"/>
                    </a:cubicBezTo>
                    <a:cubicBezTo>
                      <a:pt x="1372" y="827"/>
                      <a:pt x="1285" y="522"/>
                      <a:pt x="1285" y="392"/>
                    </a:cubicBezTo>
                    <a:cubicBezTo>
                      <a:pt x="1263" y="283"/>
                      <a:pt x="1437" y="109"/>
                      <a:pt x="1437" y="109"/>
                    </a:cubicBezTo>
                    <a:cubicBezTo>
                      <a:pt x="1437" y="109"/>
                      <a:pt x="915" y="0"/>
                      <a:pt x="762" y="0"/>
                    </a:cubicBezTo>
                    <a:close/>
                  </a:path>
                </a:pathLst>
              </a:custGeom>
              <a:solidFill>
                <a:srgbClr val="A2664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77" name="Google Shape;177;p13"/>
              <p:cNvSpPr/>
              <p:nvPr/>
            </p:nvSpPr>
            <p:spPr>
              <a:xfrm>
                <a:off x="6731300" y="2764875"/>
                <a:ext cx="92500" cy="92375"/>
              </a:xfrm>
              <a:custGeom>
                <a:avLst/>
                <a:gdLst/>
                <a:ahLst/>
                <a:cxnLst/>
                <a:rect l="l" t="t" r="r" b="b"/>
                <a:pathLst>
                  <a:path w="3700" h="3695" extrusionOk="0">
                    <a:moveTo>
                      <a:pt x="2961" y="0"/>
                    </a:moveTo>
                    <a:cubicBezTo>
                      <a:pt x="2622" y="0"/>
                      <a:pt x="2031" y="424"/>
                      <a:pt x="1567" y="1148"/>
                    </a:cubicBezTo>
                    <a:cubicBezTo>
                      <a:pt x="936" y="2127"/>
                      <a:pt x="0" y="3520"/>
                      <a:pt x="261" y="3672"/>
                    </a:cubicBezTo>
                    <a:cubicBezTo>
                      <a:pt x="288" y="3687"/>
                      <a:pt x="319" y="3694"/>
                      <a:pt x="352" y="3694"/>
                    </a:cubicBezTo>
                    <a:cubicBezTo>
                      <a:pt x="748" y="3694"/>
                      <a:pt x="1569" y="2674"/>
                      <a:pt x="2372" y="1931"/>
                    </a:cubicBezTo>
                    <a:cubicBezTo>
                      <a:pt x="3242" y="1104"/>
                      <a:pt x="3699" y="430"/>
                      <a:pt x="3112" y="38"/>
                    </a:cubicBezTo>
                    <a:cubicBezTo>
                      <a:pt x="3070" y="13"/>
                      <a:pt x="3020" y="0"/>
                      <a:pt x="2961" y="0"/>
                    </a:cubicBezTo>
                    <a:close/>
                  </a:path>
                </a:pathLst>
              </a:custGeom>
              <a:solidFill>
                <a:srgbClr val="A2664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78" name="Google Shape;178;p13"/>
              <p:cNvSpPr/>
              <p:nvPr/>
            </p:nvSpPr>
            <p:spPr>
              <a:xfrm>
                <a:off x="6716075" y="2854875"/>
                <a:ext cx="15250" cy="8475"/>
              </a:xfrm>
              <a:custGeom>
                <a:avLst/>
                <a:gdLst/>
                <a:ahLst/>
                <a:cxnLst/>
                <a:rect l="l" t="t" r="r" b="b"/>
                <a:pathLst>
                  <a:path w="610" h="339" extrusionOk="0">
                    <a:moveTo>
                      <a:pt x="504" y="1"/>
                    </a:moveTo>
                    <a:cubicBezTo>
                      <a:pt x="495" y="1"/>
                      <a:pt x="487" y="3"/>
                      <a:pt x="479" y="7"/>
                    </a:cubicBezTo>
                    <a:lnTo>
                      <a:pt x="65" y="137"/>
                    </a:lnTo>
                    <a:cubicBezTo>
                      <a:pt x="22" y="159"/>
                      <a:pt x="0" y="224"/>
                      <a:pt x="0" y="268"/>
                    </a:cubicBezTo>
                    <a:cubicBezTo>
                      <a:pt x="18" y="303"/>
                      <a:pt x="65" y="339"/>
                      <a:pt x="105" y="339"/>
                    </a:cubicBezTo>
                    <a:cubicBezTo>
                      <a:pt x="114" y="339"/>
                      <a:pt x="123" y="337"/>
                      <a:pt x="131" y="333"/>
                    </a:cubicBezTo>
                    <a:lnTo>
                      <a:pt x="522" y="202"/>
                    </a:lnTo>
                    <a:cubicBezTo>
                      <a:pt x="587" y="181"/>
                      <a:pt x="609" y="115"/>
                      <a:pt x="587" y="72"/>
                    </a:cubicBezTo>
                    <a:cubicBezTo>
                      <a:pt x="587" y="36"/>
                      <a:pt x="544" y="1"/>
                      <a:pt x="504" y="1"/>
                    </a:cubicBezTo>
                    <a:close/>
                  </a:path>
                </a:pathLst>
              </a:custGeom>
              <a:solidFill>
                <a:srgbClr val="A2664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79" name="Google Shape;179;p13"/>
              <p:cNvSpPr/>
              <p:nvPr/>
            </p:nvSpPr>
            <p:spPr>
              <a:xfrm>
                <a:off x="6713875" y="2850675"/>
                <a:ext cx="15800" cy="8400"/>
              </a:xfrm>
              <a:custGeom>
                <a:avLst/>
                <a:gdLst/>
                <a:ahLst/>
                <a:cxnLst/>
                <a:rect l="l" t="t" r="r" b="b"/>
                <a:pathLst>
                  <a:path w="632" h="336" extrusionOk="0">
                    <a:moveTo>
                      <a:pt x="480" y="1"/>
                    </a:moveTo>
                    <a:lnTo>
                      <a:pt x="88" y="131"/>
                    </a:lnTo>
                    <a:cubicBezTo>
                      <a:pt x="23" y="153"/>
                      <a:pt x="1" y="218"/>
                      <a:pt x="23" y="262"/>
                    </a:cubicBezTo>
                    <a:cubicBezTo>
                      <a:pt x="39" y="311"/>
                      <a:pt x="68" y="335"/>
                      <a:pt x="108" y="335"/>
                    </a:cubicBezTo>
                    <a:cubicBezTo>
                      <a:pt x="122" y="335"/>
                      <a:pt x="137" y="332"/>
                      <a:pt x="153" y="327"/>
                    </a:cubicBezTo>
                    <a:lnTo>
                      <a:pt x="545" y="196"/>
                    </a:lnTo>
                    <a:cubicBezTo>
                      <a:pt x="588" y="175"/>
                      <a:pt x="632" y="131"/>
                      <a:pt x="610" y="66"/>
                    </a:cubicBezTo>
                    <a:cubicBezTo>
                      <a:pt x="588" y="22"/>
                      <a:pt x="545" y="1"/>
                      <a:pt x="480" y="1"/>
                    </a:cubicBezTo>
                    <a:close/>
                  </a:path>
                </a:pathLst>
              </a:custGeom>
              <a:solidFill>
                <a:srgbClr val="A2664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80" name="Google Shape;180;p13"/>
              <p:cNvSpPr/>
              <p:nvPr/>
            </p:nvSpPr>
            <p:spPr>
              <a:xfrm>
                <a:off x="6712250" y="2846650"/>
                <a:ext cx="15800" cy="8050"/>
              </a:xfrm>
              <a:custGeom>
                <a:avLst/>
                <a:gdLst/>
                <a:ahLst/>
                <a:cxnLst/>
                <a:rect l="l" t="t" r="r" b="b"/>
                <a:pathLst>
                  <a:path w="632" h="322" extrusionOk="0">
                    <a:moveTo>
                      <a:pt x="527" y="1"/>
                    </a:moveTo>
                    <a:cubicBezTo>
                      <a:pt x="513" y="1"/>
                      <a:pt x="497" y="3"/>
                      <a:pt x="479" y="9"/>
                    </a:cubicBezTo>
                    <a:lnTo>
                      <a:pt x="88" y="140"/>
                    </a:lnTo>
                    <a:cubicBezTo>
                      <a:pt x="44" y="140"/>
                      <a:pt x="1" y="205"/>
                      <a:pt x="22" y="249"/>
                    </a:cubicBezTo>
                    <a:cubicBezTo>
                      <a:pt x="39" y="298"/>
                      <a:pt x="67" y="322"/>
                      <a:pt x="108" y="322"/>
                    </a:cubicBezTo>
                    <a:cubicBezTo>
                      <a:pt x="122" y="322"/>
                      <a:pt x="137" y="319"/>
                      <a:pt x="153" y="314"/>
                    </a:cubicBezTo>
                    <a:lnTo>
                      <a:pt x="545" y="183"/>
                    </a:lnTo>
                    <a:cubicBezTo>
                      <a:pt x="610" y="162"/>
                      <a:pt x="632" y="118"/>
                      <a:pt x="610" y="53"/>
                    </a:cubicBezTo>
                    <a:cubicBezTo>
                      <a:pt x="594" y="21"/>
                      <a:pt x="566" y="1"/>
                      <a:pt x="527" y="1"/>
                    </a:cubicBezTo>
                    <a:close/>
                  </a:path>
                </a:pathLst>
              </a:custGeom>
              <a:solidFill>
                <a:srgbClr val="A2664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81" name="Google Shape;181;p13"/>
              <p:cNvSpPr/>
              <p:nvPr/>
            </p:nvSpPr>
            <p:spPr>
              <a:xfrm>
                <a:off x="6711175" y="2842300"/>
                <a:ext cx="15800" cy="8400"/>
              </a:xfrm>
              <a:custGeom>
                <a:avLst/>
                <a:gdLst/>
                <a:ahLst/>
                <a:cxnLst/>
                <a:rect l="l" t="t" r="r" b="b"/>
                <a:pathLst>
                  <a:path w="632" h="336" extrusionOk="0">
                    <a:moveTo>
                      <a:pt x="524" y="1"/>
                    </a:moveTo>
                    <a:cubicBezTo>
                      <a:pt x="510" y="1"/>
                      <a:pt x="495" y="4"/>
                      <a:pt x="479" y="9"/>
                    </a:cubicBezTo>
                    <a:lnTo>
                      <a:pt x="87" y="140"/>
                    </a:lnTo>
                    <a:cubicBezTo>
                      <a:pt x="22" y="161"/>
                      <a:pt x="0" y="205"/>
                      <a:pt x="22" y="270"/>
                    </a:cubicBezTo>
                    <a:cubicBezTo>
                      <a:pt x="44" y="314"/>
                      <a:pt x="87" y="336"/>
                      <a:pt x="153" y="336"/>
                    </a:cubicBezTo>
                    <a:lnTo>
                      <a:pt x="544" y="183"/>
                    </a:lnTo>
                    <a:cubicBezTo>
                      <a:pt x="588" y="183"/>
                      <a:pt x="631" y="118"/>
                      <a:pt x="609" y="74"/>
                    </a:cubicBezTo>
                    <a:cubicBezTo>
                      <a:pt x="593" y="25"/>
                      <a:pt x="565" y="1"/>
                      <a:pt x="524" y="1"/>
                    </a:cubicBezTo>
                    <a:close/>
                  </a:path>
                </a:pathLst>
              </a:custGeom>
              <a:solidFill>
                <a:srgbClr val="A2664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82" name="Google Shape;182;p13"/>
              <p:cNvSpPr/>
              <p:nvPr/>
            </p:nvSpPr>
            <p:spPr>
              <a:xfrm>
                <a:off x="6712250" y="2839100"/>
                <a:ext cx="34300" cy="24100"/>
              </a:xfrm>
              <a:custGeom>
                <a:avLst/>
                <a:gdLst/>
                <a:ahLst/>
                <a:cxnLst/>
                <a:rect l="l" t="t" r="r" b="b"/>
                <a:pathLst>
                  <a:path w="1372" h="964" extrusionOk="0">
                    <a:moveTo>
                      <a:pt x="737" y="1"/>
                    </a:moveTo>
                    <a:cubicBezTo>
                      <a:pt x="681" y="1"/>
                      <a:pt x="636" y="2"/>
                      <a:pt x="610" y="7"/>
                    </a:cubicBezTo>
                    <a:cubicBezTo>
                      <a:pt x="479" y="28"/>
                      <a:pt x="1" y="289"/>
                      <a:pt x="1" y="289"/>
                    </a:cubicBezTo>
                    <a:cubicBezTo>
                      <a:pt x="1" y="289"/>
                      <a:pt x="218" y="398"/>
                      <a:pt x="240" y="529"/>
                    </a:cubicBezTo>
                    <a:cubicBezTo>
                      <a:pt x="262" y="638"/>
                      <a:pt x="284" y="964"/>
                      <a:pt x="284" y="964"/>
                    </a:cubicBezTo>
                    <a:cubicBezTo>
                      <a:pt x="284" y="964"/>
                      <a:pt x="697" y="899"/>
                      <a:pt x="915" y="833"/>
                    </a:cubicBezTo>
                    <a:cubicBezTo>
                      <a:pt x="1219" y="725"/>
                      <a:pt x="1371" y="616"/>
                      <a:pt x="1371" y="616"/>
                    </a:cubicBezTo>
                    <a:lnTo>
                      <a:pt x="1350" y="28"/>
                    </a:lnTo>
                    <a:cubicBezTo>
                      <a:pt x="1350" y="28"/>
                      <a:pt x="960" y="1"/>
                      <a:pt x="737" y="1"/>
                    </a:cubicBezTo>
                    <a:close/>
                  </a:path>
                </a:pathLst>
              </a:custGeom>
              <a:solidFill>
                <a:srgbClr val="A2664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</p:grpSp>
        <p:grpSp>
          <p:nvGrpSpPr>
            <p:cNvPr id="183" name="Google Shape;183;p13"/>
            <p:cNvGrpSpPr/>
            <p:nvPr/>
          </p:nvGrpSpPr>
          <p:grpSpPr>
            <a:xfrm>
              <a:off x="8424000" y="2244225"/>
              <a:ext cx="1197429" cy="2827098"/>
              <a:chOff x="-87625" y="2244225"/>
              <a:chExt cx="1197429" cy="2827098"/>
            </a:xfrm>
          </p:grpSpPr>
          <p:sp>
            <p:nvSpPr>
              <p:cNvPr id="184" name="Google Shape;184;p13"/>
              <p:cNvSpPr/>
              <p:nvPr/>
            </p:nvSpPr>
            <p:spPr>
              <a:xfrm>
                <a:off x="-48814" y="2669176"/>
                <a:ext cx="295773" cy="456726"/>
              </a:xfrm>
              <a:custGeom>
                <a:avLst/>
                <a:gdLst/>
                <a:ahLst/>
                <a:cxnLst/>
                <a:rect l="l" t="t" r="r" b="b"/>
                <a:pathLst>
                  <a:path w="3155" h="4872" extrusionOk="0">
                    <a:moveTo>
                      <a:pt x="718" y="0"/>
                    </a:moveTo>
                    <a:lnTo>
                      <a:pt x="0" y="348"/>
                    </a:lnTo>
                    <a:cubicBezTo>
                      <a:pt x="0" y="348"/>
                      <a:pt x="631" y="2437"/>
                      <a:pt x="914" y="3112"/>
                    </a:cubicBezTo>
                    <a:cubicBezTo>
                      <a:pt x="1183" y="3728"/>
                      <a:pt x="1725" y="4871"/>
                      <a:pt x="2283" y="4871"/>
                    </a:cubicBezTo>
                    <a:cubicBezTo>
                      <a:pt x="2356" y="4871"/>
                      <a:pt x="2429" y="4852"/>
                      <a:pt x="2502" y="4809"/>
                    </a:cubicBezTo>
                    <a:cubicBezTo>
                      <a:pt x="3155" y="4417"/>
                      <a:pt x="2959" y="3590"/>
                      <a:pt x="2872" y="3395"/>
                    </a:cubicBezTo>
                    <a:cubicBezTo>
                      <a:pt x="1958" y="1545"/>
                      <a:pt x="718" y="0"/>
                      <a:pt x="718" y="0"/>
                    </a:cubicBezTo>
                    <a:close/>
                  </a:path>
                </a:pathLst>
              </a:custGeom>
              <a:solidFill>
                <a:srgbClr val="FFA47C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85" name="Google Shape;185;p13"/>
              <p:cNvSpPr/>
              <p:nvPr/>
            </p:nvSpPr>
            <p:spPr>
              <a:xfrm>
                <a:off x="775218" y="4908769"/>
                <a:ext cx="195932" cy="162554"/>
              </a:xfrm>
              <a:custGeom>
                <a:avLst/>
                <a:gdLst/>
                <a:ahLst/>
                <a:cxnLst/>
                <a:rect l="l" t="t" r="r" b="b"/>
                <a:pathLst>
                  <a:path w="2090" h="1734" extrusionOk="0">
                    <a:moveTo>
                      <a:pt x="1850" y="1"/>
                    </a:moveTo>
                    <a:lnTo>
                      <a:pt x="457" y="327"/>
                    </a:lnTo>
                    <a:cubicBezTo>
                      <a:pt x="457" y="327"/>
                      <a:pt x="0" y="1176"/>
                      <a:pt x="66" y="1371"/>
                    </a:cubicBezTo>
                    <a:cubicBezTo>
                      <a:pt x="104" y="1449"/>
                      <a:pt x="385" y="1733"/>
                      <a:pt x="783" y="1733"/>
                    </a:cubicBezTo>
                    <a:cubicBezTo>
                      <a:pt x="833" y="1733"/>
                      <a:pt x="883" y="1729"/>
                      <a:pt x="936" y="1720"/>
                    </a:cubicBezTo>
                    <a:cubicBezTo>
                      <a:pt x="1284" y="1676"/>
                      <a:pt x="1806" y="1219"/>
                      <a:pt x="1893" y="1197"/>
                    </a:cubicBezTo>
                    <a:cubicBezTo>
                      <a:pt x="2089" y="1132"/>
                      <a:pt x="1850" y="1"/>
                      <a:pt x="1850" y="1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86" name="Google Shape;186;p13"/>
              <p:cNvSpPr/>
              <p:nvPr/>
            </p:nvSpPr>
            <p:spPr>
              <a:xfrm>
                <a:off x="106149" y="2716611"/>
                <a:ext cx="465175" cy="401416"/>
              </a:xfrm>
              <a:custGeom>
                <a:avLst/>
                <a:gdLst/>
                <a:ahLst/>
                <a:cxnLst/>
                <a:rect l="l" t="t" r="r" b="b"/>
                <a:pathLst>
                  <a:path w="4962" h="4282" extrusionOk="0">
                    <a:moveTo>
                      <a:pt x="3824" y="1"/>
                    </a:moveTo>
                    <a:cubicBezTo>
                      <a:pt x="3406" y="1"/>
                      <a:pt x="3018" y="279"/>
                      <a:pt x="2720" y="517"/>
                    </a:cubicBezTo>
                    <a:cubicBezTo>
                      <a:pt x="2285" y="865"/>
                      <a:pt x="218" y="2997"/>
                      <a:pt x="109" y="3302"/>
                    </a:cubicBezTo>
                    <a:cubicBezTo>
                      <a:pt x="1" y="3585"/>
                      <a:pt x="697" y="4281"/>
                      <a:pt x="915" y="4281"/>
                    </a:cubicBezTo>
                    <a:cubicBezTo>
                      <a:pt x="1132" y="4281"/>
                      <a:pt x="3895" y="2192"/>
                      <a:pt x="4331" y="1692"/>
                    </a:cubicBezTo>
                    <a:cubicBezTo>
                      <a:pt x="4766" y="1191"/>
                      <a:pt x="4962" y="626"/>
                      <a:pt x="4418" y="212"/>
                    </a:cubicBezTo>
                    <a:cubicBezTo>
                      <a:pt x="4218" y="61"/>
                      <a:pt x="4018" y="1"/>
                      <a:pt x="3824" y="1"/>
                    </a:cubicBezTo>
                    <a:close/>
                  </a:path>
                </a:pathLst>
              </a:custGeom>
              <a:solidFill>
                <a:srgbClr val="FFA47C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87" name="Google Shape;187;p13"/>
              <p:cNvSpPr/>
              <p:nvPr/>
            </p:nvSpPr>
            <p:spPr>
              <a:xfrm>
                <a:off x="183678" y="2715768"/>
                <a:ext cx="357084" cy="347138"/>
              </a:xfrm>
              <a:custGeom>
                <a:avLst/>
                <a:gdLst/>
                <a:ahLst/>
                <a:cxnLst/>
                <a:rect l="l" t="t" r="r" b="b"/>
                <a:pathLst>
                  <a:path w="3809" h="3703" extrusionOk="0">
                    <a:moveTo>
                      <a:pt x="2942" y="0"/>
                    </a:moveTo>
                    <a:cubicBezTo>
                      <a:pt x="2647" y="0"/>
                      <a:pt x="2084" y="117"/>
                      <a:pt x="1415" y="787"/>
                    </a:cubicBezTo>
                    <a:cubicBezTo>
                      <a:pt x="914" y="1266"/>
                      <a:pt x="0" y="2245"/>
                      <a:pt x="0" y="2245"/>
                    </a:cubicBezTo>
                    <a:cubicBezTo>
                      <a:pt x="0" y="2245"/>
                      <a:pt x="175" y="2723"/>
                      <a:pt x="631" y="3137"/>
                    </a:cubicBezTo>
                    <a:cubicBezTo>
                      <a:pt x="1154" y="3616"/>
                      <a:pt x="1654" y="3703"/>
                      <a:pt x="1654" y="3703"/>
                    </a:cubicBezTo>
                    <a:cubicBezTo>
                      <a:pt x="1654" y="3703"/>
                      <a:pt x="3612" y="1723"/>
                      <a:pt x="3765" y="1179"/>
                    </a:cubicBezTo>
                    <a:cubicBezTo>
                      <a:pt x="3808" y="1026"/>
                      <a:pt x="3743" y="47"/>
                      <a:pt x="3025" y="4"/>
                    </a:cubicBezTo>
                    <a:cubicBezTo>
                      <a:pt x="3000" y="2"/>
                      <a:pt x="2972" y="0"/>
                      <a:pt x="2942" y="0"/>
                    </a:cubicBezTo>
                    <a:close/>
                  </a:path>
                </a:pathLst>
              </a:custGeom>
              <a:solidFill>
                <a:schemeClr val="l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88" name="Google Shape;188;p13"/>
              <p:cNvSpPr/>
              <p:nvPr/>
            </p:nvSpPr>
            <p:spPr>
              <a:xfrm>
                <a:off x="320360" y="2473340"/>
                <a:ext cx="540642" cy="1187187"/>
              </a:xfrm>
              <a:custGeom>
                <a:avLst/>
                <a:gdLst/>
                <a:ahLst/>
                <a:cxnLst/>
                <a:rect l="l" t="t" r="r" b="b"/>
                <a:pathLst>
                  <a:path w="5767" h="12664" extrusionOk="0">
                    <a:moveTo>
                      <a:pt x="3395" y="1"/>
                    </a:moveTo>
                    <a:lnTo>
                      <a:pt x="1806" y="588"/>
                    </a:lnTo>
                    <a:cubicBezTo>
                      <a:pt x="1806" y="588"/>
                      <a:pt x="1676" y="2285"/>
                      <a:pt x="1654" y="2394"/>
                    </a:cubicBezTo>
                    <a:cubicBezTo>
                      <a:pt x="1632" y="2524"/>
                      <a:pt x="566" y="2851"/>
                      <a:pt x="392" y="3090"/>
                    </a:cubicBezTo>
                    <a:cubicBezTo>
                      <a:pt x="283" y="3221"/>
                      <a:pt x="305" y="3525"/>
                      <a:pt x="261" y="3721"/>
                    </a:cubicBezTo>
                    <a:cubicBezTo>
                      <a:pt x="240" y="3917"/>
                      <a:pt x="0" y="4635"/>
                      <a:pt x="174" y="5527"/>
                    </a:cubicBezTo>
                    <a:cubicBezTo>
                      <a:pt x="196" y="5658"/>
                      <a:pt x="348" y="7725"/>
                      <a:pt x="348" y="8312"/>
                    </a:cubicBezTo>
                    <a:cubicBezTo>
                      <a:pt x="348" y="8900"/>
                      <a:pt x="174" y="11228"/>
                      <a:pt x="348" y="11511"/>
                    </a:cubicBezTo>
                    <a:cubicBezTo>
                      <a:pt x="522" y="11815"/>
                      <a:pt x="1436" y="12664"/>
                      <a:pt x="1545" y="12664"/>
                    </a:cubicBezTo>
                    <a:cubicBezTo>
                      <a:pt x="1654" y="12664"/>
                      <a:pt x="4482" y="11554"/>
                      <a:pt x="4352" y="10662"/>
                    </a:cubicBezTo>
                    <a:cubicBezTo>
                      <a:pt x="4200" y="9770"/>
                      <a:pt x="3764" y="8334"/>
                      <a:pt x="3982" y="7420"/>
                    </a:cubicBezTo>
                    <a:cubicBezTo>
                      <a:pt x="4178" y="6506"/>
                      <a:pt x="5766" y="3721"/>
                      <a:pt x="5483" y="3090"/>
                    </a:cubicBezTo>
                    <a:cubicBezTo>
                      <a:pt x="5244" y="2590"/>
                      <a:pt x="3960" y="2329"/>
                      <a:pt x="3612" y="2046"/>
                    </a:cubicBezTo>
                    <a:cubicBezTo>
                      <a:pt x="3482" y="1959"/>
                      <a:pt x="3395" y="1"/>
                      <a:pt x="3395" y="1"/>
                    </a:cubicBezTo>
                    <a:close/>
                  </a:path>
                </a:pathLst>
              </a:custGeom>
              <a:solidFill>
                <a:srgbClr val="FFBD9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89" name="Google Shape;189;p13"/>
              <p:cNvSpPr/>
              <p:nvPr/>
            </p:nvSpPr>
            <p:spPr>
              <a:xfrm>
                <a:off x="324391" y="2665051"/>
                <a:ext cx="524330" cy="757178"/>
              </a:xfrm>
              <a:custGeom>
                <a:avLst/>
                <a:gdLst/>
                <a:ahLst/>
                <a:cxnLst/>
                <a:rect l="l" t="t" r="r" b="b"/>
                <a:pathLst>
                  <a:path w="5593" h="8077" extrusionOk="0">
                    <a:moveTo>
                      <a:pt x="3569" y="1"/>
                    </a:moveTo>
                    <a:lnTo>
                      <a:pt x="1850" y="1023"/>
                    </a:lnTo>
                    <a:lnTo>
                      <a:pt x="1611" y="349"/>
                    </a:lnTo>
                    <a:cubicBezTo>
                      <a:pt x="1611" y="349"/>
                      <a:pt x="479" y="719"/>
                      <a:pt x="349" y="958"/>
                    </a:cubicBezTo>
                    <a:cubicBezTo>
                      <a:pt x="197" y="1197"/>
                      <a:pt x="131" y="1807"/>
                      <a:pt x="88" y="2003"/>
                    </a:cubicBezTo>
                    <a:cubicBezTo>
                      <a:pt x="23" y="2198"/>
                      <a:pt x="1" y="3112"/>
                      <a:pt x="88" y="3895"/>
                    </a:cubicBezTo>
                    <a:cubicBezTo>
                      <a:pt x="131" y="4352"/>
                      <a:pt x="110" y="4962"/>
                      <a:pt x="197" y="5723"/>
                    </a:cubicBezTo>
                    <a:cubicBezTo>
                      <a:pt x="262" y="6398"/>
                      <a:pt x="175" y="8073"/>
                      <a:pt x="175" y="8073"/>
                    </a:cubicBezTo>
                    <a:cubicBezTo>
                      <a:pt x="175" y="8073"/>
                      <a:pt x="279" y="8077"/>
                      <a:pt x="467" y="8077"/>
                    </a:cubicBezTo>
                    <a:cubicBezTo>
                      <a:pt x="749" y="8077"/>
                      <a:pt x="1219" y="8069"/>
                      <a:pt x="1807" y="8030"/>
                    </a:cubicBezTo>
                    <a:cubicBezTo>
                      <a:pt x="2960" y="7986"/>
                      <a:pt x="4113" y="7812"/>
                      <a:pt x="4157" y="7768"/>
                    </a:cubicBezTo>
                    <a:cubicBezTo>
                      <a:pt x="4374" y="7573"/>
                      <a:pt x="4070" y="5810"/>
                      <a:pt x="4113" y="5614"/>
                    </a:cubicBezTo>
                    <a:cubicBezTo>
                      <a:pt x="4157" y="5419"/>
                      <a:pt x="5549" y="2024"/>
                      <a:pt x="5571" y="1567"/>
                    </a:cubicBezTo>
                    <a:cubicBezTo>
                      <a:pt x="5593" y="1132"/>
                      <a:pt x="5419" y="828"/>
                      <a:pt x="5070" y="654"/>
                    </a:cubicBezTo>
                    <a:cubicBezTo>
                      <a:pt x="4744" y="479"/>
                      <a:pt x="3569" y="1"/>
                      <a:pt x="3569" y="1"/>
                    </a:cubicBezTo>
                    <a:close/>
                  </a:path>
                </a:pathLst>
              </a:custGeom>
              <a:solidFill>
                <a:schemeClr val="dk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90" name="Google Shape;190;p13"/>
              <p:cNvSpPr/>
              <p:nvPr/>
            </p:nvSpPr>
            <p:spPr>
              <a:xfrm>
                <a:off x="338734" y="2720174"/>
                <a:ext cx="544673" cy="683401"/>
              </a:xfrm>
              <a:custGeom>
                <a:avLst/>
                <a:gdLst/>
                <a:ahLst/>
                <a:cxnLst/>
                <a:rect l="l" t="t" r="r" b="b"/>
                <a:pathLst>
                  <a:path w="5810" h="7290" extrusionOk="0">
                    <a:moveTo>
                      <a:pt x="4700" y="0"/>
                    </a:moveTo>
                    <a:lnTo>
                      <a:pt x="4700" y="0"/>
                    </a:lnTo>
                    <a:cubicBezTo>
                      <a:pt x="4700" y="0"/>
                      <a:pt x="5809" y="610"/>
                      <a:pt x="4722" y="1480"/>
                    </a:cubicBezTo>
                    <a:cubicBezTo>
                      <a:pt x="4243" y="1850"/>
                      <a:pt x="1958" y="2415"/>
                      <a:pt x="1523" y="2546"/>
                    </a:cubicBezTo>
                    <a:cubicBezTo>
                      <a:pt x="0" y="3025"/>
                      <a:pt x="2372" y="6419"/>
                      <a:pt x="2546" y="6680"/>
                    </a:cubicBezTo>
                    <a:cubicBezTo>
                      <a:pt x="2720" y="6941"/>
                      <a:pt x="2720" y="7289"/>
                      <a:pt x="2720" y="7289"/>
                    </a:cubicBezTo>
                    <a:lnTo>
                      <a:pt x="4199" y="7115"/>
                    </a:lnTo>
                    <a:cubicBezTo>
                      <a:pt x="4208" y="7117"/>
                      <a:pt x="4217" y="7118"/>
                      <a:pt x="4225" y="7118"/>
                    </a:cubicBezTo>
                    <a:cubicBezTo>
                      <a:pt x="4630" y="7118"/>
                      <a:pt x="3963" y="4995"/>
                      <a:pt x="4134" y="4526"/>
                    </a:cubicBezTo>
                    <a:cubicBezTo>
                      <a:pt x="4308" y="4047"/>
                      <a:pt x="5418" y="1349"/>
                      <a:pt x="5418" y="979"/>
                    </a:cubicBezTo>
                    <a:cubicBezTo>
                      <a:pt x="5418" y="196"/>
                      <a:pt x="4700" y="0"/>
                      <a:pt x="4700" y="0"/>
                    </a:cubicBezTo>
                    <a:close/>
                  </a:path>
                </a:pathLst>
              </a:custGeom>
              <a:solidFill>
                <a:schemeClr val="lt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91" name="Google Shape;191;p13"/>
              <p:cNvSpPr/>
              <p:nvPr/>
            </p:nvSpPr>
            <p:spPr>
              <a:xfrm>
                <a:off x="483479" y="2538588"/>
                <a:ext cx="167433" cy="126556"/>
              </a:xfrm>
              <a:custGeom>
                <a:avLst/>
                <a:gdLst/>
                <a:ahLst/>
                <a:cxnLst/>
                <a:rect l="l" t="t" r="r" b="b"/>
                <a:pathLst>
                  <a:path w="1786" h="1350" extrusionOk="0">
                    <a:moveTo>
                      <a:pt x="1742" y="1"/>
                    </a:moveTo>
                    <a:lnTo>
                      <a:pt x="1" y="632"/>
                    </a:lnTo>
                    <a:lnTo>
                      <a:pt x="1241" y="1350"/>
                    </a:lnTo>
                    <a:lnTo>
                      <a:pt x="1785" y="1023"/>
                    </a:lnTo>
                    <a:lnTo>
                      <a:pt x="1742" y="1"/>
                    </a:lnTo>
                    <a:close/>
                  </a:path>
                </a:pathLst>
              </a:custGeom>
              <a:solidFill>
                <a:srgbClr val="FFA47C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92" name="Google Shape;192;p13"/>
              <p:cNvSpPr/>
              <p:nvPr/>
            </p:nvSpPr>
            <p:spPr>
              <a:xfrm>
                <a:off x="399857" y="2253131"/>
                <a:ext cx="324460" cy="344325"/>
              </a:xfrm>
              <a:custGeom>
                <a:avLst/>
                <a:gdLst/>
                <a:ahLst/>
                <a:cxnLst/>
                <a:rect l="l" t="t" r="r" b="b"/>
                <a:pathLst>
                  <a:path w="3461" h="3673" extrusionOk="0">
                    <a:moveTo>
                      <a:pt x="1723" y="1"/>
                    </a:moveTo>
                    <a:cubicBezTo>
                      <a:pt x="1240" y="1"/>
                      <a:pt x="765" y="184"/>
                      <a:pt x="523" y="391"/>
                    </a:cubicBezTo>
                    <a:cubicBezTo>
                      <a:pt x="1" y="826"/>
                      <a:pt x="218" y="1610"/>
                      <a:pt x="240" y="1675"/>
                    </a:cubicBezTo>
                    <a:cubicBezTo>
                      <a:pt x="262" y="1740"/>
                      <a:pt x="110" y="2415"/>
                      <a:pt x="110" y="2524"/>
                    </a:cubicBezTo>
                    <a:cubicBezTo>
                      <a:pt x="131" y="2611"/>
                      <a:pt x="218" y="2654"/>
                      <a:pt x="262" y="2654"/>
                    </a:cubicBezTo>
                    <a:cubicBezTo>
                      <a:pt x="305" y="2654"/>
                      <a:pt x="371" y="3590"/>
                      <a:pt x="480" y="3655"/>
                    </a:cubicBezTo>
                    <a:cubicBezTo>
                      <a:pt x="517" y="3668"/>
                      <a:pt x="583" y="3673"/>
                      <a:pt x="665" y="3673"/>
                    </a:cubicBezTo>
                    <a:cubicBezTo>
                      <a:pt x="1007" y="3673"/>
                      <a:pt x="1632" y="3581"/>
                      <a:pt x="1720" y="3546"/>
                    </a:cubicBezTo>
                    <a:cubicBezTo>
                      <a:pt x="2242" y="3350"/>
                      <a:pt x="2503" y="3133"/>
                      <a:pt x="2786" y="2741"/>
                    </a:cubicBezTo>
                    <a:cubicBezTo>
                      <a:pt x="3156" y="2241"/>
                      <a:pt x="3460" y="1414"/>
                      <a:pt x="2873" y="544"/>
                    </a:cubicBezTo>
                    <a:cubicBezTo>
                      <a:pt x="2587" y="145"/>
                      <a:pt x="2151" y="1"/>
                      <a:pt x="1723" y="1"/>
                    </a:cubicBezTo>
                    <a:close/>
                  </a:path>
                </a:pathLst>
              </a:custGeom>
              <a:solidFill>
                <a:srgbClr val="FFBD9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93" name="Google Shape;193;p13"/>
              <p:cNvSpPr/>
              <p:nvPr/>
            </p:nvSpPr>
            <p:spPr>
              <a:xfrm>
                <a:off x="422356" y="2244225"/>
                <a:ext cx="301679" cy="304671"/>
              </a:xfrm>
              <a:custGeom>
                <a:avLst/>
                <a:gdLst/>
                <a:ahLst/>
                <a:cxnLst/>
                <a:rect l="l" t="t" r="r" b="b"/>
                <a:pathLst>
                  <a:path w="3218" h="3250" extrusionOk="0">
                    <a:moveTo>
                      <a:pt x="1361" y="0"/>
                    </a:moveTo>
                    <a:cubicBezTo>
                      <a:pt x="1321" y="0"/>
                      <a:pt x="1287" y="3"/>
                      <a:pt x="1262" y="8"/>
                    </a:cubicBezTo>
                    <a:cubicBezTo>
                      <a:pt x="1001" y="51"/>
                      <a:pt x="240" y="73"/>
                      <a:pt x="0" y="878"/>
                    </a:cubicBezTo>
                    <a:cubicBezTo>
                      <a:pt x="0" y="878"/>
                      <a:pt x="161" y="798"/>
                      <a:pt x="420" y="798"/>
                    </a:cubicBezTo>
                    <a:cubicBezTo>
                      <a:pt x="718" y="798"/>
                      <a:pt x="1145" y="903"/>
                      <a:pt x="1610" y="1357"/>
                    </a:cubicBezTo>
                    <a:cubicBezTo>
                      <a:pt x="1784" y="1531"/>
                      <a:pt x="1393" y="2270"/>
                      <a:pt x="1436" y="2336"/>
                    </a:cubicBezTo>
                    <a:cubicBezTo>
                      <a:pt x="1439" y="2342"/>
                      <a:pt x="1445" y="2344"/>
                      <a:pt x="1453" y="2344"/>
                    </a:cubicBezTo>
                    <a:cubicBezTo>
                      <a:pt x="1561" y="2344"/>
                      <a:pt x="2089" y="1892"/>
                      <a:pt x="2132" y="1892"/>
                    </a:cubicBezTo>
                    <a:cubicBezTo>
                      <a:pt x="2135" y="1892"/>
                      <a:pt x="2135" y="1895"/>
                      <a:pt x="2133" y="1901"/>
                    </a:cubicBezTo>
                    <a:cubicBezTo>
                      <a:pt x="1850" y="2749"/>
                      <a:pt x="2111" y="3250"/>
                      <a:pt x="2198" y="3250"/>
                    </a:cubicBezTo>
                    <a:cubicBezTo>
                      <a:pt x="2200" y="3250"/>
                      <a:pt x="2202" y="3250"/>
                      <a:pt x="2204" y="3250"/>
                    </a:cubicBezTo>
                    <a:cubicBezTo>
                      <a:pt x="2451" y="3250"/>
                      <a:pt x="3217" y="2087"/>
                      <a:pt x="2894" y="1096"/>
                    </a:cubicBezTo>
                    <a:cubicBezTo>
                      <a:pt x="2601" y="198"/>
                      <a:pt x="1714" y="0"/>
                      <a:pt x="1361" y="0"/>
                    </a:cubicBezTo>
                    <a:close/>
                  </a:path>
                </a:pathLst>
              </a:custGeom>
              <a:solidFill>
                <a:schemeClr val="accent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94" name="Google Shape;194;p13"/>
              <p:cNvSpPr/>
              <p:nvPr/>
            </p:nvSpPr>
            <p:spPr>
              <a:xfrm>
                <a:off x="569164" y="2410999"/>
                <a:ext cx="63373" cy="93651"/>
              </a:xfrm>
              <a:custGeom>
                <a:avLst/>
                <a:gdLst/>
                <a:ahLst/>
                <a:cxnLst/>
                <a:rect l="l" t="t" r="r" b="b"/>
                <a:pathLst>
                  <a:path w="676" h="999" extrusionOk="0">
                    <a:moveTo>
                      <a:pt x="409" y="0"/>
                    </a:moveTo>
                    <a:cubicBezTo>
                      <a:pt x="309" y="0"/>
                      <a:pt x="224" y="83"/>
                      <a:pt x="153" y="296"/>
                    </a:cubicBezTo>
                    <a:cubicBezTo>
                      <a:pt x="44" y="578"/>
                      <a:pt x="1" y="948"/>
                      <a:pt x="153" y="992"/>
                    </a:cubicBezTo>
                    <a:cubicBezTo>
                      <a:pt x="167" y="996"/>
                      <a:pt x="181" y="999"/>
                      <a:pt x="195" y="999"/>
                    </a:cubicBezTo>
                    <a:cubicBezTo>
                      <a:pt x="323" y="999"/>
                      <a:pt x="491" y="834"/>
                      <a:pt x="588" y="600"/>
                    </a:cubicBezTo>
                    <a:cubicBezTo>
                      <a:pt x="675" y="317"/>
                      <a:pt x="632" y="56"/>
                      <a:pt x="479" y="13"/>
                    </a:cubicBezTo>
                    <a:cubicBezTo>
                      <a:pt x="455" y="5"/>
                      <a:pt x="432" y="0"/>
                      <a:pt x="409" y="0"/>
                    </a:cubicBezTo>
                    <a:close/>
                  </a:path>
                </a:pathLst>
              </a:custGeom>
              <a:solidFill>
                <a:srgbClr val="FFBD9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95" name="Google Shape;195;p13"/>
              <p:cNvSpPr/>
              <p:nvPr/>
            </p:nvSpPr>
            <p:spPr>
              <a:xfrm>
                <a:off x="471292" y="4945518"/>
                <a:ext cx="104153" cy="18468"/>
              </a:xfrm>
              <a:custGeom>
                <a:avLst/>
                <a:gdLst/>
                <a:ahLst/>
                <a:cxnLst/>
                <a:rect l="l" t="t" r="r" b="b"/>
                <a:pathLst>
                  <a:path w="1111" h="197" extrusionOk="0">
                    <a:moveTo>
                      <a:pt x="0" y="0"/>
                    </a:moveTo>
                    <a:lnTo>
                      <a:pt x="0" y="196"/>
                    </a:lnTo>
                    <a:lnTo>
                      <a:pt x="1110" y="196"/>
                    </a:lnTo>
                    <a:lnTo>
                      <a:pt x="1110" y="0"/>
                    </a:ln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96" name="Google Shape;196;p13"/>
              <p:cNvSpPr/>
              <p:nvPr/>
            </p:nvSpPr>
            <p:spPr>
              <a:xfrm>
                <a:off x="202052" y="4807430"/>
                <a:ext cx="393740" cy="172866"/>
              </a:xfrm>
              <a:custGeom>
                <a:avLst/>
                <a:gdLst/>
                <a:ahLst/>
                <a:cxnLst/>
                <a:rect l="l" t="t" r="r" b="b"/>
                <a:pathLst>
                  <a:path w="4200" h="1844" extrusionOk="0">
                    <a:moveTo>
                      <a:pt x="3753" y="1"/>
                    </a:moveTo>
                    <a:cubicBezTo>
                      <a:pt x="3431" y="1"/>
                      <a:pt x="2807" y="37"/>
                      <a:pt x="2807" y="37"/>
                    </a:cubicBezTo>
                    <a:cubicBezTo>
                      <a:pt x="2807" y="37"/>
                      <a:pt x="2241" y="233"/>
                      <a:pt x="1393" y="1016"/>
                    </a:cubicBezTo>
                    <a:cubicBezTo>
                      <a:pt x="1066" y="1321"/>
                      <a:pt x="0" y="1125"/>
                      <a:pt x="0" y="1691"/>
                    </a:cubicBezTo>
                    <a:cubicBezTo>
                      <a:pt x="0" y="1821"/>
                      <a:pt x="566" y="1843"/>
                      <a:pt x="892" y="1843"/>
                    </a:cubicBezTo>
                    <a:cubicBezTo>
                      <a:pt x="2002" y="1843"/>
                      <a:pt x="2154" y="1604"/>
                      <a:pt x="2590" y="1539"/>
                    </a:cubicBezTo>
                    <a:cubicBezTo>
                      <a:pt x="3025" y="1495"/>
                      <a:pt x="3525" y="1473"/>
                      <a:pt x="3939" y="1473"/>
                    </a:cubicBezTo>
                    <a:cubicBezTo>
                      <a:pt x="4091" y="1473"/>
                      <a:pt x="4200" y="1016"/>
                      <a:pt x="4200" y="799"/>
                    </a:cubicBezTo>
                    <a:cubicBezTo>
                      <a:pt x="4178" y="603"/>
                      <a:pt x="4091" y="211"/>
                      <a:pt x="3939" y="16"/>
                    </a:cubicBezTo>
                    <a:cubicBezTo>
                      <a:pt x="3933" y="5"/>
                      <a:pt x="3860" y="1"/>
                      <a:pt x="3753" y="1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97" name="Google Shape;197;p13"/>
              <p:cNvSpPr/>
              <p:nvPr/>
            </p:nvSpPr>
            <p:spPr>
              <a:xfrm>
                <a:off x="328516" y="3380990"/>
                <a:ext cx="344803" cy="1478921"/>
              </a:xfrm>
              <a:custGeom>
                <a:avLst/>
                <a:gdLst/>
                <a:ahLst/>
                <a:cxnLst/>
                <a:rect l="l" t="t" r="r" b="b"/>
                <a:pathLst>
                  <a:path w="3678" h="15776" extrusionOk="0">
                    <a:moveTo>
                      <a:pt x="174" y="1"/>
                    </a:moveTo>
                    <a:cubicBezTo>
                      <a:pt x="174" y="305"/>
                      <a:pt x="0" y="2438"/>
                      <a:pt x="22" y="3178"/>
                    </a:cubicBezTo>
                    <a:cubicBezTo>
                      <a:pt x="131" y="5484"/>
                      <a:pt x="457" y="8312"/>
                      <a:pt x="501" y="8726"/>
                    </a:cubicBezTo>
                    <a:cubicBezTo>
                      <a:pt x="566" y="9357"/>
                      <a:pt x="914" y="15406"/>
                      <a:pt x="914" y="15406"/>
                    </a:cubicBezTo>
                    <a:cubicBezTo>
                      <a:pt x="914" y="15406"/>
                      <a:pt x="1371" y="15775"/>
                      <a:pt x="1893" y="15775"/>
                    </a:cubicBezTo>
                    <a:cubicBezTo>
                      <a:pt x="2720" y="15775"/>
                      <a:pt x="3046" y="15536"/>
                      <a:pt x="3046" y="15536"/>
                    </a:cubicBezTo>
                    <a:cubicBezTo>
                      <a:pt x="3046" y="15536"/>
                      <a:pt x="2981" y="13077"/>
                      <a:pt x="3003" y="11859"/>
                    </a:cubicBezTo>
                    <a:cubicBezTo>
                      <a:pt x="3025" y="10836"/>
                      <a:pt x="2590" y="9292"/>
                      <a:pt x="2524" y="8922"/>
                    </a:cubicBezTo>
                    <a:cubicBezTo>
                      <a:pt x="2481" y="8530"/>
                      <a:pt x="2611" y="8204"/>
                      <a:pt x="2829" y="6594"/>
                    </a:cubicBezTo>
                    <a:cubicBezTo>
                      <a:pt x="3046" y="4983"/>
                      <a:pt x="3677" y="2916"/>
                      <a:pt x="3612" y="2285"/>
                    </a:cubicBezTo>
                    <a:cubicBezTo>
                      <a:pt x="3525" y="1633"/>
                      <a:pt x="2067" y="153"/>
                      <a:pt x="2067" y="153"/>
                    </a:cubicBezTo>
                    <a:lnTo>
                      <a:pt x="174" y="1"/>
                    </a:ln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98" name="Google Shape;198;p13"/>
              <p:cNvSpPr/>
              <p:nvPr/>
            </p:nvSpPr>
            <p:spPr>
              <a:xfrm>
                <a:off x="497822" y="2709955"/>
                <a:ext cx="85779" cy="51091"/>
              </a:xfrm>
              <a:custGeom>
                <a:avLst/>
                <a:gdLst/>
                <a:ahLst/>
                <a:cxnLst/>
                <a:rect l="l" t="t" r="r" b="b"/>
                <a:pathLst>
                  <a:path w="915" h="545" extrusionOk="0">
                    <a:moveTo>
                      <a:pt x="914" y="0"/>
                    </a:moveTo>
                    <a:lnTo>
                      <a:pt x="87" y="131"/>
                    </a:lnTo>
                    <a:lnTo>
                      <a:pt x="0" y="544"/>
                    </a:lnTo>
                    <a:lnTo>
                      <a:pt x="914" y="0"/>
                    </a:lnTo>
                    <a:close/>
                  </a:path>
                </a:pathLst>
              </a:custGeom>
              <a:solidFill>
                <a:srgbClr val="B8D1FF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199" name="Google Shape;199;p13"/>
              <p:cNvSpPr/>
              <p:nvPr/>
            </p:nvSpPr>
            <p:spPr>
              <a:xfrm>
                <a:off x="465199" y="2713987"/>
                <a:ext cx="32718" cy="47060"/>
              </a:xfrm>
              <a:custGeom>
                <a:avLst/>
                <a:gdLst/>
                <a:ahLst/>
                <a:cxnLst/>
                <a:rect l="l" t="t" r="r" b="b"/>
                <a:pathLst>
                  <a:path w="349" h="502" extrusionOk="0">
                    <a:moveTo>
                      <a:pt x="218" y="1"/>
                    </a:moveTo>
                    <a:lnTo>
                      <a:pt x="0" y="175"/>
                    </a:lnTo>
                    <a:lnTo>
                      <a:pt x="348" y="501"/>
                    </a:lnTo>
                    <a:lnTo>
                      <a:pt x="218" y="1"/>
                    </a:lnTo>
                    <a:close/>
                  </a:path>
                </a:pathLst>
              </a:custGeom>
              <a:solidFill>
                <a:srgbClr val="B8D1FF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00" name="Google Shape;200;p13"/>
              <p:cNvSpPr/>
              <p:nvPr/>
            </p:nvSpPr>
            <p:spPr>
              <a:xfrm>
                <a:off x="467167" y="3387177"/>
                <a:ext cx="493768" cy="1566573"/>
              </a:xfrm>
              <a:custGeom>
                <a:avLst/>
                <a:gdLst/>
                <a:ahLst/>
                <a:cxnLst/>
                <a:rect l="l" t="t" r="r" b="b"/>
                <a:pathLst>
                  <a:path w="5267" h="16711" extrusionOk="0">
                    <a:moveTo>
                      <a:pt x="2873" y="0"/>
                    </a:moveTo>
                    <a:lnTo>
                      <a:pt x="1" y="44"/>
                    </a:lnTo>
                    <a:lnTo>
                      <a:pt x="218" y="2198"/>
                    </a:lnTo>
                    <a:cubicBezTo>
                      <a:pt x="218" y="2198"/>
                      <a:pt x="2024" y="8856"/>
                      <a:pt x="2198" y="9791"/>
                    </a:cubicBezTo>
                    <a:cubicBezTo>
                      <a:pt x="2373" y="10727"/>
                      <a:pt x="3439" y="16710"/>
                      <a:pt x="3439" y="16710"/>
                    </a:cubicBezTo>
                    <a:lnTo>
                      <a:pt x="5266" y="16427"/>
                    </a:lnTo>
                    <a:cubicBezTo>
                      <a:pt x="5266" y="16427"/>
                      <a:pt x="5136" y="13577"/>
                      <a:pt x="4896" y="12163"/>
                    </a:cubicBezTo>
                    <a:cubicBezTo>
                      <a:pt x="4679" y="10727"/>
                      <a:pt x="4374" y="9291"/>
                      <a:pt x="4287" y="8834"/>
                    </a:cubicBezTo>
                    <a:cubicBezTo>
                      <a:pt x="4222" y="8355"/>
                      <a:pt x="3939" y="3373"/>
                      <a:pt x="3700" y="2394"/>
                    </a:cubicBezTo>
                    <a:cubicBezTo>
                      <a:pt x="3460" y="1436"/>
                      <a:pt x="2873" y="0"/>
                      <a:pt x="2873" y="0"/>
                    </a:cubicBez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01" name="Google Shape;201;p13"/>
              <p:cNvSpPr/>
              <p:nvPr/>
            </p:nvSpPr>
            <p:spPr>
              <a:xfrm>
                <a:off x="587538" y="3387177"/>
                <a:ext cx="373396" cy="1548199"/>
              </a:xfrm>
              <a:custGeom>
                <a:avLst/>
                <a:gdLst/>
                <a:ahLst/>
                <a:cxnLst/>
                <a:rect l="l" t="t" r="r" b="b"/>
                <a:pathLst>
                  <a:path w="3983" h="16515" extrusionOk="0">
                    <a:moveTo>
                      <a:pt x="1589" y="0"/>
                    </a:moveTo>
                    <a:lnTo>
                      <a:pt x="1" y="44"/>
                    </a:lnTo>
                    <a:cubicBezTo>
                      <a:pt x="1" y="44"/>
                      <a:pt x="1393" y="3438"/>
                      <a:pt x="1545" y="4069"/>
                    </a:cubicBezTo>
                    <a:cubicBezTo>
                      <a:pt x="1698" y="4722"/>
                      <a:pt x="2133" y="9052"/>
                      <a:pt x="2176" y="9313"/>
                    </a:cubicBezTo>
                    <a:cubicBezTo>
                      <a:pt x="2198" y="9552"/>
                      <a:pt x="3330" y="16210"/>
                      <a:pt x="3373" y="16515"/>
                    </a:cubicBezTo>
                    <a:lnTo>
                      <a:pt x="3982" y="16427"/>
                    </a:lnTo>
                    <a:cubicBezTo>
                      <a:pt x="3982" y="16427"/>
                      <a:pt x="3852" y="13577"/>
                      <a:pt x="3612" y="12163"/>
                    </a:cubicBezTo>
                    <a:cubicBezTo>
                      <a:pt x="3395" y="10727"/>
                      <a:pt x="3090" y="9291"/>
                      <a:pt x="3003" y="8834"/>
                    </a:cubicBezTo>
                    <a:cubicBezTo>
                      <a:pt x="2938" y="8355"/>
                      <a:pt x="2655" y="3373"/>
                      <a:pt x="2416" y="2394"/>
                    </a:cubicBezTo>
                    <a:cubicBezTo>
                      <a:pt x="2176" y="1436"/>
                      <a:pt x="1589" y="0"/>
                      <a:pt x="1589" y="0"/>
                    </a:cubicBezTo>
                    <a:close/>
                  </a:path>
                </a:pathLst>
              </a:custGeom>
              <a:solidFill>
                <a:srgbClr val="FFFFFF">
                  <a:alpha val="18240"/>
                </a:srgbClr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02" name="Google Shape;202;p13"/>
              <p:cNvSpPr/>
              <p:nvPr/>
            </p:nvSpPr>
            <p:spPr>
              <a:xfrm>
                <a:off x="342766" y="3380990"/>
                <a:ext cx="408083" cy="51091"/>
              </a:xfrm>
              <a:custGeom>
                <a:avLst/>
                <a:gdLst/>
                <a:ahLst/>
                <a:cxnLst/>
                <a:rect l="l" t="t" r="r" b="b"/>
                <a:pathLst>
                  <a:path w="4353" h="545" extrusionOk="0">
                    <a:moveTo>
                      <a:pt x="22" y="1"/>
                    </a:moveTo>
                    <a:lnTo>
                      <a:pt x="1" y="436"/>
                    </a:lnTo>
                    <a:cubicBezTo>
                      <a:pt x="1" y="436"/>
                      <a:pt x="1067" y="545"/>
                      <a:pt x="1567" y="545"/>
                    </a:cubicBezTo>
                    <a:cubicBezTo>
                      <a:pt x="2089" y="545"/>
                      <a:pt x="4352" y="414"/>
                      <a:pt x="4352" y="414"/>
                    </a:cubicBezTo>
                    <a:lnTo>
                      <a:pt x="4243" y="66"/>
                    </a:lnTo>
                    <a:cubicBezTo>
                      <a:pt x="4243" y="66"/>
                      <a:pt x="1437" y="110"/>
                      <a:pt x="1284" y="110"/>
                    </a:cubicBezTo>
                    <a:cubicBezTo>
                      <a:pt x="1110" y="110"/>
                      <a:pt x="22" y="1"/>
                      <a:pt x="22" y="1"/>
                    </a:cubicBez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03" name="Google Shape;203;p13"/>
              <p:cNvSpPr/>
              <p:nvPr/>
            </p:nvSpPr>
            <p:spPr>
              <a:xfrm>
                <a:off x="467167" y="2720174"/>
                <a:ext cx="61311" cy="57184"/>
              </a:xfrm>
              <a:custGeom>
                <a:avLst/>
                <a:gdLst/>
                <a:ahLst/>
                <a:cxnLst/>
                <a:rect l="l" t="t" r="r" b="b"/>
                <a:pathLst>
                  <a:path w="654" h="610" extrusionOk="0">
                    <a:moveTo>
                      <a:pt x="1" y="0"/>
                    </a:moveTo>
                    <a:lnTo>
                      <a:pt x="66" y="522"/>
                    </a:lnTo>
                    <a:lnTo>
                      <a:pt x="393" y="609"/>
                    </a:lnTo>
                    <a:lnTo>
                      <a:pt x="654" y="174"/>
                    </a:lnTo>
                    <a:lnTo>
                      <a:pt x="1" y="0"/>
                    </a:ln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04" name="Google Shape;204;p13"/>
              <p:cNvSpPr/>
              <p:nvPr/>
            </p:nvSpPr>
            <p:spPr>
              <a:xfrm>
                <a:off x="393764" y="2769109"/>
                <a:ext cx="110247" cy="718087"/>
              </a:xfrm>
              <a:custGeom>
                <a:avLst/>
                <a:gdLst/>
                <a:ahLst/>
                <a:cxnLst/>
                <a:rect l="l" t="t" r="r" b="b"/>
                <a:pathLst>
                  <a:path w="1176" h="7660" extrusionOk="0">
                    <a:moveTo>
                      <a:pt x="849" y="0"/>
                    </a:moveTo>
                    <a:cubicBezTo>
                      <a:pt x="849" y="0"/>
                      <a:pt x="349" y="936"/>
                      <a:pt x="175" y="2350"/>
                    </a:cubicBezTo>
                    <a:cubicBezTo>
                      <a:pt x="1" y="3765"/>
                      <a:pt x="240" y="7007"/>
                      <a:pt x="240" y="7007"/>
                    </a:cubicBezTo>
                    <a:lnTo>
                      <a:pt x="610" y="7659"/>
                    </a:lnTo>
                    <a:lnTo>
                      <a:pt x="1045" y="6898"/>
                    </a:lnTo>
                    <a:cubicBezTo>
                      <a:pt x="1045" y="6898"/>
                      <a:pt x="588" y="3503"/>
                      <a:pt x="697" y="2459"/>
                    </a:cubicBezTo>
                    <a:cubicBezTo>
                      <a:pt x="784" y="1415"/>
                      <a:pt x="1176" y="87"/>
                      <a:pt x="1176" y="87"/>
                    </a:cubicBezTo>
                    <a:lnTo>
                      <a:pt x="849" y="0"/>
                    </a:lnTo>
                    <a:close/>
                  </a:path>
                </a:pathLst>
              </a:custGeom>
              <a:solidFill>
                <a:schemeClr val="dk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05" name="Google Shape;205;p13"/>
              <p:cNvSpPr/>
              <p:nvPr/>
            </p:nvSpPr>
            <p:spPr>
              <a:xfrm>
                <a:off x="505978" y="2634490"/>
                <a:ext cx="173433" cy="140805"/>
              </a:xfrm>
              <a:custGeom>
                <a:avLst/>
                <a:gdLst/>
                <a:ahLst/>
                <a:cxnLst/>
                <a:rect l="l" t="t" r="r" b="b"/>
                <a:pathLst>
                  <a:path w="1850" h="1502" extrusionOk="0">
                    <a:moveTo>
                      <a:pt x="1545" y="0"/>
                    </a:moveTo>
                    <a:lnTo>
                      <a:pt x="0" y="936"/>
                    </a:lnTo>
                    <a:lnTo>
                      <a:pt x="240" y="1502"/>
                    </a:lnTo>
                    <a:lnTo>
                      <a:pt x="1850" y="436"/>
                    </a:lnTo>
                    <a:lnTo>
                      <a:pt x="1545" y="0"/>
                    </a:lnTo>
                    <a:close/>
                  </a:path>
                </a:pathLst>
              </a:custGeom>
              <a:solidFill>
                <a:schemeClr val="accent6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06" name="Google Shape;206;p13"/>
              <p:cNvSpPr/>
              <p:nvPr/>
            </p:nvSpPr>
            <p:spPr>
              <a:xfrm>
                <a:off x="444762" y="2683425"/>
                <a:ext cx="40874" cy="69465"/>
              </a:xfrm>
              <a:custGeom>
                <a:avLst/>
                <a:gdLst/>
                <a:ahLst/>
                <a:cxnLst/>
                <a:rect l="l" t="t" r="r" b="b"/>
                <a:pathLst>
                  <a:path w="436" h="741" extrusionOk="0">
                    <a:moveTo>
                      <a:pt x="305" y="1"/>
                    </a:moveTo>
                    <a:lnTo>
                      <a:pt x="1" y="305"/>
                    </a:lnTo>
                    <a:lnTo>
                      <a:pt x="66" y="740"/>
                    </a:lnTo>
                    <a:lnTo>
                      <a:pt x="436" y="327"/>
                    </a:lnTo>
                    <a:lnTo>
                      <a:pt x="305" y="1"/>
                    </a:lnTo>
                    <a:close/>
                  </a:path>
                </a:pathLst>
              </a:custGeom>
              <a:solidFill>
                <a:schemeClr val="accent6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07" name="Google Shape;207;p13"/>
              <p:cNvSpPr/>
              <p:nvPr/>
            </p:nvSpPr>
            <p:spPr>
              <a:xfrm>
                <a:off x="675285" y="2725049"/>
                <a:ext cx="399833" cy="499286"/>
              </a:xfrm>
              <a:custGeom>
                <a:avLst/>
                <a:gdLst/>
                <a:ahLst/>
                <a:cxnLst/>
                <a:rect l="l" t="t" r="r" b="b"/>
                <a:pathLst>
                  <a:path w="4265" h="5326" extrusionOk="0">
                    <a:moveTo>
                      <a:pt x="1123" y="0"/>
                    </a:moveTo>
                    <a:cubicBezTo>
                      <a:pt x="939" y="0"/>
                      <a:pt x="751" y="76"/>
                      <a:pt x="566" y="253"/>
                    </a:cubicBezTo>
                    <a:cubicBezTo>
                      <a:pt x="0" y="797"/>
                      <a:pt x="305" y="1471"/>
                      <a:pt x="566" y="1928"/>
                    </a:cubicBezTo>
                    <a:cubicBezTo>
                      <a:pt x="827" y="2407"/>
                      <a:pt x="2851" y="5170"/>
                      <a:pt x="3112" y="5301"/>
                    </a:cubicBezTo>
                    <a:cubicBezTo>
                      <a:pt x="3143" y="5318"/>
                      <a:pt x="3182" y="5326"/>
                      <a:pt x="3224" y="5326"/>
                    </a:cubicBezTo>
                    <a:cubicBezTo>
                      <a:pt x="3562" y="5326"/>
                      <a:pt x="4183" y="4844"/>
                      <a:pt x="4221" y="4670"/>
                    </a:cubicBezTo>
                    <a:cubicBezTo>
                      <a:pt x="4265" y="4452"/>
                      <a:pt x="2415" y="1036"/>
                      <a:pt x="2002" y="536"/>
                    </a:cubicBezTo>
                    <a:cubicBezTo>
                      <a:pt x="1741" y="220"/>
                      <a:pt x="1438" y="0"/>
                      <a:pt x="1123" y="0"/>
                    </a:cubicBezTo>
                    <a:close/>
                  </a:path>
                </a:pathLst>
              </a:custGeom>
              <a:solidFill>
                <a:srgbClr val="FFBD9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08" name="Google Shape;208;p13"/>
              <p:cNvSpPr/>
              <p:nvPr/>
            </p:nvSpPr>
            <p:spPr>
              <a:xfrm>
                <a:off x="687472" y="2724955"/>
                <a:ext cx="330554" cy="372636"/>
              </a:xfrm>
              <a:custGeom>
                <a:avLst/>
                <a:gdLst/>
                <a:ahLst/>
                <a:cxnLst/>
                <a:rect l="l" t="t" r="r" b="b"/>
                <a:pathLst>
                  <a:path w="3526" h="3975" extrusionOk="0">
                    <a:moveTo>
                      <a:pt x="1004" y="0"/>
                    </a:moveTo>
                    <a:cubicBezTo>
                      <a:pt x="634" y="0"/>
                      <a:pt x="219" y="231"/>
                      <a:pt x="110" y="733"/>
                    </a:cubicBezTo>
                    <a:cubicBezTo>
                      <a:pt x="44" y="972"/>
                      <a:pt x="1" y="1581"/>
                      <a:pt x="305" y="1951"/>
                    </a:cubicBezTo>
                    <a:cubicBezTo>
                      <a:pt x="762" y="2495"/>
                      <a:pt x="1828" y="3974"/>
                      <a:pt x="1828" y="3974"/>
                    </a:cubicBezTo>
                    <a:cubicBezTo>
                      <a:pt x="1828" y="3974"/>
                      <a:pt x="2329" y="3887"/>
                      <a:pt x="2808" y="3518"/>
                    </a:cubicBezTo>
                    <a:cubicBezTo>
                      <a:pt x="3373" y="3061"/>
                      <a:pt x="3526" y="2582"/>
                      <a:pt x="3526" y="2582"/>
                    </a:cubicBezTo>
                    <a:cubicBezTo>
                      <a:pt x="3526" y="2582"/>
                      <a:pt x="1872" y="384"/>
                      <a:pt x="1393" y="102"/>
                    </a:cubicBezTo>
                    <a:cubicBezTo>
                      <a:pt x="1284" y="35"/>
                      <a:pt x="1147" y="0"/>
                      <a:pt x="1004" y="0"/>
                    </a:cubicBezTo>
                    <a:close/>
                  </a:path>
                </a:pathLst>
              </a:custGeom>
              <a:solidFill>
                <a:schemeClr val="dk2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09" name="Google Shape;209;p13"/>
              <p:cNvSpPr/>
              <p:nvPr/>
            </p:nvSpPr>
            <p:spPr>
              <a:xfrm>
                <a:off x="677253" y="3123938"/>
                <a:ext cx="432551" cy="369355"/>
              </a:xfrm>
              <a:custGeom>
                <a:avLst/>
                <a:gdLst/>
                <a:ahLst/>
                <a:cxnLst/>
                <a:rect l="l" t="t" r="r" b="b"/>
                <a:pathLst>
                  <a:path w="4614" h="3940" extrusionOk="0">
                    <a:moveTo>
                      <a:pt x="3446" y="1"/>
                    </a:moveTo>
                    <a:cubicBezTo>
                      <a:pt x="3062" y="1"/>
                      <a:pt x="2710" y="208"/>
                      <a:pt x="2612" y="306"/>
                    </a:cubicBezTo>
                    <a:cubicBezTo>
                      <a:pt x="1111" y="1720"/>
                      <a:pt x="1" y="3352"/>
                      <a:pt x="1" y="3352"/>
                    </a:cubicBezTo>
                    <a:lnTo>
                      <a:pt x="567" y="3940"/>
                    </a:lnTo>
                    <a:cubicBezTo>
                      <a:pt x="567" y="3940"/>
                      <a:pt x="2351" y="2721"/>
                      <a:pt x="2938" y="2242"/>
                    </a:cubicBezTo>
                    <a:cubicBezTo>
                      <a:pt x="3504" y="1764"/>
                      <a:pt x="4614" y="719"/>
                      <a:pt x="4070" y="241"/>
                    </a:cubicBezTo>
                    <a:cubicBezTo>
                      <a:pt x="3877" y="63"/>
                      <a:pt x="3657" y="1"/>
                      <a:pt x="3446" y="1"/>
                    </a:cubicBezTo>
                    <a:close/>
                  </a:path>
                </a:pathLst>
              </a:custGeom>
              <a:solidFill>
                <a:srgbClr val="FFBD9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10" name="Google Shape;210;p13"/>
              <p:cNvSpPr/>
              <p:nvPr/>
            </p:nvSpPr>
            <p:spPr>
              <a:xfrm>
                <a:off x="634505" y="3525734"/>
                <a:ext cx="65342" cy="73684"/>
              </a:xfrm>
              <a:custGeom>
                <a:avLst/>
                <a:gdLst/>
                <a:ahLst/>
                <a:cxnLst/>
                <a:rect l="l" t="t" r="r" b="b"/>
                <a:pathLst>
                  <a:path w="697" h="786" extrusionOk="0">
                    <a:moveTo>
                      <a:pt x="535" y="1"/>
                    </a:moveTo>
                    <a:cubicBezTo>
                      <a:pt x="488" y="1"/>
                      <a:pt x="442" y="25"/>
                      <a:pt x="413" y="67"/>
                    </a:cubicBezTo>
                    <a:lnTo>
                      <a:pt x="44" y="546"/>
                    </a:lnTo>
                    <a:cubicBezTo>
                      <a:pt x="0" y="611"/>
                      <a:pt x="22" y="698"/>
                      <a:pt x="87" y="763"/>
                    </a:cubicBezTo>
                    <a:cubicBezTo>
                      <a:pt x="110" y="779"/>
                      <a:pt x="136" y="786"/>
                      <a:pt x="162" y="786"/>
                    </a:cubicBezTo>
                    <a:cubicBezTo>
                      <a:pt x="209" y="786"/>
                      <a:pt x="255" y="762"/>
                      <a:pt x="283" y="720"/>
                    </a:cubicBezTo>
                    <a:lnTo>
                      <a:pt x="653" y="241"/>
                    </a:lnTo>
                    <a:cubicBezTo>
                      <a:pt x="696" y="176"/>
                      <a:pt x="675" y="89"/>
                      <a:pt x="609" y="23"/>
                    </a:cubicBezTo>
                    <a:cubicBezTo>
                      <a:pt x="586" y="8"/>
                      <a:pt x="560" y="1"/>
                      <a:pt x="535" y="1"/>
                    </a:cubicBezTo>
                    <a:close/>
                  </a:path>
                </a:pathLst>
              </a:custGeom>
              <a:solidFill>
                <a:srgbClr val="FFBD9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11" name="Google Shape;211;p13"/>
              <p:cNvSpPr/>
              <p:nvPr/>
            </p:nvSpPr>
            <p:spPr>
              <a:xfrm>
                <a:off x="614068" y="3513453"/>
                <a:ext cx="63280" cy="72465"/>
              </a:xfrm>
              <a:custGeom>
                <a:avLst/>
                <a:gdLst/>
                <a:ahLst/>
                <a:cxnLst/>
                <a:rect l="l" t="t" r="r" b="b"/>
                <a:pathLst>
                  <a:path w="675" h="773" extrusionOk="0">
                    <a:moveTo>
                      <a:pt x="517" y="0"/>
                    </a:moveTo>
                    <a:cubicBezTo>
                      <a:pt x="471" y="0"/>
                      <a:pt x="419" y="19"/>
                      <a:pt x="392" y="46"/>
                    </a:cubicBezTo>
                    <a:lnTo>
                      <a:pt x="44" y="546"/>
                    </a:lnTo>
                    <a:cubicBezTo>
                      <a:pt x="0" y="611"/>
                      <a:pt x="0" y="698"/>
                      <a:pt x="66" y="742"/>
                    </a:cubicBezTo>
                    <a:cubicBezTo>
                      <a:pt x="95" y="761"/>
                      <a:pt x="129" y="772"/>
                      <a:pt x="161" y="772"/>
                    </a:cubicBezTo>
                    <a:cubicBezTo>
                      <a:pt x="200" y="772"/>
                      <a:pt x="238" y="756"/>
                      <a:pt x="262" y="720"/>
                    </a:cubicBezTo>
                    <a:lnTo>
                      <a:pt x="631" y="220"/>
                    </a:lnTo>
                    <a:cubicBezTo>
                      <a:pt x="675" y="154"/>
                      <a:pt x="653" y="67"/>
                      <a:pt x="610" y="24"/>
                    </a:cubicBezTo>
                    <a:lnTo>
                      <a:pt x="588" y="24"/>
                    </a:lnTo>
                    <a:cubicBezTo>
                      <a:pt x="571" y="7"/>
                      <a:pt x="545" y="0"/>
                      <a:pt x="517" y="0"/>
                    </a:cubicBezTo>
                    <a:close/>
                  </a:path>
                </a:pathLst>
              </a:custGeom>
              <a:solidFill>
                <a:srgbClr val="FFBD9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12" name="Google Shape;212;p13"/>
              <p:cNvSpPr/>
              <p:nvPr/>
            </p:nvSpPr>
            <p:spPr>
              <a:xfrm>
                <a:off x="593631" y="3499204"/>
                <a:ext cx="63373" cy="73309"/>
              </a:xfrm>
              <a:custGeom>
                <a:avLst/>
                <a:gdLst/>
                <a:ahLst/>
                <a:cxnLst/>
                <a:rect l="l" t="t" r="r" b="b"/>
                <a:pathLst>
                  <a:path w="676" h="782" extrusionOk="0">
                    <a:moveTo>
                      <a:pt x="534" y="1"/>
                    </a:moveTo>
                    <a:cubicBezTo>
                      <a:pt x="486" y="1"/>
                      <a:pt x="435" y="25"/>
                      <a:pt x="393" y="67"/>
                    </a:cubicBezTo>
                    <a:lnTo>
                      <a:pt x="44" y="546"/>
                    </a:lnTo>
                    <a:cubicBezTo>
                      <a:pt x="1" y="611"/>
                      <a:pt x="1" y="698"/>
                      <a:pt x="66" y="742"/>
                    </a:cubicBezTo>
                    <a:cubicBezTo>
                      <a:pt x="94" y="769"/>
                      <a:pt x="125" y="781"/>
                      <a:pt x="155" y="781"/>
                    </a:cubicBezTo>
                    <a:cubicBezTo>
                      <a:pt x="197" y="781"/>
                      <a:pt x="237" y="758"/>
                      <a:pt x="262" y="720"/>
                    </a:cubicBezTo>
                    <a:lnTo>
                      <a:pt x="632" y="219"/>
                    </a:lnTo>
                    <a:cubicBezTo>
                      <a:pt x="675" y="176"/>
                      <a:pt x="654" y="67"/>
                      <a:pt x="610" y="24"/>
                    </a:cubicBezTo>
                    <a:cubicBezTo>
                      <a:pt x="587" y="8"/>
                      <a:pt x="561" y="1"/>
                      <a:pt x="534" y="1"/>
                    </a:cubicBezTo>
                    <a:close/>
                  </a:path>
                </a:pathLst>
              </a:custGeom>
              <a:solidFill>
                <a:srgbClr val="FFBD9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13" name="Google Shape;213;p13"/>
              <p:cNvSpPr/>
              <p:nvPr/>
            </p:nvSpPr>
            <p:spPr>
              <a:xfrm>
                <a:off x="575351" y="3484204"/>
                <a:ext cx="63280" cy="73121"/>
              </a:xfrm>
              <a:custGeom>
                <a:avLst/>
                <a:gdLst/>
                <a:ahLst/>
                <a:cxnLst/>
                <a:rect l="l" t="t" r="r" b="b"/>
                <a:pathLst>
                  <a:path w="675" h="780" extrusionOk="0">
                    <a:moveTo>
                      <a:pt x="512" y="1"/>
                    </a:moveTo>
                    <a:cubicBezTo>
                      <a:pt x="470" y="1"/>
                      <a:pt x="428" y="17"/>
                      <a:pt x="392" y="53"/>
                    </a:cubicBezTo>
                    <a:lnTo>
                      <a:pt x="44" y="553"/>
                    </a:lnTo>
                    <a:cubicBezTo>
                      <a:pt x="0" y="619"/>
                      <a:pt x="0" y="706"/>
                      <a:pt x="65" y="749"/>
                    </a:cubicBezTo>
                    <a:cubicBezTo>
                      <a:pt x="95" y="769"/>
                      <a:pt x="128" y="780"/>
                      <a:pt x="161" y="780"/>
                    </a:cubicBezTo>
                    <a:cubicBezTo>
                      <a:pt x="200" y="780"/>
                      <a:pt x="237" y="763"/>
                      <a:pt x="261" y="728"/>
                    </a:cubicBezTo>
                    <a:lnTo>
                      <a:pt x="631" y="227"/>
                    </a:lnTo>
                    <a:cubicBezTo>
                      <a:pt x="675" y="162"/>
                      <a:pt x="675" y="75"/>
                      <a:pt x="609" y="31"/>
                    </a:cubicBezTo>
                    <a:cubicBezTo>
                      <a:pt x="580" y="12"/>
                      <a:pt x="546" y="1"/>
                      <a:pt x="512" y="1"/>
                    </a:cubicBezTo>
                    <a:close/>
                  </a:path>
                </a:pathLst>
              </a:custGeom>
              <a:solidFill>
                <a:srgbClr val="FFBD9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14" name="Google Shape;214;p13"/>
              <p:cNvSpPr/>
              <p:nvPr/>
            </p:nvSpPr>
            <p:spPr>
              <a:xfrm>
                <a:off x="577319" y="3401426"/>
                <a:ext cx="173527" cy="191802"/>
              </a:xfrm>
              <a:custGeom>
                <a:avLst/>
                <a:gdLst/>
                <a:ahLst/>
                <a:cxnLst/>
                <a:rect l="l" t="t" r="r" b="b"/>
                <a:pathLst>
                  <a:path w="1851" h="2046" extrusionOk="0">
                    <a:moveTo>
                      <a:pt x="1480" y="0"/>
                    </a:moveTo>
                    <a:cubicBezTo>
                      <a:pt x="1480" y="0"/>
                      <a:pt x="588" y="501"/>
                      <a:pt x="458" y="653"/>
                    </a:cubicBezTo>
                    <a:cubicBezTo>
                      <a:pt x="327" y="805"/>
                      <a:pt x="1" y="1502"/>
                      <a:pt x="1" y="1502"/>
                    </a:cubicBezTo>
                    <a:cubicBezTo>
                      <a:pt x="1" y="1502"/>
                      <a:pt x="57" y="1495"/>
                      <a:pt x="130" y="1495"/>
                    </a:cubicBezTo>
                    <a:cubicBezTo>
                      <a:pt x="241" y="1495"/>
                      <a:pt x="392" y="1510"/>
                      <a:pt x="458" y="1589"/>
                    </a:cubicBezTo>
                    <a:cubicBezTo>
                      <a:pt x="588" y="1698"/>
                      <a:pt x="893" y="2046"/>
                      <a:pt x="893" y="2046"/>
                    </a:cubicBezTo>
                    <a:cubicBezTo>
                      <a:pt x="893" y="2046"/>
                      <a:pt x="1415" y="1632"/>
                      <a:pt x="1589" y="1371"/>
                    </a:cubicBezTo>
                    <a:cubicBezTo>
                      <a:pt x="1741" y="1110"/>
                      <a:pt x="1850" y="805"/>
                      <a:pt x="1850" y="805"/>
                    </a:cubicBezTo>
                    <a:lnTo>
                      <a:pt x="1480" y="0"/>
                    </a:lnTo>
                    <a:close/>
                  </a:path>
                </a:pathLst>
              </a:custGeom>
              <a:solidFill>
                <a:srgbClr val="FFBD95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  <p:sp>
            <p:nvSpPr>
              <p:cNvPr id="215" name="Google Shape;215;p13"/>
              <p:cNvSpPr/>
              <p:nvPr/>
            </p:nvSpPr>
            <p:spPr>
              <a:xfrm>
                <a:off x="-87625" y="2442685"/>
                <a:ext cx="148965" cy="277579"/>
              </a:xfrm>
              <a:custGeom>
                <a:avLst/>
                <a:gdLst/>
                <a:ahLst/>
                <a:cxnLst/>
                <a:rect l="l" t="t" r="r" b="b"/>
                <a:pathLst>
                  <a:path w="1589" h="2961" extrusionOk="0">
                    <a:moveTo>
                      <a:pt x="1004" y="1"/>
                    </a:moveTo>
                    <a:cubicBezTo>
                      <a:pt x="1003" y="1"/>
                      <a:pt x="1002" y="1"/>
                      <a:pt x="1002" y="1"/>
                    </a:cubicBezTo>
                    <a:cubicBezTo>
                      <a:pt x="849" y="45"/>
                      <a:pt x="1110" y="1307"/>
                      <a:pt x="1045" y="1307"/>
                    </a:cubicBezTo>
                    <a:cubicBezTo>
                      <a:pt x="980" y="1307"/>
                      <a:pt x="653" y="1328"/>
                      <a:pt x="436" y="1481"/>
                    </a:cubicBezTo>
                    <a:cubicBezTo>
                      <a:pt x="1" y="1764"/>
                      <a:pt x="414" y="2764"/>
                      <a:pt x="414" y="2764"/>
                    </a:cubicBezTo>
                    <a:lnTo>
                      <a:pt x="1241" y="2960"/>
                    </a:lnTo>
                    <a:lnTo>
                      <a:pt x="1589" y="1764"/>
                    </a:lnTo>
                    <a:cubicBezTo>
                      <a:pt x="1589" y="1764"/>
                      <a:pt x="1138" y="1"/>
                      <a:pt x="1004" y="1"/>
                    </a:cubicBezTo>
                    <a:close/>
                  </a:path>
                </a:pathLst>
              </a:custGeom>
              <a:solidFill>
                <a:srgbClr val="FFA47C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4256264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19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713225" y="593367"/>
            <a:ext cx="7717500" cy="76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500"/>
              <a:buFont typeface="Epilogue"/>
              <a:buNone/>
              <a:defRPr sz="3500" b="1">
                <a:solidFill>
                  <a:schemeClr val="dk1"/>
                </a:solidFill>
                <a:latin typeface="Epilogue"/>
                <a:ea typeface="Epilogue"/>
                <a:cs typeface="Epilogue"/>
                <a:sym typeface="Epilogue"/>
              </a:defRPr>
            </a:lvl1pPr>
            <a:lvl2pPr lvl="1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500"/>
              <a:buFont typeface="Epilogue"/>
              <a:buNone/>
              <a:defRPr sz="3500" b="1">
                <a:solidFill>
                  <a:schemeClr val="dk1"/>
                </a:solidFill>
                <a:latin typeface="Epilogue"/>
                <a:ea typeface="Epilogue"/>
                <a:cs typeface="Epilogue"/>
                <a:sym typeface="Epilogue"/>
              </a:defRPr>
            </a:lvl2pPr>
            <a:lvl3pPr lvl="2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500"/>
              <a:buFont typeface="Epilogue"/>
              <a:buNone/>
              <a:defRPr sz="3500" b="1">
                <a:solidFill>
                  <a:schemeClr val="dk1"/>
                </a:solidFill>
                <a:latin typeface="Epilogue"/>
                <a:ea typeface="Epilogue"/>
                <a:cs typeface="Epilogue"/>
                <a:sym typeface="Epilogue"/>
              </a:defRPr>
            </a:lvl3pPr>
            <a:lvl4pPr lvl="3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500"/>
              <a:buFont typeface="Epilogue"/>
              <a:buNone/>
              <a:defRPr sz="3500" b="1">
                <a:solidFill>
                  <a:schemeClr val="dk1"/>
                </a:solidFill>
                <a:latin typeface="Epilogue"/>
                <a:ea typeface="Epilogue"/>
                <a:cs typeface="Epilogue"/>
                <a:sym typeface="Epilogue"/>
              </a:defRPr>
            </a:lvl4pPr>
            <a:lvl5pPr lvl="4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500"/>
              <a:buFont typeface="Epilogue"/>
              <a:buNone/>
              <a:defRPr sz="3500" b="1">
                <a:solidFill>
                  <a:schemeClr val="dk1"/>
                </a:solidFill>
                <a:latin typeface="Epilogue"/>
                <a:ea typeface="Epilogue"/>
                <a:cs typeface="Epilogue"/>
                <a:sym typeface="Epilogue"/>
              </a:defRPr>
            </a:lvl5pPr>
            <a:lvl6pPr lvl="5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500"/>
              <a:buFont typeface="Epilogue"/>
              <a:buNone/>
              <a:defRPr sz="3500" b="1">
                <a:solidFill>
                  <a:schemeClr val="dk1"/>
                </a:solidFill>
                <a:latin typeface="Epilogue"/>
                <a:ea typeface="Epilogue"/>
                <a:cs typeface="Epilogue"/>
                <a:sym typeface="Epilogue"/>
              </a:defRPr>
            </a:lvl6pPr>
            <a:lvl7pPr lvl="6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500"/>
              <a:buFont typeface="Epilogue"/>
              <a:buNone/>
              <a:defRPr sz="3500" b="1">
                <a:solidFill>
                  <a:schemeClr val="dk1"/>
                </a:solidFill>
                <a:latin typeface="Epilogue"/>
                <a:ea typeface="Epilogue"/>
                <a:cs typeface="Epilogue"/>
                <a:sym typeface="Epilogue"/>
              </a:defRPr>
            </a:lvl7pPr>
            <a:lvl8pPr lvl="7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500"/>
              <a:buFont typeface="Epilogue"/>
              <a:buNone/>
              <a:defRPr sz="3500" b="1">
                <a:solidFill>
                  <a:schemeClr val="dk1"/>
                </a:solidFill>
                <a:latin typeface="Epilogue"/>
                <a:ea typeface="Epilogue"/>
                <a:cs typeface="Epilogue"/>
                <a:sym typeface="Epilogue"/>
              </a:defRPr>
            </a:lvl8pPr>
            <a:lvl9pPr lvl="8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500"/>
              <a:buFont typeface="Epilogue"/>
              <a:buNone/>
              <a:defRPr sz="3500" b="1">
                <a:solidFill>
                  <a:schemeClr val="dk1"/>
                </a:solidFill>
                <a:latin typeface="Epilogue"/>
                <a:ea typeface="Epilogue"/>
                <a:cs typeface="Epilogue"/>
                <a:sym typeface="Epilogue"/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713225" y="1536633"/>
            <a:ext cx="7717500" cy="455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048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Open Sans"/>
              <a:buChar char="●"/>
              <a:defRPr sz="1200">
                <a:solidFill>
                  <a:schemeClr val="dk1"/>
                </a:solidFill>
                <a:latin typeface="Open Sans"/>
                <a:ea typeface="Open Sans"/>
                <a:cs typeface="Open Sans"/>
                <a:sym typeface="Open Sans"/>
              </a:defRPr>
            </a:lvl1pPr>
            <a:lvl2pPr marL="914400" lvl="1" indent="-304800">
              <a:lnSpc>
                <a:spcPct val="100000"/>
              </a:lnSpc>
              <a:spcBef>
                <a:spcPts val="160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Open Sans"/>
              <a:buChar char="○"/>
              <a:defRPr sz="1200">
                <a:solidFill>
                  <a:schemeClr val="dk1"/>
                </a:solidFill>
                <a:latin typeface="Open Sans"/>
                <a:ea typeface="Open Sans"/>
                <a:cs typeface="Open Sans"/>
                <a:sym typeface="Open Sans"/>
              </a:defRPr>
            </a:lvl2pPr>
            <a:lvl3pPr marL="1371600" lvl="2" indent="-304800">
              <a:lnSpc>
                <a:spcPct val="100000"/>
              </a:lnSpc>
              <a:spcBef>
                <a:spcPts val="160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Open Sans"/>
              <a:buChar char="■"/>
              <a:defRPr sz="1200">
                <a:solidFill>
                  <a:schemeClr val="dk1"/>
                </a:solidFill>
                <a:latin typeface="Open Sans"/>
                <a:ea typeface="Open Sans"/>
                <a:cs typeface="Open Sans"/>
                <a:sym typeface="Open Sans"/>
              </a:defRPr>
            </a:lvl3pPr>
            <a:lvl4pPr marL="1828800" lvl="3" indent="-304800">
              <a:lnSpc>
                <a:spcPct val="100000"/>
              </a:lnSpc>
              <a:spcBef>
                <a:spcPts val="160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Open Sans"/>
              <a:buChar char="●"/>
              <a:defRPr sz="1200">
                <a:solidFill>
                  <a:schemeClr val="dk1"/>
                </a:solidFill>
                <a:latin typeface="Open Sans"/>
                <a:ea typeface="Open Sans"/>
                <a:cs typeface="Open Sans"/>
                <a:sym typeface="Open Sans"/>
              </a:defRPr>
            </a:lvl4pPr>
            <a:lvl5pPr marL="2286000" lvl="4" indent="-304800">
              <a:lnSpc>
                <a:spcPct val="100000"/>
              </a:lnSpc>
              <a:spcBef>
                <a:spcPts val="160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Open Sans"/>
              <a:buChar char="○"/>
              <a:defRPr sz="1200">
                <a:solidFill>
                  <a:schemeClr val="dk1"/>
                </a:solidFill>
                <a:latin typeface="Open Sans"/>
                <a:ea typeface="Open Sans"/>
                <a:cs typeface="Open Sans"/>
                <a:sym typeface="Open Sans"/>
              </a:defRPr>
            </a:lvl5pPr>
            <a:lvl6pPr marL="2743200" lvl="5" indent="-304800">
              <a:lnSpc>
                <a:spcPct val="100000"/>
              </a:lnSpc>
              <a:spcBef>
                <a:spcPts val="160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Open Sans"/>
              <a:buChar char="■"/>
              <a:defRPr sz="1200">
                <a:solidFill>
                  <a:schemeClr val="dk1"/>
                </a:solidFill>
                <a:latin typeface="Open Sans"/>
                <a:ea typeface="Open Sans"/>
                <a:cs typeface="Open Sans"/>
                <a:sym typeface="Open Sans"/>
              </a:defRPr>
            </a:lvl6pPr>
            <a:lvl7pPr marL="3200400" lvl="6" indent="-304800">
              <a:lnSpc>
                <a:spcPct val="100000"/>
              </a:lnSpc>
              <a:spcBef>
                <a:spcPts val="160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Open Sans"/>
              <a:buChar char="●"/>
              <a:defRPr sz="1200">
                <a:solidFill>
                  <a:schemeClr val="dk1"/>
                </a:solidFill>
                <a:latin typeface="Open Sans"/>
                <a:ea typeface="Open Sans"/>
                <a:cs typeface="Open Sans"/>
                <a:sym typeface="Open Sans"/>
              </a:defRPr>
            </a:lvl7pPr>
            <a:lvl8pPr marL="3657600" lvl="7" indent="-304800">
              <a:lnSpc>
                <a:spcPct val="100000"/>
              </a:lnSpc>
              <a:spcBef>
                <a:spcPts val="160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Open Sans"/>
              <a:buChar char="○"/>
              <a:defRPr sz="1200">
                <a:solidFill>
                  <a:schemeClr val="dk1"/>
                </a:solidFill>
                <a:latin typeface="Open Sans"/>
                <a:ea typeface="Open Sans"/>
                <a:cs typeface="Open Sans"/>
                <a:sym typeface="Open Sans"/>
              </a:defRPr>
            </a:lvl8pPr>
            <a:lvl9pPr marL="4114800" lvl="8" indent="-304800">
              <a:lnSpc>
                <a:spcPct val="100000"/>
              </a:lnSpc>
              <a:spcBef>
                <a:spcPts val="1600"/>
              </a:spcBef>
              <a:spcAft>
                <a:spcPts val="1600"/>
              </a:spcAft>
              <a:buClr>
                <a:schemeClr val="dk1"/>
              </a:buClr>
              <a:buSzPts val="1200"/>
              <a:buFont typeface="Open Sans"/>
              <a:buChar char="■"/>
              <a:defRPr sz="1200">
                <a:solidFill>
                  <a:schemeClr val="dk1"/>
                </a:solidFill>
                <a:latin typeface="Open Sans"/>
                <a:ea typeface="Open Sans"/>
                <a:cs typeface="Open Sans"/>
                <a:sym typeface="Open Sans"/>
              </a:defRPr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1168407666"/>
      </p:ext>
    </p:extLst>
  </p:cSld>
  <p:clrMap bg1="lt1" tx1="dk1" bg2="dk2" tx2="lt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  <p:sldLayoutId id="2147483684" r:id="rId12"/>
    <p:sldLayoutId id="2147483685" r:id="rId13"/>
    <p:sldLayoutId id="2147483686" r:id="rId14"/>
    <p:sldLayoutId id="2147483687" r:id="rId15"/>
    <p:sldLayoutId id="2147483688" r:id="rId16"/>
    <p:sldLayoutId id="2147483689" r:id="rId17"/>
    <p:sldLayoutId id="2147483690" r:id="rId18"/>
  </p:sldLayoutIdLst>
  <p:hf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 descr="写真, 食品, 異なる, 小さい が含まれている画像&#10;&#10;自動的に生成された説明">
            <a:extLst>
              <a:ext uri="{FF2B5EF4-FFF2-40B4-BE49-F238E27FC236}">
                <a16:creationId xmlns:a16="http://schemas.microsoft.com/office/drawing/2014/main" id="{2C3D95D6-F68F-92DA-D8B6-1FA17B770C5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2595" y="501873"/>
            <a:ext cx="5398811" cy="5398811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3924D19-7BBA-BF58-9DDD-BF88A7361D1D}"/>
              </a:ext>
            </a:extLst>
          </p:cNvPr>
          <p:cNvSpPr txBox="1"/>
          <p:nvPr/>
        </p:nvSpPr>
        <p:spPr>
          <a:xfrm>
            <a:off x="510209" y="5927188"/>
            <a:ext cx="8123583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1" i="0" u="none" strike="noStrike" kern="1200" cap="none" spc="0" normalizeH="0" baseline="0" noProof="0" dirty="0">
                <a:ln>
                  <a:noFill/>
                </a:ln>
                <a:solidFill>
                  <a:srgbClr val="191919"/>
                </a:solidFill>
                <a:effectLst/>
                <a:uLnTx/>
                <a:uFillTx/>
                <a:latin typeface="Palatino Linotype" panose="02040502050505030304" pitchFamily="18" charset="0"/>
                <a:ea typeface="ＭＳ Ｐゴシック" panose="020B0600070205080204" pitchFamily="50" charset="-128"/>
                <a:cs typeface="Posterama" panose="020B0502040204020203" pitchFamily="34" charset="0"/>
              </a:rPr>
              <a:t>Figure S3</a:t>
            </a: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srgbClr val="191919"/>
                </a:solidFill>
                <a:effectLst/>
                <a:uLnTx/>
                <a:uFillTx/>
                <a:latin typeface="Palatino Linotype" panose="02040502050505030304" pitchFamily="18" charset="0"/>
                <a:ea typeface="ＭＳ Ｐゴシック" panose="020B0600070205080204" pitchFamily="50" charset="-128"/>
                <a:cs typeface="Posterama" panose="020B0502040204020203" pitchFamily="34" charset="0"/>
              </a:rPr>
              <a:t>. Gross pathology of chickens inoculated 10</a:t>
            </a:r>
            <a:r>
              <a:rPr kumimoji="1" lang="en-US" altLang="ja-JP" sz="1100" b="0" i="0" u="none" strike="noStrike" kern="1200" cap="none" spc="0" normalizeH="0" baseline="30000" noProof="0" dirty="0">
                <a:ln>
                  <a:noFill/>
                </a:ln>
                <a:solidFill>
                  <a:srgbClr val="191919"/>
                </a:solidFill>
                <a:effectLst/>
                <a:uLnTx/>
                <a:uFillTx/>
                <a:latin typeface="Palatino Linotype" panose="02040502050505030304" pitchFamily="18" charset="0"/>
                <a:ea typeface="ＭＳ Ｐゴシック" panose="020B0600070205080204" pitchFamily="50" charset="-128"/>
                <a:cs typeface="Posterama" panose="020B0502040204020203" pitchFamily="34" charset="0"/>
              </a:rPr>
              <a:t>6</a:t>
            </a: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srgbClr val="191919"/>
                </a:solidFill>
                <a:effectLst/>
                <a:uLnTx/>
                <a:uFillTx/>
                <a:latin typeface="Palatino Linotype" panose="02040502050505030304" pitchFamily="18" charset="0"/>
                <a:ea typeface="ＭＳ Ｐゴシック" panose="020B0600070205080204" pitchFamily="50" charset="-128"/>
                <a:cs typeface="Posterama" panose="020B0502040204020203" pitchFamily="34" charset="0"/>
              </a:rPr>
              <a:t> EID</a:t>
            </a:r>
            <a:r>
              <a:rPr kumimoji="1" lang="en-US" altLang="ja-JP" sz="1100" b="0" i="0" u="none" strike="noStrike" kern="1200" cap="none" spc="0" normalizeH="0" baseline="-25000" noProof="0" dirty="0">
                <a:ln>
                  <a:noFill/>
                </a:ln>
                <a:solidFill>
                  <a:srgbClr val="191919"/>
                </a:solidFill>
                <a:effectLst/>
                <a:uLnTx/>
                <a:uFillTx/>
                <a:latin typeface="Palatino Linotype" panose="02040502050505030304" pitchFamily="18" charset="0"/>
                <a:ea typeface="ＭＳ Ｐゴシック" panose="020B0600070205080204" pitchFamily="50" charset="-128"/>
                <a:cs typeface="Posterama" panose="020B0502040204020203" pitchFamily="34" charset="0"/>
              </a:rPr>
              <a:t>50</a:t>
            </a: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srgbClr val="191919"/>
                </a:solidFill>
                <a:effectLst/>
                <a:uLnTx/>
                <a:uFillTx/>
                <a:latin typeface="Palatino Linotype" panose="02040502050505030304" pitchFamily="18" charset="0"/>
                <a:ea typeface="ＭＳ Ｐゴシック" panose="020B0600070205080204" pitchFamily="50" charset="-128"/>
                <a:cs typeface="Posterama" panose="020B0502040204020203" pitchFamily="34" charset="0"/>
              </a:rPr>
              <a:t> Saga/23A2T (</a:t>
            </a:r>
            <a:r>
              <a:rPr kumimoji="1" lang="en-US" altLang="ja-JP" sz="1100" b="0" i="0" u="none" strike="noStrike" kern="1200" cap="none" spc="0" normalizeH="0" baseline="0" noProof="0" dirty="0" err="1">
                <a:ln>
                  <a:noFill/>
                </a:ln>
                <a:solidFill>
                  <a:srgbClr val="191919"/>
                </a:solidFill>
                <a:effectLst/>
                <a:uLnTx/>
                <a:uFillTx/>
                <a:latin typeface="Palatino Linotype" panose="02040502050505030304" pitchFamily="18" charset="0"/>
                <a:ea typeface="ＭＳ Ｐゴシック" panose="020B0600070205080204" pitchFamily="50" charset="-128"/>
                <a:cs typeface="Posterama" panose="020B0502040204020203" pitchFamily="34" charset="0"/>
              </a:rPr>
              <a:t>a,b</a:t>
            </a: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srgbClr val="191919"/>
                </a:solidFill>
                <a:effectLst/>
                <a:uLnTx/>
                <a:uFillTx/>
                <a:latin typeface="Palatino Linotype" panose="02040502050505030304" pitchFamily="18" charset="0"/>
                <a:ea typeface="ＭＳ Ｐゴシック" panose="020B0600070205080204" pitchFamily="50" charset="-128"/>
                <a:cs typeface="Posterama" panose="020B0502040204020203" pitchFamily="34" charset="0"/>
              </a:rPr>
              <a:t>) and Kagoshima/23B1T (</a:t>
            </a:r>
            <a:r>
              <a:rPr kumimoji="1" lang="en-US" altLang="ja-JP" sz="1100" b="0" i="0" u="none" strike="noStrike" kern="1200" cap="none" spc="0" normalizeH="0" baseline="0" noProof="0" dirty="0" err="1">
                <a:ln>
                  <a:noFill/>
                </a:ln>
                <a:solidFill>
                  <a:srgbClr val="191919"/>
                </a:solidFill>
                <a:effectLst/>
                <a:uLnTx/>
                <a:uFillTx/>
                <a:latin typeface="Palatino Linotype" panose="02040502050505030304" pitchFamily="18" charset="0"/>
                <a:ea typeface="ＭＳ Ｐゴシック" panose="020B0600070205080204" pitchFamily="50" charset="-128"/>
                <a:cs typeface="Posterama" panose="020B0502040204020203" pitchFamily="34" charset="0"/>
              </a:rPr>
              <a:t>c,d</a:t>
            </a: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srgbClr val="191919"/>
                </a:solidFill>
                <a:effectLst/>
                <a:uLnTx/>
                <a:uFillTx/>
                <a:latin typeface="Palatino Linotype" panose="02040502050505030304" pitchFamily="18" charset="0"/>
                <a:ea typeface="ＭＳ Ｐゴシック" panose="020B0600070205080204" pitchFamily="50" charset="-128"/>
                <a:cs typeface="Posterama" panose="020B0502040204020203" pitchFamily="34" charset="0"/>
              </a:rPr>
              <a:t>). (a) Marked increase of the </a:t>
            </a:r>
            <a:r>
              <a:rPr kumimoji="1" lang="en-US" altLang="ja-JP" sz="1100" b="0" i="0" u="none" strike="noStrike" kern="1200" cap="none" spc="0" normalizeH="0" baseline="0" noProof="0" dirty="0" err="1">
                <a:ln>
                  <a:noFill/>
                </a:ln>
                <a:solidFill>
                  <a:srgbClr val="191919"/>
                </a:solidFill>
                <a:effectLst/>
                <a:uLnTx/>
                <a:uFillTx/>
                <a:latin typeface="Palatino Linotype" panose="02040502050505030304" pitchFamily="18" charset="0"/>
                <a:ea typeface="ＭＳ Ｐゴシック" panose="020B0600070205080204" pitchFamily="50" charset="-128"/>
                <a:cs typeface="Posterama" panose="020B0502040204020203" pitchFamily="34" charset="0"/>
              </a:rPr>
              <a:t>peripleural</a:t>
            </a: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srgbClr val="191919"/>
                </a:solidFill>
                <a:effectLst/>
                <a:uLnTx/>
                <a:uFillTx/>
                <a:latin typeface="Palatino Linotype" panose="02040502050505030304" pitchFamily="18" charset="0"/>
                <a:ea typeface="ＭＳ Ｐゴシック" panose="020B0600070205080204" pitchFamily="50" charset="-128"/>
                <a:cs typeface="Posterama" panose="020B0502040204020203" pitchFamily="34" charset="0"/>
              </a:rPr>
              <a:t> fluid. (b) Diffuse pulmonary congestion and edema. (c) Retention of pericardial fluid and pleural effusion; pale discoloration of the liver with small petechiae. (d) Severe hyperemia/congestion of the lungs.</a:t>
            </a:r>
            <a:endParaRPr kumimoji="1" lang="ja-JP" altLang="en-US" sz="1100" b="0" i="0" u="none" strike="noStrike" kern="1200" cap="none" spc="0" normalizeH="0" baseline="0" noProof="0" dirty="0">
              <a:ln>
                <a:noFill/>
              </a:ln>
              <a:solidFill>
                <a:srgbClr val="191919"/>
              </a:solidFill>
              <a:effectLst/>
              <a:uLnTx/>
              <a:uFillTx/>
              <a:latin typeface="Palatino Linotype" panose="02040502050505030304" pitchFamily="18" charset="0"/>
              <a:ea typeface="ＭＳ Ｐゴシック" panose="020B0600070205080204" pitchFamily="50" charset="-128"/>
              <a:cs typeface="Posterama" panose="020B05020402040202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39312371"/>
      </p:ext>
    </p:extLst>
  </p:cSld>
  <p:clrMapOvr>
    <a:masterClrMapping/>
  </p:clrMapOvr>
</p:sld>
</file>

<file path=ppt/theme/theme1.xml><?xml version="1.0" encoding="utf-8"?>
<a:theme xmlns:a="http://schemas.openxmlformats.org/drawingml/2006/main" name="Institutional Governance Meeting Infographics by Slidesgo">
  <a:themeElements>
    <a:clrScheme name="Simple Light">
      <a:dk1>
        <a:srgbClr val="191919"/>
      </a:dk1>
      <a:lt1>
        <a:srgbClr val="F0F8FF"/>
      </a:lt1>
      <a:dk2>
        <a:srgbClr val="CFE2F3"/>
      </a:dk2>
      <a:lt2>
        <a:srgbClr val="A1BFEC"/>
      </a:lt2>
      <a:accent1>
        <a:srgbClr val="3B4F8D"/>
      </a:accent1>
      <a:accent2>
        <a:srgbClr val="90A4A2"/>
      </a:accent2>
      <a:accent3>
        <a:srgbClr val="79B84F"/>
      </a:accent3>
      <a:accent4>
        <a:srgbClr val="65C99A"/>
      </a:accent4>
      <a:accent5>
        <a:srgbClr val="E2532B"/>
      </a:accent5>
      <a:accent6>
        <a:srgbClr val="FFFFFF"/>
      </a:accent6>
      <a:hlink>
        <a:srgbClr val="191919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1B8E7EBA0EE0944D8A60476C5090323E" ma:contentTypeVersion="4" ma:contentTypeDescription="新しいドキュメントを作成します。" ma:contentTypeScope="" ma:versionID="8f557056da61e5fbe63d67920799e1b0">
  <xsd:schema xmlns:xsd="http://www.w3.org/2001/XMLSchema" xmlns:xs="http://www.w3.org/2001/XMLSchema" xmlns:p="http://schemas.microsoft.com/office/2006/metadata/properties" xmlns:ns2="1df211c6-8f17-4a6b-80d3-29c65b8a01a6" targetNamespace="http://schemas.microsoft.com/office/2006/metadata/properties" ma:root="true" ma:fieldsID="f7a617a5ca74d227a7193e56a5954a8e" ns2:_="">
    <xsd:import namespace="1df211c6-8f17-4a6b-80d3-29c65b8a01a6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df211c6-8f17-4a6b-80d3-29c65b8a01a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DCA677AD-F956-4927-9614-0FFEA29BF59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df211c6-8f17-4a6b-80d3-29c65b8a01a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851A21EF-D7C2-45FB-A39B-DABFFC0053AA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5B35FD16-4638-471C-B816-121FF270CF3C}">
  <ds:schemaRefs>
    <ds:schemaRef ds:uri="http://schemas.microsoft.com/office/2006/metadata/properties"/>
    <ds:schemaRef ds:uri="http://schemas.microsoft.com/office/infopath/2007/PartnerControl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8</TotalTime>
  <Words>125</Words>
  <Application>Microsoft Office PowerPoint</Application>
  <PresentationFormat>画面に合わせる (4:3)</PresentationFormat>
  <Paragraphs>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Epilogue</vt:lpstr>
      <vt:lpstr>MyriadPro-Regular</vt:lpstr>
      <vt:lpstr>游ゴシック</vt:lpstr>
      <vt:lpstr>Arial</vt:lpstr>
      <vt:lpstr>Nunito Light</vt:lpstr>
      <vt:lpstr>Open Sans</vt:lpstr>
      <vt:lpstr>Palatino Linotype</vt:lpstr>
      <vt:lpstr>Institutional Governance Meeting Infographics by Slidesgo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西浦 颯</dc:creator>
  <cp:lastModifiedBy>西浦 颯</cp:lastModifiedBy>
  <cp:revision>1</cp:revision>
  <dcterms:created xsi:type="dcterms:W3CDTF">2024-10-15T08:09:33Z</dcterms:created>
  <dcterms:modified xsi:type="dcterms:W3CDTF">2024-11-07T02:14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B8E7EBA0EE0944D8A60476C5090323E</vt:lpwstr>
  </property>
</Properties>
</file>